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8"/>
  </p:notesMasterIdLst>
  <p:sldIdLst>
    <p:sldId id="260" r:id="rId5"/>
    <p:sldId id="258" r:id="rId6"/>
    <p:sldId id="259" r:id="rId7"/>
  </p:sldIdLst>
  <p:sldSz cx="5143500" cy="9144000" type="screen16x9"/>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arry M Rosewarne (DJPR)" initials="GMR(" lastIdx="5" clrIdx="0">
    <p:extLst>
      <p:ext uri="{19B8F6BF-5375-455C-9EA6-DF929625EA0E}">
        <p15:presenceInfo xmlns:p15="http://schemas.microsoft.com/office/powerpoint/2012/main" userId="S::garry.rosewarne@agriculture.vic.gov.au::51564b9f-0e86-4dd8-9e91-f771a6d10681" providerId="AD"/>
      </p:ext>
    </p:extLst>
  </p:cmAuthor>
  <p:cmAuthor id="2" name="Babu R Pandey (DJPR)" initials="B(" lastIdx="1" clrIdx="1">
    <p:extLst>
      <p:ext uri="{19B8F6BF-5375-455C-9EA6-DF929625EA0E}">
        <p15:presenceInfo xmlns:p15="http://schemas.microsoft.com/office/powerpoint/2012/main" userId="S::babu.pandey@agriculture.vic.gov.au::044449df-33c0-4d7f-91a8-80cfc82b8f4c"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1291F6F-DCDE-4AD1-A06E-C66A3002EF8D}" v="273" dt="2022-08-17T05:46:17.00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43" autoAdjust="0"/>
    <p:restoredTop sz="95324" autoAdjust="0"/>
  </p:normalViewPr>
  <p:slideViewPr>
    <p:cSldViewPr snapToGrid="0">
      <p:cViewPr varScale="1">
        <p:scale>
          <a:sx n="88" d="100"/>
          <a:sy n="88" d="100"/>
        </p:scale>
        <p:origin x="3366" y="90"/>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commentAuthors" Target="commentAuthors.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meer G Joshi (DJPR)" userId="bd06337d-ce8c-4c34-b1d1-7fbf8f91b6eb" providerId="ADAL" clId="{31291F6F-DCDE-4AD1-A06E-C66A3002EF8D}"/>
    <pc:docChg chg="undo custSel addSld delSld modSld">
      <pc:chgData name="Sameer G Joshi (DJPR)" userId="bd06337d-ce8c-4c34-b1d1-7fbf8f91b6eb" providerId="ADAL" clId="{31291F6F-DCDE-4AD1-A06E-C66A3002EF8D}" dt="2022-08-17T05:47:57.701" v="1669" actId="113"/>
      <pc:docMkLst>
        <pc:docMk/>
      </pc:docMkLst>
      <pc:sldChg chg="addSp delSp modSp del mod">
        <pc:chgData name="Sameer G Joshi (DJPR)" userId="bd06337d-ce8c-4c34-b1d1-7fbf8f91b6eb" providerId="ADAL" clId="{31291F6F-DCDE-4AD1-A06E-C66A3002EF8D}" dt="2022-08-14T12:53:17.675" v="799" actId="47"/>
        <pc:sldMkLst>
          <pc:docMk/>
          <pc:sldMk cId="3352034816" sldId="256"/>
        </pc:sldMkLst>
        <pc:spChg chg="del">
          <ac:chgData name="Sameer G Joshi (DJPR)" userId="bd06337d-ce8c-4c34-b1d1-7fbf8f91b6eb" providerId="ADAL" clId="{31291F6F-DCDE-4AD1-A06E-C66A3002EF8D}" dt="2022-08-12T05:29:22.951" v="0" actId="478"/>
          <ac:spMkLst>
            <pc:docMk/>
            <pc:sldMk cId="3352034816" sldId="256"/>
            <ac:spMk id="8" creationId="{520DCA2E-CECA-42FB-8D8D-F305B5344E3E}"/>
          </ac:spMkLst>
        </pc:spChg>
        <pc:spChg chg="del">
          <ac:chgData name="Sameer G Joshi (DJPR)" userId="bd06337d-ce8c-4c34-b1d1-7fbf8f91b6eb" providerId="ADAL" clId="{31291F6F-DCDE-4AD1-A06E-C66A3002EF8D}" dt="2022-08-12T05:29:22.951" v="0" actId="478"/>
          <ac:spMkLst>
            <pc:docMk/>
            <pc:sldMk cId="3352034816" sldId="256"/>
            <ac:spMk id="9" creationId="{30206B20-BF06-4357-B1DD-8CD6E08A3CF8}"/>
          </ac:spMkLst>
        </pc:spChg>
        <pc:spChg chg="del">
          <ac:chgData name="Sameer G Joshi (DJPR)" userId="bd06337d-ce8c-4c34-b1d1-7fbf8f91b6eb" providerId="ADAL" clId="{31291F6F-DCDE-4AD1-A06E-C66A3002EF8D}" dt="2022-08-12T05:29:22.951" v="0" actId="478"/>
          <ac:spMkLst>
            <pc:docMk/>
            <pc:sldMk cId="3352034816" sldId="256"/>
            <ac:spMk id="10" creationId="{FAB49720-C1D9-4B92-8980-50A09B42F116}"/>
          </ac:spMkLst>
        </pc:spChg>
        <pc:spChg chg="add mod">
          <ac:chgData name="Sameer G Joshi (DJPR)" userId="bd06337d-ce8c-4c34-b1d1-7fbf8f91b6eb" providerId="ADAL" clId="{31291F6F-DCDE-4AD1-A06E-C66A3002EF8D}" dt="2022-08-13T23:00:08.593" v="347" actId="1038"/>
          <ac:spMkLst>
            <pc:docMk/>
            <pc:sldMk cId="3352034816" sldId="256"/>
            <ac:spMk id="14" creationId="{F709233E-A4FE-4073-A7DB-ECDD581059D4}"/>
          </ac:spMkLst>
        </pc:spChg>
        <pc:spChg chg="add mod">
          <ac:chgData name="Sameer G Joshi (DJPR)" userId="bd06337d-ce8c-4c34-b1d1-7fbf8f91b6eb" providerId="ADAL" clId="{31291F6F-DCDE-4AD1-A06E-C66A3002EF8D}" dt="2022-08-13T23:00:08.593" v="347" actId="1038"/>
          <ac:spMkLst>
            <pc:docMk/>
            <pc:sldMk cId="3352034816" sldId="256"/>
            <ac:spMk id="15" creationId="{C24E8D6A-50F1-4DAA-B648-1D5A502E3239}"/>
          </ac:spMkLst>
        </pc:spChg>
        <pc:spChg chg="add mod">
          <ac:chgData name="Sameer G Joshi (DJPR)" userId="bd06337d-ce8c-4c34-b1d1-7fbf8f91b6eb" providerId="ADAL" clId="{31291F6F-DCDE-4AD1-A06E-C66A3002EF8D}" dt="2022-08-13T23:00:08.593" v="347" actId="1038"/>
          <ac:spMkLst>
            <pc:docMk/>
            <pc:sldMk cId="3352034816" sldId="256"/>
            <ac:spMk id="16" creationId="{F22F279A-1575-4658-AD0C-69428AB1CCD5}"/>
          </ac:spMkLst>
        </pc:spChg>
        <pc:graphicFrameChg chg="add mod">
          <ac:chgData name="Sameer G Joshi (DJPR)" userId="bd06337d-ce8c-4c34-b1d1-7fbf8f91b6eb" providerId="ADAL" clId="{31291F6F-DCDE-4AD1-A06E-C66A3002EF8D}" dt="2022-08-12T05:57:11.767" v="285" actId="1038"/>
          <ac:graphicFrameMkLst>
            <pc:docMk/>
            <pc:sldMk cId="3352034816" sldId="256"/>
            <ac:graphicFrameMk id="11" creationId="{D646531E-B5B3-4D70-BFB9-280CCDC05B2D}"/>
          </ac:graphicFrameMkLst>
        </pc:graphicFrameChg>
        <pc:graphicFrameChg chg="add mod">
          <ac:chgData name="Sameer G Joshi (DJPR)" userId="bd06337d-ce8c-4c34-b1d1-7fbf8f91b6eb" providerId="ADAL" clId="{31291F6F-DCDE-4AD1-A06E-C66A3002EF8D}" dt="2022-08-12T05:57:11.767" v="285" actId="1038"/>
          <ac:graphicFrameMkLst>
            <pc:docMk/>
            <pc:sldMk cId="3352034816" sldId="256"/>
            <ac:graphicFrameMk id="12" creationId="{9A07D5D6-F228-4530-A6F5-4039085474E0}"/>
          </ac:graphicFrameMkLst>
        </pc:graphicFrameChg>
        <pc:graphicFrameChg chg="add mod">
          <ac:chgData name="Sameer G Joshi (DJPR)" userId="bd06337d-ce8c-4c34-b1d1-7fbf8f91b6eb" providerId="ADAL" clId="{31291F6F-DCDE-4AD1-A06E-C66A3002EF8D}" dt="2022-08-12T05:57:11.767" v="285" actId="1038"/>
          <ac:graphicFrameMkLst>
            <pc:docMk/>
            <pc:sldMk cId="3352034816" sldId="256"/>
            <ac:graphicFrameMk id="13" creationId="{3B84F9CD-A4B7-4F22-A2D6-79D2C6DC605E}"/>
          </ac:graphicFrameMkLst>
        </pc:graphicFrameChg>
        <pc:picChg chg="del">
          <ac:chgData name="Sameer G Joshi (DJPR)" userId="bd06337d-ce8c-4c34-b1d1-7fbf8f91b6eb" providerId="ADAL" clId="{31291F6F-DCDE-4AD1-A06E-C66A3002EF8D}" dt="2022-08-12T05:29:22.951" v="0" actId="478"/>
          <ac:picMkLst>
            <pc:docMk/>
            <pc:sldMk cId="3352034816" sldId="256"/>
            <ac:picMk id="5" creationId="{DCDAA8EF-E4E7-4A09-9325-192D7AEB08E8}"/>
          </ac:picMkLst>
        </pc:picChg>
        <pc:picChg chg="del">
          <ac:chgData name="Sameer G Joshi (DJPR)" userId="bd06337d-ce8c-4c34-b1d1-7fbf8f91b6eb" providerId="ADAL" clId="{31291F6F-DCDE-4AD1-A06E-C66A3002EF8D}" dt="2022-08-12T05:29:22.951" v="0" actId="478"/>
          <ac:picMkLst>
            <pc:docMk/>
            <pc:sldMk cId="3352034816" sldId="256"/>
            <ac:picMk id="7" creationId="{78743228-9D9E-44EB-AAA9-79ECE72B6591}"/>
          </ac:picMkLst>
        </pc:picChg>
      </pc:sldChg>
      <pc:sldChg chg="addSp delSp modSp new del mod">
        <pc:chgData name="Sameer G Joshi (DJPR)" userId="bd06337d-ce8c-4c34-b1d1-7fbf8f91b6eb" providerId="ADAL" clId="{31291F6F-DCDE-4AD1-A06E-C66A3002EF8D}" dt="2022-08-14T12:53:19.042" v="800" actId="47"/>
        <pc:sldMkLst>
          <pc:docMk/>
          <pc:sldMk cId="3205030577" sldId="257"/>
        </pc:sldMkLst>
        <pc:spChg chg="del">
          <ac:chgData name="Sameer G Joshi (DJPR)" userId="bd06337d-ce8c-4c34-b1d1-7fbf8f91b6eb" providerId="ADAL" clId="{31291F6F-DCDE-4AD1-A06E-C66A3002EF8D}" dt="2022-08-12T05:37:44.895" v="88" actId="478"/>
          <ac:spMkLst>
            <pc:docMk/>
            <pc:sldMk cId="3205030577" sldId="257"/>
            <ac:spMk id="2" creationId="{E2AE6D04-AC36-4C70-8727-427E3937B548}"/>
          </ac:spMkLst>
        </pc:spChg>
        <pc:spChg chg="del">
          <ac:chgData name="Sameer G Joshi (DJPR)" userId="bd06337d-ce8c-4c34-b1d1-7fbf8f91b6eb" providerId="ADAL" clId="{31291F6F-DCDE-4AD1-A06E-C66A3002EF8D}" dt="2022-08-12T05:37:44.895" v="88" actId="478"/>
          <ac:spMkLst>
            <pc:docMk/>
            <pc:sldMk cId="3205030577" sldId="257"/>
            <ac:spMk id="3" creationId="{9B96CD2E-2D77-42E8-821D-5CB97C3FA524}"/>
          </ac:spMkLst>
        </pc:spChg>
        <pc:spChg chg="add mod">
          <ac:chgData name="Sameer G Joshi (DJPR)" userId="bd06337d-ce8c-4c34-b1d1-7fbf8f91b6eb" providerId="ADAL" clId="{31291F6F-DCDE-4AD1-A06E-C66A3002EF8D}" dt="2022-08-13T22:58:36.670" v="323" actId="1076"/>
          <ac:spMkLst>
            <pc:docMk/>
            <pc:sldMk cId="3205030577" sldId="257"/>
            <ac:spMk id="7" creationId="{25518310-F081-47DD-84BF-F39EDBC7BA51}"/>
          </ac:spMkLst>
        </pc:spChg>
        <pc:spChg chg="add mod">
          <ac:chgData name="Sameer G Joshi (DJPR)" userId="bd06337d-ce8c-4c34-b1d1-7fbf8f91b6eb" providerId="ADAL" clId="{31291F6F-DCDE-4AD1-A06E-C66A3002EF8D}" dt="2022-08-13T22:59:45.787" v="336" actId="12788"/>
          <ac:spMkLst>
            <pc:docMk/>
            <pc:sldMk cId="3205030577" sldId="257"/>
            <ac:spMk id="8" creationId="{60400EBC-90C2-4A33-81AC-BF4D8E580DDB}"/>
          </ac:spMkLst>
        </pc:spChg>
        <pc:spChg chg="add mod">
          <ac:chgData name="Sameer G Joshi (DJPR)" userId="bd06337d-ce8c-4c34-b1d1-7fbf8f91b6eb" providerId="ADAL" clId="{31291F6F-DCDE-4AD1-A06E-C66A3002EF8D}" dt="2022-08-13T22:59:45.787" v="336" actId="12788"/>
          <ac:spMkLst>
            <pc:docMk/>
            <pc:sldMk cId="3205030577" sldId="257"/>
            <ac:spMk id="9" creationId="{F9662766-7219-4156-B00E-2B8039BE2BC0}"/>
          </ac:spMkLst>
        </pc:spChg>
        <pc:spChg chg="add mod">
          <ac:chgData name="Sameer G Joshi (DJPR)" userId="bd06337d-ce8c-4c34-b1d1-7fbf8f91b6eb" providerId="ADAL" clId="{31291F6F-DCDE-4AD1-A06E-C66A3002EF8D}" dt="2022-08-13T22:59:45.787" v="336" actId="12788"/>
          <ac:spMkLst>
            <pc:docMk/>
            <pc:sldMk cId="3205030577" sldId="257"/>
            <ac:spMk id="10" creationId="{7BD7D6EE-8614-422F-838A-4922BB33B42C}"/>
          </ac:spMkLst>
        </pc:spChg>
        <pc:graphicFrameChg chg="add mod">
          <ac:chgData name="Sameer G Joshi (DJPR)" userId="bd06337d-ce8c-4c34-b1d1-7fbf8f91b6eb" providerId="ADAL" clId="{31291F6F-DCDE-4AD1-A06E-C66A3002EF8D}" dt="2022-08-14T12:19:04.239" v="388"/>
          <ac:graphicFrameMkLst>
            <pc:docMk/>
            <pc:sldMk cId="3205030577" sldId="257"/>
            <ac:graphicFrameMk id="4" creationId="{6BCF7811-8F6C-4D1D-B2B6-DB80CC3D0AA3}"/>
          </ac:graphicFrameMkLst>
        </pc:graphicFrameChg>
        <pc:graphicFrameChg chg="add mod">
          <ac:chgData name="Sameer G Joshi (DJPR)" userId="bd06337d-ce8c-4c34-b1d1-7fbf8f91b6eb" providerId="ADAL" clId="{31291F6F-DCDE-4AD1-A06E-C66A3002EF8D}" dt="2022-08-12T05:57:18.926" v="290" actId="1038"/>
          <ac:graphicFrameMkLst>
            <pc:docMk/>
            <pc:sldMk cId="3205030577" sldId="257"/>
            <ac:graphicFrameMk id="5" creationId="{F907B87D-C7A4-47FB-88D3-010174A7A1B6}"/>
          </ac:graphicFrameMkLst>
        </pc:graphicFrameChg>
        <pc:graphicFrameChg chg="add mod">
          <ac:chgData name="Sameer G Joshi (DJPR)" userId="bd06337d-ce8c-4c34-b1d1-7fbf8f91b6eb" providerId="ADAL" clId="{31291F6F-DCDE-4AD1-A06E-C66A3002EF8D}" dt="2022-08-12T05:57:18.926" v="290" actId="1038"/>
          <ac:graphicFrameMkLst>
            <pc:docMk/>
            <pc:sldMk cId="3205030577" sldId="257"/>
            <ac:graphicFrameMk id="6" creationId="{A890C498-2FE0-48C5-89FA-785C10DFD2E2}"/>
          </ac:graphicFrameMkLst>
        </pc:graphicFrameChg>
      </pc:sldChg>
      <pc:sldChg chg="addSp delSp modSp new mod">
        <pc:chgData name="Sameer G Joshi (DJPR)" userId="bd06337d-ce8c-4c34-b1d1-7fbf8f91b6eb" providerId="ADAL" clId="{31291F6F-DCDE-4AD1-A06E-C66A3002EF8D}" dt="2022-08-17T04:13:48.531" v="1602" actId="1035"/>
        <pc:sldMkLst>
          <pc:docMk/>
          <pc:sldMk cId="557093235" sldId="258"/>
        </pc:sldMkLst>
        <pc:spChg chg="del">
          <ac:chgData name="Sameer G Joshi (DJPR)" userId="bd06337d-ce8c-4c34-b1d1-7fbf8f91b6eb" providerId="ADAL" clId="{31291F6F-DCDE-4AD1-A06E-C66A3002EF8D}" dt="2022-08-14T04:56:41.451" v="349" actId="478"/>
          <ac:spMkLst>
            <pc:docMk/>
            <pc:sldMk cId="557093235" sldId="258"/>
            <ac:spMk id="2" creationId="{C803A065-6EA8-4E49-AF82-F9DD227147AD}"/>
          </ac:spMkLst>
        </pc:spChg>
        <pc:spChg chg="del">
          <ac:chgData name="Sameer G Joshi (DJPR)" userId="bd06337d-ce8c-4c34-b1d1-7fbf8f91b6eb" providerId="ADAL" clId="{31291F6F-DCDE-4AD1-A06E-C66A3002EF8D}" dt="2022-08-14T04:56:41.451" v="349" actId="478"/>
          <ac:spMkLst>
            <pc:docMk/>
            <pc:sldMk cId="557093235" sldId="258"/>
            <ac:spMk id="3" creationId="{AB6DFF58-6082-4457-9E24-FBC4A8E9504D}"/>
          </ac:spMkLst>
        </pc:spChg>
        <pc:spChg chg="add mod">
          <ac:chgData name="Sameer G Joshi (DJPR)" userId="bd06337d-ce8c-4c34-b1d1-7fbf8f91b6eb" providerId="ADAL" clId="{31291F6F-DCDE-4AD1-A06E-C66A3002EF8D}" dt="2022-08-15T03:48:42.875" v="1545" actId="14100"/>
          <ac:spMkLst>
            <pc:docMk/>
            <pc:sldMk cId="557093235" sldId="258"/>
            <ac:spMk id="10" creationId="{104B54DA-2ACF-4D2F-9628-203800804B01}"/>
          </ac:spMkLst>
        </pc:spChg>
        <pc:spChg chg="add mod">
          <ac:chgData name="Sameer G Joshi (DJPR)" userId="bd06337d-ce8c-4c34-b1d1-7fbf8f91b6eb" providerId="ADAL" clId="{31291F6F-DCDE-4AD1-A06E-C66A3002EF8D}" dt="2022-08-15T03:42:13.856" v="1436" actId="1076"/>
          <ac:spMkLst>
            <pc:docMk/>
            <pc:sldMk cId="557093235" sldId="258"/>
            <ac:spMk id="11" creationId="{7E2881C9-791E-43C5-987C-B68E93BDDD2F}"/>
          </ac:spMkLst>
        </pc:spChg>
        <pc:spChg chg="add mod">
          <ac:chgData name="Sameer G Joshi (DJPR)" userId="bd06337d-ce8c-4c34-b1d1-7fbf8f91b6eb" providerId="ADAL" clId="{31291F6F-DCDE-4AD1-A06E-C66A3002EF8D}" dt="2022-08-17T04:13:04.517" v="1579" actId="1036"/>
          <ac:spMkLst>
            <pc:docMk/>
            <pc:sldMk cId="557093235" sldId="258"/>
            <ac:spMk id="15" creationId="{C09FDC9F-8375-4B0E-BF4B-FC0A711EBBF8}"/>
          </ac:spMkLst>
        </pc:spChg>
        <pc:spChg chg="add mod">
          <ac:chgData name="Sameer G Joshi (DJPR)" userId="bd06337d-ce8c-4c34-b1d1-7fbf8f91b6eb" providerId="ADAL" clId="{31291F6F-DCDE-4AD1-A06E-C66A3002EF8D}" dt="2022-08-15T03:42:05.459" v="1435" actId="1076"/>
          <ac:spMkLst>
            <pc:docMk/>
            <pc:sldMk cId="557093235" sldId="258"/>
            <ac:spMk id="16" creationId="{222346BD-5D31-40F9-A7F1-826F9DBAFFAB}"/>
          </ac:spMkLst>
        </pc:spChg>
        <pc:spChg chg="add mod">
          <ac:chgData name="Sameer G Joshi (DJPR)" userId="bd06337d-ce8c-4c34-b1d1-7fbf8f91b6eb" providerId="ADAL" clId="{31291F6F-DCDE-4AD1-A06E-C66A3002EF8D}" dt="2022-08-15T03:42:02.182" v="1434" actId="1076"/>
          <ac:spMkLst>
            <pc:docMk/>
            <pc:sldMk cId="557093235" sldId="258"/>
            <ac:spMk id="17" creationId="{095D69FD-E1B4-45A9-A37E-03F027EAF430}"/>
          </ac:spMkLst>
        </pc:spChg>
        <pc:spChg chg="add mod">
          <ac:chgData name="Sameer G Joshi (DJPR)" userId="bd06337d-ce8c-4c34-b1d1-7fbf8f91b6eb" providerId="ADAL" clId="{31291F6F-DCDE-4AD1-A06E-C66A3002EF8D}" dt="2022-08-14T12:33:48.130" v="569" actId="255"/>
          <ac:spMkLst>
            <pc:docMk/>
            <pc:sldMk cId="557093235" sldId="258"/>
            <ac:spMk id="18" creationId="{BF4A03D7-D376-456F-A710-2CD4D8A4A0F8}"/>
          </ac:spMkLst>
        </pc:spChg>
        <pc:spChg chg="add mod">
          <ac:chgData name="Sameer G Joshi (DJPR)" userId="bd06337d-ce8c-4c34-b1d1-7fbf8f91b6eb" providerId="ADAL" clId="{31291F6F-DCDE-4AD1-A06E-C66A3002EF8D}" dt="2022-08-14T12:34:01.085" v="571" actId="20577"/>
          <ac:spMkLst>
            <pc:docMk/>
            <pc:sldMk cId="557093235" sldId="258"/>
            <ac:spMk id="19" creationId="{4F78C8B9-780C-4860-8FE4-4B89D8BABE42}"/>
          </ac:spMkLst>
        </pc:spChg>
        <pc:spChg chg="add mod">
          <ac:chgData name="Sameer G Joshi (DJPR)" userId="bd06337d-ce8c-4c34-b1d1-7fbf8f91b6eb" providerId="ADAL" clId="{31291F6F-DCDE-4AD1-A06E-C66A3002EF8D}" dt="2022-08-14T12:34:07.683" v="573" actId="20577"/>
          <ac:spMkLst>
            <pc:docMk/>
            <pc:sldMk cId="557093235" sldId="258"/>
            <ac:spMk id="20" creationId="{A38DEE29-6C86-45B2-97B1-16A62AC653EA}"/>
          </ac:spMkLst>
        </pc:spChg>
        <pc:spChg chg="add mod">
          <ac:chgData name="Sameer G Joshi (DJPR)" userId="bd06337d-ce8c-4c34-b1d1-7fbf8f91b6eb" providerId="ADAL" clId="{31291F6F-DCDE-4AD1-A06E-C66A3002EF8D}" dt="2022-08-14T12:45:39.524" v="745" actId="20577"/>
          <ac:spMkLst>
            <pc:docMk/>
            <pc:sldMk cId="557093235" sldId="258"/>
            <ac:spMk id="21" creationId="{A41730E7-FE46-4A25-B3F0-88E33BD9FF30}"/>
          </ac:spMkLst>
        </pc:spChg>
        <pc:spChg chg="add mod">
          <ac:chgData name="Sameer G Joshi (DJPR)" userId="bd06337d-ce8c-4c34-b1d1-7fbf8f91b6eb" providerId="ADAL" clId="{31291F6F-DCDE-4AD1-A06E-C66A3002EF8D}" dt="2022-08-14T12:45:43.471" v="748" actId="20577"/>
          <ac:spMkLst>
            <pc:docMk/>
            <pc:sldMk cId="557093235" sldId="258"/>
            <ac:spMk id="22" creationId="{CA9D736A-6A1A-48A7-B4D8-4DCF85C76412}"/>
          </ac:spMkLst>
        </pc:spChg>
        <pc:spChg chg="add mod">
          <ac:chgData name="Sameer G Joshi (DJPR)" userId="bd06337d-ce8c-4c34-b1d1-7fbf8f91b6eb" providerId="ADAL" clId="{31291F6F-DCDE-4AD1-A06E-C66A3002EF8D}" dt="2022-08-14T12:46:15.652" v="763" actId="20577"/>
          <ac:spMkLst>
            <pc:docMk/>
            <pc:sldMk cId="557093235" sldId="258"/>
            <ac:spMk id="23" creationId="{02DDE154-9CFD-4FEA-B104-84CD64C69E44}"/>
          </ac:spMkLst>
        </pc:spChg>
        <pc:spChg chg="add mod">
          <ac:chgData name="Sameer G Joshi (DJPR)" userId="bd06337d-ce8c-4c34-b1d1-7fbf8f91b6eb" providerId="ADAL" clId="{31291F6F-DCDE-4AD1-A06E-C66A3002EF8D}" dt="2022-08-17T04:13:18.144" v="1593" actId="1036"/>
          <ac:spMkLst>
            <pc:docMk/>
            <pc:sldMk cId="557093235" sldId="258"/>
            <ac:spMk id="24" creationId="{4BB56304-B29F-430E-887B-F4FDFF4F289B}"/>
          </ac:spMkLst>
        </pc:spChg>
        <pc:spChg chg="add del mod">
          <ac:chgData name="Sameer G Joshi (DJPR)" userId="bd06337d-ce8c-4c34-b1d1-7fbf8f91b6eb" providerId="ADAL" clId="{31291F6F-DCDE-4AD1-A06E-C66A3002EF8D}" dt="2022-08-15T01:45:34.442" v="847" actId="478"/>
          <ac:spMkLst>
            <pc:docMk/>
            <pc:sldMk cId="557093235" sldId="258"/>
            <ac:spMk id="24" creationId="{778E7A92-AB8B-4C34-86DB-EAD850CB1419}"/>
          </ac:spMkLst>
        </pc:spChg>
        <pc:spChg chg="add mod">
          <ac:chgData name="Sameer G Joshi (DJPR)" userId="bd06337d-ce8c-4c34-b1d1-7fbf8f91b6eb" providerId="ADAL" clId="{31291F6F-DCDE-4AD1-A06E-C66A3002EF8D}" dt="2022-08-17T04:13:48.531" v="1602" actId="1035"/>
          <ac:spMkLst>
            <pc:docMk/>
            <pc:sldMk cId="557093235" sldId="258"/>
            <ac:spMk id="25" creationId="{11DD4ED1-39FF-4CE3-9494-A467C4CD55C4}"/>
          </ac:spMkLst>
        </pc:spChg>
        <pc:picChg chg="add mod modCrop">
          <ac:chgData name="Sameer G Joshi (DJPR)" userId="bd06337d-ce8c-4c34-b1d1-7fbf8f91b6eb" providerId="ADAL" clId="{31291F6F-DCDE-4AD1-A06E-C66A3002EF8D}" dt="2022-08-15T03:40:30.360" v="1414" actId="14100"/>
          <ac:picMkLst>
            <pc:docMk/>
            <pc:sldMk cId="557093235" sldId="258"/>
            <ac:picMk id="3" creationId="{19CB36F8-1BD7-457F-82E7-EB17E23725CB}"/>
          </ac:picMkLst>
        </pc:picChg>
        <pc:picChg chg="add del mod">
          <ac:chgData name="Sameer G Joshi (DJPR)" userId="bd06337d-ce8c-4c34-b1d1-7fbf8f91b6eb" providerId="ADAL" clId="{31291F6F-DCDE-4AD1-A06E-C66A3002EF8D}" dt="2022-08-14T06:04:50.750" v="366" actId="478"/>
          <ac:picMkLst>
            <pc:docMk/>
            <pc:sldMk cId="557093235" sldId="258"/>
            <ac:picMk id="5" creationId="{2C628C9A-B076-4891-88A6-8A63B7DEFDC0}"/>
          </ac:picMkLst>
        </pc:picChg>
        <pc:picChg chg="add mod modCrop">
          <ac:chgData name="Sameer G Joshi (DJPR)" userId="bd06337d-ce8c-4c34-b1d1-7fbf8f91b6eb" providerId="ADAL" clId="{31291F6F-DCDE-4AD1-A06E-C66A3002EF8D}" dt="2022-08-15T03:40:38.855" v="1417" actId="14100"/>
          <ac:picMkLst>
            <pc:docMk/>
            <pc:sldMk cId="557093235" sldId="258"/>
            <ac:picMk id="5" creationId="{F20A2574-756A-415C-AC36-A9F18674EA5C}"/>
          </ac:picMkLst>
        </pc:picChg>
        <pc:picChg chg="add del mod">
          <ac:chgData name="Sameer G Joshi (DJPR)" userId="bd06337d-ce8c-4c34-b1d1-7fbf8f91b6eb" providerId="ADAL" clId="{31291F6F-DCDE-4AD1-A06E-C66A3002EF8D}" dt="2022-08-14T06:06:47.497" v="381" actId="478"/>
          <ac:picMkLst>
            <pc:docMk/>
            <pc:sldMk cId="557093235" sldId="258"/>
            <ac:picMk id="7" creationId="{400C8CB5-CE80-4386-B395-CD2D2F656E82}"/>
          </ac:picMkLst>
        </pc:picChg>
        <pc:picChg chg="add mod modCrop">
          <ac:chgData name="Sameer G Joshi (DJPR)" userId="bd06337d-ce8c-4c34-b1d1-7fbf8f91b6eb" providerId="ADAL" clId="{31291F6F-DCDE-4AD1-A06E-C66A3002EF8D}" dt="2022-08-15T03:41:56.764" v="1433" actId="1076"/>
          <ac:picMkLst>
            <pc:docMk/>
            <pc:sldMk cId="557093235" sldId="258"/>
            <ac:picMk id="7" creationId="{D347D469-9370-4A90-8676-137927145E1B}"/>
          </ac:picMkLst>
        </pc:picChg>
        <pc:picChg chg="add del mod modCrop">
          <ac:chgData name="Sameer G Joshi (DJPR)" userId="bd06337d-ce8c-4c34-b1d1-7fbf8f91b6eb" providerId="ADAL" clId="{31291F6F-DCDE-4AD1-A06E-C66A3002EF8D}" dt="2022-08-15T03:38:06.728" v="1382" actId="478"/>
          <ac:picMkLst>
            <pc:docMk/>
            <pc:sldMk cId="557093235" sldId="258"/>
            <ac:picMk id="9" creationId="{F46027D5-55D3-44AD-ACBE-140D67E8CE31}"/>
          </ac:picMkLst>
        </pc:picChg>
        <pc:picChg chg="add del mod modCrop">
          <ac:chgData name="Sameer G Joshi (DJPR)" userId="bd06337d-ce8c-4c34-b1d1-7fbf8f91b6eb" providerId="ADAL" clId="{31291F6F-DCDE-4AD1-A06E-C66A3002EF8D}" dt="2022-08-15T03:38:57.974" v="1391" actId="478"/>
          <ac:picMkLst>
            <pc:docMk/>
            <pc:sldMk cId="557093235" sldId="258"/>
            <ac:picMk id="13" creationId="{687F30E4-2189-4900-A0C2-61B1078F09CC}"/>
          </ac:picMkLst>
        </pc:picChg>
        <pc:picChg chg="add del mod modCrop">
          <ac:chgData name="Sameer G Joshi (DJPR)" userId="bd06337d-ce8c-4c34-b1d1-7fbf8f91b6eb" providerId="ADAL" clId="{31291F6F-DCDE-4AD1-A06E-C66A3002EF8D}" dt="2022-08-15T03:40:57.549" v="1418" actId="478"/>
          <ac:picMkLst>
            <pc:docMk/>
            <pc:sldMk cId="557093235" sldId="258"/>
            <ac:picMk id="15" creationId="{0D78644E-FE37-45D3-BE2C-48275694DC08}"/>
          </ac:picMkLst>
        </pc:picChg>
      </pc:sldChg>
      <pc:sldChg chg="del">
        <pc:chgData name="Sameer G Joshi (DJPR)" userId="bd06337d-ce8c-4c34-b1d1-7fbf8f91b6eb" providerId="ADAL" clId="{31291F6F-DCDE-4AD1-A06E-C66A3002EF8D}" dt="2022-08-12T05:29:30.079" v="1" actId="47"/>
        <pc:sldMkLst>
          <pc:docMk/>
          <pc:sldMk cId="2203674866" sldId="258"/>
        </pc:sldMkLst>
      </pc:sldChg>
      <pc:sldChg chg="addSp delSp modSp new mod">
        <pc:chgData name="Sameer G Joshi (DJPR)" userId="bd06337d-ce8c-4c34-b1d1-7fbf8f91b6eb" providerId="ADAL" clId="{31291F6F-DCDE-4AD1-A06E-C66A3002EF8D}" dt="2022-08-17T05:46:26.625" v="1653" actId="20577"/>
        <pc:sldMkLst>
          <pc:docMk/>
          <pc:sldMk cId="1524927946" sldId="259"/>
        </pc:sldMkLst>
        <pc:spChg chg="del">
          <ac:chgData name="Sameer G Joshi (DJPR)" userId="bd06337d-ce8c-4c34-b1d1-7fbf8f91b6eb" providerId="ADAL" clId="{31291F6F-DCDE-4AD1-A06E-C66A3002EF8D}" dt="2022-08-14T12:35:41.865" v="575" actId="478"/>
          <ac:spMkLst>
            <pc:docMk/>
            <pc:sldMk cId="1524927946" sldId="259"/>
            <ac:spMk id="2" creationId="{075FA795-9FCA-4987-8D77-A1BCE1A86AE5}"/>
          </ac:spMkLst>
        </pc:spChg>
        <pc:spChg chg="add mod">
          <ac:chgData name="Sameer G Joshi (DJPR)" userId="bd06337d-ce8c-4c34-b1d1-7fbf8f91b6eb" providerId="ADAL" clId="{31291F6F-DCDE-4AD1-A06E-C66A3002EF8D}" dt="2022-08-17T04:11:58.566" v="1563" actId="1037"/>
          <ac:spMkLst>
            <pc:docMk/>
            <pc:sldMk cId="1524927946" sldId="259"/>
            <ac:spMk id="2" creationId="{A8371189-6095-481B-B1BD-4753FCAAA347}"/>
          </ac:spMkLst>
        </pc:spChg>
        <pc:spChg chg="del">
          <ac:chgData name="Sameer G Joshi (DJPR)" userId="bd06337d-ce8c-4c34-b1d1-7fbf8f91b6eb" providerId="ADAL" clId="{31291F6F-DCDE-4AD1-A06E-C66A3002EF8D}" dt="2022-08-14T12:35:41.865" v="575" actId="478"/>
          <ac:spMkLst>
            <pc:docMk/>
            <pc:sldMk cId="1524927946" sldId="259"/>
            <ac:spMk id="3" creationId="{41AF6DC2-19C8-491D-AA36-F502B7B61CE4}"/>
          </ac:spMkLst>
        </pc:spChg>
        <pc:spChg chg="add mod">
          <ac:chgData name="Sameer G Joshi (DJPR)" userId="bd06337d-ce8c-4c34-b1d1-7fbf8f91b6eb" providerId="ADAL" clId="{31291F6F-DCDE-4AD1-A06E-C66A3002EF8D}" dt="2022-08-15T01:44:44.133" v="844" actId="1035"/>
          <ac:spMkLst>
            <pc:docMk/>
            <pc:sldMk cId="1524927946" sldId="259"/>
            <ac:spMk id="6" creationId="{E0B0C1E0-6FDE-475D-ABA8-3D6EC69EC323}"/>
          </ac:spMkLst>
        </pc:spChg>
        <pc:spChg chg="add mod">
          <ac:chgData name="Sameer G Joshi (DJPR)" userId="bd06337d-ce8c-4c34-b1d1-7fbf8f91b6eb" providerId="ADAL" clId="{31291F6F-DCDE-4AD1-A06E-C66A3002EF8D}" dt="2022-08-15T01:55:47.316" v="1376" actId="1036"/>
          <ac:spMkLst>
            <pc:docMk/>
            <pc:sldMk cId="1524927946" sldId="259"/>
            <ac:spMk id="11" creationId="{7E21F5E0-D655-4B7E-BEBF-44228D0C3F80}"/>
          </ac:spMkLst>
        </pc:spChg>
        <pc:spChg chg="add mod">
          <ac:chgData name="Sameer G Joshi (DJPR)" userId="bd06337d-ce8c-4c34-b1d1-7fbf8f91b6eb" providerId="ADAL" clId="{31291F6F-DCDE-4AD1-A06E-C66A3002EF8D}" dt="2022-08-15T01:52:28.160" v="1261" actId="1035"/>
          <ac:spMkLst>
            <pc:docMk/>
            <pc:sldMk cId="1524927946" sldId="259"/>
            <ac:spMk id="12" creationId="{B7A90DAA-B5C7-4482-B49E-A18875F99856}"/>
          </ac:spMkLst>
        </pc:spChg>
        <pc:spChg chg="add mod">
          <ac:chgData name="Sameer G Joshi (DJPR)" userId="bd06337d-ce8c-4c34-b1d1-7fbf8f91b6eb" providerId="ADAL" clId="{31291F6F-DCDE-4AD1-A06E-C66A3002EF8D}" dt="2022-08-15T01:52:28.160" v="1261" actId="1035"/>
          <ac:spMkLst>
            <pc:docMk/>
            <pc:sldMk cId="1524927946" sldId="259"/>
            <ac:spMk id="13" creationId="{811402F5-C89C-4BAF-8A75-3E0ADADC6EA1}"/>
          </ac:spMkLst>
        </pc:spChg>
        <pc:spChg chg="add mod">
          <ac:chgData name="Sameer G Joshi (DJPR)" userId="bd06337d-ce8c-4c34-b1d1-7fbf8f91b6eb" providerId="ADAL" clId="{31291F6F-DCDE-4AD1-A06E-C66A3002EF8D}" dt="2022-08-15T01:55:41.939" v="1369" actId="1035"/>
          <ac:spMkLst>
            <pc:docMk/>
            <pc:sldMk cId="1524927946" sldId="259"/>
            <ac:spMk id="14" creationId="{EDCDE73B-68F3-4A6B-831F-FA548F8450D1}"/>
          </ac:spMkLst>
        </pc:spChg>
        <pc:spChg chg="add mod">
          <ac:chgData name="Sameer G Joshi (DJPR)" userId="bd06337d-ce8c-4c34-b1d1-7fbf8f91b6eb" providerId="ADAL" clId="{31291F6F-DCDE-4AD1-A06E-C66A3002EF8D}" dt="2022-08-15T01:55:54.425" v="1381" actId="1035"/>
          <ac:spMkLst>
            <pc:docMk/>
            <pc:sldMk cId="1524927946" sldId="259"/>
            <ac:spMk id="15" creationId="{2A11BAFA-50ED-44BD-A06C-59A363CBC906}"/>
          </ac:spMkLst>
        </pc:spChg>
        <pc:spChg chg="add mod">
          <ac:chgData name="Sameer G Joshi (DJPR)" userId="bd06337d-ce8c-4c34-b1d1-7fbf8f91b6eb" providerId="ADAL" clId="{31291F6F-DCDE-4AD1-A06E-C66A3002EF8D}" dt="2022-08-15T01:52:28.160" v="1261" actId="1035"/>
          <ac:spMkLst>
            <pc:docMk/>
            <pc:sldMk cId="1524927946" sldId="259"/>
            <ac:spMk id="16" creationId="{700F26B8-2ACC-4351-A8E9-5FEA32FE078F}"/>
          </ac:spMkLst>
        </pc:spChg>
        <pc:spChg chg="add mod">
          <ac:chgData name="Sameer G Joshi (DJPR)" userId="bd06337d-ce8c-4c34-b1d1-7fbf8f91b6eb" providerId="ADAL" clId="{31291F6F-DCDE-4AD1-A06E-C66A3002EF8D}" dt="2022-08-15T01:55:41.939" v="1369" actId="1035"/>
          <ac:spMkLst>
            <pc:docMk/>
            <pc:sldMk cId="1524927946" sldId="259"/>
            <ac:spMk id="17" creationId="{6A90DE88-D929-4115-BDAC-3ED9DC855F03}"/>
          </ac:spMkLst>
        </pc:spChg>
        <pc:spChg chg="add mod">
          <ac:chgData name="Sameer G Joshi (DJPR)" userId="bd06337d-ce8c-4c34-b1d1-7fbf8f91b6eb" providerId="ADAL" clId="{31291F6F-DCDE-4AD1-A06E-C66A3002EF8D}" dt="2022-08-15T01:55:54.425" v="1381" actId="1035"/>
          <ac:spMkLst>
            <pc:docMk/>
            <pc:sldMk cId="1524927946" sldId="259"/>
            <ac:spMk id="18" creationId="{68F846AF-AB5E-4C56-8848-DE725446639C}"/>
          </ac:spMkLst>
        </pc:spChg>
        <pc:spChg chg="add mod">
          <ac:chgData name="Sameer G Joshi (DJPR)" userId="bd06337d-ce8c-4c34-b1d1-7fbf8f91b6eb" providerId="ADAL" clId="{31291F6F-DCDE-4AD1-A06E-C66A3002EF8D}" dt="2022-08-15T01:52:28.160" v="1261" actId="1035"/>
          <ac:spMkLst>
            <pc:docMk/>
            <pc:sldMk cId="1524927946" sldId="259"/>
            <ac:spMk id="19" creationId="{BBD539D0-4F64-4068-A46C-06BCF9F906C9}"/>
          </ac:spMkLst>
        </pc:spChg>
        <pc:spChg chg="add mod">
          <ac:chgData name="Sameer G Joshi (DJPR)" userId="bd06337d-ce8c-4c34-b1d1-7fbf8f91b6eb" providerId="ADAL" clId="{31291F6F-DCDE-4AD1-A06E-C66A3002EF8D}" dt="2022-08-17T05:46:26.625" v="1653" actId="20577"/>
          <ac:spMkLst>
            <pc:docMk/>
            <pc:sldMk cId="1524927946" sldId="259"/>
            <ac:spMk id="20" creationId="{851780F3-DCAF-460C-914D-B75533DCD51A}"/>
          </ac:spMkLst>
        </pc:spChg>
        <pc:spChg chg="add mod">
          <ac:chgData name="Sameer G Joshi (DJPR)" userId="bd06337d-ce8c-4c34-b1d1-7fbf8f91b6eb" providerId="ADAL" clId="{31291F6F-DCDE-4AD1-A06E-C66A3002EF8D}" dt="2022-08-17T04:14:27.727" v="1615" actId="1035"/>
          <ac:spMkLst>
            <pc:docMk/>
            <pc:sldMk cId="1524927946" sldId="259"/>
            <ac:spMk id="22" creationId="{0785FD63-81C2-46FD-8CD8-2E8D880C126A}"/>
          </ac:spMkLst>
        </pc:spChg>
        <pc:spChg chg="add mod">
          <ac:chgData name="Sameer G Joshi (DJPR)" userId="bd06337d-ce8c-4c34-b1d1-7fbf8f91b6eb" providerId="ADAL" clId="{31291F6F-DCDE-4AD1-A06E-C66A3002EF8D}" dt="2022-08-17T04:15:02.516" v="1648" actId="1037"/>
          <ac:spMkLst>
            <pc:docMk/>
            <pc:sldMk cId="1524927946" sldId="259"/>
            <ac:spMk id="23" creationId="{A6E4C43E-EE2F-4C81-8F04-29380981D8C4}"/>
          </ac:spMkLst>
        </pc:spChg>
        <pc:picChg chg="add mod modCrop">
          <ac:chgData name="Sameer G Joshi (DJPR)" userId="bd06337d-ce8c-4c34-b1d1-7fbf8f91b6eb" providerId="ADAL" clId="{31291F6F-DCDE-4AD1-A06E-C66A3002EF8D}" dt="2022-08-15T03:45:44.066" v="1453"/>
          <ac:picMkLst>
            <pc:docMk/>
            <pc:sldMk cId="1524927946" sldId="259"/>
            <ac:picMk id="3" creationId="{D7B41613-4B41-4B09-88CC-92F44D9368A2}"/>
          </ac:picMkLst>
        </pc:picChg>
        <pc:picChg chg="add del mod modCrop">
          <ac:chgData name="Sameer G Joshi (DJPR)" userId="bd06337d-ce8c-4c34-b1d1-7fbf8f91b6eb" providerId="ADAL" clId="{31291F6F-DCDE-4AD1-A06E-C66A3002EF8D}" dt="2022-08-15T03:44:34.749" v="1437" actId="478"/>
          <ac:picMkLst>
            <pc:docMk/>
            <pc:sldMk cId="1524927946" sldId="259"/>
            <ac:picMk id="5" creationId="{00FA5ECB-9A6A-4006-B94D-83B260D473FE}"/>
          </ac:picMkLst>
        </pc:picChg>
        <pc:picChg chg="add mod modCrop">
          <ac:chgData name="Sameer G Joshi (DJPR)" userId="bd06337d-ce8c-4c34-b1d1-7fbf8f91b6eb" providerId="ADAL" clId="{31291F6F-DCDE-4AD1-A06E-C66A3002EF8D}" dt="2022-08-15T03:46:36.779" v="1469" actId="1076"/>
          <ac:picMkLst>
            <pc:docMk/>
            <pc:sldMk cId="1524927946" sldId="259"/>
            <ac:picMk id="7" creationId="{1624CCFB-4DAE-4D3C-B38D-0FB4842573DC}"/>
          </ac:picMkLst>
        </pc:picChg>
        <pc:picChg chg="add del mod modCrop">
          <ac:chgData name="Sameer G Joshi (DJPR)" userId="bd06337d-ce8c-4c34-b1d1-7fbf8f91b6eb" providerId="ADAL" clId="{31291F6F-DCDE-4AD1-A06E-C66A3002EF8D}" dt="2022-08-15T03:45:49.683" v="1454" actId="478"/>
          <ac:picMkLst>
            <pc:docMk/>
            <pc:sldMk cId="1524927946" sldId="259"/>
            <ac:picMk id="8" creationId="{58ECB9F2-85A9-4EAF-A14E-888B4DE83D0B}"/>
          </ac:picMkLst>
        </pc:picChg>
        <pc:picChg chg="add del mod modCrop">
          <ac:chgData name="Sameer G Joshi (DJPR)" userId="bd06337d-ce8c-4c34-b1d1-7fbf8f91b6eb" providerId="ADAL" clId="{31291F6F-DCDE-4AD1-A06E-C66A3002EF8D}" dt="2022-08-15T03:46:39.315" v="1470" actId="478"/>
          <ac:picMkLst>
            <pc:docMk/>
            <pc:sldMk cId="1524927946" sldId="259"/>
            <ac:picMk id="10" creationId="{55899A51-80A1-47AD-83C9-F77567898C12}"/>
          </ac:picMkLst>
        </pc:picChg>
        <pc:picChg chg="add mod modCrop">
          <ac:chgData name="Sameer G Joshi (DJPR)" userId="bd06337d-ce8c-4c34-b1d1-7fbf8f91b6eb" providerId="ADAL" clId="{31291F6F-DCDE-4AD1-A06E-C66A3002EF8D}" dt="2022-08-15T03:47:39.958" v="1490" actId="1076"/>
          <ac:picMkLst>
            <pc:docMk/>
            <pc:sldMk cId="1524927946" sldId="259"/>
            <ac:picMk id="21" creationId="{62958B15-C3C3-4A03-ABBF-4F3E71E48418}"/>
          </ac:picMkLst>
        </pc:picChg>
      </pc:sldChg>
      <pc:sldChg chg="addSp delSp modSp new mod">
        <pc:chgData name="Sameer G Joshi (DJPR)" userId="bd06337d-ce8c-4c34-b1d1-7fbf8f91b6eb" providerId="ADAL" clId="{31291F6F-DCDE-4AD1-A06E-C66A3002EF8D}" dt="2022-08-17T05:47:57.701" v="1669" actId="113"/>
        <pc:sldMkLst>
          <pc:docMk/>
          <pc:sldMk cId="233930628" sldId="260"/>
        </pc:sldMkLst>
        <pc:spChg chg="del">
          <ac:chgData name="Sameer G Joshi (DJPR)" userId="bd06337d-ce8c-4c34-b1d1-7fbf8f91b6eb" providerId="ADAL" clId="{31291F6F-DCDE-4AD1-A06E-C66A3002EF8D}" dt="2022-08-17T05:46:04.862" v="1650" actId="478"/>
          <ac:spMkLst>
            <pc:docMk/>
            <pc:sldMk cId="233930628" sldId="260"/>
            <ac:spMk id="2" creationId="{6DD48ABC-F2A4-411B-B124-22782F33A310}"/>
          </ac:spMkLst>
        </pc:spChg>
        <pc:spChg chg="del">
          <ac:chgData name="Sameer G Joshi (DJPR)" userId="bd06337d-ce8c-4c34-b1d1-7fbf8f91b6eb" providerId="ADAL" clId="{31291F6F-DCDE-4AD1-A06E-C66A3002EF8D}" dt="2022-08-17T05:46:04.862" v="1650" actId="478"/>
          <ac:spMkLst>
            <pc:docMk/>
            <pc:sldMk cId="233930628" sldId="260"/>
            <ac:spMk id="3" creationId="{5F6C3D2D-623B-4E8C-9DD1-614601189366}"/>
          </ac:spMkLst>
        </pc:spChg>
        <pc:spChg chg="add mod">
          <ac:chgData name="Sameer G Joshi (DJPR)" userId="bd06337d-ce8c-4c34-b1d1-7fbf8f91b6eb" providerId="ADAL" clId="{31291F6F-DCDE-4AD1-A06E-C66A3002EF8D}" dt="2022-08-17T05:47:57.701" v="1669" actId="113"/>
          <ac:spMkLst>
            <pc:docMk/>
            <pc:sldMk cId="233930628" sldId="260"/>
            <ac:spMk id="6" creationId="{8DCDC6EC-6E71-4C6F-BD73-6B62F915E554}"/>
          </ac:spMkLst>
        </pc:spChg>
        <pc:spChg chg="add mod">
          <ac:chgData name="Sameer G Joshi (DJPR)" userId="bd06337d-ce8c-4c34-b1d1-7fbf8f91b6eb" providerId="ADAL" clId="{31291F6F-DCDE-4AD1-A06E-C66A3002EF8D}" dt="2022-08-17T05:46:17.004" v="1651"/>
          <ac:spMkLst>
            <pc:docMk/>
            <pc:sldMk cId="233930628" sldId="260"/>
            <ac:spMk id="7" creationId="{FEC7E80B-2463-40E3-A660-48C107A19F58}"/>
          </ac:spMkLst>
        </pc:spChg>
        <pc:spChg chg="add mod">
          <ac:chgData name="Sameer G Joshi (DJPR)" userId="bd06337d-ce8c-4c34-b1d1-7fbf8f91b6eb" providerId="ADAL" clId="{31291F6F-DCDE-4AD1-A06E-C66A3002EF8D}" dt="2022-08-17T05:46:17.004" v="1651"/>
          <ac:spMkLst>
            <pc:docMk/>
            <pc:sldMk cId="233930628" sldId="260"/>
            <ac:spMk id="8" creationId="{709122D4-5954-4374-8F5E-8D03A12CC6F3}"/>
          </ac:spMkLst>
        </pc:spChg>
        <pc:picChg chg="add mod">
          <ac:chgData name="Sameer G Joshi (DJPR)" userId="bd06337d-ce8c-4c34-b1d1-7fbf8f91b6eb" providerId="ADAL" clId="{31291F6F-DCDE-4AD1-A06E-C66A3002EF8D}" dt="2022-08-17T05:46:17.004" v="1651"/>
          <ac:picMkLst>
            <pc:docMk/>
            <pc:sldMk cId="233930628" sldId="260"/>
            <ac:picMk id="4" creationId="{1EFA5835-E534-4D42-A7CB-56F3929F60DC}"/>
          </ac:picMkLst>
        </pc:picChg>
        <pc:picChg chg="add mod">
          <ac:chgData name="Sameer G Joshi (DJPR)" userId="bd06337d-ce8c-4c34-b1d1-7fbf8f91b6eb" providerId="ADAL" clId="{31291F6F-DCDE-4AD1-A06E-C66A3002EF8D}" dt="2022-08-17T05:46:17.004" v="1651"/>
          <ac:picMkLst>
            <pc:docMk/>
            <pc:sldMk cId="233930628" sldId="260"/>
            <ac:picMk id="5" creationId="{618E246C-3142-4EEA-A3C9-AAAC2D555660}"/>
          </ac:picMkLst>
        </pc:picChg>
      </pc:sldChg>
      <pc:sldChg chg="del">
        <pc:chgData name="Sameer G Joshi (DJPR)" userId="bd06337d-ce8c-4c34-b1d1-7fbf8f91b6eb" providerId="ADAL" clId="{31291F6F-DCDE-4AD1-A06E-C66A3002EF8D}" dt="2022-08-12T05:29:30.079" v="1" actId="47"/>
        <pc:sldMkLst>
          <pc:docMk/>
          <pc:sldMk cId="2000004557" sldId="260"/>
        </pc:sldMkLst>
      </pc:sldChg>
      <pc:sldChg chg="del">
        <pc:chgData name="Sameer G Joshi (DJPR)" userId="bd06337d-ce8c-4c34-b1d1-7fbf8f91b6eb" providerId="ADAL" clId="{31291F6F-DCDE-4AD1-A06E-C66A3002EF8D}" dt="2022-08-12T05:29:30.079" v="1" actId="47"/>
        <pc:sldMkLst>
          <pc:docMk/>
          <pc:sldMk cId="3894103260" sldId="261"/>
        </pc:sldMkLst>
      </pc:sldChg>
      <pc:sldChg chg="del">
        <pc:chgData name="Sameer G Joshi (DJPR)" userId="bd06337d-ce8c-4c34-b1d1-7fbf8f91b6eb" providerId="ADAL" clId="{31291F6F-DCDE-4AD1-A06E-C66A3002EF8D}" dt="2022-08-12T05:29:30.079" v="1" actId="47"/>
        <pc:sldMkLst>
          <pc:docMk/>
          <pc:sldMk cId="583791291" sldId="265"/>
        </pc:sldMkLst>
      </pc:sldChg>
      <pc:sldChg chg="del">
        <pc:chgData name="Sameer G Joshi (DJPR)" userId="bd06337d-ce8c-4c34-b1d1-7fbf8f91b6eb" providerId="ADAL" clId="{31291F6F-DCDE-4AD1-A06E-C66A3002EF8D}" dt="2022-08-12T05:29:30.079" v="1" actId="47"/>
        <pc:sldMkLst>
          <pc:docMk/>
          <pc:sldMk cId="3253327431" sldId="266"/>
        </pc:sldMkLst>
      </pc:sldChg>
      <pc:sldChg chg="del">
        <pc:chgData name="Sameer G Joshi (DJPR)" userId="bd06337d-ce8c-4c34-b1d1-7fbf8f91b6eb" providerId="ADAL" clId="{31291F6F-DCDE-4AD1-A06E-C66A3002EF8D}" dt="2022-08-12T05:29:30.079" v="1" actId="47"/>
        <pc:sldMkLst>
          <pc:docMk/>
          <pc:sldMk cId="1068351154" sldId="267"/>
        </pc:sldMkLst>
      </pc:sldChg>
      <pc:sldChg chg="del">
        <pc:chgData name="Sameer G Joshi (DJPR)" userId="bd06337d-ce8c-4c34-b1d1-7fbf8f91b6eb" providerId="ADAL" clId="{31291F6F-DCDE-4AD1-A06E-C66A3002EF8D}" dt="2022-08-12T05:29:30.079" v="1" actId="47"/>
        <pc:sldMkLst>
          <pc:docMk/>
          <pc:sldMk cId="2979161283" sldId="268"/>
        </pc:sldMkLst>
      </pc:sldChg>
      <pc:sldChg chg="del">
        <pc:chgData name="Sameer G Joshi (DJPR)" userId="bd06337d-ce8c-4c34-b1d1-7fbf8f91b6eb" providerId="ADAL" clId="{31291F6F-DCDE-4AD1-A06E-C66A3002EF8D}" dt="2022-08-12T05:29:30.079" v="1" actId="47"/>
        <pc:sldMkLst>
          <pc:docMk/>
          <pc:sldMk cId="2824909811" sldId="269"/>
        </pc:sldMkLst>
      </pc:sldChg>
      <pc:sldChg chg="del">
        <pc:chgData name="Sameer G Joshi (DJPR)" userId="bd06337d-ce8c-4c34-b1d1-7fbf8f91b6eb" providerId="ADAL" clId="{31291F6F-DCDE-4AD1-A06E-C66A3002EF8D}" dt="2022-08-12T05:29:30.079" v="1" actId="47"/>
        <pc:sldMkLst>
          <pc:docMk/>
          <pc:sldMk cId="431396935" sldId="270"/>
        </pc:sldMkLst>
      </pc:sldChg>
    </pc:docChg>
  </pc:docChgLst>
  <pc:docChgLst>
    <pc:chgData name="Sameer G Joshi (DJPR)" userId="bd06337d-ce8c-4c34-b1d1-7fbf8f91b6eb" providerId="ADAL" clId="{3E4D07CD-E88C-43B0-96B0-3692FC3887B3}"/>
    <pc:docChg chg="undo custSel modSld">
      <pc:chgData name="Sameer G Joshi (DJPR)" userId="bd06337d-ce8c-4c34-b1d1-7fbf8f91b6eb" providerId="ADAL" clId="{3E4D07CD-E88C-43B0-96B0-3692FC3887B3}" dt="2021-11-26T05:14:09.362" v="74" actId="114"/>
      <pc:docMkLst>
        <pc:docMk/>
      </pc:docMkLst>
      <pc:sldChg chg="modSp">
        <pc:chgData name="Sameer G Joshi (DJPR)" userId="bd06337d-ce8c-4c34-b1d1-7fbf8f91b6eb" providerId="ADAL" clId="{3E4D07CD-E88C-43B0-96B0-3692FC3887B3}" dt="2021-11-26T05:14:09.362" v="74" actId="114"/>
        <pc:sldMkLst>
          <pc:docMk/>
          <pc:sldMk cId="2203674866" sldId="258"/>
        </pc:sldMkLst>
        <pc:graphicFrameChg chg="mod">
          <ac:chgData name="Sameer G Joshi (DJPR)" userId="bd06337d-ce8c-4c34-b1d1-7fbf8f91b6eb" providerId="ADAL" clId="{3E4D07CD-E88C-43B0-96B0-3692FC3887B3}" dt="2021-11-26T05:14:09.362" v="74" actId="114"/>
          <ac:graphicFrameMkLst>
            <pc:docMk/>
            <pc:sldMk cId="2203674866" sldId="258"/>
            <ac:graphicFrameMk id="4" creationId="{420D9C9C-6635-4308-B32A-F1C1403CACCA}"/>
          </ac:graphicFrameMkLst>
        </pc:graphicFrameChg>
      </pc:sldChg>
      <pc:sldChg chg="addSp delSp modSp mod">
        <pc:chgData name="Sameer G Joshi (DJPR)" userId="bd06337d-ce8c-4c34-b1d1-7fbf8f91b6eb" providerId="ADAL" clId="{3E4D07CD-E88C-43B0-96B0-3692FC3887B3}" dt="2021-11-26T04:33:53.092" v="73" actId="20577"/>
        <pc:sldMkLst>
          <pc:docMk/>
          <pc:sldMk cId="2000004557" sldId="260"/>
        </pc:sldMkLst>
        <pc:spChg chg="del mod">
          <ac:chgData name="Sameer G Joshi (DJPR)" userId="bd06337d-ce8c-4c34-b1d1-7fbf8f91b6eb" providerId="ADAL" clId="{3E4D07CD-E88C-43B0-96B0-3692FC3887B3}" dt="2021-11-26T04:31:19.582" v="17" actId="478"/>
          <ac:spMkLst>
            <pc:docMk/>
            <pc:sldMk cId="2000004557" sldId="260"/>
            <ac:spMk id="10" creationId="{59C0504E-C7AF-4D43-8383-ED0A5BC07BE9}"/>
          </ac:spMkLst>
        </pc:spChg>
        <pc:spChg chg="mod">
          <ac:chgData name="Sameer G Joshi (DJPR)" userId="bd06337d-ce8c-4c34-b1d1-7fbf8f91b6eb" providerId="ADAL" clId="{3E4D07CD-E88C-43B0-96B0-3692FC3887B3}" dt="2021-11-26T04:33:53.092" v="73" actId="20577"/>
          <ac:spMkLst>
            <pc:docMk/>
            <pc:sldMk cId="2000004557" sldId="260"/>
            <ac:spMk id="11" creationId="{B85949FD-1409-4C16-86E6-61191A01DC54}"/>
          </ac:spMkLst>
        </pc:spChg>
        <pc:spChg chg="add mod">
          <ac:chgData name="Sameer G Joshi (DJPR)" userId="bd06337d-ce8c-4c34-b1d1-7fbf8f91b6eb" providerId="ADAL" clId="{3E4D07CD-E88C-43B0-96B0-3692FC3887B3}" dt="2021-11-26T04:33:39.444" v="62" actId="20577"/>
          <ac:spMkLst>
            <pc:docMk/>
            <pc:sldMk cId="2000004557" sldId="260"/>
            <ac:spMk id="12" creationId="{C2FE5A7F-05CE-4198-9DB5-083D731C7875}"/>
          </ac:spMkLst>
        </pc:spChg>
        <pc:graphicFrameChg chg="mod">
          <ac:chgData name="Sameer G Joshi (DJPR)" userId="bd06337d-ce8c-4c34-b1d1-7fbf8f91b6eb" providerId="ADAL" clId="{3E4D07CD-E88C-43B0-96B0-3692FC3887B3}" dt="2021-11-26T04:32:24.415" v="32" actId="1037"/>
          <ac:graphicFrameMkLst>
            <pc:docMk/>
            <pc:sldMk cId="2000004557" sldId="260"/>
            <ac:graphicFrameMk id="4" creationId="{7F2C73C6-B831-4FAE-935A-F943A81563E3}"/>
          </ac:graphicFrameMkLst>
        </pc:graphicFrameChg>
      </pc:sldChg>
      <pc:sldChg chg="modSp mod">
        <pc:chgData name="Sameer G Joshi (DJPR)" userId="bd06337d-ce8c-4c34-b1d1-7fbf8f91b6eb" providerId="ADAL" clId="{3E4D07CD-E88C-43B0-96B0-3692FC3887B3}" dt="2021-11-26T04:33:22.590" v="51" actId="6549"/>
        <pc:sldMkLst>
          <pc:docMk/>
          <pc:sldMk cId="3894103260" sldId="261"/>
        </pc:sldMkLst>
        <pc:spChg chg="mod">
          <ac:chgData name="Sameer G Joshi (DJPR)" userId="bd06337d-ce8c-4c34-b1d1-7fbf8f91b6eb" providerId="ADAL" clId="{3E4D07CD-E88C-43B0-96B0-3692FC3887B3}" dt="2021-11-26T04:33:22.590" v="51" actId="6549"/>
          <ac:spMkLst>
            <pc:docMk/>
            <pc:sldMk cId="3894103260" sldId="261"/>
            <ac:spMk id="16" creationId="{90125D82-0349-4F5F-B634-E6EA15E91039}"/>
          </ac:spMkLst>
        </pc:spChg>
      </pc:sldChg>
    </pc:docChg>
  </pc:docChgLst>
  <pc:docChgLst>
    <pc:chgData name="Sameer G Joshi (DJPR)" userId="bd06337d-ce8c-4c34-b1d1-7fbf8f91b6eb" providerId="ADAL" clId="{C8DFC56E-394E-4B2C-A990-7682C40B4206}"/>
    <pc:docChg chg="undo custSel modSld">
      <pc:chgData name="Sameer G Joshi (DJPR)" userId="bd06337d-ce8c-4c34-b1d1-7fbf8f91b6eb" providerId="ADAL" clId="{C8DFC56E-394E-4B2C-A990-7682C40B4206}" dt="2021-10-08T05:57:31.451" v="52" actId="14100"/>
      <pc:docMkLst>
        <pc:docMk/>
      </pc:docMkLst>
      <pc:sldChg chg="modSp mod">
        <pc:chgData name="Sameer G Joshi (DJPR)" userId="bd06337d-ce8c-4c34-b1d1-7fbf8f91b6eb" providerId="ADAL" clId="{C8DFC56E-394E-4B2C-A990-7682C40B4206}" dt="2021-10-08T05:57:31.451" v="52" actId="14100"/>
        <pc:sldMkLst>
          <pc:docMk/>
          <pc:sldMk cId="2203674866" sldId="258"/>
        </pc:sldMkLst>
        <pc:spChg chg="mod">
          <ac:chgData name="Sameer G Joshi (DJPR)" userId="bd06337d-ce8c-4c34-b1d1-7fbf8f91b6eb" providerId="ADAL" clId="{C8DFC56E-394E-4B2C-A990-7682C40B4206}" dt="2021-10-06T22:52:04.614" v="42" actId="1036"/>
          <ac:spMkLst>
            <pc:docMk/>
            <pc:sldMk cId="2203674866" sldId="258"/>
            <ac:spMk id="5" creationId="{C1C7D342-C5AF-4282-A34C-A99726B755CD}"/>
          </ac:spMkLst>
        </pc:spChg>
        <pc:spChg chg="mod">
          <ac:chgData name="Sameer G Joshi (DJPR)" userId="bd06337d-ce8c-4c34-b1d1-7fbf8f91b6eb" providerId="ADAL" clId="{C8DFC56E-394E-4B2C-A990-7682C40B4206}" dt="2021-10-06T22:52:04.614" v="42" actId="1036"/>
          <ac:spMkLst>
            <pc:docMk/>
            <pc:sldMk cId="2203674866" sldId="258"/>
            <ac:spMk id="11" creationId="{F47A1C11-6121-479E-999B-743F8B3B0102}"/>
          </ac:spMkLst>
        </pc:spChg>
        <pc:spChg chg="mod">
          <ac:chgData name="Sameer G Joshi (DJPR)" userId="bd06337d-ce8c-4c34-b1d1-7fbf8f91b6eb" providerId="ADAL" clId="{C8DFC56E-394E-4B2C-A990-7682C40B4206}" dt="2021-10-06T22:52:33.113" v="43" actId="14100"/>
          <ac:spMkLst>
            <pc:docMk/>
            <pc:sldMk cId="2203674866" sldId="258"/>
            <ac:spMk id="12" creationId="{39B48064-32AF-488B-A4AC-5E955AE5DC19}"/>
          </ac:spMkLst>
        </pc:spChg>
        <pc:spChg chg="mod">
          <ac:chgData name="Sameer G Joshi (DJPR)" userId="bd06337d-ce8c-4c34-b1d1-7fbf8f91b6eb" providerId="ADAL" clId="{C8DFC56E-394E-4B2C-A990-7682C40B4206}" dt="2021-10-06T22:52:04.614" v="42" actId="1036"/>
          <ac:spMkLst>
            <pc:docMk/>
            <pc:sldMk cId="2203674866" sldId="258"/>
            <ac:spMk id="13" creationId="{166DCA8E-895F-42C9-8D34-A942C93FDA3E}"/>
          </ac:spMkLst>
        </pc:spChg>
        <pc:spChg chg="mod">
          <ac:chgData name="Sameer G Joshi (DJPR)" userId="bd06337d-ce8c-4c34-b1d1-7fbf8f91b6eb" providerId="ADAL" clId="{C8DFC56E-394E-4B2C-A990-7682C40B4206}" dt="2021-10-08T05:57:31.451" v="52" actId="14100"/>
          <ac:spMkLst>
            <pc:docMk/>
            <pc:sldMk cId="2203674866" sldId="258"/>
            <ac:spMk id="14" creationId="{1A4BC8A9-00C7-4001-9DA9-3C8D33C7C327}"/>
          </ac:spMkLst>
        </pc:spChg>
        <pc:spChg chg="mod">
          <ac:chgData name="Sameer G Joshi (DJPR)" userId="bd06337d-ce8c-4c34-b1d1-7fbf8f91b6eb" providerId="ADAL" clId="{C8DFC56E-394E-4B2C-A990-7682C40B4206}" dt="2021-10-06T22:52:04.614" v="42" actId="1036"/>
          <ac:spMkLst>
            <pc:docMk/>
            <pc:sldMk cId="2203674866" sldId="258"/>
            <ac:spMk id="17" creationId="{C87AED42-E587-4B6F-8ABA-76C8FE76E503}"/>
          </ac:spMkLst>
        </pc:spChg>
        <pc:spChg chg="mod">
          <ac:chgData name="Sameer G Joshi (DJPR)" userId="bd06337d-ce8c-4c34-b1d1-7fbf8f91b6eb" providerId="ADAL" clId="{C8DFC56E-394E-4B2C-A990-7682C40B4206}" dt="2021-10-06T22:52:04.614" v="42" actId="1036"/>
          <ac:spMkLst>
            <pc:docMk/>
            <pc:sldMk cId="2203674866" sldId="258"/>
            <ac:spMk id="19" creationId="{106A8FBD-909B-4774-B43F-1FC484A71BE3}"/>
          </ac:spMkLst>
        </pc:spChg>
        <pc:graphicFrameChg chg="mod">
          <ac:chgData name="Sameer G Joshi (DJPR)" userId="bd06337d-ce8c-4c34-b1d1-7fbf8f91b6eb" providerId="ADAL" clId="{C8DFC56E-394E-4B2C-A990-7682C40B4206}" dt="2021-10-06T22:53:58.441" v="51" actId="14100"/>
          <ac:graphicFrameMkLst>
            <pc:docMk/>
            <pc:sldMk cId="2203674866" sldId="258"/>
            <ac:graphicFrameMk id="4" creationId="{420D9C9C-6635-4308-B32A-F1C1403CACCA}"/>
          </ac:graphicFrameMkLst>
        </pc:graphicFrameChg>
        <pc:picChg chg="mod">
          <ac:chgData name="Sameer G Joshi (DJPR)" userId="bd06337d-ce8c-4c34-b1d1-7fbf8f91b6eb" providerId="ADAL" clId="{C8DFC56E-394E-4B2C-A990-7682C40B4206}" dt="2021-10-06T22:52:04.614" v="42" actId="1036"/>
          <ac:picMkLst>
            <pc:docMk/>
            <pc:sldMk cId="2203674866" sldId="258"/>
            <ac:picMk id="10" creationId="{981463CE-92E3-455D-B01F-2BD9BBE3F108}"/>
          </ac:picMkLst>
        </pc:picChg>
      </pc:sldChg>
    </pc:docChg>
  </pc:docChgLst>
  <pc:docChgLst>
    <pc:chgData name="Sameer G Joshi (DJPR)" userId="bd06337d-ce8c-4c34-b1d1-7fbf8f91b6eb" providerId="ADAL" clId="{D21F9A12-E0C3-4C74-B558-F81C246AECD6}"/>
    <pc:docChg chg="modSld">
      <pc:chgData name="Sameer G Joshi (DJPR)" userId="bd06337d-ce8c-4c34-b1d1-7fbf8f91b6eb" providerId="ADAL" clId="{D21F9A12-E0C3-4C74-B558-F81C246AECD6}" dt="2021-09-10T06:07:09.302" v="1" actId="20577"/>
      <pc:docMkLst>
        <pc:docMk/>
      </pc:docMkLst>
      <pc:sldChg chg="modSp mod">
        <pc:chgData name="Sameer G Joshi (DJPR)" userId="bd06337d-ce8c-4c34-b1d1-7fbf8f91b6eb" providerId="ADAL" clId="{D21F9A12-E0C3-4C74-B558-F81C246AECD6}" dt="2021-09-10T06:07:09.302" v="1" actId="20577"/>
        <pc:sldMkLst>
          <pc:docMk/>
          <pc:sldMk cId="583791291" sldId="265"/>
        </pc:sldMkLst>
        <pc:spChg chg="mod">
          <ac:chgData name="Sameer G Joshi (DJPR)" userId="bd06337d-ce8c-4c34-b1d1-7fbf8f91b6eb" providerId="ADAL" clId="{D21F9A12-E0C3-4C74-B558-F81C246AECD6}" dt="2021-09-10T06:07:09.302" v="1" actId="20577"/>
          <ac:spMkLst>
            <pc:docMk/>
            <pc:sldMk cId="583791291" sldId="265"/>
            <ac:spMk id="14" creationId="{49211749-BCC9-422A-AA45-479681C574AF}"/>
          </ac:spMkLst>
        </pc:spChg>
      </pc:sldChg>
    </pc:docChg>
  </pc:docChgLst>
  <pc:docChgLst>
    <pc:chgData name="Yvonne O Ogaji (DJPR)" userId="S::yvonne.ogaji@agriculture.vic.gov.au::d7eba346-1bba-4662-a31d-509a6839a156" providerId="AD" clId="Web-{240190DD-3989-7F87-44F6-5CD9D9484421}"/>
    <pc:docChg chg="mod modMainMaster">
      <pc:chgData name="Yvonne O Ogaji (DJPR)" userId="S::yvonne.ogaji@agriculture.vic.gov.au::d7eba346-1bba-4662-a31d-509a6839a156" providerId="AD" clId="Web-{240190DD-3989-7F87-44F6-5CD9D9484421}" dt="2022-04-18T03:11:27.534" v="1" actId="33475"/>
      <pc:docMkLst>
        <pc:docMk/>
      </pc:docMkLst>
      <pc:sldMasterChg chg="addSp">
        <pc:chgData name="Yvonne O Ogaji (DJPR)" userId="S::yvonne.ogaji@agriculture.vic.gov.au::d7eba346-1bba-4662-a31d-509a6839a156" providerId="AD" clId="Web-{240190DD-3989-7F87-44F6-5CD9D9484421}" dt="2022-04-18T03:11:27.534" v="0" actId="33475"/>
        <pc:sldMasterMkLst>
          <pc:docMk/>
          <pc:sldMasterMk cId="3643008945" sldId="2147483684"/>
        </pc:sldMasterMkLst>
        <pc:spChg chg="add">
          <ac:chgData name="Yvonne O Ogaji (DJPR)" userId="S::yvonne.ogaji@agriculture.vic.gov.au::d7eba346-1bba-4662-a31d-509a6839a156" providerId="AD" clId="Web-{240190DD-3989-7F87-44F6-5CD9D9484421}" dt="2022-04-18T03:11:27.534" v="0" actId="33475"/>
          <ac:spMkLst>
            <pc:docMk/>
            <pc:sldMasterMk cId="3643008945" sldId="2147483684"/>
            <ac:spMk id="9" creationId="{486F4C76-40FB-F09D-548D-5F43BE3F8900}"/>
          </ac:spMkLst>
        </pc:spChg>
        <pc:spChg chg="add">
          <ac:chgData name="Yvonne O Ogaji (DJPR)" userId="S::yvonne.ogaji@agriculture.vic.gov.au::d7eba346-1bba-4662-a31d-509a6839a156" providerId="AD" clId="Web-{240190DD-3989-7F87-44F6-5CD9D9484421}" dt="2022-04-18T03:11:27.534" v="0" actId="33475"/>
          <ac:spMkLst>
            <pc:docMk/>
            <pc:sldMasterMk cId="3643008945" sldId="2147483684"/>
            <ac:spMk id="10" creationId="{8DAD24F2-F946-C1BC-D312-28D6654BD15C}"/>
          </ac:spMkLst>
        </pc:spChg>
      </pc:sldMasterChg>
    </pc:docChg>
  </pc:docChgLst>
  <pc:docChgLst>
    <pc:chgData name="Garry M Rosewarne (DJPR)" userId="51564b9f-0e86-4dd8-9e91-f771a6d10681" providerId="ADAL" clId="{864AAC0C-8FB0-487E-9EE5-D34EA2881A6C}"/>
    <pc:docChg chg="modSld">
      <pc:chgData name="Garry M Rosewarne (DJPR)" userId="51564b9f-0e86-4dd8-9e91-f771a6d10681" providerId="ADAL" clId="{864AAC0C-8FB0-487E-9EE5-D34EA2881A6C}" dt="2021-04-29T12:27:56.934" v="0" actId="1076"/>
      <pc:docMkLst>
        <pc:docMk/>
      </pc:docMkLst>
      <pc:sldChg chg="modSp mod">
        <pc:chgData name="Garry M Rosewarne (DJPR)" userId="51564b9f-0e86-4dd8-9e91-f771a6d10681" providerId="ADAL" clId="{864AAC0C-8FB0-487E-9EE5-D34EA2881A6C}" dt="2021-04-29T12:27:56.934" v="0" actId="1076"/>
        <pc:sldMkLst>
          <pc:docMk/>
          <pc:sldMk cId="477948994" sldId="262"/>
        </pc:sldMkLst>
        <pc:picChg chg="mod">
          <ac:chgData name="Garry M Rosewarne (DJPR)" userId="51564b9f-0e86-4dd8-9e91-f771a6d10681" providerId="ADAL" clId="{864AAC0C-8FB0-487E-9EE5-D34EA2881A6C}" dt="2021-04-29T12:27:56.934" v="0" actId="1076"/>
          <ac:picMkLst>
            <pc:docMk/>
            <pc:sldMk cId="477948994" sldId="262"/>
            <ac:picMk id="33" creationId="{71F80468-2BCF-4AB1-9EC0-99CBECA10147}"/>
          </ac:picMkLst>
        </pc:picChg>
      </pc:sldChg>
    </pc:docChg>
  </pc:docChgLst>
  <pc:docChgLst>
    <pc:chgData name="Sameer Joshi" userId="bd06337d-ce8c-4c34-b1d1-7fbf8f91b6eb" providerId="ADAL" clId="{31291F6F-DCDE-4AD1-A06E-C66A3002EF8D}"/>
    <pc:docChg chg="custSel modSld">
      <pc:chgData name="Sameer Joshi" userId="bd06337d-ce8c-4c34-b1d1-7fbf8f91b6eb" providerId="ADAL" clId="{31291F6F-DCDE-4AD1-A06E-C66A3002EF8D}" dt="2022-08-18T04:38:11.954" v="1" actId="478"/>
      <pc:docMkLst>
        <pc:docMk/>
      </pc:docMkLst>
      <pc:sldChg chg="delSp mod">
        <pc:chgData name="Sameer Joshi" userId="bd06337d-ce8c-4c34-b1d1-7fbf8f91b6eb" providerId="ADAL" clId="{31291F6F-DCDE-4AD1-A06E-C66A3002EF8D}" dt="2022-08-18T04:38:05.490" v="0" actId="478"/>
        <pc:sldMkLst>
          <pc:docMk/>
          <pc:sldMk cId="557093235" sldId="258"/>
        </pc:sldMkLst>
        <pc:spChg chg="del">
          <ac:chgData name="Sameer Joshi" userId="bd06337d-ce8c-4c34-b1d1-7fbf8f91b6eb" providerId="ADAL" clId="{31291F6F-DCDE-4AD1-A06E-C66A3002EF8D}" dt="2022-08-18T04:38:05.490" v="0" actId="478"/>
          <ac:spMkLst>
            <pc:docMk/>
            <pc:sldMk cId="557093235" sldId="258"/>
            <ac:spMk id="21" creationId="{A41730E7-FE46-4A25-B3F0-88E33BD9FF30}"/>
          </ac:spMkLst>
        </pc:spChg>
        <pc:spChg chg="del">
          <ac:chgData name="Sameer Joshi" userId="bd06337d-ce8c-4c34-b1d1-7fbf8f91b6eb" providerId="ADAL" clId="{31291F6F-DCDE-4AD1-A06E-C66A3002EF8D}" dt="2022-08-18T04:38:05.490" v="0" actId="478"/>
          <ac:spMkLst>
            <pc:docMk/>
            <pc:sldMk cId="557093235" sldId="258"/>
            <ac:spMk id="22" creationId="{CA9D736A-6A1A-48A7-B4D8-4DCF85C76412}"/>
          </ac:spMkLst>
        </pc:spChg>
        <pc:spChg chg="del">
          <ac:chgData name="Sameer Joshi" userId="bd06337d-ce8c-4c34-b1d1-7fbf8f91b6eb" providerId="ADAL" clId="{31291F6F-DCDE-4AD1-A06E-C66A3002EF8D}" dt="2022-08-18T04:38:05.490" v="0" actId="478"/>
          <ac:spMkLst>
            <pc:docMk/>
            <pc:sldMk cId="557093235" sldId="258"/>
            <ac:spMk id="23" creationId="{02DDE154-9CFD-4FEA-B104-84CD64C69E44}"/>
          </ac:spMkLst>
        </pc:spChg>
      </pc:sldChg>
      <pc:sldChg chg="delSp mod">
        <pc:chgData name="Sameer Joshi" userId="bd06337d-ce8c-4c34-b1d1-7fbf8f91b6eb" providerId="ADAL" clId="{31291F6F-DCDE-4AD1-A06E-C66A3002EF8D}" dt="2022-08-18T04:38:11.954" v="1" actId="478"/>
        <pc:sldMkLst>
          <pc:docMk/>
          <pc:sldMk cId="1524927946" sldId="259"/>
        </pc:sldMkLst>
        <pc:spChg chg="del">
          <ac:chgData name="Sameer Joshi" userId="bd06337d-ce8c-4c34-b1d1-7fbf8f91b6eb" providerId="ADAL" clId="{31291F6F-DCDE-4AD1-A06E-C66A3002EF8D}" dt="2022-08-18T04:38:11.954" v="1" actId="478"/>
          <ac:spMkLst>
            <pc:docMk/>
            <pc:sldMk cId="1524927946" sldId="259"/>
            <ac:spMk id="17" creationId="{6A90DE88-D929-4115-BDAC-3ED9DC855F03}"/>
          </ac:spMkLst>
        </pc:spChg>
        <pc:spChg chg="del">
          <ac:chgData name="Sameer Joshi" userId="bd06337d-ce8c-4c34-b1d1-7fbf8f91b6eb" providerId="ADAL" clId="{31291F6F-DCDE-4AD1-A06E-C66A3002EF8D}" dt="2022-08-18T04:38:11.954" v="1" actId="478"/>
          <ac:spMkLst>
            <pc:docMk/>
            <pc:sldMk cId="1524927946" sldId="259"/>
            <ac:spMk id="18" creationId="{68F846AF-AB5E-4C56-8848-DE725446639C}"/>
          </ac:spMkLst>
        </pc:spChg>
        <pc:spChg chg="del">
          <ac:chgData name="Sameer Joshi" userId="bd06337d-ce8c-4c34-b1d1-7fbf8f91b6eb" providerId="ADAL" clId="{31291F6F-DCDE-4AD1-A06E-C66A3002EF8D}" dt="2022-08-18T04:38:11.954" v="1" actId="478"/>
          <ac:spMkLst>
            <pc:docMk/>
            <pc:sldMk cId="1524927946" sldId="259"/>
            <ac:spMk id="19" creationId="{BBD539D0-4F64-4068-A46C-06BCF9F906C9}"/>
          </ac:spMkLst>
        </pc:spChg>
      </pc:sldChg>
    </pc:docChg>
  </pc:docChgLst>
  <pc:docChgLst>
    <pc:chgData name="Sameer G Joshi (DJPR)" userId="bd06337d-ce8c-4c34-b1d1-7fbf8f91b6eb" providerId="ADAL" clId="{2304431B-3308-474F-869B-FB04C6A8525A}"/>
    <pc:docChg chg="custSel delSld modSld modMainMaster">
      <pc:chgData name="Sameer G Joshi (DJPR)" userId="bd06337d-ce8c-4c34-b1d1-7fbf8f91b6eb" providerId="ADAL" clId="{2304431B-3308-474F-869B-FB04C6A8525A}" dt="2022-06-23T03:57:03.648" v="39" actId="47"/>
      <pc:docMkLst>
        <pc:docMk/>
      </pc:docMkLst>
      <pc:sldChg chg="modSp mod">
        <pc:chgData name="Sameer G Joshi (DJPR)" userId="bd06337d-ce8c-4c34-b1d1-7fbf8f91b6eb" providerId="ADAL" clId="{2304431B-3308-474F-869B-FB04C6A8525A}" dt="2022-06-22T23:01:50.866" v="17" actId="20577"/>
        <pc:sldMkLst>
          <pc:docMk/>
          <pc:sldMk cId="3352034816" sldId="256"/>
        </pc:sldMkLst>
        <pc:spChg chg="mod">
          <ac:chgData name="Sameer G Joshi (DJPR)" userId="bd06337d-ce8c-4c34-b1d1-7fbf8f91b6eb" providerId="ADAL" clId="{2304431B-3308-474F-869B-FB04C6A8525A}" dt="2022-06-22T23:01:50.866" v="17" actId="20577"/>
          <ac:spMkLst>
            <pc:docMk/>
            <pc:sldMk cId="3352034816" sldId="256"/>
            <ac:spMk id="8" creationId="{520DCA2E-CECA-42FB-8D8D-F305B5344E3E}"/>
          </ac:spMkLst>
        </pc:spChg>
      </pc:sldChg>
      <pc:sldChg chg="modSp mod delCm">
        <pc:chgData name="Sameer G Joshi (DJPR)" userId="bd06337d-ce8c-4c34-b1d1-7fbf8f91b6eb" providerId="ADAL" clId="{2304431B-3308-474F-869B-FB04C6A8525A}" dt="2022-06-22T23:01:57.100" v="19" actId="20577"/>
        <pc:sldMkLst>
          <pc:docMk/>
          <pc:sldMk cId="2203674866" sldId="258"/>
        </pc:sldMkLst>
        <pc:spChg chg="mod">
          <ac:chgData name="Sameer G Joshi (DJPR)" userId="bd06337d-ce8c-4c34-b1d1-7fbf8f91b6eb" providerId="ADAL" clId="{2304431B-3308-474F-869B-FB04C6A8525A}" dt="2022-06-22T23:01:57.100" v="19" actId="20577"/>
          <ac:spMkLst>
            <pc:docMk/>
            <pc:sldMk cId="2203674866" sldId="258"/>
            <ac:spMk id="19" creationId="{106A8FBD-909B-4774-B43F-1FC484A71BE3}"/>
          </ac:spMkLst>
        </pc:spChg>
      </pc:sldChg>
      <pc:sldChg chg="modSp del mod delCm">
        <pc:chgData name="Sameer G Joshi (DJPR)" userId="bd06337d-ce8c-4c34-b1d1-7fbf8f91b6eb" providerId="ADAL" clId="{2304431B-3308-474F-869B-FB04C6A8525A}" dt="2022-06-23T03:57:03.648" v="39" actId="47"/>
        <pc:sldMkLst>
          <pc:docMk/>
          <pc:sldMk cId="424659793" sldId="259"/>
        </pc:sldMkLst>
        <pc:spChg chg="mod">
          <ac:chgData name="Sameer G Joshi (DJPR)" userId="bd06337d-ce8c-4c34-b1d1-7fbf8f91b6eb" providerId="ADAL" clId="{2304431B-3308-474F-869B-FB04C6A8525A}" dt="2022-06-22T23:02:19.883" v="22" actId="113"/>
          <ac:spMkLst>
            <pc:docMk/>
            <pc:sldMk cId="424659793" sldId="259"/>
            <ac:spMk id="64" creationId="{E945096F-49E4-4222-A35A-CF28CE8283A8}"/>
          </ac:spMkLst>
        </pc:spChg>
      </pc:sldChg>
      <pc:sldChg chg="modSp mod delCm">
        <pc:chgData name="Sameer G Joshi (DJPR)" userId="bd06337d-ce8c-4c34-b1d1-7fbf8f91b6eb" providerId="ADAL" clId="{2304431B-3308-474F-869B-FB04C6A8525A}" dt="2022-06-22T23:02:31.470" v="25" actId="20577"/>
        <pc:sldMkLst>
          <pc:docMk/>
          <pc:sldMk cId="2000004557" sldId="260"/>
        </pc:sldMkLst>
        <pc:spChg chg="mod">
          <ac:chgData name="Sameer G Joshi (DJPR)" userId="bd06337d-ce8c-4c34-b1d1-7fbf8f91b6eb" providerId="ADAL" clId="{2304431B-3308-474F-869B-FB04C6A8525A}" dt="2022-06-22T23:02:31.470" v="25" actId="20577"/>
          <ac:spMkLst>
            <pc:docMk/>
            <pc:sldMk cId="2000004557" sldId="260"/>
            <ac:spMk id="6" creationId="{4E8C1A93-770A-4C1C-9961-68EC984DFA55}"/>
          </ac:spMkLst>
        </pc:spChg>
      </pc:sldChg>
      <pc:sldChg chg="modSp mod">
        <pc:chgData name="Sameer G Joshi (DJPR)" userId="bd06337d-ce8c-4c34-b1d1-7fbf8f91b6eb" providerId="ADAL" clId="{2304431B-3308-474F-869B-FB04C6A8525A}" dt="2022-06-22T23:02:37.885" v="27" actId="20577"/>
        <pc:sldMkLst>
          <pc:docMk/>
          <pc:sldMk cId="3894103260" sldId="261"/>
        </pc:sldMkLst>
        <pc:spChg chg="mod">
          <ac:chgData name="Sameer G Joshi (DJPR)" userId="bd06337d-ce8c-4c34-b1d1-7fbf8f91b6eb" providerId="ADAL" clId="{2304431B-3308-474F-869B-FB04C6A8525A}" dt="2022-06-22T23:02:37.885" v="27" actId="20577"/>
          <ac:spMkLst>
            <pc:docMk/>
            <pc:sldMk cId="3894103260" sldId="261"/>
            <ac:spMk id="13" creationId="{06EDB3DB-11B7-4BF7-9207-CE06B65DA4AC}"/>
          </ac:spMkLst>
        </pc:spChg>
      </pc:sldChg>
      <pc:sldChg chg="addSp delSp modSp mod">
        <pc:chgData name="Sameer G Joshi (DJPR)" userId="bd06337d-ce8c-4c34-b1d1-7fbf8f91b6eb" providerId="ADAL" clId="{2304431B-3308-474F-869B-FB04C6A8525A}" dt="2022-06-22T23:03:43.887" v="35" actId="1076"/>
        <pc:sldMkLst>
          <pc:docMk/>
          <pc:sldMk cId="583791291" sldId="265"/>
        </pc:sldMkLst>
        <pc:spChg chg="del">
          <ac:chgData name="Sameer G Joshi (DJPR)" userId="bd06337d-ce8c-4c34-b1d1-7fbf8f91b6eb" providerId="ADAL" clId="{2304431B-3308-474F-869B-FB04C6A8525A}" dt="2022-06-22T22:49:30.832" v="6" actId="478"/>
          <ac:spMkLst>
            <pc:docMk/>
            <pc:sldMk cId="583791291" sldId="265"/>
            <ac:spMk id="14" creationId="{49211749-BCC9-422A-AA45-479681C574AF}"/>
          </ac:spMkLst>
        </pc:spChg>
        <pc:spChg chg="del">
          <ac:chgData name="Sameer G Joshi (DJPR)" userId="bd06337d-ce8c-4c34-b1d1-7fbf8f91b6eb" providerId="ADAL" clId="{2304431B-3308-474F-869B-FB04C6A8525A}" dt="2022-06-22T22:49:32.632" v="7" actId="478"/>
          <ac:spMkLst>
            <pc:docMk/>
            <pc:sldMk cId="583791291" sldId="265"/>
            <ac:spMk id="15" creationId="{67BF43C3-DAC3-4414-BDF0-3D7F4DCF211A}"/>
          </ac:spMkLst>
        </pc:spChg>
        <pc:spChg chg="del">
          <ac:chgData name="Sameer G Joshi (DJPR)" userId="bd06337d-ce8c-4c34-b1d1-7fbf8f91b6eb" providerId="ADAL" clId="{2304431B-3308-474F-869B-FB04C6A8525A}" dt="2022-06-22T22:49:35.055" v="8" actId="478"/>
          <ac:spMkLst>
            <pc:docMk/>
            <pc:sldMk cId="583791291" sldId="265"/>
            <ac:spMk id="16" creationId="{C4C9D8BB-EF55-49C5-B6F0-F2648539960A}"/>
          </ac:spMkLst>
        </pc:spChg>
        <pc:spChg chg="add mod">
          <ac:chgData name="Sameer G Joshi (DJPR)" userId="bd06337d-ce8c-4c34-b1d1-7fbf8f91b6eb" providerId="ADAL" clId="{2304431B-3308-474F-869B-FB04C6A8525A}" dt="2022-06-22T23:03:43.887" v="35" actId="1076"/>
          <ac:spMkLst>
            <pc:docMk/>
            <pc:sldMk cId="583791291" sldId="265"/>
            <ac:spMk id="49" creationId="{77670414-D219-40B9-BF3E-30DEE128B4DE}"/>
          </ac:spMkLst>
        </pc:spChg>
      </pc:sldChg>
      <pc:sldChg chg="delSp modSp mod">
        <pc:chgData name="Sameer G Joshi (DJPR)" userId="bd06337d-ce8c-4c34-b1d1-7fbf8f91b6eb" providerId="ADAL" clId="{2304431B-3308-474F-869B-FB04C6A8525A}" dt="2022-06-22T23:02:44.801" v="29" actId="20577"/>
        <pc:sldMkLst>
          <pc:docMk/>
          <pc:sldMk cId="3253327431" sldId="266"/>
        </pc:sldMkLst>
        <pc:spChg chg="del">
          <ac:chgData name="Sameer G Joshi (DJPR)" userId="bd06337d-ce8c-4c34-b1d1-7fbf8f91b6eb" providerId="ADAL" clId="{2304431B-3308-474F-869B-FB04C6A8525A}" dt="2022-06-22T22:49:40.374" v="9" actId="478"/>
          <ac:spMkLst>
            <pc:docMk/>
            <pc:sldMk cId="3253327431" sldId="266"/>
            <ac:spMk id="5" creationId="{69238EC4-59B3-4851-A3D6-B55D5FC3F117}"/>
          </ac:spMkLst>
        </pc:spChg>
        <pc:spChg chg="del">
          <ac:chgData name="Sameer G Joshi (DJPR)" userId="bd06337d-ce8c-4c34-b1d1-7fbf8f91b6eb" providerId="ADAL" clId="{2304431B-3308-474F-869B-FB04C6A8525A}" dt="2022-06-22T22:49:42.549" v="10" actId="478"/>
          <ac:spMkLst>
            <pc:docMk/>
            <pc:sldMk cId="3253327431" sldId="266"/>
            <ac:spMk id="47" creationId="{58598D9D-FF64-4D59-9BA5-0BA7BC3B11B0}"/>
          </ac:spMkLst>
        </pc:spChg>
        <pc:spChg chg="mod">
          <ac:chgData name="Sameer G Joshi (DJPR)" userId="bd06337d-ce8c-4c34-b1d1-7fbf8f91b6eb" providerId="ADAL" clId="{2304431B-3308-474F-869B-FB04C6A8525A}" dt="2022-06-22T23:02:44.801" v="29" actId="20577"/>
          <ac:spMkLst>
            <pc:docMk/>
            <pc:sldMk cId="3253327431" sldId="266"/>
            <ac:spMk id="48" creationId="{06100C58-1A0B-49E1-8972-28A68BCAE230}"/>
          </ac:spMkLst>
        </pc:spChg>
      </pc:sldChg>
      <pc:sldChg chg="addSp delSp modSp mod">
        <pc:chgData name="Sameer G Joshi (DJPR)" userId="bd06337d-ce8c-4c34-b1d1-7fbf8f91b6eb" providerId="ADAL" clId="{2304431B-3308-474F-869B-FB04C6A8525A}" dt="2022-06-22T23:03:31.592" v="33" actId="1076"/>
        <pc:sldMkLst>
          <pc:docMk/>
          <pc:sldMk cId="1068351154" sldId="267"/>
        </pc:sldMkLst>
        <pc:spChg chg="del">
          <ac:chgData name="Sameer G Joshi (DJPR)" userId="bd06337d-ce8c-4c34-b1d1-7fbf8f91b6eb" providerId="ADAL" clId="{2304431B-3308-474F-869B-FB04C6A8525A}" dt="2022-06-22T22:49:46.449" v="11" actId="478"/>
          <ac:spMkLst>
            <pc:docMk/>
            <pc:sldMk cId="1068351154" sldId="267"/>
            <ac:spMk id="5" creationId="{CE9DE831-95AB-40C4-BCA2-95245D60333B}"/>
          </ac:spMkLst>
        </pc:spChg>
        <pc:spChg chg="del">
          <ac:chgData name="Sameer G Joshi (DJPR)" userId="bd06337d-ce8c-4c34-b1d1-7fbf8f91b6eb" providerId="ADAL" clId="{2304431B-3308-474F-869B-FB04C6A8525A}" dt="2022-06-22T22:49:48.853" v="12" actId="478"/>
          <ac:spMkLst>
            <pc:docMk/>
            <pc:sldMk cId="1068351154" sldId="267"/>
            <ac:spMk id="7" creationId="{BF2EA55A-EFE4-43B0-8A6C-0F2DE6FEFAF5}"/>
          </ac:spMkLst>
        </pc:spChg>
        <pc:spChg chg="del">
          <ac:chgData name="Sameer G Joshi (DJPR)" userId="bd06337d-ce8c-4c34-b1d1-7fbf8f91b6eb" providerId="ADAL" clId="{2304431B-3308-474F-869B-FB04C6A8525A}" dt="2022-06-22T22:49:51.532" v="13" actId="478"/>
          <ac:spMkLst>
            <pc:docMk/>
            <pc:sldMk cId="1068351154" sldId="267"/>
            <ac:spMk id="8" creationId="{6DA7E0A0-3E7B-4B17-82F0-69F6AB822B58}"/>
          </ac:spMkLst>
        </pc:spChg>
        <pc:spChg chg="add mod">
          <ac:chgData name="Sameer G Joshi (DJPR)" userId="bd06337d-ce8c-4c34-b1d1-7fbf8f91b6eb" providerId="ADAL" clId="{2304431B-3308-474F-869B-FB04C6A8525A}" dt="2022-06-22T23:03:31.592" v="33" actId="1076"/>
          <ac:spMkLst>
            <pc:docMk/>
            <pc:sldMk cId="1068351154" sldId="267"/>
            <ac:spMk id="37" creationId="{9D545ABA-C30D-4238-B980-1461727389F9}"/>
          </ac:spMkLst>
        </pc:spChg>
      </pc:sldChg>
      <pc:sldChg chg="delSp modSp mod">
        <pc:chgData name="Sameer G Joshi (DJPR)" userId="bd06337d-ce8c-4c34-b1d1-7fbf8f91b6eb" providerId="ADAL" clId="{2304431B-3308-474F-869B-FB04C6A8525A}" dt="2022-06-22T23:51:38.721" v="38" actId="1036"/>
        <pc:sldMkLst>
          <pc:docMk/>
          <pc:sldMk cId="2979161283" sldId="268"/>
        </pc:sldMkLst>
        <pc:spChg chg="del">
          <ac:chgData name="Sameer G Joshi (DJPR)" userId="bd06337d-ce8c-4c34-b1d1-7fbf8f91b6eb" providerId="ADAL" clId="{2304431B-3308-474F-869B-FB04C6A8525A}" dt="2022-06-22T22:49:55.828" v="14" actId="478"/>
          <ac:spMkLst>
            <pc:docMk/>
            <pc:sldMk cId="2979161283" sldId="268"/>
            <ac:spMk id="6" creationId="{CA202E37-96BD-427E-B175-3BE8C8F8037A}"/>
          </ac:spMkLst>
        </pc:spChg>
        <pc:spChg chg="del">
          <ac:chgData name="Sameer G Joshi (DJPR)" userId="bd06337d-ce8c-4c34-b1d1-7fbf8f91b6eb" providerId="ADAL" clId="{2304431B-3308-474F-869B-FB04C6A8525A}" dt="2022-06-22T22:49:57.918" v="15" actId="478"/>
          <ac:spMkLst>
            <pc:docMk/>
            <pc:sldMk cId="2979161283" sldId="268"/>
            <ac:spMk id="7" creationId="{160F0EE4-00BD-4C36-B867-7272062E708A}"/>
          </ac:spMkLst>
        </pc:spChg>
        <pc:spChg chg="mod">
          <ac:chgData name="Sameer G Joshi (DJPR)" userId="bd06337d-ce8c-4c34-b1d1-7fbf8f91b6eb" providerId="ADAL" clId="{2304431B-3308-474F-869B-FB04C6A8525A}" dt="2022-06-22T23:51:38.721" v="38" actId="1036"/>
          <ac:spMkLst>
            <pc:docMk/>
            <pc:sldMk cId="2979161283" sldId="268"/>
            <ac:spMk id="36" creationId="{09FA44B6-6D81-42D7-B5B5-3517607D9C8F}"/>
          </ac:spMkLst>
        </pc:spChg>
        <pc:spChg chg="mod">
          <ac:chgData name="Sameer G Joshi (DJPR)" userId="bd06337d-ce8c-4c34-b1d1-7fbf8f91b6eb" providerId="ADAL" clId="{2304431B-3308-474F-869B-FB04C6A8525A}" dt="2022-06-22T23:02:50.918" v="31" actId="20577"/>
          <ac:spMkLst>
            <pc:docMk/>
            <pc:sldMk cId="2979161283" sldId="268"/>
            <ac:spMk id="38" creationId="{C903D545-BD34-41D8-87FF-B96084478DA4}"/>
          </ac:spMkLst>
        </pc:spChg>
      </pc:sldChg>
      <pc:sldMasterChg chg="delSp mod">
        <pc:chgData name="Sameer G Joshi (DJPR)" userId="bd06337d-ce8c-4c34-b1d1-7fbf8f91b6eb" providerId="ADAL" clId="{2304431B-3308-474F-869B-FB04C6A8525A}" dt="2022-06-22T23:14:32.489" v="37" actId="478"/>
        <pc:sldMasterMkLst>
          <pc:docMk/>
          <pc:sldMasterMk cId="3643008945" sldId="2147483684"/>
        </pc:sldMasterMkLst>
        <pc:spChg chg="del">
          <ac:chgData name="Sameer G Joshi (DJPR)" userId="bd06337d-ce8c-4c34-b1d1-7fbf8f91b6eb" providerId="ADAL" clId="{2304431B-3308-474F-869B-FB04C6A8525A}" dt="2022-06-22T23:14:26.113" v="36" actId="478"/>
          <ac:spMkLst>
            <pc:docMk/>
            <pc:sldMasterMk cId="3643008945" sldId="2147483684"/>
            <ac:spMk id="7" creationId="{EB22633E-C8E8-4CB7-9F96-A88C0198C9C2}"/>
          </ac:spMkLst>
        </pc:spChg>
        <pc:spChg chg="del">
          <ac:chgData name="Sameer G Joshi (DJPR)" userId="bd06337d-ce8c-4c34-b1d1-7fbf8f91b6eb" providerId="ADAL" clId="{2304431B-3308-474F-869B-FB04C6A8525A}" dt="2022-06-22T23:14:32.489" v="37" actId="478"/>
          <ac:spMkLst>
            <pc:docMk/>
            <pc:sldMasterMk cId="3643008945" sldId="2147483684"/>
            <ac:spMk id="8" creationId="{5D49426D-3D5A-424E-9125-F12B43A3471C}"/>
          </ac:spMkLst>
        </pc:spChg>
      </pc:sldMasterChg>
    </pc:docChg>
  </pc:docChgLst>
  <pc:docChgLst>
    <pc:chgData name="Sameer G Joshi (DJPR)" userId="bd06337d-ce8c-4c34-b1d1-7fbf8f91b6eb" providerId="ADAL" clId="{E439969B-FA00-48CC-8739-0554D3941C45}"/>
    <pc:docChg chg="undo redo custSel delSld modSld sldOrd modMainMaster">
      <pc:chgData name="Sameer G Joshi (DJPR)" userId="bd06337d-ce8c-4c34-b1d1-7fbf8f91b6eb" providerId="ADAL" clId="{E439969B-FA00-48CC-8739-0554D3941C45}" dt="2022-06-14T02:05:46.620" v="867"/>
      <pc:docMkLst>
        <pc:docMk/>
      </pc:docMkLst>
      <pc:sldChg chg="modCm">
        <pc:chgData name="Sameer G Joshi (DJPR)" userId="bd06337d-ce8c-4c34-b1d1-7fbf8f91b6eb" providerId="ADAL" clId="{E439969B-FA00-48CC-8739-0554D3941C45}" dt="2022-04-08T00:39:29.148" v="1"/>
        <pc:sldMkLst>
          <pc:docMk/>
          <pc:sldMk cId="2203674866" sldId="258"/>
        </pc:sldMkLst>
      </pc:sldChg>
      <pc:sldChg chg="addSp delSp modSp mod">
        <pc:chgData name="Sameer G Joshi (DJPR)" userId="bd06337d-ce8c-4c34-b1d1-7fbf8f91b6eb" providerId="ADAL" clId="{E439969B-FA00-48CC-8739-0554D3941C45}" dt="2022-06-14T02:05:46.620" v="867"/>
        <pc:sldMkLst>
          <pc:docMk/>
          <pc:sldMk cId="424659793" sldId="259"/>
        </pc:sldMkLst>
        <pc:spChg chg="mod">
          <ac:chgData name="Sameer G Joshi (DJPR)" userId="bd06337d-ce8c-4c34-b1d1-7fbf8f91b6eb" providerId="ADAL" clId="{E439969B-FA00-48CC-8739-0554D3941C45}" dt="2022-06-14T02:05:07.604" v="862" actId="1076"/>
          <ac:spMkLst>
            <pc:docMk/>
            <pc:sldMk cId="424659793" sldId="259"/>
            <ac:spMk id="18" creationId="{F134EDC0-26BB-46FC-9913-81B80CBDE563}"/>
          </ac:spMkLst>
        </pc:spChg>
        <pc:spChg chg="mod">
          <ac:chgData name="Sameer G Joshi (DJPR)" userId="bd06337d-ce8c-4c34-b1d1-7fbf8f91b6eb" providerId="ADAL" clId="{E439969B-FA00-48CC-8739-0554D3941C45}" dt="2022-06-14T02:05:07.604" v="862" actId="1076"/>
          <ac:spMkLst>
            <pc:docMk/>
            <pc:sldMk cId="424659793" sldId="259"/>
            <ac:spMk id="19" creationId="{D4257AF1-0BDB-48E1-B152-19CF54928A63}"/>
          </ac:spMkLst>
        </pc:spChg>
        <pc:spChg chg="mod">
          <ac:chgData name="Sameer G Joshi (DJPR)" userId="bd06337d-ce8c-4c34-b1d1-7fbf8f91b6eb" providerId="ADAL" clId="{E439969B-FA00-48CC-8739-0554D3941C45}" dt="2022-06-14T02:05:07.604" v="862" actId="1076"/>
          <ac:spMkLst>
            <pc:docMk/>
            <pc:sldMk cId="424659793" sldId="259"/>
            <ac:spMk id="20" creationId="{E4C5A3CE-82FA-4F04-A686-770C1652DD38}"/>
          </ac:spMkLst>
        </pc:spChg>
        <pc:spChg chg="mod">
          <ac:chgData name="Sameer G Joshi (DJPR)" userId="bd06337d-ce8c-4c34-b1d1-7fbf8f91b6eb" providerId="ADAL" clId="{E439969B-FA00-48CC-8739-0554D3941C45}" dt="2022-06-14T02:05:12.052" v="865" actId="1035"/>
          <ac:spMkLst>
            <pc:docMk/>
            <pc:sldMk cId="424659793" sldId="259"/>
            <ac:spMk id="21" creationId="{34C3EEAE-D391-43F5-8D3F-FD32A2F9807E}"/>
          </ac:spMkLst>
        </pc:spChg>
        <pc:spChg chg="mod">
          <ac:chgData name="Sameer G Joshi (DJPR)" userId="bd06337d-ce8c-4c34-b1d1-7fbf8f91b6eb" providerId="ADAL" clId="{E439969B-FA00-48CC-8739-0554D3941C45}" dt="2022-06-14T02:03:46.137" v="857" actId="1037"/>
          <ac:spMkLst>
            <pc:docMk/>
            <pc:sldMk cId="424659793" sldId="259"/>
            <ac:spMk id="45" creationId="{0227BC53-1451-4229-BC1B-B04DA18D1F65}"/>
          </ac:spMkLst>
        </pc:spChg>
        <pc:spChg chg="mod">
          <ac:chgData name="Sameer G Joshi (DJPR)" userId="bd06337d-ce8c-4c34-b1d1-7fbf8f91b6eb" providerId="ADAL" clId="{E439969B-FA00-48CC-8739-0554D3941C45}" dt="2022-06-14T02:03:46.137" v="857" actId="1037"/>
          <ac:spMkLst>
            <pc:docMk/>
            <pc:sldMk cId="424659793" sldId="259"/>
            <ac:spMk id="46" creationId="{74B73A61-87F6-4DB1-BB45-EF26BF045C5D}"/>
          </ac:spMkLst>
        </pc:spChg>
        <pc:spChg chg="mod">
          <ac:chgData name="Sameer G Joshi (DJPR)" userId="bd06337d-ce8c-4c34-b1d1-7fbf8f91b6eb" providerId="ADAL" clId="{E439969B-FA00-48CC-8739-0554D3941C45}" dt="2022-06-14T02:03:46.137" v="857" actId="1037"/>
          <ac:spMkLst>
            <pc:docMk/>
            <pc:sldMk cId="424659793" sldId="259"/>
            <ac:spMk id="47" creationId="{20092974-FFF2-427F-86BE-3F8CE2B7DF58}"/>
          </ac:spMkLst>
        </pc:spChg>
        <pc:spChg chg="mod">
          <ac:chgData name="Sameer G Joshi (DJPR)" userId="bd06337d-ce8c-4c34-b1d1-7fbf8f91b6eb" providerId="ADAL" clId="{E439969B-FA00-48CC-8739-0554D3941C45}" dt="2022-06-14T02:03:46.137" v="857" actId="1037"/>
          <ac:spMkLst>
            <pc:docMk/>
            <pc:sldMk cId="424659793" sldId="259"/>
            <ac:spMk id="48" creationId="{6F2001C1-FB4C-440D-B8E4-8186B1FE4F5B}"/>
          </ac:spMkLst>
        </pc:spChg>
        <pc:spChg chg="del">
          <ac:chgData name="Sameer G Joshi (DJPR)" userId="bd06337d-ce8c-4c34-b1d1-7fbf8f91b6eb" providerId="ADAL" clId="{E439969B-FA00-48CC-8739-0554D3941C45}" dt="2022-06-14T01:58:06.746" v="721" actId="478"/>
          <ac:spMkLst>
            <pc:docMk/>
            <pc:sldMk cId="424659793" sldId="259"/>
            <ac:spMk id="49" creationId="{6BD89384-B8F0-48CE-BB60-15E33C29F509}"/>
          </ac:spMkLst>
        </pc:spChg>
        <pc:spChg chg="del">
          <ac:chgData name="Sameer G Joshi (DJPR)" userId="bd06337d-ce8c-4c34-b1d1-7fbf8f91b6eb" providerId="ADAL" clId="{E439969B-FA00-48CC-8739-0554D3941C45}" dt="2022-06-14T01:58:11.925" v="722" actId="478"/>
          <ac:spMkLst>
            <pc:docMk/>
            <pc:sldMk cId="424659793" sldId="259"/>
            <ac:spMk id="50" creationId="{81821875-2D3B-45C0-922F-745DD1306B42}"/>
          </ac:spMkLst>
        </pc:spChg>
        <pc:spChg chg="del">
          <ac:chgData name="Sameer G Joshi (DJPR)" userId="bd06337d-ce8c-4c34-b1d1-7fbf8f91b6eb" providerId="ADAL" clId="{E439969B-FA00-48CC-8739-0554D3941C45}" dt="2022-06-14T01:58:06.746" v="721" actId="478"/>
          <ac:spMkLst>
            <pc:docMk/>
            <pc:sldMk cId="424659793" sldId="259"/>
            <ac:spMk id="51" creationId="{D0993CDF-5917-4120-87F5-545380F8F160}"/>
          </ac:spMkLst>
        </pc:spChg>
        <pc:spChg chg="del">
          <ac:chgData name="Sameer G Joshi (DJPR)" userId="bd06337d-ce8c-4c34-b1d1-7fbf8f91b6eb" providerId="ADAL" clId="{E439969B-FA00-48CC-8739-0554D3941C45}" dt="2022-06-14T01:56:27.565" v="686" actId="478"/>
          <ac:spMkLst>
            <pc:docMk/>
            <pc:sldMk cId="424659793" sldId="259"/>
            <ac:spMk id="52" creationId="{04D8749E-0701-4826-8647-1EBE4FFF68C3}"/>
          </ac:spMkLst>
        </pc:spChg>
        <pc:spChg chg="del">
          <ac:chgData name="Sameer G Joshi (DJPR)" userId="bd06337d-ce8c-4c34-b1d1-7fbf8f91b6eb" providerId="ADAL" clId="{E439969B-FA00-48CC-8739-0554D3941C45}" dt="2022-06-14T01:56:27.565" v="686" actId="478"/>
          <ac:spMkLst>
            <pc:docMk/>
            <pc:sldMk cId="424659793" sldId="259"/>
            <ac:spMk id="53" creationId="{46F2D02C-0EAA-4928-8836-AA0064670ACE}"/>
          </ac:spMkLst>
        </pc:spChg>
        <pc:spChg chg="del">
          <ac:chgData name="Sameer G Joshi (DJPR)" userId="bd06337d-ce8c-4c34-b1d1-7fbf8f91b6eb" providerId="ADAL" clId="{E439969B-FA00-48CC-8739-0554D3941C45}" dt="2022-06-14T01:56:27.565" v="686" actId="478"/>
          <ac:spMkLst>
            <pc:docMk/>
            <pc:sldMk cId="424659793" sldId="259"/>
            <ac:spMk id="54" creationId="{FE813D58-DAF1-4639-BC1D-3DE4CBEF83FD}"/>
          </ac:spMkLst>
        </pc:spChg>
        <pc:spChg chg="del">
          <ac:chgData name="Sameer G Joshi (DJPR)" userId="bd06337d-ce8c-4c34-b1d1-7fbf8f91b6eb" providerId="ADAL" clId="{E439969B-FA00-48CC-8739-0554D3941C45}" dt="2022-06-14T01:56:27.565" v="686" actId="478"/>
          <ac:spMkLst>
            <pc:docMk/>
            <pc:sldMk cId="424659793" sldId="259"/>
            <ac:spMk id="55" creationId="{B0C557C0-83C4-4E77-BD40-A7F21D2AC8EA}"/>
          </ac:spMkLst>
        </pc:spChg>
        <pc:spChg chg="del">
          <ac:chgData name="Sameer G Joshi (DJPR)" userId="bd06337d-ce8c-4c34-b1d1-7fbf8f91b6eb" providerId="ADAL" clId="{E439969B-FA00-48CC-8739-0554D3941C45}" dt="2022-06-14T01:58:06.746" v="721" actId="478"/>
          <ac:spMkLst>
            <pc:docMk/>
            <pc:sldMk cId="424659793" sldId="259"/>
            <ac:spMk id="56" creationId="{86005B86-1FA2-420D-8781-6AE2E5E797B3}"/>
          </ac:spMkLst>
        </pc:spChg>
        <pc:spChg chg="del">
          <ac:chgData name="Sameer G Joshi (DJPR)" userId="bd06337d-ce8c-4c34-b1d1-7fbf8f91b6eb" providerId="ADAL" clId="{E439969B-FA00-48CC-8739-0554D3941C45}" dt="2022-06-14T01:58:11.925" v="722" actId="478"/>
          <ac:spMkLst>
            <pc:docMk/>
            <pc:sldMk cId="424659793" sldId="259"/>
            <ac:spMk id="57" creationId="{766946AD-BF11-421E-B794-68CCB02A5848}"/>
          </ac:spMkLst>
        </pc:spChg>
        <pc:spChg chg="del">
          <ac:chgData name="Sameer G Joshi (DJPR)" userId="bd06337d-ce8c-4c34-b1d1-7fbf8f91b6eb" providerId="ADAL" clId="{E439969B-FA00-48CC-8739-0554D3941C45}" dt="2022-06-14T01:58:06.746" v="721" actId="478"/>
          <ac:spMkLst>
            <pc:docMk/>
            <pc:sldMk cId="424659793" sldId="259"/>
            <ac:spMk id="58" creationId="{165743CB-DB4C-428B-A331-C5E3CB154CD3}"/>
          </ac:spMkLst>
        </pc:spChg>
        <pc:spChg chg="del">
          <ac:chgData name="Sameer G Joshi (DJPR)" userId="bd06337d-ce8c-4c34-b1d1-7fbf8f91b6eb" providerId="ADAL" clId="{E439969B-FA00-48CC-8739-0554D3941C45}" dt="2022-06-14T01:58:06.746" v="721" actId="478"/>
          <ac:spMkLst>
            <pc:docMk/>
            <pc:sldMk cId="424659793" sldId="259"/>
            <ac:spMk id="59" creationId="{87F8A615-74C5-4097-B633-4A8D3D829A64}"/>
          </ac:spMkLst>
        </pc:spChg>
        <pc:spChg chg="del">
          <ac:chgData name="Sameer G Joshi (DJPR)" userId="bd06337d-ce8c-4c34-b1d1-7fbf8f91b6eb" providerId="ADAL" clId="{E439969B-FA00-48CC-8739-0554D3941C45}" dt="2022-06-14T01:58:21.738" v="723" actId="478"/>
          <ac:spMkLst>
            <pc:docMk/>
            <pc:sldMk cId="424659793" sldId="259"/>
            <ac:spMk id="60" creationId="{B31399A1-928F-44CD-A96D-B340E4ADEE0B}"/>
          </ac:spMkLst>
        </pc:spChg>
        <pc:spChg chg="del">
          <ac:chgData name="Sameer G Joshi (DJPR)" userId="bd06337d-ce8c-4c34-b1d1-7fbf8f91b6eb" providerId="ADAL" clId="{E439969B-FA00-48CC-8739-0554D3941C45}" dt="2022-06-14T01:58:24.997" v="724" actId="478"/>
          <ac:spMkLst>
            <pc:docMk/>
            <pc:sldMk cId="424659793" sldId="259"/>
            <ac:spMk id="61" creationId="{DE43E371-9D86-47B7-8835-26D443F69183}"/>
          </ac:spMkLst>
        </pc:spChg>
        <pc:spChg chg="del">
          <ac:chgData name="Sameer G Joshi (DJPR)" userId="bd06337d-ce8c-4c34-b1d1-7fbf8f91b6eb" providerId="ADAL" clId="{E439969B-FA00-48CC-8739-0554D3941C45}" dt="2022-06-14T01:58:21.738" v="723" actId="478"/>
          <ac:spMkLst>
            <pc:docMk/>
            <pc:sldMk cId="424659793" sldId="259"/>
            <ac:spMk id="62" creationId="{F69A1AE3-1AA8-46D2-A368-96A14F0F66F8}"/>
          </ac:spMkLst>
        </pc:spChg>
        <pc:spChg chg="del">
          <ac:chgData name="Sameer G Joshi (DJPR)" userId="bd06337d-ce8c-4c34-b1d1-7fbf8f91b6eb" providerId="ADAL" clId="{E439969B-FA00-48CC-8739-0554D3941C45}" dt="2022-06-14T01:58:21.738" v="723" actId="478"/>
          <ac:spMkLst>
            <pc:docMk/>
            <pc:sldMk cId="424659793" sldId="259"/>
            <ac:spMk id="63" creationId="{91B9C6C1-15B8-466A-8898-75F3D0455C44}"/>
          </ac:spMkLst>
        </pc:spChg>
        <pc:spChg chg="mod">
          <ac:chgData name="Sameer G Joshi (DJPR)" userId="bd06337d-ce8c-4c34-b1d1-7fbf8f91b6eb" providerId="ADAL" clId="{E439969B-FA00-48CC-8739-0554D3941C45}" dt="2022-06-14T02:05:46.620" v="867"/>
          <ac:spMkLst>
            <pc:docMk/>
            <pc:sldMk cId="424659793" sldId="259"/>
            <ac:spMk id="64" creationId="{E945096F-49E4-4222-A35A-CF28CE8283A8}"/>
          </ac:spMkLst>
        </pc:spChg>
        <pc:spChg chg="del">
          <ac:chgData name="Sameer G Joshi (DJPR)" userId="bd06337d-ce8c-4c34-b1d1-7fbf8f91b6eb" providerId="ADAL" clId="{E439969B-FA00-48CC-8739-0554D3941C45}" dt="2022-06-14T01:58:06.746" v="721" actId="478"/>
          <ac:spMkLst>
            <pc:docMk/>
            <pc:sldMk cId="424659793" sldId="259"/>
            <ac:spMk id="67" creationId="{0A73ADE7-BBEE-41CF-9677-8B35A13A483E}"/>
          </ac:spMkLst>
        </pc:spChg>
        <pc:spChg chg="del">
          <ac:chgData name="Sameer G Joshi (DJPR)" userId="bd06337d-ce8c-4c34-b1d1-7fbf8f91b6eb" providerId="ADAL" clId="{E439969B-FA00-48CC-8739-0554D3941C45}" dt="2022-06-14T01:58:21.738" v="723" actId="478"/>
          <ac:spMkLst>
            <pc:docMk/>
            <pc:sldMk cId="424659793" sldId="259"/>
            <ac:spMk id="68" creationId="{83916AE0-9EAC-4561-8941-752C32314158}"/>
          </ac:spMkLst>
        </pc:spChg>
        <pc:spChg chg="del">
          <ac:chgData name="Sameer G Joshi (DJPR)" userId="bd06337d-ce8c-4c34-b1d1-7fbf8f91b6eb" providerId="ADAL" clId="{E439969B-FA00-48CC-8739-0554D3941C45}" dt="2022-06-14T01:58:21.738" v="723" actId="478"/>
          <ac:spMkLst>
            <pc:docMk/>
            <pc:sldMk cId="424659793" sldId="259"/>
            <ac:spMk id="69" creationId="{F9FC764F-EBA4-4B4C-84F2-AB9A34FB7355}"/>
          </ac:spMkLst>
        </pc:spChg>
        <pc:spChg chg="del">
          <ac:chgData name="Sameer G Joshi (DJPR)" userId="bd06337d-ce8c-4c34-b1d1-7fbf8f91b6eb" providerId="ADAL" clId="{E439969B-FA00-48CC-8739-0554D3941C45}" dt="2022-06-14T01:58:21.738" v="723" actId="478"/>
          <ac:spMkLst>
            <pc:docMk/>
            <pc:sldMk cId="424659793" sldId="259"/>
            <ac:spMk id="70" creationId="{25EF780B-AEAB-44D7-ADFF-FDD8C83D25AF}"/>
          </ac:spMkLst>
        </pc:spChg>
        <pc:spChg chg="del">
          <ac:chgData name="Sameer G Joshi (DJPR)" userId="bd06337d-ce8c-4c34-b1d1-7fbf8f91b6eb" providerId="ADAL" clId="{E439969B-FA00-48CC-8739-0554D3941C45}" dt="2022-06-14T01:58:21.738" v="723" actId="478"/>
          <ac:spMkLst>
            <pc:docMk/>
            <pc:sldMk cId="424659793" sldId="259"/>
            <ac:spMk id="71" creationId="{CAB21247-47EC-4FF6-94C1-A376FDC9D1C8}"/>
          </ac:spMkLst>
        </pc:spChg>
        <pc:spChg chg="del">
          <ac:chgData name="Sameer G Joshi (DJPR)" userId="bd06337d-ce8c-4c34-b1d1-7fbf8f91b6eb" providerId="ADAL" clId="{E439969B-FA00-48CC-8739-0554D3941C45}" dt="2022-06-14T01:57:20.531" v="710" actId="478"/>
          <ac:spMkLst>
            <pc:docMk/>
            <pc:sldMk cId="424659793" sldId="259"/>
            <ac:spMk id="72" creationId="{F7748153-2009-4C94-9A07-2AA420FA1AB4}"/>
          </ac:spMkLst>
        </pc:spChg>
        <pc:spChg chg="del">
          <ac:chgData name="Sameer G Joshi (DJPR)" userId="bd06337d-ce8c-4c34-b1d1-7fbf8f91b6eb" providerId="ADAL" clId="{E439969B-FA00-48CC-8739-0554D3941C45}" dt="2022-06-14T01:57:20.531" v="710" actId="478"/>
          <ac:spMkLst>
            <pc:docMk/>
            <pc:sldMk cId="424659793" sldId="259"/>
            <ac:spMk id="73" creationId="{27D79F2D-F874-4538-8889-07FF2968E88A}"/>
          </ac:spMkLst>
        </pc:spChg>
        <pc:spChg chg="del">
          <ac:chgData name="Sameer G Joshi (DJPR)" userId="bd06337d-ce8c-4c34-b1d1-7fbf8f91b6eb" providerId="ADAL" clId="{E439969B-FA00-48CC-8739-0554D3941C45}" dt="2022-06-14T01:57:20.531" v="710" actId="478"/>
          <ac:spMkLst>
            <pc:docMk/>
            <pc:sldMk cId="424659793" sldId="259"/>
            <ac:spMk id="74" creationId="{61C844A3-15BF-4CCE-8AB5-FDEC228B5B98}"/>
          </ac:spMkLst>
        </pc:spChg>
        <pc:spChg chg="del">
          <ac:chgData name="Sameer G Joshi (DJPR)" userId="bd06337d-ce8c-4c34-b1d1-7fbf8f91b6eb" providerId="ADAL" clId="{E439969B-FA00-48CC-8739-0554D3941C45}" dt="2022-06-14T01:57:20.531" v="710" actId="478"/>
          <ac:spMkLst>
            <pc:docMk/>
            <pc:sldMk cId="424659793" sldId="259"/>
            <ac:spMk id="75" creationId="{75A0A8A1-8E8F-4113-A4B6-33148AD14392}"/>
          </ac:spMkLst>
        </pc:spChg>
        <pc:spChg chg="add mod">
          <ac:chgData name="Sameer G Joshi (DJPR)" userId="bd06337d-ce8c-4c34-b1d1-7fbf8f91b6eb" providerId="ADAL" clId="{E439969B-FA00-48CC-8739-0554D3941C45}" dt="2022-06-14T02:04:52.180" v="861" actId="1076"/>
          <ac:spMkLst>
            <pc:docMk/>
            <pc:sldMk cId="424659793" sldId="259"/>
            <ac:spMk id="76" creationId="{8B5FA508-6D15-4C41-9956-3153F7778598}"/>
          </ac:spMkLst>
        </pc:spChg>
        <pc:spChg chg="add mod">
          <ac:chgData name="Sameer G Joshi (DJPR)" userId="bd06337d-ce8c-4c34-b1d1-7fbf8f91b6eb" providerId="ADAL" clId="{E439969B-FA00-48CC-8739-0554D3941C45}" dt="2022-06-14T02:04:52.180" v="861" actId="1076"/>
          <ac:spMkLst>
            <pc:docMk/>
            <pc:sldMk cId="424659793" sldId="259"/>
            <ac:spMk id="77" creationId="{9BF9CCC1-25B1-462D-9A54-9A321C593D18}"/>
          </ac:spMkLst>
        </pc:spChg>
        <pc:spChg chg="add mod">
          <ac:chgData name="Sameer G Joshi (DJPR)" userId="bd06337d-ce8c-4c34-b1d1-7fbf8f91b6eb" providerId="ADAL" clId="{E439969B-FA00-48CC-8739-0554D3941C45}" dt="2022-06-14T02:04:52.180" v="861" actId="1076"/>
          <ac:spMkLst>
            <pc:docMk/>
            <pc:sldMk cId="424659793" sldId="259"/>
            <ac:spMk id="78" creationId="{63858031-DDCD-4EDE-B8BF-CF5CE61C235A}"/>
          </ac:spMkLst>
        </pc:spChg>
        <pc:spChg chg="add mod">
          <ac:chgData name="Sameer G Joshi (DJPR)" userId="bd06337d-ce8c-4c34-b1d1-7fbf8f91b6eb" providerId="ADAL" clId="{E439969B-FA00-48CC-8739-0554D3941C45}" dt="2022-06-14T02:04:52.180" v="861" actId="1076"/>
          <ac:spMkLst>
            <pc:docMk/>
            <pc:sldMk cId="424659793" sldId="259"/>
            <ac:spMk id="79" creationId="{E7817802-2254-40FA-9FFF-C9198036BB21}"/>
          </ac:spMkLst>
        </pc:spChg>
        <pc:spChg chg="add mod">
          <ac:chgData name="Sameer G Joshi (DJPR)" userId="bd06337d-ce8c-4c34-b1d1-7fbf8f91b6eb" providerId="ADAL" clId="{E439969B-FA00-48CC-8739-0554D3941C45}" dt="2022-06-14T02:03:46.137" v="857" actId="1037"/>
          <ac:spMkLst>
            <pc:docMk/>
            <pc:sldMk cId="424659793" sldId="259"/>
            <ac:spMk id="80" creationId="{DA219EC5-CBDA-49CA-91E8-E88EB5F72DF6}"/>
          </ac:spMkLst>
        </pc:spChg>
        <pc:spChg chg="add mod">
          <ac:chgData name="Sameer G Joshi (DJPR)" userId="bd06337d-ce8c-4c34-b1d1-7fbf8f91b6eb" providerId="ADAL" clId="{E439969B-FA00-48CC-8739-0554D3941C45}" dt="2022-06-14T02:03:46.137" v="857" actId="1037"/>
          <ac:spMkLst>
            <pc:docMk/>
            <pc:sldMk cId="424659793" sldId="259"/>
            <ac:spMk id="81" creationId="{490BCE15-789E-4776-8741-8129D4010223}"/>
          </ac:spMkLst>
        </pc:spChg>
        <pc:spChg chg="add mod">
          <ac:chgData name="Sameer G Joshi (DJPR)" userId="bd06337d-ce8c-4c34-b1d1-7fbf8f91b6eb" providerId="ADAL" clId="{E439969B-FA00-48CC-8739-0554D3941C45}" dt="2022-06-14T02:03:46.137" v="857" actId="1037"/>
          <ac:spMkLst>
            <pc:docMk/>
            <pc:sldMk cId="424659793" sldId="259"/>
            <ac:spMk id="82" creationId="{5DC96B83-661C-48B7-B831-7567E8389D01}"/>
          </ac:spMkLst>
        </pc:spChg>
        <pc:spChg chg="add mod">
          <ac:chgData name="Sameer G Joshi (DJPR)" userId="bd06337d-ce8c-4c34-b1d1-7fbf8f91b6eb" providerId="ADAL" clId="{E439969B-FA00-48CC-8739-0554D3941C45}" dt="2022-06-14T02:03:46.137" v="857" actId="1037"/>
          <ac:spMkLst>
            <pc:docMk/>
            <pc:sldMk cId="424659793" sldId="259"/>
            <ac:spMk id="83" creationId="{E801B14D-D1B6-4AAA-916F-C2D87CC74B9C}"/>
          </ac:spMkLst>
        </pc:spChg>
        <pc:spChg chg="add mod">
          <ac:chgData name="Sameer G Joshi (DJPR)" userId="bd06337d-ce8c-4c34-b1d1-7fbf8f91b6eb" providerId="ADAL" clId="{E439969B-FA00-48CC-8739-0554D3941C45}" dt="2022-06-14T02:03:27.828" v="855" actId="1076"/>
          <ac:spMkLst>
            <pc:docMk/>
            <pc:sldMk cId="424659793" sldId="259"/>
            <ac:spMk id="84" creationId="{0B955934-CCD8-44A1-A136-0DB730F0C1D6}"/>
          </ac:spMkLst>
        </pc:spChg>
        <pc:spChg chg="add mod">
          <ac:chgData name="Sameer G Joshi (DJPR)" userId="bd06337d-ce8c-4c34-b1d1-7fbf8f91b6eb" providerId="ADAL" clId="{E439969B-FA00-48CC-8739-0554D3941C45}" dt="2022-06-14T02:03:20.248" v="854" actId="1076"/>
          <ac:spMkLst>
            <pc:docMk/>
            <pc:sldMk cId="424659793" sldId="259"/>
            <ac:spMk id="85" creationId="{797FEC39-F903-49C7-A9AD-8FB236CA5D96}"/>
          </ac:spMkLst>
        </pc:spChg>
        <pc:spChg chg="add mod">
          <ac:chgData name="Sameer G Joshi (DJPR)" userId="bd06337d-ce8c-4c34-b1d1-7fbf8f91b6eb" providerId="ADAL" clId="{E439969B-FA00-48CC-8739-0554D3941C45}" dt="2022-06-14T02:03:12.649" v="853" actId="1076"/>
          <ac:spMkLst>
            <pc:docMk/>
            <pc:sldMk cId="424659793" sldId="259"/>
            <ac:spMk id="86" creationId="{53A7803D-6F7F-435F-A579-2546978BC2CB}"/>
          </ac:spMkLst>
        </pc:spChg>
        <pc:spChg chg="add mod">
          <ac:chgData name="Sameer G Joshi (DJPR)" userId="bd06337d-ce8c-4c34-b1d1-7fbf8f91b6eb" providerId="ADAL" clId="{E439969B-FA00-48CC-8739-0554D3941C45}" dt="2022-06-14T02:03:06.635" v="852" actId="1076"/>
          <ac:spMkLst>
            <pc:docMk/>
            <pc:sldMk cId="424659793" sldId="259"/>
            <ac:spMk id="87" creationId="{35CEC7E3-44FF-4D0C-916D-356CE0FF1DE5}"/>
          </ac:spMkLst>
        </pc:spChg>
        <pc:spChg chg="add mod">
          <ac:chgData name="Sameer G Joshi (DJPR)" userId="bd06337d-ce8c-4c34-b1d1-7fbf8f91b6eb" providerId="ADAL" clId="{E439969B-FA00-48CC-8739-0554D3941C45}" dt="2022-06-14T02:02:57.177" v="851" actId="1076"/>
          <ac:spMkLst>
            <pc:docMk/>
            <pc:sldMk cId="424659793" sldId="259"/>
            <ac:spMk id="88" creationId="{74CF8D99-4E32-4839-818A-28602AE97EBE}"/>
          </ac:spMkLst>
        </pc:spChg>
        <pc:spChg chg="add mod">
          <ac:chgData name="Sameer G Joshi (DJPR)" userId="bd06337d-ce8c-4c34-b1d1-7fbf8f91b6eb" providerId="ADAL" clId="{E439969B-FA00-48CC-8739-0554D3941C45}" dt="2022-06-14T02:02:51.245" v="850" actId="1076"/>
          <ac:spMkLst>
            <pc:docMk/>
            <pc:sldMk cId="424659793" sldId="259"/>
            <ac:spMk id="89" creationId="{F3661886-B6C1-4504-93D1-576402E10516}"/>
          </ac:spMkLst>
        </pc:spChg>
        <pc:spChg chg="add mod">
          <ac:chgData name="Sameer G Joshi (DJPR)" userId="bd06337d-ce8c-4c34-b1d1-7fbf8f91b6eb" providerId="ADAL" clId="{E439969B-FA00-48CC-8739-0554D3941C45}" dt="2022-06-14T02:02:38.342" v="849" actId="1076"/>
          <ac:spMkLst>
            <pc:docMk/>
            <pc:sldMk cId="424659793" sldId="259"/>
            <ac:spMk id="90" creationId="{D1FAF972-CCAB-4413-8E9A-2E9F67A16753}"/>
          </ac:spMkLst>
        </pc:spChg>
        <pc:spChg chg="add mod">
          <ac:chgData name="Sameer G Joshi (DJPR)" userId="bd06337d-ce8c-4c34-b1d1-7fbf8f91b6eb" providerId="ADAL" clId="{E439969B-FA00-48CC-8739-0554D3941C45}" dt="2022-06-14T02:02:30.827" v="848" actId="1076"/>
          <ac:spMkLst>
            <pc:docMk/>
            <pc:sldMk cId="424659793" sldId="259"/>
            <ac:spMk id="91" creationId="{FA365860-ECAC-473B-AFCA-FE979832982B}"/>
          </ac:spMkLst>
        </pc:spChg>
        <pc:spChg chg="add mod">
          <ac:chgData name="Sameer G Joshi (DJPR)" userId="bd06337d-ce8c-4c34-b1d1-7fbf8f91b6eb" providerId="ADAL" clId="{E439969B-FA00-48CC-8739-0554D3941C45}" dt="2022-06-14T02:04:02.358" v="859" actId="1076"/>
          <ac:spMkLst>
            <pc:docMk/>
            <pc:sldMk cId="424659793" sldId="259"/>
            <ac:spMk id="92" creationId="{4EEA85E8-0F8E-46DB-BAC5-2EDCFC55EAC8}"/>
          </ac:spMkLst>
        </pc:spChg>
        <pc:spChg chg="add mod">
          <ac:chgData name="Sameer G Joshi (DJPR)" userId="bd06337d-ce8c-4c34-b1d1-7fbf8f91b6eb" providerId="ADAL" clId="{E439969B-FA00-48CC-8739-0554D3941C45}" dt="2022-06-14T02:04:02.358" v="859" actId="1076"/>
          <ac:spMkLst>
            <pc:docMk/>
            <pc:sldMk cId="424659793" sldId="259"/>
            <ac:spMk id="93" creationId="{90D5F635-A187-47E4-B9DB-0ECA02D0F47D}"/>
          </ac:spMkLst>
        </pc:spChg>
        <pc:spChg chg="add mod">
          <ac:chgData name="Sameer G Joshi (DJPR)" userId="bd06337d-ce8c-4c34-b1d1-7fbf8f91b6eb" providerId="ADAL" clId="{E439969B-FA00-48CC-8739-0554D3941C45}" dt="2022-06-14T02:04:02.358" v="859" actId="1076"/>
          <ac:spMkLst>
            <pc:docMk/>
            <pc:sldMk cId="424659793" sldId="259"/>
            <ac:spMk id="94" creationId="{C1F83C0F-69F0-4BC7-928C-7F7F408184E7}"/>
          </ac:spMkLst>
        </pc:spChg>
        <pc:spChg chg="add mod">
          <ac:chgData name="Sameer G Joshi (DJPR)" userId="bd06337d-ce8c-4c34-b1d1-7fbf8f91b6eb" providerId="ADAL" clId="{E439969B-FA00-48CC-8739-0554D3941C45}" dt="2022-06-14T02:04:02.358" v="859" actId="1076"/>
          <ac:spMkLst>
            <pc:docMk/>
            <pc:sldMk cId="424659793" sldId="259"/>
            <ac:spMk id="95" creationId="{90960F60-9DC2-467E-AD81-34A759FAB8EC}"/>
          </ac:spMkLst>
        </pc:spChg>
        <pc:spChg chg="add mod">
          <ac:chgData name="Sameer G Joshi (DJPR)" userId="bd06337d-ce8c-4c34-b1d1-7fbf8f91b6eb" providerId="ADAL" clId="{E439969B-FA00-48CC-8739-0554D3941C45}" dt="2022-06-14T02:04:02.358" v="859" actId="1076"/>
          <ac:spMkLst>
            <pc:docMk/>
            <pc:sldMk cId="424659793" sldId="259"/>
            <ac:spMk id="96" creationId="{8B08E97F-85D0-4026-9A25-6F4D345A3BEB}"/>
          </ac:spMkLst>
        </pc:spChg>
        <pc:spChg chg="add mod">
          <ac:chgData name="Sameer G Joshi (DJPR)" userId="bd06337d-ce8c-4c34-b1d1-7fbf8f91b6eb" providerId="ADAL" clId="{E439969B-FA00-48CC-8739-0554D3941C45}" dt="2022-06-14T02:04:02.358" v="859" actId="1076"/>
          <ac:spMkLst>
            <pc:docMk/>
            <pc:sldMk cId="424659793" sldId="259"/>
            <ac:spMk id="97" creationId="{0202F5F9-2F38-4766-B167-C141720E6B90}"/>
          </ac:spMkLst>
        </pc:spChg>
        <pc:spChg chg="add mod">
          <ac:chgData name="Sameer G Joshi (DJPR)" userId="bd06337d-ce8c-4c34-b1d1-7fbf8f91b6eb" providerId="ADAL" clId="{E439969B-FA00-48CC-8739-0554D3941C45}" dt="2022-06-14T02:04:02.358" v="859" actId="1076"/>
          <ac:spMkLst>
            <pc:docMk/>
            <pc:sldMk cId="424659793" sldId="259"/>
            <ac:spMk id="98" creationId="{9E8ADE9B-486E-4E81-B0CF-D017DF78FD98}"/>
          </ac:spMkLst>
        </pc:spChg>
        <pc:spChg chg="add mod">
          <ac:chgData name="Sameer G Joshi (DJPR)" userId="bd06337d-ce8c-4c34-b1d1-7fbf8f91b6eb" providerId="ADAL" clId="{E439969B-FA00-48CC-8739-0554D3941C45}" dt="2022-06-14T02:04:02.358" v="859" actId="1076"/>
          <ac:spMkLst>
            <pc:docMk/>
            <pc:sldMk cId="424659793" sldId="259"/>
            <ac:spMk id="99" creationId="{3E41654F-36C9-4399-8BD3-F3EA58CF10E2}"/>
          </ac:spMkLst>
        </pc:spChg>
        <pc:grpChg chg="mod">
          <ac:chgData name="Sameer G Joshi (DJPR)" userId="bd06337d-ce8c-4c34-b1d1-7fbf8f91b6eb" providerId="ADAL" clId="{E439969B-FA00-48CC-8739-0554D3941C45}" dt="2022-06-14T02:01:23.726" v="832" actId="1035"/>
          <ac:grpSpMkLst>
            <pc:docMk/>
            <pc:sldMk cId="424659793" sldId="259"/>
            <ac:grpSpMk id="9" creationId="{B3A8B81C-30B7-4B97-8027-C028D4B127ED}"/>
          </ac:grpSpMkLst>
        </pc:grpChg>
      </pc:sldChg>
      <pc:sldChg chg="modSp mod">
        <pc:chgData name="Sameer G Joshi (DJPR)" userId="bd06337d-ce8c-4c34-b1d1-7fbf8f91b6eb" providerId="ADAL" clId="{E439969B-FA00-48CC-8739-0554D3941C45}" dt="2022-06-14T01:54:25.757" v="648" actId="6549"/>
        <pc:sldMkLst>
          <pc:docMk/>
          <pc:sldMk cId="2000004557" sldId="260"/>
        </pc:sldMkLst>
        <pc:spChg chg="mod">
          <ac:chgData name="Sameer G Joshi (DJPR)" userId="bd06337d-ce8c-4c34-b1d1-7fbf8f91b6eb" providerId="ADAL" clId="{E439969B-FA00-48CC-8739-0554D3941C45}" dt="2022-06-14T01:54:25.757" v="648" actId="6549"/>
          <ac:spMkLst>
            <pc:docMk/>
            <pc:sldMk cId="2000004557" sldId="260"/>
            <ac:spMk id="6" creationId="{4E8C1A93-770A-4C1C-9961-68EC984DFA55}"/>
          </ac:spMkLst>
        </pc:spChg>
        <pc:spChg chg="mod">
          <ac:chgData name="Sameer G Joshi (DJPR)" userId="bd06337d-ce8c-4c34-b1d1-7fbf8f91b6eb" providerId="ADAL" clId="{E439969B-FA00-48CC-8739-0554D3941C45}" dt="2022-06-14T01:37:11.254" v="269" actId="20577"/>
          <ac:spMkLst>
            <pc:docMk/>
            <pc:sldMk cId="2000004557" sldId="260"/>
            <ac:spMk id="20" creationId="{59426C56-0B19-4AF0-8867-B5A25BF208C9}"/>
          </ac:spMkLst>
        </pc:spChg>
        <pc:spChg chg="mod">
          <ac:chgData name="Sameer G Joshi (DJPR)" userId="bd06337d-ce8c-4c34-b1d1-7fbf8f91b6eb" providerId="ADAL" clId="{E439969B-FA00-48CC-8739-0554D3941C45}" dt="2022-06-14T01:37:14.969" v="271" actId="20577"/>
          <ac:spMkLst>
            <pc:docMk/>
            <pc:sldMk cId="2000004557" sldId="260"/>
            <ac:spMk id="21" creationId="{BA9AE161-CC28-4179-93B5-E7F4915D4EF4}"/>
          </ac:spMkLst>
        </pc:spChg>
        <pc:spChg chg="mod">
          <ac:chgData name="Sameer G Joshi (DJPR)" userId="bd06337d-ce8c-4c34-b1d1-7fbf8f91b6eb" providerId="ADAL" clId="{E439969B-FA00-48CC-8739-0554D3941C45}" dt="2022-06-14T01:37:17.521" v="273" actId="20577"/>
          <ac:spMkLst>
            <pc:docMk/>
            <pc:sldMk cId="2000004557" sldId="260"/>
            <ac:spMk id="22" creationId="{C8E32B93-2A34-45BF-B18C-57BB5EB245D8}"/>
          </ac:spMkLst>
        </pc:spChg>
        <pc:spChg chg="mod">
          <ac:chgData name="Sameer G Joshi (DJPR)" userId="bd06337d-ce8c-4c34-b1d1-7fbf8f91b6eb" providerId="ADAL" clId="{E439969B-FA00-48CC-8739-0554D3941C45}" dt="2022-06-14T01:37:20.339" v="275" actId="20577"/>
          <ac:spMkLst>
            <pc:docMk/>
            <pc:sldMk cId="2000004557" sldId="260"/>
            <ac:spMk id="23" creationId="{6DC06F12-CAC3-4A3D-A765-F2461E4E0BDE}"/>
          </ac:spMkLst>
        </pc:spChg>
        <pc:spChg chg="mod">
          <ac:chgData name="Sameer G Joshi (DJPR)" userId="bd06337d-ce8c-4c34-b1d1-7fbf8f91b6eb" providerId="ADAL" clId="{E439969B-FA00-48CC-8739-0554D3941C45}" dt="2022-06-14T01:37:23.684" v="277" actId="20577"/>
          <ac:spMkLst>
            <pc:docMk/>
            <pc:sldMk cId="2000004557" sldId="260"/>
            <ac:spMk id="24" creationId="{A30377AD-8E00-475A-A4D8-4BADACF3BCEB}"/>
          </ac:spMkLst>
        </pc:spChg>
        <pc:spChg chg="mod">
          <ac:chgData name="Sameer G Joshi (DJPR)" userId="bd06337d-ce8c-4c34-b1d1-7fbf8f91b6eb" providerId="ADAL" clId="{E439969B-FA00-48CC-8739-0554D3941C45}" dt="2022-06-14T01:37:26.473" v="279" actId="20577"/>
          <ac:spMkLst>
            <pc:docMk/>
            <pc:sldMk cId="2000004557" sldId="260"/>
            <ac:spMk id="25" creationId="{71D3EB14-B8AF-4CF3-BCDA-169130A8A5C5}"/>
          </ac:spMkLst>
        </pc:spChg>
        <pc:spChg chg="mod">
          <ac:chgData name="Sameer G Joshi (DJPR)" userId="bd06337d-ce8c-4c34-b1d1-7fbf8f91b6eb" providerId="ADAL" clId="{E439969B-FA00-48CC-8739-0554D3941C45}" dt="2022-06-14T01:37:30.130" v="281" actId="20577"/>
          <ac:spMkLst>
            <pc:docMk/>
            <pc:sldMk cId="2000004557" sldId="260"/>
            <ac:spMk id="26" creationId="{B939DAF8-5884-4439-A550-23E6BBF37B28}"/>
          </ac:spMkLst>
        </pc:spChg>
        <pc:spChg chg="mod">
          <ac:chgData name="Sameer G Joshi (DJPR)" userId="bd06337d-ce8c-4c34-b1d1-7fbf8f91b6eb" providerId="ADAL" clId="{E439969B-FA00-48CC-8739-0554D3941C45}" dt="2022-06-14T01:37:33.385" v="283" actId="20577"/>
          <ac:spMkLst>
            <pc:docMk/>
            <pc:sldMk cId="2000004557" sldId="260"/>
            <ac:spMk id="27" creationId="{BB6A9DAF-F676-4DFD-898E-3F2D73F0D840}"/>
          </ac:spMkLst>
        </pc:spChg>
      </pc:sldChg>
      <pc:sldChg chg="mod">
        <pc:chgData name="Sameer G Joshi (DJPR)" userId="bd06337d-ce8c-4c34-b1d1-7fbf8f91b6eb" providerId="ADAL" clId="{E439969B-FA00-48CC-8739-0554D3941C45}" dt="2022-04-12T13:56:50.544" v="132" actId="27918"/>
        <pc:sldMkLst>
          <pc:docMk/>
          <pc:sldMk cId="583791291" sldId="265"/>
        </pc:sldMkLst>
      </pc:sldChg>
      <pc:sldChg chg="mod">
        <pc:chgData name="Sameer G Joshi (DJPR)" userId="bd06337d-ce8c-4c34-b1d1-7fbf8f91b6eb" providerId="ADAL" clId="{E439969B-FA00-48CC-8739-0554D3941C45}" dt="2022-04-12T14:06:27.404" v="135" actId="27918"/>
        <pc:sldMkLst>
          <pc:docMk/>
          <pc:sldMk cId="3253327431" sldId="266"/>
        </pc:sldMkLst>
      </pc:sldChg>
      <pc:sldChg chg="mod ord">
        <pc:chgData name="Sameer G Joshi (DJPR)" userId="bd06337d-ce8c-4c34-b1d1-7fbf8f91b6eb" providerId="ADAL" clId="{E439969B-FA00-48CC-8739-0554D3941C45}" dt="2022-04-12T13:29:59.085" v="120" actId="27918"/>
        <pc:sldMkLst>
          <pc:docMk/>
          <pc:sldMk cId="1068351154" sldId="267"/>
        </pc:sldMkLst>
      </pc:sldChg>
      <pc:sldChg chg="mod">
        <pc:chgData name="Sameer G Joshi (DJPR)" userId="bd06337d-ce8c-4c34-b1d1-7fbf8f91b6eb" providerId="ADAL" clId="{E439969B-FA00-48CC-8739-0554D3941C45}" dt="2022-04-12T14:11:57.848" v="137" actId="27918"/>
        <pc:sldMkLst>
          <pc:docMk/>
          <pc:sldMk cId="2979161283" sldId="268"/>
        </pc:sldMkLst>
      </pc:sldChg>
      <pc:sldChg chg="del">
        <pc:chgData name="Sameer G Joshi (DJPR)" userId="bd06337d-ce8c-4c34-b1d1-7fbf8f91b6eb" providerId="ADAL" clId="{E439969B-FA00-48CC-8739-0554D3941C45}" dt="2022-04-04T11:43:56.086" v="0" actId="2696"/>
        <pc:sldMkLst>
          <pc:docMk/>
          <pc:sldMk cId="446862676" sldId="269"/>
        </pc:sldMkLst>
      </pc:sldChg>
      <pc:sldMasterChg chg="addSp delSp modSp mod">
        <pc:chgData name="Sameer G Joshi (DJPR)" userId="bd06337d-ce8c-4c34-b1d1-7fbf8f91b6eb" providerId="ADAL" clId="{E439969B-FA00-48CC-8739-0554D3941C45}" dt="2022-04-22T00:34:27" v="263"/>
        <pc:sldMasterMkLst>
          <pc:docMk/>
          <pc:sldMasterMk cId="3643008945" sldId="2147483684"/>
        </pc:sldMasterMkLst>
        <pc:spChg chg="add mod ord modVis">
          <ac:chgData name="Sameer G Joshi (DJPR)" userId="bd06337d-ce8c-4c34-b1d1-7fbf8f91b6eb" providerId="ADAL" clId="{E439969B-FA00-48CC-8739-0554D3941C45}" dt="2022-04-22T00:34:27" v="263"/>
          <ac:spMkLst>
            <pc:docMk/>
            <pc:sldMasterMk cId="3643008945" sldId="2147483684"/>
            <ac:spMk id="7" creationId="{EB22633E-C8E8-4CB7-9F96-A88C0198C9C2}"/>
          </ac:spMkLst>
        </pc:spChg>
        <pc:spChg chg="add mod ord modVis">
          <ac:chgData name="Sameer G Joshi (DJPR)" userId="bd06337d-ce8c-4c34-b1d1-7fbf8f91b6eb" providerId="ADAL" clId="{E439969B-FA00-48CC-8739-0554D3941C45}" dt="2022-04-22T00:34:26.984" v="233"/>
          <ac:spMkLst>
            <pc:docMk/>
            <pc:sldMasterMk cId="3643008945" sldId="2147483684"/>
            <ac:spMk id="8" creationId="{5D49426D-3D5A-424E-9125-F12B43A3471C}"/>
          </ac:spMkLst>
        </pc:spChg>
        <pc:spChg chg="del">
          <ac:chgData name="Sameer G Joshi (DJPR)" userId="bd06337d-ce8c-4c34-b1d1-7fbf8f91b6eb" providerId="ADAL" clId="{E439969B-FA00-48CC-8739-0554D3941C45}" dt="2022-04-21T23:13:14.826" v="141"/>
          <ac:spMkLst>
            <pc:docMk/>
            <pc:sldMasterMk cId="3643008945" sldId="2147483684"/>
            <ac:spMk id="9" creationId="{486F4C76-40FB-F09D-548D-5F43BE3F8900}"/>
          </ac:spMkLst>
        </pc:spChg>
        <pc:spChg chg="del">
          <ac:chgData name="Sameer G Joshi (DJPR)" userId="bd06337d-ce8c-4c34-b1d1-7fbf8f91b6eb" providerId="ADAL" clId="{E439969B-FA00-48CC-8739-0554D3941C45}" dt="2022-04-21T23:13:14.826" v="139"/>
          <ac:spMkLst>
            <pc:docMk/>
            <pc:sldMasterMk cId="3643008945" sldId="2147483684"/>
            <ac:spMk id="10" creationId="{8DAD24F2-F946-C1BC-D312-28D6654BD15C}"/>
          </ac:spMkLst>
        </pc:spChg>
      </pc:sldMasterChg>
    </pc:docChg>
  </pc:docChgLst>
  <pc:docChgLst>
    <pc:chgData name="Garry M Rosewarne (DJPR)" userId="51564b9f-0e86-4dd8-9e91-f771a6d10681" providerId="ADAL" clId="{D2A48406-73AE-40CC-81FA-F34DF718EC3D}"/>
    <pc:docChg chg="custSel modSld">
      <pc:chgData name="Garry M Rosewarne (DJPR)" userId="51564b9f-0e86-4dd8-9e91-f771a6d10681" providerId="ADAL" clId="{D2A48406-73AE-40CC-81FA-F34DF718EC3D}" dt="2022-06-10T06:05:58.377" v="7"/>
      <pc:docMkLst>
        <pc:docMk/>
      </pc:docMkLst>
      <pc:sldChg chg="addCm modCm">
        <pc:chgData name="Garry M Rosewarne (DJPR)" userId="51564b9f-0e86-4dd8-9e91-f771a6d10681" providerId="ADAL" clId="{D2A48406-73AE-40CC-81FA-F34DF718EC3D}" dt="2022-06-10T06:05:58.377" v="7"/>
        <pc:sldMkLst>
          <pc:docMk/>
          <pc:sldMk cId="2000004557" sldId="260"/>
        </pc:sldMkLst>
      </pc:sldChg>
    </pc:docChg>
  </pc:docChgLst>
  <pc:docChgLst>
    <pc:chgData name="Sameer G Joshi (DJPR)" userId="bd06337d-ce8c-4c34-b1d1-7fbf8f91b6eb" providerId="ADAL" clId="{449E2AB2-FE71-461C-94D3-9E867087BE31}"/>
    <pc:docChg chg="undo redo custSel addSld modSld">
      <pc:chgData name="Sameer G Joshi (DJPR)" userId="bd06337d-ce8c-4c34-b1d1-7fbf8f91b6eb" providerId="ADAL" clId="{449E2AB2-FE71-461C-94D3-9E867087BE31}" dt="2021-04-16T04:11:50.598" v="2920" actId="27918"/>
      <pc:docMkLst>
        <pc:docMk/>
      </pc:docMkLst>
      <pc:sldChg chg="addSp delSp modSp new mod">
        <pc:chgData name="Sameer G Joshi (DJPR)" userId="bd06337d-ce8c-4c34-b1d1-7fbf8f91b6eb" providerId="ADAL" clId="{449E2AB2-FE71-461C-94D3-9E867087BE31}" dt="2021-03-21T11:32:49.558" v="2347" actId="692"/>
        <pc:sldMkLst>
          <pc:docMk/>
          <pc:sldMk cId="370308576" sldId="257"/>
        </pc:sldMkLst>
        <pc:spChg chg="del">
          <ac:chgData name="Sameer G Joshi (DJPR)" userId="bd06337d-ce8c-4c34-b1d1-7fbf8f91b6eb" providerId="ADAL" clId="{449E2AB2-FE71-461C-94D3-9E867087BE31}" dt="2021-03-19T04:28:05.910" v="1" actId="478"/>
          <ac:spMkLst>
            <pc:docMk/>
            <pc:sldMk cId="370308576" sldId="257"/>
            <ac:spMk id="2" creationId="{E52FE6C4-315F-406A-9BEC-0BDB76DB5366}"/>
          </ac:spMkLst>
        </pc:spChg>
        <pc:spChg chg="del">
          <ac:chgData name="Sameer G Joshi (DJPR)" userId="bd06337d-ce8c-4c34-b1d1-7fbf8f91b6eb" providerId="ADAL" clId="{449E2AB2-FE71-461C-94D3-9E867087BE31}" dt="2021-03-19T04:28:05.910" v="1" actId="478"/>
          <ac:spMkLst>
            <pc:docMk/>
            <pc:sldMk cId="370308576" sldId="257"/>
            <ac:spMk id="3" creationId="{4CEF30C8-EA87-42C1-A6A9-17C0B0AE2A85}"/>
          </ac:spMkLst>
        </pc:spChg>
        <pc:spChg chg="add mod">
          <ac:chgData name="Sameer G Joshi (DJPR)" userId="bd06337d-ce8c-4c34-b1d1-7fbf8f91b6eb" providerId="ADAL" clId="{449E2AB2-FE71-461C-94D3-9E867087BE31}" dt="2021-03-19T05:32:34.648" v="209" actId="1076"/>
          <ac:spMkLst>
            <pc:docMk/>
            <pc:sldMk cId="370308576" sldId="257"/>
            <ac:spMk id="5" creationId="{FE29ABBE-D0E7-4836-8A92-F70FBE6B7118}"/>
          </ac:spMkLst>
        </pc:spChg>
        <pc:spChg chg="add mod">
          <ac:chgData name="Sameer G Joshi (DJPR)" userId="bd06337d-ce8c-4c34-b1d1-7fbf8f91b6eb" providerId="ADAL" clId="{449E2AB2-FE71-461C-94D3-9E867087BE31}" dt="2021-03-19T05:34:25.058" v="230" actId="1076"/>
          <ac:spMkLst>
            <pc:docMk/>
            <pc:sldMk cId="370308576" sldId="257"/>
            <ac:spMk id="6" creationId="{6C719FE6-B23C-4502-9E7C-F3C21CE3933C}"/>
          </ac:spMkLst>
        </pc:spChg>
        <pc:spChg chg="add mod">
          <ac:chgData name="Sameer G Joshi (DJPR)" userId="bd06337d-ce8c-4c34-b1d1-7fbf8f91b6eb" providerId="ADAL" clId="{449E2AB2-FE71-461C-94D3-9E867087BE31}" dt="2021-03-19T05:34:04.990" v="218" actId="12788"/>
          <ac:spMkLst>
            <pc:docMk/>
            <pc:sldMk cId="370308576" sldId="257"/>
            <ac:spMk id="7" creationId="{B3A04D8B-AA8B-424A-9958-3046C6DEEB4B}"/>
          </ac:spMkLst>
        </pc:spChg>
        <pc:spChg chg="add mod">
          <ac:chgData name="Sameer G Joshi (DJPR)" userId="bd06337d-ce8c-4c34-b1d1-7fbf8f91b6eb" providerId="ADAL" clId="{449E2AB2-FE71-461C-94D3-9E867087BE31}" dt="2021-03-19T05:34:12.224" v="219" actId="1076"/>
          <ac:spMkLst>
            <pc:docMk/>
            <pc:sldMk cId="370308576" sldId="257"/>
            <ac:spMk id="9" creationId="{A7343642-E786-4F55-8323-A2489A7ACD1F}"/>
          </ac:spMkLst>
        </pc:spChg>
        <pc:spChg chg="add mod">
          <ac:chgData name="Sameer G Joshi (DJPR)" userId="bd06337d-ce8c-4c34-b1d1-7fbf8f91b6eb" providerId="ADAL" clId="{449E2AB2-FE71-461C-94D3-9E867087BE31}" dt="2021-03-19T05:34:17.664" v="229" actId="1035"/>
          <ac:spMkLst>
            <pc:docMk/>
            <pc:sldMk cId="370308576" sldId="257"/>
            <ac:spMk id="10" creationId="{C0048344-15C2-4E24-89E3-2DCD0B6FBC9D}"/>
          </ac:spMkLst>
        </pc:spChg>
        <pc:spChg chg="add mod">
          <ac:chgData name="Sameer G Joshi (DJPR)" userId="bd06337d-ce8c-4c34-b1d1-7fbf8f91b6eb" providerId="ADAL" clId="{449E2AB2-FE71-461C-94D3-9E867087BE31}" dt="2021-03-20T15:30:31.800" v="650" actId="114"/>
          <ac:spMkLst>
            <pc:docMk/>
            <pc:sldMk cId="370308576" sldId="257"/>
            <ac:spMk id="11" creationId="{A23CB308-B3A7-472D-94CB-A4661D696ED2}"/>
          </ac:spMkLst>
        </pc:spChg>
        <pc:spChg chg="add mod">
          <ac:chgData name="Sameer G Joshi (DJPR)" userId="bd06337d-ce8c-4c34-b1d1-7fbf8f91b6eb" providerId="ADAL" clId="{449E2AB2-FE71-461C-94D3-9E867087BE31}" dt="2021-03-21T10:44:26.385" v="1330" actId="255"/>
          <ac:spMkLst>
            <pc:docMk/>
            <pc:sldMk cId="370308576" sldId="257"/>
            <ac:spMk id="12" creationId="{CCE5C626-AE56-4E2C-87D8-9ADA7A00A9DF}"/>
          </ac:spMkLst>
        </pc:spChg>
        <pc:spChg chg="add mod">
          <ac:chgData name="Sameer G Joshi (DJPR)" userId="bd06337d-ce8c-4c34-b1d1-7fbf8f91b6eb" providerId="ADAL" clId="{449E2AB2-FE71-461C-94D3-9E867087BE31}" dt="2021-03-21T10:44:26.385" v="1330" actId="255"/>
          <ac:spMkLst>
            <pc:docMk/>
            <pc:sldMk cId="370308576" sldId="257"/>
            <ac:spMk id="13" creationId="{CED314A4-33B4-4BBB-9F19-7CCF07270BA3}"/>
          </ac:spMkLst>
        </pc:spChg>
        <pc:spChg chg="add mod">
          <ac:chgData name="Sameer G Joshi (DJPR)" userId="bd06337d-ce8c-4c34-b1d1-7fbf8f91b6eb" providerId="ADAL" clId="{449E2AB2-FE71-461C-94D3-9E867087BE31}" dt="2021-03-21T10:44:26.385" v="1330" actId="255"/>
          <ac:spMkLst>
            <pc:docMk/>
            <pc:sldMk cId="370308576" sldId="257"/>
            <ac:spMk id="14" creationId="{8CC81BD8-0953-43CC-9CA8-FEEBCBBDABD8}"/>
          </ac:spMkLst>
        </pc:spChg>
        <pc:spChg chg="add mod">
          <ac:chgData name="Sameer G Joshi (DJPR)" userId="bd06337d-ce8c-4c34-b1d1-7fbf8f91b6eb" providerId="ADAL" clId="{449E2AB2-FE71-461C-94D3-9E867087BE31}" dt="2021-03-21T10:44:26.385" v="1330" actId="255"/>
          <ac:spMkLst>
            <pc:docMk/>
            <pc:sldMk cId="370308576" sldId="257"/>
            <ac:spMk id="15" creationId="{602AA814-4DFA-491F-9C66-80D4C6E8955D}"/>
          </ac:spMkLst>
        </pc:spChg>
        <pc:spChg chg="add mod">
          <ac:chgData name="Sameer G Joshi (DJPR)" userId="bd06337d-ce8c-4c34-b1d1-7fbf8f91b6eb" providerId="ADAL" clId="{449E2AB2-FE71-461C-94D3-9E867087BE31}" dt="2021-03-21T10:44:26.385" v="1330" actId="255"/>
          <ac:spMkLst>
            <pc:docMk/>
            <pc:sldMk cId="370308576" sldId="257"/>
            <ac:spMk id="16" creationId="{8147E8C9-9A1A-496C-95A3-D0EC330C0968}"/>
          </ac:spMkLst>
        </pc:spChg>
        <pc:spChg chg="add mod">
          <ac:chgData name="Sameer G Joshi (DJPR)" userId="bd06337d-ce8c-4c34-b1d1-7fbf8f91b6eb" providerId="ADAL" clId="{449E2AB2-FE71-461C-94D3-9E867087BE31}" dt="2021-03-21T10:44:26.385" v="1330" actId="255"/>
          <ac:spMkLst>
            <pc:docMk/>
            <pc:sldMk cId="370308576" sldId="257"/>
            <ac:spMk id="17" creationId="{FFA0D330-5AE6-4088-87C8-4084CBA302B5}"/>
          </ac:spMkLst>
        </pc:spChg>
        <pc:spChg chg="add mod">
          <ac:chgData name="Sameer G Joshi (DJPR)" userId="bd06337d-ce8c-4c34-b1d1-7fbf8f91b6eb" providerId="ADAL" clId="{449E2AB2-FE71-461C-94D3-9E867087BE31}" dt="2021-03-21T10:44:26.385" v="1330" actId="255"/>
          <ac:spMkLst>
            <pc:docMk/>
            <pc:sldMk cId="370308576" sldId="257"/>
            <ac:spMk id="18" creationId="{2F8C8F51-7130-4AB3-BA68-D6492523E1AB}"/>
          </ac:spMkLst>
        </pc:spChg>
        <pc:spChg chg="add mod">
          <ac:chgData name="Sameer G Joshi (DJPR)" userId="bd06337d-ce8c-4c34-b1d1-7fbf8f91b6eb" providerId="ADAL" clId="{449E2AB2-FE71-461C-94D3-9E867087BE31}" dt="2021-03-21T10:44:26.385" v="1330" actId="255"/>
          <ac:spMkLst>
            <pc:docMk/>
            <pc:sldMk cId="370308576" sldId="257"/>
            <ac:spMk id="19" creationId="{16675909-BCE2-45A9-B1CC-BB3633368B30}"/>
          </ac:spMkLst>
        </pc:spChg>
        <pc:spChg chg="add mod">
          <ac:chgData name="Sameer G Joshi (DJPR)" userId="bd06337d-ce8c-4c34-b1d1-7fbf8f91b6eb" providerId="ADAL" clId="{449E2AB2-FE71-461C-94D3-9E867087BE31}" dt="2021-03-21T10:44:26.385" v="1330" actId="255"/>
          <ac:spMkLst>
            <pc:docMk/>
            <pc:sldMk cId="370308576" sldId="257"/>
            <ac:spMk id="20" creationId="{A912B59C-585F-4051-B646-698660255F40}"/>
          </ac:spMkLst>
        </pc:spChg>
        <pc:spChg chg="add mod">
          <ac:chgData name="Sameer G Joshi (DJPR)" userId="bd06337d-ce8c-4c34-b1d1-7fbf8f91b6eb" providerId="ADAL" clId="{449E2AB2-FE71-461C-94D3-9E867087BE31}" dt="2021-03-21T10:44:26.385" v="1330" actId="255"/>
          <ac:spMkLst>
            <pc:docMk/>
            <pc:sldMk cId="370308576" sldId="257"/>
            <ac:spMk id="21" creationId="{253D8772-DB97-47F1-AC2B-CD870B4ACB0E}"/>
          </ac:spMkLst>
        </pc:spChg>
        <pc:spChg chg="add mod">
          <ac:chgData name="Sameer G Joshi (DJPR)" userId="bd06337d-ce8c-4c34-b1d1-7fbf8f91b6eb" providerId="ADAL" clId="{449E2AB2-FE71-461C-94D3-9E867087BE31}" dt="2021-03-21T10:44:26.385" v="1330" actId="255"/>
          <ac:spMkLst>
            <pc:docMk/>
            <pc:sldMk cId="370308576" sldId="257"/>
            <ac:spMk id="22" creationId="{3E4301C3-7258-41C5-AF1A-551BB6BB26F4}"/>
          </ac:spMkLst>
        </pc:spChg>
        <pc:spChg chg="add mod">
          <ac:chgData name="Sameer G Joshi (DJPR)" userId="bd06337d-ce8c-4c34-b1d1-7fbf8f91b6eb" providerId="ADAL" clId="{449E2AB2-FE71-461C-94D3-9E867087BE31}" dt="2021-03-21T10:44:26.385" v="1330" actId="255"/>
          <ac:spMkLst>
            <pc:docMk/>
            <pc:sldMk cId="370308576" sldId="257"/>
            <ac:spMk id="23" creationId="{0B9F7579-86AF-4BAC-BD55-7089AB5AC9C0}"/>
          </ac:spMkLst>
        </pc:spChg>
        <pc:spChg chg="add mod">
          <ac:chgData name="Sameer G Joshi (DJPR)" userId="bd06337d-ce8c-4c34-b1d1-7fbf8f91b6eb" providerId="ADAL" clId="{449E2AB2-FE71-461C-94D3-9E867087BE31}" dt="2021-03-21T10:44:26.385" v="1330" actId="255"/>
          <ac:spMkLst>
            <pc:docMk/>
            <pc:sldMk cId="370308576" sldId="257"/>
            <ac:spMk id="24" creationId="{24B81FBE-5CC7-4E25-8711-768EB60890EB}"/>
          </ac:spMkLst>
        </pc:spChg>
        <pc:spChg chg="add mod">
          <ac:chgData name="Sameer G Joshi (DJPR)" userId="bd06337d-ce8c-4c34-b1d1-7fbf8f91b6eb" providerId="ADAL" clId="{449E2AB2-FE71-461C-94D3-9E867087BE31}" dt="2021-03-21T10:44:26.385" v="1330" actId="255"/>
          <ac:spMkLst>
            <pc:docMk/>
            <pc:sldMk cId="370308576" sldId="257"/>
            <ac:spMk id="25" creationId="{FB097C79-2461-44C7-8925-5D45175D3713}"/>
          </ac:spMkLst>
        </pc:spChg>
        <pc:spChg chg="add mod">
          <ac:chgData name="Sameer G Joshi (DJPR)" userId="bd06337d-ce8c-4c34-b1d1-7fbf8f91b6eb" providerId="ADAL" clId="{449E2AB2-FE71-461C-94D3-9E867087BE31}" dt="2021-03-21T10:44:26.385" v="1330" actId="255"/>
          <ac:spMkLst>
            <pc:docMk/>
            <pc:sldMk cId="370308576" sldId="257"/>
            <ac:spMk id="26" creationId="{31F3D738-C36D-40A2-AA11-4321D1BEDBE8}"/>
          </ac:spMkLst>
        </pc:spChg>
        <pc:spChg chg="add mod">
          <ac:chgData name="Sameer G Joshi (DJPR)" userId="bd06337d-ce8c-4c34-b1d1-7fbf8f91b6eb" providerId="ADAL" clId="{449E2AB2-FE71-461C-94D3-9E867087BE31}" dt="2021-03-21T10:44:26.385" v="1330" actId="255"/>
          <ac:spMkLst>
            <pc:docMk/>
            <pc:sldMk cId="370308576" sldId="257"/>
            <ac:spMk id="27" creationId="{4544EEAF-BED2-4F0E-BD0E-94953608A34B}"/>
          </ac:spMkLst>
        </pc:spChg>
        <pc:spChg chg="add mod">
          <ac:chgData name="Sameer G Joshi (DJPR)" userId="bd06337d-ce8c-4c34-b1d1-7fbf8f91b6eb" providerId="ADAL" clId="{449E2AB2-FE71-461C-94D3-9E867087BE31}" dt="2021-03-21T10:45:54.527" v="1420" actId="1037"/>
          <ac:spMkLst>
            <pc:docMk/>
            <pc:sldMk cId="370308576" sldId="257"/>
            <ac:spMk id="28" creationId="{5777B869-E785-4220-9D4A-07D406FDF7F8}"/>
          </ac:spMkLst>
        </pc:spChg>
        <pc:spChg chg="add mod">
          <ac:chgData name="Sameer G Joshi (DJPR)" userId="bd06337d-ce8c-4c34-b1d1-7fbf8f91b6eb" providerId="ADAL" clId="{449E2AB2-FE71-461C-94D3-9E867087BE31}" dt="2021-03-21T10:45:33.031" v="1367" actId="1036"/>
          <ac:spMkLst>
            <pc:docMk/>
            <pc:sldMk cId="370308576" sldId="257"/>
            <ac:spMk id="29" creationId="{0F896F8E-0040-48D5-B735-53650DC43D60}"/>
          </ac:spMkLst>
        </pc:spChg>
        <pc:spChg chg="add mod">
          <ac:chgData name="Sameer G Joshi (DJPR)" userId="bd06337d-ce8c-4c34-b1d1-7fbf8f91b6eb" providerId="ADAL" clId="{449E2AB2-FE71-461C-94D3-9E867087BE31}" dt="2021-03-21T10:45:43.341" v="1407" actId="1035"/>
          <ac:spMkLst>
            <pc:docMk/>
            <pc:sldMk cId="370308576" sldId="257"/>
            <ac:spMk id="30" creationId="{9EB07A2B-4FDD-4C52-A395-0DEB77613253}"/>
          </ac:spMkLst>
        </pc:spChg>
        <pc:spChg chg="add mod">
          <ac:chgData name="Sameer G Joshi (DJPR)" userId="bd06337d-ce8c-4c34-b1d1-7fbf8f91b6eb" providerId="ADAL" clId="{449E2AB2-FE71-461C-94D3-9E867087BE31}" dt="2021-03-21T10:46:29.411" v="1433" actId="1036"/>
          <ac:spMkLst>
            <pc:docMk/>
            <pc:sldMk cId="370308576" sldId="257"/>
            <ac:spMk id="31" creationId="{AA67D449-241E-41A5-AC28-8B3A0ECC8F69}"/>
          </ac:spMkLst>
        </pc:spChg>
        <pc:spChg chg="add mod">
          <ac:chgData name="Sameer G Joshi (DJPR)" userId="bd06337d-ce8c-4c34-b1d1-7fbf8f91b6eb" providerId="ADAL" clId="{449E2AB2-FE71-461C-94D3-9E867087BE31}" dt="2021-03-21T10:46:22.837" v="1426" actId="1076"/>
          <ac:spMkLst>
            <pc:docMk/>
            <pc:sldMk cId="370308576" sldId="257"/>
            <ac:spMk id="32" creationId="{8D1C2F28-3272-42A4-BAB5-72EFF9065B83}"/>
          </ac:spMkLst>
        </pc:spChg>
        <pc:spChg chg="add mod">
          <ac:chgData name="Sameer G Joshi (DJPR)" userId="bd06337d-ce8c-4c34-b1d1-7fbf8f91b6eb" providerId="ADAL" clId="{449E2AB2-FE71-461C-94D3-9E867087BE31}" dt="2021-03-21T10:46:49.770" v="1437" actId="14100"/>
          <ac:spMkLst>
            <pc:docMk/>
            <pc:sldMk cId="370308576" sldId="257"/>
            <ac:spMk id="33" creationId="{571A4912-C932-48F6-A7A0-344325095455}"/>
          </ac:spMkLst>
        </pc:spChg>
        <pc:spChg chg="add mod">
          <ac:chgData name="Sameer G Joshi (DJPR)" userId="bd06337d-ce8c-4c34-b1d1-7fbf8f91b6eb" providerId="ADAL" clId="{449E2AB2-FE71-461C-94D3-9E867087BE31}" dt="2021-03-21T10:46:57.748" v="1439" actId="1076"/>
          <ac:spMkLst>
            <pc:docMk/>
            <pc:sldMk cId="370308576" sldId="257"/>
            <ac:spMk id="34" creationId="{DBB87338-4D65-4986-B274-EE13427C59FD}"/>
          </ac:spMkLst>
        </pc:spChg>
        <pc:spChg chg="add mod">
          <ac:chgData name="Sameer G Joshi (DJPR)" userId="bd06337d-ce8c-4c34-b1d1-7fbf8f91b6eb" providerId="ADAL" clId="{449E2AB2-FE71-461C-94D3-9E867087BE31}" dt="2021-03-21T10:47:13.356" v="1443" actId="14100"/>
          <ac:spMkLst>
            <pc:docMk/>
            <pc:sldMk cId="370308576" sldId="257"/>
            <ac:spMk id="35" creationId="{61DB5F7C-A07B-40A5-A844-88AE3E9EED89}"/>
          </ac:spMkLst>
        </pc:spChg>
        <pc:spChg chg="add mod">
          <ac:chgData name="Sameer G Joshi (DJPR)" userId="bd06337d-ce8c-4c34-b1d1-7fbf8f91b6eb" providerId="ADAL" clId="{449E2AB2-FE71-461C-94D3-9E867087BE31}" dt="2021-03-21T10:47:23.725" v="1445" actId="1076"/>
          <ac:spMkLst>
            <pc:docMk/>
            <pc:sldMk cId="370308576" sldId="257"/>
            <ac:spMk id="36" creationId="{92FD7434-4BFA-4582-B065-58738E89C410}"/>
          </ac:spMkLst>
        </pc:spChg>
        <pc:spChg chg="add mod">
          <ac:chgData name="Sameer G Joshi (DJPR)" userId="bd06337d-ce8c-4c34-b1d1-7fbf8f91b6eb" providerId="ADAL" clId="{449E2AB2-FE71-461C-94D3-9E867087BE31}" dt="2021-03-21T10:47:48.666" v="1449" actId="14100"/>
          <ac:spMkLst>
            <pc:docMk/>
            <pc:sldMk cId="370308576" sldId="257"/>
            <ac:spMk id="37" creationId="{45745397-5F22-4FFA-9441-FA1FE1DE28BF}"/>
          </ac:spMkLst>
        </pc:spChg>
        <pc:spChg chg="add mod">
          <ac:chgData name="Sameer G Joshi (DJPR)" userId="bd06337d-ce8c-4c34-b1d1-7fbf8f91b6eb" providerId="ADAL" clId="{449E2AB2-FE71-461C-94D3-9E867087BE31}" dt="2021-03-21T10:47:55.254" v="1451" actId="1076"/>
          <ac:spMkLst>
            <pc:docMk/>
            <pc:sldMk cId="370308576" sldId="257"/>
            <ac:spMk id="38" creationId="{563914C8-B85A-4815-AF07-E7764F927372}"/>
          </ac:spMkLst>
        </pc:spChg>
        <pc:spChg chg="add mod">
          <ac:chgData name="Sameer G Joshi (DJPR)" userId="bd06337d-ce8c-4c34-b1d1-7fbf8f91b6eb" providerId="ADAL" clId="{449E2AB2-FE71-461C-94D3-9E867087BE31}" dt="2021-03-21T10:48:11.649" v="1458" actId="1036"/>
          <ac:spMkLst>
            <pc:docMk/>
            <pc:sldMk cId="370308576" sldId="257"/>
            <ac:spMk id="39" creationId="{D94D0E7E-0778-4B4E-A4D2-09EA1C4C65D6}"/>
          </ac:spMkLst>
        </pc:spChg>
        <pc:spChg chg="add mod">
          <ac:chgData name="Sameer G Joshi (DJPR)" userId="bd06337d-ce8c-4c34-b1d1-7fbf8f91b6eb" providerId="ADAL" clId="{449E2AB2-FE71-461C-94D3-9E867087BE31}" dt="2021-03-21T10:48:24.763" v="1461" actId="20577"/>
          <ac:spMkLst>
            <pc:docMk/>
            <pc:sldMk cId="370308576" sldId="257"/>
            <ac:spMk id="40" creationId="{064D5353-18FD-41C9-B03B-67B53FAB85AA}"/>
          </ac:spMkLst>
        </pc:spChg>
        <pc:spChg chg="add mod">
          <ac:chgData name="Sameer G Joshi (DJPR)" userId="bd06337d-ce8c-4c34-b1d1-7fbf8f91b6eb" providerId="ADAL" clId="{449E2AB2-FE71-461C-94D3-9E867087BE31}" dt="2021-03-21T10:48:54.585" v="1465" actId="14100"/>
          <ac:spMkLst>
            <pc:docMk/>
            <pc:sldMk cId="370308576" sldId="257"/>
            <ac:spMk id="41" creationId="{37855EC7-E404-4180-8DE4-93C08B14E7BA}"/>
          </ac:spMkLst>
        </pc:spChg>
        <pc:spChg chg="add mod">
          <ac:chgData name="Sameer G Joshi (DJPR)" userId="bd06337d-ce8c-4c34-b1d1-7fbf8f91b6eb" providerId="ADAL" clId="{449E2AB2-FE71-461C-94D3-9E867087BE31}" dt="2021-03-21T10:49:01.692" v="1467" actId="1076"/>
          <ac:spMkLst>
            <pc:docMk/>
            <pc:sldMk cId="370308576" sldId="257"/>
            <ac:spMk id="42" creationId="{CA519B19-D77A-4460-AC1E-71C6DCA3D455}"/>
          </ac:spMkLst>
        </pc:spChg>
        <pc:spChg chg="add mod">
          <ac:chgData name="Sameer G Joshi (DJPR)" userId="bd06337d-ce8c-4c34-b1d1-7fbf8f91b6eb" providerId="ADAL" clId="{449E2AB2-FE71-461C-94D3-9E867087BE31}" dt="2021-03-21T10:49:16.572" v="1471" actId="14100"/>
          <ac:spMkLst>
            <pc:docMk/>
            <pc:sldMk cId="370308576" sldId="257"/>
            <ac:spMk id="43" creationId="{C342B2FA-1425-4F9E-85BA-AD31D1DA9190}"/>
          </ac:spMkLst>
        </pc:spChg>
        <pc:graphicFrameChg chg="add mod">
          <ac:chgData name="Sameer G Joshi (DJPR)" userId="bd06337d-ce8c-4c34-b1d1-7fbf8f91b6eb" providerId="ADAL" clId="{449E2AB2-FE71-461C-94D3-9E867087BE31}" dt="2021-03-21T11:32:35.698" v="2341" actId="692"/>
          <ac:graphicFrameMkLst>
            <pc:docMk/>
            <pc:sldMk cId="370308576" sldId="257"/>
            <ac:graphicFrameMk id="4" creationId="{B82E53B8-98C2-4BD0-9E22-B3DEFB498CD2}"/>
          </ac:graphicFrameMkLst>
        </pc:graphicFrameChg>
        <pc:graphicFrameChg chg="add mod">
          <ac:chgData name="Sameer G Joshi (DJPR)" userId="bd06337d-ce8c-4c34-b1d1-7fbf8f91b6eb" providerId="ADAL" clId="{449E2AB2-FE71-461C-94D3-9E867087BE31}" dt="2021-03-21T11:32:49.558" v="2347" actId="692"/>
          <ac:graphicFrameMkLst>
            <pc:docMk/>
            <pc:sldMk cId="370308576" sldId="257"/>
            <ac:graphicFrameMk id="8" creationId="{58FAD2E8-E208-4375-A008-D095BAE3DE07}"/>
          </ac:graphicFrameMkLst>
        </pc:graphicFrameChg>
      </pc:sldChg>
      <pc:sldChg chg="addSp delSp modSp new mod">
        <pc:chgData name="Sameer G Joshi (DJPR)" userId="bd06337d-ce8c-4c34-b1d1-7fbf8f91b6eb" providerId="ADAL" clId="{449E2AB2-FE71-461C-94D3-9E867087BE31}" dt="2021-04-16T04:11:50.598" v="2920" actId="27918"/>
        <pc:sldMkLst>
          <pc:docMk/>
          <pc:sldMk cId="2203674866" sldId="258"/>
        </pc:sldMkLst>
        <pc:spChg chg="del">
          <ac:chgData name="Sameer G Joshi (DJPR)" userId="bd06337d-ce8c-4c34-b1d1-7fbf8f91b6eb" providerId="ADAL" clId="{449E2AB2-FE71-461C-94D3-9E867087BE31}" dt="2021-03-20T14:57:59.337" v="235" actId="478"/>
          <ac:spMkLst>
            <pc:docMk/>
            <pc:sldMk cId="2203674866" sldId="258"/>
            <ac:spMk id="2" creationId="{12160F93-5479-4A8E-9D98-B3EA243F005F}"/>
          </ac:spMkLst>
        </pc:spChg>
        <pc:spChg chg="del">
          <ac:chgData name="Sameer G Joshi (DJPR)" userId="bd06337d-ce8c-4c34-b1d1-7fbf8f91b6eb" providerId="ADAL" clId="{449E2AB2-FE71-461C-94D3-9E867087BE31}" dt="2021-03-20T14:57:59.337" v="235" actId="478"/>
          <ac:spMkLst>
            <pc:docMk/>
            <pc:sldMk cId="2203674866" sldId="258"/>
            <ac:spMk id="3" creationId="{89906324-DDB5-44E5-BD12-0177E70D008F}"/>
          </ac:spMkLst>
        </pc:spChg>
        <pc:spChg chg="add mod">
          <ac:chgData name="Sameer G Joshi (DJPR)" userId="bd06337d-ce8c-4c34-b1d1-7fbf8f91b6eb" providerId="ADAL" clId="{449E2AB2-FE71-461C-94D3-9E867087BE31}" dt="2021-03-20T15:39:33.175" v="883" actId="1036"/>
          <ac:spMkLst>
            <pc:docMk/>
            <pc:sldMk cId="2203674866" sldId="258"/>
            <ac:spMk id="5" creationId="{C1C7D342-C5AF-4282-A34C-A99726B755CD}"/>
          </ac:spMkLst>
        </pc:spChg>
        <pc:spChg chg="add mod">
          <ac:chgData name="Sameer G Joshi (DJPR)" userId="bd06337d-ce8c-4c34-b1d1-7fbf8f91b6eb" providerId="ADAL" clId="{449E2AB2-FE71-461C-94D3-9E867087BE31}" dt="2021-03-20T15:38:38.818" v="814" actId="1076"/>
          <ac:spMkLst>
            <pc:docMk/>
            <pc:sldMk cId="2203674866" sldId="258"/>
            <ac:spMk id="6" creationId="{CF2FA352-EA4B-48AA-BCD9-0B5D417DE429}"/>
          </ac:spMkLst>
        </pc:spChg>
        <pc:spChg chg="add del mod">
          <ac:chgData name="Sameer G Joshi (DJPR)" userId="bd06337d-ce8c-4c34-b1d1-7fbf8f91b6eb" providerId="ADAL" clId="{449E2AB2-FE71-461C-94D3-9E867087BE31}" dt="2021-03-20T15:39:33.175" v="883" actId="1036"/>
          <ac:spMkLst>
            <pc:docMk/>
            <pc:sldMk cId="2203674866" sldId="258"/>
            <ac:spMk id="11" creationId="{F47A1C11-6121-479E-999B-743F8B3B0102}"/>
          </ac:spMkLst>
        </pc:spChg>
        <pc:spChg chg="add mod">
          <ac:chgData name="Sameer G Joshi (DJPR)" userId="bd06337d-ce8c-4c34-b1d1-7fbf8f91b6eb" providerId="ADAL" clId="{449E2AB2-FE71-461C-94D3-9E867087BE31}" dt="2021-03-20T15:39:33.175" v="883" actId="1036"/>
          <ac:spMkLst>
            <pc:docMk/>
            <pc:sldMk cId="2203674866" sldId="258"/>
            <ac:spMk id="12" creationId="{39B48064-32AF-488B-A4AC-5E955AE5DC19}"/>
          </ac:spMkLst>
        </pc:spChg>
        <pc:spChg chg="add mod">
          <ac:chgData name="Sameer G Joshi (DJPR)" userId="bd06337d-ce8c-4c34-b1d1-7fbf8f91b6eb" providerId="ADAL" clId="{449E2AB2-FE71-461C-94D3-9E867087BE31}" dt="2021-03-20T15:39:33.175" v="883" actId="1036"/>
          <ac:spMkLst>
            <pc:docMk/>
            <pc:sldMk cId="2203674866" sldId="258"/>
            <ac:spMk id="13" creationId="{166DCA8E-895F-42C9-8D34-A942C93FDA3E}"/>
          </ac:spMkLst>
        </pc:spChg>
        <pc:spChg chg="add mod">
          <ac:chgData name="Sameer G Joshi (DJPR)" userId="bd06337d-ce8c-4c34-b1d1-7fbf8f91b6eb" providerId="ADAL" clId="{449E2AB2-FE71-461C-94D3-9E867087BE31}" dt="2021-03-20T15:39:33.175" v="883" actId="1036"/>
          <ac:spMkLst>
            <pc:docMk/>
            <pc:sldMk cId="2203674866" sldId="258"/>
            <ac:spMk id="14" creationId="{1A4BC8A9-00C7-4001-9DA9-3C8D33C7C327}"/>
          </ac:spMkLst>
        </pc:spChg>
        <pc:spChg chg="add del mod">
          <ac:chgData name="Sameer G Joshi (DJPR)" userId="bd06337d-ce8c-4c34-b1d1-7fbf8f91b6eb" providerId="ADAL" clId="{449E2AB2-FE71-461C-94D3-9E867087BE31}" dt="2021-03-20T15:30:49.978" v="651" actId="478"/>
          <ac:spMkLst>
            <pc:docMk/>
            <pc:sldMk cId="2203674866" sldId="258"/>
            <ac:spMk id="15" creationId="{E70A30B7-3852-4C00-9078-D684DE7F98B9}"/>
          </ac:spMkLst>
        </pc:spChg>
        <pc:spChg chg="add mod">
          <ac:chgData name="Sameer G Joshi (DJPR)" userId="bd06337d-ce8c-4c34-b1d1-7fbf8f91b6eb" providerId="ADAL" clId="{449E2AB2-FE71-461C-94D3-9E867087BE31}" dt="2021-03-20T15:15:20.857" v="477"/>
          <ac:spMkLst>
            <pc:docMk/>
            <pc:sldMk cId="2203674866" sldId="258"/>
            <ac:spMk id="16" creationId="{25B65A05-F4D7-4A73-94C3-EFF9E3C8BC70}"/>
          </ac:spMkLst>
        </pc:spChg>
        <pc:spChg chg="add mod">
          <ac:chgData name="Sameer G Joshi (DJPR)" userId="bd06337d-ce8c-4c34-b1d1-7fbf8f91b6eb" providerId="ADAL" clId="{449E2AB2-FE71-461C-94D3-9E867087BE31}" dt="2021-03-20T15:39:33.175" v="883" actId="1036"/>
          <ac:spMkLst>
            <pc:docMk/>
            <pc:sldMk cId="2203674866" sldId="258"/>
            <ac:spMk id="17" creationId="{C87AED42-E587-4B6F-8ABA-76C8FE76E503}"/>
          </ac:spMkLst>
        </pc:spChg>
        <pc:spChg chg="add del mod">
          <ac:chgData name="Sameer G Joshi (DJPR)" userId="bd06337d-ce8c-4c34-b1d1-7fbf8f91b6eb" providerId="ADAL" clId="{449E2AB2-FE71-461C-94D3-9E867087BE31}" dt="2021-03-20T15:31:38.323" v="676" actId="478"/>
          <ac:spMkLst>
            <pc:docMk/>
            <pc:sldMk cId="2203674866" sldId="258"/>
            <ac:spMk id="18" creationId="{2E633813-4897-47DD-99C1-5BE0C6809452}"/>
          </ac:spMkLst>
        </pc:spChg>
        <pc:spChg chg="add mod">
          <ac:chgData name="Sameer G Joshi (DJPR)" userId="bd06337d-ce8c-4c34-b1d1-7fbf8f91b6eb" providerId="ADAL" clId="{449E2AB2-FE71-461C-94D3-9E867087BE31}" dt="2021-03-20T15:39:38.697" v="894" actId="1036"/>
          <ac:spMkLst>
            <pc:docMk/>
            <pc:sldMk cId="2203674866" sldId="258"/>
            <ac:spMk id="19" creationId="{106A8FBD-909B-4774-B43F-1FC484A71BE3}"/>
          </ac:spMkLst>
        </pc:spChg>
        <pc:graphicFrameChg chg="add mod">
          <ac:chgData name="Sameer G Joshi (DJPR)" userId="bd06337d-ce8c-4c34-b1d1-7fbf8f91b6eb" providerId="ADAL" clId="{449E2AB2-FE71-461C-94D3-9E867087BE31}" dt="2021-03-21T11:32:17.871" v="2335" actId="692"/>
          <ac:graphicFrameMkLst>
            <pc:docMk/>
            <pc:sldMk cId="2203674866" sldId="258"/>
            <ac:graphicFrameMk id="4" creationId="{420D9C9C-6635-4308-B32A-F1C1403CACCA}"/>
          </ac:graphicFrameMkLst>
        </pc:graphicFrameChg>
        <pc:picChg chg="add del mod">
          <ac:chgData name="Sameer G Joshi (DJPR)" userId="bd06337d-ce8c-4c34-b1d1-7fbf8f91b6eb" providerId="ADAL" clId="{449E2AB2-FE71-461C-94D3-9E867087BE31}" dt="2021-03-20T15:02:01.852" v="330" actId="478"/>
          <ac:picMkLst>
            <pc:docMk/>
            <pc:sldMk cId="2203674866" sldId="258"/>
            <ac:picMk id="8" creationId="{EE78C72D-61CF-43E3-9979-3BBCC366FE99}"/>
          </ac:picMkLst>
        </pc:picChg>
        <pc:picChg chg="add mod modCrop">
          <ac:chgData name="Sameer G Joshi (DJPR)" userId="bd06337d-ce8c-4c34-b1d1-7fbf8f91b6eb" providerId="ADAL" clId="{449E2AB2-FE71-461C-94D3-9E867087BE31}" dt="2021-03-20T15:39:33.175" v="883" actId="1036"/>
          <ac:picMkLst>
            <pc:docMk/>
            <pc:sldMk cId="2203674866" sldId="258"/>
            <ac:picMk id="10" creationId="{981463CE-92E3-455D-B01F-2BD9BBE3F108}"/>
          </ac:picMkLst>
        </pc:picChg>
      </pc:sldChg>
      <pc:sldChg chg="addSp delSp modSp new mod">
        <pc:chgData name="Sameer G Joshi (DJPR)" userId="bd06337d-ce8c-4c34-b1d1-7fbf8f91b6eb" providerId="ADAL" clId="{449E2AB2-FE71-461C-94D3-9E867087BE31}" dt="2021-03-21T12:12:10.128" v="2717" actId="1035"/>
        <pc:sldMkLst>
          <pc:docMk/>
          <pc:sldMk cId="424659793" sldId="259"/>
        </pc:sldMkLst>
        <pc:spChg chg="del">
          <ac:chgData name="Sameer G Joshi (DJPR)" userId="bd06337d-ce8c-4c34-b1d1-7fbf8f91b6eb" providerId="ADAL" clId="{449E2AB2-FE71-461C-94D3-9E867087BE31}" dt="2021-03-21T10:52:21.871" v="1473" actId="478"/>
          <ac:spMkLst>
            <pc:docMk/>
            <pc:sldMk cId="424659793" sldId="259"/>
            <ac:spMk id="2" creationId="{2EFC474D-2C51-4885-BEF3-A3BF60265261}"/>
          </ac:spMkLst>
        </pc:spChg>
        <pc:spChg chg="del">
          <ac:chgData name="Sameer G Joshi (DJPR)" userId="bd06337d-ce8c-4c34-b1d1-7fbf8f91b6eb" providerId="ADAL" clId="{449E2AB2-FE71-461C-94D3-9E867087BE31}" dt="2021-03-21T10:52:21.871" v="1473" actId="478"/>
          <ac:spMkLst>
            <pc:docMk/>
            <pc:sldMk cId="424659793" sldId="259"/>
            <ac:spMk id="3" creationId="{F66B3938-7791-49B6-ABA0-321B2CD9DE40}"/>
          </ac:spMkLst>
        </pc:spChg>
        <pc:spChg chg="add mod">
          <ac:chgData name="Sameer G Joshi (DJPR)" userId="bd06337d-ce8c-4c34-b1d1-7fbf8f91b6eb" providerId="ADAL" clId="{449E2AB2-FE71-461C-94D3-9E867087BE31}" dt="2021-03-21T11:18:51.485" v="2244" actId="1035"/>
          <ac:spMkLst>
            <pc:docMk/>
            <pc:sldMk cId="424659793" sldId="259"/>
            <ac:spMk id="14" creationId="{DCD7250A-AE64-4AE7-8AC4-447D72E13899}"/>
          </ac:spMkLst>
        </pc:spChg>
        <pc:spChg chg="add mod">
          <ac:chgData name="Sameer G Joshi (DJPR)" userId="bd06337d-ce8c-4c34-b1d1-7fbf8f91b6eb" providerId="ADAL" clId="{449E2AB2-FE71-461C-94D3-9E867087BE31}" dt="2021-03-21T11:18:51.485" v="2244" actId="1035"/>
          <ac:spMkLst>
            <pc:docMk/>
            <pc:sldMk cId="424659793" sldId="259"/>
            <ac:spMk id="15" creationId="{2CDFF904-DC94-4136-A2FA-998A5710B95E}"/>
          </ac:spMkLst>
        </pc:spChg>
        <pc:spChg chg="add mod">
          <ac:chgData name="Sameer G Joshi (DJPR)" userId="bd06337d-ce8c-4c34-b1d1-7fbf8f91b6eb" providerId="ADAL" clId="{449E2AB2-FE71-461C-94D3-9E867087BE31}" dt="2021-03-21T11:18:51.485" v="2244" actId="1035"/>
          <ac:spMkLst>
            <pc:docMk/>
            <pc:sldMk cId="424659793" sldId="259"/>
            <ac:spMk id="16" creationId="{C72024A2-A6AC-4852-85CC-C8585BC01007}"/>
          </ac:spMkLst>
        </pc:spChg>
        <pc:spChg chg="add mod">
          <ac:chgData name="Sameer G Joshi (DJPR)" userId="bd06337d-ce8c-4c34-b1d1-7fbf8f91b6eb" providerId="ADAL" clId="{449E2AB2-FE71-461C-94D3-9E867087BE31}" dt="2021-03-21T11:18:51.485" v="2244" actId="1035"/>
          <ac:spMkLst>
            <pc:docMk/>
            <pc:sldMk cId="424659793" sldId="259"/>
            <ac:spMk id="17" creationId="{40081187-1F92-417A-B8DE-50F1A0239FEB}"/>
          </ac:spMkLst>
        </pc:spChg>
        <pc:spChg chg="add mod">
          <ac:chgData name="Sameer G Joshi (DJPR)" userId="bd06337d-ce8c-4c34-b1d1-7fbf8f91b6eb" providerId="ADAL" clId="{449E2AB2-FE71-461C-94D3-9E867087BE31}" dt="2021-03-21T11:18:51.485" v="2244" actId="1035"/>
          <ac:spMkLst>
            <pc:docMk/>
            <pc:sldMk cId="424659793" sldId="259"/>
            <ac:spMk id="18" creationId="{F134EDC0-26BB-46FC-9913-81B80CBDE563}"/>
          </ac:spMkLst>
        </pc:spChg>
        <pc:spChg chg="add mod">
          <ac:chgData name="Sameer G Joshi (DJPR)" userId="bd06337d-ce8c-4c34-b1d1-7fbf8f91b6eb" providerId="ADAL" clId="{449E2AB2-FE71-461C-94D3-9E867087BE31}" dt="2021-03-21T11:18:51.485" v="2244" actId="1035"/>
          <ac:spMkLst>
            <pc:docMk/>
            <pc:sldMk cId="424659793" sldId="259"/>
            <ac:spMk id="19" creationId="{D4257AF1-0BDB-48E1-B152-19CF54928A63}"/>
          </ac:spMkLst>
        </pc:spChg>
        <pc:spChg chg="add mod">
          <ac:chgData name="Sameer G Joshi (DJPR)" userId="bd06337d-ce8c-4c34-b1d1-7fbf8f91b6eb" providerId="ADAL" clId="{449E2AB2-FE71-461C-94D3-9E867087BE31}" dt="2021-03-21T11:18:51.485" v="2244" actId="1035"/>
          <ac:spMkLst>
            <pc:docMk/>
            <pc:sldMk cId="424659793" sldId="259"/>
            <ac:spMk id="20" creationId="{E4C5A3CE-82FA-4F04-A686-770C1652DD38}"/>
          </ac:spMkLst>
        </pc:spChg>
        <pc:spChg chg="add mod">
          <ac:chgData name="Sameer G Joshi (DJPR)" userId="bd06337d-ce8c-4c34-b1d1-7fbf8f91b6eb" providerId="ADAL" clId="{449E2AB2-FE71-461C-94D3-9E867087BE31}" dt="2021-03-21T11:18:51.485" v="2244" actId="1035"/>
          <ac:spMkLst>
            <pc:docMk/>
            <pc:sldMk cId="424659793" sldId="259"/>
            <ac:spMk id="21" creationId="{34C3EEAE-D391-43F5-8D3F-FD32A2F9807E}"/>
          </ac:spMkLst>
        </pc:spChg>
        <pc:spChg chg="add del mod">
          <ac:chgData name="Sameer G Joshi (DJPR)" userId="bd06337d-ce8c-4c34-b1d1-7fbf8f91b6eb" providerId="ADAL" clId="{449E2AB2-FE71-461C-94D3-9E867087BE31}" dt="2021-03-21T11:07:05.776" v="1851" actId="478"/>
          <ac:spMkLst>
            <pc:docMk/>
            <pc:sldMk cId="424659793" sldId="259"/>
            <ac:spMk id="22" creationId="{17FCBB73-313F-4669-A871-D4FC6405BE4F}"/>
          </ac:spMkLst>
        </pc:spChg>
        <pc:spChg chg="add del mod">
          <ac:chgData name="Sameer G Joshi (DJPR)" userId="bd06337d-ce8c-4c34-b1d1-7fbf8f91b6eb" providerId="ADAL" clId="{449E2AB2-FE71-461C-94D3-9E867087BE31}" dt="2021-03-21T11:07:05.776" v="1851" actId="478"/>
          <ac:spMkLst>
            <pc:docMk/>
            <pc:sldMk cId="424659793" sldId="259"/>
            <ac:spMk id="23" creationId="{FEB4E449-5BD6-4AF6-B6E2-08C59B7BDF17}"/>
          </ac:spMkLst>
        </pc:spChg>
        <pc:spChg chg="add del mod">
          <ac:chgData name="Sameer G Joshi (DJPR)" userId="bd06337d-ce8c-4c34-b1d1-7fbf8f91b6eb" providerId="ADAL" clId="{449E2AB2-FE71-461C-94D3-9E867087BE31}" dt="2021-03-21T11:07:05.776" v="1851" actId="478"/>
          <ac:spMkLst>
            <pc:docMk/>
            <pc:sldMk cId="424659793" sldId="259"/>
            <ac:spMk id="24" creationId="{C7E803EA-7243-4265-A24F-4D1796B20D86}"/>
          </ac:spMkLst>
        </pc:spChg>
        <pc:spChg chg="add del mod">
          <ac:chgData name="Sameer G Joshi (DJPR)" userId="bd06337d-ce8c-4c34-b1d1-7fbf8f91b6eb" providerId="ADAL" clId="{449E2AB2-FE71-461C-94D3-9E867087BE31}" dt="2021-03-21T11:07:05.776" v="1851" actId="478"/>
          <ac:spMkLst>
            <pc:docMk/>
            <pc:sldMk cId="424659793" sldId="259"/>
            <ac:spMk id="25" creationId="{7B69CE77-7713-4E1B-AFC8-E3FCADC91D70}"/>
          </ac:spMkLst>
        </pc:spChg>
        <pc:spChg chg="add del mod">
          <ac:chgData name="Sameer G Joshi (DJPR)" userId="bd06337d-ce8c-4c34-b1d1-7fbf8f91b6eb" providerId="ADAL" clId="{449E2AB2-FE71-461C-94D3-9E867087BE31}" dt="2021-03-21T11:17:26.025" v="2187" actId="478"/>
          <ac:spMkLst>
            <pc:docMk/>
            <pc:sldMk cId="424659793" sldId="259"/>
            <ac:spMk id="26" creationId="{09172B0A-C598-45AF-A7F0-6108E9FB04DF}"/>
          </ac:spMkLst>
        </pc:spChg>
        <pc:spChg chg="add del mod">
          <ac:chgData name="Sameer G Joshi (DJPR)" userId="bd06337d-ce8c-4c34-b1d1-7fbf8f91b6eb" providerId="ADAL" clId="{449E2AB2-FE71-461C-94D3-9E867087BE31}" dt="2021-03-21T11:17:26.025" v="2187" actId="478"/>
          <ac:spMkLst>
            <pc:docMk/>
            <pc:sldMk cId="424659793" sldId="259"/>
            <ac:spMk id="27" creationId="{9612AA3B-3199-42F0-86D4-112B6E7731CA}"/>
          </ac:spMkLst>
        </pc:spChg>
        <pc:spChg chg="add del mod">
          <ac:chgData name="Sameer G Joshi (DJPR)" userId="bd06337d-ce8c-4c34-b1d1-7fbf8f91b6eb" providerId="ADAL" clId="{449E2AB2-FE71-461C-94D3-9E867087BE31}" dt="2021-03-21T11:17:26.025" v="2187" actId="478"/>
          <ac:spMkLst>
            <pc:docMk/>
            <pc:sldMk cId="424659793" sldId="259"/>
            <ac:spMk id="28" creationId="{889612D5-4CDD-4714-B72B-65528122E7BE}"/>
          </ac:spMkLst>
        </pc:spChg>
        <pc:spChg chg="add del mod">
          <ac:chgData name="Sameer G Joshi (DJPR)" userId="bd06337d-ce8c-4c34-b1d1-7fbf8f91b6eb" providerId="ADAL" clId="{449E2AB2-FE71-461C-94D3-9E867087BE31}" dt="2021-03-21T11:17:26.025" v="2187" actId="478"/>
          <ac:spMkLst>
            <pc:docMk/>
            <pc:sldMk cId="424659793" sldId="259"/>
            <ac:spMk id="29" creationId="{3B8DD698-0D07-4724-BC80-0D894C958F73}"/>
          </ac:spMkLst>
        </pc:spChg>
        <pc:spChg chg="add del mod">
          <ac:chgData name="Sameer G Joshi (DJPR)" userId="bd06337d-ce8c-4c34-b1d1-7fbf8f91b6eb" providerId="ADAL" clId="{449E2AB2-FE71-461C-94D3-9E867087BE31}" dt="2021-03-21T11:11:44.021" v="2021" actId="478"/>
          <ac:spMkLst>
            <pc:docMk/>
            <pc:sldMk cId="424659793" sldId="259"/>
            <ac:spMk id="40" creationId="{C0D8D311-9947-4D1F-84B5-F5A547FBDCB1}"/>
          </ac:spMkLst>
        </pc:spChg>
        <pc:spChg chg="add del mod">
          <ac:chgData name="Sameer G Joshi (DJPR)" userId="bd06337d-ce8c-4c34-b1d1-7fbf8f91b6eb" providerId="ADAL" clId="{449E2AB2-FE71-461C-94D3-9E867087BE31}" dt="2021-03-21T11:11:44.021" v="2021" actId="478"/>
          <ac:spMkLst>
            <pc:docMk/>
            <pc:sldMk cId="424659793" sldId="259"/>
            <ac:spMk id="41" creationId="{6FDA45B3-E327-450F-B77C-1A9DE7FAB783}"/>
          </ac:spMkLst>
        </pc:spChg>
        <pc:spChg chg="add del mod">
          <ac:chgData name="Sameer G Joshi (DJPR)" userId="bd06337d-ce8c-4c34-b1d1-7fbf8f91b6eb" providerId="ADAL" clId="{449E2AB2-FE71-461C-94D3-9E867087BE31}" dt="2021-03-21T11:14:26.130" v="2074" actId="478"/>
          <ac:spMkLst>
            <pc:docMk/>
            <pc:sldMk cId="424659793" sldId="259"/>
            <ac:spMk id="42" creationId="{632B9357-1464-4A9E-993E-DD19CB2E0E3C}"/>
          </ac:spMkLst>
        </pc:spChg>
        <pc:spChg chg="add del mod">
          <ac:chgData name="Sameer G Joshi (DJPR)" userId="bd06337d-ce8c-4c34-b1d1-7fbf8f91b6eb" providerId="ADAL" clId="{449E2AB2-FE71-461C-94D3-9E867087BE31}" dt="2021-03-21T11:14:26.130" v="2074" actId="478"/>
          <ac:spMkLst>
            <pc:docMk/>
            <pc:sldMk cId="424659793" sldId="259"/>
            <ac:spMk id="43" creationId="{1375A7D9-0884-40CF-9003-460B5E9F4686}"/>
          </ac:spMkLst>
        </pc:spChg>
        <pc:spChg chg="add del mod">
          <ac:chgData name="Sameer G Joshi (DJPR)" userId="bd06337d-ce8c-4c34-b1d1-7fbf8f91b6eb" providerId="ADAL" clId="{449E2AB2-FE71-461C-94D3-9E867087BE31}" dt="2021-03-21T11:14:32.821" v="2076" actId="478"/>
          <ac:spMkLst>
            <pc:docMk/>
            <pc:sldMk cId="424659793" sldId="259"/>
            <ac:spMk id="44" creationId="{28F63E7B-2C59-4749-8CFA-9577C3B0E295}"/>
          </ac:spMkLst>
        </pc:spChg>
        <pc:spChg chg="add del mod">
          <ac:chgData name="Sameer G Joshi (DJPR)" userId="bd06337d-ce8c-4c34-b1d1-7fbf8f91b6eb" providerId="ADAL" clId="{449E2AB2-FE71-461C-94D3-9E867087BE31}" dt="2021-03-21T11:14:32.821" v="2076" actId="478"/>
          <ac:spMkLst>
            <pc:docMk/>
            <pc:sldMk cId="424659793" sldId="259"/>
            <ac:spMk id="45" creationId="{5A898771-A112-4CAC-9DD8-3A43B1C0DB5D}"/>
          </ac:spMkLst>
        </pc:spChg>
        <pc:spChg chg="add del mod">
          <ac:chgData name="Sameer G Joshi (DJPR)" userId="bd06337d-ce8c-4c34-b1d1-7fbf8f91b6eb" providerId="ADAL" clId="{449E2AB2-FE71-461C-94D3-9E867087BE31}" dt="2021-03-21T11:14:32.821" v="2076" actId="478"/>
          <ac:spMkLst>
            <pc:docMk/>
            <pc:sldMk cId="424659793" sldId="259"/>
            <ac:spMk id="46" creationId="{23B84D04-A71B-42CB-96D0-FF395B3D9A91}"/>
          </ac:spMkLst>
        </pc:spChg>
        <pc:spChg chg="add del mod">
          <ac:chgData name="Sameer G Joshi (DJPR)" userId="bd06337d-ce8c-4c34-b1d1-7fbf8f91b6eb" providerId="ADAL" clId="{449E2AB2-FE71-461C-94D3-9E867087BE31}" dt="2021-03-21T11:14:32.821" v="2076" actId="478"/>
          <ac:spMkLst>
            <pc:docMk/>
            <pc:sldMk cId="424659793" sldId="259"/>
            <ac:spMk id="47" creationId="{A2844548-A345-4165-989B-94D4A8FAB273}"/>
          </ac:spMkLst>
        </pc:spChg>
        <pc:spChg chg="add del mod">
          <ac:chgData name="Sameer G Joshi (DJPR)" userId="bd06337d-ce8c-4c34-b1d1-7fbf8f91b6eb" providerId="ADAL" clId="{449E2AB2-FE71-461C-94D3-9E867087BE31}" dt="2021-03-21T11:14:28.892" v="2075" actId="478"/>
          <ac:spMkLst>
            <pc:docMk/>
            <pc:sldMk cId="424659793" sldId="259"/>
            <ac:spMk id="48" creationId="{B77D09FE-1209-4F8D-89DD-8FE81BD9027C}"/>
          </ac:spMkLst>
        </pc:spChg>
        <pc:spChg chg="add del mod">
          <ac:chgData name="Sameer G Joshi (DJPR)" userId="bd06337d-ce8c-4c34-b1d1-7fbf8f91b6eb" providerId="ADAL" clId="{449E2AB2-FE71-461C-94D3-9E867087BE31}" dt="2021-03-21T11:14:28.892" v="2075" actId="478"/>
          <ac:spMkLst>
            <pc:docMk/>
            <pc:sldMk cId="424659793" sldId="259"/>
            <ac:spMk id="49" creationId="{9EEAD1F4-6239-4882-ACA7-1CF0B717CF7A}"/>
          </ac:spMkLst>
        </pc:spChg>
        <pc:spChg chg="add del mod">
          <ac:chgData name="Sameer G Joshi (DJPR)" userId="bd06337d-ce8c-4c34-b1d1-7fbf8f91b6eb" providerId="ADAL" clId="{449E2AB2-FE71-461C-94D3-9E867087BE31}" dt="2021-03-21T11:14:28.892" v="2075" actId="478"/>
          <ac:spMkLst>
            <pc:docMk/>
            <pc:sldMk cId="424659793" sldId="259"/>
            <ac:spMk id="50" creationId="{43E3679F-CA7A-4AC1-BF2E-50060FEA221A}"/>
          </ac:spMkLst>
        </pc:spChg>
        <pc:spChg chg="add del mod">
          <ac:chgData name="Sameer G Joshi (DJPR)" userId="bd06337d-ce8c-4c34-b1d1-7fbf8f91b6eb" providerId="ADAL" clId="{449E2AB2-FE71-461C-94D3-9E867087BE31}" dt="2021-03-21T11:14:28.892" v="2075" actId="478"/>
          <ac:spMkLst>
            <pc:docMk/>
            <pc:sldMk cId="424659793" sldId="259"/>
            <ac:spMk id="51" creationId="{CCF2E64A-4AA0-42F8-A535-DFA30C784B66}"/>
          </ac:spMkLst>
        </pc:spChg>
        <pc:spChg chg="add mod">
          <ac:chgData name="Sameer G Joshi (DJPR)" userId="bd06337d-ce8c-4c34-b1d1-7fbf8f91b6eb" providerId="ADAL" clId="{449E2AB2-FE71-461C-94D3-9E867087BE31}" dt="2021-03-21T12:12:10.128" v="2717" actId="1035"/>
          <ac:spMkLst>
            <pc:docMk/>
            <pc:sldMk cId="424659793" sldId="259"/>
            <ac:spMk id="52" creationId="{04D8749E-0701-4826-8647-1EBE4FFF68C3}"/>
          </ac:spMkLst>
        </pc:spChg>
        <pc:spChg chg="add mod">
          <ac:chgData name="Sameer G Joshi (DJPR)" userId="bd06337d-ce8c-4c34-b1d1-7fbf8f91b6eb" providerId="ADAL" clId="{449E2AB2-FE71-461C-94D3-9E867087BE31}" dt="2021-03-21T12:12:10.128" v="2717" actId="1035"/>
          <ac:spMkLst>
            <pc:docMk/>
            <pc:sldMk cId="424659793" sldId="259"/>
            <ac:spMk id="53" creationId="{46F2D02C-0EAA-4928-8836-AA0064670ACE}"/>
          </ac:spMkLst>
        </pc:spChg>
        <pc:spChg chg="add mod">
          <ac:chgData name="Sameer G Joshi (DJPR)" userId="bd06337d-ce8c-4c34-b1d1-7fbf8f91b6eb" providerId="ADAL" clId="{449E2AB2-FE71-461C-94D3-9E867087BE31}" dt="2021-03-21T12:12:10.128" v="2717" actId="1035"/>
          <ac:spMkLst>
            <pc:docMk/>
            <pc:sldMk cId="424659793" sldId="259"/>
            <ac:spMk id="54" creationId="{FE813D58-DAF1-4639-BC1D-3DE4CBEF83FD}"/>
          </ac:spMkLst>
        </pc:spChg>
        <pc:spChg chg="add mod">
          <ac:chgData name="Sameer G Joshi (DJPR)" userId="bd06337d-ce8c-4c34-b1d1-7fbf8f91b6eb" providerId="ADAL" clId="{449E2AB2-FE71-461C-94D3-9E867087BE31}" dt="2021-03-21T12:12:10.128" v="2717" actId="1035"/>
          <ac:spMkLst>
            <pc:docMk/>
            <pc:sldMk cId="424659793" sldId="259"/>
            <ac:spMk id="55" creationId="{B0C557C0-83C4-4E77-BD40-A7F21D2AC8EA}"/>
          </ac:spMkLst>
        </pc:spChg>
        <pc:spChg chg="add mod">
          <ac:chgData name="Sameer G Joshi (DJPR)" userId="bd06337d-ce8c-4c34-b1d1-7fbf8f91b6eb" providerId="ADAL" clId="{449E2AB2-FE71-461C-94D3-9E867087BE31}" dt="2021-03-21T11:18:51.485" v="2244" actId="1035"/>
          <ac:spMkLst>
            <pc:docMk/>
            <pc:sldMk cId="424659793" sldId="259"/>
            <ac:spMk id="56" creationId="{86005B86-1FA2-420D-8781-6AE2E5E797B3}"/>
          </ac:spMkLst>
        </pc:spChg>
        <pc:spChg chg="add mod">
          <ac:chgData name="Sameer G Joshi (DJPR)" userId="bd06337d-ce8c-4c34-b1d1-7fbf8f91b6eb" providerId="ADAL" clId="{449E2AB2-FE71-461C-94D3-9E867087BE31}" dt="2021-03-21T11:18:51.485" v="2244" actId="1035"/>
          <ac:spMkLst>
            <pc:docMk/>
            <pc:sldMk cId="424659793" sldId="259"/>
            <ac:spMk id="57" creationId="{766946AD-BF11-421E-B794-68CCB02A5848}"/>
          </ac:spMkLst>
        </pc:spChg>
        <pc:spChg chg="add mod">
          <ac:chgData name="Sameer G Joshi (DJPR)" userId="bd06337d-ce8c-4c34-b1d1-7fbf8f91b6eb" providerId="ADAL" clId="{449E2AB2-FE71-461C-94D3-9E867087BE31}" dt="2021-03-21T11:18:51.485" v="2244" actId="1035"/>
          <ac:spMkLst>
            <pc:docMk/>
            <pc:sldMk cId="424659793" sldId="259"/>
            <ac:spMk id="58" creationId="{165743CB-DB4C-428B-A331-C5E3CB154CD3}"/>
          </ac:spMkLst>
        </pc:spChg>
        <pc:spChg chg="add mod">
          <ac:chgData name="Sameer G Joshi (DJPR)" userId="bd06337d-ce8c-4c34-b1d1-7fbf8f91b6eb" providerId="ADAL" clId="{449E2AB2-FE71-461C-94D3-9E867087BE31}" dt="2021-03-21T11:18:51.485" v="2244" actId="1035"/>
          <ac:spMkLst>
            <pc:docMk/>
            <pc:sldMk cId="424659793" sldId="259"/>
            <ac:spMk id="59" creationId="{87F8A615-74C5-4097-B633-4A8D3D829A64}"/>
          </ac:spMkLst>
        </pc:spChg>
        <pc:spChg chg="add mod">
          <ac:chgData name="Sameer G Joshi (DJPR)" userId="bd06337d-ce8c-4c34-b1d1-7fbf8f91b6eb" providerId="ADAL" clId="{449E2AB2-FE71-461C-94D3-9E867087BE31}" dt="2021-03-21T12:12:10.128" v="2717" actId="1035"/>
          <ac:spMkLst>
            <pc:docMk/>
            <pc:sldMk cId="424659793" sldId="259"/>
            <ac:spMk id="60" creationId="{B31399A1-928F-44CD-A96D-B340E4ADEE0B}"/>
          </ac:spMkLst>
        </pc:spChg>
        <pc:spChg chg="add mod">
          <ac:chgData name="Sameer G Joshi (DJPR)" userId="bd06337d-ce8c-4c34-b1d1-7fbf8f91b6eb" providerId="ADAL" clId="{449E2AB2-FE71-461C-94D3-9E867087BE31}" dt="2021-03-21T12:12:10.128" v="2717" actId="1035"/>
          <ac:spMkLst>
            <pc:docMk/>
            <pc:sldMk cId="424659793" sldId="259"/>
            <ac:spMk id="61" creationId="{DE43E371-9D86-47B7-8835-26D443F69183}"/>
          </ac:spMkLst>
        </pc:spChg>
        <pc:spChg chg="add mod">
          <ac:chgData name="Sameer G Joshi (DJPR)" userId="bd06337d-ce8c-4c34-b1d1-7fbf8f91b6eb" providerId="ADAL" clId="{449E2AB2-FE71-461C-94D3-9E867087BE31}" dt="2021-03-21T12:12:10.128" v="2717" actId="1035"/>
          <ac:spMkLst>
            <pc:docMk/>
            <pc:sldMk cId="424659793" sldId="259"/>
            <ac:spMk id="62" creationId="{F69A1AE3-1AA8-46D2-A368-96A14F0F66F8}"/>
          </ac:spMkLst>
        </pc:spChg>
        <pc:spChg chg="add mod">
          <ac:chgData name="Sameer G Joshi (DJPR)" userId="bd06337d-ce8c-4c34-b1d1-7fbf8f91b6eb" providerId="ADAL" clId="{449E2AB2-FE71-461C-94D3-9E867087BE31}" dt="2021-03-21T12:12:10.128" v="2717" actId="1035"/>
          <ac:spMkLst>
            <pc:docMk/>
            <pc:sldMk cId="424659793" sldId="259"/>
            <ac:spMk id="63" creationId="{91B9C6C1-15B8-466A-8898-75F3D0455C44}"/>
          </ac:spMkLst>
        </pc:spChg>
        <pc:spChg chg="add mod">
          <ac:chgData name="Sameer G Joshi (DJPR)" userId="bd06337d-ce8c-4c34-b1d1-7fbf8f91b6eb" providerId="ADAL" clId="{449E2AB2-FE71-461C-94D3-9E867087BE31}" dt="2021-03-21T12:11:44.785" v="2702" actId="1036"/>
          <ac:spMkLst>
            <pc:docMk/>
            <pc:sldMk cId="424659793" sldId="259"/>
            <ac:spMk id="64" creationId="{E945096F-49E4-4222-A35A-CF28CE8283A8}"/>
          </ac:spMkLst>
        </pc:spChg>
        <pc:spChg chg="add mod">
          <ac:chgData name="Sameer G Joshi (DJPR)" userId="bd06337d-ce8c-4c34-b1d1-7fbf8f91b6eb" providerId="ADAL" clId="{449E2AB2-FE71-461C-94D3-9E867087BE31}" dt="2021-03-21T12:11:33.975" v="2675" actId="1037"/>
          <ac:spMkLst>
            <pc:docMk/>
            <pc:sldMk cId="424659793" sldId="259"/>
            <ac:spMk id="65" creationId="{0FB803E0-295F-491E-9DA3-8B041ACB29BD}"/>
          </ac:spMkLst>
        </pc:spChg>
        <pc:spChg chg="add mod">
          <ac:chgData name="Sameer G Joshi (DJPR)" userId="bd06337d-ce8c-4c34-b1d1-7fbf8f91b6eb" providerId="ADAL" clId="{449E2AB2-FE71-461C-94D3-9E867087BE31}" dt="2021-03-21T12:12:01.629" v="2710" actId="1035"/>
          <ac:spMkLst>
            <pc:docMk/>
            <pc:sldMk cId="424659793" sldId="259"/>
            <ac:spMk id="66" creationId="{9A758585-214B-4CFE-9328-BF628DB65CA2}"/>
          </ac:spMkLst>
        </pc:spChg>
        <pc:grpChg chg="add mod">
          <ac:chgData name="Sameer G Joshi (DJPR)" userId="bd06337d-ce8c-4c34-b1d1-7fbf8f91b6eb" providerId="ADAL" clId="{449E2AB2-FE71-461C-94D3-9E867087BE31}" dt="2021-03-21T11:18:51.485" v="2244" actId="1035"/>
          <ac:grpSpMkLst>
            <pc:docMk/>
            <pc:sldMk cId="424659793" sldId="259"/>
            <ac:grpSpMk id="4" creationId="{199DDE7E-B395-49CB-930A-C2C673C6DE90}"/>
          </ac:grpSpMkLst>
        </pc:grpChg>
        <pc:grpChg chg="add mod">
          <ac:chgData name="Sameer G Joshi (DJPR)" userId="bd06337d-ce8c-4c34-b1d1-7fbf8f91b6eb" providerId="ADAL" clId="{449E2AB2-FE71-461C-94D3-9E867087BE31}" dt="2021-03-21T11:18:51.485" v="2244" actId="1035"/>
          <ac:grpSpMkLst>
            <pc:docMk/>
            <pc:sldMk cId="424659793" sldId="259"/>
            <ac:grpSpMk id="9" creationId="{B3A8B81C-30B7-4B97-8027-C028D4B127ED}"/>
          </ac:grpSpMkLst>
        </pc:grpChg>
        <pc:grpChg chg="add mod">
          <ac:chgData name="Sameer G Joshi (DJPR)" userId="bd06337d-ce8c-4c34-b1d1-7fbf8f91b6eb" providerId="ADAL" clId="{449E2AB2-FE71-461C-94D3-9E867087BE31}" dt="2021-03-21T12:12:10.128" v="2717" actId="1035"/>
          <ac:grpSpMkLst>
            <pc:docMk/>
            <pc:sldMk cId="424659793" sldId="259"/>
            <ac:grpSpMk id="30" creationId="{9EA0A4B8-2729-41B2-8668-FA98BD79D0BE}"/>
          </ac:grpSpMkLst>
        </pc:grpChg>
        <pc:grpChg chg="add mod">
          <ac:chgData name="Sameer G Joshi (DJPR)" userId="bd06337d-ce8c-4c34-b1d1-7fbf8f91b6eb" providerId="ADAL" clId="{449E2AB2-FE71-461C-94D3-9E867087BE31}" dt="2021-03-21T12:12:10.128" v="2717" actId="1035"/>
          <ac:grpSpMkLst>
            <pc:docMk/>
            <pc:sldMk cId="424659793" sldId="259"/>
            <ac:grpSpMk id="35" creationId="{A00F72AD-4F8B-41CB-9EC4-BDE7CD1BA065}"/>
          </ac:grpSpMkLst>
        </pc:grpChg>
        <pc:picChg chg="mod">
          <ac:chgData name="Sameer G Joshi (DJPR)" userId="bd06337d-ce8c-4c34-b1d1-7fbf8f91b6eb" providerId="ADAL" clId="{449E2AB2-FE71-461C-94D3-9E867087BE31}" dt="2021-03-21T10:58:31.979" v="1474"/>
          <ac:picMkLst>
            <pc:docMk/>
            <pc:sldMk cId="424659793" sldId="259"/>
            <ac:picMk id="5" creationId="{BF4E60D9-99C5-4327-966D-CEA144304423}"/>
          </ac:picMkLst>
        </pc:picChg>
        <pc:picChg chg="mod">
          <ac:chgData name="Sameer G Joshi (DJPR)" userId="bd06337d-ce8c-4c34-b1d1-7fbf8f91b6eb" providerId="ADAL" clId="{449E2AB2-FE71-461C-94D3-9E867087BE31}" dt="2021-03-21T10:58:31.979" v="1474"/>
          <ac:picMkLst>
            <pc:docMk/>
            <pc:sldMk cId="424659793" sldId="259"/>
            <ac:picMk id="6" creationId="{7C50B30D-81E5-486F-A64A-8D2BC3C11829}"/>
          </ac:picMkLst>
        </pc:picChg>
        <pc:picChg chg="mod">
          <ac:chgData name="Sameer G Joshi (DJPR)" userId="bd06337d-ce8c-4c34-b1d1-7fbf8f91b6eb" providerId="ADAL" clId="{449E2AB2-FE71-461C-94D3-9E867087BE31}" dt="2021-03-21T10:58:31.979" v="1474"/>
          <ac:picMkLst>
            <pc:docMk/>
            <pc:sldMk cId="424659793" sldId="259"/>
            <ac:picMk id="7" creationId="{614733D8-7BF1-42C5-872B-D2B9024890D4}"/>
          </ac:picMkLst>
        </pc:picChg>
        <pc:picChg chg="mod">
          <ac:chgData name="Sameer G Joshi (DJPR)" userId="bd06337d-ce8c-4c34-b1d1-7fbf8f91b6eb" providerId="ADAL" clId="{449E2AB2-FE71-461C-94D3-9E867087BE31}" dt="2021-03-21T10:58:31.979" v="1474"/>
          <ac:picMkLst>
            <pc:docMk/>
            <pc:sldMk cId="424659793" sldId="259"/>
            <ac:picMk id="8" creationId="{C238E075-9119-4838-9B0C-90E6D9B8FA91}"/>
          </ac:picMkLst>
        </pc:picChg>
        <pc:picChg chg="mod">
          <ac:chgData name="Sameer G Joshi (DJPR)" userId="bd06337d-ce8c-4c34-b1d1-7fbf8f91b6eb" providerId="ADAL" clId="{449E2AB2-FE71-461C-94D3-9E867087BE31}" dt="2021-03-21T10:58:31.979" v="1474"/>
          <ac:picMkLst>
            <pc:docMk/>
            <pc:sldMk cId="424659793" sldId="259"/>
            <ac:picMk id="10" creationId="{E4FDA631-2DF2-4F35-B2B3-074A6BEECAF9}"/>
          </ac:picMkLst>
        </pc:picChg>
        <pc:picChg chg="mod">
          <ac:chgData name="Sameer G Joshi (DJPR)" userId="bd06337d-ce8c-4c34-b1d1-7fbf8f91b6eb" providerId="ADAL" clId="{449E2AB2-FE71-461C-94D3-9E867087BE31}" dt="2021-03-21T10:58:31.979" v="1474"/>
          <ac:picMkLst>
            <pc:docMk/>
            <pc:sldMk cId="424659793" sldId="259"/>
            <ac:picMk id="11" creationId="{97AE85BB-F171-4070-889B-697474B67DB9}"/>
          </ac:picMkLst>
        </pc:picChg>
        <pc:picChg chg="mod">
          <ac:chgData name="Sameer G Joshi (DJPR)" userId="bd06337d-ce8c-4c34-b1d1-7fbf8f91b6eb" providerId="ADAL" clId="{449E2AB2-FE71-461C-94D3-9E867087BE31}" dt="2021-03-21T10:58:31.979" v="1474"/>
          <ac:picMkLst>
            <pc:docMk/>
            <pc:sldMk cId="424659793" sldId="259"/>
            <ac:picMk id="12" creationId="{34FF865B-A5A4-4D49-9A6A-DE1DF88F5DFE}"/>
          </ac:picMkLst>
        </pc:picChg>
        <pc:picChg chg="mod">
          <ac:chgData name="Sameer G Joshi (DJPR)" userId="bd06337d-ce8c-4c34-b1d1-7fbf8f91b6eb" providerId="ADAL" clId="{449E2AB2-FE71-461C-94D3-9E867087BE31}" dt="2021-03-21T10:58:31.979" v="1474"/>
          <ac:picMkLst>
            <pc:docMk/>
            <pc:sldMk cId="424659793" sldId="259"/>
            <ac:picMk id="13" creationId="{2A41BA1A-A007-41FC-ACD6-861C1FF0CFDC}"/>
          </ac:picMkLst>
        </pc:picChg>
        <pc:picChg chg="mod">
          <ac:chgData name="Sameer G Joshi (DJPR)" userId="bd06337d-ce8c-4c34-b1d1-7fbf8f91b6eb" providerId="ADAL" clId="{449E2AB2-FE71-461C-94D3-9E867087BE31}" dt="2021-03-21T11:12:33.739" v="2053" actId="14100"/>
          <ac:picMkLst>
            <pc:docMk/>
            <pc:sldMk cId="424659793" sldId="259"/>
            <ac:picMk id="31" creationId="{054617E4-0440-4224-8AD1-ABCDDC144DF4}"/>
          </ac:picMkLst>
        </pc:picChg>
        <pc:picChg chg="mod">
          <ac:chgData name="Sameer G Joshi (DJPR)" userId="bd06337d-ce8c-4c34-b1d1-7fbf8f91b6eb" providerId="ADAL" clId="{449E2AB2-FE71-461C-94D3-9E867087BE31}" dt="2021-03-21T11:12:38.839" v="2054" actId="14100"/>
          <ac:picMkLst>
            <pc:docMk/>
            <pc:sldMk cId="424659793" sldId="259"/>
            <ac:picMk id="32" creationId="{087FB6C6-D63C-4E56-9014-AFE8EC79BEF0}"/>
          </ac:picMkLst>
        </pc:picChg>
        <pc:picChg chg="mod">
          <ac:chgData name="Sameer G Joshi (DJPR)" userId="bd06337d-ce8c-4c34-b1d1-7fbf8f91b6eb" providerId="ADAL" clId="{449E2AB2-FE71-461C-94D3-9E867087BE31}" dt="2021-03-21T11:12:43.178" v="2055" actId="14100"/>
          <ac:picMkLst>
            <pc:docMk/>
            <pc:sldMk cId="424659793" sldId="259"/>
            <ac:picMk id="33" creationId="{35AD487E-C520-4E4B-8841-2C73E84CC0E1}"/>
          </ac:picMkLst>
        </pc:picChg>
        <pc:picChg chg="mod">
          <ac:chgData name="Sameer G Joshi (DJPR)" userId="bd06337d-ce8c-4c34-b1d1-7fbf8f91b6eb" providerId="ADAL" clId="{449E2AB2-FE71-461C-94D3-9E867087BE31}" dt="2021-03-21T11:12:51.481" v="2057" actId="14100"/>
          <ac:picMkLst>
            <pc:docMk/>
            <pc:sldMk cId="424659793" sldId="259"/>
            <ac:picMk id="34" creationId="{6E249896-3C3D-4099-A423-C736F5C73AB7}"/>
          </ac:picMkLst>
        </pc:picChg>
        <pc:picChg chg="mod">
          <ac:chgData name="Sameer G Joshi (DJPR)" userId="bd06337d-ce8c-4c34-b1d1-7fbf8f91b6eb" providerId="ADAL" clId="{449E2AB2-FE71-461C-94D3-9E867087BE31}" dt="2021-03-21T11:13:26.753" v="2070" actId="14100"/>
          <ac:picMkLst>
            <pc:docMk/>
            <pc:sldMk cId="424659793" sldId="259"/>
            <ac:picMk id="36" creationId="{597544FC-2283-4FE2-B6D3-DE2E02F5E81D}"/>
          </ac:picMkLst>
        </pc:picChg>
        <pc:picChg chg="mod">
          <ac:chgData name="Sameer G Joshi (DJPR)" userId="bd06337d-ce8c-4c34-b1d1-7fbf8f91b6eb" providerId="ADAL" clId="{449E2AB2-FE71-461C-94D3-9E867087BE31}" dt="2021-03-21T11:14:09.535" v="2073" actId="14100"/>
          <ac:picMkLst>
            <pc:docMk/>
            <pc:sldMk cId="424659793" sldId="259"/>
            <ac:picMk id="37" creationId="{882ABA55-BD47-4898-A864-9FFF98BED62F}"/>
          </ac:picMkLst>
        </pc:picChg>
        <pc:picChg chg="mod">
          <ac:chgData name="Sameer G Joshi (DJPR)" userId="bd06337d-ce8c-4c34-b1d1-7fbf8f91b6eb" providerId="ADAL" clId="{449E2AB2-FE71-461C-94D3-9E867087BE31}" dt="2021-03-21T11:13:49.935" v="2071" actId="14100"/>
          <ac:picMkLst>
            <pc:docMk/>
            <pc:sldMk cId="424659793" sldId="259"/>
            <ac:picMk id="38" creationId="{64541CC1-7580-4260-BAA6-BA5C0EADC2E9}"/>
          </ac:picMkLst>
        </pc:picChg>
        <pc:picChg chg="mod">
          <ac:chgData name="Sameer G Joshi (DJPR)" userId="bd06337d-ce8c-4c34-b1d1-7fbf8f91b6eb" providerId="ADAL" clId="{449E2AB2-FE71-461C-94D3-9E867087BE31}" dt="2021-03-21T11:13:59.871" v="2072" actId="14100"/>
          <ac:picMkLst>
            <pc:docMk/>
            <pc:sldMk cId="424659793" sldId="259"/>
            <ac:picMk id="39" creationId="{4ECFF335-3146-42DD-A295-9AD9407448CE}"/>
          </ac:picMkLst>
        </pc:picChg>
      </pc:sldChg>
      <pc:sldChg chg="addSp delSp modSp new mod">
        <pc:chgData name="Sameer G Joshi (DJPR)" userId="bd06337d-ce8c-4c34-b1d1-7fbf8f91b6eb" providerId="ADAL" clId="{449E2AB2-FE71-461C-94D3-9E867087BE31}" dt="2021-03-21T22:36:23.227" v="2917" actId="1076"/>
        <pc:sldMkLst>
          <pc:docMk/>
          <pc:sldMk cId="2000004557" sldId="260"/>
        </pc:sldMkLst>
        <pc:spChg chg="del">
          <ac:chgData name="Sameer G Joshi (DJPR)" userId="bd06337d-ce8c-4c34-b1d1-7fbf8f91b6eb" providerId="ADAL" clId="{449E2AB2-FE71-461C-94D3-9E867087BE31}" dt="2021-03-21T11:19:09.709" v="2250" actId="478"/>
          <ac:spMkLst>
            <pc:docMk/>
            <pc:sldMk cId="2000004557" sldId="260"/>
            <ac:spMk id="2" creationId="{611C2E60-D7CA-4B01-8032-8174AEC4A79B}"/>
          </ac:spMkLst>
        </pc:spChg>
        <pc:spChg chg="del">
          <ac:chgData name="Sameer G Joshi (DJPR)" userId="bd06337d-ce8c-4c34-b1d1-7fbf8f91b6eb" providerId="ADAL" clId="{449E2AB2-FE71-461C-94D3-9E867087BE31}" dt="2021-03-21T11:19:09.709" v="2250" actId="478"/>
          <ac:spMkLst>
            <pc:docMk/>
            <pc:sldMk cId="2000004557" sldId="260"/>
            <ac:spMk id="3" creationId="{F2F6FD44-F286-4A24-8C97-C92C58556E59}"/>
          </ac:spMkLst>
        </pc:spChg>
        <pc:spChg chg="add mod">
          <ac:chgData name="Sameer G Joshi (DJPR)" userId="bd06337d-ce8c-4c34-b1d1-7fbf8f91b6eb" providerId="ADAL" clId="{449E2AB2-FE71-461C-94D3-9E867087BE31}" dt="2021-03-21T22:32:28.707" v="2903" actId="20577"/>
          <ac:spMkLst>
            <pc:docMk/>
            <pc:sldMk cId="2000004557" sldId="260"/>
            <ac:spMk id="6" creationId="{4E8C1A93-770A-4C1C-9961-68EC984DFA55}"/>
          </ac:spMkLst>
        </pc:spChg>
        <pc:spChg chg="add mod">
          <ac:chgData name="Sameer G Joshi (DJPR)" userId="bd06337d-ce8c-4c34-b1d1-7fbf8f91b6eb" providerId="ADAL" clId="{449E2AB2-FE71-461C-94D3-9E867087BE31}" dt="2021-03-21T22:09:39.578" v="2723" actId="1076"/>
          <ac:spMkLst>
            <pc:docMk/>
            <pc:sldMk cId="2000004557" sldId="260"/>
            <ac:spMk id="7" creationId="{1C3C3A10-9CE1-4A4D-A74C-83315D339EA1}"/>
          </ac:spMkLst>
        </pc:spChg>
        <pc:spChg chg="add mod">
          <ac:chgData name="Sameer G Joshi (DJPR)" userId="bd06337d-ce8c-4c34-b1d1-7fbf8f91b6eb" providerId="ADAL" clId="{449E2AB2-FE71-461C-94D3-9E867087BE31}" dt="2021-03-21T22:09:44.755" v="2724" actId="1076"/>
          <ac:spMkLst>
            <pc:docMk/>
            <pc:sldMk cId="2000004557" sldId="260"/>
            <ac:spMk id="8" creationId="{5CC67F77-E7A1-4802-802A-575670CD8EC1}"/>
          </ac:spMkLst>
        </pc:spChg>
        <pc:spChg chg="add mod">
          <ac:chgData name="Sameer G Joshi (DJPR)" userId="bd06337d-ce8c-4c34-b1d1-7fbf8f91b6eb" providerId="ADAL" clId="{449E2AB2-FE71-461C-94D3-9E867087BE31}" dt="2021-03-21T22:10:13.605" v="2736" actId="20577"/>
          <ac:spMkLst>
            <pc:docMk/>
            <pc:sldMk cId="2000004557" sldId="260"/>
            <ac:spMk id="9" creationId="{73D193C3-6FAD-40EF-8AF7-53322AED14EC}"/>
          </ac:spMkLst>
        </pc:spChg>
        <pc:spChg chg="add mod">
          <ac:chgData name="Sameer G Joshi (DJPR)" userId="bd06337d-ce8c-4c34-b1d1-7fbf8f91b6eb" providerId="ADAL" clId="{449E2AB2-FE71-461C-94D3-9E867087BE31}" dt="2021-03-21T22:36:09.524" v="2914" actId="14100"/>
          <ac:spMkLst>
            <pc:docMk/>
            <pc:sldMk cId="2000004557" sldId="260"/>
            <ac:spMk id="10" creationId="{59C0504E-C7AF-4D43-8383-ED0A5BC07BE9}"/>
          </ac:spMkLst>
        </pc:spChg>
        <pc:spChg chg="add del mod">
          <ac:chgData name="Sameer G Joshi (DJPR)" userId="bd06337d-ce8c-4c34-b1d1-7fbf8f91b6eb" providerId="ADAL" clId="{449E2AB2-FE71-461C-94D3-9E867087BE31}" dt="2021-03-21T22:36:14.348" v="2915" actId="478"/>
          <ac:spMkLst>
            <pc:docMk/>
            <pc:sldMk cId="2000004557" sldId="260"/>
            <ac:spMk id="11" creationId="{F7B2DA8E-7D62-4D77-9459-640B42A7968B}"/>
          </ac:spMkLst>
        </pc:spChg>
        <pc:spChg chg="add mod">
          <ac:chgData name="Sameer G Joshi (DJPR)" userId="bd06337d-ce8c-4c34-b1d1-7fbf8f91b6eb" providerId="ADAL" clId="{449E2AB2-FE71-461C-94D3-9E867087BE31}" dt="2021-03-21T22:36:23.227" v="2917" actId="1076"/>
          <ac:spMkLst>
            <pc:docMk/>
            <pc:sldMk cId="2000004557" sldId="260"/>
            <ac:spMk id="12" creationId="{A41F9AFE-C61D-425F-A866-666AE31AD4F0}"/>
          </ac:spMkLst>
        </pc:spChg>
        <pc:graphicFrameChg chg="add mod">
          <ac:chgData name="Sameer G Joshi (DJPR)" userId="bd06337d-ce8c-4c34-b1d1-7fbf8f91b6eb" providerId="ADAL" clId="{449E2AB2-FE71-461C-94D3-9E867087BE31}" dt="2021-03-21T11:31:27.091" v="2323" actId="692"/>
          <ac:graphicFrameMkLst>
            <pc:docMk/>
            <pc:sldMk cId="2000004557" sldId="260"/>
            <ac:graphicFrameMk id="4" creationId="{7F2C73C6-B831-4FAE-935A-F943A81563E3}"/>
          </ac:graphicFrameMkLst>
        </pc:graphicFrameChg>
        <pc:graphicFrameChg chg="add del mod">
          <ac:chgData name="Sameer G Joshi (DJPR)" userId="bd06337d-ce8c-4c34-b1d1-7fbf8f91b6eb" providerId="ADAL" clId="{449E2AB2-FE71-461C-94D3-9E867087BE31}" dt="2021-03-21T11:31:52.519" v="2329" actId="692"/>
          <ac:graphicFrameMkLst>
            <pc:docMk/>
            <pc:sldMk cId="2000004557" sldId="260"/>
            <ac:graphicFrameMk id="5" creationId="{CC083DA7-C645-4144-AD26-1F761AB8FAC1}"/>
          </ac:graphicFrameMkLst>
        </pc:graphicFrameChg>
      </pc:sldChg>
    </pc:docChg>
  </pc:docChgLst>
  <pc:docChgLst>
    <pc:chgData name="Sameer G Joshi (DJPR)" userId="bd06337d-ce8c-4c34-b1d1-7fbf8f91b6eb" providerId="ADAL" clId="{0712B517-A32B-4403-878A-0FEF26CE07CC}"/>
    <pc:docChg chg="modSld">
      <pc:chgData name="Sameer G Joshi (DJPR)" userId="bd06337d-ce8c-4c34-b1d1-7fbf8f91b6eb" providerId="ADAL" clId="{0712B517-A32B-4403-878A-0FEF26CE07CC}" dt="2021-04-19T23:21:08.021" v="1" actId="114"/>
      <pc:docMkLst>
        <pc:docMk/>
      </pc:docMkLst>
      <pc:sldChg chg="modSp">
        <pc:chgData name="Sameer G Joshi (DJPR)" userId="bd06337d-ce8c-4c34-b1d1-7fbf8f91b6eb" providerId="ADAL" clId="{0712B517-A32B-4403-878A-0FEF26CE07CC}" dt="2021-04-19T23:21:08.021" v="1" actId="114"/>
        <pc:sldMkLst>
          <pc:docMk/>
          <pc:sldMk cId="2203674866" sldId="258"/>
        </pc:sldMkLst>
        <pc:spChg chg="mod">
          <ac:chgData name="Sameer G Joshi (DJPR)" userId="bd06337d-ce8c-4c34-b1d1-7fbf8f91b6eb" providerId="ADAL" clId="{0712B517-A32B-4403-878A-0FEF26CE07CC}" dt="2021-04-19T23:21:03.341" v="0" actId="114"/>
          <ac:spMkLst>
            <pc:docMk/>
            <pc:sldMk cId="2203674866" sldId="258"/>
            <ac:spMk id="11" creationId="{F47A1C11-6121-479E-999B-743F8B3B0102}"/>
          </ac:spMkLst>
        </pc:spChg>
        <pc:spChg chg="mod">
          <ac:chgData name="Sameer G Joshi (DJPR)" userId="bd06337d-ce8c-4c34-b1d1-7fbf8f91b6eb" providerId="ADAL" clId="{0712B517-A32B-4403-878A-0FEF26CE07CC}" dt="2021-04-19T23:21:08.021" v="1" actId="114"/>
          <ac:spMkLst>
            <pc:docMk/>
            <pc:sldMk cId="2203674866" sldId="258"/>
            <ac:spMk id="12" creationId="{39B48064-32AF-488B-A4AC-5E955AE5DC19}"/>
          </ac:spMkLst>
        </pc:spChg>
      </pc:sldChg>
    </pc:docChg>
  </pc:docChgLst>
  <pc:docChgLst>
    <pc:chgData name="Babu R Pandey (DJPR)" userId="S::babu.pandey@agriculture.vic.gov.au::044449df-33c0-4d7f-91a8-80cfc82b8f4c" providerId="AD" clId="Web-{F224D89D-1660-E994-DF74-2FD281286EDA}"/>
    <pc:docChg chg="sldOrd">
      <pc:chgData name="Babu R Pandey (DJPR)" userId="S::babu.pandey@agriculture.vic.gov.au::044449df-33c0-4d7f-91a8-80cfc82b8f4c" providerId="AD" clId="Web-{F224D89D-1660-E994-DF74-2FD281286EDA}" dt="2022-04-07T04:47:17.241" v="2"/>
      <pc:docMkLst>
        <pc:docMk/>
      </pc:docMkLst>
      <pc:sldChg chg="addCm modCm">
        <pc:chgData name="Babu R Pandey (DJPR)" userId="S::babu.pandey@agriculture.vic.gov.au::044449df-33c0-4d7f-91a8-80cfc82b8f4c" providerId="AD" clId="Web-{F224D89D-1660-E994-DF74-2FD281286EDA}" dt="2022-04-07T04:12:31.908" v="1"/>
        <pc:sldMkLst>
          <pc:docMk/>
          <pc:sldMk cId="2203674866" sldId="258"/>
        </pc:sldMkLst>
      </pc:sldChg>
      <pc:sldChg chg="ord">
        <pc:chgData name="Babu R Pandey (DJPR)" userId="S::babu.pandey@agriculture.vic.gov.au::044449df-33c0-4d7f-91a8-80cfc82b8f4c" providerId="AD" clId="Web-{F224D89D-1660-E994-DF74-2FD281286EDA}" dt="2022-04-07T04:47:17.241" v="2"/>
        <pc:sldMkLst>
          <pc:docMk/>
          <pc:sldMk cId="2979161283" sldId="268"/>
        </pc:sldMkLst>
      </pc:sldChg>
    </pc:docChg>
  </pc:docChgLst>
  <pc:docChgLst>
    <pc:chgData name="Sameer G Joshi (DJPR)" userId="bd06337d-ce8c-4c34-b1d1-7fbf8f91b6eb" providerId="ADAL" clId="{F3155301-60F9-466A-97B1-4E5391BEC052}"/>
    <pc:docChg chg="custSel modSld modMainMaster">
      <pc:chgData name="Sameer G Joshi (DJPR)" userId="bd06337d-ce8c-4c34-b1d1-7fbf8f91b6eb" providerId="ADAL" clId="{F3155301-60F9-466A-97B1-4E5391BEC052}" dt="2022-02-06T22:43:28.930" v="151" actId="1036"/>
      <pc:docMkLst>
        <pc:docMk/>
      </pc:docMkLst>
      <pc:sldChg chg="modSp">
        <pc:chgData name="Sameer G Joshi (DJPR)" userId="bd06337d-ce8c-4c34-b1d1-7fbf8f91b6eb" providerId="ADAL" clId="{F3155301-60F9-466A-97B1-4E5391BEC052}" dt="2022-02-06T22:40:29.098" v="35"/>
        <pc:sldMkLst>
          <pc:docMk/>
          <pc:sldMk cId="3352034816" sldId="256"/>
        </pc:sldMkLst>
        <pc:spChg chg="mod">
          <ac:chgData name="Sameer G Joshi (DJPR)" userId="bd06337d-ce8c-4c34-b1d1-7fbf8f91b6eb" providerId="ADAL" clId="{F3155301-60F9-466A-97B1-4E5391BEC052}" dt="2022-02-06T22:40:29.098" v="35"/>
          <ac:spMkLst>
            <pc:docMk/>
            <pc:sldMk cId="3352034816" sldId="256"/>
            <ac:spMk id="8" creationId="{520DCA2E-CECA-42FB-8D8D-F305B5344E3E}"/>
          </ac:spMkLst>
        </pc:spChg>
      </pc:sldChg>
      <pc:sldChg chg="modSp">
        <pc:chgData name="Sameer G Joshi (DJPR)" userId="bd06337d-ce8c-4c34-b1d1-7fbf8f91b6eb" providerId="ADAL" clId="{F3155301-60F9-466A-97B1-4E5391BEC052}" dt="2022-02-06T22:40:31.346" v="36"/>
        <pc:sldMkLst>
          <pc:docMk/>
          <pc:sldMk cId="2203674866" sldId="258"/>
        </pc:sldMkLst>
        <pc:spChg chg="mod">
          <ac:chgData name="Sameer G Joshi (DJPR)" userId="bd06337d-ce8c-4c34-b1d1-7fbf8f91b6eb" providerId="ADAL" clId="{F3155301-60F9-466A-97B1-4E5391BEC052}" dt="2022-02-06T22:40:31.346" v="36"/>
          <ac:spMkLst>
            <pc:docMk/>
            <pc:sldMk cId="2203674866" sldId="258"/>
            <ac:spMk id="6" creationId="{CF2FA352-EA4B-48AA-BCD9-0B5D417DE429}"/>
          </ac:spMkLst>
        </pc:spChg>
        <pc:spChg chg="mod">
          <ac:chgData name="Sameer G Joshi (DJPR)" userId="bd06337d-ce8c-4c34-b1d1-7fbf8f91b6eb" providerId="ADAL" clId="{F3155301-60F9-466A-97B1-4E5391BEC052}" dt="2022-02-06T22:40:29.098" v="35"/>
          <ac:spMkLst>
            <pc:docMk/>
            <pc:sldMk cId="2203674866" sldId="258"/>
            <ac:spMk id="14" creationId="{1A4BC8A9-00C7-4001-9DA9-3C8D33C7C327}"/>
          </ac:spMkLst>
        </pc:spChg>
        <pc:spChg chg="mod">
          <ac:chgData name="Sameer G Joshi (DJPR)" userId="bd06337d-ce8c-4c34-b1d1-7fbf8f91b6eb" providerId="ADAL" clId="{F3155301-60F9-466A-97B1-4E5391BEC052}" dt="2022-02-06T22:40:29.098" v="35"/>
          <ac:spMkLst>
            <pc:docMk/>
            <pc:sldMk cId="2203674866" sldId="258"/>
            <ac:spMk id="19" creationId="{106A8FBD-909B-4774-B43F-1FC484A71BE3}"/>
          </ac:spMkLst>
        </pc:spChg>
      </pc:sldChg>
      <pc:sldChg chg="modSp">
        <pc:chgData name="Sameer G Joshi (DJPR)" userId="bd06337d-ce8c-4c34-b1d1-7fbf8f91b6eb" providerId="ADAL" clId="{F3155301-60F9-466A-97B1-4E5391BEC052}" dt="2022-02-06T22:40:29.098" v="35"/>
        <pc:sldMkLst>
          <pc:docMk/>
          <pc:sldMk cId="424659793" sldId="259"/>
        </pc:sldMkLst>
        <pc:spChg chg="mod">
          <ac:chgData name="Sameer G Joshi (DJPR)" userId="bd06337d-ce8c-4c34-b1d1-7fbf8f91b6eb" providerId="ADAL" clId="{F3155301-60F9-466A-97B1-4E5391BEC052}" dt="2022-02-06T22:40:29.098" v="35"/>
          <ac:spMkLst>
            <pc:docMk/>
            <pc:sldMk cId="424659793" sldId="259"/>
            <ac:spMk id="14" creationId="{DCD7250A-AE64-4AE7-8AC4-447D72E13899}"/>
          </ac:spMkLst>
        </pc:spChg>
        <pc:spChg chg="mod">
          <ac:chgData name="Sameer G Joshi (DJPR)" userId="bd06337d-ce8c-4c34-b1d1-7fbf8f91b6eb" providerId="ADAL" clId="{F3155301-60F9-466A-97B1-4E5391BEC052}" dt="2022-02-06T22:40:29.098" v="35"/>
          <ac:spMkLst>
            <pc:docMk/>
            <pc:sldMk cId="424659793" sldId="259"/>
            <ac:spMk id="16" creationId="{C72024A2-A6AC-4852-85CC-C8585BC01007}"/>
          </ac:spMkLst>
        </pc:spChg>
        <pc:spChg chg="mod">
          <ac:chgData name="Sameer G Joshi (DJPR)" userId="bd06337d-ce8c-4c34-b1d1-7fbf8f91b6eb" providerId="ADAL" clId="{F3155301-60F9-466A-97B1-4E5391BEC052}" dt="2022-02-06T22:40:29.098" v="35"/>
          <ac:spMkLst>
            <pc:docMk/>
            <pc:sldMk cId="424659793" sldId="259"/>
            <ac:spMk id="64" creationId="{E945096F-49E4-4222-A35A-CF28CE8283A8}"/>
          </ac:spMkLst>
        </pc:spChg>
      </pc:sldChg>
      <pc:sldChg chg="addSp delSp modSp mod">
        <pc:chgData name="Sameer G Joshi (DJPR)" userId="bd06337d-ce8c-4c34-b1d1-7fbf8f91b6eb" providerId="ADAL" clId="{F3155301-60F9-466A-97B1-4E5391BEC052}" dt="2022-02-06T22:43:28.930" v="151" actId="1036"/>
        <pc:sldMkLst>
          <pc:docMk/>
          <pc:sldMk cId="2000004557" sldId="260"/>
        </pc:sldMkLst>
        <pc:spChg chg="add mod">
          <ac:chgData name="Sameer G Joshi (DJPR)" userId="bd06337d-ce8c-4c34-b1d1-7fbf8f91b6eb" providerId="ADAL" clId="{F3155301-60F9-466A-97B1-4E5391BEC052}" dt="2022-02-06T22:43:01.782" v="148" actId="12789"/>
          <ac:spMkLst>
            <pc:docMk/>
            <pc:sldMk cId="2000004557" sldId="260"/>
            <ac:spMk id="2" creationId="{E35B76DD-A214-4A92-9F3B-53EC4EA754C4}"/>
          </ac:spMkLst>
        </pc:spChg>
        <pc:spChg chg="mod">
          <ac:chgData name="Sameer G Joshi (DJPR)" userId="bd06337d-ce8c-4c34-b1d1-7fbf8f91b6eb" providerId="ADAL" clId="{F3155301-60F9-466A-97B1-4E5391BEC052}" dt="2022-02-06T22:42:47.264" v="147" actId="20577"/>
          <ac:spMkLst>
            <pc:docMk/>
            <pc:sldMk cId="2000004557" sldId="260"/>
            <ac:spMk id="6" creationId="{4E8C1A93-770A-4C1C-9961-68EC984DFA55}"/>
          </ac:spMkLst>
        </pc:spChg>
        <pc:spChg chg="mod">
          <ac:chgData name="Sameer G Joshi (DJPR)" userId="bd06337d-ce8c-4c34-b1d1-7fbf8f91b6eb" providerId="ADAL" clId="{F3155301-60F9-466A-97B1-4E5391BEC052}" dt="2022-02-06T22:41:26.157" v="52" actId="1076"/>
          <ac:spMkLst>
            <pc:docMk/>
            <pc:sldMk cId="2000004557" sldId="260"/>
            <ac:spMk id="9" creationId="{73D193C3-6FAD-40EF-8AF7-53322AED14EC}"/>
          </ac:spMkLst>
        </pc:spChg>
        <pc:spChg chg="mod">
          <ac:chgData name="Sameer G Joshi (DJPR)" userId="bd06337d-ce8c-4c34-b1d1-7fbf8f91b6eb" providerId="ADAL" clId="{F3155301-60F9-466A-97B1-4E5391BEC052}" dt="2022-02-06T22:40:29.098" v="35"/>
          <ac:spMkLst>
            <pc:docMk/>
            <pc:sldMk cId="2000004557" sldId="260"/>
            <ac:spMk id="11" creationId="{B85949FD-1409-4C16-86E6-61191A01DC54}"/>
          </ac:spMkLst>
        </pc:spChg>
        <pc:spChg chg="mod">
          <ac:chgData name="Sameer G Joshi (DJPR)" userId="bd06337d-ce8c-4c34-b1d1-7fbf8f91b6eb" providerId="ADAL" clId="{F3155301-60F9-466A-97B1-4E5391BEC052}" dt="2022-02-06T22:40:29.098" v="35"/>
          <ac:spMkLst>
            <pc:docMk/>
            <pc:sldMk cId="2000004557" sldId="260"/>
            <ac:spMk id="12" creationId="{C2FE5A7F-05CE-4198-9DB5-083D731C7875}"/>
          </ac:spMkLst>
        </pc:spChg>
        <pc:spChg chg="add mod">
          <ac:chgData name="Sameer G Joshi (DJPR)" userId="bd06337d-ce8c-4c34-b1d1-7fbf8f91b6eb" providerId="ADAL" clId="{F3155301-60F9-466A-97B1-4E5391BEC052}" dt="2022-02-06T22:43:01.782" v="148" actId="12789"/>
          <ac:spMkLst>
            <pc:docMk/>
            <pc:sldMk cId="2000004557" sldId="260"/>
            <ac:spMk id="13" creationId="{66B1DBAD-791E-4A20-9332-75B621EBBD86}"/>
          </ac:spMkLst>
        </pc:spChg>
        <pc:spChg chg="add mod">
          <ac:chgData name="Sameer G Joshi (DJPR)" userId="bd06337d-ce8c-4c34-b1d1-7fbf8f91b6eb" providerId="ADAL" clId="{F3155301-60F9-466A-97B1-4E5391BEC052}" dt="2022-02-06T22:43:01.782" v="148" actId="12789"/>
          <ac:spMkLst>
            <pc:docMk/>
            <pc:sldMk cId="2000004557" sldId="260"/>
            <ac:spMk id="14" creationId="{C36B7B0B-35DF-4332-86A5-D51F2AD55438}"/>
          </ac:spMkLst>
        </pc:spChg>
        <pc:spChg chg="add mod">
          <ac:chgData name="Sameer G Joshi (DJPR)" userId="bd06337d-ce8c-4c34-b1d1-7fbf8f91b6eb" providerId="ADAL" clId="{F3155301-60F9-466A-97B1-4E5391BEC052}" dt="2022-02-06T22:43:01.782" v="148" actId="12789"/>
          <ac:spMkLst>
            <pc:docMk/>
            <pc:sldMk cId="2000004557" sldId="260"/>
            <ac:spMk id="15" creationId="{DEAB99B5-7EBF-4267-A832-0BDD77FC5E36}"/>
          </ac:spMkLst>
        </pc:spChg>
        <pc:spChg chg="add mod">
          <ac:chgData name="Sameer G Joshi (DJPR)" userId="bd06337d-ce8c-4c34-b1d1-7fbf8f91b6eb" providerId="ADAL" clId="{F3155301-60F9-466A-97B1-4E5391BEC052}" dt="2022-02-06T22:43:01.782" v="148" actId="12789"/>
          <ac:spMkLst>
            <pc:docMk/>
            <pc:sldMk cId="2000004557" sldId="260"/>
            <ac:spMk id="16" creationId="{9AB3CEDE-F0B9-468F-AC52-D12C83F61B17}"/>
          </ac:spMkLst>
        </pc:spChg>
        <pc:spChg chg="add mod">
          <ac:chgData name="Sameer G Joshi (DJPR)" userId="bd06337d-ce8c-4c34-b1d1-7fbf8f91b6eb" providerId="ADAL" clId="{F3155301-60F9-466A-97B1-4E5391BEC052}" dt="2022-02-06T22:43:01.782" v="148" actId="12789"/>
          <ac:spMkLst>
            <pc:docMk/>
            <pc:sldMk cId="2000004557" sldId="260"/>
            <ac:spMk id="17" creationId="{9ED1D411-132C-41F7-AA34-7D9A4FD7B354}"/>
          </ac:spMkLst>
        </pc:spChg>
        <pc:spChg chg="add mod">
          <ac:chgData name="Sameer G Joshi (DJPR)" userId="bd06337d-ce8c-4c34-b1d1-7fbf8f91b6eb" providerId="ADAL" clId="{F3155301-60F9-466A-97B1-4E5391BEC052}" dt="2022-02-06T22:43:01.782" v="148" actId="12789"/>
          <ac:spMkLst>
            <pc:docMk/>
            <pc:sldMk cId="2000004557" sldId="260"/>
            <ac:spMk id="18" creationId="{D688DCF6-566C-463E-8D5C-3CCA282022BD}"/>
          </ac:spMkLst>
        </pc:spChg>
        <pc:spChg chg="add mod">
          <ac:chgData name="Sameer G Joshi (DJPR)" userId="bd06337d-ce8c-4c34-b1d1-7fbf8f91b6eb" providerId="ADAL" clId="{F3155301-60F9-466A-97B1-4E5391BEC052}" dt="2022-02-06T22:43:01.782" v="148" actId="12789"/>
          <ac:spMkLst>
            <pc:docMk/>
            <pc:sldMk cId="2000004557" sldId="260"/>
            <ac:spMk id="19" creationId="{B0CA1011-34E9-43F7-ACDC-44BE9C466332}"/>
          </ac:spMkLst>
        </pc:spChg>
        <pc:spChg chg="add mod">
          <ac:chgData name="Sameer G Joshi (DJPR)" userId="bd06337d-ce8c-4c34-b1d1-7fbf8f91b6eb" providerId="ADAL" clId="{F3155301-60F9-466A-97B1-4E5391BEC052}" dt="2022-02-06T22:43:28.930" v="151" actId="1036"/>
          <ac:spMkLst>
            <pc:docMk/>
            <pc:sldMk cId="2000004557" sldId="260"/>
            <ac:spMk id="20" creationId="{59426C56-0B19-4AF0-8867-B5A25BF208C9}"/>
          </ac:spMkLst>
        </pc:spChg>
        <pc:spChg chg="add mod">
          <ac:chgData name="Sameer G Joshi (DJPR)" userId="bd06337d-ce8c-4c34-b1d1-7fbf8f91b6eb" providerId="ADAL" clId="{F3155301-60F9-466A-97B1-4E5391BEC052}" dt="2022-02-06T22:43:28.930" v="151" actId="1036"/>
          <ac:spMkLst>
            <pc:docMk/>
            <pc:sldMk cId="2000004557" sldId="260"/>
            <ac:spMk id="21" creationId="{BA9AE161-CC28-4179-93B5-E7F4915D4EF4}"/>
          </ac:spMkLst>
        </pc:spChg>
        <pc:spChg chg="add mod">
          <ac:chgData name="Sameer G Joshi (DJPR)" userId="bd06337d-ce8c-4c34-b1d1-7fbf8f91b6eb" providerId="ADAL" clId="{F3155301-60F9-466A-97B1-4E5391BEC052}" dt="2022-02-06T22:43:28.930" v="151" actId="1036"/>
          <ac:spMkLst>
            <pc:docMk/>
            <pc:sldMk cId="2000004557" sldId="260"/>
            <ac:spMk id="22" creationId="{C8E32B93-2A34-45BF-B18C-57BB5EB245D8}"/>
          </ac:spMkLst>
        </pc:spChg>
        <pc:spChg chg="add mod">
          <ac:chgData name="Sameer G Joshi (DJPR)" userId="bd06337d-ce8c-4c34-b1d1-7fbf8f91b6eb" providerId="ADAL" clId="{F3155301-60F9-466A-97B1-4E5391BEC052}" dt="2022-02-06T22:43:28.930" v="151" actId="1036"/>
          <ac:spMkLst>
            <pc:docMk/>
            <pc:sldMk cId="2000004557" sldId="260"/>
            <ac:spMk id="23" creationId="{6DC06F12-CAC3-4A3D-A765-F2461E4E0BDE}"/>
          </ac:spMkLst>
        </pc:spChg>
        <pc:spChg chg="add mod">
          <ac:chgData name="Sameer G Joshi (DJPR)" userId="bd06337d-ce8c-4c34-b1d1-7fbf8f91b6eb" providerId="ADAL" clId="{F3155301-60F9-466A-97B1-4E5391BEC052}" dt="2022-02-06T22:43:28.930" v="151" actId="1036"/>
          <ac:spMkLst>
            <pc:docMk/>
            <pc:sldMk cId="2000004557" sldId="260"/>
            <ac:spMk id="24" creationId="{A30377AD-8E00-475A-A4D8-4BADACF3BCEB}"/>
          </ac:spMkLst>
        </pc:spChg>
        <pc:spChg chg="add mod">
          <ac:chgData name="Sameer G Joshi (DJPR)" userId="bd06337d-ce8c-4c34-b1d1-7fbf8f91b6eb" providerId="ADAL" clId="{F3155301-60F9-466A-97B1-4E5391BEC052}" dt="2022-02-06T22:43:28.930" v="151" actId="1036"/>
          <ac:spMkLst>
            <pc:docMk/>
            <pc:sldMk cId="2000004557" sldId="260"/>
            <ac:spMk id="25" creationId="{71D3EB14-B8AF-4CF3-BCDA-169130A8A5C5}"/>
          </ac:spMkLst>
        </pc:spChg>
        <pc:spChg chg="add mod">
          <ac:chgData name="Sameer G Joshi (DJPR)" userId="bd06337d-ce8c-4c34-b1d1-7fbf8f91b6eb" providerId="ADAL" clId="{F3155301-60F9-466A-97B1-4E5391BEC052}" dt="2022-02-06T22:43:28.930" v="151" actId="1036"/>
          <ac:spMkLst>
            <pc:docMk/>
            <pc:sldMk cId="2000004557" sldId="260"/>
            <ac:spMk id="26" creationId="{B939DAF8-5884-4439-A550-23E6BBF37B28}"/>
          </ac:spMkLst>
        </pc:spChg>
        <pc:spChg chg="add mod">
          <ac:chgData name="Sameer G Joshi (DJPR)" userId="bd06337d-ce8c-4c34-b1d1-7fbf8f91b6eb" providerId="ADAL" clId="{F3155301-60F9-466A-97B1-4E5391BEC052}" dt="2022-02-06T22:43:28.930" v="151" actId="1036"/>
          <ac:spMkLst>
            <pc:docMk/>
            <pc:sldMk cId="2000004557" sldId="260"/>
            <ac:spMk id="27" creationId="{BB6A9DAF-F676-4DFD-898E-3F2D73F0D840}"/>
          </ac:spMkLst>
        </pc:spChg>
        <pc:spChg chg="add del mod">
          <ac:chgData name="Sameer G Joshi (DJPR)" userId="bd06337d-ce8c-4c34-b1d1-7fbf8f91b6eb" providerId="ADAL" clId="{F3155301-60F9-466A-97B1-4E5391BEC052}" dt="2022-02-06T22:41:57.433" v="75" actId="478"/>
          <ac:spMkLst>
            <pc:docMk/>
            <pc:sldMk cId="2000004557" sldId="260"/>
            <ac:spMk id="28" creationId="{A40BD027-BAA6-48B5-BD04-43F615ACC69F}"/>
          </ac:spMkLst>
        </pc:spChg>
      </pc:sldChg>
      <pc:sldChg chg="modSp">
        <pc:chgData name="Sameer G Joshi (DJPR)" userId="bd06337d-ce8c-4c34-b1d1-7fbf8f91b6eb" providerId="ADAL" clId="{F3155301-60F9-466A-97B1-4E5391BEC052}" dt="2022-02-06T22:40:31.346" v="36"/>
        <pc:sldMkLst>
          <pc:docMk/>
          <pc:sldMk cId="3894103260" sldId="261"/>
        </pc:sldMkLst>
        <pc:spChg chg="mod">
          <ac:chgData name="Sameer G Joshi (DJPR)" userId="bd06337d-ce8c-4c34-b1d1-7fbf8f91b6eb" providerId="ADAL" clId="{F3155301-60F9-466A-97B1-4E5391BEC052}" dt="2022-02-06T22:40:29.098" v="35"/>
          <ac:spMkLst>
            <pc:docMk/>
            <pc:sldMk cId="3894103260" sldId="261"/>
            <ac:spMk id="7" creationId="{5DA62E7F-4D8B-4F68-A7A1-F0286AE3CEE2}"/>
          </ac:spMkLst>
        </pc:spChg>
        <pc:spChg chg="mod">
          <ac:chgData name="Sameer G Joshi (DJPR)" userId="bd06337d-ce8c-4c34-b1d1-7fbf8f91b6eb" providerId="ADAL" clId="{F3155301-60F9-466A-97B1-4E5391BEC052}" dt="2022-02-06T22:40:29.098" v="35"/>
          <ac:spMkLst>
            <pc:docMk/>
            <pc:sldMk cId="3894103260" sldId="261"/>
            <ac:spMk id="8" creationId="{272C0B60-CFDB-4C5B-B2D1-AF4193BBDF06}"/>
          </ac:spMkLst>
        </pc:spChg>
        <pc:spChg chg="mod">
          <ac:chgData name="Sameer G Joshi (DJPR)" userId="bd06337d-ce8c-4c34-b1d1-7fbf8f91b6eb" providerId="ADAL" clId="{F3155301-60F9-466A-97B1-4E5391BEC052}" dt="2022-02-06T22:40:29.098" v="35"/>
          <ac:spMkLst>
            <pc:docMk/>
            <pc:sldMk cId="3894103260" sldId="261"/>
            <ac:spMk id="13" creationId="{06EDB3DB-11B7-4BF7-9207-CE06B65DA4AC}"/>
          </ac:spMkLst>
        </pc:spChg>
        <pc:spChg chg="mod">
          <ac:chgData name="Sameer G Joshi (DJPR)" userId="bd06337d-ce8c-4c34-b1d1-7fbf8f91b6eb" providerId="ADAL" clId="{F3155301-60F9-466A-97B1-4E5391BEC052}" dt="2022-02-06T22:40:31.346" v="36"/>
          <ac:spMkLst>
            <pc:docMk/>
            <pc:sldMk cId="3894103260" sldId="261"/>
            <ac:spMk id="14" creationId="{97F0DAA3-B7BA-4A6F-AD4F-6242C6F5A64E}"/>
          </ac:spMkLst>
        </pc:spChg>
        <pc:spChg chg="mod">
          <ac:chgData name="Sameer G Joshi (DJPR)" userId="bd06337d-ce8c-4c34-b1d1-7fbf8f91b6eb" providerId="ADAL" clId="{F3155301-60F9-466A-97B1-4E5391BEC052}" dt="2022-02-06T22:40:29.098" v="35"/>
          <ac:spMkLst>
            <pc:docMk/>
            <pc:sldMk cId="3894103260" sldId="261"/>
            <ac:spMk id="15" creationId="{8C5BCF82-98BD-4AE7-B566-5E13F6C903C3}"/>
          </ac:spMkLst>
        </pc:spChg>
        <pc:spChg chg="mod">
          <ac:chgData name="Sameer G Joshi (DJPR)" userId="bd06337d-ce8c-4c34-b1d1-7fbf8f91b6eb" providerId="ADAL" clId="{F3155301-60F9-466A-97B1-4E5391BEC052}" dt="2022-02-06T22:40:29.098" v="35"/>
          <ac:spMkLst>
            <pc:docMk/>
            <pc:sldMk cId="3894103260" sldId="261"/>
            <ac:spMk id="16" creationId="{90125D82-0349-4F5F-B634-E6EA15E91039}"/>
          </ac:spMkLst>
        </pc:spChg>
      </pc:sldChg>
      <pc:sldChg chg="modSp">
        <pc:chgData name="Sameer G Joshi (DJPR)" userId="bd06337d-ce8c-4c34-b1d1-7fbf8f91b6eb" providerId="ADAL" clId="{F3155301-60F9-466A-97B1-4E5391BEC052}" dt="2022-02-06T22:40:31.346" v="36"/>
        <pc:sldMkLst>
          <pc:docMk/>
          <pc:sldMk cId="583791291" sldId="265"/>
        </pc:sldMkLst>
        <pc:spChg chg="mod">
          <ac:chgData name="Sameer G Joshi (DJPR)" userId="bd06337d-ce8c-4c34-b1d1-7fbf8f91b6eb" providerId="ADAL" clId="{F3155301-60F9-466A-97B1-4E5391BEC052}" dt="2022-02-06T22:40:31.346" v="36"/>
          <ac:spMkLst>
            <pc:docMk/>
            <pc:sldMk cId="583791291" sldId="265"/>
            <ac:spMk id="7" creationId="{669EC6DC-A060-4FEB-9F88-3207967995BC}"/>
          </ac:spMkLst>
        </pc:spChg>
        <pc:spChg chg="mod">
          <ac:chgData name="Sameer G Joshi (DJPR)" userId="bd06337d-ce8c-4c34-b1d1-7fbf8f91b6eb" providerId="ADAL" clId="{F3155301-60F9-466A-97B1-4E5391BEC052}" dt="2022-02-06T22:40:31.346" v="36"/>
          <ac:spMkLst>
            <pc:docMk/>
            <pc:sldMk cId="583791291" sldId="265"/>
            <ac:spMk id="46" creationId="{45F850D6-674D-46BB-BC57-F7B3BFE344EA}"/>
          </ac:spMkLst>
        </pc:spChg>
      </pc:sldChg>
      <pc:sldChg chg="modSp">
        <pc:chgData name="Sameer G Joshi (DJPR)" userId="bd06337d-ce8c-4c34-b1d1-7fbf8f91b6eb" providerId="ADAL" clId="{F3155301-60F9-466A-97B1-4E5391BEC052}" dt="2022-02-06T22:40:31.346" v="36"/>
        <pc:sldMkLst>
          <pc:docMk/>
          <pc:sldMk cId="3253327431" sldId="266"/>
        </pc:sldMkLst>
        <pc:spChg chg="mod">
          <ac:chgData name="Sameer G Joshi (DJPR)" userId="bd06337d-ce8c-4c34-b1d1-7fbf8f91b6eb" providerId="ADAL" clId="{F3155301-60F9-466A-97B1-4E5391BEC052}" dt="2022-02-06T22:40:31.346" v="36"/>
          <ac:spMkLst>
            <pc:docMk/>
            <pc:sldMk cId="3253327431" sldId="266"/>
            <ac:spMk id="44" creationId="{E779D197-D829-4C20-AFC3-CFAF41DE6490}"/>
          </ac:spMkLst>
        </pc:spChg>
        <pc:spChg chg="mod">
          <ac:chgData name="Sameer G Joshi (DJPR)" userId="bd06337d-ce8c-4c34-b1d1-7fbf8f91b6eb" providerId="ADAL" clId="{F3155301-60F9-466A-97B1-4E5391BEC052}" dt="2022-02-06T22:40:29.098" v="35"/>
          <ac:spMkLst>
            <pc:docMk/>
            <pc:sldMk cId="3253327431" sldId="266"/>
            <ac:spMk id="47" creationId="{58598D9D-FF64-4D59-9BA5-0BA7BC3B11B0}"/>
          </ac:spMkLst>
        </pc:spChg>
        <pc:spChg chg="mod">
          <ac:chgData name="Sameer G Joshi (DJPR)" userId="bd06337d-ce8c-4c34-b1d1-7fbf8f91b6eb" providerId="ADAL" clId="{F3155301-60F9-466A-97B1-4E5391BEC052}" dt="2022-02-06T22:40:29.098" v="35"/>
          <ac:spMkLst>
            <pc:docMk/>
            <pc:sldMk cId="3253327431" sldId="266"/>
            <ac:spMk id="48" creationId="{06100C58-1A0B-49E1-8972-28A68BCAE230}"/>
          </ac:spMkLst>
        </pc:spChg>
        <pc:spChg chg="mod">
          <ac:chgData name="Sameer G Joshi (DJPR)" userId="bd06337d-ce8c-4c34-b1d1-7fbf8f91b6eb" providerId="ADAL" clId="{F3155301-60F9-466A-97B1-4E5391BEC052}" dt="2022-02-06T22:40:31.346" v="36"/>
          <ac:spMkLst>
            <pc:docMk/>
            <pc:sldMk cId="3253327431" sldId="266"/>
            <ac:spMk id="52" creationId="{60C3E0AD-79A0-4B96-BF83-63FA6FB09CDD}"/>
          </ac:spMkLst>
        </pc:spChg>
      </pc:sldChg>
      <pc:sldChg chg="modSp">
        <pc:chgData name="Sameer G Joshi (DJPR)" userId="bd06337d-ce8c-4c34-b1d1-7fbf8f91b6eb" providerId="ADAL" clId="{F3155301-60F9-466A-97B1-4E5391BEC052}" dt="2022-02-06T22:40:31.346" v="36"/>
        <pc:sldMkLst>
          <pc:docMk/>
          <pc:sldMk cId="1068351154" sldId="267"/>
        </pc:sldMkLst>
        <pc:spChg chg="mod">
          <ac:chgData name="Sameer G Joshi (DJPR)" userId="bd06337d-ce8c-4c34-b1d1-7fbf8f91b6eb" providerId="ADAL" clId="{F3155301-60F9-466A-97B1-4E5391BEC052}" dt="2022-02-06T22:40:31.346" v="36"/>
          <ac:spMkLst>
            <pc:docMk/>
            <pc:sldMk cId="1068351154" sldId="267"/>
            <ac:spMk id="27" creationId="{BFC6561F-D021-49C5-A874-0E33501DD689}"/>
          </ac:spMkLst>
        </pc:spChg>
        <pc:spChg chg="mod">
          <ac:chgData name="Sameer G Joshi (DJPR)" userId="bd06337d-ce8c-4c34-b1d1-7fbf8f91b6eb" providerId="ADAL" clId="{F3155301-60F9-466A-97B1-4E5391BEC052}" dt="2022-02-06T22:40:31.346" v="36"/>
          <ac:spMkLst>
            <pc:docMk/>
            <pc:sldMk cId="1068351154" sldId="267"/>
            <ac:spMk id="48" creationId="{E5B8C49A-94D0-4BED-9917-B52D66E25F03}"/>
          </ac:spMkLst>
        </pc:spChg>
      </pc:sldChg>
      <pc:sldChg chg="modSp">
        <pc:chgData name="Sameer G Joshi (DJPR)" userId="bd06337d-ce8c-4c34-b1d1-7fbf8f91b6eb" providerId="ADAL" clId="{F3155301-60F9-466A-97B1-4E5391BEC052}" dt="2022-02-06T22:40:31.346" v="36"/>
        <pc:sldMkLst>
          <pc:docMk/>
          <pc:sldMk cId="2979161283" sldId="268"/>
        </pc:sldMkLst>
        <pc:spChg chg="mod">
          <ac:chgData name="Sameer G Joshi (DJPR)" userId="bd06337d-ce8c-4c34-b1d1-7fbf8f91b6eb" providerId="ADAL" clId="{F3155301-60F9-466A-97B1-4E5391BEC052}" dt="2022-02-06T22:40:29.098" v="35"/>
          <ac:spMkLst>
            <pc:docMk/>
            <pc:sldMk cId="2979161283" sldId="268"/>
            <ac:spMk id="7" creationId="{160F0EE4-00BD-4C36-B867-7272062E708A}"/>
          </ac:spMkLst>
        </pc:spChg>
        <pc:spChg chg="mod">
          <ac:chgData name="Sameer G Joshi (DJPR)" userId="bd06337d-ce8c-4c34-b1d1-7fbf8f91b6eb" providerId="ADAL" clId="{F3155301-60F9-466A-97B1-4E5391BEC052}" dt="2022-02-06T22:40:31.346" v="36"/>
          <ac:spMkLst>
            <pc:docMk/>
            <pc:sldMk cId="2979161283" sldId="268"/>
            <ac:spMk id="36" creationId="{09FA44B6-6D81-42D7-B5B5-3517607D9C8F}"/>
          </ac:spMkLst>
        </pc:spChg>
        <pc:spChg chg="mod">
          <ac:chgData name="Sameer G Joshi (DJPR)" userId="bd06337d-ce8c-4c34-b1d1-7fbf8f91b6eb" providerId="ADAL" clId="{F3155301-60F9-466A-97B1-4E5391BEC052}" dt="2022-02-06T22:40:29.098" v="35"/>
          <ac:spMkLst>
            <pc:docMk/>
            <pc:sldMk cId="2979161283" sldId="268"/>
            <ac:spMk id="38" creationId="{C903D545-BD34-41D8-87FF-B96084478DA4}"/>
          </ac:spMkLst>
        </pc:spChg>
        <pc:spChg chg="mod">
          <ac:chgData name="Sameer G Joshi (DJPR)" userId="bd06337d-ce8c-4c34-b1d1-7fbf8f91b6eb" providerId="ADAL" clId="{F3155301-60F9-466A-97B1-4E5391BEC052}" dt="2022-02-06T22:40:31.346" v="36"/>
          <ac:spMkLst>
            <pc:docMk/>
            <pc:sldMk cId="2979161283" sldId="268"/>
            <ac:spMk id="40" creationId="{126E7DE3-B5E6-46D5-BB5C-775FC3C4DBD4}"/>
          </ac:spMkLst>
        </pc:spChg>
      </pc:sldChg>
      <pc:sldChg chg="modSp">
        <pc:chgData name="Sameer G Joshi (DJPR)" userId="bd06337d-ce8c-4c34-b1d1-7fbf8f91b6eb" providerId="ADAL" clId="{F3155301-60F9-466A-97B1-4E5391BEC052}" dt="2022-02-06T22:40:29.098" v="35"/>
        <pc:sldMkLst>
          <pc:docMk/>
          <pc:sldMk cId="446862676" sldId="269"/>
        </pc:sldMkLst>
        <pc:spChg chg="mod">
          <ac:chgData name="Sameer G Joshi (DJPR)" userId="bd06337d-ce8c-4c34-b1d1-7fbf8f91b6eb" providerId="ADAL" clId="{F3155301-60F9-466A-97B1-4E5391BEC052}" dt="2022-02-06T22:40:29.098" v="35"/>
          <ac:spMkLst>
            <pc:docMk/>
            <pc:sldMk cId="446862676" sldId="269"/>
            <ac:spMk id="5" creationId="{251A451C-65F8-4F03-8117-EF5D0DAAADEE}"/>
          </ac:spMkLst>
        </pc:spChg>
        <pc:graphicFrameChg chg="mod">
          <ac:chgData name="Sameer G Joshi (DJPR)" userId="bd06337d-ce8c-4c34-b1d1-7fbf8f91b6eb" providerId="ADAL" clId="{F3155301-60F9-466A-97B1-4E5391BEC052}" dt="2022-02-06T22:40:29.098" v="35"/>
          <ac:graphicFrameMkLst>
            <pc:docMk/>
            <pc:sldMk cId="446862676" sldId="269"/>
            <ac:graphicFrameMk id="10" creationId="{228EABB7-3E76-43B4-AA81-C0C3CC4D3E5E}"/>
          </ac:graphicFrameMkLst>
        </pc:graphicFrameChg>
      </pc:sldChg>
      <pc:sldMasterChg chg="modSldLayout">
        <pc:chgData name="Sameer G Joshi (DJPR)" userId="bd06337d-ce8c-4c34-b1d1-7fbf8f91b6eb" providerId="ADAL" clId="{F3155301-60F9-466A-97B1-4E5391BEC052}" dt="2022-02-06T22:40:29.098" v="35"/>
        <pc:sldMasterMkLst>
          <pc:docMk/>
          <pc:sldMasterMk cId="3643008945" sldId="2147483684"/>
        </pc:sldMasterMkLst>
        <pc:sldLayoutChg chg="modSp">
          <pc:chgData name="Sameer G Joshi (DJPR)" userId="bd06337d-ce8c-4c34-b1d1-7fbf8f91b6eb" providerId="ADAL" clId="{F3155301-60F9-466A-97B1-4E5391BEC052}" dt="2022-02-06T22:40:29.098" v="35"/>
          <pc:sldLayoutMkLst>
            <pc:docMk/>
            <pc:sldMasterMk cId="3643008945" sldId="2147483684"/>
            <pc:sldLayoutMk cId="3622483055" sldId="2147483693"/>
          </pc:sldLayoutMkLst>
          <pc:spChg chg="mod">
            <ac:chgData name="Sameer G Joshi (DJPR)" userId="bd06337d-ce8c-4c34-b1d1-7fbf8f91b6eb" providerId="ADAL" clId="{F3155301-60F9-466A-97B1-4E5391BEC052}" dt="2022-02-06T22:40:29.098" v="35"/>
            <ac:spMkLst>
              <pc:docMk/>
              <pc:sldMasterMk cId="3643008945" sldId="2147483684"/>
              <pc:sldLayoutMk cId="3622483055" sldId="2147483693"/>
              <ac:spMk id="3" creationId="{00000000-0000-0000-0000-000000000000}"/>
            </ac:spMkLst>
          </pc:spChg>
        </pc:sldLayoutChg>
      </pc:sldMasterChg>
    </pc:docChg>
  </pc:docChgLst>
  <pc:docChgLst>
    <pc:chgData name="Sameer G Joshi (DJPR)" userId="bd06337d-ce8c-4c34-b1d1-7fbf8f91b6eb" providerId="ADAL" clId="{B9B8FF69-58F3-48D8-9439-0B94E292364A}"/>
    <pc:docChg chg="undo custSel addSld delSld modSld modMainMaster modNotesMaster">
      <pc:chgData name="Sameer G Joshi (DJPR)" userId="bd06337d-ce8c-4c34-b1d1-7fbf8f91b6eb" providerId="ADAL" clId="{B9B8FF69-58F3-48D8-9439-0B94E292364A}" dt="2021-06-20T12:30:35.206" v="4396" actId="20577"/>
      <pc:docMkLst>
        <pc:docMk/>
      </pc:docMkLst>
      <pc:sldChg chg="modSp mod">
        <pc:chgData name="Sameer G Joshi (DJPR)" userId="bd06337d-ce8c-4c34-b1d1-7fbf8f91b6eb" providerId="ADAL" clId="{B9B8FF69-58F3-48D8-9439-0B94E292364A}" dt="2021-06-08T06:18:56.350" v="121" actId="1035"/>
        <pc:sldMkLst>
          <pc:docMk/>
          <pc:sldMk cId="3352034816" sldId="256"/>
        </pc:sldMkLst>
        <pc:spChg chg="mod">
          <ac:chgData name="Sameer G Joshi (DJPR)" userId="bd06337d-ce8c-4c34-b1d1-7fbf8f91b6eb" providerId="ADAL" clId="{B9B8FF69-58F3-48D8-9439-0B94E292364A}" dt="2021-06-08T06:18:56.350" v="121" actId="1035"/>
          <ac:spMkLst>
            <pc:docMk/>
            <pc:sldMk cId="3352034816" sldId="256"/>
            <ac:spMk id="8" creationId="{520DCA2E-CECA-42FB-8D8D-F305B5344E3E}"/>
          </ac:spMkLst>
        </pc:spChg>
        <pc:spChg chg="mod">
          <ac:chgData name="Sameer G Joshi (DJPR)" userId="bd06337d-ce8c-4c34-b1d1-7fbf8f91b6eb" providerId="ADAL" clId="{B9B8FF69-58F3-48D8-9439-0B94E292364A}" dt="2021-06-08T06:18:56.350" v="121" actId="1035"/>
          <ac:spMkLst>
            <pc:docMk/>
            <pc:sldMk cId="3352034816" sldId="256"/>
            <ac:spMk id="9" creationId="{30206B20-BF06-4357-B1DD-8CD6E08A3CF8}"/>
          </ac:spMkLst>
        </pc:spChg>
        <pc:spChg chg="mod">
          <ac:chgData name="Sameer G Joshi (DJPR)" userId="bd06337d-ce8c-4c34-b1d1-7fbf8f91b6eb" providerId="ADAL" clId="{B9B8FF69-58F3-48D8-9439-0B94E292364A}" dt="2021-06-08T06:18:56.350" v="121" actId="1035"/>
          <ac:spMkLst>
            <pc:docMk/>
            <pc:sldMk cId="3352034816" sldId="256"/>
            <ac:spMk id="10" creationId="{FAB49720-C1D9-4B92-8980-50A09B42F116}"/>
          </ac:spMkLst>
        </pc:spChg>
        <pc:picChg chg="mod">
          <ac:chgData name="Sameer G Joshi (DJPR)" userId="bd06337d-ce8c-4c34-b1d1-7fbf8f91b6eb" providerId="ADAL" clId="{B9B8FF69-58F3-48D8-9439-0B94E292364A}" dt="2021-06-08T06:18:56.350" v="121" actId="1035"/>
          <ac:picMkLst>
            <pc:docMk/>
            <pc:sldMk cId="3352034816" sldId="256"/>
            <ac:picMk id="5" creationId="{DCDAA8EF-E4E7-4A09-9325-192D7AEB08E8}"/>
          </ac:picMkLst>
        </pc:picChg>
        <pc:picChg chg="mod">
          <ac:chgData name="Sameer G Joshi (DJPR)" userId="bd06337d-ce8c-4c34-b1d1-7fbf8f91b6eb" providerId="ADAL" clId="{B9B8FF69-58F3-48D8-9439-0B94E292364A}" dt="2021-06-08T06:18:56.350" v="121" actId="1035"/>
          <ac:picMkLst>
            <pc:docMk/>
            <pc:sldMk cId="3352034816" sldId="256"/>
            <ac:picMk id="7" creationId="{78743228-9D9E-44EB-AAA9-79ECE72B6591}"/>
          </ac:picMkLst>
        </pc:picChg>
      </pc:sldChg>
      <pc:sldChg chg="modSp del">
        <pc:chgData name="Sameer G Joshi (DJPR)" userId="bd06337d-ce8c-4c34-b1d1-7fbf8f91b6eb" providerId="ADAL" clId="{B9B8FF69-58F3-48D8-9439-0B94E292364A}" dt="2021-06-15T00:45:03.011" v="1076" actId="47"/>
        <pc:sldMkLst>
          <pc:docMk/>
          <pc:sldMk cId="370308576" sldId="257"/>
        </pc:sldMkLst>
        <pc:spChg chg="mod">
          <ac:chgData name="Sameer G Joshi (DJPR)" userId="bd06337d-ce8c-4c34-b1d1-7fbf8f91b6eb" providerId="ADAL" clId="{B9B8FF69-58F3-48D8-9439-0B94E292364A}" dt="2021-06-08T06:19:13.210" v="175" actId="1036"/>
          <ac:spMkLst>
            <pc:docMk/>
            <pc:sldMk cId="370308576" sldId="257"/>
            <ac:spMk id="5" creationId="{FE29ABBE-D0E7-4836-8A92-F70FBE6B7118}"/>
          </ac:spMkLst>
        </pc:spChg>
        <pc:spChg chg="mod">
          <ac:chgData name="Sameer G Joshi (DJPR)" userId="bd06337d-ce8c-4c34-b1d1-7fbf8f91b6eb" providerId="ADAL" clId="{B9B8FF69-58F3-48D8-9439-0B94E292364A}" dt="2021-06-08T06:19:13.210" v="175" actId="1036"/>
          <ac:spMkLst>
            <pc:docMk/>
            <pc:sldMk cId="370308576" sldId="257"/>
            <ac:spMk id="6" creationId="{6C719FE6-B23C-4502-9E7C-F3C21CE3933C}"/>
          </ac:spMkLst>
        </pc:spChg>
        <pc:spChg chg="mod">
          <ac:chgData name="Sameer G Joshi (DJPR)" userId="bd06337d-ce8c-4c34-b1d1-7fbf8f91b6eb" providerId="ADAL" clId="{B9B8FF69-58F3-48D8-9439-0B94E292364A}" dt="2021-06-08T06:19:13.210" v="175" actId="1036"/>
          <ac:spMkLst>
            <pc:docMk/>
            <pc:sldMk cId="370308576" sldId="257"/>
            <ac:spMk id="7" creationId="{B3A04D8B-AA8B-424A-9958-3046C6DEEB4B}"/>
          </ac:spMkLst>
        </pc:spChg>
        <pc:spChg chg="mod">
          <ac:chgData name="Sameer G Joshi (DJPR)" userId="bd06337d-ce8c-4c34-b1d1-7fbf8f91b6eb" providerId="ADAL" clId="{B9B8FF69-58F3-48D8-9439-0B94E292364A}" dt="2021-06-08T06:19:13.210" v="175" actId="1036"/>
          <ac:spMkLst>
            <pc:docMk/>
            <pc:sldMk cId="370308576" sldId="257"/>
            <ac:spMk id="9" creationId="{A7343642-E786-4F55-8323-A2489A7ACD1F}"/>
          </ac:spMkLst>
        </pc:spChg>
        <pc:spChg chg="mod">
          <ac:chgData name="Sameer G Joshi (DJPR)" userId="bd06337d-ce8c-4c34-b1d1-7fbf8f91b6eb" providerId="ADAL" clId="{B9B8FF69-58F3-48D8-9439-0B94E292364A}" dt="2021-06-08T06:19:13.210" v="175" actId="1036"/>
          <ac:spMkLst>
            <pc:docMk/>
            <pc:sldMk cId="370308576" sldId="257"/>
            <ac:spMk id="10" creationId="{C0048344-15C2-4E24-89E3-2DCD0B6FBC9D}"/>
          </ac:spMkLst>
        </pc:spChg>
        <pc:spChg chg="mod">
          <ac:chgData name="Sameer G Joshi (DJPR)" userId="bd06337d-ce8c-4c34-b1d1-7fbf8f91b6eb" providerId="ADAL" clId="{B9B8FF69-58F3-48D8-9439-0B94E292364A}" dt="2021-06-08T06:19:13.210" v="175" actId="1036"/>
          <ac:spMkLst>
            <pc:docMk/>
            <pc:sldMk cId="370308576" sldId="257"/>
            <ac:spMk id="11" creationId="{A23CB308-B3A7-472D-94CB-A4661D696ED2}"/>
          </ac:spMkLst>
        </pc:spChg>
        <pc:spChg chg="mod">
          <ac:chgData name="Sameer G Joshi (DJPR)" userId="bd06337d-ce8c-4c34-b1d1-7fbf8f91b6eb" providerId="ADAL" clId="{B9B8FF69-58F3-48D8-9439-0B94E292364A}" dt="2021-06-08T06:19:13.210" v="175" actId="1036"/>
          <ac:spMkLst>
            <pc:docMk/>
            <pc:sldMk cId="370308576" sldId="257"/>
            <ac:spMk id="12" creationId="{CCE5C626-AE56-4E2C-87D8-9ADA7A00A9DF}"/>
          </ac:spMkLst>
        </pc:spChg>
        <pc:spChg chg="mod">
          <ac:chgData name="Sameer G Joshi (DJPR)" userId="bd06337d-ce8c-4c34-b1d1-7fbf8f91b6eb" providerId="ADAL" clId="{B9B8FF69-58F3-48D8-9439-0B94E292364A}" dt="2021-06-08T06:19:13.210" v="175" actId="1036"/>
          <ac:spMkLst>
            <pc:docMk/>
            <pc:sldMk cId="370308576" sldId="257"/>
            <ac:spMk id="13" creationId="{CED314A4-33B4-4BBB-9F19-7CCF07270BA3}"/>
          </ac:spMkLst>
        </pc:spChg>
        <pc:spChg chg="mod">
          <ac:chgData name="Sameer G Joshi (DJPR)" userId="bd06337d-ce8c-4c34-b1d1-7fbf8f91b6eb" providerId="ADAL" clId="{B9B8FF69-58F3-48D8-9439-0B94E292364A}" dt="2021-06-08T06:19:13.210" v="175" actId="1036"/>
          <ac:spMkLst>
            <pc:docMk/>
            <pc:sldMk cId="370308576" sldId="257"/>
            <ac:spMk id="14" creationId="{8CC81BD8-0953-43CC-9CA8-FEEBCBBDABD8}"/>
          </ac:spMkLst>
        </pc:spChg>
        <pc:spChg chg="mod">
          <ac:chgData name="Sameer G Joshi (DJPR)" userId="bd06337d-ce8c-4c34-b1d1-7fbf8f91b6eb" providerId="ADAL" clId="{B9B8FF69-58F3-48D8-9439-0B94E292364A}" dt="2021-06-08T06:19:13.210" v="175" actId="1036"/>
          <ac:spMkLst>
            <pc:docMk/>
            <pc:sldMk cId="370308576" sldId="257"/>
            <ac:spMk id="15" creationId="{602AA814-4DFA-491F-9C66-80D4C6E8955D}"/>
          </ac:spMkLst>
        </pc:spChg>
        <pc:spChg chg="mod">
          <ac:chgData name="Sameer G Joshi (DJPR)" userId="bd06337d-ce8c-4c34-b1d1-7fbf8f91b6eb" providerId="ADAL" clId="{B9B8FF69-58F3-48D8-9439-0B94E292364A}" dt="2021-06-08T06:19:13.210" v="175" actId="1036"/>
          <ac:spMkLst>
            <pc:docMk/>
            <pc:sldMk cId="370308576" sldId="257"/>
            <ac:spMk id="16" creationId="{8147E8C9-9A1A-496C-95A3-D0EC330C0968}"/>
          </ac:spMkLst>
        </pc:spChg>
        <pc:spChg chg="mod">
          <ac:chgData name="Sameer G Joshi (DJPR)" userId="bd06337d-ce8c-4c34-b1d1-7fbf8f91b6eb" providerId="ADAL" clId="{B9B8FF69-58F3-48D8-9439-0B94E292364A}" dt="2021-06-08T06:19:13.210" v="175" actId="1036"/>
          <ac:spMkLst>
            <pc:docMk/>
            <pc:sldMk cId="370308576" sldId="257"/>
            <ac:spMk id="17" creationId="{FFA0D330-5AE6-4088-87C8-4084CBA302B5}"/>
          </ac:spMkLst>
        </pc:spChg>
        <pc:spChg chg="mod">
          <ac:chgData name="Sameer G Joshi (DJPR)" userId="bd06337d-ce8c-4c34-b1d1-7fbf8f91b6eb" providerId="ADAL" clId="{B9B8FF69-58F3-48D8-9439-0B94E292364A}" dt="2021-06-08T06:19:13.210" v="175" actId="1036"/>
          <ac:spMkLst>
            <pc:docMk/>
            <pc:sldMk cId="370308576" sldId="257"/>
            <ac:spMk id="18" creationId="{2F8C8F51-7130-4AB3-BA68-D6492523E1AB}"/>
          </ac:spMkLst>
        </pc:spChg>
        <pc:spChg chg="mod">
          <ac:chgData name="Sameer G Joshi (DJPR)" userId="bd06337d-ce8c-4c34-b1d1-7fbf8f91b6eb" providerId="ADAL" clId="{B9B8FF69-58F3-48D8-9439-0B94E292364A}" dt="2021-06-08T06:19:13.210" v="175" actId="1036"/>
          <ac:spMkLst>
            <pc:docMk/>
            <pc:sldMk cId="370308576" sldId="257"/>
            <ac:spMk id="19" creationId="{16675909-BCE2-45A9-B1CC-BB3633368B30}"/>
          </ac:spMkLst>
        </pc:spChg>
        <pc:spChg chg="mod">
          <ac:chgData name="Sameer G Joshi (DJPR)" userId="bd06337d-ce8c-4c34-b1d1-7fbf8f91b6eb" providerId="ADAL" clId="{B9B8FF69-58F3-48D8-9439-0B94E292364A}" dt="2021-06-08T06:19:13.210" v="175" actId="1036"/>
          <ac:spMkLst>
            <pc:docMk/>
            <pc:sldMk cId="370308576" sldId="257"/>
            <ac:spMk id="20" creationId="{A912B59C-585F-4051-B646-698660255F40}"/>
          </ac:spMkLst>
        </pc:spChg>
        <pc:spChg chg="mod">
          <ac:chgData name="Sameer G Joshi (DJPR)" userId="bd06337d-ce8c-4c34-b1d1-7fbf8f91b6eb" providerId="ADAL" clId="{B9B8FF69-58F3-48D8-9439-0B94E292364A}" dt="2021-06-08T06:19:13.210" v="175" actId="1036"/>
          <ac:spMkLst>
            <pc:docMk/>
            <pc:sldMk cId="370308576" sldId="257"/>
            <ac:spMk id="21" creationId="{253D8772-DB97-47F1-AC2B-CD870B4ACB0E}"/>
          </ac:spMkLst>
        </pc:spChg>
        <pc:spChg chg="mod">
          <ac:chgData name="Sameer G Joshi (DJPR)" userId="bd06337d-ce8c-4c34-b1d1-7fbf8f91b6eb" providerId="ADAL" clId="{B9B8FF69-58F3-48D8-9439-0B94E292364A}" dt="2021-06-08T06:19:13.210" v="175" actId="1036"/>
          <ac:spMkLst>
            <pc:docMk/>
            <pc:sldMk cId="370308576" sldId="257"/>
            <ac:spMk id="22" creationId="{3E4301C3-7258-41C5-AF1A-551BB6BB26F4}"/>
          </ac:spMkLst>
        </pc:spChg>
        <pc:spChg chg="mod">
          <ac:chgData name="Sameer G Joshi (DJPR)" userId="bd06337d-ce8c-4c34-b1d1-7fbf8f91b6eb" providerId="ADAL" clId="{B9B8FF69-58F3-48D8-9439-0B94E292364A}" dt="2021-06-08T06:19:13.210" v="175" actId="1036"/>
          <ac:spMkLst>
            <pc:docMk/>
            <pc:sldMk cId="370308576" sldId="257"/>
            <ac:spMk id="23" creationId="{0B9F7579-86AF-4BAC-BD55-7089AB5AC9C0}"/>
          </ac:spMkLst>
        </pc:spChg>
        <pc:spChg chg="mod">
          <ac:chgData name="Sameer G Joshi (DJPR)" userId="bd06337d-ce8c-4c34-b1d1-7fbf8f91b6eb" providerId="ADAL" clId="{B9B8FF69-58F3-48D8-9439-0B94E292364A}" dt="2021-06-08T06:19:13.210" v="175" actId="1036"/>
          <ac:spMkLst>
            <pc:docMk/>
            <pc:sldMk cId="370308576" sldId="257"/>
            <ac:spMk id="24" creationId="{24B81FBE-5CC7-4E25-8711-768EB60890EB}"/>
          </ac:spMkLst>
        </pc:spChg>
        <pc:spChg chg="mod">
          <ac:chgData name="Sameer G Joshi (DJPR)" userId="bd06337d-ce8c-4c34-b1d1-7fbf8f91b6eb" providerId="ADAL" clId="{B9B8FF69-58F3-48D8-9439-0B94E292364A}" dt="2021-06-08T06:19:13.210" v="175" actId="1036"/>
          <ac:spMkLst>
            <pc:docMk/>
            <pc:sldMk cId="370308576" sldId="257"/>
            <ac:spMk id="25" creationId="{FB097C79-2461-44C7-8925-5D45175D3713}"/>
          </ac:spMkLst>
        </pc:spChg>
        <pc:spChg chg="mod">
          <ac:chgData name="Sameer G Joshi (DJPR)" userId="bd06337d-ce8c-4c34-b1d1-7fbf8f91b6eb" providerId="ADAL" clId="{B9B8FF69-58F3-48D8-9439-0B94E292364A}" dt="2021-06-08T06:19:13.210" v="175" actId="1036"/>
          <ac:spMkLst>
            <pc:docMk/>
            <pc:sldMk cId="370308576" sldId="257"/>
            <ac:spMk id="26" creationId="{31F3D738-C36D-40A2-AA11-4321D1BEDBE8}"/>
          </ac:spMkLst>
        </pc:spChg>
        <pc:spChg chg="mod">
          <ac:chgData name="Sameer G Joshi (DJPR)" userId="bd06337d-ce8c-4c34-b1d1-7fbf8f91b6eb" providerId="ADAL" clId="{B9B8FF69-58F3-48D8-9439-0B94E292364A}" dt="2021-06-08T06:19:13.210" v="175" actId="1036"/>
          <ac:spMkLst>
            <pc:docMk/>
            <pc:sldMk cId="370308576" sldId="257"/>
            <ac:spMk id="27" creationId="{4544EEAF-BED2-4F0E-BD0E-94953608A34B}"/>
          </ac:spMkLst>
        </pc:spChg>
        <pc:spChg chg="mod">
          <ac:chgData name="Sameer G Joshi (DJPR)" userId="bd06337d-ce8c-4c34-b1d1-7fbf8f91b6eb" providerId="ADAL" clId="{B9B8FF69-58F3-48D8-9439-0B94E292364A}" dt="2021-06-08T06:19:13.210" v="175" actId="1036"/>
          <ac:spMkLst>
            <pc:docMk/>
            <pc:sldMk cId="370308576" sldId="257"/>
            <ac:spMk id="28" creationId="{5777B869-E785-4220-9D4A-07D406FDF7F8}"/>
          </ac:spMkLst>
        </pc:spChg>
        <pc:spChg chg="mod">
          <ac:chgData name="Sameer G Joshi (DJPR)" userId="bd06337d-ce8c-4c34-b1d1-7fbf8f91b6eb" providerId="ADAL" clId="{B9B8FF69-58F3-48D8-9439-0B94E292364A}" dt="2021-06-08T06:19:13.210" v="175" actId="1036"/>
          <ac:spMkLst>
            <pc:docMk/>
            <pc:sldMk cId="370308576" sldId="257"/>
            <ac:spMk id="29" creationId="{0F896F8E-0040-48D5-B735-53650DC43D60}"/>
          </ac:spMkLst>
        </pc:spChg>
        <pc:spChg chg="mod">
          <ac:chgData name="Sameer G Joshi (DJPR)" userId="bd06337d-ce8c-4c34-b1d1-7fbf8f91b6eb" providerId="ADAL" clId="{B9B8FF69-58F3-48D8-9439-0B94E292364A}" dt="2021-06-08T06:19:13.210" v="175" actId="1036"/>
          <ac:spMkLst>
            <pc:docMk/>
            <pc:sldMk cId="370308576" sldId="257"/>
            <ac:spMk id="30" creationId="{9EB07A2B-4FDD-4C52-A395-0DEB77613253}"/>
          </ac:spMkLst>
        </pc:spChg>
        <pc:spChg chg="mod">
          <ac:chgData name="Sameer G Joshi (DJPR)" userId="bd06337d-ce8c-4c34-b1d1-7fbf8f91b6eb" providerId="ADAL" clId="{B9B8FF69-58F3-48D8-9439-0B94E292364A}" dt="2021-06-08T06:19:13.210" v="175" actId="1036"/>
          <ac:spMkLst>
            <pc:docMk/>
            <pc:sldMk cId="370308576" sldId="257"/>
            <ac:spMk id="31" creationId="{AA67D449-241E-41A5-AC28-8B3A0ECC8F69}"/>
          </ac:spMkLst>
        </pc:spChg>
        <pc:spChg chg="mod">
          <ac:chgData name="Sameer G Joshi (DJPR)" userId="bd06337d-ce8c-4c34-b1d1-7fbf8f91b6eb" providerId="ADAL" clId="{B9B8FF69-58F3-48D8-9439-0B94E292364A}" dt="2021-06-08T06:19:13.210" v="175" actId="1036"/>
          <ac:spMkLst>
            <pc:docMk/>
            <pc:sldMk cId="370308576" sldId="257"/>
            <ac:spMk id="32" creationId="{8D1C2F28-3272-42A4-BAB5-72EFF9065B83}"/>
          </ac:spMkLst>
        </pc:spChg>
        <pc:spChg chg="mod">
          <ac:chgData name="Sameer G Joshi (DJPR)" userId="bd06337d-ce8c-4c34-b1d1-7fbf8f91b6eb" providerId="ADAL" clId="{B9B8FF69-58F3-48D8-9439-0B94E292364A}" dt="2021-06-08T06:19:13.210" v="175" actId="1036"/>
          <ac:spMkLst>
            <pc:docMk/>
            <pc:sldMk cId="370308576" sldId="257"/>
            <ac:spMk id="33" creationId="{571A4912-C932-48F6-A7A0-344325095455}"/>
          </ac:spMkLst>
        </pc:spChg>
        <pc:spChg chg="mod">
          <ac:chgData name="Sameer G Joshi (DJPR)" userId="bd06337d-ce8c-4c34-b1d1-7fbf8f91b6eb" providerId="ADAL" clId="{B9B8FF69-58F3-48D8-9439-0B94E292364A}" dt="2021-06-08T06:19:13.210" v="175" actId="1036"/>
          <ac:spMkLst>
            <pc:docMk/>
            <pc:sldMk cId="370308576" sldId="257"/>
            <ac:spMk id="34" creationId="{DBB87338-4D65-4986-B274-EE13427C59FD}"/>
          </ac:spMkLst>
        </pc:spChg>
        <pc:spChg chg="mod">
          <ac:chgData name="Sameer G Joshi (DJPR)" userId="bd06337d-ce8c-4c34-b1d1-7fbf8f91b6eb" providerId="ADAL" clId="{B9B8FF69-58F3-48D8-9439-0B94E292364A}" dt="2021-06-08T06:19:13.210" v="175" actId="1036"/>
          <ac:spMkLst>
            <pc:docMk/>
            <pc:sldMk cId="370308576" sldId="257"/>
            <ac:spMk id="35" creationId="{61DB5F7C-A07B-40A5-A844-88AE3E9EED89}"/>
          </ac:spMkLst>
        </pc:spChg>
        <pc:spChg chg="mod">
          <ac:chgData name="Sameer G Joshi (DJPR)" userId="bd06337d-ce8c-4c34-b1d1-7fbf8f91b6eb" providerId="ADAL" clId="{B9B8FF69-58F3-48D8-9439-0B94E292364A}" dt="2021-06-08T06:19:13.210" v="175" actId="1036"/>
          <ac:spMkLst>
            <pc:docMk/>
            <pc:sldMk cId="370308576" sldId="257"/>
            <ac:spMk id="36" creationId="{92FD7434-4BFA-4582-B065-58738E89C410}"/>
          </ac:spMkLst>
        </pc:spChg>
        <pc:spChg chg="mod">
          <ac:chgData name="Sameer G Joshi (DJPR)" userId="bd06337d-ce8c-4c34-b1d1-7fbf8f91b6eb" providerId="ADAL" clId="{B9B8FF69-58F3-48D8-9439-0B94E292364A}" dt="2021-06-08T06:19:13.210" v="175" actId="1036"/>
          <ac:spMkLst>
            <pc:docMk/>
            <pc:sldMk cId="370308576" sldId="257"/>
            <ac:spMk id="37" creationId="{45745397-5F22-4FFA-9441-FA1FE1DE28BF}"/>
          </ac:spMkLst>
        </pc:spChg>
        <pc:spChg chg="mod">
          <ac:chgData name="Sameer G Joshi (DJPR)" userId="bd06337d-ce8c-4c34-b1d1-7fbf8f91b6eb" providerId="ADAL" clId="{B9B8FF69-58F3-48D8-9439-0B94E292364A}" dt="2021-06-08T06:19:13.210" v="175" actId="1036"/>
          <ac:spMkLst>
            <pc:docMk/>
            <pc:sldMk cId="370308576" sldId="257"/>
            <ac:spMk id="38" creationId="{563914C8-B85A-4815-AF07-E7764F927372}"/>
          </ac:spMkLst>
        </pc:spChg>
        <pc:spChg chg="mod">
          <ac:chgData name="Sameer G Joshi (DJPR)" userId="bd06337d-ce8c-4c34-b1d1-7fbf8f91b6eb" providerId="ADAL" clId="{B9B8FF69-58F3-48D8-9439-0B94E292364A}" dt="2021-06-08T06:19:13.210" v="175" actId="1036"/>
          <ac:spMkLst>
            <pc:docMk/>
            <pc:sldMk cId="370308576" sldId="257"/>
            <ac:spMk id="39" creationId="{D94D0E7E-0778-4B4E-A4D2-09EA1C4C65D6}"/>
          </ac:spMkLst>
        </pc:spChg>
        <pc:spChg chg="mod">
          <ac:chgData name="Sameer G Joshi (DJPR)" userId="bd06337d-ce8c-4c34-b1d1-7fbf8f91b6eb" providerId="ADAL" clId="{B9B8FF69-58F3-48D8-9439-0B94E292364A}" dt="2021-06-08T06:19:13.210" v="175" actId="1036"/>
          <ac:spMkLst>
            <pc:docMk/>
            <pc:sldMk cId="370308576" sldId="257"/>
            <ac:spMk id="40" creationId="{064D5353-18FD-41C9-B03B-67B53FAB85AA}"/>
          </ac:spMkLst>
        </pc:spChg>
        <pc:spChg chg="mod">
          <ac:chgData name="Sameer G Joshi (DJPR)" userId="bd06337d-ce8c-4c34-b1d1-7fbf8f91b6eb" providerId="ADAL" clId="{B9B8FF69-58F3-48D8-9439-0B94E292364A}" dt="2021-06-08T06:19:13.210" v="175" actId="1036"/>
          <ac:spMkLst>
            <pc:docMk/>
            <pc:sldMk cId="370308576" sldId="257"/>
            <ac:spMk id="41" creationId="{37855EC7-E404-4180-8DE4-93C08B14E7BA}"/>
          </ac:spMkLst>
        </pc:spChg>
        <pc:spChg chg="mod">
          <ac:chgData name="Sameer G Joshi (DJPR)" userId="bd06337d-ce8c-4c34-b1d1-7fbf8f91b6eb" providerId="ADAL" clId="{B9B8FF69-58F3-48D8-9439-0B94E292364A}" dt="2021-06-08T06:19:13.210" v="175" actId="1036"/>
          <ac:spMkLst>
            <pc:docMk/>
            <pc:sldMk cId="370308576" sldId="257"/>
            <ac:spMk id="42" creationId="{CA519B19-D77A-4460-AC1E-71C6DCA3D455}"/>
          </ac:spMkLst>
        </pc:spChg>
        <pc:spChg chg="mod">
          <ac:chgData name="Sameer G Joshi (DJPR)" userId="bd06337d-ce8c-4c34-b1d1-7fbf8f91b6eb" providerId="ADAL" clId="{B9B8FF69-58F3-48D8-9439-0B94E292364A}" dt="2021-06-08T06:19:13.210" v="175" actId="1036"/>
          <ac:spMkLst>
            <pc:docMk/>
            <pc:sldMk cId="370308576" sldId="257"/>
            <ac:spMk id="43" creationId="{C342B2FA-1425-4F9E-85BA-AD31D1DA9190}"/>
          </ac:spMkLst>
        </pc:spChg>
        <pc:graphicFrameChg chg="mod">
          <ac:chgData name="Sameer G Joshi (DJPR)" userId="bd06337d-ce8c-4c34-b1d1-7fbf8f91b6eb" providerId="ADAL" clId="{B9B8FF69-58F3-48D8-9439-0B94E292364A}" dt="2021-06-08T06:19:13.210" v="175" actId="1036"/>
          <ac:graphicFrameMkLst>
            <pc:docMk/>
            <pc:sldMk cId="370308576" sldId="257"/>
            <ac:graphicFrameMk id="4" creationId="{B82E53B8-98C2-4BD0-9E22-B3DEFB498CD2}"/>
          </ac:graphicFrameMkLst>
        </pc:graphicFrameChg>
        <pc:graphicFrameChg chg="mod">
          <ac:chgData name="Sameer G Joshi (DJPR)" userId="bd06337d-ce8c-4c34-b1d1-7fbf8f91b6eb" providerId="ADAL" clId="{B9B8FF69-58F3-48D8-9439-0B94E292364A}" dt="2021-06-08T06:19:13.210" v="175" actId="1036"/>
          <ac:graphicFrameMkLst>
            <pc:docMk/>
            <pc:sldMk cId="370308576" sldId="257"/>
            <ac:graphicFrameMk id="8" creationId="{58FAD2E8-E208-4375-A008-D095BAE3DE07}"/>
          </ac:graphicFrameMkLst>
        </pc:graphicFrameChg>
      </pc:sldChg>
      <pc:sldChg chg="modSp">
        <pc:chgData name="Sameer G Joshi (DJPR)" userId="bd06337d-ce8c-4c34-b1d1-7fbf8f91b6eb" providerId="ADAL" clId="{B9B8FF69-58F3-48D8-9439-0B94E292364A}" dt="2021-06-08T06:19:21.405" v="209" actId="1036"/>
        <pc:sldMkLst>
          <pc:docMk/>
          <pc:sldMk cId="2203674866" sldId="258"/>
        </pc:sldMkLst>
        <pc:spChg chg="mod">
          <ac:chgData name="Sameer G Joshi (DJPR)" userId="bd06337d-ce8c-4c34-b1d1-7fbf8f91b6eb" providerId="ADAL" clId="{B9B8FF69-58F3-48D8-9439-0B94E292364A}" dt="2021-06-08T06:19:21.405" v="209" actId="1036"/>
          <ac:spMkLst>
            <pc:docMk/>
            <pc:sldMk cId="2203674866" sldId="258"/>
            <ac:spMk id="5" creationId="{C1C7D342-C5AF-4282-A34C-A99726B755CD}"/>
          </ac:spMkLst>
        </pc:spChg>
        <pc:spChg chg="mod">
          <ac:chgData name="Sameer G Joshi (DJPR)" userId="bd06337d-ce8c-4c34-b1d1-7fbf8f91b6eb" providerId="ADAL" clId="{B9B8FF69-58F3-48D8-9439-0B94E292364A}" dt="2021-06-08T06:19:21.405" v="209" actId="1036"/>
          <ac:spMkLst>
            <pc:docMk/>
            <pc:sldMk cId="2203674866" sldId="258"/>
            <ac:spMk id="6" creationId="{CF2FA352-EA4B-48AA-BCD9-0B5D417DE429}"/>
          </ac:spMkLst>
        </pc:spChg>
        <pc:spChg chg="mod">
          <ac:chgData name="Sameer G Joshi (DJPR)" userId="bd06337d-ce8c-4c34-b1d1-7fbf8f91b6eb" providerId="ADAL" clId="{B9B8FF69-58F3-48D8-9439-0B94E292364A}" dt="2021-06-08T06:19:21.405" v="209" actId="1036"/>
          <ac:spMkLst>
            <pc:docMk/>
            <pc:sldMk cId="2203674866" sldId="258"/>
            <ac:spMk id="11" creationId="{F47A1C11-6121-479E-999B-743F8B3B0102}"/>
          </ac:spMkLst>
        </pc:spChg>
        <pc:spChg chg="mod">
          <ac:chgData name="Sameer G Joshi (DJPR)" userId="bd06337d-ce8c-4c34-b1d1-7fbf8f91b6eb" providerId="ADAL" clId="{B9B8FF69-58F3-48D8-9439-0B94E292364A}" dt="2021-06-08T06:19:21.405" v="209" actId="1036"/>
          <ac:spMkLst>
            <pc:docMk/>
            <pc:sldMk cId="2203674866" sldId="258"/>
            <ac:spMk id="12" creationId="{39B48064-32AF-488B-A4AC-5E955AE5DC19}"/>
          </ac:spMkLst>
        </pc:spChg>
        <pc:spChg chg="mod">
          <ac:chgData name="Sameer G Joshi (DJPR)" userId="bd06337d-ce8c-4c34-b1d1-7fbf8f91b6eb" providerId="ADAL" clId="{B9B8FF69-58F3-48D8-9439-0B94E292364A}" dt="2021-06-08T06:19:21.405" v="209" actId="1036"/>
          <ac:spMkLst>
            <pc:docMk/>
            <pc:sldMk cId="2203674866" sldId="258"/>
            <ac:spMk id="13" creationId="{166DCA8E-895F-42C9-8D34-A942C93FDA3E}"/>
          </ac:spMkLst>
        </pc:spChg>
        <pc:spChg chg="mod">
          <ac:chgData name="Sameer G Joshi (DJPR)" userId="bd06337d-ce8c-4c34-b1d1-7fbf8f91b6eb" providerId="ADAL" clId="{B9B8FF69-58F3-48D8-9439-0B94E292364A}" dt="2021-06-08T06:19:21.405" v="209" actId="1036"/>
          <ac:spMkLst>
            <pc:docMk/>
            <pc:sldMk cId="2203674866" sldId="258"/>
            <ac:spMk id="14" creationId="{1A4BC8A9-00C7-4001-9DA9-3C8D33C7C327}"/>
          </ac:spMkLst>
        </pc:spChg>
        <pc:spChg chg="mod">
          <ac:chgData name="Sameer G Joshi (DJPR)" userId="bd06337d-ce8c-4c34-b1d1-7fbf8f91b6eb" providerId="ADAL" clId="{B9B8FF69-58F3-48D8-9439-0B94E292364A}" dt="2021-06-08T06:19:21.405" v="209" actId="1036"/>
          <ac:spMkLst>
            <pc:docMk/>
            <pc:sldMk cId="2203674866" sldId="258"/>
            <ac:spMk id="16" creationId="{25B65A05-F4D7-4A73-94C3-EFF9E3C8BC70}"/>
          </ac:spMkLst>
        </pc:spChg>
        <pc:spChg chg="mod">
          <ac:chgData name="Sameer G Joshi (DJPR)" userId="bd06337d-ce8c-4c34-b1d1-7fbf8f91b6eb" providerId="ADAL" clId="{B9B8FF69-58F3-48D8-9439-0B94E292364A}" dt="2021-06-08T06:19:21.405" v="209" actId="1036"/>
          <ac:spMkLst>
            <pc:docMk/>
            <pc:sldMk cId="2203674866" sldId="258"/>
            <ac:spMk id="17" creationId="{C87AED42-E587-4B6F-8ABA-76C8FE76E503}"/>
          </ac:spMkLst>
        </pc:spChg>
        <pc:spChg chg="mod">
          <ac:chgData name="Sameer G Joshi (DJPR)" userId="bd06337d-ce8c-4c34-b1d1-7fbf8f91b6eb" providerId="ADAL" clId="{B9B8FF69-58F3-48D8-9439-0B94E292364A}" dt="2021-06-08T06:19:21.405" v="209" actId="1036"/>
          <ac:spMkLst>
            <pc:docMk/>
            <pc:sldMk cId="2203674866" sldId="258"/>
            <ac:spMk id="19" creationId="{106A8FBD-909B-4774-B43F-1FC484A71BE3}"/>
          </ac:spMkLst>
        </pc:spChg>
        <pc:graphicFrameChg chg="mod">
          <ac:chgData name="Sameer G Joshi (DJPR)" userId="bd06337d-ce8c-4c34-b1d1-7fbf8f91b6eb" providerId="ADAL" clId="{B9B8FF69-58F3-48D8-9439-0B94E292364A}" dt="2021-06-08T06:19:21.405" v="209" actId="1036"/>
          <ac:graphicFrameMkLst>
            <pc:docMk/>
            <pc:sldMk cId="2203674866" sldId="258"/>
            <ac:graphicFrameMk id="4" creationId="{420D9C9C-6635-4308-B32A-F1C1403CACCA}"/>
          </ac:graphicFrameMkLst>
        </pc:graphicFrameChg>
        <pc:picChg chg="mod">
          <ac:chgData name="Sameer G Joshi (DJPR)" userId="bd06337d-ce8c-4c34-b1d1-7fbf8f91b6eb" providerId="ADAL" clId="{B9B8FF69-58F3-48D8-9439-0B94E292364A}" dt="2021-06-08T06:19:21.405" v="209" actId="1036"/>
          <ac:picMkLst>
            <pc:docMk/>
            <pc:sldMk cId="2203674866" sldId="258"/>
            <ac:picMk id="10" creationId="{981463CE-92E3-455D-B01F-2BD9BBE3F108}"/>
          </ac:picMkLst>
        </pc:picChg>
      </pc:sldChg>
      <pc:sldChg chg="modSp mod">
        <pc:chgData name="Sameer G Joshi (DJPR)" userId="bd06337d-ce8c-4c34-b1d1-7fbf8f91b6eb" providerId="ADAL" clId="{B9B8FF69-58F3-48D8-9439-0B94E292364A}" dt="2021-06-08T06:20:08.306" v="257" actId="1035"/>
        <pc:sldMkLst>
          <pc:docMk/>
          <pc:sldMk cId="424659793" sldId="259"/>
        </pc:sldMkLst>
        <pc:spChg chg="mod">
          <ac:chgData name="Sameer G Joshi (DJPR)" userId="bd06337d-ce8c-4c34-b1d1-7fbf8f91b6eb" providerId="ADAL" clId="{B9B8FF69-58F3-48D8-9439-0B94E292364A}" dt="2021-06-08T06:20:08.306" v="257" actId="1035"/>
          <ac:spMkLst>
            <pc:docMk/>
            <pc:sldMk cId="424659793" sldId="259"/>
            <ac:spMk id="14" creationId="{DCD7250A-AE64-4AE7-8AC4-447D72E13899}"/>
          </ac:spMkLst>
        </pc:spChg>
        <pc:spChg chg="mod">
          <ac:chgData name="Sameer G Joshi (DJPR)" userId="bd06337d-ce8c-4c34-b1d1-7fbf8f91b6eb" providerId="ADAL" clId="{B9B8FF69-58F3-48D8-9439-0B94E292364A}" dt="2021-06-08T06:20:08.306" v="257" actId="1035"/>
          <ac:spMkLst>
            <pc:docMk/>
            <pc:sldMk cId="424659793" sldId="259"/>
            <ac:spMk id="15" creationId="{2CDFF904-DC94-4136-A2FA-998A5710B95E}"/>
          </ac:spMkLst>
        </pc:spChg>
        <pc:spChg chg="mod">
          <ac:chgData name="Sameer G Joshi (DJPR)" userId="bd06337d-ce8c-4c34-b1d1-7fbf8f91b6eb" providerId="ADAL" clId="{B9B8FF69-58F3-48D8-9439-0B94E292364A}" dt="2021-06-08T06:20:08.306" v="257" actId="1035"/>
          <ac:spMkLst>
            <pc:docMk/>
            <pc:sldMk cId="424659793" sldId="259"/>
            <ac:spMk id="16" creationId="{C72024A2-A6AC-4852-85CC-C8585BC01007}"/>
          </ac:spMkLst>
        </pc:spChg>
        <pc:spChg chg="mod">
          <ac:chgData name="Sameer G Joshi (DJPR)" userId="bd06337d-ce8c-4c34-b1d1-7fbf8f91b6eb" providerId="ADAL" clId="{B9B8FF69-58F3-48D8-9439-0B94E292364A}" dt="2021-06-08T06:20:08.306" v="257" actId="1035"/>
          <ac:spMkLst>
            <pc:docMk/>
            <pc:sldMk cId="424659793" sldId="259"/>
            <ac:spMk id="17" creationId="{40081187-1F92-417A-B8DE-50F1A0239FEB}"/>
          </ac:spMkLst>
        </pc:spChg>
        <pc:spChg chg="mod">
          <ac:chgData name="Sameer G Joshi (DJPR)" userId="bd06337d-ce8c-4c34-b1d1-7fbf8f91b6eb" providerId="ADAL" clId="{B9B8FF69-58F3-48D8-9439-0B94E292364A}" dt="2021-06-08T06:20:08.306" v="257" actId="1035"/>
          <ac:spMkLst>
            <pc:docMk/>
            <pc:sldMk cId="424659793" sldId="259"/>
            <ac:spMk id="18" creationId="{F134EDC0-26BB-46FC-9913-81B80CBDE563}"/>
          </ac:spMkLst>
        </pc:spChg>
        <pc:spChg chg="mod">
          <ac:chgData name="Sameer G Joshi (DJPR)" userId="bd06337d-ce8c-4c34-b1d1-7fbf8f91b6eb" providerId="ADAL" clId="{B9B8FF69-58F3-48D8-9439-0B94E292364A}" dt="2021-06-08T06:20:08.306" v="257" actId="1035"/>
          <ac:spMkLst>
            <pc:docMk/>
            <pc:sldMk cId="424659793" sldId="259"/>
            <ac:spMk id="19" creationId="{D4257AF1-0BDB-48E1-B152-19CF54928A63}"/>
          </ac:spMkLst>
        </pc:spChg>
        <pc:spChg chg="mod">
          <ac:chgData name="Sameer G Joshi (DJPR)" userId="bd06337d-ce8c-4c34-b1d1-7fbf8f91b6eb" providerId="ADAL" clId="{B9B8FF69-58F3-48D8-9439-0B94E292364A}" dt="2021-06-08T06:20:08.306" v="257" actId="1035"/>
          <ac:spMkLst>
            <pc:docMk/>
            <pc:sldMk cId="424659793" sldId="259"/>
            <ac:spMk id="20" creationId="{E4C5A3CE-82FA-4F04-A686-770C1652DD38}"/>
          </ac:spMkLst>
        </pc:spChg>
        <pc:spChg chg="mod">
          <ac:chgData name="Sameer G Joshi (DJPR)" userId="bd06337d-ce8c-4c34-b1d1-7fbf8f91b6eb" providerId="ADAL" clId="{B9B8FF69-58F3-48D8-9439-0B94E292364A}" dt="2021-06-08T06:20:08.306" v="257" actId="1035"/>
          <ac:spMkLst>
            <pc:docMk/>
            <pc:sldMk cId="424659793" sldId="259"/>
            <ac:spMk id="21" creationId="{34C3EEAE-D391-43F5-8D3F-FD32A2F9807E}"/>
          </ac:spMkLst>
        </pc:spChg>
        <pc:spChg chg="mod">
          <ac:chgData name="Sameer G Joshi (DJPR)" userId="bd06337d-ce8c-4c34-b1d1-7fbf8f91b6eb" providerId="ADAL" clId="{B9B8FF69-58F3-48D8-9439-0B94E292364A}" dt="2021-06-08T06:20:08.306" v="257" actId="1035"/>
          <ac:spMkLst>
            <pc:docMk/>
            <pc:sldMk cId="424659793" sldId="259"/>
            <ac:spMk id="45" creationId="{0227BC53-1451-4229-BC1B-B04DA18D1F65}"/>
          </ac:spMkLst>
        </pc:spChg>
        <pc:spChg chg="mod">
          <ac:chgData name="Sameer G Joshi (DJPR)" userId="bd06337d-ce8c-4c34-b1d1-7fbf8f91b6eb" providerId="ADAL" clId="{B9B8FF69-58F3-48D8-9439-0B94E292364A}" dt="2021-06-08T06:20:08.306" v="257" actId="1035"/>
          <ac:spMkLst>
            <pc:docMk/>
            <pc:sldMk cId="424659793" sldId="259"/>
            <ac:spMk id="46" creationId="{74B73A61-87F6-4DB1-BB45-EF26BF045C5D}"/>
          </ac:spMkLst>
        </pc:spChg>
        <pc:spChg chg="mod">
          <ac:chgData name="Sameer G Joshi (DJPR)" userId="bd06337d-ce8c-4c34-b1d1-7fbf8f91b6eb" providerId="ADAL" clId="{B9B8FF69-58F3-48D8-9439-0B94E292364A}" dt="2021-06-08T06:20:08.306" v="257" actId="1035"/>
          <ac:spMkLst>
            <pc:docMk/>
            <pc:sldMk cId="424659793" sldId="259"/>
            <ac:spMk id="47" creationId="{20092974-FFF2-427F-86BE-3F8CE2B7DF58}"/>
          </ac:spMkLst>
        </pc:spChg>
        <pc:spChg chg="mod">
          <ac:chgData name="Sameer G Joshi (DJPR)" userId="bd06337d-ce8c-4c34-b1d1-7fbf8f91b6eb" providerId="ADAL" clId="{B9B8FF69-58F3-48D8-9439-0B94E292364A}" dt="2021-06-08T06:20:08.306" v="257" actId="1035"/>
          <ac:spMkLst>
            <pc:docMk/>
            <pc:sldMk cId="424659793" sldId="259"/>
            <ac:spMk id="48" creationId="{6F2001C1-FB4C-440D-B8E4-8186B1FE4F5B}"/>
          </ac:spMkLst>
        </pc:spChg>
        <pc:spChg chg="mod">
          <ac:chgData name="Sameer G Joshi (DJPR)" userId="bd06337d-ce8c-4c34-b1d1-7fbf8f91b6eb" providerId="ADAL" clId="{B9B8FF69-58F3-48D8-9439-0B94E292364A}" dt="2021-06-08T06:20:08.306" v="257" actId="1035"/>
          <ac:spMkLst>
            <pc:docMk/>
            <pc:sldMk cId="424659793" sldId="259"/>
            <ac:spMk id="49" creationId="{6BD89384-B8F0-48CE-BB60-15E33C29F509}"/>
          </ac:spMkLst>
        </pc:spChg>
        <pc:spChg chg="mod">
          <ac:chgData name="Sameer G Joshi (DJPR)" userId="bd06337d-ce8c-4c34-b1d1-7fbf8f91b6eb" providerId="ADAL" clId="{B9B8FF69-58F3-48D8-9439-0B94E292364A}" dt="2021-06-08T06:20:08.306" v="257" actId="1035"/>
          <ac:spMkLst>
            <pc:docMk/>
            <pc:sldMk cId="424659793" sldId="259"/>
            <ac:spMk id="50" creationId="{81821875-2D3B-45C0-922F-745DD1306B42}"/>
          </ac:spMkLst>
        </pc:spChg>
        <pc:spChg chg="mod">
          <ac:chgData name="Sameer G Joshi (DJPR)" userId="bd06337d-ce8c-4c34-b1d1-7fbf8f91b6eb" providerId="ADAL" clId="{B9B8FF69-58F3-48D8-9439-0B94E292364A}" dt="2021-06-08T06:20:08.306" v="257" actId="1035"/>
          <ac:spMkLst>
            <pc:docMk/>
            <pc:sldMk cId="424659793" sldId="259"/>
            <ac:spMk id="51" creationId="{D0993CDF-5917-4120-87F5-545380F8F160}"/>
          </ac:spMkLst>
        </pc:spChg>
        <pc:spChg chg="mod">
          <ac:chgData name="Sameer G Joshi (DJPR)" userId="bd06337d-ce8c-4c34-b1d1-7fbf8f91b6eb" providerId="ADAL" clId="{B9B8FF69-58F3-48D8-9439-0B94E292364A}" dt="2021-06-08T06:20:08.306" v="257" actId="1035"/>
          <ac:spMkLst>
            <pc:docMk/>
            <pc:sldMk cId="424659793" sldId="259"/>
            <ac:spMk id="52" creationId="{04D8749E-0701-4826-8647-1EBE4FFF68C3}"/>
          </ac:spMkLst>
        </pc:spChg>
        <pc:spChg chg="mod">
          <ac:chgData name="Sameer G Joshi (DJPR)" userId="bd06337d-ce8c-4c34-b1d1-7fbf8f91b6eb" providerId="ADAL" clId="{B9B8FF69-58F3-48D8-9439-0B94E292364A}" dt="2021-06-08T06:20:08.306" v="257" actId="1035"/>
          <ac:spMkLst>
            <pc:docMk/>
            <pc:sldMk cId="424659793" sldId="259"/>
            <ac:spMk id="53" creationId="{46F2D02C-0EAA-4928-8836-AA0064670ACE}"/>
          </ac:spMkLst>
        </pc:spChg>
        <pc:spChg chg="mod">
          <ac:chgData name="Sameer G Joshi (DJPR)" userId="bd06337d-ce8c-4c34-b1d1-7fbf8f91b6eb" providerId="ADAL" clId="{B9B8FF69-58F3-48D8-9439-0B94E292364A}" dt="2021-06-08T06:20:08.306" v="257" actId="1035"/>
          <ac:spMkLst>
            <pc:docMk/>
            <pc:sldMk cId="424659793" sldId="259"/>
            <ac:spMk id="54" creationId="{FE813D58-DAF1-4639-BC1D-3DE4CBEF83FD}"/>
          </ac:spMkLst>
        </pc:spChg>
        <pc:spChg chg="mod">
          <ac:chgData name="Sameer G Joshi (DJPR)" userId="bd06337d-ce8c-4c34-b1d1-7fbf8f91b6eb" providerId="ADAL" clId="{B9B8FF69-58F3-48D8-9439-0B94E292364A}" dt="2021-06-08T06:20:08.306" v="257" actId="1035"/>
          <ac:spMkLst>
            <pc:docMk/>
            <pc:sldMk cId="424659793" sldId="259"/>
            <ac:spMk id="55" creationId="{B0C557C0-83C4-4E77-BD40-A7F21D2AC8EA}"/>
          </ac:spMkLst>
        </pc:spChg>
        <pc:spChg chg="mod">
          <ac:chgData name="Sameer G Joshi (DJPR)" userId="bd06337d-ce8c-4c34-b1d1-7fbf8f91b6eb" providerId="ADAL" clId="{B9B8FF69-58F3-48D8-9439-0B94E292364A}" dt="2021-06-08T06:20:08.306" v="257" actId="1035"/>
          <ac:spMkLst>
            <pc:docMk/>
            <pc:sldMk cId="424659793" sldId="259"/>
            <ac:spMk id="56" creationId="{86005B86-1FA2-420D-8781-6AE2E5E797B3}"/>
          </ac:spMkLst>
        </pc:spChg>
        <pc:spChg chg="mod">
          <ac:chgData name="Sameer G Joshi (DJPR)" userId="bd06337d-ce8c-4c34-b1d1-7fbf8f91b6eb" providerId="ADAL" clId="{B9B8FF69-58F3-48D8-9439-0B94E292364A}" dt="2021-06-08T06:20:08.306" v="257" actId="1035"/>
          <ac:spMkLst>
            <pc:docMk/>
            <pc:sldMk cId="424659793" sldId="259"/>
            <ac:spMk id="57" creationId="{766946AD-BF11-421E-B794-68CCB02A5848}"/>
          </ac:spMkLst>
        </pc:spChg>
        <pc:spChg chg="mod">
          <ac:chgData name="Sameer G Joshi (DJPR)" userId="bd06337d-ce8c-4c34-b1d1-7fbf8f91b6eb" providerId="ADAL" clId="{B9B8FF69-58F3-48D8-9439-0B94E292364A}" dt="2021-06-08T06:20:08.306" v="257" actId="1035"/>
          <ac:spMkLst>
            <pc:docMk/>
            <pc:sldMk cId="424659793" sldId="259"/>
            <ac:spMk id="58" creationId="{165743CB-DB4C-428B-A331-C5E3CB154CD3}"/>
          </ac:spMkLst>
        </pc:spChg>
        <pc:spChg chg="mod">
          <ac:chgData name="Sameer G Joshi (DJPR)" userId="bd06337d-ce8c-4c34-b1d1-7fbf8f91b6eb" providerId="ADAL" clId="{B9B8FF69-58F3-48D8-9439-0B94E292364A}" dt="2021-06-08T06:20:08.306" v="257" actId="1035"/>
          <ac:spMkLst>
            <pc:docMk/>
            <pc:sldMk cId="424659793" sldId="259"/>
            <ac:spMk id="59" creationId="{87F8A615-74C5-4097-B633-4A8D3D829A64}"/>
          </ac:spMkLst>
        </pc:spChg>
        <pc:spChg chg="mod">
          <ac:chgData name="Sameer G Joshi (DJPR)" userId="bd06337d-ce8c-4c34-b1d1-7fbf8f91b6eb" providerId="ADAL" clId="{B9B8FF69-58F3-48D8-9439-0B94E292364A}" dt="2021-06-08T06:20:08.306" v="257" actId="1035"/>
          <ac:spMkLst>
            <pc:docMk/>
            <pc:sldMk cId="424659793" sldId="259"/>
            <ac:spMk id="60" creationId="{B31399A1-928F-44CD-A96D-B340E4ADEE0B}"/>
          </ac:spMkLst>
        </pc:spChg>
        <pc:spChg chg="mod">
          <ac:chgData name="Sameer G Joshi (DJPR)" userId="bd06337d-ce8c-4c34-b1d1-7fbf8f91b6eb" providerId="ADAL" clId="{B9B8FF69-58F3-48D8-9439-0B94E292364A}" dt="2021-06-08T06:20:08.306" v="257" actId="1035"/>
          <ac:spMkLst>
            <pc:docMk/>
            <pc:sldMk cId="424659793" sldId="259"/>
            <ac:spMk id="61" creationId="{DE43E371-9D86-47B7-8835-26D443F69183}"/>
          </ac:spMkLst>
        </pc:spChg>
        <pc:spChg chg="mod">
          <ac:chgData name="Sameer G Joshi (DJPR)" userId="bd06337d-ce8c-4c34-b1d1-7fbf8f91b6eb" providerId="ADAL" clId="{B9B8FF69-58F3-48D8-9439-0B94E292364A}" dt="2021-06-08T06:20:08.306" v="257" actId="1035"/>
          <ac:spMkLst>
            <pc:docMk/>
            <pc:sldMk cId="424659793" sldId="259"/>
            <ac:spMk id="62" creationId="{F69A1AE3-1AA8-46D2-A368-96A14F0F66F8}"/>
          </ac:spMkLst>
        </pc:spChg>
        <pc:spChg chg="mod">
          <ac:chgData name="Sameer G Joshi (DJPR)" userId="bd06337d-ce8c-4c34-b1d1-7fbf8f91b6eb" providerId="ADAL" clId="{B9B8FF69-58F3-48D8-9439-0B94E292364A}" dt="2021-06-08T06:20:08.306" v="257" actId="1035"/>
          <ac:spMkLst>
            <pc:docMk/>
            <pc:sldMk cId="424659793" sldId="259"/>
            <ac:spMk id="63" creationId="{91B9C6C1-15B8-466A-8898-75F3D0455C44}"/>
          </ac:spMkLst>
        </pc:spChg>
        <pc:spChg chg="mod">
          <ac:chgData name="Sameer G Joshi (DJPR)" userId="bd06337d-ce8c-4c34-b1d1-7fbf8f91b6eb" providerId="ADAL" clId="{B9B8FF69-58F3-48D8-9439-0B94E292364A}" dt="2021-06-08T06:20:08.306" v="257" actId="1035"/>
          <ac:spMkLst>
            <pc:docMk/>
            <pc:sldMk cId="424659793" sldId="259"/>
            <ac:spMk id="64" creationId="{E945096F-49E4-4222-A35A-CF28CE8283A8}"/>
          </ac:spMkLst>
        </pc:spChg>
        <pc:spChg chg="mod">
          <ac:chgData name="Sameer G Joshi (DJPR)" userId="bd06337d-ce8c-4c34-b1d1-7fbf8f91b6eb" providerId="ADAL" clId="{B9B8FF69-58F3-48D8-9439-0B94E292364A}" dt="2021-06-08T06:20:08.306" v="257" actId="1035"/>
          <ac:spMkLst>
            <pc:docMk/>
            <pc:sldMk cId="424659793" sldId="259"/>
            <ac:spMk id="65" creationId="{0FB803E0-295F-491E-9DA3-8B041ACB29BD}"/>
          </ac:spMkLst>
        </pc:spChg>
        <pc:spChg chg="mod">
          <ac:chgData name="Sameer G Joshi (DJPR)" userId="bd06337d-ce8c-4c34-b1d1-7fbf8f91b6eb" providerId="ADAL" clId="{B9B8FF69-58F3-48D8-9439-0B94E292364A}" dt="2021-06-08T06:20:08.306" v="257" actId="1035"/>
          <ac:spMkLst>
            <pc:docMk/>
            <pc:sldMk cId="424659793" sldId="259"/>
            <ac:spMk id="66" creationId="{9A758585-214B-4CFE-9328-BF628DB65CA2}"/>
          </ac:spMkLst>
        </pc:spChg>
        <pc:spChg chg="mod">
          <ac:chgData name="Sameer G Joshi (DJPR)" userId="bd06337d-ce8c-4c34-b1d1-7fbf8f91b6eb" providerId="ADAL" clId="{B9B8FF69-58F3-48D8-9439-0B94E292364A}" dt="2021-06-08T06:20:08.306" v="257" actId="1035"/>
          <ac:spMkLst>
            <pc:docMk/>
            <pc:sldMk cId="424659793" sldId="259"/>
            <ac:spMk id="67" creationId="{0A73ADE7-BBEE-41CF-9677-8B35A13A483E}"/>
          </ac:spMkLst>
        </pc:spChg>
        <pc:spChg chg="mod">
          <ac:chgData name="Sameer G Joshi (DJPR)" userId="bd06337d-ce8c-4c34-b1d1-7fbf8f91b6eb" providerId="ADAL" clId="{B9B8FF69-58F3-48D8-9439-0B94E292364A}" dt="2021-06-08T06:20:08.306" v="257" actId="1035"/>
          <ac:spMkLst>
            <pc:docMk/>
            <pc:sldMk cId="424659793" sldId="259"/>
            <ac:spMk id="68" creationId="{83916AE0-9EAC-4561-8941-752C32314158}"/>
          </ac:spMkLst>
        </pc:spChg>
        <pc:spChg chg="mod">
          <ac:chgData name="Sameer G Joshi (DJPR)" userId="bd06337d-ce8c-4c34-b1d1-7fbf8f91b6eb" providerId="ADAL" clId="{B9B8FF69-58F3-48D8-9439-0B94E292364A}" dt="2021-06-08T06:20:08.306" v="257" actId="1035"/>
          <ac:spMkLst>
            <pc:docMk/>
            <pc:sldMk cId="424659793" sldId="259"/>
            <ac:spMk id="69" creationId="{F9FC764F-EBA4-4B4C-84F2-AB9A34FB7355}"/>
          </ac:spMkLst>
        </pc:spChg>
        <pc:spChg chg="mod">
          <ac:chgData name="Sameer G Joshi (DJPR)" userId="bd06337d-ce8c-4c34-b1d1-7fbf8f91b6eb" providerId="ADAL" clId="{B9B8FF69-58F3-48D8-9439-0B94E292364A}" dt="2021-06-08T06:20:08.306" v="257" actId="1035"/>
          <ac:spMkLst>
            <pc:docMk/>
            <pc:sldMk cId="424659793" sldId="259"/>
            <ac:spMk id="70" creationId="{25EF780B-AEAB-44D7-ADFF-FDD8C83D25AF}"/>
          </ac:spMkLst>
        </pc:spChg>
        <pc:spChg chg="mod">
          <ac:chgData name="Sameer G Joshi (DJPR)" userId="bd06337d-ce8c-4c34-b1d1-7fbf8f91b6eb" providerId="ADAL" clId="{B9B8FF69-58F3-48D8-9439-0B94E292364A}" dt="2021-06-08T06:20:08.306" v="257" actId="1035"/>
          <ac:spMkLst>
            <pc:docMk/>
            <pc:sldMk cId="424659793" sldId="259"/>
            <ac:spMk id="71" creationId="{CAB21247-47EC-4FF6-94C1-A376FDC9D1C8}"/>
          </ac:spMkLst>
        </pc:spChg>
        <pc:spChg chg="mod">
          <ac:chgData name="Sameer G Joshi (DJPR)" userId="bd06337d-ce8c-4c34-b1d1-7fbf8f91b6eb" providerId="ADAL" clId="{B9B8FF69-58F3-48D8-9439-0B94E292364A}" dt="2021-06-08T06:20:08.306" v="257" actId="1035"/>
          <ac:spMkLst>
            <pc:docMk/>
            <pc:sldMk cId="424659793" sldId="259"/>
            <ac:spMk id="72" creationId="{F7748153-2009-4C94-9A07-2AA420FA1AB4}"/>
          </ac:spMkLst>
        </pc:spChg>
        <pc:spChg chg="mod">
          <ac:chgData name="Sameer G Joshi (DJPR)" userId="bd06337d-ce8c-4c34-b1d1-7fbf8f91b6eb" providerId="ADAL" clId="{B9B8FF69-58F3-48D8-9439-0B94E292364A}" dt="2021-06-08T06:20:08.306" v="257" actId="1035"/>
          <ac:spMkLst>
            <pc:docMk/>
            <pc:sldMk cId="424659793" sldId="259"/>
            <ac:spMk id="73" creationId="{27D79F2D-F874-4538-8889-07FF2968E88A}"/>
          </ac:spMkLst>
        </pc:spChg>
        <pc:spChg chg="mod">
          <ac:chgData name="Sameer G Joshi (DJPR)" userId="bd06337d-ce8c-4c34-b1d1-7fbf8f91b6eb" providerId="ADAL" clId="{B9B8FF69-58F3-48D8-9439-0B94E292364A}" dt="2021-06-08T06:20:08.306" v="257" actId="1035"/>
          <ac:spMkLst>
            <pc:docMk/>
            <pc:sldMk cId="424659793" sldId="259"/>
            <ac:spMk id="74" creationId="{61C844A3-15BF-4CCE-8AB5-FDEC228B5B98}"/>
          </ac:spMkLst>
        </pc:spChg>
        <pc:spChg chg="mod">
          <ac:chgData name="Sameer G Joshi (DJPR)" userId="bd06337d-ce8c-4c34-b1d1-7fbf8f91b6eb" providerId="ADAL" clId="{B9B8FF69-58F3-48D8-9439-0B94E292364A}" dt="2021-06-08T06:20:08.306" v="257" actId="1035"/>
          <ac:spMkLst>
            <pc:docMk/>
            <pc:sldMk cId="424659793" sldId="259"/>
            <ac:spMk id="75" creationId="{75A0A8A1-8E8F-4113-A4B6-33148AD14392}"/>
          </ac:spMkLst>
        </pc:spChg>
        <pc:grpChg chg="mod">
          <ac:chgData name="Sameer G Joshi (DJPR)" userId="bd06337d-ce8c-4c34-b1d1-7fbf8f91b6eb" providerId="ADAL" clId="{B9B8FF69-58F3-48D8-9439-0B94E292364A}" dt="2021-06-08T06:20:08.306" v="257" actId="1035"/>
          <ac:grpSpMkLst>
            <pc:docMk/>
            <pc:sldMk cId="424659793" sldId="259"/>
            <ac:grpSpMk id="4" creationId="{199DDE7E-B395-49CB-930A-C2C673C6DE90}"/>
          </ac:grpSpMkLst>
        </pc:grpChg>
        <pc:grpChg chg="mod">
          <ac:chgData name="Sameer G Joshi (DJPR)" userId="bd06337d-ce8c-4c34-b1d1-7fbf8f91b6eb" providerId="ADAL" clId="{B9B8FF69-58F3-48D8-9439-0B94E292364A}" dt="2021-06-08T06:20:08.306" v="257" actId="1035"/>
          <ac:grpSpMkLst>
            <pc:docMk/>
            <pc:sldMk cId="424659793" sldId="259"/>
            <ac:grpSpMk id="9" creationId="{B3A8B81C-30B7-4B97-8027-C028D4B127ED}"/>
          </ac:grpSpMkLst>
        </pc:grpChg>
        <pc:grpChg chg="mod">
          <ac:chgData name="Sameer G Joshi (DJPR)" userId="bd06337d-ce8c-4c34-b1d1-7fbf8f91b6eb" providerId="ADAL" clId="{B9B8FF69-58F3-48D8-9439-0B94E292364A}" dt="2021-06-08T06:20:08.306" v="257" actId="1035"/>
          <ac:grpSpMkLst>
            <pc:docMk/>
            <pc:sldMk cId="424659793" sldId="259"/>
            <ac:grpSpMk id="30" creationId="{9EA0A4B8-2729-41B2-8668-FA98BD79D0BE}"/>
          </ac:grpSpMkLst>
        </pc:grpChg>
        <pc:grpChg chg="mod">
          <ac:chgData name="Sameer G Joshi (DJPR)" userId="bd06337d-ce8c-4c34-b1d1-7fbf8f91b6eb" providerId="ADAL" clId="{B9B8FF69-58F3-48D8-9439-0B94E292364A}" dt="2021-06-08T06:20:08.306" v="257" actId="1035"/>
          <ac:grpSpMkLst>
            <pc:docMk/>
            <pc:sldMk cId="424659793" sldId="259"/>
            <ac:grpSpMk id="35" creationId="{A00F72AD-4F8B-41CB-9EC4-BDE7CD1BA065}"/>
          </ac:grpSpMkLst>
        </pc:grpChg>
        <pc:picChg chg="mod">
          <ac:chgData name="Sameer G Joshi (DJPR)" userId="bd06337d-ce8c-4c34-b1d1-7fbf8f91b6eb" providerId="ADAL" clId="{B9B8FF69-58F3-48D8-9439-0B94E292364A}" dt="2021-06-08T06:18:29.137" v="92"/>
          <ac:picMkLst>
            <pc:docMk/>
            <pc:sldMk cId="424659793" sldId="259"/>
            <ac:picMk id="5" creationId="{BF4E60D9-99C5-4327-966D-CEA144304423}"/>
          </ac:picMkLst>
        </pc:picChg>
        <pc:picChg chg="mod">
          <ac:chgData name="Sameer G Joshi (DJPR)" userId="bd06337d-ce8c-4c34-b1d1-7fbf8f91b6eb" providerId="ADAL" clId="{B9B8FF69-58F3-48D8-9439-0B94E292364A}" dt="2021-06-08T06:18:29.137" v="92"/>
          <ac:picMkLst>
            <pc:docMk/>
            <pc:sldMk cId="424659793" sldId="259"/>
            <ac:picMk id="6" creationId="{7C50B30D-81E5-486F-A64A-8D2BC3C11829}"/>
          </ac:picMkLst>
        </pc:picChg>
        <pc:picChg chg="mod">
          <ac:chgData name="Sameer G Joshi (DJPR)" userId="bd06337d-ce8c-4c34-b1d1-7fbf8f91b6eb" providerId="ADAL" clId="{B9B8FF69-58F3-48D8-9439-0B94E292364A}" dt="2021-06-08T06:18:29.137" v="92"/>
          <ac:picMkLst>
            <pc:docMk/>
            <pc:sldMk cId="424659793" sldId="259"/>
            <ac:picMk id="7" creationId="{614733D8-7BF1-42C5-872B-D2B9024890D4}"/>
          </ac:picMkLst>
        </pc:picChg>
        <pc:picChg chg="mod">
          <ac:chgData name="Sameer G Joshi (DJPR)" userId="bd06337d-ce8c-4c34-b1d1-7fbf8f91b6eb" providerId="ADAL" clId="{B9B8FF69-58F3-48D8-9439-0B94E292364A}" dt="2021-06-08T06:18:29.137" v="92"/>
          <ac:picMkLst>
            <pc:docMk/>
            <pc:sldMk cId="424659793" sldId="259"/>
            <ac:picMk id="8" creationId="{C238E075-9119-4838-9B0C-90E6D9B8FA91}"/>
          </ac:picMkLst>
        </pc:picChg>
        <pc:picChg chg="mod">
          <ac:chgData name="Sameer G Joshi (DJPR)" userId="bd06337d-ce8c-4c34-b1d1-7fbf8f91b6eb" providerId="ADAL" clId="{B9B8FF69-58F3-48D8-9439-0B94E292364A}" dt="2021-06-08T06:18:29.137" v="92"/>
          <ac:picMkLst>
            <pc:docMk/>
            <pc:sldMk cId="424659793" sldId="259"/>
            <ac:picMk id="10" creationId="{E4FDA631-2DF2-4F35-B2B3-074A6BEECAF9}"/>
          </ac:picMkLst>
        </pc:picChg>
        <pc:picChg chg="mod">
          <ac:chgData name="Sameer G Joshi (DJPR)" userId="bd06337d-ce8c-4c34-b1d1-7fbf8f91b6eb" providerId="ADAL" clId="{B9B8FF69-58F3-48D8-9439-0B94E292364A}" dt="2021-06-08T06:18:29.137" v="92"/>
          <ac:picMkLst>
            <pc:docMk/>
            <pc:sldMk cId="424659793" sldId="259"/>
            <ac:picMk id="11" creationId="{97AE85BB-F171-4070-889B-697474B67DB9}"/>
          </ac:picMkLst>
        </pc:picChg>
        <pc:picChg chg="mod">
          <ac:chgData name="Sameer G Joshi (DJPR)" userId="bd06337d-ce8c-4c34-b1d1-7fbf8f91b6eb" providerId="ADAL" clId="{B9B8FF69-58F3-48D8-9439-0B94E292364A}" dt="2021-06-08T06:18:29.137" v="92"/>
          <ac:picMkLst>
            <pc:docMk/>
            <pc:sldMk cId="424659793" sldId="259"/>
            <ac:picMk id="12" creationId="{34FF865B-A5A4-4D49-9A6A-DE1DF88F5DFE}"/>
          </ac:picMkLst>
        </pc:picChg>
        <pc:picChg chg="mod">
          <ac:chgData name="Sameer G Joshi (DJPR)" userId="bd06337d-ce8c-4c34-b1d1-7fbf8f91b6eb" providerId="ADAL" clId="{B9B8FF69-58F3-48D8-9439-0B94E292364A}" dt="2021-06-08T06:18:29.137" v="92"/>
          <ac:picMkLst>
            <pc:docMk/>
            <pc:sldMk cId="424659793" sldId="259"/>
            <ac:picMk id="13" creationId="{2A41BA1A-A007-41FC-ACD6-861C1FF0CFDC}"/>
          </ac:picMkLst>
        </pc:picChg>
        <pc:picChg chg="mod">
          <ac:chgData name="Sameer G Joshi (DJPR)" userId="bd06337d-ce8c-4c34-b1d1-7fbf8f91b6eb" providerId="ADAL" clId="{B9B8FF69-58F3-48D8-9439-0B94E292364A}" dt="2021-06-08T06:18:29.137" v="92"/>
          <ac:picMkLst>
            <pc:docMk/>
            <pc:sldMk cId="424659793" sldId="259"/>
            <ac:picMk id="31" creationId="{054617E4-0440-4224-8AD1-ABCDDC144DF4}"/>
          </ac:picMkLst>
        </pc:picChg>
        <pc:picChg chg="mod">
          <ac:chgData name="Sameer G Joshi (DJPR)" userId="bd06337d-ce8c-4c34-b1d1-7fbf8f91b6eb" providerId="ADAL" clId="{B9B8FF69-58F3-48D8-9439-0B94E292364A}" dt="2021-06-08T06:18:29.137" v="92"/>
          <ac:picMkLst>
            <pc:docMk/>
            <pc:sldMk cId="424659793" sldId="259"/>
            <ac:picMk id="32" creationId="{087FB6C6-D63C-4E56-9014-AFE8EC79BEF0}"/>
          </ac:picMkLst>
        </pc:picChg>
        <pc:picChg chg="mod">
          <ac:chgData name="Sameer G Joshi (DJPR)" userId="bd06337d-ce8c-4c34-b1d1-7fbf8f91b6eb" providerId="ADAL" clId="{B9B8FF69-58F3-48D8-9439-0B94E292364A}" dt="2021-06-08T06:18:29.137" v="92"/>
          <ac:picMkLst>
            <pc:docMk/>
            <pc:sldMk cId="424659793" sldId="259"/>
            <ac:picMk id="33" creationId="{35AD487E-C520-4E4B-8841-2C73E84CC0E1}"/>
          </ac:picMkLst>
        </pc:picChg>
        <pc:picChg chg="mod">
          <ac:chgData name="Sameer G Joshi (DJPR)" userId="bd06337d-ce8c-4c34-b1d1-7fbf8f91b6eb" providerId="ADAL" clId="{B9B8FF69-58F3-48D8-9439-0B94E292364A}" dt="2021-06-08T06:18:29.137" v="92"/>
          <ac:picMkLst>
            <pc:docMk/>
            <pc:sldMk cId="424659793" sldId="259"/>
            <ac:picMk id="34" creationId="{6E249896-3C3D-4099-A423-C736F5C73AB7}"/>
          </ac:picMkLst>
        </pc:picChg>
        <pc:picChg chg="mod">
          <ac:chgData name="Sameer G Joshi (DJPR)" userId="bd06337d-ce8c-4c34-b1d1-7fbf8f91b6eb" providerId="ADAL" clId="{B9B8FF69-58F3-48D8-9439-0B94E292364A}" dt="2021-06-08T06:18:29.137" v="92"/>
          <ac:picMkLst>
            <pc:docMk/>
            <pc:sldMk cId="424659793" sldId="259"/>
            <ac:picMk id="36" creationId="{597544FC-2283-4FE2-B6D3-DE2E02F5E81D}"/>
          </ac:picMkLst>
        </pc:picChg>
        <pc:picChg chg="mod">
          <ac:chgData name="Sameer G Joshi (DJPR)" userId="bd06337d-ce8c-4c34-b1d1-7fbf8f91b6eb" providerId="ADAL" clId="{B9B8FF69-58F3-48D8-9439-0B94E292364A}" dt="2021-06-08T06:18:29.137" v="92"/>
          <ac:picMkLst>
            <pc:docMk/>
            <pc:sldMk cId="424659793" sldId="259"/>
            <ac:picMk id="37" creationId="{882ABA55-BD47-4898-A864-9FFF98BED62F}"/>
          </ac:picMkLst>
        </pc:picChg>
        <pc:picChg chg="mod">
          <ac:chgData name="Sameer G Joshi (DJPR)" userId="bd06337d-ce8c-4c34-b1d1-7fbf8f91b6eb" providerId="ADAL" clId="{B9B8FF69-58F3-48D8-9439-0B94E292364A}" dt="2021-06-08T06:18:29.137" v="92"/>
          <ac:picMkLst>
            <pc:docMk/>
            <pc:sldMk cId="424659793" sldId="259"/>
            <ac:picMk id="38" creationId="{64541CC1-7580-4260-BAA6-BA5C0EADC2E9}"/>
          </ac:picMkLst>
        </pc:picChg>
        <pc:picChg chg="mod">
          <ac:chgData name="Sameer G Joshi (DJPR)" userId="bd06337d-ce8c-4c34-b1d1-7fbf8f91b6eb" providerId="ADAL" clId="{B9B8FF69-58F3-48D8-9439-0B94E292364A}" dt="2021-06-08T06:18:29.137" v="92"/>
          <ac:picMkLst>
            <pc:docMk/>
            <pc:sldMk cId="424659793" sldId="259"/>
            <ac:picMk id="39" creationId="{4ECFF335-3146-42DD-A295-9AD9407448CE}"/>
          </ac:picMkLst>
        </pc:picChg>
      </pc:sldChg>
      <pc:sldChg chg="modSp modNotes">
        <pc:chgData name="Sameer G Joshi (DJPR)" userId="bd06337d-ce8c-4c34-b1d1-7fbf8f91b6eb" providerId="ADAL" clId="{B9B8FF69-58F3-48D8-9439-0B94E292364A}" dt="2021-06-08T06:20:21.428" v="282" actId="1037"/>
        <pc:sldMkLst>
          <pc:docMk/>
          <pc:sldMk cId="2000004557" sldId="260"/>
        </pc:sldMkLst>
        <pc:spChg chg="mod">
          <ac:chgData name="Sameer G Joshi (DJPR)" userId="bd06337d-ce8c-4c34-b1d1-7fbf8f91b6eb" providerId="ADAL" clId="{B9B8FF69-58F3-48D8-9439-0B94E292364A}" dt="2021-06-08T06:20:21.428" v="282" actId="1037"/>
          <ac:spMkLst>
            <pc:docMk/>
            <pc:sldMk cId="2000004557" sldId="260"/>
            <ac:spMk id="6" creationId="{4E8C1A93-770A-4C1C-9961-68EC984DFA55}"/>
          </ac:spMkLst>
        </pc:spChg>
        <pc:spChg chg="mod">
          <ac:chgData name="Sameer G Joshi (DJPR)" userId="bd06337d-ce8c-4c34-b1d1-7fbf8f91b6eb" providerId="ADAL" clId="{B9B8FF69-58F3-48D8-9439-0B94E292364A}" dt="2021-06-08T06:20:21.428" v="282" actId="1037"/>
          <ac:spMkLst>
            <pc:docMk/>
            <pc:sldMk cId="2000004557" sldId="260"/>
            <ac:spMk id="7" creationId="{1C3C3A10-9CE1-4A4D-A74C-83315D339EA1}"/>
          </ac:spMkLst>
        </pc:spChg>
        <pc:spChg chg="mod">
          <ac:chgData name="Sameer G Joshi (DJPR)" userId="bd06337d-ce8c-4c34-b1d1-7fbf8f91b6eb" providerId="ADAL" clId="{B9B8FF69-58F3-48D8-9439-0B94E292364A}" dt="2021-06-08T06:20:21.428" v="282" actId="1037"/>
          <ac:spMkLst>
            <pc:docMk/>
            <pc:sldMk cId="2000004557" sldId="260"/>
            <ac:spMk id="8" creationId="{5CC67F77-E7A1-4802-802A-575670CD8EC1}"/>
          </ac:spMkLst>
        </pc:spChg>
        <pc:spChg chg="mod">
          <ac:chgData name="Sameer G Joshi (DJPR)" userId="bd06337d-ce8c-4c34-b1d1-7fbf8f91b6eb" providerId="ADAL" clId="{B9B8FF69-58F3-48D8-9439-0B94E292364A}" dt="2021-06-08T06:20:21.428" v="282" actId="1037"/>
          <ac:spMkLst>
            <pc:docMk/>
            <pc:sldMk cId="2000004557" sldId="260"/>
            <ac:spMk id="9" creationId="{73D193C3-6FAD-40EF-8AF7-53322AED14EC}"/>
          </ac:spMkLst>
        </pc:spChg>
        <pc:spChg chg="mod">
          <ac:chgData name="Sameer G Joshi (DJPR)" userId="bd06337d-ce8c-4c34-b1d1-7fbf8f91b6eb" providerId="ADAL" clId="{B9B8FF69-58F3-48D8-9439-0B94E292364A}" dt="2021-06-08T06:20:21.428" v="282" actId="1037"/>
          <ac:spMkLst>
            <pc:docMk/>
            <pc:sldMk cId="2000004557" sldId="260"/>
            <ac:spMk id="10" creationId="{59C0504E-C7AF-4D43-8383-ED0A5BC07BE9}"/>
          </ac:spMkLst>
        </pc:spChg>
        <pc:spChg chg="mod">
          <ac:chgData name="Sameer G Joshi (DJPR)" userId="bd06337d-ce8c-4c34-b1d1-7fbf8f91b6eb" providerId="ADAL" clId="{B9B8FF69-58F3-48D8-9439-0B94E292364A}" dt="2021-06-08T06:20:21.428" v="282" actId="1037"/>
          <ac:spMkLst>
            <pc:docMk/>
            <pc:sldMk cId="2000004557" sldId="260"/>
            <ac:spMk id="11" creationId="{B85949FD-1409-4C16-86E6-61191A01DC54}"/>
          </ac:spMkLst>
        </pc:spChg>
        <pc:graphicFrameChg chg="mod">
          <ac:chgData name="Sameer G Joshi (DJPR)" userId="bd06337d-ce8c-4c34-b1d1-7fbf8f91b6eb" providerId="ADAL" clId="{B9B8FF69-58F3-48D8-9439-0B94E292364A}" dt="2021-06-08T06:20:21.428" v="282" actId="1037"/>
          <ac:graphicFrameMkLst>
            <pc:docMk/>
            <pc:sldMk cId="2000004557" sldId="260"/>
            <ac:graphicFrameMk id="4" creationId="{7F2C73C6-B831-4FAE-935A-F943A81563E3}"/>
          </ac:graphicFrameMkLst>
        </pc:graphicFrameChg>
        <pc:graphicFrameChg chg="mod">
          <ac:chgData name="Sameer G Joshi (DJPR)" userId="bd06337d-ce8c-4c34-b1d1-7fbf8f91b6eb" providerId="ADAL" clId="{B9B8FF69-58F3-48D8-9439-0B94E292364A}" dt="2021-06-08T06:20:21.428" v="282" actId="1037"/>
          <ac:graphicFrameMkLst>
            <pc:docMk/>
            <pc:sldMk cId="2000004557" sldId="260"/>
            <ac:graphicFrameMk id="5" creationId="{CC083DA7-C645-4144-AD26-1F761AB8FAC1}"/>
          </ac:graphicFrameMkLst>
        </pc:graphicFrameChg>
      </pc:sldChg>
      <pc:sldChg chg="delSp modSp mod">
        <pc:chgData name="Sameer G Joshi (DJPR)" userId="bd06337d-ce8c-4c34-b1d1-7fbf8f91b6eb" providerId="ADAL" clId="{B9B8FF69-58F3-48D8-9439-0B94E292364A}" dt="2021-06-08T06:21:21.756" v="320" actId="1076"/>
        <pc:sldMkLst>
          <pc:docMk/>
          <pc:sldMk cId="3894103260" sldId="261"/>
        </pc:sldMkLst>
        <pc:spChg chg="mod">
          <ac:chgData name="Sameer G Joshi (DJPR)" userId="bd06337d-ce8c-4c34-b1d1-7fbf8f91b6eb" providerId="ADAL" clId="{B9B8FF69-58F3-48D8-9439-0B94E292364A}" dt="2021-06-08T06:21:09.366" v="318" actId="1076"/>
          <ac:spMkLst>
            <pc:docMk/>
            <pc:sldMk cId="3894103260" sldId="261"/>
            <ac:spMk id="7" creationId="{5DA62E7F-4D8B-4F68-A7A1-F0286AE3CEE2}"/>
          </ac:spMkLst>
        </pc:spChg>
        <pc:spChg chg="mod">
          <ac:chgData name="Sameer G Joshi (DJPR)" userId="bd06337d-ce8c-4c34-b1d1-7fbf8f91b6eb" providerId="ADAL" clId="{B9B8FF69-58F3-48D8-9439-0B94E292364A}" dt="2021-06-08T06:21:21.756" v="320" actId="1076"/>
          <ac:spMkLst>
            <pc:docMk/>
            <pc:sldMk cId="3894103260" sldId="261"/>
            <ac:spMk id="8" creationId="{272C0B60-CFDB-4C5B-B2D1-AF4193BBDF06}"/>
          </ac:spMkLst>
        </pc:spChg>
        <pc:spChg chg="del">
          <ac:chgData name="Sameer G Joshi (DJPR)" userId="bd06337d-ce8c-4c34-b1d1-7fbf8f91b6eb" providerId="ADAL" clId="{B9B8FF69-58F3-48D8-9439-0B94E292364A}" dt="2021-05-27T01:01:30.834" v="0" actId="478"/>
          <ac:spMkLst>
            <pc:docMk/>
            <pc:sldMk cId="3894103260" sldId="261"/>
            <ac:spMk id="9" creationId="{73D2CAE9-63A3-4C5F-AEC4-0D6D07752DAC}"/>
          </ac:spMkLst>
        </pc:spChg>
        <pc:spChg chg="del">
          <ac:chgData name="Sameer G Joshi (DJPR)" userId="bd06337d-ce8c-4c34-b1d1-7fbf8f91b6eb" providerId="ADAL" clId="{B9B8FF69-58F3-48D8-9439-0B94E292364A}" dt="2021-05-27T01:01:47.359" v="1" actId="478"/>
          <ac:spMkLst>
            <pc:docMk/>
            <pc:sldMk cId="3894103260" sldId="261"/>
            <ac:spMk id="10" creationId="{3945BAE7-35EC-47C1-B85D-A5D4017CEEDF}"/>
          </ac:spMkLst>
        </pc:spChg>
        <pc:spChg chg="del">
          <ac:chgData name="Sameer G Joshi (DJPR)" userId="bd06337d-ce8c-4c34-b1d1-7fbf8f91b6eb" providerId="ADAL" clId="{B9B8FF69-58F3-48D8-9439-0B94E292364A}" dt="2021-05-27T01:01:57.412" v="2" actId="478"/>
          <ac:spMkLst>
            <pc:docMk/>
            <pc:sldMk cId="3894103260" sldId="261"/>
            <ac:spMk id="11" creationId="{56822EF3-1A32-4209-9381-5ACEF9224BF9}"/>
          </ac:spMkLst>
        </pc:spChg>
        <pc:spChg chg="del">
          <ac:chgData name="Sameer G Joshi (DJPR)" userId="bd06337d-ce8c-4c34-b1d1-7fbf8f91b6eb" providerId="ADAL" clId="{B9B8FF69-58F3-48D8-9439-0B94E292364A}" dt="2021-05-27T01:02:01.366" v="3" actId="478"/>
          <ac:spMkLst>
            <pc:docMk/>
            <pc:sldMk cId="3894103260" sldId="261"/>
            <ac:spMk id="12" creationId="{D07A34F5-E1D7-4963-92A4-A34305AD7E4D}"/>
          </ac:spMkLst>
        </pc:spChg>
        <pc:spChg chg="mod">
          <ac:chgData name="Sameer G Joshi (DJPR)" userId="bd06337d-ce8c-4c34-b1d1-7fbf8f91b6eb" providerId="ADAL" clId="{B9B8FF69-58F3-48D8-9439-0B94E292364A}" dt="2021-06-08T06:20:32.762" v="314" actId="1036"/>
          <ac:spMkLst>
            <pc:docMk/>
            <pc:sldMk cId="3894103260" sldId="261"/>
            <ac:spMk id="13" creationId="{06EDB3DB-11B7-4BF7-9207-CE06B65DA4AC}"/>
          </ac:spMkLst>
        </pc:spChg>
        <pc:spChg chg="mod">
          <ac:chgData name="Sameer G Joshi (DJPR)" userId="bd06337d-ce8c-4c34-b1d1-7fbf8f91b6eb" providerId="ADAL" clId="{B9B8FF69-58F3-48D8-9439-0B94E292364A}" dt="2021-06-08T06:20:32.762" v="314" actId="1036"/>
          <ac:spMkLst>
            <pc:docMk/>
            <pc:sldMk cId="3894103260" sldId="261"/>
            <ac:spMk id="14" creationId="{97F0DAA3-B7BA-4A6F-AD4F-6242C6F5A64E}"/>
          </ac:spMkLst>
        </pc:spChg>
        <pc:spChg chg="mod">
          <ac:chgData name="Sameer G Joshi (DJPR)" userId="bd06337d-ce8c-4c34-b1d1-7fbf8f91b6eb" providerId="ADAL" clId="{B9B8FF69-58F3-48D8-9439-0B94E292364A}" dt="2021-06-08T06:20:32.762" v="314" actId="1036"/>
          <ac:spMkLst>
            <pc:docMk/>
            <pc:sldMk cId="3894103260" sldId="261"/>
            <ac:spMk id="15" creationId="{8C5BCF82-98BD-4AE7-B566-5E13F6C903C3}"/>
          </ac:spMkLst>
        </pc:spChg>
        <pc:spChg chg="mod">
          <ac:chgData name="Sameer G Joshi (DJPR)" userId="bd06337d-ce8c-4c34-b1d1-7fbf8f91b6eb" providerId="ADAL" clId="{B9B8FF69-58F3-48D8-9439-0B94E292364A}" dt="2021-06-08T06:20:32.762" v="314" actId="1036"/>
          <ac:spMkLst>
            <pc:docMk/>
            <pc:sldMk cId="3894103260" sldId="261"/>
            <ac:spMk id="16" creationId="{90125D82-0349-4F5F-B634-E6EA15E91039}"/>
          </ac:spMkLst>
        </pc:spChg>
        <pc:spChg chg="mod">
          <ac:chgData name="Sameer G Joshi (DJPR)" userId="bd06337d-ce8c-4c34-b1d1-7fbf8f91b6eb" providerId="ADAL" clId="{B9B8FF69-58F3-48D8-9439-0B94E292364A}" dt="2021-06-08T06:20:32.762" v="314" actId="1036"/>
          <ac:spMkLst>
            <pc:docMk/>
            <pc:sldMk cId="3894103260" sldId="261"/>
            <ac:spMk id="17" creationId="{824517C7-5926-46FA-B58D-313660F00FE7}"/>
          </ac:spMkLst>
        </pc:spChg>
        <pc:spChg chg="mod">
          <ac:chgData name="Sameer G Joshi (DJPR)" userId="bd06337d-ce8c-4c34-b1d1-7fbf8f91b6eb" providerId="ADAL" clId="{B9B8FF69-58F3-48D8-9439-0B94E292364A}" dt="2021-06-08T06:20:32.762" v="314" actId="1036"/>
          <ac:spMkLst>
            <pc:docMk/>
            <pc:sldMk cId="3894103260" sldId="261"/>
            <ac:spMk id="18" creationId="{9F1DF5AA-1841-427B-899E-BFD1CA7693DE}"/>
          </ac:spMkLst>
        </pc:spChg>
        <pc:graphicFrameChg chg="mod">
          <ac:chgData name="Sameer G Joshi (DJPR)" userId="bd06337d-ce8c-4c34-b1d1-7fbf8f91b6eb" providerId="ADAL" clId="{B9B8FF69-58F3-48D8-9439-0B94E292364A}" dt="2021-06-08T06:20:44.754" v="315"/>
          <ac:graphicFrameMkLst>
            <pc:docMk/>
            <pc:sldMk cId="3894103260" sldId="261"/>
            <ac:graphicFrameMk id="4" creationId="{83F68524-785E-4614-8FB3-E608D0FDB6CC}"/>
          </ac:graphicFrameMkLst>
        </pc:graphicFrameChg>
        <pc:graphicFrameChg chg="mod">
          <ac:chgData name="Sameer G Joshi (DJPR)" userId="bd06337d-ce8c-4c34-b1d1-7fbf8f91b6eb" providerId="ADAL" clId="{B9B8FF69-58F3-48D8-9439-0B94E292364A}" dt="2021-06-08T06:20:32.762" v="314" actId="1036"/>
          <ac:graphicFrameMkLst>
            <pc:docMk/>
            <pc:sldMk cId="3894103260" sldId="261"/>
            <ac:graphicFrameMk id="5" creationId="{F88B36AA-8262-4DAB-A280-CD4CF3198FBC}"/>
          </ac:graphicFrameMkLst>
        </pc:graphicFrameChg>
      </pc:sldChg>
      <pc:sldChg chg="modSp del mod">
        <pc:chgData name="Sameer G Joshi (DJPR)" userId="bd06337d-ce8c-4c34-b1d1-7fbf8f91b6eb" providerId="ADAL" clId="{B9B8FF69-58F3-48D8-9439-0B94E292364A}" dt="2021-06-15T00:45:00.646" v="1075" actId="47"/>
        <pc:sldMkLst>
          <pc:docMk/>
          <pc:sldMk cId="477948994" sldId="262"/>
        </pc:sldMkLst>
        <pc:spChg chg="mod">
          <ac:chgData name="Sameer G Joshi (DJPR)" userId="bd06337d-ce8c-4c34-b1d1-7fbf8f91b6eb" providerId="ADAL" clId="{B9B8FF69-58F3-48D8-9439-0B94E292364A}" dt="2021-06-08T06:19:05.506" v="146" actId="1035"/>
          <ac:spMkLst>
            <pc:docMk/>
            <pc:sldMk cId="477948994" sldId="262"/>
            <ac:spMk id="34" creationId="{ABDAA586-0445-4E95-BEB2-6FB7147CA9D9}"/>
          </ac:spMkLst>
        </pc:spChg>
        <pc:picChg chg="mod">
          <ac:chgData name="Sameer G Joshi (DJPR)" userId="bd06337d-ce8c-4c34-b1d1-7fbf8f91b6eb" providerId="ADAL" clId="{B9B8FF69-58F3-48D8-9439-0B94E292364A}" dt="2021-06-08T06:19:05.506" v="146" actId="1035"/>
          <ac:picMkLst>
            <pc:docMk/>
            <pc:sldMk cId="477948994" sldId="262"/>
            <ac:picMk id="31" creationId="{A1A9CCFA-12A9-424F-B698-82AA8A8D5E35}"/>
          </ac:picMkLst>
        </pc:picChg>
        <pc:picChg chg="mod">
          <ac:chgData name="Sameer G Joshi (DJPR)" userId="bd06337d-ce8c-4c34-b1d1-7fbf8f91b6eb" providerId="ADAL" clId="{B9B8FF69-58F3-48D8-9439-0B94E292364A}" dt="2021-06-08T06:19:05.506" v="146" actId="1035"/>
          <ac:picMkLst>
            <pc:docMk/>
            <pc:sldMk cId="477948994" sldId="262"/>
            <ac:picMk id="33" creationId="{71F80468-2BCF-4AB1-9EC0-99CBECA10147}"/>
          </ac:picMkLst>
        </pc:picChg>
      </pc:sldChg>
      <pc:sldChg chg="modSp del">
        <pc:chgData name="Sameer G Joshi (DJPR)" userId="bd06337d-ce8c-4c34-b1d1-7fbf8f91b6eb" providerId="ADAL" clId="{B9B8FF69-58F3-48D8-9439-0B94E292364A}" dt="2021-06-15T04:51:59.564" v="3931" actId="47"/>
        <pc:sldMkLst>
          <pc:docMk/>
          <pc:sldMk cId="1609758187" sldId="263"/>
        </pc:sldMkLst>
        <pc:spChg chg="mod">
          <ac:chgData name="Sameer G Joshi (DJPR)" userId="bd06337d-ce8c-4c34-b1d1-7fbf8f91b6eb" providerId="ADAL" clId="{B9B8FF69-58F3-48D8-9439-0B94E292364A}" dt="2021-06-08T06:18:29.137" v="92"/>
          <ac:spMkLst>
            <pc:docMk/>
            <pc:sldMk cId="1609758187" sldId="263"/>
            <ac:spMk id="4" creationId="{522CAF92-07D5-4CA8-8BCB-5C73D1A04CF6}"/>
          </ac:spMkLst>
        </pc:spChg>
      </pc:sldChg>
      <pc:sldChg chg="modSp del">
        <pc:chgData name="Sameer G Joshi (DJPR)" userId="bd06337d-ce8c-4c34-b1d1-7fbf8f91b6eb" providerId="ADAL" clId="{B9B8FF69-58F3-48D8-9439-0B94E292364A}" dt="2021-06-15T04:52:01.234" v="3932" actId="47"/>
        <pc:sldMkLst>
          <pc:docMk/>
          <pc:sldMk cId="2515884158" sldId="264"/>
        </pc:sldMkLst>
        <pc:spChg chg="mod">
          <ac:chgData name="Sameer G Joshi (DJPR)" userId="bd06337d-ce8c-4c34-b1d1-7fbf8f91b6eb" providerId="ADAL" clId="{B9B8FF69-58F3-48D8-9439-0B94E292364A}" dt="2021-06-08T06:18:29.137" v="92"/>
          <ac:spMkLst>
            <pc:docMk/>
            <pc:sldMk cId="2515884158" sldId="264"/>
            <ac:spMk id="4" creationId="{13C379B6-F83E-4BDB-822B-B675E25271B2}"/>
          </ac:spMkLst>
        </pc:spChg>
      </pc:sldChg>
      <pc:sldChg chg="addSp delSp modSp new mod">
        <pc:chgData name="Sameer G Joshi (DJPR)" userId="bd06337d-ce8c-4c34-b1d1-7fbf8f91b6eb" providerId="ADAL" clId="{B9B8FF69-58F3-48D8-9439-0B94E292364A}" dt="2021-06-15T02:40:58.549" v="3356" actId="1037"/>
        <pc:sldMkLst>
          <pc:docMk/>
          <pc:sldMk cId="583791291" sldId="265"/>
        </pc:sldMkLst>
        <pc:spChg chg="del">
          <ac:chgData name="Sameer G Joshi (DJPR)" userId="bd06337d-ce8c-4c34-b1d1-7fbf8f91b6eb" providerId="ADAL" clId="{B9B8FF69-58F3-48D8-9439-0B94E292364A}" dt="2021-06-08T04:52:36.484" v="5" actId="478"/>
          <ac:spMkLst>
            <pc:docMk/>
            <pc:sldMk cId="583791291" sldId="265"/>
            <ac:spMk id="2" creationId="{0A88F483-CDAC-427D-96EC-C1DF4E91141E}"/>
          </ac:spMkLst>
        </pc:spChg>
        <pc:spChg chg="del">
          <ac:chgData name="Sameer G Joshi (DJPR)" userId="bd06337d-ce8c-4c34-b1d1-7fbf8f91b6eb" providerId="ADAL" clId="{B9B8FF69-58F3-48D8-9439-0B94E292364A}" dt="2021-06-08T04:52:36.484" v="5" actId="478"/>
          <ac:spMkLst>
            <pc:docMk/>
            <pc:sldMk cId="583791291" sldId="265"/>
            <ac:spMk id="3" creationId="{C0A1A55C-4AC3-4902-8C53-53AF2B1D59E8}"/>
          </ac:spMkLst>
        </pc:spChg>
        <pc:spChg chg="add del mod">
          <ac:chgData name="Sameer G Joshi (DJPR)" userId="bd06337d-ce8c-4c34-b1d1-7fbf8f91b6eb" providerId="ADAL" clId="{B9B8FF69-58F3-48D8-9439-0B94E292364A}" dt="2021-06-08T04:54:35.659" v="21" actId="478"/>
          <ac:spMkLst>
            <pc:docMk/>
            <pc:sldMk cId="583791291" sldId="265"/>
            <ac:spMk id="5" creationId="{3A10190B-59DC-42DB-8970-8C58E6461B7D}"/>
          </ac:spMkLst>
        </pc:spChg>
        <pc:spChg chg="add del mod">
          <ac:chgData name="Sameer G Joshi (DJPR)" userId="bd06337d-ce8c-4c34-b1d1-7fbf8f91b6eb" providerId="ADAL" clId="{B9B8FF69-58F3-48D8-9439-0B94E292364A}" dt="2021-06-08T06:23:25.191" v="332" actId="478"/>
          <ac:spMkLst>
            <pc:docMk/>
            <pc:sldMk cId="583791291" sldId="265"/>
            <ac:spMk id="6" creationId="{6B18149A-8764-4993-91DE-AC72E093E1E3}"/>
          </ac:spMkLst>
        </pc:spChg>
        <pc:spChg chg="add mod">
          <ac:chgData name="Sameer G Joshi (DJPR)" userId="bd06337d-ce8c-4c34-b1d1-7fbf8f91b6eb" providerId="ADAL" clId="{B9B8FF69-58F3-48D8-9439-0B94E292364A}" dt="2021-06-15T02:08:09.075" v="2595" actId="1035"/>
          <ac:spMkLst>
            <pc:docMk/>
            <pc:sldMk cId="583791291" sldId="265"/>
            <ac:spMk id="7" creationId="{669EC6DC-A060-4FEB-9F88-3207967995BC}"/>
          </ac:spMkLst>
        </pc:spChg>
        <pc:spChg chg="add del mod">
          <ac:chgData name="Sameer G Joshi (DJPR)" userId="bd06337d-ce8c-4c34-b1d1-7fbf8f91b6eb" providerId="ADAL" clId="{B9B8FF69-58F3-48D8-9439-0B94E292364A}" dt="2021-06-08T06:23:25.191" v="332" actId="478"/>
          <ac:spMkLst>
            <pc:docMk/>
            <pc:sldMk cId="583791291" sldId="265"/>
            <ac:spMk id="7" creationId="{67FB1D62-A8E8-43D6-B971-82EF00BC7FFD}"/>
          </ac:spMkLst>
        </pc:spChg>
        <pc:spChg chg="add mod">
          <ac:chgData name="Sameer G Joshi (DJPR)" userId="bd06337d-ce8c-4c34-b1d1-7fbf8f91b6eb" providerId="ADAL" clId="{B9B8FF69-58F3-48D8-9439-0B94E292364A}" dt="2021-06-15T02:08:27.059" v="2610" actId="12788"/>
          <ac:spMkLst>
            <pc:docMk/>
            <pc:sldMk cId="583791291" sldId="265"/>
            <ac:spMk id="8" creationId="{659CF953-6ACD-41DC-A672-802C4C22DCE4}"/>
          </ac:spMkLst>
        </pc:spChg>
        <pc:spChg chg="add del mod">
          <ac:chgData name="Sameer G Joshi (DJPR)" userId="bd06337d-ce8c-4c34-b1d1-7fbf8f91b6eb" providerId="ADAL" clId="{B9B8FF69-58F3-48D8-9439-0B94E292364A}" dt="2021-06-08T06:23:25.191" v="332" actId="478"/>
          <ac:spMkLst>
            <pc:docMk/>
            <pc:sldMk cId="583791291" sldId="265"/>
            <ac:spMk id="8" creationId="{95DC7EC5-E90C-4697-AC0C-FFFAB27F25D5}"/>
          </ac:spMkLst>
        </pc:spChg>
        <pc:spChg chg="add del mod">
          <ac:chgData name="Sameer G Joshi (DJPR)" userId="bd06337d-ce8c-4c34-b1d1-7fbf8f91b6eb" providerId="ADAL" clId="{B9B8FF69-58F3-48D8-9439-0B94E292364A}" dt="2021-06-08T06:23:25.191" v="332" actId="478"/>
          <ac:spMkLst>
            <pc:docMk/>
            <pc:sldMk cId="583791291" sldId="265"/>
            <ac:spMk id="9" creationId="{0E6AEF7A-3B41-4D82-B95D-8F2B27DEF859}"/>
          </ac:spMkLst>
        </pc:spChg>
        <pc:spChg chg="add mod">
          <ac:chgData name="Sameer G Joshi (DJPR)" userId="bd06337d-ce8c-4c34-b1d1-7fbf8f91b6eb" providerId="ADAL" clId="{B9B8FF69-58F3-48D8-9439-0B94E292364A}" dt="2021-06-15T02:40:58.549" v="3356" actId="1037"/>
          <ac:spMkLst>
            <pc:docMk/>
            <pc:sldMk cId="583791291" sldId="265"/>
            <ac:spMk id="9" creationId="{22BF6A7C-6AE9-4BD0-97BD-9F16660F100A}"/>
          </ac:spMkLst>
        </pc:spChg>
        <pc:spChg chg="add mod">
          <ac:chgData name="Sameer G Joshi (DJPR)" userId="bd06337d-ce8c-4c34-b1d1-7fbf8f91b6eb" providerId="ADAL" clId="{B9B8FF69-58F3-48D8-9439-0B94E292364A}" dt="2021-06-15T02:06:49.629" v="2530" actId="1076"/>
          <ac:spMkLst>
            <pc:docMk/>
            <pc:sldMk cId="583791291" sldId="265"/>
            <ac:spMk id="10" creationId="{3927051D-AEBE-41FC-A603-69ECF2338DEA}"/>
          </ac:spMkLst>
        </pc:spChg>
        <pc:spChg chg="add mod">
          <ac:chgData name="Sameer G Joshi (DJPR)" userId="bd06337d-ce8c-4c34-b1d1-7fbf8f91b6eb" providerId="ADAL" clId="{B9B8FF69-58F3-48D8-9439-0B94E292364A}" dt="2021-06-15T02:31:29.115" v="3118" actId="1076"/>
          <ac:spMkLst>
            <pc:docMk/>
            <pc:sldMk cId="583791291" sldId="265"/>
            <ac:spMk id="14" creationId="{49211749-BCC9-422A-AA45-479681C574AF}"/>
          </ac:spMkLst>
        </pc:spChg>
        <pc:spChg chg="add mod">
          <ac:chgData name="Sameer G Joshi (DJPR)" userId="bd06337d-ce8c-4c34-b1d1-7fbf8f91b6eb" providerId="ADAL" clId="{B9B8FF69-58F3-48D8-9439-0B94E292364A}" dt="2021-06-15T02:31:33.487" v="3119" actId="1076"/>
          <ac:spMkLst>
            <pc:docMk/>
            <pc:sldMk cId="583791291" sldId="265"/>
            <ac:spMk id="15" creationId="{67BF43C3-DAC3-4414-BDF0-3D7F4DCF211A}"/>
          </ac:spMkLst>
        </pc:spChg>
        <pc:spChg chg="add mod">
          <ac:chgData name="Sameer G Joshi (DJPR)" userId="bd06337d-ce8c-4c34-b1d1-7fbf8f91b6eb" providerId="ADAL" clId="{B9B8FF69-58F3-48D8-9439-0B94E292364A}" dt="2021-06-15T02:31:37.590" v="3120" actId="1076"/>
          <ac:spMkLst>
            <pc:docMk/>
            <pc:sldMk cId="583791291" sldId="265"/>
            <ac:spMk id="16" creationId="{C4C9D8BB-EF55-49C5-B6F0-F2648539960A}"/>
          </ac:spMkLst>
        </pc:spChg>
        <pc:spChg chg="add del mod">
          <ac:chgData name="Sameer G Joshi (DJPR)" userId="bd06337d-ce8c-4c34-b1d1-7fbf8f91b6eb" providerId="ADAL" clId="{B9B8FF69-58F3-48D8-9439-0B94E292364A}" dt="2021-06-08T06:36:03.240" v="598" actId="21"/>
          <ac:spMkLst>
            <pc:docMk/>
            <pc:sldMk cId="583791291" sldId="265"/>
            <ac:spMk id="18" creationId="{FA83D3C3-7A66-4294-AD00-F53ECF032E31}"/>
          </ac:spMkLst>
        </pc:spChg>
        <pc:spChg chg="add del mod">
          <ac:chgData name="Sameer G Joshi (DJPR)" userId="bd06337d-ce8c-4c34-b1d1-7fbf8f91b6eb" providerId="ADAL" clId="{B9B8FF69-58F3-48D8-9439-0B94E292364A}" dt="2021-06-08T06:57:41.251" v="957" actId="478"/>
          <ac:spMkLst>
            <pc:docMk/>
            <pc:sldMk cId="583791291" sldId="265"/>
            <ac:spMk id="19" creationId="{DBC47AFE-2F85-4430-B767-5B19DBB77467}"/>
          </ac:spMkLst>
        </pc:spChg>
        <pc:spChg chg="add del mod">
          <ac:chgData name="Sameer G Joshi (DJPR)" userId="bd06337d-ce8c-4c34-b1d1-7fbf8f91b6eb" providerId="ADAL" clId="{B9B8FF69-58F3-48D8-9439-0B94E292364A}" dt="2021-06-08T06:57:18.618" v="874" actId="478"/>
          <ac:spMkLst>
            <pc:docMk/>
            <pc:sldMk cId="583791291" sldId="265"/>
            <ac:spMk id="20" creationId="{41F37DAE-5865-4488-8BD7-B2007B28351F}"/>
          </ac:spMkLst>
        </pc:spChg>
        <pc:spChg chg="add del mod">
          <ac:chgData name="Sameer G Joshi (DJPR)" userId="bd06337d-ce8c-4c34-b1d1-7fbf8f91b6eb" providerId="ADAL" clId="{B9B8FF69-58F3-48D8-9439-0B94E292364A}" dt="2021-06-08T06:56:54.321" v="811" actId="478"/>
          <ac:spMkLst>
            <pc:docMk/>
            <pc:sldMk cId="583791291" sldId="265"/>
            <ac:spMk id="21" creationId="{8DBD0213-425B-4311-92B7-1505FA4D3042}"/>
          </ac:spMkLst>
        </pc:spChg>
        <pc:spChg chg="add del mod">
          <ac:chgData name="Sameer G Joshi (DJPR)" userId="bd06337d-ce8c-4c34-b1d1-7fbf8f91b6eb" providerId="ADAL" clId="{B9B8FF69-58F3-48D8-9439-0B94E292364A}" dt="2021-06-15T02:09:05.559" v="2611" actId="14100"/>
          <ac:spMkLst>
            <pc:docMk/>
            <pc:sldMk cId="583791291" sldId="265"/>
            <ac:spMk id="22" creationId="{992E1A0D-4BB8-4079-BB62-0A9293F01807}"/>
          </ac:spMkLst>
        </pc:spChg>
        <pc:spChg chg="add mod">
          <ac:chgData name="Sameer G Joshi (DJPR)" userId="bd06337d-ce8c-4c34-b1d1-7fbf8f91b6eb" providerId="ADAL" clId="{B9B8FF69-58F3-48D8-9439-0B94E292364A}" dt="2021-06-15T02:07:50.123" v="2562" actId="1036"/>
          <ac:spMkLst>
            <pc:docMk/>
            <pc:sldMk cId="583791291" sldId="265"/>
            <ac:spMk id="23" creationId="{2F3DC777-2325-4CDE-9761-4F948C9F5A49}"/>
          </ac:spMkLst>
        </pc:spChg>
        <pc:spChg chg="add mod">
          <ac:chgData name="Sameer G Joshi (DJPR)" userId="bd06337d-ce8c-4c34-b1d1-7fbf8f91b6eb" providerId="ADAL" clId="{B9B8FF69-58F3-48D8-9439-0B94E292364A}" dt="2021-06-15T02:08:09.075" v="2595" actId="1035"/>
          <ac:spMkLst>
            <pc:docMk/>
            <pc:sldMk cId="583791291" sldId="265"/>
            <ac:spMk id="24" creationId="{393487D0-C5B9-4599-B261-0F46399B13A9}"/>
          </ac:spMkLst>
        </pc:spChg>
        <pc:spChg chg="add mod">
          <ac:chgData name="Sameer G Joshi (DJPR)" userId="bd06337d-ce8c-4c34-b1d1-7fbf8f91b6eb" providerId="ADAL" clId="{B9B8FF69-58F3-48D8-9439-0B94E292364A}" dt="2021-06-15T02:08:09.075" v="2595" actId="1035"/>
          <ac:spMkLst>
            <pc:docMk/>
            <pc:sldMk cId="583791291" sldId="265"/>
            <ac:spMk id="25" creationId="{9EA8E082-A215-4CA9-A7BF-AD15A02FB43F}"/>
          </ac:spMkLst>
        </pc:spChg>
        <pc:spChg chg="add mod">
          <ac:chgData name="Sameer G Joshi (DJPR)" userId="bd06337d-ce8c-4c34-b1d1-7fbf8f91b6eb" providerId="ADAL" clId="{B9B8FF69-58F3-48D8-9439-0B94E292364A}" dt="2021-06-15T02:08:09.075" v="2595" actId="1035"/>
          <ac:spMkLst>
            <pc:docMk/>
            <pc:sldMk cId="583791291" sldId="265"/>
            <ac:spMk id="26" creationId="{6346F46E-3665-40F3-A57E-4A4A52142C5D}"/>
          </ac:spMkLst>
        </pc:spChg>
        <pc:spChg chg="add mod">
          <ac:chgData name="Sameer G Joshi (DJPR)" userId="bd06337d-ce8c-4c34-b1d1-7fbf8f91b6eb" providerId="ADAL" clId="{B9B8FF69-58F3-48D8-9439-0B94E292364A}" dt="2021-06-15T02:08:09.075" v="2595" actId="1035"/>
          <ac:spMkLst>
            <pc:docMk/>
            <pc:sldMk cId="583791291" sldId="265"/>
            <ac:spMk id="27" creationId="{8035719F-FA9B-4DFD-846A-BBED0BCFD52F}"/>
          </ac:spMkLst>
        </pc:spChg>
        <pc:spChg chg="add mod">
          <ac:chgData name="Sameer G Joshi (DJPR)" userId="bd06337d-ce8c-4c34-b1d1-7fbf8f91b6eb" providerId="ADAL" clId="{B9B8FF69-58F3-48D8-9439-0B94E292364A}" dt="2021-06-15T02:08:09.075" v="2595" actId="1035"/>
          <ac:spMkLst>
            <pc:docMk/>
            <pc:sldMk cId="583791291" sldId="265"/>
            <ac:spMk id="28" creationId="{34BB7CA0-CFD8-440D-B6A7-80035AA16B2D}"/>
          </ac:spMkLst>
        </pc:spChg>
        <pc:spChg chg="add del mod">
          <ac:chgData name="Sameer G Joshi (DJPR)" userId="bd06337d-ce8c-4c34-b1d1-7fbf8f91b6eb" providerId="ADAL" clId="{B9B8FF69-58F3-48D8-9439-0B94E292364A}" dt="2021-06-15T02:09:05.559" v="2611" actId="14100"/>
          <ac:spMkLst>
            <pc:docMk/>
            <pc:sldMk cId="583791291" sldId="265"/>
            <ac:spMk id="29" creationId="{BF70156A-562E-427C-9A66-4F12B1D7ADD3}"/>
          </ac:spMkLst>
        </pc:spChg>
        <pc:spChg chg="add del mod">
          <ac:chgData name="Sameer G Joshi (DJPR)" userId="bd06337d-ce8c-4c34-b1d1-7fbf8f91b6eb" providerId="ADAL" clId="{B9B8FF69-58F3-48D8-9439-0B94E292364A}" dt="2021-06-15T02:09:05.559" v="2611" actId="14100"/>
          <ac:spMkLst>
            <pc:docMk/>
            <pc:sldMk cId="583791291" sldId="265"/>
            <ac:spMk id="30" creationId="{D562767F-9E9C-4C1E-9D0C-0051F57FD02D}"/>
          </ac:spMkLst>
        </pc:spChg>
        <pc:spChg chg="add del mod">
          <ac:chgData name="Sameer G Joshi (DJPR)" userId="bd06337d-ce8c-4c34-b1d1-7fbf8f91b6eb" providerId="ADAL" clId="{B9B8FF69-58F3-48D8-9439-0B94E292364A}" dt="2021-06-15T02:09:05.559" v="2611" actId="14100"/>
          <ac:spMkLst>
            <pc:docMk/>
            <pc:sldMk cId="583791291" sldId="265"/>
            <ac:spMk id="31" creationId="{94F470F8-2C3E-44F7-BC69-2D4A60270D8E}"/>
          </ac:spMkLst>
        </pc:spChg>
        <pc:spChg chg="add mod">
          <ac:chgData name="Sameer G Joshi (DJPR)" userId="bd06337d-ce8c-4c34-b1d1-7fbf8f91b6eb" providerId="ADAL" clId="{B9B8FF69-58F3-48D8-9439-0B94E292364A}" dt="2021-06-15T02:08:09.075" v="2595" actId="1035"/>
          <ac:spMkLst>
            <pc:docMk/>
            <pc:sldMk cId="583791291" sldId="265"/>
            <ac:spMk id="32" creationId="{6213541E-BF29-4D80-8B8A-5A886924F1B4}"/>
          </ac:spMkLst>
        </pc:spChg>
        <pc:spChg chg="add mod">
          <ac:chgData name="Sameer G Joshi (DJPR)" userId="bd06337d-ce8c-4c34-b1d1-7fbf8f91b6eb" providerId="ADAL" clId="{B9B8FF69-58F3-48D8-9439-0B94E292364A}" dt="2021-06-15T02:08:09.075" v="2595" actId="1035"/>
          <ac:spMkLst>
            <pc:docMk/>
            <pc:sldMk cId="583791291" sldId="265"/>
            <ac:spMk id="33" creationId="{75B447A9-83E6-41C7-B3E6-923FE820F704}"/>
          </ac:spMkLst>
        </pc:spChg>
        <pc:spChg chg="add mod">
          <ac:chgData name="Sameer G Joshi (DJPR)" userId="bd06337d-ce8c-4c34-b1d1-7fbf8f91b6eb" providerId="ADAL" clId="{B9B8FF69-58F3-48D8-9439-0B94E292364A}" dt="2021-06-15T02:08:09.075" v="2595" actId="1035"/>
          <ac:spMkLst>
            <pc:docMk/>
            <pc:sldMk cId="583791291" sldId="265"/>
            <ac:spMk id="34" creationId="{7A928E5D-BE2E-4E05-B56D-CEFAE3A892F0}"/>
          </ac:spMkLst>
        </pc:spChg>
        <pc:spChg chg="add mod">
          <ac:chgData name="Sameer G Joshi (DJPR)" userId="bd06337d-ce8c-4c34-b1d1-7fbf8f91b6eb" providerId="ADAL" clId="{B9B8FF69-58F3-48D8-9439-0B94E292364A}" dt="2021-06-15T02:08:09.075" v="2595" actId="1035"/>
          <ac:spMkLst>
            <pc:docMk/>
            <pc:sldMk cId="583791291" sldId="265"/>
            <ac:spMk id="35" creationId="{271BC50E-A8E7-4C92-9CF3-011F2F7BFD69}"/>
          </ac:spMkLst>
        </pc:spChg>
        <pc:spChg chg="add mod">
          <ac:chgData name="Sameer G Joshi (DJPR)" userId="bd06337d-ce8c-4c34-b1d1-7fbf8f91b6eb" providerId="ADAL" clId="{B9B8FF69-58F3-48D8-9439-0B94E292364A}" dt="2021-06-15T02:08:09.075" v="2595" actId="1035"/>
          <ac:spMkLst>
            <pc:docMk/>
            <pc:sldMk cId="583791291" sldId="265"/>
            <ac:spMk id="36" creationId="{BE020AE4-2644-4F97-BFDB-F58F3FD6E0AF}"/>
          </ac:spMkLst>
        </pc:spChg>
        <pc:spChg chg="add mod">
          <ac:chgData name="Sameer G Joshi (DJPR)" userId="bd06337d-ce8c-4c34-b1d1-7fbf8f91b6eb" providerId="ADAL" clId="{B9B8FF69-58F3-48D8-9439-0B94E292364A}" dt="2021-06-15T02:08:09.075" v="2595" actId="1035"/>
          <ac:spMkLst>
            <pc:docMk/>
            <pc:sldMk cId="583791291" sldId="265"/>
            <ac:spMk id="37" creationId="{47E03D7D-80D6-4FA8-B6EA-0EDB08AF84EE}"/>
          </ac:spMkLst>
        </pc:spChg>
        <pc:spChg chg="add mod">
          <ac:chgData name="Sameer G Joshi (DJPR)" userId="bd06337d-ce8c-4c34-b1d1-7fbf8f91b6eb" providerId="ADAL" clId="{B9B8FF69-58F3-48D8-9439-0B94E292364A}" dt="2021-06-15T02:08:09.075" v="2595" actId="1035"/>
          <ac:spMkLst>
            <pc:docMk/>
            <pc:sldMk cId="583791291" sldId="265"/>
            <ac:spMk id="38" creationId="{9E5B10F8-6420-49A7-B1EE-B173BC05719A}"/>
          </ac:spMkLst>
        </pc:spChg>
        <pc:spChg chg="add mod">
          <ac:chgData name="Sameer G Joshi (DJPR)" userId="bd06337d-ce8c-4c34-b1d1-7fbf8f91b6eb" providerId="ADAL" clId="{B9B8FF69-58F3-48D8-9439-0B94E292364A}" dt="2021-06-15T02:08:09.075" v="2595" actId="1035"/>
          <ac:spMkLst>
            <pc:docMk/>
            <pc:sldMk cId="583791291" sldId="265"/>
            <ac:spMk id="39" creationId="{B74597AD-A9BB-4EB5-B30B-731046F52670}"/>
          </ac:spMkLst>
        </pc:spChg>
        <pc:spChg chg="add mod">
          <ac:chgData name="Sameer G Joshi (DJPR)" userId="bd06337d-ce8c-4c34-b1d1-7fbf8f91b6eb" providerId="ADAL" clId="{B9B8FF69-58F3-48D8-9439-0B94E292364A}" dt="2021-06-15T02:08:09.075" v="2595" actId="1035"/>
          <ac:spMkLst>
            <pc:docMk/>
            <pc:sldMk cId="583791291" sldId="265"/>
            <ac:spMk id="40" creationId="{5BB9CF40-01FA-4414-8AB4-671F3A2BCE02}"/>
          </ac:spMkLst>
        </pc:spChg>
        <pc:spChg chg="add mod">
          <ac:chgData name="Sameer G Joshi (DJPR)" userId="bd06337d-ce8c-4c34-b1d1-7fbf8f91b6eb" providerId="ADAL" clId="{B9B8FF69-58F3-48D8-9439-0B94E292364A}" dt="2021-06-15T02:08:09.075" v="2595" actId="1035"/>
          <ac:spMkLst>
            <pc:docMk/>
            <pc:sldMk cId="583791291" sldId="265"/>
            <ac:spMk id="41" creationId="{B1067D69-FC17-4747-B00F-3DB9E5DE238A}"/>
          </ac:spMkLst>
        </pc:spChg>
        <pc:spChg chg="add mod">
          <ac:chgData name="Sameer G Joshi (DJPR)" userId="bd06337d-ce8c-4c34-b1d1-7fbf8f91b6eb" providerId="ADAL" clId="{B9B8FF69-58F3-48D8-9439-0B94E292364A}" dt="2021-06-15T02:08:09.075" v="2595" actId="1035"/>
          <ac:spMkLst>
            <pc:docMk/>
            <pc:sldMk cId="583791291" sldId="265"/>
            <ac:spMk id="42" creationId="{7984CBDD-FAA5-4E25-8E5E-F7022EE4D62B}"/>
          </ac:spMkLst>
        </pc:spChg>
        <pc:spChg chg="add mod">
          <ac:chgData name="Sameer G Joshi (DJPR)" userId="bd06337d-ce8c-4c34-b1d1-7fbf8f91b6eb" providerId="ADAL" clId="{B9B8FF69-58F3-48D8-9439-0B94E292364A}" dt="2021-06-15T02:08:09.075" v="2595" actId="1035"/>
          <ac:spMkLst>
            <pc:docMk/>
            <pc:sldMk cId="583791291" sldId="265"/>
            <ac:spMk id="43" creationId="{8230D23F-051A-4508-BBA8-52F6A68170E5}"/>
          </ac:spMkLst>
        </pc:spChg>
        <pc:spChg chg="add mod">
          <ac:chgData name="Sameer G Joshi (DJPR)" userId="bd06337d-ce8c-4c34-b1d1-7fbf8f91b6eb" providerId="ADAL" clId="{B9B8FF69-58F3-48D8-9439-0B94E292364A}" dt="2021-06-15T02:08:27.059" v="2610" actId="12788"/>
          <ac:spMkLst>
            <pc:docMk/>
            <pc:sldMk cId="583791291" sldId="265"/>
            <ac:spMk id="44" creationId="{ADA4E465-BF73-4D08-844A-7CC87D4B5C1D}"/>
          </ac:spMkLst>
        </pc:spChg>
        <pc:spChg chg="add mod">
          <ac:chgData name="Sameer G Joshi (DJPR)" userId="bd06337d-ce8c-4c34-b1d1-7fbf8f91b6eb" providerId="ADAL" clId="{B9B8FF69-58F3-48D8-9439-0B94E292364A}" dt="2021-06-15T02:08:27.059" v="2610" actId="12788"/>
          <ac:spMkLst>
            <pc:docMk/>
            <pc:sldMk cId="583791291" sldId="265"/>
            <ac:spMk id="45" creationId="{B71F5496-F122-42B5-AD0F-D6F7707291A0}"/>
          </ac:spMkLst>
        </pc:spChg>
        <pc:spChg chg="add mod">
          <ac:chgData name="Sameer G Joshi (DJPR)" userId="bd06337d-ce8c-4c34-b1d1-7fbf8f91b6eb" providerId="ADAL" clId="{B9B8FF69-58F3-48D8-9439-0B94E292364A}" dt="2021-06-15T02:40:38.376" v="3350" actId="113"/>
          <ac:spMkLst>
            <pc:docMk/>
            <pc:sldMk cId="583791291" sldId="265"/>
            <ac:spMk id="46" creationId="{45F850D6-674D-46BB-BC57-F7B3BFE344EA}"/>
          </ac:spMkLst>
        </pc:spChg>
        <pc:spChg chg="add mod">
          <ac:chgData name="Sameer G Joshi (DJPR)" userId="bd06337d-ce8c-4c34-b1d1-7fbf8f91b6eb" providerId="ADAL" clId="{B9B8FF69-58F3-48D8-9439-0B94E292364A}" dt="2021-06-15T02:40:38.376" v="3350" actId="113"/>
          <ac:spMkLst>
            <pc:docMk/>
            <pc:sldMk cId="583791291" sldId="265"/>
            <ac:spMk id="47" creationId="{C32B7E20-BE7D-4AD8-BDD6-AD5B8227D322}"/>
          </ac:spMkLst>
        </pc:spChg>
        <pc:spChg chg="add mod">
          <ac:chgData name="Sameer G Joshi (DJPR)" userId="bd06337d-ce8c-4c34-b1d1-7fbf8f91b6eb" providerId="ADAL" clId="{B9B8FF69-58F3-48D8-9439-0B94E292364A}" dt="2021-06-15T02:40:38.376" v="3350" actId="113"/>
          <ac:spMkLst>
            <pc:docMk/>
            <pc:sldMk cId="583791291" sldId="265"/>
            <ac:spMk id="48" creationId="{1B54EEDF-DD3B-4CA1-8D2E-69980AB878CA}"/>
          </ac:spMkLst>
        </pc:spChg>
        <pc:graphicFrameChg chg="add del mod">
          <ac:chgData name="Sameer G Joshi (DJPR)" userId="bd06337d-ce8c-4c34-b1d1-7fbf8f91b6eb" providerId="ADAL" clId="{B9B8FF69-58F3-48D8-9439-0B94E292364A}" dt="2021-06-15T02:06:16.043" v="2525" actId="1036"/>
          <ac:graphicFrameMkLst>
            <pc:docMk/>
            <pc:sldMk cId="583791291" sldId="265"/>
            <ac:graphicFrameMk id="4" creationId="{C6141EE1-2ACE-453F-88FB-1D4F9F2D1A27}"/>
          </ac:graphicFrameMkLst>
        </pc:graphicFrameChg>
        <pc:graphicFrameChg chg="add mod">
          <ac:chgData name="Sameer G Joshi (DJPR)" userId="bd06337d-ce8c-4c34-b1d1-7fbf8f91b6eb" providerId="ADAL" clId="{B9B8FF69-58F3-48D8-9439-0B94E292364A}" dt="2021-06-15T02:07:50.123" v="2562" actId="1036"/>
          <ac:graphicFrameMkLst>
            <pc:docMk/>
            <pc:sldMk cId="583791291" sldId="265"/>
            <ac:graphicFrameMk id="11" creationId="{9FFD596F-22DD-43A8-91C0-083F7FE6F33E}"/>
          </ac:graphicFrameMkLst>
        </pc:graphicFrameChg>
        <pc:graphicFrameChg chg="add mod">
          <ac:chgData name="Sameer G Joshi (DJPR)" userId="bd06337d-ce8c-4c34-b1d1-7fbf8f91b6eb" providerId="ADAL" clId="{B9B8FF69-58F3-48D8-9439-0B94E292364A}" dt="2021-06-15T02:08:09.075" v="2595" actId="1035"/>
          <ac:graphicFrameMkLst>
            <pc:docMk/>
            <pc:sldMk cId="583791291" sldId="265"/>
            <ac:graphicFrameMk id="12" creationId="{2F82BF82-5D29-4105-9959-CE826A51DC9F}"/>
          </ac:graphicFrameMkLst>
        </pc:graphicFrameChg>
        <pc:graphicFrameChg chg="add del mod">
          <ac:chgData name="Sameer G Joshi (DJPR)" userId="bd06337d-ce8c-4c34-b1d1-7fbf8f91b6eb" providerId="ADAL" clId="{B9B8FF69-58F3-48D8-9439-0B94E292364A}" dt="2021-06-08T06:29:46.235" v="449" actId="478"/>
          <ac:graphicFrameMkLst>
            <pc:docMk/>
            <pc:sldMk cId="583791291" sldId="265"/>
            <ac:graphicFrameMk id="13" creationId="{21D0D93B-2CDC-43D7-9B5D-5EA7BD113020}"/>
          </ac:graphicFrameMkLst>
        </pc:graphicFrameChg>
        <pc:graphicFrameChg chg="add del mod">
          <ac:chgData name="Sameer G Joshi (DJPR)" userId="bd06337d-ce8c-4c34-b1d1-7fbf8f91b6eb" providerId="ADAL" clId="{B9B8FF69-58F3-48D8-9439-0B94E292364A}" dt="2021-06-08T06:34:31.631" v="578" actId="21"/>
          <ac:graphicFrameMkLst>
            <pc:docMk/>
            <pc:sldMk cId="583791291" sldId="265"/>
            <ac:graphicFrameMk id="17" creationId="{21D0D93B-2CDC-43D7-9B5D-5EA7BD113020}"/>
          </ac:graphicFrameMkLst>
        </pc:graphicFrameChg>
        <pc:cxnChg chg="add mod">
          <ac:chgData name="Sameer G Joshi (DJPR)" userId="bd06337d-ce8c-4c34-b1d1-7fbf8f91b6eb" providerId="ADAL" clId="{B9B8FF69-58F3-48D8-9439-0B94E292364A}" dt="2021-06-15T02:08:09.075" v="2595" actId="1035"/>
          <ac:cxnSpMkLst>
            <pc:docMk/>
            <pc:sldMk cId="583791291" sldId="265"/>
            <ac:cxnSpMk id="3" creationId="{61C2947D-BBA5-4A70-98B1-2010E166F00D}"/>
          </ac:cxnSpMkLst>
        </pc:cxnChg>
      </pc:sldChg>
      <pc:sldChg chg="addSp delSp modSp new mod">
        <pc:chgData name="Sameer G Joshi (DJPR)" userId="bd06337d-ce8c-4c34-b1d1-7fbf8f91b6eb" providerId="ADAL" clId="{B9B8FF69-58F3-48D8-9439-0B94E292364A}" dt="2021-06-15T02:41:11.482" v="3357" actId="14100"/>
        <pc:sldMkLst>
          <pc:docMk/>
          <pc:sldMk cId="3253327431" sldId="266"/>
        </pc:sldMkLst>
        <pc:spChg chg="del">
          <ac:chgData name="Sameer G Joshi (DJPR)" userId="bd06337d-ce8c-4c34-b1d1-7fbf8f91b6eb" providerId="ADAL" clId="{B9B8FF69-58F3-48D8-9439-0B94E292364A}" dt="2021-06-08T06:34:25.958" v="577" actId="478"/>
          <ac:spMkLst>
            <pc:docMk/>
            <pc:sldMk cId="3253327431" sldId="266"/>
            <ac:spMk id="2" creationId="{F4501CC6-7EDA-4B7E-B240-C66FD4C39997}"/>
          </ac:spMkLst>
        </pc:spChg>
        <pc:spChg chg="del">
          <ac:chgData name="Sameer G Joshi (DJPR)" userId="bd06337d-ce8c-4c34-b1d1-7fbf8f91b6eb" providerId="ADAL" clId="{B9B8FF69-58F3-48D8-9439-0B94E292364A}" dt="2021-06-08T06:34:25.958" v="577" actId="478"/>
          <ac:spMkLst>
            <pc:docMk/>
            <pc:sldMk cId="3253327431" sldId="266"/>
            <ac:spMk id="3" creationId="{72AC1C0F-B3B6-4E2C-8F2D-8AD22AC4B35A}"/>
          </ac:spMkLst>
        </pc:spChg>
        <pc:spChg chg="add mod">
          <ac:chgData name="Sameer G Joshi (DJPR)" userId="bd06337d-ce8c-4c34-b1d1-7fbf8f91b6eb" providerId="ADAL" clId="{B9B8FF69-58F3-48D8-9439-0B94E292364A}" dt="2021-06-15T02:09:44.399" v="2646" actId="1036"/>
          <ac:spMkLst>
            <pc:docMk/>
            <pc:sldMk cId="3253327431" sldId="266"/>
            <ac:spMk id="5" creationId="{69238EC4-59B3-4851-A3D6-B55D5FC3F117}"/>
          </ac:spMkLst>
        </pc:spChg>
        <pc:spChg chg="add del mod">
          <ac:chgData name="Sameer G Joshi (DJPR)" userId="bd06337d-ce8c-4c34-b1d1-7fbf8f91b6eb" providerId="ADAL" clId="{B9B8FF69-58F3-48D8-9439-0B94E292364A}" dt="2021-06-15T00:47:39.740" v="1114" actId="478"/>
          <ac:spMkLst>
            <pc:docMk/>
            <pc:sldMk cId="3253327431" sldId="266"/>
            <ac:spMk id="7" creationId="{2B041CD7-DC4F-4871-BCCC-81420C651E22}"/>
          </ac:spMkLst>
        </pc:spChg>
        <pc:spChg chg="add del mod">
          <ac:chgData name="Sameer G Joshi (DJPR)" userId="bd06337d-ce8c-4c34-b1d1-7fbf8f91b6eb" providerId="ADAL" clId="{B9B8FF69-58F3-48D8-9439-0B94E292364A}" dt="2021-06-15T00:47:39.740" v="1114" actId="478"/>
          <ac:spMkLst>
            <pc:docMk/>
            <pc:sldMk cId="3253327431" sldId="266"/>
            <ac:spMk id="8" creationId="{C4031B8A-600D-41D7-A455-F114BE2E3131}"/>
          </ac:spMkLst>
        </pc:spChg>
        <pc:spChg chg="add del mod">
          <ac:chgData name="Sameer G Joshi (DJPR)" userId="bd06337d-ce8c-4c34-b1d1-7fbf8f91b6eb" providerId="ADAL" clId="{B9B8FF69-58F3-48D8-9439-0B94E292364A}" dt="2021-06-15T00:47:39.740" v="1114" actId="478"/>
          <ac:spMkLst>
            <pc:docMk/>
            <pc:sldMk cId="3253327431" sldId="266"/>
            <ac:spMk id="9" creationId="{9B547447-99CE-4CA0-BC14-75E9115DF89E}"/>
          </ac:spMkLst>
        </pc:spChg>
        <pc:spChg chg="add del mod">
          <ac:chgData name="Sameer G Joshi (DJPR)" userId="bd06337d-ce8c-4c34-b1d1-7fbf8f91b6eb" providerId="ADAL" clId="{B9B8FF69-58F3-48D8-9439-0B94E292364A}" dt="2021-06-15T00:47:39.740" v="1114" actId="478"/>
          <ac:spMkLst>
            <pc:docMk/>
            <pc:sldMk cId="3253327431" sldId="266"/>
            <ac:spMk id="10" creationId="{F4191AD8-D4C0-4D34-8752-B87BE7C2CB7F}"/>
          </ac:spMkLst>
        </pc:spChg>
        <pc:spChg chg="add del mod">
          <ac:chgData name="Sameer G Joshi (DJPR)" userId="bd06337d-ce8c-4c34-b1d1-7fbf8f91b6eb" providerId="ADAL" clId="{B9B8FF69-58F3-48D8-9439-0B94E292364A}" dt="2021-06-15T00:47:39.740" v="1114" actId="478"/>
          <ac:spMkLst>
            <pc:docMk/>
            <pc:sldMk cId="3253327431" sldId="266"/>
            <ac:spMk id="11" creationId="{54DE6437-0EF0-44AB-B5B3-310DCE759B0D}"/>
          </ac:spMkLst>
        </pc:spChg>
        <pc:spChg chg="add del mod">
          <ac:chgData name="Sameer G Joshi (DJPR)" userId="bd06337d-ce8c-4c34-b1d1-7fbf8f91b6eb" providerId="ADAL" clId="{B9B8FF69-58F3-48D8-9439-0B94E292364A}" dt="2021-06-15T00:47:39.740" v="1114" actId="478"/>
          <ac:spMkLst>
            <pc:docMk/>
            <pc:sldMk cId="3253327431" sldId="266"/>
            <ac:spMk id="12" creationId="{5E8DDD2B-DDF2-47D2-BD52-BDFCAD0B62FA}"/>
          </ac:spMkLst>
        </pc:spChg>
        <pc:spChg chg="add del mod">
          <ac:chgData name="Sameer G Joshi (DJPR)" userId="bd06337d-ce8c-4c34-b1d1-7fbf8f91b6eb" providerId="ADAL" clId="{B9B8FF69-58F3-48D8-9439-0B94E292364A}" dt="2021-06-15T00:47:39.740" v="1114" actId="478"/>
          <ac:spMkLst>
            <pc:docMk/>
            <pc:sldMk cId="3253327431" sldId="266"/>
            <ac:spMk id="13" creationId="{294F0983-76A1-4DA1-B3CD-363C218271FB}"/>
          </ac:spMkLst>
        </pc:spChg>
        <pc:spChg chg="add del mod">
          <ac:chgData name="Sameer G Joshi (DJPR)" userId="bd06337d-ce8c-4c34-b1d1-7fbf8f91b6eb" providerId="ADAL" clId="{B9B8FF69-58F3-48D8-9439-0B94E292364A}" dt="2021-06-15T00:47:39.740" v="1114" actId="478"/>
          <ac:spMkLst>
            <pc:docMk/>
            <pc:sldMk cId="3253327431" sldId="266"/>
            <ac:spMk id="14" creationId="{76338E50-6253-4821-B79C-30D1F2EB3B26}"/>
          </ac:spMkLst>
        </pc:spChg>
        <pc:spChg chg="add del mod">
          <ac:chgData name="Sameer G Joshi (DJPR)" userId="bd06337d-ce8c-4c34-b1d1-7fbf8f91b6eb" providerId="ADAL" clId="{B9B8FF69-58F3-48D8-9439-0B94E292364A}" dt="2021-06-15T00:47:39.740" v="1114" actId="478"/>
          <ac:spMkLst>
            <pc:docMk/>
            <pc:sldMk cId="3253327431" sldId="266"/>
            <ac:spMk id="15" creationId="{08ADAB69-D8C8-4EAC-9F25-38B857B39C3F}"/>
          </ac:spMkLst>
        </pc:spChg>
        <pc:spChg chg="add del mod">
          <ac:chgData name="Sameer G Joshi (DJPR)" userId="bd06337d-ce8c-4c34-b1d1-7fbf8f91b6eb" providerId="ADAL" clId="{B9B8FF69-58F3-48D8-9439-0B94E292364A}" dt="2021-06-15T00:47:39.740" v="1114" actId="478"/>
          <ac:spMkLst>
            <pc:docMk/>
            <pc:sldMk cId="3253327431" sldId="266"/>
            <ac:spMk id="16" creationId="{3F00EFA9-B04F-4D94-9FCF-2C0C61C2C02C}"/>
          </ac:spMkLst>
        </pc:spChg>
        <pc:spChg chg="add del mod">
          <ac:chgData name="Sameer G Joshi (DJPR)" userId="bd06337d-ce8c-4c34-b1d1-7fbf8f91b6eb" providerId="ADAL" clId="{B9B8FF69-58F3-48D8-9439-0B94E292364A}" dt="2021-06-15T00:47:39.740" v="1114" actId="478"/>
          <ac:spMkLst>
            <pc:docMk/>
            <pc:sldMk cId="3253327431" sldId="266"/>
            <ac:spMk id="17" creationId="{FD220530-CB53-40AA-98C8-33BD1D073A7F}"/>
          </ac:spMkLst>
        </pc:spChg>
        <pc:spChg chg="add del mod">
          <ac:chgData name="Sameer G Joshi (DJPR)" userId="bd06337d-ce8c-4c34-b1d1-7fbf8f91b6eb" providerId="ADAL" clId="{B9B8FF69-58F3-48D8-9439-0B94E292364A}" dt="2021-06-15T00:47:39.740" v="1114" actId="478"/>
          <ac:spMkLst>
            <pc:docMk/>
            <pc:sldMk cId="3253327431" sldId="266"/>
            <ac:spMk id="18" creationId="{71CFEE41-9E97-4272-8F79-F4250B7AED28}"/>
          </ac:spMkLst>
        </pc:spChg>
        <pc:spChg chg="add del mod">
          <ac:chgData name="Sameer G Joshi (DJPR)" userId="bd06337d-ce8c-4c34-b1d1-7fbf8f91b6eb" providerId="ADAL" clId="{B9B8FF69-58F3-48D8-9439-0B94E292364A}" dt="2021-06-15T00:47:39.740" v="1114" actId="478"/>
          <ac:spMkLst>
            <pc:docMk/>
            <pc:sldMk cId="3253327431" sldId="266"/>
            <ac:spMk id="19" creationId="{1F89E899-5A5E-40AB-8D09-E8D674FE46E2}"/>
          </ac:spMkLst>
        </pc:spChg>
        <pc:spChg chg="add del mod">
          <ac:chgData name="Sameer G Joshi (DJPR)" userId="bd06337d-ce8c-4c34-b1d1-7fbf8f91b6eb" providerId="ADAL" clId="{B9B8FF69-58F3-48D8-9439-0B94E292364A}" dt="2021-06-15T00:47:39.740" v="1114" actId="478"/>
          <ac:spMkLst>
            <pc:docMk/>
            <pc:sldMk cId="3253327431" sldId="266"/>
            <ac:spMk id="20" creationId="{71F3ACE8-C7CC-4CFC-9264-F5C2049FC983}"/>
          </ac:spMkLst>
        </pc:spChg>
        <pc:spChg chg="add del mod">
          <ac:chgData name="Sameer G Joshi (DJPR)" userId="bd06337d-ce8c-4c34-b1d1-7fbf8f91b6eb" providerId="ADAL" clId="{B9B8FF69-58F3-48D8-9439-0B94E292364A}" dt="2021-06-15T00:47:39.740" v="1114" actId="478"/>
          <ac:spMkLst>
            <pc:docMk/>
            <pc:sldMk cId="3253327431" sldId="266"/>
            <ac:spMk id="21" creationId="{4E2081D9-20A8-459F-A808-8EDCA302CBED}"/>
          </ac:spMkLst>
        </pc:spChg>
        <pc:spChg chg="add del mod">
          <ac:chgData name="Sameer G Joshi (DJPR)" userId="bd06337d-ce8c-4c34-b1d1-7fbf8f91b6eb" providerId="ADAL" clId="{B9B8FF69-58F3-48D8-9439-0B94E292364A}" dt="2021-06-15T00:47:39.740" v="1114" actId="478"/>
          <ac:spMkLst>
            <pc:docMk/>
            <pc:sldMk cId="3253327431" sldId="266"/>
            <ac:spMk id="22" creationId="{1D7F282D-901B-4EDB-A0E5-2EEBAA2A17F1}"/>
          </ac:spMkLst>
        </pc:spChg>
        <pc:spChg chg="add mod">
          <ac:chgData name="Sameer G Joshi (DJPR)" userId="bd06337d-ce8c-4c34-b1d1-7fbf8f91b6eb" providerId="ADAL" clId="{B9B8FF69-58F3-48D8-9439-0B94E292364A}" dt="2021-06-15T02:41:11.482" v="3357" actId="14100"/>
          <ac:spMkLst>
            <pc:docMk/>
            <pc:sldMk cId="3253327431" sldId="266"/>
            <ac:spMk id="23" creationId="{3DFF5369-E9DD-48D6-AFF8-14B03C75F19C}"/>
          </ac:spMkLst>
        </pc:spChg>
        <pc:spChg chg="add mod">
          <ac:chgData name="Sameer G Joshi (DJPR)" userId="bd06337d-ce8c-4c34-b1d1-7fbf8f91b6eb" providerId="ADAL" clId="{B9B8FF69-58F3-48D8-9439-0B94E292364A}" dt="2021-06-15T02:09:44.399" v="2646" actId="1036"/>
          <ac:spMkLst>
            <pc:docMk/>
            <pc:sldMk cId="3253327431" sldId="266"/>
            <ac:spMk id="24" creationId="{4F720097-A45A-4CDA-ABA7-C7176C6B6310}"/>
          </ac:spMkLst>
        </pc:spChg>
        <pc:spChg chg="add mod">
          <ac:chgData name="Sameer G Joshi (DJPR)" userId="bd06337d-ce8c-4c34-b1d1-7fbf8f91b6eb" providerId="ADAL" clId="{B9B8FF69-58F3-48D8-9439-0B94E292364A}" dt="2021-06-15T02:09:44.399" v="2646" actId="1036"/>
          <ac:spMkLst>
            <pc:docMk/>
            <pc:sldMk cId="3253327431" sldId="266"/>
            <ac:spMk id="25" creationId="{C46B61B1-F872-494A-AF6B-1D242C9C2766}"/>
          </ac:spMkLst>
        </pc:spChg>
        <pc:spChg chg="add mod">
          <ac:chgData name="Sameer G Joshi (DJPR)" userId="bd06337d-ce8c-4c34-b1d1-7fbf8f91b6eb" providerId="ADAL" clId="{B9B8FF69-58F3-48D8-9439-0B94E292364A}" dt="2021-06-15T02:09:44.399" v="2646" actId="1036"/>
          <ac:spMkLst>
            <pc:docMk/>
            <pc:sldMk cId="3253327431" sldId="266"/>
            <ac:spMk id="26" creationId="{1E54B7B7-123B-4093-B8C1-6E9B4F22419F}"/>
          </ac:spMkLst>
        </pc:spChg>
        <pc:spChg chg="add mod">
          <ac:chgData name="Sameer G Joshi (DJPR)" userId="bd06337d-ce8c-4c34-b1d1-7fbf8f91b6eb" providerId="ADAL" clId="{B9B8FF69-58F3-48D8-9439-0B94E292364A}" dt="2021-06-15T02:09:44.399" v="2646" actId="1036"/>
          <ac:spMkLst>
            <pc:docMk/>
            <pc:sldMk cId="3253327431" sldId="266"/>
            <ac:spMk id="27" creationId="{650F07B4-B560-44B2-9BD3-B5893FD1EEA2}"/>
          </ac:spMkLst>
        </pc:spChg>
        <pc:spChg chg="add mod">
          <ac:chgData name="Sameer G Joshi (DJPR)" userId="bd06337d-ce8c-4c34-b1d1-7fbf8f91b6eb" providerId="ADAL" clId="{B9B8FF69-58F3-48D8-9439-0B94E292364A}" dt="2021-06-15T02:09:44.399" v="2646" actId="1036"/>
          <ac:spMkLst>
            <pc:docMk/>
            <pc:sldMk cId="3253327431" sldId="266"/>
            <ac:spMk id="28" creationId="{26B558CC-267A-400D-B48D-59C61709C702}"/>
          </ac:spMkLst>
        </pc:spChg>
        <pc:spChg chg="add mod">
          <ac:chgData name="Sameer G Joshi (DJPR)" userId="bd06337d-ce8c-4c34-b1d1-7fbf8f91b6eb" providerId="ADAL" clId="{B9B8FF69-58F3-48D8-9439-0B94E292364A}" dt="2021-06-15T02:09:44.399" v="2646" actId="1036"/>
          <ac:spMkLst>
            <pc:docMk/>
            <pc:sldMk cId="3253327431" sldId="266"/>
            <ac:spMk id="29" creationId="{F9036F89-5F94-4F86-B4CA-E98C94297E12}"/>
          </ac:spMkLst>
        </pc:spChg>
        <pc:spChg chg="add mod">
          <ac:chgData name="Sameer G Joshi (DJPR)" userId="bd06337d-ce8c-4c34-b1d1-7fbf8f91b6eb" providerId="ADAL" clId="{B9B8FF69-58F3-48D8-9439-0B94E292364A}" dt="2021-06-15T02:09:44.399" v="2646" actId="1036"/>
          <ac:spMkLst>
            <pc:docMk/>
            <pc:sldMk cId="3253327431" sldId="266"/>
            <ac:spMk id="30" creationId="{D71BDABE-0BA1-4219-B7D9-57799C09B69B}"/>
          </ac:spMkLst>
        </pc:spChg>
        <pc:spChg chg="add mod">
          <ac:chgData name="Sameer G Joshi (DJPR)" userId="bd06337d-ce8c-4c34-b1d1-7fbf8f91b6eb" providerId="ADAL" clId="{B9B8FF69-58F3-48D8-9439-0B94E292364A}" dt="2021-06-15T02:09:44.399" v="2646" actId="1036"/>
          <ac:spMkLst>
            <pc:docMk/>
            <pc:sldMk cId="3253327431" sldId="266"/>
            <ac:spMk id="31" creationId="{DB4415AF-6096-4B5B-ACF3-1264CE322978}"/>
          </ac:spMkLst>
        </pc:spChg>
        <pc:spChg chg="add mod">
          <ac:chgData name="Sameer G Joshi (DJPR)" userId="bd06337d-ce8c-4c34-b1d1-7fbf8f91b6eb" providerId="ADAL" clId="{B9B8FF69-58F3-48D8-9439-0B94E292364A}" dt="2021-06-15T02:09:44.399" v="2646" actId="1036"/>
          <ac:spMkLst>
            <pc:docMk/>
            <pc:sldMk cId="3253327431" sldId="266"/>
            <ac:spMk id="32" creationId="{1952E398-B3E7-4E67-96BB-85C75C744A32}"/>
          </ac:spMkLst>
        </pc:spChg>
        <pc:spChg chg="add mod">
          <ac:chgData name="Sameer G Joshi (DJPR)" userId="bd06337d-ce8c-4c34-b1d1-7fbf8f91b6eb" providerId="ADAL" clId="{B9B8FF69-58F3-48D8-9439-0B94E292364A}" dt="2021-06-15T02:09:44.399" v="2646" actId="1036"/>
          <ac:spMkLst>
            <pc:docMk/>
            <pc:sldMk cId="3253327431" sldId="266"/>
            <ac:spMk id="33" creationId="{90EBB9E1-EAE7-4F31-AC83-4C5A9788DDB3}"/>
          </ac:spMkLst>
        </pc:spChg>
        <pc:spChg chg="add mod">
          <ac:chgData name="Sameer G Joshi (DJPR)" userId="bd06337d-ce8c-4c34-b1d1-7fbf8f91b6eb" providerId="ADAL" clId="{B9B8FF69-58F3-48D8-9439-0B94E292364A}" dt="2021-06-15T02:09:44.399" v="2646" actId="1036"/>
          <ac:spMkLst>
            <pc:docMk/>
            <pc:sldMk cId="3253327431" sldId="266"/>
            <ac:spMk id="34" creationId="{265E5BE5-99EE-46B1-A376-B2D7EB44AE23}"/>
          </ac:spMkLst>
        </pc:spChg>
        <pc:spChg chg="add mod">
          <ac:chgData name="Sameer G Joshi (DJPR)" userId="bd06337d-ce8c-4c34-b1d1-7fbf8f91b6eb" providerId="ADAL" clId="{B9B8FF69-58F3-48D8-9439-0B94E292364A}" dt="2021-06-15T02:09:44.399" v="2646" actId="1036"/>
          <ac:spMkLst>
            <pc:docMk/>
            <pc:sldMk cId="3253327431" sldId="266"/>
            <ac:spMk id="35" creationId="{07E692E5-920A-48BC-83F8-A5186A3EBE4F}"/>
          </ac:spMkLst>
        </pc:spChg>
        <pc:spChg chg="add mod">
          <ac:chgData name="Sameer G Joshi (DJPR)" userId="bd06337d-ce8c-4c34-b1d1-7fbf8f91b6eb" providerId="ADAL" clId="{B9B8FF69-58F3-48D8-9439-0B94E292364A}" dt="2021-06-15T02:09:44.399" v="2646" actId="1036"/>
          <ac:spMkLst>
            <pc:docMk/>
            <pc:sldMk cId="3253327431" sldId="266"/>
            <ac:spMk id="36" creationId="{9CD1792E-7BF4-4398-8EBE-5C608A8D168C}"/>
          </ac:spMkLst>
        </pc:spChg>
        <pc:spChg chg="add mod">
          <ac:chgData name="Sameer G Joshi (DJPR)" userId="bd06337d-ce8c-4c34-b1d1-7fbf8f91b6eb" providerId="ADAL" clId="{B9B8FF69-58F3-48D8-9439-0B94E292364A}" dt="2021-06-15T02:09:44.399" v="2646" actId="1036"/>
          <ac:spMkLst>
            <pc:docMk/>
            <pc:sldMk cId="3253327431" sldId="266"/>
            <ac:spMk id="37" creationId="{A17D7775-F069-4A57-95A6-ED9A0FF43779}"/>
          </ac:spMkLst>
        </pc:spChg>
        <pc:spChg chg="add mod">
          <ac:chgData name="Sameer G Joshi (DJPR)" userId="bd06337d-ce8c-4c34-b1d1-7fbf8f91b6eb" providerId="ADAL" clId="{B9B8FF69-58F3-48D8-9439-0B94E292364A}" dt="2021-06-15T02:09:44.399" v="2646" actId="1036"/>
          <ac:spMkLst>
            <pc:docMk/>
            <pc:sldMk cId="3253327431" sldId="266"/>
            <ac:spMk id="38" creationId="{A8407A11-137B-4078-979E-023AB9771F7F}"/>
          </ac:spMkLst>
        </pc:spChg>
        <pc:spChg chg="add mod">
          <ac:chgData name="Sameer G Joshi (DJPR)" userId="bd06337d-ce8c-4c34-b1d1-7fbf8f91b6eb" providerId="ADAL" clId="{B9B8FF69-58F3-48D8-9439-0B94E292364A}" dt="2021-06-15T02:09:44.399" v="2646" actId="1036"/>
          <ac:spMkLst>
            <pc:docMk/>
            <pc:sldMk cId="3253327431" sldId="266"/>
            <ac:spMk id="39" creationId="{40F27AA9-C7EB-4CEB-8089-5A5C0EFC3879}"/>
          </ac:spMkLst>
        </pc:spChg>
        <pc:spChg chg="add mod">
          <ac:chgData name="Sameer G Joshi (DJPR)" userId="bd06337d-ce8c-4c34-b1d1-7fbf8f91b6eb" providerId="ADAL" clId="{B9B8FF69-58F3-48D8-9439-0B94E292364A}" dt="2021-06-15T02:09:44.399" v="2646" actId="1036"/>
          <ac:spMkLst>
            <pc:docMk/>
            <pc:sldMk cId="3253327431" sldId="266"/>
            <ac:spMk id="40" creationId="{95254748-4D82-4E8E-B13A-5EC4652A4C7C}"/>
          </ac:spMkLst>
        </pc:spChg>
        <pc:spChg chg="add mod">
          <ac:chgData name="Sameer G Joshi (DJPR)" userId="bd06337d-ce8c-4c34-b1d1-7fbf8f91b6eb" providerId="ADAL" clId="{B9B8FF69-58F3-48D8-9439-0B94E292364A}" dt="2021-06-15T02:09:44.399" v="2646" actId="1036"/>
          <ac:spMkLst>
            <pc:docMk/>
            <pc:sldMk cId="3253327431" sldId="266"/>
            <ac:spMk id="41" creationId="{4BF8F0A3-5BA9-452C-8391-7D1F7482DA85}"/>
          </ac:spMkLst>
        </pc:spChg>
        <pc:spChg chg="add mod">
          <ac:chgData name="Sameer G Joshi (DJPR)" userId="bd06337d-ce8c-4c34-b1d1-7fbf8f91b6eb" providerId="ADAL" clId="{B9B8FF69-58F3-48D8-9439-0B94E292364A}" dt="2021-06-15T02:09:44.399" v="2646" actId="1036"/>
          <ac:spMkLst>
            <pc:docMk/>
            <pc:sldMk cId="3253327431" sldId="266"/>
            <ac:spMk id="42" creationId="{8A857F65-CA73-4A68-A329-6AAADCC5A636}"/>
          </ac:spMkLst>
        </pc:spChg>
        <pc:spChg chg="add mod">
          <ac:chgData name="Sameer G Joshi (DJPR)" userId="bd06337d-ce8c-4c34-b1d1-7fbf8f91b6eb" providerId="ADAL" clId="{B9B8FF69-58F3-48D8-9439-0B94E292364A}" dt="2021-06-15T02:09:44.399" v="2646" actId="1036"/>
          <ac:spMkLst>
            <pc:docMk/>
            <pc:sldMk cId="3253327431" sldId="266"/>
            <ac:spMk id="44" creationId="{E779D197-D829-4C20-AFC3-CFAF41DE6490}"/>
          </ac:spMkLst>
        </pc:spChg>
        <pc:spChg chg="add mod">
          <ac:chgData name="Sameer G Joshi (DJPR)" userId="bd06337d-ce8c-4c34-b1d1-7fbf8f91b6eb" providerId="ADAL" clId="{B9B8FF69-58F3-48D8-9439-0B94E292364A}" dt="2021-06-15T02:09:44.399" v="2646" actId="1036"/>
          <ac:spMkLst>
            <pc:docMk/>
            <pc:sldMk cId="3253327431" sldId="266"/>
            <ac:spMk id="45" creationId="{B776AF74-27F7-4AE7-9FB4-14AF2FA44014}"/>
          </ac:spMkLst>
        </pc:spChg>
        <pc:spChg chg="add mod">
          <ac:chgData name="Sameer G Joshi (DJPR)" userId="bd06337d-ce8c-4c34-b1d1-7fbf8f91b6eb" providerId="ADAL" clId="{B9B8FF69-58F3-48D8-9439-0B94E292364A}" dt="2021-06-15T02:09:44.399" v="2646" actId="1036"/>
          <ac:spMkLst>
            <pc:docMk/>
            <pc:sldMk cId="3253327431" sldId="266"/>
            <ac:spMk id="46" creationId="{9446DA60-7BE4-4929-86F3-0DD0F0C85A6C}"/>
          </ac:spMkLst>
        </pc:spChg>
        <pc:spChg chg="add mod">
          <ac:chgData name="Sameer G Joshi (DJPR)" userId="bd06337d-ce8c-4c34-b1d1-7fbf8f91b6eb" providerId="ADAL" clId="{B9B8FF69-58F3-48D8-9439-0B94E292364A}" dt="2021-06-15T02:09:44.399" v="2646" actId="1036"/>
          <ac:spMkLst>
            <pc:docMk/>
            <pc:sldMk cId="3253327431" sldId="266"/>
            <ac:spMk id="47" creationId="{58598D9D-FF64-4D59-9BA5-0BA7BC3B11B0}"/>
          </ac:spMkLst>
        </pc:spChg>
        <pc:spChg chg="add mod">
          <ac:chgData name="Sameer G Joshi (DJPR)" userId="bd06337d-ce8c-4c34-b1d1-7fbf8f91b6eb" providerId="ADAL" clId="{B9B8FF69-58F3-48D8-9439-0B94E292364A}" dt="2021-06-15T02:28:17.604" v="3113" actId="6549"/>
          <ac:spMkLst>
            <pc:docMk/>
            <pc:sldMk cId="3253327431" sldId="266"/>
            <ac:spMk id="48" creationId="{06100C58-1A0B-49E1-8972-28A68BCAE230}"/>
          </ac:spMkLst>
        </pc:spChg>
        <pc:spChg chg="add mod">
          <ac:chgData name="Sameer G Joshi (DJPR)" userId="bd06337d-ce8c-4c34-b1d1-7fbf8f91b6eb" providerId="ADAL" clId="{B9B8FF69-58F3-48D8-9439-0B94E292364A}" dt="2021-06-15T02:10:16.149" v="2666" actId="12788"/>
          <ac:spMkLst>
            <pc:docMk/>
            <pc:sldMk cId="3253327431" sldId="266"/>
            <ac:spMk id="49" creationId="{CC68062E-6B46-4811-90FE-B8C150AD7D11}"/>
          </ac:spMkLst>
        </pc:spChg>
        <pc:spChg chg="add mod">
          <ac:chgData name="Sameer G Joshi (DJPR)" userId="bd06337d-ce8c-4c34-b1d1-7fbf8f91b6eb" providerId="ADAL" clId="{B9B8FF69-58F3-48D8-9439-0B94E292364A}" dt="2021-06-15T02:10:16.149" v="2666" actId="12788"/>
          <ac:spMkLst>
            <pc:docMk/>
            <pc:sldMk cId="3253327431" sldId="266"/>
            <ac:spMk id="50" creationId="{AD3D9B52-2A45-498B-A7C3-DE7E22A78F0E}"/>
          </ac:spMkLst>
        </pc:spChg>
        <pc:spChg chg="add mod">
          <ac:chgData name="Sameer G Joshi (DJPR)" userId="bd06337d-ce8c-4c34-b1d1-7fbf8f91b6eb" providerId="ADAL" clId="{B9B8FF69-58F3-48D8-9439-0B94E292364A}" dt="2021-06-15T02:40:52.380" v="3353" actId="1037"/>
          <ac:spMkLst>
            <pc:docMk/>
            <pc:sldMk cId="3253327431" sldId="266"/>
            <ac:spMk id="51" creationId="{E9C7DE87-FCE5-4B85-8DE3-17FAFB866BFE}"/>
          </ac:spMkLst>
        </pc:spChg>
        <pc:spChg chg="add mod">
          <ac:chgData name="Sameer G Joshi (DJPR)" userId="bd06337d-ce8c-4c34-b1d1-7fbf8f91b6eb" providerId="ADAL" clId="{B9B8FF69-58F3-48D8-9439-0B94E292364A}" dt="2021-06-15T02:40:46.388" v="3351" actId="113"/>
          <ac:spMkLst>
            <pc:docMk/>
            <pc:sldMk cId="3253327431" sldId="266"/>
            <ac:spMk id="52" creationId="{60C3E0AD-79A0-4B96-BF83-63FA6FB09CDD}"/>
          </ac:spMkLst>
        </pc:spChg>
        <pc:spChg chg="add mod">
          <ac:chgData name="Sameer G Joshi (DJPR)" userId="bd06337d-ce8c-4c34-b1d1-7fbf8f91b6eb" providerId="ADAL" clId="{B9B8FF69-58F3-48D8-9439-0B94E292364A}" dt="2021-06-15T02:40:46.388" v="3351" actId="113"/>
          <ac:spMkLst>
            <pc:docMk/>
            <pc:sldMk cId="3253327431" sldId="266"/>
            <ac:spMk id="53" creationId="{3A4DB749-DDB4-4BB3-9C24-7271C5CFAAE7}"/>
          </ac:spMkLst>
        </pc:spChg>
        <pc:spChg chg="add mod">
          <ac:chgData name="Sameer G Joshi (DJPR)" userId="bd06337d-ce8c-4c34-b1d1-7fbf8f91b6eb" providerId="ADAL" clId="{B9B8FF69-58F3-48D8-9439-0B94E292364A}" dt="2021-06-15T02:40:46.388" v="3351" actId="113"/>
          <ac:spMkLst>
            <pc:docMk/>
            <pc:sldMk cId="3253327431" sldId="266"/>
            <ac:spMk id="54" creationId="{2B42E743-7080-4C0E-9A95-1C512C06216C}"/>
          </ac:spMkLst>
        </pc:spChg>
        <pc:graphicFrameChg chg="add mod">
          <ac:chgData name="Sameer G Joshi (DJPR)" userId="bd06337d-ce8c-4c34-b1d1-7fbf8f91b6eb" providerId="ADAL" clId="{B9B8FF69-58F3-48D8-9439-0B94E292364A}" dt="2021-06-15T02:09:44.399" v="2646" actId="1036"/>
          <ac:graphicFrameMkLst>
            <pc:docMk/>
            <pc:sldMk cId="3253327431" sldId="266"/>
            <ac:graphicFrameMk id="4" creationId="{B4F142F7-E095-410F-AAEA-E0E9C20CB6F5}"/>
          </ac:graphicFrameMkLst>
        </pc:graphicFrameChg>
        <pc:graphicFrameChg chg="add mod">
          <ac:chgData name="Sameer G Joshi (DJPR)" userId="bd06337d-ce8c-4c34-b1d1-7fbf8f91b6eb" providerId="ADAL" clId="{B9B8FF69-58F3-48D8-9439-0B94E292364A}" dt="2021-06-15T02:09:44.399" v="2646" actId="1036"/>
          <ac:graphicFrameMkLst>
            <pc:docMk/>
            <pc:sldMk cId="3253327431" sldId="266"/>
            <ac:graphicFrameMk id="6" creationId="{2597846A-35A0-4DCD-9CD1-B2062105BED1}"/>
          </ac:graphicFrameMkLst>
        </pc:graphicFrameChg>
        <pc:cxnChg chg="add mod">
          <ac:chgData name="Sameer G Joshi (DJPR)" userId="bd06337d-ce8c-4c34-b1d1-7fbf8f91b6eb" providerId="ADAL" clId="{B9B8FF69-58F3-48D8-9439-0B94E292364A}" dt="2021-06-15T02:09:44.399" v="2646" actId="1036"/>
          <ac:cxnSpMkLst>
            <pc:docMk/>
            <pc:sldMk cId="3253327431" sldId="266"/>
            <ac:cxnSpMk id="43" creationId="{594413A3-59BF-4354-A5C2-125A9E72A625}"/>
          </ac:cxnSpMkLst>
        </pc:cxnChg>
      </pc:sldChg>
      <pc:sldChg chg="addSp delSp modSp new mod">
        <pc:chgData name="Sameer G Joshi (DJPR)" userId="bd06337d-ce8c-4c34-b1d1-7fbf8f91b6eb" providerId="ADAL" clId="{B9B8FF69-58F3-48D8-9439-0B94E292364A}" dt="2021-06-15T02:41:40.235" v="3362" actId="14100"/>
        <pc:sldMkLst>
          <pc:docMk/>
          <pc:sldMk cId="1068351154" sldId="267"/>
        </pc:sldMkLst>
        <pc:spChg chg="del">
          <ac:chgData name="Sameer G Joshi (DJPR)" userId="bd06337d-ce8c-4c34-b1d1-7fbf8f91b6eb" providerId="ADAL" clId="{B9B8FF69-58F3-48D8-9439-0B94E292364A}" dt="2021-06-15T01:00:28.224" v="1467" actId="478"/>
          <ac:spMkLst>
            <pc:docMk/>
            <pc:sldMk cId="1068351154" sldId="267"/>
            <ac:spMk id="2" creationId="{FAA66D59-2FC4-49AF-A93A-2AC2D5D61FBE}"/>
          </ac:spMkLst>
        </pc:spChg>
        <pc:spChg chg="del">
          <ac:chgData name="Sameer G Joshi (DJPR)" userId="bd06337d-ce8c-4c34-b1d1-7fbf8f91b6eb" providerId="ADAL" clId="{B9B8FF69-58F3-48D8-9439-0B94E292364A}" dt="2021-06-15T01:00:28.224" v="1467" actId="478"/>
          <ac:spMkLst>
            <pc:docMk/>
            <pc:sldMk cId="1068351154" sldId="267"/>
            <ac:spMk id="3" creationId="{A499D1D1-931D-427E-895E-DBDAB00D1A6D}"/>
          </ac:spMkLst>
        </pc:spChg>
        <pc:spChg chg="add mod">
          <ac:chgData name="Sameer G Joshi (DJPR)" userId="bd06337d-ce8c-4c34-b1d1-7fbf8f91b6eb" providerId="ADAL" clId="{B9B8FF69-58F3-48D8-9439-0B94E292364A}" dt="2021-06-15T01:04:35.866" v="1621" actId="1076"/>
          <ac:spMkLst>
            <pc:docMk/>
            <pc:sldMk cId="1068351154" sldId="267"/>
            <ac:spMk id="5" creationId="{CE9DE831-95AB-40C4-BCA2-95245D60333B}"/>
          </ac:spMkLst>
        </pc:spChg>
        <pc:spChg chg="add mod">
          <ac:chgData name="Sameer G Joshi (DJPR)" userId="bd06337d-ce8c-4c34-b1d1-7fbf8f91b6eb" providerId="ADAL" clId="{B9B8FF69-58F3-48D8-9439-0B94E292364A}" dt="2021-06-15T02:31:14.227" v="3116" actId="1076"/>
          <ac:spMkLst>
            <pc:docMk/>
            <pc:sldMk cId="1068351154" sldId="267"/>
            <ac:spMk id="7" creationId="{BF2EA55A-EFE4-43B0-8A6C-0F2DE6FEFAF5}"/>
          </ac:spMkLst>
        </pc:spChg>
        <pc:spChg chg="add mod">
          <ac:chgData name="Sameer G Joshi (DJPR)" userId="bd06337d-ce8c-4c34-b1d1-7fbf8f91b6eb" providerId="ADAL" clId="{B9B8FF69-58F3-48D8-9439-0B94E292364A}" dt="2021-06-15T02:31:18.907" v="3117" actId="1076"/>
          <ac:spMkLst>
            <pc:docMk/>
            <pc:sldMk cId="1068351154" sldId="267"/>
            <ac:spMk id="8" creationId="{6DA7E0A0-3E7B-4B17-82F0-69F6AB822B58}"/>
          </ac:spMkLst>
        </pc:spChg>
        <pc:spChg chg="add mod">
          <ac:chgData name="Sameer G Joshi (DJPR)" userId="bd06337d-ce8c-4c34-b1d1-7fbf8f91b6eb" providerId="ADAL" clId="{B9B8FF69-58F3-48D8-9439-0B94E292364A}" dt="2021-06-15T02:11:01.242" v="2696" actId="1036"/>
          <ac:spMkLst>
            <pc:docMk/>
            <pc:sldMk cId="1068351154" sldId="267"/>
            <ac:spMk id="10" creationId="{8F702178-ED62-4188-B3E4-6ABE3D9C1789}"/>
          </ac:spMkLst>
        </pc:spChg>
        <pc:spChg chg="add mod">
          <ac:chgData name="Sameer G Joshi (DJPR)" userId="bd06337d-ce8c-4c34-b1d1-7fbf8f91b6eb" providerId="ADAL" clId="{B9B8FF69-58F3-48D8-9439-0B94E292364A}" dt="2021-06-15T02:11:01.242" v="2696" actId="1036"/>
          <ac:spMkLst>
            <pc:docMk/>
            <pc:sldMk cId="1068351154" sldId="267"/>
            <ac:spMk id="11" creationId="{E3DD3BB5-97AC-47BD-80D4-7459C1EB0E2F}"/>
          </ac:spMkLst>
        </pc:spChg>
        <pc:spChg chg="add mod">
          <ac:chgData name="Sameer G Joshi (DJPR)" userId="bd06337d-ce8c-4c34-b1d1-7fbf8f91b6eb" providerId="ADAL" clId="{B9B8FF69-58F3-48D8-9439-0B94E292364A}" dt="2021-06-15T02:11:01.242" v="2696" actId="1036"/>
          <ac:spMkLst>
            <pc:docMk/>
            <pc:sldMk cId="1068351154" sldId="267"/>
            <ac:spMk id="12" creationId="{80D9527D-1293-4E66-B873-960B9C1E8445}"/>
          </ac:spMkLst>
        </pc:spChg>
        <pc:spChg chg="add mod">
          <ac:chgData name="Sameer G Joshi (DJPR)" userId="bd06337d-ce8c-4c34-b1d1-7fbf8f91b6eb" providerId="ADAL" clId="{B9B8FF69-58F3-48D8-9439-0B94E292364A}" dt="2021-06-15T02:11:01.242" v="2696" actId="1036"/>
          <ac:spMkLst>
            <pc:docMk/>
            <pc:sldMk cId="1068351154" sldId="267"/>
            <ac:spMk id="13" creationId="{73AC9B00-27FB-4BCE-9203-87900FB7E6ED}"/>
          </ac:spMkLst>
        </pc:spChg>
        <pc:spChg chg="add mod">
          <ac:chgData name="Sameer G Joshi (DJPR)" userId="bd06337d-ce8c-4c34-b1d1-7fbf8f91b6eb" providerId="ADAL" clId="{B9B8FF69-58F3-48D8-9439-0B94E292364A}" dt="2021-06-15T02:11:01.242" v="2696" actId="1036"/>
          <ac:spMkLst>
            <pc:docMk/>
            <pc:sldMk cId="1068351154" sldId="267"/>
            <ac:spMk id="14" creationId="{0F02B6B4-69A4-4347-8CA9-461C9CEB8AAA}"/>
          </ac:spMkLst>
        </pc:spChg>
        <pc:spChg chg="add mod">
          <ac:chgData name="Sameer G Joshi (DJPR)" userId="bd06337d-ce8c-4c34-b1d1-7fbf8f91b6eb" providerId="ADAL" clId="{B9B8FF69-58F3-48D8-9439-0B94E292364A}" dt="2021-06-15T02:11:01.242" v="2696" actId="1036"/>
          <ac:spMkLst>
            <pc:docMk/>
            <pc:sldMk cId="1068351154" sldId="267"/>
            <ac:spMk id="15" creationId="{9833B40E-9A19-47D8-B618-6C121B9EC188}"/>
          </ac:spMkLst>
        </pc:spChg>
        <pc:spChg chg="add mod">
          <ac:chgData name="Sameer G Joshi (DJPR)" userId="bd06337d-ce8c-4c34-b1d1-7fbf8f91b6eb" providerId="ADAL" clId="{B9B8FF69-58F3-48D8-9439-0B94E292364A}" dt="2021-06-15T02:11:01.242" v="2696" actId="1036"/>
          <ac:spMkLst>
            <pc:docMk/>
            <pc:sldMk cId="1068351154" sldId="267"/>
            <ac:spMk id="16" creationId="{2662E484-7BF4-4618-8766-D256CD594D46}"/>
          </ac:spMkLst>
        </pc:spChg>
        <pc:spChg chg="add mod">
          <ac:chgData name="Sameer G Joshi (DJPR)" userId="bd06337d-ce8c-4c34-b1d1-7fbf8f91b6eb" providerId="ADAL" clId="{B9B8FF69-58F3-48D8-9439-0B94E292364A}" dt="2021-06-15T02:11:01.242" v="2696" actId="1036"/>
          <ac:spMkLst>
            <pc:docMk/>
            <pc:sldMk cId="1068351154" sldId="267"/>
            <ac:spMk id="17" creationId="{E0D8CE18-B762-4D16-A410-CF00EE605BA3}"/>
          </ac:spMkLst>
        </pc:spChg>
        <pc:spChg chg="add mod">
          <ac:chgData name="Sameer G Joshi (DJPR)" userId="bd06337d-ce8c-4c34-b1d1-7fbf8f91b6eb" providerId="ADAL" clId="{B9B8FF69-58F3-48D8-9439-0B94E292364A}" dt="2021-06-15T02:11:01.242" v="2696" actId="1036"/>
          <ac:spMkLst>
            <pc:docMk/>
            <pc:sldMk cId="1068351154" sldId="267"/>
            <ac:spMk id="18" creationId="{1D6DB7A4-15CA-4786-AA6B-78AEBC93EF41}"/>
          </ac:spMkLst>
        </pc:spChg>
        <pc:spChg chg="add mod">
          <ac:chgData name="Sameer G Joshi (DJPR)" userId="bd06337d-ce8c-4c34-b1d1-7fbf8f91b6eb" providerId="ADAL" clId="{B9B8FF69-58F3-48D8-9439-0B94E292364A}" dt="2021-06-15T02:11:01.242" v="2696" actId="1036"/>
          <ac:spMkLst>
            <pc:docMk/>
            <pc:sldMk cId="1068351154" sldId="267"/>
            <ac:spMk id="19" creationId="{ABDD93B1-D909-4B4D-8B95-26B1A5CCF7CE}"/>
          </ac:spMkLst>
        </pc:spChg>
        <pc:spChg chg="add mod">
          <ac:chgData name="Sameer G Joshi (DJPR)" userId="bd06337d-ce8c-4c34-b1d1-7fbf8f91b6eb" providerId="ADAL" clId="{B9B8FF69-58F3-48D8-9439-0B94E292364A}" dt="2021-06-15T02:11:01.242" v="2696" actId="1036"/>
          <ac:spMkLst>
            <pc:docMk/>
            <pc:sldMk cId="1068351154" sldId="267"/>
            <ac:spMk id="20" creationId="{0E79331F-DB80-4BA9-8CBE-85E21B199F01}"/>
          </ac:spMkLst>
        </pc:spChg>
        <pc:spChg chg="add mod">
          <ac:chgData name="Sameer G Joshi (DJPR)" userId="bd06337d-ce8c-4c34-b1d1-7fbf8f91b6eb" providerId="ADAL" clId="{B9B8FF69-58F3-48D8-9439-0B94E292364A}" dt="2021-06-15T02:11:01.242" v="2696" actId="1036"/>
          <ac:spMkLst>
            <pc:docMk/>
            <pc:sldMk cId="1068351154" sldId="267"/>
            <ac:spMk id="21" creationId="{6B449CCD-49E3-4984-A649-126CCBBA22B0}"/>
          </ac:spMkLst>
        </pc:spChg>
        <pc:spChg chg="add mod">
          <ac:chgData name="Sameer G Joshi (DJPR)" userId="bd06337d-ce8c-4c34-b1d1-7fbf8f91b6eb" providerId="ADAL" clId="{B9B8FF69-58F3-48D8-9439-0B94E292364A}" dt="2021-06-15T02:11:01.242" v="2696" actId="1036"/>
          <ac:spMkLst>
            <pc:docMk/>
            <pc:sldMk cId="1068351154" sldId="267"/>
            <ac:spMk id="22" creationId="{0531FD1B-AE1B-4604-92B7-F85B514C9913}"/>
          </ac:spMkLst>
        </pc:spChg>
        <pc:spChg chg="add mod">
          <ac:chgData name="Sameer G Joshi (DJPR)" userId="bd06337d-ce8c-4c34-b1d1-7fbf8f91b6eb" providerId="ADAL" clId="{B9B8FF69-58F3-48D8-9439-0B94E292364A}" dt="2021-06-15T02:11:01.242" v="2696" actId="1036"/>
          <ac:spMkLst>
            <pc:docMk/>
            <pc:sldMk cId="1068351154" sldId="267"/>
            <ac:spMk id="23" creationId="{26104DE7-6089-4DDF-A69D-091AEE22B19A}"/>
          </ac:spMkLst>
        </pc:spChg>
        <pc:spChg chg="add mod">
          <ac:chgData name="Sameer G Joshi (DJPR)" userId="bd06337d-ce8c-4c34-b1d1-7fbf8f91b6eb" providerId="ADAL" clId="{B9B8FF69-58F3-48D8-9439-0B94E292364A}" dt="2021-06-15T02:11:01.242" v="2696" actId="1036"/>
          <ac:spMkLst>
            <pc:docMk/>
            <pc:sldMk cId="1068351154" sldId="267"/>
            <ac:spMk id="24" creationId="{7E387B03-B759-40F2-BC74-39A135F571C9}"/>
          </ac:spMkLst>
        </pc:spChg>
        <pc:spChg chg="add mod">
          <ac:chgData name="Sameer G Joshi (DJPR)" userId="bd06337d-ce8c-4c34-b1d1-7fbf8f91b6eb" providerId="ADAL" clId="{B9B8FF69-58F3-48D8-9439-0B94E292364A}" dt="2021-06-15T02:11:01.242" v="2696" actId="1036"/>
          <ac:spMkLst>
            <pc:docMk/>
            <pc:sldMk cId="1068351154" sldId="267"/>
            <ac:spMk id="25" creationId="{1D5F5816-AE5B-4FBF-AAA4-AA9B9313B3E9}"/>
          </ac:spMkLst>
        </pc:spChg>
        <pc:spChg chg="add mod">
          <ac:chgData name="Sameer G Joshi (DJPR)" userId="bd06337d-ce8c-4c34-b1d1-7fbf8f91b6eb" providerId="ADAL" clId="{B9B8FF69-58F3-48D8-9439-0B94E292364A}" dt="2021-06-15T02:11:01.242" v="2696" actId="1036"/>
          <ac:spMkLst>
            <pc:docMk/>
            <pc:sldMk cId="1068351154" sldId="267"/>
            <ac:spMk id="27" creationId="{BFC6561F-D021-49C5-A874-0E33501DD689}"/>
          </ac:spMkLst>
        </pc:spChg>
        <pc:spChg chg="add del mod">
          <ac:chgData name="Sameer G Joshi (DJPR)" userId="bd06337d-ce8c-4c34-b1d1-7fbf8f91b6eb" providerId="ADAL" clId="{B9B8FF69-58F3-48D8-9439-0B94E292364A}" dt="2021-06-15T01:14:25.474" v="1897" actId="478"/>
          <ac:spMkLst>
            <pc:docMk/>
            <pc:sldMk cId="1068351154" sldId="267"/>
            <ac:spMk id="30" creationId="{10318FEF-B047-4D0D-8E2E-A2EB9E1AB38B}"/>
          </ac:spMkLst>
        </pc:spChg>
        <pc:spChg chg="add del mod">
          <ac:chgData name="Sameer G Joshi (DJPR)" userId="bd06337d-ce8c-4c34-b1d1-7fbf8f91b6eb" providerId="ADAL" clId="{B9B8FF69-58F3-48D8-9439-0B94E292364A}" dt="2021-06-15T01:14:23.476" v="1896" actId="478"/>
          <ac:spMkLst>
            <pc:docMk/>
            <pc:sldMk cId="1068351154" sldId="267"/>
            <ac:spMk id="31" creationId="{3605DF72-C509-4D7E-97CA-1F2EE4157CF0}"/>
          </ac:spMkLst>
        </pc:spChg>
        <pc:spChg chg="add del mod">
          <ac:chgData name="Sameer G Joshi (DJPR)" userId="bd06337d-ce8c-4c34-b1d1-7fbf8f91b6eb" providerId="ADAL" clId="{B9B8FF69-58F3-48D8-9439-0B94E292364A}" dt="2021-06-15T01:14:21.942" v="1895" actId="478"/>
          <ac:spMkLst>
            <pc:docMk/>
            <pc:sldMk cId="1068351154" sldId="267"/>
            <ac:spMk id="32" creationId="{AAA2C303-C54E-4F1A-A5F7-C77DC2E5F72C}"/>
          </ac:spMkLst>
        </pc:spChg>
        <pc:spChg chg="add del mod">
          <ac:chgData name="Sameer G Joshi (DJPR)" userId="bd06337d-ce8c-4c34-b1d1-7fbf8f91b6eb" providerId="ADAL" clId="{B9B8FF69-58F3-48D8-9439-0B94E292364A}" dt="2021-06-15T01:14:19.929" v="1894" actId="478"/>
          <ac:spMkLst>
            <pc:docMk/>
            <pc:sldMk cId="1068351154" sldId="267"/>
            <ac:spMk id="33" creationId="{9C87F0B9-8E93-4975-A806-730DEAC30D8B}"/>
          </ac:spMkLst>
        </pc:spChg>
        <pc:spChg chg="add mod">
          <ac:chgData name="Sameer G Joshi (DJPR)" userId="bd06337d-ce8c-4c34-b1d1-7fbf8f91b6eb" providerId="ADAL" clId="{B9B8FF69-58F3-48D8-9439-0B94E292364A}" dt="2021-06-15T02:11:58.900" v="2699" actId="14100"/>
          <ac:spMkLst>
            <pc:docMk/>
            <pc:sldMk cId="1068351154" sldId="267"/>
            <ac:spMk id="34" creationId="{63637FE7-F2BB-49D2-AAD1-23FAE0B0D685}"/>
          </ac:spMkLst>
        </pc:spChg>
        <pc:spChg chg="add mod">
          <ac:chgData name="Sameer G Joshi (DJPR)" userId="bd06337d-ce8c-4c34-b1d1-7fbf8f91b6eb" providerId="ADAL" clId="{B9B8FF69-58F3-48D8-9439-0B94E292364A}" dt="2021-06-15T02:11:58.900" v="2699" actId="14100"/>
          <ac:spMkLst>
            <pc:docMk/>
            <pc:sldMk cId="1068351154" sldId="267"/>
            <ac:spMk id="35" creationId="{887F381B-0094-42F6-82A4-10779961DC2B}"/>
          </ac:spMkLst>
        </pc:spChg>
        <pc:spChg chg="add mod">
          <ac:chgData name="Sameer G Joshi (DJPR)" userId="bd06337d-ce8c-4c34-b1d1-7fbf8f91b6eb" providerId="ADAL" clId="{B9B8FF69-58F3-48D8-9439-0B94E292364A}" dt="2021-06-15T02:11:58.900" v="2699" actId="14100"/>
          <ac:spMkLst>
            <pc:docMk/>
            <pc:sldMk cId="1068351154" sldId="267"/>
            <ac:spMk id="39" creationId="{41E3C300-FC80-45F9-973F-BB0C6434EDF8}"/>
          </ac:spMkLst>
        </pc:spChg>
        <pc:spChg chg="add mod">
          <ac:chgData name="Sameer G Joshi (DJPR)" userId="bd06337d-ce8c-4c34-b1d1-7fbf8f91b6eb" providerId="ADAL" clId="{B9B8FF69-58F3-48D8-9439-0B94E292364A}" dt="2021-06-15T02:41:40.235" v="3362" actId="14100"/>
          <ac:spMkLst>
            <pc:docMk/>
            <pc:sldMk cId="1068351154" sldId="267"/>
            <ac:spMk id="40" creationId="{7805954D-7917-4416-B5EF-9AF9B6C529D5}"/>
          </ac:spMkLst>
        </pc:spChg>
        <pc:spChg chg="add mod">
          <ac:chgData name="Sameer G Joshi (DJPR)" userId="bd06337d-ce8c-4c34-b1d1-7fbf8f91b6eb" providerId="ADAL" clId="{B9B8FF69-58F3-48D8-9439-0B94E292364A}" dt="2021-06-15T01:45:02.024" v="2218" actId="1076"/>
          <ac:spMkLst>
            <pc:docMk/>
            <pc:sldMk cId="1068351154" sldId="267"/>
            <ac:spMk id="41" creationId="{8AC624DE-4325-4262-A409-4E1DC1D1DA6A}"/>
          </ac:spMkLst>
        </pc:spChg>
        <pc:spChg chg="add mod">
          <ac:chgData name="Sameer G Joshi (DJPR)" userId="bd06337d-ce8c-4c34-b1d1-7fbf8f91b6eb" providerId="ADAL" clId="{B9B8FF69-58F3-48D8-9439-0B94E292364A}" dt="2021-06-15T02:10:44.684" v="2683" actId="1036"/>
          <ac:spMkLst>
            <pc:docMk/>
            <pc:sldMk cId="1068351154" sldId="267"/>
            <ac:spMk id="42" creationId="{528AD286-8FDD-4F9D-9862-67A8135C6717}"/>
          </ac:spMkLst>
        </pc:spChg>
        <pc:spChg chg="add mod">
          <ac:chgData name="Sameer G Joshi (DJPR)" userId="bd06337d-ce8c-4c34-b1d1-7fbf8f91b6eb" providerId="ADAL" clId="{B9B8FF69-58F3-48D8-9439-0B94E292364A}" dt="2021-06-15T02:11:01.242" v="2696" actId="1036"/>
          <ac:spMkLst>
            <pc:docMk/>
            <pc:sldMk cId="1068351154" sldId="267"/>
            <ac:spMk id="43" creationId="{4DD99DC6-4541-41EA-8CB4-E8F9BDB4A658}"/>
          </ac:spMkLst>
        </pc:spChg>
        <pc:spChg chg="add mod">
          <ac:chgData name="Sameer G Joshi (DJPR)" userId="bd06337d-ce8c-4c34-b1d1-7fbf8f91b6eb" providerId="ADAL" clId="{B9B8FF69-58F3-48D8-9439-0B94E292364A}" dt="2021-06-15T02:11:19.513" v="2698" actId="12788"/>
          <ac:spMkLst>
            <pc:docMk/>
            <pc:sldMk cId="1068351154" sldId="267"/>
            <ac:spMk id="44" creationId="{247C204D-F387-4742-939E-8CA83CBE5355}"/>
          </ac:spMkLst>
        </pc:spChg>
        <pc:spChg chg="add mod">
          <ac:chgData name="Sameer G Joshi (DJPR)" userId="bd06337d-ce8c-4c34-b1d1-7fbf8f91b6eb" providerId="ADAL" clId="{B9B8FF69-58F3-48D8-9439-0B94E292364A}" dt="2021-06-15T02:11:19.513" v="2698" actId="12788"/>
          <ac:spMkLst>
            <pc:docMk/>
            <pc:sldMk cId="1068351154" sldId="267"/>
            <ac:spMk id="45" creationId="{CA4A7CBA-9303-4BB5-896F-DFF086E529B9}"/>
          </ac:spMkLst>
        </pc:spChg>
        <pc:spChg chg="add mod">
          <ac:chgData name="Sameer G Joshi (DJPR)" userId="bd06337d-ce8c-4c34-b1d1-7fbf8f91b6eb" providerId="ADAL" clId="{B9B8FF69-58F3-48D8-9439-0B94E292364A}" dt="2021-06-15T02:11:19.513" v="2698" actId="12788"/>
          <ac:spMkLst>
            <pc:docMk/>
            <pc:sldMk cId="1068351154" sldId="267"/>
            <ac:spMk id="46" creationId="{C8AA2B34-9019-41E4-9DA1-1771C6706B4B}"/>
          </ac:spMkLst>
        </pc:spChg>
        <pc:spChg chg="add mod">
          <ac:chgData name="Sameer G Joshi (DJPR)" userId="bd06337d-ce8c-4c34-b1d1-7fbf8f91b6eb" providerId="ADAL" clId="{B9B8FF69-58F3-48D8-9439-0B94E292364A}" dt="2021-06-15T02:41:28.157" v="3361" actId="1037"/>
          <ac:spMkLst>
            <pc:docMk/>
            <pc:sldMk cId="1068351154" sldId="267"/>
            <ac:spMk id="47" creationId="{E2DD1C9D-F865-441E-9DB5-A70AB1EB8976}"/>
          </ac:spMkLst>
        </pc:spChg>
        <pc:spChg chg="add mod">
          <ac:chgData name="Sameer G Joshi (DJPR)" userId="bd06337d-ce8c-4c34-b1d1-7fbf8f91b6eb" providerId="ADAL" clId="{B9B8FF69-58F3-48D8-9439-0B94E292364A}" dt="2021-06-15T02:41:21.527" v="3358" actId="113"/>
          <ac:spMkLst>
            <pc:docMk/>
            <pc:sldMk cId="1068351154" sldId="267"/>
            <ac:spMk id="48" creationId="{E5B8C49A-94D0-4BED-9917-B52D66E25F03}"/>
          </ac:spMkLst>
        </pc:spChg>
        <pc:spChg chg="add mod">
          <ac:chgData name="Sameer G Joshi (DJPR)" userId="bd06337d-ce8c-4c34-b1d1-7fbf8f91b6eb" providerId="ADAL" clId="{B9B8FF69-58F3-48D8-9439-0B94E292364A}" dt="2021-06-15T02:41:21.527" v="3358" actId="113"/>
          <ac:spMkLst>
            <pc:docMk/>
            <pc:sldMk cId="1068351154" sldId="267"/>
            <ac:spMk id="49" creationId="{FA0158E4-FF67-4810-B5AF-8C8FD8D8511A}"/>
          </ac:spMkLst>
        </pc:spChg>
        <pc:spChg chg="add mod">
          <ac:chgData name="Sameer G Joshi (DJPR)" userId="bd06337d-ce8c-4c34-b1d1-7fbf8f91b6eb" providerId="ADAL" clId="{B9B8FF69-58F3-48D8-9439-0B94E292364A}" dt="2021-06-15T02:41:21.527" v="3358" actId="113"/>
          <ac:spMkLst>
            <pc:docMk/>
            <pc:sldMk cId="1068351154" sldId="267"/>
            <ac:spMk id="50" creationId="{05EFC73D-A356-4FB2-887D-2B3C543C4263}"/>
          </ac:spMkLst>
        </pc:spChg>
        <pc:graphicFrameChg chg="add mod">
          <ac:chgData name="Sameer G Joshi (DJPR)" userId="bd06337d-ce8c-4c34-b1d1-7fbf8f91b6eb" providerId="ADAL" clId="{B9B8FF69-58F3-48D8-9439-0B94E292364A}" dt="2021-06-15T01:48:30.179" v="2284" actId="13822"/>
          <ac:graphicFrameMkLst>
            <pc:docMk/>
            <pc:sldMk cId="1068351154" sldId="267"/>
            <ac:graphicFrameMk id="4" creationId="{0C239B8B-09DC-47A1-8EFD-3AF724F16352}"/>
          </ac:graphicFrameMkLst>
        </pc:graphicFrameChg>
        <pc:graphicFrameChg chg="add del mod">
          <ac:chgData name="Sameer G Joshi (DJPR)" userId="bd06337d-ce8c-4c34-b1d1-7fbf8f91b6eb" providerId="ADAL" clId="{B9B8FF69-58F3-48D8-9439-0B94E292364A}" dt="2021-06-15T01:18:13.375" v="1907" actId="478"/>
          <ac:graphicFrameMkLst>
            <pc:docMk/>
            <pc:sldMk cId="1068351154" sldId="267"/>
            <ac:graphicFrameMk id="6" creationId="{DBC89C2B-E182-40D2-8AB9-09BC712F90E6}"/>
          </ac:graphicFrameMkLst>
        </pc:graphicFrameChg>
        <pc:graphicFrameChg chg="add mod">
          <ac:chgData name="Sameer G Joshi (DJPR)" userId="bd06337d-ce8c-4c34-b1d1-7fbf8f91b6eb" providerId="ADAL" clId="{B9B8FF69-58F3-48D8-9439-0B94E292364A}" dt="2021-06-15T02:11:01.242" v="2696" actId="1036"/>
          <ac:graphicFrameMkLst>
            <pc:docMk/>
            <pc:sldMk cId="1068351154" sldId="267"/>
            <ac:graphicFrameMk id="9" creationId="{7C95EF75-3FFD-4498-9F0E-DC130A699839}"/>
          </ac:graphicFrameMkLst>
        </pc:graphicFrameChg>
        <pc:graphicFrameChg chg="add del mod">
          <ac:chgData name="Sameer G Joshi (DJPR)" userId="bd06337d-ce8c-4c34-b1d1-7fbf8f91b6eb" providerId="ADAL" clId="{B9B8FF69-58F3-48D8-9439-0B94E292364A}" dt="2021-06-15T01:19:18.823" v="1916" actId="478"/>
          <ac:graphicFrameMkLst>
            <pc:docMk/>
            <pc:sldMk cId="1068351154" sldId="267"/>
            <ac:graphicFrameMk id="36" creationId="{DBC89C2B-E182-40D2-8AB9-09BC712F90E6}"/>
          </ac:graphicFrameMkLst>
        </pc:graphicFrameChg>
        <pc:graphicFrameChg chg="add del mod">
          <ac:chgData name="Sameer G Joshi (DJPR)" userId="bd06337d-ce8c-4c34-b1d1-7fbf8f91b6eb" providerId="ADAL" clId="{B9B8FF69-58F3-48D8-9439-0B94E292364A}" dt="2021-06-15T01:23:29.372" v="2022" actId="478"/>
          <ac:graphicFrameMkLst>
            <pc:docMk/>
            <pc:sldMk cId="1068351154" sldId="267"/>
            <ac:graphicFrameMk id="37" creationId="{DBC89C2B-E182-40D2-8AB9-09BC712F90E6}"/>
          </ac:graphicFrameMkLst>
        </pc:graphicFrameChg>
        <pc:graphicFrameChg chg="add mod">
          <ac:chgData name="Sameer G Joshi (DJPR)" userId="bd06337d-ce8c-4c34-b1d1-7fbf8f91b6eb" providerId="ADAL" clId="{B9B8FF69-58F3-48D8-9439-0B94E292364A}" dt="2021-06-15T02:10:44.684" v="2683" actId="1036"/>
          <ac:graphicFrameMkLst>
            <pc:docMk/>
            <pc:sldMk cId="1068351154" sldId="267"/>
            <ac:graphicFrameMk id="38" creationId="{DBC89C2B-E182-40D2-8AB9-09BC712F90E6}"/>
          </ac:graphicFrameMkLst>
        </pc:graphicFrameChg>
        <pc:cxnChg chg="add mod">
          <ac:chgData name="Sameer G Joshi (DJPR)" userId="bd06337d-ce8c-4c34-b1d1-7fbf8f91b6eb" providerId="ADAL" clId="{B9B8FF69-58F3-48D8-9439-0B94E292364A}" dt="2021-06-15T02:11:01.242" v="2696" actId="1036"/>
          <ac:cxnSpMkLst>
            <pc:docMk/>
            <pc:sldMk cId="1068351154" sldId="267"/>
            <ac:cxnSpMk id="26" creationId="{17012415-C847-4533-A0E4-8F2EA6A9CBD1}"/>
          </ac:cxnSpMkLst>
        </pc:cxnChg>
      </pc:sldChg>
      <pc:sldChg chg="addSp delSp modSp new mod">
        <pc:chgData name="Sameer G Joshi (DJPR)" userId="bd06337d-ce8c-4c34-b1d1-7fbf8f91b6eb" providerId="ADAL" clId="{B9B8FF69-58F3-48D8-9439-0B94E292364A}" dt="2021-06-15T05:18:39.532" v="3945" actId="14100"/>
        <pc:sldMkLst>
          <pc:docMk/>
          <pc:sldMk cId="2979161283" sldId="268"/>
        </pc:sldMkLst>
        <pc:spChg chg="del">
          <ac:chgData name="Sameer G Joshi (DJPR)" userId="bd06337d-ce8c-4c34-b1d1-7fbf8f91b6eb" providerId="ADAL" clId="{B9B8FF69-58F3-48D8-9439-0B94E292364A}" dt="2021-06-15T01:28:41.460" v="2142" actId="478"/>
          <ac:spMkLst>
            <pc:docMk/>
            <pc:sldMk cId="2979161283" sldId="268"/>
            <ac:spMk id="2" creationId="{40739E83-3CD5-4C99-8D62-D22E3D21BE26}"/>
          </ac:spMkLst>
        </pc:spChg>
        <pc:spChg chg="del">
          <ac:chgData name="Sameer G Joshi (DJPR)" userId="bd06337d-ce8c-4c34-b1d1-7fbf8f91b6eb" providerId="ADAL" clId="{B9B8FF69-58F3-48D8-9439-0B94E292364A}" dt="2021-06-15T01:28:41.460" v="2142" actId="478"/>
          <ac:spMkLst>
            <pc:docMk/>
            <pc:sldMk cId="2979161283" sldId="268"/>
            <ac:spMk id="3" creationId="{5D6E199C-2EC0-48CF-98F9-57F9D898A90A}"/>
          </ac:spMkLst>
        </pc:spChg>
        <pc:spChg chg="add mod">
          <ac:chgData name="Sameer G Joshi (DJPR)" userId="bd06337d-ce8c-4c34-b1d1-7fbf8f91b6eb" providerId="ADAL" clId="{B9B8FF69-58F3-48D8-9439-0B94E292364A}" dt="2021-06-15T01:45:56.355" v="2234" actId="1036"/>
          <ac:spMkLst>
            <pc:docMk/>
            <pc:sldMk cId="2979161283" sldId="268"/>
            <ac:spMk id="6" creationId="{CA202E37-96BD-427E-B175-3BE8C8F8037A}"/>
          </ac:spMkLst>
        </pc:spChg>
        <pc:spChg chg="add mod">
          <ac:chgData name="Sameer G Joshi (DJPR)" userId="bd06337d-ce8c-4c34-b1d1-7fbf8f91b6eb" providerId="ADAL" clId="{B9B8FF69-58F3-48D8-9439-0B94E292364A}" dt="2021-06-15T01:45:56.355" v="2234" actId="1036"/>
          <ac:spMkLst>
            <pc:docMk/>
            <pc:sldMk cId="2979161283" sldId="268"/>
            <ac:spMk id="7" creationId="{160F0EE4-00BD-4C36-B867-7272062E708A}"/>
          </ac:spMkLst>
        </pc:spChg>
        <pc:spChg chg="add del mod">
          <ac:chgData name="Sameer G Joshi (DJPR)" userId="bd06337d-ce8c-4c34-b1d1-7fbf8f91b6eb" providerId="ADAL" clId="{B9B8FF69-58F3-48D8-9439-0B94E292364A}" dt="2021-06-15T01:41:45.611" v="2176"/>
          <ac:spMkLst>
            <pc:docMk/>
            <pc:sldMk cId="2979161283" sldId="268"/>
            <ac:spMk id="9" creationId="{81F407CE-0730-4434-9977-8DA6EECAED44}"/>
          </ac:spMkLst>
        </pc:spChg>
        <pc:spChg chg="add del mod">
          <ac:chgData name="Sameer G Joshi (DJPR)" userId="bd06337d-ce8c-4c34-b1d1-7fbf8f91b6eb" providerId="ADAL" clId="{B9B8FF69-58F3-48D8-9439-0B94E292364A}" dt="2021-06-15T01:41:45.611" v="2176"/>
          <ac:spMkLst>
            <pc:docMk/>
            <pc:sldMk cId="2979161283" sldId="268"/>
            <ac:spMk id="10" creationId="{251AEDE3-7B2B-452B-9396-73B101C9ED29}"/>
          </ac:spMkLst>
        </pc:spChg>
        <pc:spChg chg="add del mod">
          <ac:chgData name="Sameer G Joshi (DJPR)" userId="bd06337d-ce8c-4c34-b1d1-7fbf8f91b6eb" providerId="ADAL" clId="{B9B8FF69-58F3-48D8-9439-0B94E292364A}" dt="2021-06-15T01:41:45.611" v="2176"/>
          <ac:spMkLst>
            <pc:docMk/>
            <pc:sldMk cId="2979161283" sldId="268"/>
            <ac:spMk id="11" creationId="{91102152-22C0-412C-9D9F-8D8860D901BD}"/>
          </ac:spMkLst>
        </pc:spChg>
        <pc:spChg chg="add del mod">
          <ac:chgData name="Sameer G Joshi (DJPR)" userId="bd06337d-ce8c-4c34-b1d1-7fbf8f91b6eb" providerId="ADAL" clId="{B9B8FF69-58F3-48D8-9439-0B94E292364A}" dt="2021-06-15T01:41:45.611" v="2176"/>
          <ac:spMkLst>
            <pc:docMk/>
            <pc:sldMk cId="2979161283" sldId="268"/>
            <ac:spMk id="12" creationId="{08F3B561-3C33-428F-AC09-9257BDDF4F7A}"/>
          </ac:spMkLst>
        </pc:spChg>
        <pc:spChg chg="add mod">
          <ac:chgData name="Sameer G Joshi (DJPR)" userId="bd06337d-ce8c-4c34-b1d1-7fbf8f91b6eb" providerId="ADAL" clId="{B9B8FF69-58F3-48D8-9439-0B94E292364A}" dt="2021-06-15T02:46:25.668" v="3368" actId="1035"/>
          <ac:spMkLst>
            <pc:docMk/>
            <pc:sldMk cId="2979161283" sldId="268"/>
            <ac:spMk id="13" creationId="{3EED0205-D585-48C0-B4FD-187DD78D61D0}"/>
          </ac:spMkLst>
        </pc:spChg>
        <pc:spChg chg="add mod">
          <ac:chgData name="Sameer G Joshi (DJPR)" userId="bd06337d-ce8c-4c34-b1d1-7fbf8f91b6eb" providerId="ADAL" clId="{B9B8FF69-58F3-48D8-9439-0B94E292364A}" dt="2021-06-15T02:46:25.668" v="3368" actId="1035"/>
          <ac:spMkLst>
            <pc:docMk/>
            <pc:sldMk cId="2979161283" sldId="268"/>
            <ac:spMk id="14" creationId="{077B056F-2B4A-4CA9-945E-3CCE46E26E84}"/>
          </ac:spMkLst>
        </pc:spChg>
        <pc:spChg chg="add mod">
          <ac:chgData name="Sameer G Joshi (DJPR)" userId="bd06337d-ce8c-4c34-b1d1-7fbf8f91b6eb" providerId="ADAL" clId="{B9B8FF69-58F3-48D8-9439-0B94E292364A}" dt="2021-06-15T02:15:15.084" v="2821" actId="14100"/>
          <ac:spMkLst>
            <pc:docMk/>
            <pc:sldMk cId="2979161283" sldId="268"/>
            <ac:spMk id="15" creationId="{4923BC69-785F-45AB-973F-7A24E065C110}"/>
          </ac:spMkLst>
        </pc:spChg>
        <pc:spChg chg="add mod">
          <ac:chgData name="Sameer G Joshi (DJPR)" userId="bd06337d-ce8c-4c34-b1d1-7fbf8f91b6eb" providerId="ADAL" clId="{B9B8FF69-58F3-48D8-9439-0B94E292364A}" dt="2021-06-15T02:46:39.828" v="3369" actId="1036"/>
          <ac:spMkLst>
            <pc:docMk/>
            <pc:sldMk cId="2979161283" sldId="268"/>
            <ac:spMk id="16" creationId="{F22EF4D3-10FC-41FC-BD86-9DBF8013B311}"/>
          </ac:spMkLst>
        </pc:spChg>
        <pc:spChg chg="add mod">
          <ac:chgData name="Sameer G Joshi (DJPR)" userId="bd06337d-ce8c-4c34-b1d1-7fbf8f91b6eb" providerId="ADAL" clId="{B9B8FF69-58F3-48D8-9439-0B94E292364A}" dt="2021-06-15T01:45:56.355" v="2234" actId="1036"/>
          <ac:spMkLst>
            <pc:docMk/>
            <pc:sldMk cId="2979161283" sldId="268"/>
            <ac:spMk id="17" creationId="{E2AFD118-21B6-4607-9FD0-FB5D6979B100}"/>
          </ac:spMkLst>
        </pc:spChg>
        <pc:spChg chg="add mod">
          <ac:chgData name="Sameer G Joshi (DJPR)" userId="bd06337d-ce8c-4c34-b1d1-7fbf8f91b6eb" providerId="ADAL" clId="{B9B8FF69-58F3-48D8-9439-0B94E292364A}" dt="2021-06-15T01:45:56.355" v="2234" actId="1036"/>
          <ac:spMkLst>
            <pc:docMk/>
            <pc:sldMk cId="2979161283" sldId="268"/>
            <ac:spMk id="18" creationId="{8A15F008-D525-436F-8B0D-B772B228FCAA}"/>
          </ac:spMkLst>
        </pc:spChg>
        <pc:spChg chg="add mod">
          <ac:chgData name="Sameer G Joshi (DJPR)" userId="bd06337d-ce8c-4c34-b1d1-7fbf8f91b6eb" providerId="ADAL" clId="{B9B8FF69-58F3-48D8-9439-0B94E292364A}" dt="2021-06-15T01:46:32.661" v="2237" actId="1076"/>
          <ac:spMkLst>
            <pc:docMk/>
            <pc:sldMk cId="2979161283" sldId="268"/>
            <ac:spMk id="19" creationId="{CB1A43BA-4F6C-4EDA-BEF2-D5157513412B}"/>
          </ac:spMkLst>
        </pc:spChg>
        <pc:spChg chg="add mod">
          <ac:chgData name="Sameer G Joshi (DJPR)" userId="bd06337d-ce8c-4c34-b1d1-7fbf8f91b6eb" providerId="ADAL" clId="{B9B8FF69-58F3-48D8-9439-0B94E292364A}" dt="2021-06-15T01:46:32.661" v="2237" actId="1076"/>
          <ac:spMkLst>
            <pc:docMk/>
            <pc:sldMk cId="2979161283" sldId="268"/>
            <ac:spMk id="20" creationId="{CCCE620F-214C-466C-BB2A-80B9BB6E577A}"/>
          </ac:spMkLst>
        </pc:spChg>
        <pc:spChg chg="add mod">
          <ac:chgData name="Sameer G Joshi (DJPR)" userId="bd06337d-ce8c-4c34-b1d1-7fbf8f91b6eb" providerId="ADAL" clId="{B9B8FF69-58F3-48D8-9439-0B94E292364A}" dt="2021-06-15T01:46:32.661" v="2237" actId="1076"/>
          <ac:spMkLst>
            <pc:docMk/>
            <pc:sldMk cId="2979161283" sldId="268"/>
            <ac:spMk id="21" creationId="{BF08BE3D-227F-4317-998C-566F89096545}"/>
          </ac:spMkLst>
        </pc:spChg>
        <pc:spChg chg="add mod">
          <ac:chgData name="Sameer G Joshi (DJPR)" userId="bd06337d-ce8c-4c34-b1d1-7fbf8f91b6eb" providerId="ADAL" clId="{B9B8FF69-58F3-48D8-9439-0B94E292364A}" dt="2021-06-15T01:46:32.661" v="2237" actId="1076"/>
          <ac:spMkLst>
            <pc:docMk/>
            <pc:sldMk cId="2979161283" sldId="268"/>
            <ac:spMk id="22" creationId="{9889860D-58FF-4948-9269-9B1F1DC0E527}"/>
          </ac:spMkLst>
        </pc:spChg>
        <pc:spChg chg="add mod">
          <ac:chgData name="Sameer G Joshi (DJPR)" userId="bd06337d-ce8c-4c34-b1d1-7fbf8f91b6eb" providerId="ADAL" clId="{B9B8FF69-58F3-48D8-9439-0B94E292364A}" dt="2021-06-15T01:46:32.661" v="2237" actId="1076"/>
          <ac:spMkLst>
            <pc:docMk/>
            <pc:sldMk cId="2979161283" sldId="268"/>
            <ac:spMk id="23" creationId="{3CCD6AAD-8814-4C8F-B6EB-F2078E20C84C}"/>
          </ac:spMkLst>
        </pc:spChg>
        <pc:spChg chg="add mod">
          <ac:chgData name="Sameer G Joshi (DJPR)" userId="bd06337d-ce8c-4c34-b1d1-7fbf8f91b6eb" providerId="ADAL" clId="{B9B8FF69-58F3-48D8-9439-0B94E292364A}" dt="2021-06-15T01:46:32.661" v="2237" actId="1076"/>
          <ac:spMkLst>
            <pc:docMk/>
            <pc:sldMk cId="2979161283" sldId="268"/>
            <ac:spMk id="24" creationId="{6AFC1058-34B2-4617-A1A7-312FDBE1564D}"/>
          </ac:spMkLst>
        </pc:spChg>
        <pc:spChg chg="add mod">
          <ac:chgData name="Sameer G Joshi (DJPR)" userId="bd06337d-ce8c-4c34-b1d1-7fbf8f91b6eb" providerId="ADAL" clId="{B9B8FF69-58F3-48D8-9439-0B94E292364A}" dt="2021-06-15T01:46:32.661" v="2237" actId="1076"/>
          <ac:spMkLst>
            <pc:docMk/>
            <pc:sldMk cId="2979161283" sldId="268"/>
            <ac:spMk id="25" creationId="{710CD284-60CD-4367-B38E-F812D71EADCD}"/>
          </ac:spMkLst>
        </pc:spChg>
        <pc:spChg chg="add mod">
          <ac:chgData name="Sameer G Joshi (DJPR)" userId="bd06337d-ce8c-4c34-b1d1-7fbf8f91b6eb" providerId="ADAL" clId="{B9B8FF69-58F3-48D8-9439-0B94E292364A}" dt="2021-06-15T01:46:32.661" v="2237" actId="1076"/>
          <ac:spMkLst>
            <pc:docMk/>
            <pc:sldMk cId="2979161283" sldId="268"/>
            <ac:spMk id="26" creationId="{078656E5-5609-42D2-B4B3-0FB4ECE4AF0A}"/>
          </ac:spMkLst>
        </pc:spChg>
        <pc:spChg chg="add mod">
          <ac:chgData name="Sameer G Joshi (DJPR)" userId="bd06337d-ce8c-4c34-b1d1-7fbf8f91b6eb" providerId="ADAL" clId="{B9B8FF69-58F3-48D8-9439-0B94E292364A}" dt="2021-06-15T01:47:14.990" v="2283" actId="1037"/>
          <ac:spMkLst>
            <pc:docMk/>
            <pc:sldMk cId="2979161283" sldId="268"/>
            <ac:spMk id="27" creationId="{0A4CD161-8E9E-4A0B-87C1-E25849F1B632}"/>
          </ac:spMkLst>
        </pc:spChg>
        <pc:spChg chg="add mod">
          <ac:chgData name="Sameer G Joshi (DJPR)" userId="bd06337d-ce8c-4c34-b1d1-7fbf8f91b6eb" providerId="ADAL" clId="{B9B8FF69-58F3-48D8-9439-0B94E292364A}" dt="2021-06-15T01:47:08.478" v="2280" actId="1037"/>
          <ac:spMkLst>
            <pc:docMk/>
            <pc:sldMk cId="2979161283" sldId="268"/>
            <ac:spMk id="28" creationId="{3E3BC0AB-1ADB-4EC3-9BE9-6EB4F214DF84}"/>
          </ac:spMkLst>
        </pc:spChg>
        <pc:spChg chg="add mod">
          <ac:chgData name="Sameer G Joshi (DJPR)" userId="bd06337d-ce8c-4c34-b1d1-7fbf8f91b6eb" providerId="ADAL" clId="{B9B8FF69-58F3-48D8-9439-0B94E292364A}" dt="2021-06-15T01:46:32.661" v="2237" actId="1076"/>
          <ac:spMkLst>
            <pc:docMk/>
            <pc:sldMk cId="2979161283" sldId="268"/>
            <ac:spMk id="29" creationId="{BE3D9BBD-12E6-4E6A-8971-39E79D2D423A}"/>
          </ac:spMkLst>
        </pc:spChg>
        <pc:spChg chg="add mod">
          <ac:chgData name="Sameer G Joshi (DJPR)" userId="bd06337d-ce8c-4c34-b1d1-7fbf8f91b6eb" providerId="ADAL" clId="{B9B8FF69-58F3-48D8-9439-0B94E292364A}" dt="2021-06-15T01:47:02.301" v="2274" actId="1037"/>
          <ac:spMkLst>
            <pc:docMk/>
            <pc:sldMk cId="2979161283" sldId="268"/>
            <ac:spMk id="30" creationId="{81D7B129-2598-4A5B-A4C0-BE3047626B92}"/>
          </ac:spMkLst>
        </pc:spChg>
        <pc:spChg chg="add mod">
          <ac:chgData name="Sameer G Joshi (DJPR)" userId="bd06337d-ce8c-4c34-b1d1-7fbf8f91b6eb" providerId="ADAL" clId="{B9B8FF69-58F3-48D8-9439-0B94E292364A}" dt="2021-06-15T01:46:40.413" v="2248" actId="1037"/>
          <ac:spMkLst>
            <pc:docMk/>
            <pc:sldMk cId="2979161283" sldId="268"/>
            <ac:spMk id="31" creationId="{D916B54B-9527-40E4-A113-8E900D9CF06F}"/>
          </ac:spMkLst>
        </pc:spChg>
        <pc:spChg chg="add mod">
          <ac:chgData name="Sameer G Joshi (DJPR)" userId="bd06337d-ce8c-4c34-b1d1-7fbf8f91b6eb" providerId="ADAL" clId="{B9B8FF69-58F3-48D8-9439-0B94E292364A}" dt="2021-06-15T01:46:40.413" v="2248" actId="1037"/>
          <ac:spMkLst>
            <pc:docMk/>
            <pc:sldMk cId="2979161283" sldId="268"/>
            <ac:spMk id="32" creationId="{ADB4E65A-65F4-4935-96A9-07531B4F55D9}"/>
          </ac:spMkLst>
        </pc:spChg>
        <pc:spChg chg="add mod">
          <ac:chgData name="Sameer G Joshi (DJPR)" userId="bd06337d-ce8c-4c34-b1d1-7fbf8f91b6eb" providerId="ADAL" clId="{B9B8FF69-58F3-48D8-9439-0B94E292364A}" dt="2021-06-15T01:46:56.116" v="2269" actId="1037"/>
          <ac:spMkLst>
            <pc:docMk/>
            <pc:sldMk cId="2979161283" sldId="268"/>
            <ac:spMk id="33" creationId="{8D7BDC7F-7EC0-4BB1-97CA-FD04CEF69807}"/>
          </ac:spMkLst>
        </pc:spChg>
        <pc:spChg chg="add mod">
          <ac:chgData name="Sameer G Joshi (DJPR)" userId="bd06337d-ce8c-4c34-b1d1-7fbf8f91b6eb" providerId="ADAL" clId="{B9B8FF69-58F3-48D8-9439-0B94E292364A}" dt="2021-06-15T01:46:50.188" v="2261" actId="1037"/>
          <ac:spMkLst>
            <pc:docMk/>
            <pc:sldMk cId="2979161283" sldId="268"/>
            <ac:spMk id="34" creationId="{FA2DD28C-ADBF-40FE-80E9-52D8FB2FBF0A}"/>
          </ac:spMkLst>
        </pc:spChg>
        <pc:spChg chg="add mod">
          <ac:chgData name="Sameer G Joshi (DJPR)" userId="bd06337d-ce8c-4c34-b1d1-7fbf8f91b6eb" providerId="ADAL" clId="{B9B8FF69-58F3-48D8-9439-0B94E292364A}" dt="2021-06-15T01:46:32.661" v="2237" actId="1076"/>
          <ac:spMkLst>
            <pc:docMk/>
            <pc:sldMk cId="2979161283" sldId="268"/>
            <ac:spMk id="36" creationId="{09FA44B6-6D81-42D7-B5B5-3517607D9C8F}"/>
          </ac:spMkLst>
        </pc:spChg>
        <pc:spChg chg="add del mod">
          <ac:chgData name="Sameer G Joshi (DJPR)" userId="bd06337d-ce8c-4c34-b1d1-7fbf8f91b6eb" providerId="ADAL" clId="{B9B8FF69-58F3-48D8-9439-0B94E292364A}" dt="2021-06-15T02:12:21.709" v="2700" actId="478"/>
          <ac:spMkLst>
            <pc:docMk/>
            <pc:sldMk cId="2979161283" sldId="268"/>
            <ac:spMk id="37" creationId="{325B826D-1043-4594-AFBC-750B0EFBABE9}"/>
          </ac:spMkLst>
        </pc:spChg>
        <pc:spChg chg="add mod">
          <ac:chgData name="Sameer G Joshi (DJPR)" userId="bd06337d-ce8c-4c34-b1d1-7fbf8f91b6eb" providerId="ADAL" clId="{B9B8FF69-58F3-48D8-9439-0B94E292364A}" dt="2021-06-15T02:28:35.413" v="3115"/>
          <ac:spMkLst>
            <pc:docMk/>
            <pc:sldMk cId="2979161283" sldId="268"/>
            <ac:spMk id="38" creationId="{C903D545-BD34-41D8-87FF-B96084478DA4}"/>
          </ac:spMkLst>
        </pc:spChg>
        <pc:spChg chg="add mod">
          <ac:chgData name="Sameer G Joshi (DJPR)" userId="bd06337d-ce8c-4c34-b1d1-7fbf8f91b6eb" providerId="ADAL" clId="{B9B8FF69-58F3-48D8-9439-0B94E292364A}" dt="2021-06-15T02:42:03.692" v="3364" actId="1037"/>
          <ac:spMkLst>
            <pc:docMk/>
            <pc:sldMk cId="2979161283" sldId="268"/>
            <ac:spMk id="39" creationId="{BA57A2D4-09C6-42CD-8DC8-8C5A0902613B}"/>
          </ac:spMkLst>
        </pc:spChg>
        <pc:spChg chg="add mod">
          <ac:chgData name="Sameer G Joshi (DJPR)" userId="bd06337d-ce8c-4c34-b1d1-7fbf8f91b6eb" providerId="ADAL" clId="{B9B8FF69-58F3-48D8-9439-0B94E292364A}" dt="2021-06-15T02:41:59.020" v="3363" actId="113"/>
          <ac:spMkLst>
            <pc:docMk/>
            <pc:sldMk cId="2979161283" sldId="268"/>
            <ac:spMk id="40" creationId="{126E7DE3-B5E6-46D5-BB5C-775FC3C4DBD4}"/>
          </ac:spMkLst>
        </pc:spChg>
        <pc:spChg chg="add mod">
          <ac:chgData name="Sameer G Joshi (DJPR)" userId="bd06337d-ce8c-4c34-b1d1-7fbf8f91b6eb" providerId="ADAL" clId="{B9B8FF69-58F3-48D8-9439-0B94E292364A}" dt="2021-06-15T02:41:59.020" v="3363" actId="113"/>
          <ac:spMkLst>
            <pc:docMk/>
            <pc:sldMk cId="2979161283" sldId="268"/>
            <ac:spMk id="41" creationId="{34B42631-7962-4761-857E-1FCB1693BB9A}"/>
          </ac:spMkLst>
        </pc:spChg>
        <pc:spChg chg="add mod">
          <ac:chgData name="Sameer G Joshi (DJPR)" userId="bd06337d-ce8c-4c34-b1d1-7fbf8f91b6eb" providerId="ADAL" clId="{B9B8FF69-58F3-48D8-9439-0B94E292364A}" dt="2021-06-15T02:41:59.020" v="3363" actId="113"/>
          <ac:spMkLst>
            <pc:docMk/>
            <pc:sldMk cId="2979161283" sldId="268"/>
            <ac:spMk id="42" creationId="{FB189CD9-33D5-4A44-A4EF-A1E322DDCBC1}"/>
          </ac:spMkLst>
        </pc:spChg>
        <pc:graphicFrameChg chg="add mod">
          <ac:chgData name="Sameer G Joshi (DJPR)" userId="bd06337d-ce8c-4c34-b1d1-7fbf8f91b6eb" providerId="ADAL" clId="{B9B8FF69-58F3-48D8-9439-0B94E292364A}" dt="2021-06-15T01:48:51.236" v="2287" actId="13822"/>
          <ac:graphicFrameMkLst>
            <pc:docMk/>
            <pc:sldMk cId="2979161283" sldId="268"/>
            <ac:graphicFrameMk id="4" creationId="{26B0E2CE-352C-44C1-956E-E49B592CCBD5}"/>
          </ac:graphicFrameMkLst>
        </pc:graphicFrameChg>
        <pc:graphicFrameChg chg="add mod">
          <ac:chgData name="Sameer G Joshi (DJPR)" userId="bd06337d-ce8c-4c34-b1d1-7fbf8f91b6eb" providerId="ADAL" clId="{B9B8FF69-58F3-48D8-9439-0B94E292364A}" dt="2021-06-15T01:48:56.284" v="2288" actId="13822"/>
          <ac:graphicFrameMkLst>
            <pc:docMk/>
            <pc:sldMk cId="2979161283" sldId="268"/>
            <ac:graphicFrameMk id="5" creationId="{B058E45D-4E73-4346-BE1D-1A6AECF04C09}"/>
          </ac:graphicFrameMkLst>
        </pc:graphicFrameChg>
        <pc:graphicFrameChg chg="add del mod">
          <ac:chgData name="Sameer G Joshi (DJPR)" userId="bd06337d-ce8c-4c34-b1d1-7fbf8f91b6eb" providerId="ADAL" clId="{B9B8FF69-58F3-48D8-9439-0B94E292364A}" dt="2021-06-15T01:41:45.611" v="2176"/>
          <ac:graphicFrameMkLst>
            <pc:docMk/>
            <pc:sldMk cId="2979161283" sldId="268"/>
            <ac:graphicFrameMk id="8" creationId="{45206BCF-341E-4FDA-8D02-3A119779C2F5}"/>
          </ac:graphicFrameMkLst>
        </pc:graphicFrameChg>
        <pc:cxnChg chg="add mod">
          <ac:chgData name="Sameer G Joshi (DJPR)" userId="bd06337d-ce8c-4c34-b1d1-7fbf8f91b6eb" providerId="ADAL" clId="{B9B8FF69-58F3-48D8-9439-0B94E292364A}" dt="2021-06-15T05:18:39.532" v="3945" actId="14100"/>
          <ac:cxnSpMkLst>
            <pc:docMk/>
            <pc:sldMk cId="2979161283" sldId="268"/>
            <ac:cxnSpMk id="35" creationId="{5E185F10-424C-4321-8F87-E7D7A5E446E3}"/>
          </ac:cxnSpMkLst>
        </pc:cxnChg>
      </pc:sldChg>
      <pc:sldChg chg="addSp delSp modSp new mod">
        <pc:chgData name="Sameer G Joshi (DJPR)" userId="bd06337d-ce8c-4c34-b1d1-7fbf8f91b6eb" providerId="ADAL" clId="{B9B8FF69-58F3-48D8-9439-0B94E292364A}" dt="2021-06-20T12:30:35.206" v="4396" actId="20577"/>
        <pc:sldMkLst>
          <pc:docMk/>
          <pc:sldMk cId="446862676" sldId="269"/>
        </pc:sldMkLst>
        <pc:spChg chg="del">
          <ac:chgData name="Sameer G Joshi (DJPR)" userId="bd06337d-ce8c-4c34-b1d1-7fbf8f91b6eb" providerId="ADAL" clId="{B9B8FF69-58F3-48D8-9439-0B94E292364A}" dt="2021-06-15T04:43:20.353" v="3371" actId="478"/>
          <ac:spMkLst>
            <pc:docMk/>
            <pc:sldMk cId="446862676" sldId="269"/>
            <ac:spMk id="2" creationId="{70D694D0-A53A-4E75-B314-C0947F4DB371}"/>
          </ac:spMkLst>
        </pc:spChg>
        <pc:spChg chg="del">
          <ac:chgData name="Sameer G Joshi (DJPR)" userId="bd06337d-ce8c-4c34-b1d1-7fbf8f91b6eb" providerId="ADAL" clId="{B9B8FF69-58F3-48D8-9439-0B94E292364A}" dt="2021-06-15T04:43:20.353" v="3371" actId="478"/>
          <ac:spMkLst>
            <pc:docMk/>
            <pc:sldMk cId="446862676" sldId="269"/>
            <ac:spMk id="3" creationId="{1B84D76C-09F2-4522-AAF7-E6380CF45D91}"/>
          </ac:spMkLst>
        </pc:spChg>
        <pc:spChg chg="add mod">
          <ac:chgData name="Sameer G Joshi (DJPR)" userId="bd06337d-ce8c-4c34-b1d1-7fbf8f91b6eb" providerId="ADAL" clId="{B9B8FF69-58F3-48D8-9439-0B94E292364A}" dt="2021-06-20T12:30:35.206" v="4396" actId="20577"/>
          <ac:spMkLst>
            <pc:docMk/>
            <pc:sldMk cId="446862676" sldId="269"/>
            <ac:spMk id="5" creationId="{251A451C-65F8-4F03-8117-EF5D0DAAADEE}"/>
          </ac:spMkLst>
        </pc:spChg>
        <pc:graphicFrameChg chg="add del mod">
          <ac:chgData name="Sameer G Joshi (DJPR)" userId="bd06337d-ce8c-4c34-b1d1-7fbf8f91b6eb" providerId="ADAL" clId="{B9B8FF69-58F3-48D8-9439-0B94E292364A}" dt="2021-06-20T11:30:37.618" v="3948"/>
          <ac:graphicFrameMkLst>
            <pc:docMk/>
            <pc:sldMk cId="446862676" sldId="269"/>
            <ac:graphicFrameMk id="2" creationId="{5994DD53-D575-44C7-B309-057690F6DD90}"/>
          </ac:graphicFrameMkLst>
        </pc:graphicFrameChg>
        <pc:graphicFrameChg chg="add del mod">
          <ac:chgData name="Sameer G Joshi (DJPR)" userId="bd06337d-ce8c-4c34-b1d1-7fbf8f91b6eb" providerId="ADAL" clId="{B9B8FF69-58F3-48D8-9439-0B94E292364A}" dt="2021-06-20T11:34:41.252" v="3955" actId="478"/>
          <ac:graphicFrameMkLst>
            <pc:docMk/>
            <pc:sldMk cId="446862676" sldId="269"/>
            <ac:graphicFrameMk id="3" creationId="{50EEA834-2D0B-4FDC-94A0-01D597FEBDA4}"/>
          </ac:graphicFrameMkLst>
        </pc:graphicFrameChg>
        <pc:graphicFrameChg chg="add del mod modGraphic">
          <ac:chgData name="Sameer G Joshi (DJPR)" userId="bd06337d-ce8c-4c34-b1d1-7fbf8f91b6eb" providerId="ADAL" clId="{B9B8FF69-58F3-48D8-9439-0B94E292364A}" dt="2021-06-20T11:34:12.665" v="3951" actId="478"/>
          <ac:graphicFrameMkLst>
            <pc:docMk/>
            <pc:sldMk cId="446862676" sldId="269"/>
            <ac:graphicFrameMk id="4" creationId="{3D4A43E7-960E-4A1A-802C-172452BA976B}"/>
          </ac:graphicFrameMkLst>
        </pc:graphicFrameChg>
        <pc:graphicFrameChg chg="add del mod modGraphic">
          <ac:chgData name="Sameer G Joshi (DJPR)" userId="bd06337d-ce8c-4c34-b1d1-7fbf8f91b6eb" providerId="ADAL" clId="{B9B8FF69-58F3-48D8-9439-0B94E292364A}" dt="2021-06-20T12:27:43.419" v="4254" actId="478"/>
          <ac:graphicFrameMkLst>
            <pc:docMk/>
            <pc:sldMk cId="446862676" sldId="269"/>
            <ac:graphicFrameMk id="6" creationId="{409FE8AE-52CD-4DC4-A855-D5C2C020606E}"/>
          </ac:graphicFrameMkLst>
        </pc:graphicFrameChg>
        <pc:graphicFrameChg chg="add del mod modGraphic">
          <ac:chgData name="Sameer G Joshi (DJPR)" userId="bd06337d-ce8c-4c34-b1d1-7fbf8f91b6eb" providerId="ADAL" clId="{B9B8FF69-58F3-48D8-9439-0B94E292364A}" dt="2021-06-20T12:27:47.293" v="4255" actId="478"/>
          <ac:graphicFrameMkLst>
            <pc:docMk/>
            <pc:sldMk cId="446862676" sldId="269"/>
            <ac:graphicFrameMk id="7" creationId="{51F7E7B8-6346-4277-BBF7-93A2ED4E588F}"/>
          </ac:graphicFrameMkLst>
        </pc:graphicFrameChg>
        <pc:graphicFrameChg chg="add del mod">
          <ac:chgData name="Sameer G Joshi (DJPR)" userId="bd06337d-ce8c-4c34-b1d1-7fbf8f91b6eb" providerId="ADAL" clId="{B9B8FF69-58F3-48D8-9439-0B94E292364A}" dt="2021-06-20T11:46:36.158" v="4032" actId="478"/>
          <ac:graphicFrameMkLst>
            <pc:docMk/>
            <pc:sldMk cId="446862676" sldId="269"/>
            <ac:graphicFrameMk id="8" creationId="{74ED000C-33A1-49A7-A426-F78FE581C1D9}"/>
          </ac:graphicFrameMkLst>
        </pc:graphicFrameChg>
        <pc:graphicFrameChg chg="add del mod modGraphic">
          <ac:chgData name="Sameer G Joshi (DJPR)" userId="bd06337d-ce8c-4c34-b1d1-7fbf8f91b6eb" providerId="ADAL" clId="{B9B8FF69-58F3-48D8-9439-0B94E292364A}" dt="2021-06-20T12:23:48.935" v="4185" actId="478"/>
          <ac:graphicFrameMkLst>
            <pc:docMk/>
            <pc:sldMk cId="446862676" sldId="269"/>
            <ac:graphicFrameMk id="9" creationId="{ED53525E-666C-4124-BB33-3C86BD530EEB}"/>
          </ac:graphicFrameMkLst>
        </pc:graphicFrameChg>
        <pc:graphicFrameChg chg="add mod modGraphic">
          <ac:chgData name="Sameer G Joshi (DJPR)" userId="bd06337d-ce8c-4c34-b1d1-7fbf8f91b6eb" providerId="ADAL" clId="{B9B8FF69-58F3-48D8-9439-0B94E292364A}" dt="2021-06-20T12:28:10.521" v="4365" actId="1036"/>
          <ac:graphicFrameMkLst>
            <pc:docMk/>
            <pc:sldMk cId="446862676" sldId="269"/>
            <ac:graphicFrameMk id="10" creationId="{228EABB7-3E76-43B4-AA81-C0C3CC4D3E5E}"/>
          </ac:graphicFrameMkLst>
        </pc:graphicFrameChg>
      </pc:sldChg>
      <pc:sldMasterChg chg="modSp modSldLayout">
        <pc:chgData name="Sameer G Joshi (DJPR)" userId="bd06337d-ce8c-4c34-b1d1-7fbf8f91b6eb" providerId="ADAL" clId="{B9B8FF69-58F3-48D8-9439-0B94E292364A}" dt="2021-06-08T06:18:29.137" v="92"/>
        <pc:sldMasterMkLst>
          <pc:docMk/>
          <pc:sldMasterMk cId="1116890232" sldId="2147483672"/>
        </pc:sldMasterMkLst>
        <pc:spChg chg="mod">
          <ac:chgData name="Sameer G Joshi (DJPR)" userId="bd06337d-ce8c-4c34-b1d1-7fbf8f91b6eb" providerId="ADAL" clId="{B9B8FF69-58F3-48D8-9439-0B94E292364A}" dt="2021-06-08T06:18:29.137" v="92"/>
          <ac:spMkLst>
            <pc:docMk/>
            <pc:sldMasterMk cId="1116890232" sldId="2147483672"/>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ac:spMk id="3"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ac:spMk id="4"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ac:spMk id="5"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ac:spMk id="6" creationId="{00000000-0000-0000-0000-000000000000}"/>
          </ac:spMkLst>
        </pc:spChg>
        <pc:sldLayoutChg chg="modSp">
          <pc:chgData name="Sameer G Joshi (DJPR)" userId="bd06337d-ce8c-4c34-b1d1-7fbf8f91b6eb" providerId="ADAL" clId="{B9B8FF69-58F3-48D8-9439-0B94E292364A}" dt="2021-06-08T06:18:29.137" v="92"/>
          <pc:sldLayoutMkLst>
            <pc:docMk/>
            <pc:sldMasterMk cId="1116890232" sldId="2147483672"/>
            <pc:sldLayoutMk cId="1229446493" sldId="2147483673"/>
          </pc:sldLayoutMkLst>
          <pc:spChg chg="mod">
            <ac:chgData name="Sameer G Joshi (DJPR)" userId="bd06337d-ce8c-4c34-b1d1-7fbf8f91b6eb" providerId="ADAL" clId="{B9B8FF69-58F3-48D8-9439-0B94E292364A}" dt="2021-06-08T06:18:29.137" v="92"/>
            <ac:spMkLst>
              <pc:docMk/>
              <pc:sldMasterMk cId="1116890232" sldId="2147483672"/>
              <pc:sldLayoutMk cId="1229446493" sldId="2147483673"/>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1229446493" sldId="2147483673"/>
              <ac:spMk id="3" creationId="{00000000-0000-0000-0000-000000000000}"/>
            </ac:spMkLst>
          </pc:spChg>
        </pc:sldLayoutChg>
        <pc:sldLayoutChg chg="modSp">
          <pc:chgData name="Sameer G Joshi (DJPR)" userId="bd06337d-ce8c-4c34-b1d1-7fbf8f91b6eb" providerId="ADAL" clId="{B9B8FF69-58F3-48D8-9439-0B94E292364A}" dt="2021-06-08T06:18:29.137" v="92"/>
          <pc:sldLayoutMkLst>
            <pc:docMk/>
            <pc:sldMasterMk cId="1116890232" sldId="2147483672"/>
            <pc:sldLayoutMk cId="1551209057" sldId="2147483675"/>
          </pc:sldLayoutMkLst>
          <pc:spChg chg="mod">
            <ac:chgData name="Sameer G Joshi (DJPR)" userId="bd06337d-ce8c-4c34-b1d1-7fbf8f91b6eb" providerId="ADAL" clId="{B9B8FF69-58F3-48D8-9439-0B94E292364A}" dt="2021-06-08T06:18:29.137" v="92"/>
            <ac:spMkLst>
              <pc:docMk/>
              <pc:sldMasterMk cId="1116890232" sldId="2147483672"/>
              <pc:sldLayoutMk cId="1551209057" sldId="2147483675"/>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1551209057" sldId="2147483675"/>
              <ac:spMk id="3" creationId="{00000000-0000-0000-0000-000000000000}"/>
            </ac:spMkLst>
          </pc:spChg>
        </pc:sldLayoutChg>
        <pc:sldLayoutChg chg="modSp">
          <pc:chgData name="Sameer G Joshi (DJPR)" userId="bd06337d-ce8c-4c34-b1d1-7fbf8f91b6eb" providerId="ADAL" clId="{B9B8FF69-58F3-48D8-9439-0B94E292364A}" dt="2021-06-08T06:18:29.137" v="92"/>
          <pc:sldLayoutMkLst>
            <pc:docMk/>
            <pc:sldMasterMk cId="1116890232" sldId="2147483672"/>
            <pc:sldLayoutMk cId="1906172614" sldId="2147483676"/>
          </pc:sldLayoutMkLst>
          <pc:spChg chg="mod">
            <ac:chgData name="Sameer G Joshi (DJPR)" userId="bd06337d-ce8c-4c34-b1d1-7fbf8f91b6eb" providerId="ADAL" clId="{B9B8FF69-58F3-48D8-9439-0B94E292364A}" dt="2021-06-08T06:18:29.137" v="92"/>
            <ac:spMkLst>
              <pc:docMk/>
              <pc:sldMasterMk cId="1116890232" sldId="2147483672"/>
              <pc:sldLayoutMk cId="1906172614" sldId="2147483676"/>
              <ac:spMk id="3"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1906172614" sldId="2147483676"/>
              <ac:spMk id="4" creationId="{00000000-0000-0000-0000-000000000000}"/>
            </ac:spMkLst>
          </pc:spChg>
        </pc:sldLayoutChg>
        <pc:sldLayoutChg chg="modSp">
          <pc:chgData name="Sameer G Joshi (DJPR)" userId="bd06337d-ce8c-4c34-b1d1-7fbf8f91b6eb" providerId="ADAL" clId="{B9B8FF69-58F3-48D8-9439-0B94E292364A}" dt="2021-06-08T06:18:29.137" v="92"/>
          <pc:sldLayoutMkLst>
            <pc:docMk/>
            <pc:sldMasterMk cId="1116890232" sldId="2147483672"/>
            <pc:sldLayoutMk cId="3659659709" sldId="2147483677"/>
          </pc:sldLayoutMkLst>
          <pc:spChg chg="mod">
            <ac:chgData name="Sameer G Joshi (DJPR)" userId="bd06337d-ce8c-4c34-b1d1-7fbf8f91b6eb" providerId="ADAL" clId="{B9B8FF69-58F3-48D8-9439-0B94E292364A}" dt="2021-06-08T06:18:29.137" v="92"/>
            <ac:spMkLst>
              <pc:docMk/>
              <pc:sldMasterMk cId="1116890232" sldId="2147483672"/>
              <pc:sldLayoutMk cId="3659659709" sldId="2147483677"/>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3659659709" sldId="2147483677"/>
              <ac:spMk id="3"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3659659709" sldId="2147483677"/>
              <ac:spMk id="4"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3659659709" sldId="2147483677"/>
              <ac:spMk id="5"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3659659709" sldId="2147483677"/>
              <ac:spMk id="6" creationId="{00000000-0000-0000-0000-000000000000}"/>
            </ac:spMkLst>
          </pc:spChg>
        </pc:sldLayoutChg>
        <pc:sldLayoutChg chg="modSp">
          <pc:chgData name="Sameer G Joshi (DJPR)" userId="bd06337d-ce8c-4c34-b1d1-7fbf8f91b6eb" providerId="ADAL" clId="{B9B8FF69-58F3-48D8-9439-0B94E292364A}" dt="2021-06-08T06:18:29.137" v="92"/>
          <pc:sldLayoutMkLst>
            <pc:docMk/>
            <pc:sldMasterMk cId="1116890232" sldId="2147483672"/>
            <pc:sldLayoutMk cId="1216423029" sldId="2147483680"/>
          </pc:sldLayoutMkLst>
          <pc:spChg chg="mod">
            <ac:chgData name="Sameer G Joshi (DJPR)" userId="bd06337d-ce8c-4c34-b1d1-7fbf8f91b6eb" providerId="ADAL" clId="{B9B8FF69-58F3-48D8-9439-0B94E292364A}" dt="2021-06-08T06:18:29.137" v="92"/>
            <ac:spMkLst>
              <pc:docMk/>
              <pc:sldMasterMk cId="1116890232" sldId="2147483672"/>
              <pc:sldLayoutMk cId="1216423029" sldId="2147483680"/>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1216423029" sldId="2147483680"/>
              <ac:spMk id="3"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1216423029" sldId="2147483680"/>
              <ac:spMk id="4" creationId="{00000000-0000-0000-0000-000000000000}"/>
            </ac:spMkLst>
          </pc:spChg>
        </pc:sldLayoutChg>
        <pc:sldLayoutChg chg="modSp">
          <pc:chgData name="Sameer G Joshi (DJPR)" userId="bd06337d-ce8c-4c34-b1d1-7fbf8f91b6eb" providerId="ADAL" clId="{B9B8FF69-58F3-48D8-9439-0B94E292364A}" dt="2021-06-08T06:18:29.137" v="92"/>
          <pc:sldLayoutMkLst>
            <pc:docMk/>
            <pc:sldMasterMk cId="1116890232" sldId="2147483672"/>
            <pc:sldLayoutMk cId="2243666499" sldId="2147483681"/>
          </pc:sldLayoutMkLst>
          <pc:spChg chg="mod">
            <ac:chgData name="Sameer G Joshi (DJPR)" userId="bd06337d-ce8c-4c34-b1d1-7fbf8f91b6eb" providerId="ADAL" clId="{B9B8FF69-58F3-48D8-9439-0B94E292364A}" dt="2021-06-08T06:18:29.137" v="92"/>
            <ac:spMkLst>
              <pc:docMk/>
              <pc:sldMasterMk cId="1116890232" sldId="2147483672"/>
              <pc:sldLayoutMk cId="2243666499" sldId="2147483681"/>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2243666499" sldId="2147483681"/>
              <ac:spMk id="3"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2243666499" sldId="2147483681"/>
              <ac:spMk id="4" creationId="{00000000-0000-0000-0000-000000000000}"/>
            </ac:spMkLst>
          </pc:spChg>
        </pc:sldLayoutChg>
        <pc:sldLayoutChg chg="modSp">
          <pc:chgData name="Sameer G Joshi (DJPR)" userId="bd06337d-ce8c-4c34-b1d1-7fbf8f91b6eb" providerId="ADAL" clId="{B9B8FF69-58F3-48D8-9439-0B94E292364A}" dt="2021-06-08T06:18:29.137" v="92"/>
          <pc:sldLayoutMkLst>
            <pc:docMk/>
            <pc:sldMasterMk cId="1116890232" sldId="2147483672"/>
            <pc:sldLayoutMk cId="3740349338" sldId="2147483683"/>
          </pc:sldLayoutMkLst>
          <pc:spChg chg="mod">
            <ac:chgData name="Sameer G Joshi (DJPR)" userId="bd06337d-ce8c-4c34-b1d1-7fbf8f91b6eb" providerId="ADAL" clId="{B9B8FF69-58F3-48D8-9439-0B94E292364A}" dt="2021-06-08T06:18:29.137" v="92"/>
            <ac:spMkLst>
              <pc:docMk/>
              <pc:sldMasterMk cId="1116890232" sldId="2147483672"/>
              <pc:sldLayoutMk cId="3740349338" sldId="2147483683"/>
              <ac:spMk id="2" creationId="{00000000-0000-0000-0000-000000000000}"/>
            </ac:spMkLst>
          </pc:spChg>
          <pc:spChg chg="mod">
            <ac:chgData name="Sameer G Joshi (DJPR)" userId="bd06337d-ce8c-4c34-b1d1-7fbf8f91b6eb" providerId="ADAL" clId="{B9B8FF69-58F3-48D8-9439-0B94E292364A}" dt="2021-06-08T06:18:29.137" v="92"/>
            <ac:spMkLst>
              <pc:docMk/>
              <pc:sldMasterMk cId="1116890232" sldId="2147483672"/>
              <pc:sldLayoutMk cId="3740349338" sldId="2147483683"/>
              <ac:spMk id="3" creationId="{00000000-0000-0000-0000-000000000000}"/>
            </ac:spMkLst>
          </pc:spChg>
        </pc:sldLayoutChg>
      </pc:sldMasterChg>
    </pc:docChg>
  </pc:docChgLst>
  <pc:docChgLst>
    <pc:chgData name="Sameer G Joshi (DJPR)" userId="bd06337d-ce8c-4c34-b1d1-7fbf8f91b6eb" providerId="ADAL" clId="{7BF6CCE1-D8BE-47A6-A57C-E281D236CFBA}"/>
    <pc:docChg chg="undo redo custSel addSld modSld">
      <pc:chgData name="Sameer G Joshi (DJPR)" userId="bd06337d-ce8c-4c34-b1d1-7fbf8f91b6eb" providerId="ADAL" clId="{7BF6CCE1-D8BE-47A6-A57C-E281D236CFBA}" dt="2022-08-12T05:24:21.447" v="2232" actId="20577"/>
      <pc:docMkLst>
        <pc:docMk/>
      </pc:docMkLst>
      <pc:sldChg chg="addSp delSp modSp mod">
        <pc:chgData name="Sameer G Joshi (DJPR)" userId="bd06337d-ce8c-4c34-b1d1-7fbf8f91b6eb" providerId="ADAL" clId="{7BF6CCE1-D8BE-47A6-A57C-E281D236CFBA}" dt="2022-08-11T13:03:03.240" v="470" actId="1076"/>
        <pc:sldMkLst>
          <pc:docMk/>
          <pc:sldMk cId="2203674866" sldId="258"/>
        </pc:sldMkLst>
        <pc:spChg chg="del mod">
          <ac:chgData name="Sameer G Joshi (DJPR)" userId="bd06337d-ce8c-4c34-b1d1-7fbf8f91b6eb" providerId="ADAL" clId="{7BF6CCE1-D8BE-47A6-A57C-E281D236CFBA}" dt="2022-08-11T12:41:22.782" v="92" actId="478"/>
          <ac:spMkLst>
            <pc:docMk/>
            <pc:sldMk cId="2203674866" sldId="258"/>
            <ac:spMk id="5" creationId="{C1C7D342-C5AF-4282-A34C-A99726B755CD}"/>
          </ac:spMkLst>
        </pc:spChg>
        <pc:spChg chg="del mod">
          <ac:chgData name="Sameer G Joshi (DJPR)" userId="bd06337d-ce8c-4c34-b1d1-7fbf8f91b6eb" providerId="ADAL" clId="{7BF6CCE1-D8BE-47A6-A57C-E281D236CFBA}" dt="2022-08-11T12:41:25.334" v="93" actId="478"/>
          <ac:spMkLst>
            <pc:docMk/>
            <pc:sldMk cId="2203674866" sldId="258"/>
            <ac:spMk id="6" creationId="{CF2FA352-EA4B-48AA-BCD9-0B5D417DE429}"/>
          </ac:spMkLst>
        </pc:spChg>
        <pc:spChg chg="add mod">
          <ac:chgData name="Sameer G Joshi (DJPR)" userId="bd06337d-ce8c-4c34-b1d1-7fbf8f91b6eb" providerId="ADAL" clId="{7BF6CCE1-D8BE-47A6-A57C-E281D236CFBA}" dt="2022-08-11T12:59:27.547" v="429" actId="1037"/>
          <ac:spMkLst>
            <pc:docMk/>
            <pc:sldMk cId="2203674866" sldId="258"/>
            <ac:spMk id="9" creationId="{AC565DF5-8825-474A-AE74-EE19E8CD8E73}"/>
          </ac:spMkLst>
        </pc:spChg>
        <pc:spChg chg="mod">
          <ac:chgData name="Sameer G Joshi (DJPR)" userId="bd06337d-ce8c-4c34-b1d1-7fbf8f91b6eb" providerId="ADAL" clId="{7BF6CCE1-D8BE-47A6-A57C-E281D236CFBA}" dt="2022-08-11T12:44:52.312" v="164" actId="1036"/>
          <ac:spMkLst>
            <pc:docMk/>
            <pc:sldMk cId="2203674866" sldId="258"/>
            <ac:spMk id="11" creationId="{F47A1C11-6121-479E-999B-743F8B3B0102}"/>
          </ac:spMkLst>
        </pc:spChg>
        <pc:spChg chg="mod">
          <ac:chgData name="Sameer G Joshi (DJPR)" userId="bd06337d-ce8c-4c34-b1d1-7fbf8f91b6eb" providerId="ADAL" clId="{7BF6CCE1-D8BE-47A6-A57C-E281D236CFBA}" dt="2022-08-11T12:44:52.312" v="164" actId="1036"/>
          <ac:spMkLst>
            <pc:docMk/>
            <pc:sldMk cId="2203674866" sldId="258"/>
            <ac:spMk id="12" creationId="{39B48064-32AF-488B-A4AC-5E955AE5DC19}"/>
          </ac:spMkLst>
        </pc:spChg>
        <pc:spChg chg="mod">
          <ac:chgData name="Sameer G Joshi (DJPR)" userId="bd06337d-ce8c-4c34-b1d1-7fbf8f91b6eb" providerId="ADAL" clId="{7BF6CCE1-D8BE-47A6-A57C-E281D236CFBA}" dt="2022-08-11T12:44:52.312" v="164" actId="1036"/>
          <ac:spMkLst>
            <pc:docMk/>
            <pc:sldMk cId="2203674866" sldId="258"/>
            <ac:spMk id="13" creationId="{166DCA8E-895F-42C9-8D34-A942C93FDA3E}"/>
          </ac:spMkLst>
        </pc:spChg>
        <pc:spChg chg="mod">
          <ac:chgData name="Sameer G Joshi (DJPR)" userId="bd06337d-ce8c-4c34-b1d1-7fbf8f91b6eb" providerId="ADAL" clId="{7BF6CCE1-D8BE-47A6-A57C-E281D236CFBA}" dt="2022-08-11T12:44:52.312" v="164" actId="1036"/>
          <ac:spMkLst>
            <pc:docMk/>
            <pc:sldMk cId="2203674866" sldId="258"/>
            <ac:spMk id="14" creationId="{1A4BC8A9-00C7-4001-9DA9-3C8D33C7C327}"/>
          </ac:spMkLst>
        </pc:spChg>
        <pc:spChg chg="mod">
          <ac:chgData name="Sameer G Joshi (DJPR)" userId="bd06337d-ce8c-4c34-b1d1-7fbf8f91b6eb" providerId="ADAL" clId="{7BF6CCE1-D8BE-47A6-A57C-E281D236CFBA}" dt="2022-08-11T12:43:57.730" v="133" actId="12788"/>
          <ac:spMkLst>
            <pc:docMk/>
            <pc:sldMk cId="2203674866" sldId="258"/>
            <ac:spMk id="16" creationId="{25B65A05-F4D7-4A73-94C3-EFF9E3C8BC70}"/>
          </ac:spMkLst>
        </pc:spChg>
        <pc:spChg chg="mod">
          <ac:chgData name="Sameer G Joshi (DJPR)" userId="bd06337d-ce8c-4c34-b1d1-7fbf8f91b6eb" providerId="ADAL" clId="{7BF6CCE1-D8BE-47A6-A57C-E281D236CFBA}" dt="2022-08-11T12:44:40.782" v="146" actId="20577"/>
          <ac:spMkLst>
            <pc:docMk/>
            <pc:sldMk cId="2203674866" sldId="258"/>
            <ac:spMk id="17" creationId="{C87AED42-E587-4B6F-8ABA-76C8FE76E503}"/>
          </ac:spMkLst>
        </pc:spChg>
        <pc:spChg chg="add mod">
          <ac:chgData name="Sameer G Joshi (DJPR)" userId="bd06337d-ce8c-4c34-b1d1-7fbf8f91b6eb" providerId="ADAL" clId="{7BF6CCE1-D8BE-47A6-A57C-E281D236CFBA}" dt="2022-08-11T12:44:17.175" v="135" actId="12788"/>
          <ac:spMkLst>
            <pc:docMk/>
            <pc:sldMk cId="2203674866" sldId="258"/>
            <ac:spMk id="18" creationId="{084508F0-FFB5-45FC-80C9-18CEB863B67D}"/>
          </ac:spMkLst>
        </pc:spChg>
        <pc:spChg chg="mod">
          <ac:chgData name="Sameer G Joshi (DJPR)" userId="bd06337d-ce8c-4c34-b1d1-7fbf8f91b6eb" providerId="ADAL" clId="{7BF6CCE1-D8BE-47A6-A57C-E281D236CFBA}" dt="2022-08-11T12:44:56.966" v="165" actId="1076"/>
          <ac:spMkLst>
            <pc:docMk/>
            <pc:sldMk cId="2203674866" sldId="258"/>
            <ac:spMk id="19" creationId="{106A8FBD-909B-4774-B43F-1FC484A71BE3}"/>
          </ac:spMkLst>
        </pc:spChg>
        <pc:spChg chg="add mod">
          <ac:chgData name="Sameer G Joshi (DJPR)" userId="bd06337d-ce8c-4c34-b1d1-7fbf8f91b6eb" providerId="ADAL" clId="{7BF6CCE1-D8BE-47A6-A57C-E281D236CFBA}" dt="2022-08-11T12:46:41.426" v="185" actId="20577"/>
          <ac:spMkLst>
            <pc:docMk/>
            <pc:sldMk cId="2203674866" sldId="258"/>
            <ac:spMk id="20" creationId="{975FB944-6113-4B41-BAFD-186F3EC4088F}"/>
          </ac:spMkLst>
        </pc:spChg>
        <pc:spChg chg="add mod">
          <ac:chgData name="Sameer G Joshi (DJPR)" userId="bd06337d-ce8c-4c34-b1d1-7fbf8f91b6eb" providerId="ADAL" clId="{7BF6CCE1-D8BE-47A6-A57C-E281D236CFBA}" dt="2022-08-11T12:48:46.583" v="269" actId="12788"/>
          <ac:spMkLst>
            <pc:docMk/>
            <pc:sldMk cId="2203674866" sldId="258"/>
            <ac:spMk id="21" creationId="{86D9FDC6-39FE-43D2-A68B-3908375A985F}"/>
          </ac:spMkLst>
        </pc:spChg>
        <pc:spChg chg="add mod">
          <ac:chgData name="Sameer G Joshi (DJPR)" userId="bd06337d-ce8c-4c34-b1d1-7fbf8f91b6eb" providerId="ADAL" clId="{7BF6CCE1-D8BE-47A6-A57C-E281D236CFBA}" dt="2022-08-11T12:48:46.583" v="269" actId="12788"/>
          <ac:spMkLst>
            <pc:docMk/>
            <pc:sldMk cId="2203674866" sldId="258"/>
            <ac:spMk id="22" creationId="{D9EC748E-9265-4B4D-B388-5878DABC1F7C}"/>
          </ac:spMkLst>
        </pc:spChg>
        <pc:spChg chg="add mod">
          <ac:chgData name="Sameer G Joshi (DJPR)" userId="bd06337d-ce8c-4c34-b1d1-7fbf8f91b6eb" providerId="ADAL" clId="{7BF6CCE1-D8BE-47A6-A57C-E281D236CFBA}" dt="2022-08-11T12:54:20.891" v="314" actId="1037"/>
          <ac:spMkLst>
            <pc:docMk/>
            <pc:sldMk cId="2203674866" sldId="258"/>
            <ac:spMk id="23" creationId="{B7A17959-E24D-4975-BFEC-EEA319AA135E}"/>
          </ac:spMkLst>
        </pc:spChg>
        <pc:spChg chg="add mod">
          <ac:chgData name="Sameer G Joshi (DJPR)" userId="bd06337d-ce8c-4c34-b1d1-7fbf8f91b6eb" providerId="ADAL" clId="{7BF6CCE1-D8BE-47A6-A57C-E281D236CFBA}" dt="2022-08-11T12:54:46.074" v="318" actId="1037"/>
          <ac:spMkLst>
            <pc:docMk/>
            <pc:sldMk cId="2203674866" sldId="258"/>
            <ac:spMk id="24" creationId="{97E880C3-DEB8-4CF1-893A-702B82FFE1D7}"/>
          </ac:spMkLst>
        </pc:spChg>
        <pc:spChg chg="add mod">
          <ac:chgData name="Sameer G Joshi (DJPR)" userId="bd06337d-ce8c-4c34-b1d1-7fbf8f91b6eb" providerId="ADAL" clId="{7BF6CCE1-D8BE-47A6-A57C-E281D236CFBA}" dt="2022-08-11T12:54:46.074" v="318" actId="1037"/>
          <ac:spMkLst>
            <pc:docMk/>
            <pc:sldMk cId="2203674866" sldId="258"/>
            <ac:spMk id="25" creationId="{9AE91FB4-2927-453E-BD4A-0451F66F2F6C}"/>
          </ac:spMkLst>
        </pc:spChg>
        <pc:spChg chg="add mod">
          <ac:chgData name="Sameer G Joshi (DJPR)" userId="bd06337d-ce8c-4c34-b1d1-7fbf8f91b6eb" providerId="ADAL" clId="{7BF6CCE1-D8BE-47A6-A57C-E281D236CFBA}" dt="2022-08-11T12:54:56.475" v="325" actId="1037"/>
          <ac:spMkLst>
            <pc:docMk/>
            <pc:sldMk cId="2203674866" sldId="258"/>
            <ac:spMk id="26" creationId="{6E958C7F-55F5-46ED-A1B0-4C7F2F1F6C61}"/>
          </ac:spMkLst>
        </pc:spChg>
        <pc:spChg chg="add mod">
          <ac:chgData name="Sameer G Joshi (DJPR)" userId="bd06337d-ce8c-4c34-b1d1-7fbf8f91b6eb" providerId="ADAL" clId="{7BF6CCE1-D8BE-47A6-A57C-E281D236CFBA}" dt="2022-08-11T12:54:56.475" v="325" actId="1037"/>
          <ac:spMkLst>
            <pc:docMk/>
            <pc:sldMk cId="2203674866" sldId="258"/>
            <ac:spMk id="27" creationId="{AE501451-B321-431E-9F90-04C38C3DFC0A}"/>
          </ac:spMkLst>
        </pc:spChg>
        <pc:spChg chg="add mod">
          <ac:chgData name="Sameer G Joshi (DJPR)" userId="bd06337d-ce8c-4c34-b1d1-7fbf8f91b6eb" providerId="ADAL" clId="{7BF6CCE1-D8BE-47A6-A57C-E281D236CFBA}" dt="2022-08-11T12:54:56.475" v="325" actId="1037"/>
          <ac:spMkLst>
            <pc:docMk/>
            <pc:sldMk cId="2203674866" sldId="258"/>
            <ac:spMk id="28" creationId="{022CF1DE-44B1-4F89-B3B8-69E52D3B9724}"/>
          </ac:spMkLst>
        </pc:spChg>
        <pc:spChg chg="add mod">
          <ac:chgData name="Sameer G Joshi (DJPR)" userId="bd06337d-ce8c-4c34-b1d1-7fbf8f91b6eb" providerId="ADAL" clId="{7BF6CCE1-D8BE-47A6-A57C-E281D236CFBA}" dt="2022-08-11T12:55:08.410" v="339" actId="1037"/>
          <ac:spMkLst>
            <pc:docMk/>
            <pc:sldMk cId="2203674866" sldId="258"/>
            <ac:spMk id="29" creationId="{70C73370-5556-4CFC-88ED-DB240E009AD9}"/>
          </ac:spMkLst>
        </pc:spChg>
        <pc:spChg chg="add mod">
          <ac:chgData name="Sameer G Joshi (DJPR)" userId="bd06337d-ce8c-4c34-b1d1-7fbf8f91b6eb" providerId="ADAL" clId="{7BF6CCE1-D8BE-47A6-A57C-E281D236CFBA}" dt="2022-08-11T12:56:20.563" v="378" actId="1038"/>
          <ac:spMkLst>
            <pc:docMk/>
            <pc:sldMk cId="2203674866" sldId="258"/>
            <ac:spMk id="30" creationId="{AD3C6CC2-86BA-4B1C-BDA3-36F9BB0BE6CB}"/>
          </ac:spMkLst>
        </pc:spChg>
        <pc:spChg chg="add mod">
          <ac:chgData name="Sameer G Joshi (DJPR)" userId="bd06337d-ce8c-4c34-b1d1-7fbf8f91b6eb" providerId="ADAL" clId="{7BF6CCE1-D8BE-47A6-A57C-E281D236CFBA}" dt="2022-08-11T12:56:08.643" v="344" actId="1038"/>
          <ac:spMkLst>
            <pc:docMk/>
            <pc:sldMk cId="2203674866" sldId="258"/>
            <ac:spMk id="31" creationId="{09960A7B-E48C-443F-B879-23E5688E0C8B}"/>
          </ac:spMkLst>
        </pc:spChg>
        <pc:spChg chg="add mod">
          <ac:chgData name="Sameer G Joshi (DJPR)" userId="bd06337d-ce8c-4c34-b1d1-7fbf8f91b6eb" providerId="ADAL" clId="{7BF6CCE1-D8BE-47A6-A57C-E281D236CFBA}" dt="2022-08-11T12:56:53.210" v="387" actId="1038"/>
          <ac:spMkLst>
            <pc:docMk/>
            <pc:sldMk cId="2203674866" sldId="258"/>
            <ac:spMk id="32" creationId="{5811C8C4-AC58-4F64-90ED-D11B59BBB988}"/>
          </ac:spMkLst>
        </pc:spChg>
        <pc:spChg chg="add mod">
          <ac:chgData name="Sameer G Joshi (DJPR)" userId="bd06337d-ce8c-4c34-b1d1-7fbf8f91b6eb" providerId="ADAL" clId="{7BF6CCE1-D8BE-47A6-A57C-E281D236CFBA}" dt="2022-08-11T12:57:02.193" v="389" actId="1076"/>
          <ac:spMkLst>
            <pc:docMk/>
            <pc:sldMk cId="2203674866" sldId="258"/>
            <ac:spMk id="33" creationId="{1792E14F-82E3-448D-B4B5-22073A1D40CA}"/>
          </ac:spMkLst>
        </pc:spChg>
        <pc:spChg chg="add mod">
          <ac:chgData name="Sameer G Joshi (DJPR)" userId="bd06337d-ce8c-4c34-b1d1-7fbf8f91b6eb" providerId="ADAL" clId="{7BF6CCE1-D8BE-47A6-A57C-E281D236CFBA}" dt="2022-08-11T12:57:23.699" v="403" actId="1035"/>
          <ac:spMkLst>
            <pc:docMk/>
            <pc:sldMk cId="2203674866" sldId="258"/>
            <ac:spMk id="34" creationId="{E55B5C02-3548-4C55-8E13-6B04B401D6B1}"/>
          </ac:spMkLst>
        </pc:spChg>
        <pc:spChg chg="add mod">
          <ac:chgData name="Sameer G Joshi (DJPR)" userId="bd06337d-ce8c-4c34-b1d1-7fbf8f91b6eb" providerId="ADAL" clId="{7BF6CCE1-D8BE-47A6-A57C-E281D236CFBA}" dt="2022-08-11T12:57:50.564" v="413" actId="1036"/>
          <ac:spMkLst>
            <pc:docMk/>
            <pc:sldMk cId="2203674866" sldId="258"/>
            <ac:spMk id="35" creationId="{47BEB788-3DA8-4190-B1FE-72A1194F3354}"/>
          </ac:spMkLst>
        </pc:spChg>
        <pc:spChg chg="add mod">
          <ac:chgData name="Sameer G Joshi (DJPR)" userId="bd06337d-ce8c-4c34-b1d1-7fbf8f91b6eb" providerId="ADAL" clId="{7BF6CCE1-D8BE-47A6-A57C-E281D236CFBA}" dt="2022-08-11T12:58:01.220" v="424" actId="1076"/>
          <ac:spMkLst>
            <pc:docMk/>
            <pc:sldMk cId="2203674866" sldId="258"/>
            <ac:spMk id="36" creationId="{54E01010-BBCC-4377-854D-AA8CE2CDBCFB}"/>
          </ac:spMkLst>
        </pc:spChg>
        <pc:spChg chg="add mod">
          <ac:chgData name="Sameer G Joshi (DJPR)" userId="bd06337d-ce8c-4c34-b1d1-7fbf8f91b6eb" providerId="ADAL" clId="{7BF6CCE1-D8BE-47A6-A57C-E281D236CFBA}" dt="2022-08-11T12:58:10.355" v="427" actId="6549"/>
          <ac:spMkLst>
            <pc:docMk/>
            <pc:sldMk cId="2203674866" sldId="258"/>
            <ac:spMk id="37" creationId="{EF78D233-3A75-4D99-80F3-4791FD9164B9}"/>
          </ac:spMkLst>
        </pc:spChg>
        <pc:spChg chg="add mod">
          <ac:chgData name="Sameer G Joshi (DJPR)" userId="bd06337d-ce8c-4c34-b1d1-7fbf8f91b6eb" providerId="ADAL" clId="{7BF6CCE1-D8BE-47A6-A57C-E281D236CFBA}" dt="2022-08-11T12:59:44.652" v="432" actId="20577"/>
          <ac:spMkLst>
            <pc:docMk/>
            <pc:sldMk cId="2203674866" sldId="258"/>
            <ac:spMk id="38" creationId="{1353959B-507D-453F-89C8-853B5CE950FF}"/>
          </ac:spMkLst>
        </pc:spChg>
        <pc:spChg chg="add mod">
          <ac:chgData name="Sameer G Joshi (DJPR)" userId="bd06337d-ce8c-4c34-b1d1-7fbf8f91b6eb" providerId="ADAL" clId="{7BF6CCE1-D8BE-47A6-A57C-E281D236CFBA}" dt="2022-08-11T12:59:57.137" v="434" actId="1076"/>
          <ac:spMkLst>
            <pc:docMk/>
            <pc:sldMk cId="2203674866" sldId="258"/>
            <ac:spMk id="39" creationId="{1A117FCA-AD4E-40B6-86F4-F05976232B7A}"/>
          </ac:spMkLst>
        </pc:spChg>
        <pc:spChg chg="add mod">
          <ac:chgData name="Sameer G Joshi (DJPR)" userId="bd06337d-ce8c-4c34-b1d1-7fbf8f91b6eb" providerId="ADAL" clId="{7BF6CCE1-D8BE-47A6-A57C-E281D236CFBA}" dt="2022-08-11T13:00:21.364" v="438" actId="1037"/>
          <ac:spMkLst>
            <pc:docMk/>
            <pc:sldMk cId="2203674866" sldId="258"/>
            <ac:spMk id="40" creationId="{E83CE6C8-41F9-4C8F-9BE0-A19FFDD257A4}"/>
          </ac:spMkLst>
        </pc:spChg>
        <pc:spChg chg="add mod">
          <ac:chgData name="Sameer G Joshi (DJPR)" userId="bd06337d-ce8c-4c34-b1d1-7fbf8f91b6eb" providerId="ADAL" clId="{7BF6CCE1-D8BE-47A6-A57C-E281D236CFBA}" dt="2022-08-11T13:00:47.068" v="442" actId="1037"/>
          <ac:spMkLst>
            <pc:docMk/>
            <pc:sldMk cId="2203674866" sldId="258"/>
            <ac:spMk id="41" creationId="{37247AC8-0BFA-43EF-9FA4-3D08BA2DC58F}"/>
          </ac:spMkLst>
        </pc:spChg>
        <pc:spChg chg="add mod">
          <ac:chgData name="Sameer G Joshi (DJPR)" userId="bd06337d-ce8c-4c34-b1d1-7fbf8f91b6eb" providerId="ADAL" clId="{7BF6CCE1-D8BE-47A6-A57C-E281D236CFBA}" dt="2022-08-11T13:01:02.912" v="444" actId="1076"/>
          <ac:spMkLst>
            <pc:docMk/>
            <pc:sldMk cId="2203674866" sldId="258"/>
            <ac:spMk id="42" creationId="{FE337FFA-B824-4EE1-9F6D-089CD364C775}"/>
          </ac:spMkLst>
        </pc:spChg>
        <pc:spChg chg="add mod">
          <ac:chgData name="Sameer G Joshi (DJPR)" userId="bd06337d-ce8c-4c34-b1d1-7fbf8f91b6eb" providerId="ADAL" clId="{7BF6CCE1-D8BE-47A6-A57C-E281D236CFBA}" dt="2022-08-11T13:01:07.857" v="446" actId="1076"/>
          <ac:spMkLst>
            <pc:docMk/>
            <pc:sldMk cId="2203674866" sldId="258"/>
            <ac:spMk id="43" creationId="{FB76B311-2AE7-4DBF-B54C-E5FB9A74F21F}"/>
          </ac:spMkLst>
        </pc:spChg>
        <pc:spChg chg="add mod">
          <ac:chgData name="Sameer G Joshi (DJPR)" userId="bd06337d-ce8c-4c34-b1d1-7fbf8f91b6eb" providerId="ADAL" clId="{7BF6CCE1-D8BE-47A6-A57C-E281D236CFBA}" dt="2022-08-11T13:01:15.251" v="448" actId="1076"/>
          <ac:spMkLst>
            <pc:docMk/>
            <pc:sldMk cId="2203674866" sldId="258"/>
            <ac:spMk id="44" creationId="{0F3A8AB0-77B1-4262-8861-2536D1D41336}"/>
          </ac:spMkLst>
        </pc:spChg>
        <pc:spChg chg="add mod">
          <ac:chgData name="Sameer G Joshi (DJPR)" userId="bd06337d-ce8c-4c34-b1d1-7fbf8f91b6eb" providerId="ADAL" clId="{7BF6CCE1-D8BE-47A6-A57C-E281D236CFBA}" dt="2022-08-11T13:01:23.587" v="450" actId="1076"/>
          <ac:spMkLst>
            <pc:docMk/>
            <pc:sldMk cId="2203674866" sldId="258"/>
            <ac:spMk id="45" creationId="{A4B71550-A597-4C04-9FB8-5454B1EF63FF}"/>
          </ac:spMkLst>
        </pc:spChg>
        <pc:spChg chg="add mod">
          <ac:chgData name="Sameer G Joshi (DJPR)" userId="bd06337d-ce8c-4c34-b1d1-7fbf8f91b6eb" providerId="ADAL" clId="{7BF6CCE1-D8BE-47A6-A57C-E281D236CFBA}" dt="2022-08-11T13:01:34.765" v="452" actId="1076"/>
          <ac:spMkLst>
            <pc:docMk/>
            <pc:sldMk cId="2203674866" sldId="258"/>
            <ac:spMk id="46" creationId="{C0E635D1-F665-4C36-AC1D-B3AB5988752C}"/>
          </ac:spMkLst>
        </pc:spChg>
        <pc:spChg chg="add mod">
          <ac:chgData name="Sameer G Joshi (DJPR)" userId="bd06337d-ce8c-4c34-b1d1-7fbf8f91b6eb" providerId="ADAL" clId="{7BF6CCE1-D8BE-47A6-A57C-E281D236CFBA}" dt="2022-08-11T13:01:57.589" v="456" actId="6549"/>
          <ac:spMkLst>
            <pc:docMk/>
            <pc:sldMk cId="2203674866" sldId="258"/>
            <ac:spMk id="47" creationId="{D0A89AB9-18C6-4F55-8F25-9B8637E97F8C}"/>
          </ac:spMkLst>
        </pc:spChg>
        <pc:spChg chg="add mod">
          <ac:chgData name="Sameer G Joshi (DJPR)" userId="bd06337d-ce8c-4c34-b1d1-7fbf8f91b6eb" providerId="ADAL" clId="{7BF6CCE1-D8BE-47A6-A57C-E281D236CFBA}" dt="2022-08-11T13:02:14.836" v="459" actId="20577"/>
          <ac:spMkLst>
            <pc:docMk/>
            <pc:sldMk cId="2203674866" sldId="258"/>
            <ac:spMk id="48" creationId="{5781666D-E0FF-47C3-A83C-6AFB0EC79806}"/>
          </ac:spMkLst>
        </pc:spChg>
        <pc:spChg chg="add mod">
          <ac:chgData name="Sameer G Joshi (DJPR)" userId="bd06337d-ce8c-4c34-b1d1-7fbf8f91b6eb" providerId="ADAL" clId="{7BF6CCE1-D8BE-47A6-A57C-E281D236CFBA}" dt="2022-08-11T13:02:20.810" v="461" actId="1076"/>
          <ac:spMkLst>
            <pc:docMk/>
            <pc:sldMk cId="2203674866" sldId="258"/>
            <ac:spMk id="49" creationId="{6C814B39-4967-4B79-B03F-D38C2A35F7C3}"/>
          </ac:spMkLst>
        </pc:spChg>
        <pc:spChg chg="add mod">
          <ac:chgData name="Sameer G Joshi (DJPR)" userId="bd06337d-ce8c-4c34-b1d1-7fbf8f91b6eb" providerId="ADAL" clId="{7BF6CCE1-D8BE-47A6-A57C-E281D236CFBA}" dt="2022-08-11T13:02:41.284" v="464" actId="6549"/>
          <ac:spMkLst>
            <pc:docMk/>
            <pc:sldMk cId="2203674866" sldId="258"/>
            <ac:spMk id="50" creationId="{67DF6868-D2A3-4888-AB4B-5D0C0A671CDD}"/>
          </ac:spMkLst>
        </pc:spChg>
        <pc:spChg chg="add mod">
          <ac:chgData name="Sameer G Joshi (DJPR)" userId="bd06337d-ce8c-4c34-b1d1-7fbf8f91b6eb" providerId="ADAL" clId="{7BF6CCE1-D8BE-47A6-A57C-E281D236CFBA}" dt="2022-08-11T13:02:49.827" v="466" actId="1076"/>
          <ac:spMkLst>
            <pc:docMk/>
            <pc:sldMk cId="2203674866" sldId="258"/>
            <ac:spMk id="51" creationId="{963EDC6E-486B-4BD3-9ADD-D7EB120F2FE7}"/>
          </ac:spMkLst>
        </pc:spChg>
        <pc:spChg chg="add mod">
          <ac:chgData name="Sameer G Joshi (DJPR)" userId="bd06337d-ce8c-4c34-b1d1-7fbf8f91b6eb" providerId="ADAL" clId="{7BF6CCE1-D8BE-47A6-A57C-E281D236CFBA}" dt="2022-08-11T13:02:55.568" v="468" actId="1076"/>
          <ac:spMkLst>
            <pc:docMk/>
            <pc:sldMk cId="2203674866" sldId="258"/>
            <ac:spMk id="52" creationId="{2881524A-4C85-4C6E-9C09-46D70BA54760}"/>
          </ac:spMkLst>
        </pc:spChg>
        <pc:spChg chg="add mod">
          <ac:chgData name="Sameer G Joshi (DJPR)" userId="bd06337d-ce8c-4c34-b1d1-7fbf8f91b6eb" providerId="ADAL" clId="{7BF6CCE1-D8BE-47A6-A57C-E281D236CFBA}" dt="2022-08-11T13:03:03.240" v="470" actId="1076"/>
          <ac:spMkLst>
            <pc:docMk/>
            <pc:sldMk cId="2203674866" sldId="258"/>
            <ac:spMk id="53" creationId="{AB8F6861-E218-42D8-B89D-0281CD1A4911}"/>
          </ac:spMkLst>
        </pc:spChg>
        <pc:graphicFrameChg chg="del">
          <ac:chgData name="Sameer G Joshi (DJPR)" userId="bd06337d-ce8c-4c34-b1d1-7fbf8f91b6eb" providerId="ADAL" clId="{7BF6CCE1-D8BE-47A6-A57C-E281D236CFBA}" dt="2022-08-10T01:19:31.364" v="0" actId="478"/>
          <ac:graphicFrameMkLst>
            <pc:docMk/>
            <pc:sldMk cId="2203674866" sldId="258"/>
            <ac:graphicFrameMk id="4" creationId="{420D9C9C-6635-4308-B32A-F1C1403CACCA}"/>
          </ac:graphicFrameMkLst>
        </pc:graphicFrameChg>
        <pc:picChg chg="add del mod modCrop">
          <ac:chgData name="Sameer G Joshi (DJPR)" userId="bd06337d-ce8c-4c34-b1d1-7fbf8f91b6eb" providerId="ADAL" clId="{7BF6CCE1-D8BE-47A6-A57C-E281D236CFBA}" dt="2022-08-11T12:27:22.952" v="86" actId="478"/>
          <ac:picMkLst>
            <pc:docMk/>
            <pc:sldMk cId="2203674866" sldId="258"/>
            <ac:picMk id="3" creationId="{93369F57-50CC-4A4E-B991-0AAE19D46B77}"/>
          </ac:picMkLst>
        </pc:picChg>
        <pc:picChg chg="add mod modCrop">
          <ac:chgData name="Sameer G Joshi (DJPR)" userId="bd06337d-ce8c-4c34-b1d1-7fbf8f91b6eb" providerId="ADAL" clId="{7BF6CCE1-D8BE-47A6-A57C-E281D236CFBA}" dt="2022-08-11T12:47:12.987" v="187" actId="732"/>
          <ac:picMkLst>
            <pc:docMk/>
            <pc:sldMk cId="2203674866" sldId="258"/>
            <ac:picMk id="4" creationId="{78CF50CB-0DD6-47BE-A272-BEF9A7A97B40}"/>
          </ac:picMkLst>
        </pc:picChg>
        <pc:picChg chg="add mod modCrop">
          <ac:chgData name="Sameer G Joshi (DJPR)" userId="bd06337d-ce8c-4c34-b1d1-7fbf8f91b6eb" providerId="ADAL" clId="{7BF6CCE1-D8BE-47A6-A57C-E281D236CFBA}" dt="2022-08-11T12:47:01.016" v="186" actId="732"/>
          <ac:picMkLst>
            <pc:docMk/>
            <pc:sldMk cId="2203674866" sldId="258"/>
            <ac:picMk id="8" creationId="{43501754-DBDE-4EA3-9810-A601709E2D6D}"/>
          </ac:picMkLst>
        </pc:picChg>
        <pc:picChg chg="mod">
          <ac:chgData name="Sameer G Joshi (DJPR)" userId="bd06337d-ce8c-4c34-b1d1-7fbf8f91b6eb" providerId="ADAL" clId="{7BF6CCE1-D8BE-47A6-A57C-E281D236CFBA}" dt="2022-08-11T12:47:30.160" v="191" actId="1076"/>
          <ac:picMkLst>
            <pc:docMk/>
            <pc:sldMk cId="2203674866" sldId="258"/>
            <ac:picMk id="10" creationId="{981463CE-92E3-455D-B01F-2BD9BBE3F108}"/>
          </ac:picMkLst>
        </pc:picChg>
      </pc:sldChg>
      <pc:sldChg chg="addSp modSp mod">
        <pc:chgData name="Sameer G Joshi (DJPR)" userId="bd06337d-ce8c-4c34-b1d1-7fbf8f91b6eb" providerId="ADAL" clId="{7BF6CCE1-D8BE-47A6-A57C-E281D236CFBA}" dt="2022-08-12T01:55:50.998" v="1263" actId="1035"/>
        <pc:sldMkLst>
          <pc:docMk/>
          <pc:sldMk cId="583791291" sldId="265"/>
        </pc:sldMkLst>
        <pc:spChg chg="add mod">
          <ac:chgData name="Sameer G Joshi (DJPR)" userId="bd06337d-ce8c-4c34-b1d1-7fbf8f91b6eb" providerId="ADAL" clId="{7BF6CCE1-D8BE-47A6-A57C-E281D236CFBA}" dt="2022-08-12T00:19:46.297" v="720" actId="1076"/>
          <ac:spMkLst>
            <pc:docMk/>
            <pc:sldMk cId="583791291" sldId="265"/>
            <ac:spMk id="2" creationId="{9928D831-75D2-4FF8-8680-B2BDB02625EF}"/>
          </ac:spMkLst>
        </pc:spChg>
        <pc:spChg chg="add mod">
          <ac:chgData name="Sameer G Joshi (DJPR)" userId="bd06337d-ce8c-4c34-b1d1-7fbf8f91b6eb" providerId="ADAL" clId="{7BF6CCE1-D8BE-47A6-A57C-E281D236CFBA}" dt="2022-08-12T00:20:04.636" v="732" actId="1037"/>
          <ac:spMkLst>
            <pc:docMk/>
            <pc:sldMk cId="583791291" sldId="265"/>
            <ac:spMk id="50" creationId="{28E93C28-AC09-4E46-A0A8-22920607A22A}"/>
          </ac:spMkLst>
        </pc:spChg>
        <pc:spChg chg="add mod">
          <ac:chgData name="Sameer G Joshi (DJPR)" userId="bd06337d-ce8c-4c34-b1d1-7fbf8f91b6eb" providerId="ADAL" clId="{7BF6CCE1-D8BE-47A6-A57C-E281D236CFBA}" dt="2022-08-12T00:20:16.917" v="786" actId="1038"/>
          <ac:spMkLst>
            <pc:docMk/>
            <pc:sldMk cId="583791291" sldId="265"/>
            <ac:spMk id="51" creationId="{264A7844-A01D-428D-B7B3-4EB957E7F94D}"/>
          </ac:spMkLst>
        </pc:spChg>
        <pc:spChg chg="add mod">
          <ac:chgData name="Sameer G Joshi (DJPR)" userId="bd06337d-ce8c-4c34-b1d1-7fbf8f91b6eb" providerId="ADAL" clId="{7BF6CCE1-D8BE-47A6-A57C-E281D236CFBA}" dt="2022-08-12T00:53:54.549" v="808" actId="1036"/>
          <ac:spMkLst>
            <pc:docMk/>
            <pc:sldMk cId="583791291" sldId="265"/>
            <ac:spMk id="52" creationId="{CCF52757-F563-4917-9C5B-627321A78592}"/>
          </ac:spMkLst>
        </pc:spChg>
        <pc:spChg chg="add mod">
          <ac:chgData name="Sameer G Joshi (DJPR)" userId="bd06337d-ce8c-4c34-b1d1-7fbf8f91b6eb" providerId="ADAL" clId="{7BF6CCE1-D8BE-47A6-A57C-E281D236CFBA}" dt="2022-08-12T00:54:15.446" v="810" actId="1076"/>
          <ac:spMkLst>
            <pc:docMk/>
            <pc:sldMk cId="583791291" sldId="265"/>
            <ac:spMk id="53" creationId="{A5967100-5D1E-4CE8-949F-AABED55674F7}"/>
          </ac:spMkLst>
        </pc:spChg>
        <pc:spChg chg="add mod">
          <ac:chgData name="Sameer G Joshi (DJPR)" userId="bd06337d-ce8c-4c34-b1d1-7fbf8f91b6eb" providerId="ADAL" clId="{7BF6CCE1-D8BE-47A6-A57C-E281D236CFBA}" dt="2022-08-12T00:54:21.819" v="812" actId="1076"/>
          <ac:spMkLst>
            <pc:docMk/>
            <pc:sldMk cId="583791291" sldId="265"/>
            <ac:spMk id="54" creationId="{C140FEE1-317E-4CA6-B760-669A0858567E}"/>
          </ac:spMkLst>
        </pc:spChg>
        <pc:spChg chg="add mod">
          <ac:chgData name="Sameer G Joshi (DJPR)" userId="bd06337d-ce8c-4c34-b1d1-7fbf8f91b6eb" providerId="ADAL" clId="{7BF6CCE1-D8BE-47A6-A57C-E281D236CFBA}" dt="2022-08-12T00:54:26.715" v="814" actId="1076"/>
          <ac:spMkLst>
            <pc:docMk/>
            <pc:sldMk cId="583791291" sldId="265"/>
            <ac:spMk id="55" creationId="{B80C3ECE-5734-47D4-AB5E-34DBEE439879}"/>
          </ac:spMkLst>
        </pc:spChg>
        <pc:spChg chg="add mod">
          <ac:chgData name="Sameer G Joshi (DJPR)" userId="bd06337d-ce8c-4c34-b1d1-7fbf8f91b6eb" providerId="ADAL" clId="{7BF6CCE1-D8BE-47A6-A57C-E281D236CFBA}" dt="2022-08-12T00:54:52.003" v="826" actId="1035"/>
          <ac:spMkLst>
            <pc:docMk/>
            <pc:sldMk cId="583791291" sldId="265"/>
            <ac:spMk id="56" creationId="{E296E29F-97D6-4D54-8B6B-3CE84F9D7E8A}"/>
          </ac:spMkLst>
        </pc:spChg>
        <pc:spChg chg="add mod">
          <ac:chgData name="Sameer G Joshi (DJPR)" userId="bd06337d-ce8c-4c34-b1d1-7fbf8f91b6eb" providerId="ADAL" clId="{7BF6CCE1-D8BE-47A6-A57C-E281D236CFBA}" dt="2022-08-12T00:55:13.526" v="837" actId="1038"/>
          <ac:spMkLst>
            <pc:docMk/>
            <pc:sldMk cId="583791291" sldId="265"/>
            <ac:spMk id="57" creationId="{264685D5-6BAF-48C3-A837-6D3683B896D9}"/>
          </ac:spMkLst>
        </pc:spChg>
        <pc:spChg chg="add mod">
          <ac:chgData name="Sameer G Joshi (DJPR)" userId="bd06337d-ce8c-4c34-b1d1-7fbf8f91b6eb" providerId="ADAL" clId="{7BF6CCE1-D8BE-47A6-A57C-E281D236CFBA}" dt="2022-08-12T00:55:22.624" v="841" actId="20577"/>
          <ac:spMkLst>
            <pc:docMk/>
            <pc:sldMk cId="583791291" sldId="265"/>
            <ac:spMk id="58" creationId="{4D3C9220-6614-4ACC-A6A3-A2287D07CD96}"/>
          </ac:spMkLst>
        </pc:spChg>
        <pc:spChg chg="add mod">
          <ac:chgData name="Sameer G Joshi (DJPR)" userId="bd06337d-ce8c-4c34-b1d1-7fbf8f91b6eb" providerId="ADAL" clId="{7BF6CCE1-D8BE-47A6-A57C-E281D236CFBA}" dt="2022-08-12T00:55:37.064" v="845" actId="20577"/>
          <ac:spMkLst>
            <pc:docMk/>
            <pc:sldMk cId="583791291" sldId="265"/>
            <ac:spMk id="59" creationId="{2DFC2118-F2D6-4825-AC76-095C5A057605}"/>
          </ac:spMkLst>
        </pc:spChg>
        <pc:spChg chg="add mod">
          <ac:chgData name="Sameer G Joshi (DJPR)" userId="bd06337d-ce8c-4c34-b1d1-7fbf8f91b6eb" providerId="ADAL" clId="{7BF6CCE1-D8BE-47A6-A57C-E281D236CFBA}" dt="2022-08-12T00:55:48.689" v="854" actId="20577"/>
          <ac:spMkLst>
            <pc:docMk/>
            <pc:sldMk cId="583791291" sldId="265"/>
            <ac:spMk id="60" creationId="{98F23971-91B4-41C7-8037-8ABFBFEC2539}"/>
          </ac:spMkLst>
        </pc:spChg>
        <pc:spChg chg="add mod">
          <ac:chgData name="Sameer G Joshi (DJPR)" userId="bd06337d-ce8c-4c34-b1d1-7fbf8f91b6eb" providerId="ADAL" clId="{7BF6CCE1-D8BE-47A6-A57C-E281D236CFBA}" dt="2022-08-12T00:56:07.735" v="867" actId="1037"/>
          <ac:spMkLst>
            <pc:docMk/>
            <pc:sldMk cId="583791291" sldId="265"/>
            <ac:spMk id="61" creationId="{D98F27B2-A60C-41CB-8001-23422D7E5DB4}"/>
          </ac:spMkLst>
        </pc:spChg>
        <pc:spChg chg="add mod">
          <ac:chgData name="Sameer G Joshi (DJPR)" userId="bd06337d-ce8c-4c34-b1d1-7fbf8f91b6eb" providerId="ADAL" clId="{7BF6CCE1-D8BE-47A6-A57C-E281D236CFBA}" dt="2022-08-12T00:56:25.752" v="872" actId="1037"/>
          <ac:spMkLst>
            <pc:docMk/>
            <pc:sldMk cId="583791291" sldId="265"/>
            <ac:spMk id="62" creationId="{8C7E9926-B5A8-4DA8-A842-C9C2423DA934}"/>
          </ac:spMkLst>
        </pc:spChg>
        <pc:spChg chg="add mod">
          <ac:chgData name="Sameer G Joshi (DJPR)" userId="bd06337d-ce8c-4c34-b1d1-7fbf8f91b6eb" providerId="ADAL" clId="{7BF6CCE1-D8BE-47A6-A57C-E281D236CFBA}" dt="2022-08-12T00:56:40.057" v="883" actId="1038"/>
          <ac:spMkLst>
            <pc:docMk/>
            <pc:sldMk cId="583791291" sldId="265"/>
            <ac:spMk id="63" creationId="{C664E406-8BD0-4530-8A56-9DF78B21013E}"/>
          </ac:spMkLst>
        </pc:spChg>
        <pc:spChg chg="add mod">
          <ac:chgData name="Sameer G Joshi (DJPR)" userId="bd06337d-ce8c-4c34-b1d1-7fbf8f91b6eb" providerId="ADAL" clId="{7BF6CCE1-D8BE-47A6-A57C-E281D236CFBA}" dt="2022-08-12T00:56:49.975" v="891" actId="20577"/>
          <ac:spMkLst>
            <pc:docMk/>
            <pc:sldMk cId="583791291" sldId="265"/>
            <ac:spMk id="64" creationId="{461342C0-3CAC-4A68-ADA4-19A2B6299CAA}"/>
          </ac:spMkLst>
        </pc:spChg>
        <pc:spChg chg="add mod">
          <ac:chgData name="Sameer G Joshi (DJPR)" userId="bd06337d-ce8c-4c34-b1d1-7fbf8f91b6eb" providerId="ADAL" clId="{7BF6CCE1-D8BE-47A6-A57C-E281D236CFBA}" dt="2022-08-12T01:42:23.236" v="966" actId="20577"/>
          <ac:spMkLst>
            <pc:docMk/>
            <pc:sldMk cId="583791291" sldId="265"/>
            <ac:spMk id="65" creationId="{055CF21B-6B13-4C06-B662-860949BC9FAF}"/>
          </ac:spMkLst>
        </pc:spChg>
        <pc:spChg chg="add mod">
          <ac:chgData name="Sameer G Joshi (DJPR)" userId="bd06337d-ce8c-4c34-b1d1-7fbf8f91b6eb" providerId="ADAL" clId="{7BF6CCE1-D8BE-47A6-A57C-E281D236CFBA}" dt="2022-08-12T01:42:28.883" v="973" actId="20577"/>
          <ac:spMkLst>
            <pc:docMk/>
            <pc:sldMk cId="583791291" sldId="265"/>
            <ac:spMk id="66" creationId="{D4EA47F0-1A41-43DE-9AFB-2A8EE95FECAF}"/>
          </ac:spMkLst>
        </pc:spChg>
        <pc:spChg chg="add mod">
          <ac:chgData name="Sameer G Joshi (DJPR)" userId="bd06337d-ce8c-4c34-b1d1-7fbf8f91b6eb" providerId="ADAL" clId="{7BF6CCE1-D8BE-47A6-A57C-E281D236CFBA}" dt="2022-08-12T01:42:34.132" v="980" actId="20577"/>
          <ac:spMkLst>
            <pc:docMk/>
            <pc:sldMk cId="583791291" sldId="265"/>
            <ac:spMk id="67" creationId="{BEEDFE4B-618B-49CC-A15D-0BF54FB00061}"/>
          </ac:spMkLst>
        </pc:spChg>
        <pc:spChg chg="add mod">
          <ac:chgData name="Sameer G Joshi (DJPR)" userId="bd06337d-ce8c-4c34-b1d1-7fbf8f91b6eb" providerId="ADAL" clId="{7BF6CCE1-D8BE-47A6-A57C-E281D236CFBA}" dt="2022-08-12T01:42:44.678" v="985" actId="1037"/>
          <ac:spMkLst>
            <pc:docMk/>
            <pc:sldMk cId="583791291" sldId="265"/>
            <ac:spMk id="68" creationId="{F5DDE670-4D17-4C26-971F-2A0FD7B4EA63}"/>
          </ac:spMkLst>
        </pc:spChg>
        <pc:spChg chg="add mod">
          <ac:chgData name="Sameer G Joshi (DJPR)" userId="bd06337d-ce8c-4c34-b1d1-7fbf8f91b6eb" providerId="ADAL" clId="{7BF6CCE1-D8BE-47A6-A57C-E281D236CFBA}" dt="2022-08-12T01:42:49.132" v="987" actId="20577"/>
          <ac:spMkLst>
            <pc:docMk/>
            <pc:sldMk cId="583791291" sldId="265"/>
            <ac:spMk id="69" creationId="{C0CDBF3F-11BA-4F5C-89D5-3C23A5F77847}"/>
          </ac:spMkLst>
        </pc:spChg>
        <pc:spChg chg="add mod">
          <ac:chgData name="Sameer G Joshi (DJPR)" userId="bd06337d-ce8c-4c34-b1d1-7fbf8f91b6eb" providerId="ADAL" clId="{7BF6CCE1-D8BE-47A6-A57C-E281D236CFBA}" dt="2022-08-12T01:42:51.620" v="989" actId="20577"/>
          <ac:spMkLst>
            <pc:docMk/>
            <pc:sldMk cId="583791291" sldId="265"/>
            <ac:spMk id="70" creationId="{CF7D25EB-F6F8-445A-A4EC-8A6281671FF1}"/>
          </ac:spMkLst>
        </pc:spChg>
        <pc:spChg chg="add mod">
          <ac:chgData name="Sameer G Joshi (DJPR)" userId="bd06337d-ce8c-4c34-b1d1-7fbf8f91b6eb" providerId="ADAL" clId="{7BF6CCE1-D8BE-47A6-A57C-E281D236CFBA}" dt="2022-08-12T01:42:55.028" v="991" actId="20577"/>
          <ac:spMkLst>
            <pc:docMk/>
            <pc:sldMk cId="583791291" sldId="265"/>
            <ac:spMk id="71" creationId="{EFE5208B-6517-4F9B-822D-A3CDC0671655}"/>
          </ac:spMkLst>
        </pc:spChg>
        <pc:spChg chg="add mod">
          <ac:chgData name="Sameer G Joshi (DJPR)" userId="bd06337d-ce8c-4c34-b1d1-7fbf8f91b6eb" providerId="ADAL" clId="{7BF6CCE1-D8BE-47A6-A57C-E281D236CFBA}" dt="2022-08-12T01:43:05.252" v="998" actId="20577"/>
          <ac:spMkLst>
            <pc:docMk/>
            <pc:sldMk cId="583791291" sldId="265"/>
            <ac:spMk id="72" creationId="{00D25EE0-2371-4977-9D75-9EFC831DB600}"/>
          </ac:spMkLst>
        </pc:spChg>
        <pc:spChg chg="add mod">
          <ac:chgData name="Sameer G Joshi (DJPR)" userId="bd06337d-ce8c-4c34-b1d1-7fbf8f91b6eb" providerId="ADAL" clId="{7BF6CCE1-D8BE-47A6-A57C-E281D236CFBA}" dt="2022-08-12T01:43:14.412" v="1004" actId="20577"/>
          <ac:spMkLst>
            <pc:docMk/>
            <pc:sldMk cId="583791291" sldId="265"/>
            <ac:spMk id="73" creationId="{629F8CBC-CECC-4872-8C4C-85C890807161}"/>
          </ac:spMkLst>
        </pc:spChg>
        <pc:spChg chg="add mod">
          <ac:chgData name="Sameer G Joshi (DJPR)" userId="bd06337d-ce8c-4c34-b1d1-7fbf8f91b6eb" providerId="ADAL" clId="{7BF6CCE1-D8BE-47A6-A57C-E281D236CFBA}" dt="2022-08-12T01:43:28.446" v="1019" actId="1038"/>
          <ac:spMkLst>
            <pc:docMk/>
            <pc:sldMk cId="583791291" sldId="265"/>
            <ac:spMk id="74" creationId="{068AEC07-E048-4554-9275-18E27E182A13}"/>
          </ac:spMkLst>
        </pc:spChg>
        <pc:spChg chg="add mod">
          <ac:chgData name="Sameer G Joshi (DJPR)" userId="bd06337d-ce8c-4c34-b1d1-7fbf8f91b6eb" providerId="ADAL" clId="{7BF6CCE1-D8BE-47A6-A57C-E281D236CFBA}" dt="2022-08-12T01:43:46.621" v="1024" actId="20577"/>
          <ac:spMkLst>
            <pc:docMk/>
            <pc:sldMk cId="583791291" sldId="265"/>
            <ac:spMk id="75" creationId="{2C426480-DBC1-4136-9F79-A7303A62FE59}"/>
          </ac:spMkLst>
        </pc:spChg>
        <pc:spChg chg="add mod">
          <ac:chgData name="Sameer G Joshi (DJPR)" userId="bd06337d-ce8c-4c34-b1d1-7fbf8f91b6eb" providerId="ADAL" clId="{7BF6CCE1-D8BE-47A6-A57C-E281D236CFBA}" dt="2022-08-12T01:43:58.756" v="1029" actId="20577"/>
          <ac:spMkLst>
            <pc:docMk/>
            <pc:sldMk cId="583791291" sldId="265"/>
            <ac:spMk id="76" creationId="{6BA394A8-3596-4C25-8AF5-2DC2F4A338E3}"/>
          </ac:spMkLst>
        </pc:spChg>
        <pc:spChg chg="add mod">
          <ac:chgData name="Sameer G Joshi (DJPR)" userId="bd06337d-ce8c-4c34-b1d1-7fbf8f91b6eb" providerId="ADAL" clId="{7BF6CCE1-D8BE-47A6-A57C-E281D236CFBA}" dt="2022-08-12T01:44:16.199" v="1043" actId="1038"/>
          <ac:spMkLst>
            <pc:docMk/>
            <pc:sldMk cId="583791291" sldId="265"/>
            <ac:spMk id="77" creationId="{04F32AB1-0310-43C8-8138-C005C1119C70}"/>
          </ac:spMkLst>
        </pc:spChg>
        <pc:spChg chg="add mod">
          <ac:chgData name="Sameer G Joshi (DJPR)" userId="bd06337d-ce8c-4c34-b1d1-7fbf8f91b6eb" providerId="ADAL" clId="{7BF6CCE1-D8BE-47A6-A57C-E281D236CFBA}" dt="2022-08-12T01:44:27.139" v="1045" actId="1076"/>
          <ac:spMkLst>
            <pc:docMk/>
            <pc:sldMk cId="583791291" sldId="265"/>
            <ac:spMk id="78" creationId="{D268E627-E776-458F-A28D-8F02FE6B731E}"/>
          </ac:spMkLst>
        </pc:spChg>
        <pc:spChg chg="add mod">
          <ac:chgData name="Sameer G Joshi (DJPR)" userId="bd06337d-ce8c-4c34-b1d1-7fbf8f91b6eb" providerId="ADAL" clId="{7BF6CCE1-D8BE-47A6-A57C-E281D236CFBA}" dt="2022-08-12T01:44:35.204" v="1049" actId="20577"/>
          <ac:spMkLst>
            <pc:docMk/>
            <pc:sldMk cId="583791291" sldId="265"/>
            <ac:spMk id="79" creationId="{76EB2875-0049-479B-947D-F1059F6EFA65}"/>
          </ac:spMkLst>
        </pc:spChg>
        <pc:spChg chg="add mod">
          <ac:chgData name="Sameer G Joshi (DJPR)" userId="bd06337d-ce8c-4c34-b1d1-7fbf8f91b6eb" providerId="ADAL" clId="{7BF6CCE1-D8BE-47A6-A57C-E281D236CFBA}" dt="2022-08-12T01:44:50.532" v="1053" actId="20577"/>
          <ac:spMkLst>
            <pc:docMk/>
            <pc:sldMk cId="583791291" sldId="265"/>
            <ac:spMk id="80" creationId="{1717EC37-60E9-4457-8D4B-A95A951290BC}"/>
          </ac:spMkLst>
        </pc:spChg>
        <pc:spChg chg="add mod">
          <ac:chgData name="Sameer G Joshi (DJPR)" userId="bd06337d-ce8c-4c34-b1d1-7fbf8f91b6eb" providerId="ADAL" clId="{7BF6CCE1-D8BE-47A6-A57C-E281D236CFBA}" dt="2022-08-12T01:52:54.774" v="1056" actId="20577"/>
          <ac:spMkLst>
            <pc:docMk/>
            <pc:sldMk cId="583791291" sldId="265"/>
            <ac:spMk id="81" creationId="{91A6DD42-4E4B-49FC-B281-D8F23E9C8239}"/>
          </ac:spMkLst>
        </pc:spChg>
        <pc:spChg chg="add mod">
          <ac:chgData name="Sameer G Joshi (DJPR)" userId="bd06337d-ce8c-4c34-b1d1-7fbf8f91b6eb" providerId="ADAL" clId="{7BF6CCE1-D8BE-47A6-A57C-E281D236CFBA}" dt="2022-08-12T01:53:10.917" v="1058" actId="1076"/>
          <ac:spMkLst>
            <pc:docMk/>
            <pc:sldMk cId="583791291" sldId="265"/>
            <ac:spMk id="82" creationId="{BDB519FD-178D-4515-A085-A1FF99C9A76E}"/>
          </ac:spMkLst>
        </pc:spChg>
        <pc:spChg chg="add mod">
          <ac:chgData name="Sameer G Joshi (DJPR)" userId="bd06337d-ce8c-4c34-b1d1-7fbf8f91b6eb" providerId="ADAL" clId="{7BF6CCE1-D8BE-47A6-A57C-E281D236CFBA}" dt="2022-08-12T01:53:17.883" v="1061" actId="1038"/>
          <ac:spMkLst>
            <pc:docMk/>
            <pc:sldMk cId="583791291" sldId="265"/>
            <ac:spMk id="83" creationId="{1CCF77AC-43A3-480F-B3E0-2C116968E019}"/>
          </ac:spMkLst>
        </pc:spChg>
        <pc:spChg chg="add mod">
          <ac:chgData name="Sameer G Joshi (DJPR)" userId="bd06337d-ce8c-4c34-b1d1-7fbf8f91b6eb" providerId="ADAL" clId="{7BF6CCE1-D8BE-47A6-A57C-E281D236CFBA}" dt="2022-08-12T01:53:22.984" v="1063" actId="1076"/>
          <ac:spMkLst>
            <pc:docMk/>
            <pc:sldMk cId="583791291" sldId="265"/>
            <ac:spMk id="84" creationId="{14D47036-55F5-4023-8369-6415E2E7E828}"/>
          </ac:spMkLst>
        </pc:spChg>
        <pc:spChg chg="add mod">
          <ac:chgData name="Sameer G Joshi (DJPR)" userId="bd06337d-ce8c-4c34-b1d1-7fbf8f91b6eb" providerId="ADAL" clId="{7BF6CCE1-D8BE-47A6-A57C-E281D236CFBA}" dt="2022-08-12T01:53:39.222" v="1065" actId="1076"/>
          <ac:spMkLst>
            <pc:docMk/>
            <pc:sldMk cId="583791291" sldId="265"/>
            <ac:spMk id="85" creationId="{DA3E5D05-1BBF-410B-86E6-C67E9AF58049}"/>
          </ac:spMkLst>
        </pc:spChg>
        <pc:spChg chg="add mod">
          <ac:chgData name="Sameer G Joshi (DJPR)" userId="bd06337d-ce8c-4c34-b1d1-7fbf8f91b6eb" providerId="ADAL" clId="{7BF6CCE1-D8BE-47A6-A57C-E281D236CFBA}" dt="2022-08-12T01:53:47.240" v="1068" actId="20577"/>
          <ac:spMkLst>
            <pc:docMk/>
            <pc:sldMk cId="583791291" sldId="265"/>
            <ac:spMk id="86" creationId="{35393269-D881-4B0A-85F3-29C605D81BEB}"/>
          </ac:spMkLst>
        </pc:spChg>
        <pc:spChg chg="add mod">
          <ac:chgData name="Sameer G Joshi (DJPR)" userId="bd06337d-ce8c-4c34-b1d1-7fbf8f91b6eb" providerId="ADAL" clId="{7BF6CCE1-D8BE-47A6-A57C-E281D236CFBA}" dt="2022-08-12T01:53:54.089" v="1071" actId="20577"/>
          <ac:spMkLst>
            <pc:docMk/>
            <pc:sldMk cId="583791291" sldId="265"/>
            <ac:spMk id="87" creationId="{D109453B-4764-4674-AC2B-2B4E15926C22}"/>
          </ac:spMkLst>
        </pc:spChg>
        <pc:spChg chg="add mod">
          <ac:chgData name="Sameer G Joshi (DJPR)" userId="bd06337d-ce8c-4c34-b1d1-7fbf8f91b6eb" providerId="ADAL" clId="{7BF6CCE1-D8BE-47A6-A57C-E281D236CFBA}" dt="2022-08-12T01:54:08.608" v="1075" actId="20577"/>
          <ac:spMkLst>
            <pc:docMk/>
            <pc:sldMk cId="583791291" sldId="265"/>
            <ac:spMk id="88" creationId="{6C4F3A42-9B9D-40C2-B323-F7CC71364178}"/>
          </ac:spMkLst>
        </pc:spChg>
        <pc:spChg chg="add mod">
          <ac:chgData name="Sameer G Joshi (DJPR)" userId="bd06337d-ce8c-4c34-b1d1-7fbf8f91b6eb" providerId="ADAL" clId="{7BF6CCE1-D8BE-47A6-A57C-E281D236CFBA}" dt="2022-08-12T01:54:22.268" v="1082" actId="1037"/>
          <ac:spMkLst>
            <pc:docMk/>
            <pc:sldMk cId="583791291" sldId="265"/>
            <ac:spMk id="89" creationId="{62348AE6-2252-480C-9B8F-BEBF76B4ABB7}"/>
          </ac:spMkLst>
        </pc:spChg>
        <pc:spChg chg="add mod">
          <ac:chgData name="Sameer G Joshi (DJPR)" userId="bd06337d-ce8c-4c34-b1d1-7fbf8f91b6eb" providerId="ADAL" clId="{7BF6CCE1-D8BE-47A6-A57C-E281D236CFBA}" dt="2022-08-12T01:54:45.085" v="1150" actId="1038"/>
          <ac:spMkLst>
            <pc:docMk/>
            <pc:sldMk cId="583791291" sldId="265"/>
            <ac:spMk id="90" creationId="{E888F0B3-C55E-4816-9E67-2F6698445276}"/>
          </ac:spMkLst>
        </pc:spChg>
        <pc:spChg chg="add mod">
          <ac:chgData name="Sameer G Joshi (DJPR)" userId="bd06337d-ce8c-4c34-b1d1-7fbf8f91b6eb" providerId="ADAL" clId="{7BF6CCE1-D8BE-47A6-A57C-E281D236CFBA}" dt="2022-08-12T01:54:56.793" v="1153" actId="20577"/>
          <ac:spMkLst>
            <pc:docMk/>
            <pc:sldMk cId="583791291" sldId="265"/>
            <ac:spMk id="91" creationId="{9CE48794-1870-4E1C-A170-75FABA3D66AC}"/>
          </ac:spMkLst>
        </pc:spChg>
        <pc:spChg chg="add mod">
          <ac:chgData name="Sameer G Joshi (DJPR)" userId="bd06337d-ce8c-4c34-b1d1-7fbf8f91b6eb" providerId="ADAL" clId="{7BF6CCE1-D8BE-47A6-A57C-E281D236CFBA}" dt="2022-08-12T01:55:03.666" v="1155" actId="1076"/>
          <ac:spMkLst>
            <pc:docMk/>
            <pc:sldMk cId="583791291" sldId="265"/>
            <ac:spMk id="92" creationId="{7BEB3841-54C9-4973-9CEF-15D60308F905}"/>
          </ac:spMkLst>
        </pc:spChg>
        <pc:spChg chg="add mod">
          <ac:chgData name="Sameer G Joshi (DJPR)" userId="bd06337d-ce8c-4c34-b1d1-7fbf8f91b6eb" providerId="ADAL" clId="{7BF6CCE1-D8BE-47A6-A57C-E281D236CFBA}" dt="2022-08-12T01:55:16.081" v="1158" actId="20577"/>
          <ac:spMkLst>
            <pc:docMk/>
            <pc:sldMk cId="583791291" sldId="265"/>
            <ac:spMk id="93" creationId="{C1090951-AB22-49E2-AB0D-A56B28839A37}"/>
          </ac:spMkLst>
        </pc:spChg>
        <pc:spChg chg="add mod">
          <ac:chgData name="Sameer G Joshi (DJPR)" userId="bd06337d-ce8c-4c34-b1d1-7fbf8f91b6eb" providerId="ADAL" clId="{7BF6CCE1-D8BE-47A6-A57C-E281D236CFBA}" dt="2022-08-12T01:55:31.869" v="1199" actId="1037"/>
          <ac:spMkLst>
            <pc:docMk/>
            <pc:sldMk cId="583791291" sldId="265"/>
            <ac:spMk id="94" creationId="{9D2C78AE-C914-4E41-B41D-D4FA02678D88}"/>
          </ac:spMkLst>
        </pc:spChg>
        <pc:spChg chg="add mod">
          <ac:chgData name="Sameer G Joshi (DJPR)" userId="bd06337d-ce8c-4c34-b1d1-7fbf8f91b6eb" providerId="ADAL" clId="{7BF6CCE1-D8BE-47A6-A57C-E281D236CFBA}" dt="2022-08-12T01:55:44.054" v="1225" actId="1037"/>
          <ac:spMkLst>
            <pc:docMk/>
            <pc:sldMk cId="583791291" sldId="265"/>
            <ac:spMk id="95" creationId="{15D05E4A-2EC8-441C-8FA2-9BD076F311E2}"/>
          </ac:spMkLst>
        </pc:spChg>
        <pc:spChg chg="add mod">
          <ac:chgData name="Sameer G Joshi (DJPR)" userId="bd06337d-ce8c-4c34-b1d1-7fbf8f91b6eb" providerId="ADAL" clId="{7BF6CCE1-D8BE-47A6-A57C-E281D236CFBA}" dt="2022-08-12T01:55:50.998" v="1263" actId="1035"/>
          <ac:spMkLst>
            <pc:docMk/>
            <pc:sldMk cId="583791291" sldId="265"/>
            <ac:spMk id="96" creationId="{3B6616F2-5917-4ACB-BFA2-57BD394644AC}"/>
          </ac:spMkLst>
        </pc:spChg>
      </pc:sldChg>
      <pc:sldChg chg="addSp delSp modSp mod">
        <pc:chgData name="Sameer G Joshi (DJPR)" userId="bd06337d-ce8c-4c34-b1d1-7fbf8f91b6eb" providerId="ADAL" clId="{7BF6CCE1-D8BE-47A6-A57C-E281D236CFBA}" dt="2022-08-12T02:35:44.283" v="1491" actId="20577"/>
        <pc:sldMkLst>
          <pc:docMk/>
          <pc:sldMk cId="3253327431" sldId="266"/>
        </pc:sldMkLst>
        <pc:spChg chg="add mod">
          <ac:chgData name="Sameer G Joshi (DJPR)" userId="bd06337d-ce8c-4c34-b1d1-7fbf8f91b6eb" providerId="ADAL" clId="{7BF6CCE1-D8BE-47A6-A57C-E281D236CFBA}" dt="2022-08-12T02:05:30.959" v="1266" actId="20577"/>
          <ac:spMkLst>
            <pc:docMk/>
            <pc:sldMk cId="3253327431" sldId="266"/>
            <ac:spMk id="47" creationId="{113B18E3-BCA8-4904-8867-9584E1ED2909}"/>
          </ac:spMkLst>
        </pc:spChg>
        <pc:spChg chg="add mod">
          <ac:chgData name="Sameer G Joshi (DJPR)" userId="bd06337d-ce8c-4c34-b1d1-7fbf8f91b6eb" providerId="ADAL" clId="{7BF6CCE1-D8BE-47A6-A57C-E281D236CFBA}" dt="2022-08-12T02:05:44.907" v="1277" actId="1036"/>
          <ac:spMkLst>
            <pc:docMk/>
            <pc:sldMk cId="3253327431" sldId="266"/>
            <ac:spMk id="55" creationId="{08209AE6-6F58-4664-9BC2-3058181D2157}"/>
          </ac:spMkLst>
        </pc:spChg>
        <pc:spChg chg="add mod">
          <ac:chgData name="Sameer G Joshi (DJPR)" userId="bd06337d-ce8c-4c34-b1d1-7fbf8f91b6eb" providerId="ADAL" clId="{7BF6CCE1-D8BE-47A6-A57C-E281D236CFBA}" dt="2022-08-12T02:05:50.278" v="1279" actId="1076"/>
          <ac:spMkLst>
            <pc:docMk/>
            <pc:sldMk cId="3253327431" sldId="266"/>
            <ac:spMk id="56" creationId="{C9748069-A4C3-43CF-AD3B-FD82F0E952B9}"/>
          </ac:spMkLst>
        </pc:spChg>
        <pc:spChg chg="add mod">
          <ac:chgData name="Sameer G Joshi (DJPR)" userId="bd06337d-ce8c-4c34-b1d1-7fbf8f91b6eb" providerId="ADAL" clId="{7BF6CCE1-D8BE-47A6-A57C-E281D236CFBA}" dt="2022-08-12T02:05:55.936" v="1281" actId="1076"/>
          <ac:spMkLst>
            <pc:docMk/>
            <pc:sldMk cId="3253327431" sldId="266"/>
            <ac:spMk id="57" creationId="{C437B6C9-0159-4707-A79D-1A132B04B189}"/>
          </ac:spMkLst>
        </pc:spChg>
        <pc:spChg chg="add mod">
          <ac:chgData name="Sameer G Joshi (DJPR)" userId="bd06337d-ce8c-4c34-b1d1-7fbf8f91b6eb" providerId="ADAL" clId="{7BF6CCE1-D8BE-47A6-A57C-E281D236CFBA}" dt="2022-08-12T02:06:04.216" v="1283" actId="1076"/>
          <ac:spMkLst>
            <pc:docMk/>
            <pc:sldMk cId="3253327431" sldId="266"/>
            <ac:spMk id="58" creationId="{E7B79C6D-8256-46D3-BB2D-C8AF838BAA23}"/>
          </ac:spMkLst>
        </pc:spChg>
        <pc:spChg chg="add mod">
          <ac:chgData name="Sameer G Joshi (DJPR)" userId="bd06337d-ce8c-4c34-b1d1-7fbf8f91b6eb" providerId="ADAL" clId="{7BF6CCE1-D8BE-47A6-A57C-E281D236CFBA}" dt="2022-08-12T02:06:16.622" v="1286" actId="20577"/>
          <ac:spMkLst>
            <pc:docMk/>
            <pc:sldMk cId="3253327431" sldId="266"/>
            <ac:spMk id="59" creationId="{7217705F-1246-4541-900D-742B1177A58C}"/>
          </ac:spMkLst>
        </pc:spChg>
        <pc:spChg chg="add mod">
          <ac:chgData name="Sameer G Joshi (DJPR)" userId="bd06337d-ce8c-4c34-b1d1-7fbf8f91b6eb" providerId="ADAL" clId="{7BF6CCE1-D8BE-47A6-A57C-E281D236CFBA}" dt="2022-08-12T02:06:28.528" v="1293" actId="1038"/>
          <ac:spMkLst>
            <pc:docMk/>
            <pc:sldMk cId="3253327431" sldId="266"/>
            <ac:spMk id="60" creationId="{D87190BC-AD5A-4890-9AF9-D9BE01DC2B61}"/>
          </ac:spMkLst>
        </pc:spChg>
        <pc:spChg chg="add mod">
          <ac:chgData name="Sameer G Joshi (DJPR)" userId="bd06337d-ce8c-4c34-b1d1-7fbf8f91b6eb" providerId="ADAL" clId="{7BF6CCE1-D8BE-47A6-A57C-E281D236CFBA}" dt="2022-08-12T02:06:44.460" v="1301" actId="1037"/>
          <ac:spMkLst>
            <pc:docMk/>
            <pc:sldMk cId="3253327431" sldId="266"/>
            <ac:spMk id="61" creationId="{6F88566B-EB00-4BC0-8446-198836181296}"/>
          </ac:spMkLst>
        </pc:spChg>
        <pc:spChg chg="add mod">
          <ac:chgData name="Sameer G Joshi (DJPR)" userId="bd06337d-ce8c-4c34-b1d1-7fbf8f91b6eb" providerId="ADAL" clId="{7BF6CCE1-D8BE-47A6-A57C-E281D236CFBA}" dt="2022-08-12T02:06:49.667" v="1303" actId="1076"/>
          <ac:spMkLst>
            <pc:docMk/>
            <pc:sldMk cId="3253327431" sldId="266"/>
            <ac:spMk id="62" creationId="{ED70E077-BE2E-4F83-A0A5-78DCCC524FDC}"/>
          </ac:spMkLst>
        </pc:spChg>
        <pc:spChg chg="add mod">
          <ac:chgData name="Sameer G Joshi (DJPR)" userId="bd06337d-ce8c-4c34-b1d1-7fbf8f91b6eb" providerId="ADAL" clId="{7BF6CCE1-D8BE-47A6-A57C-E281D236CFBA}" dt="2022-08-12T02:07:01.124" v="1311" actId="1038"/>
          <ac:spMkLst>
            <pc:docMk/>
            <pc:sldMk cId="3253327431" sldId="266"/>
            <ac:spMk id="63" creationId="{E996F7A7-5BAC-403F-951C-D32EF5E46AC4}"/>
          </ac:spMkLst>
        </pc:spChg>
        <pc:spChg chg="add mod">
          <ac:chgData name="Sameer G Joshi (DJPR)" userId="bd06337d-ce8c-4c34-b1d1-7fbf8f91b6eb" providerId="ADAL" clId="{7BF6CCE1-D8BE-47A6-A57C-E281D236CFBA}" dt="2022-08-12T02:07:10.251" v="1313" actId="1076"/>
          <ac:spMkLst>
            <pc:docMk/>
            <pc:sldMk cId="3253327431" sldId="266"/>
            <ac:spMk id="64" creationId="{9401A543-478E-437F-AB93-4CAF2A17510E}"/>
          </ac:spMkLst>
        </pc:spChg>
        <pc:spChg chg="add mod">
          <ac:chgData name="Sameer G Joshi (DJPR)" userId="bd06337d-ce8c-4c34-b1d1-7fbf8f91b6eb" providerId="ADAL" clId="{7BF6CCE1-D8BE-47A6-A57C-E281D236CFBA}" dt="2022-08-12T02:07:15.868" v="1315" actId="1076"/>
          <ac:spMkLst>
            <pc:docMk/>
            <pc:sldMk cId="3253327431" sldId="266"/>
            <ac:spMk id="65" creationId="{31169412-79D0-4F38-BBCE-70AD199577D1}"/>
          </ac:spMkLst>
        </pc:spChg>
        <pc:spChg chg="add mod">
          <ac:chgData name="Sameer G Joshi (DJPR)" userId="bd06337d-ce8c-4c34-b1d1-7fbf8f91b6eb" providerId="ADAL" clId="{7BF6CCE1-D8BE-47A6-A57C-E281D236CFBA}" dt="2022-08-12T02:07:23.107" v="1318" actId="20577"/>
          <ac:spMkLst>
            <pc:docMk/>
            <pc:sldMk cId="3253327431" sldId="266"/>
            <ac:spMk id="66" creationId="{53D4C34C-CF0B-45E2-A637-C69CFBDAA597}"/>
          </ac:spMkLst>
        </pc:spChg>
        <pc:spChg chg="add mod">
          <ac:chgData name="Sameer G Joshi (DJPR)" userId="bd06337d-ce8c-4c34-b1d1-7fbf8f91b6eb" providerId="ADAL" clId="{7BF6CCE1-D8BE-47A6-A57C-E281D236CFBA}" dt="2022-08-12T02:35:44.283" v="1491" actId="20577"/>
          <ac:spMkLst>
            <pc:docMk/>
            <pc:sldMk cId="3253327431" sldId="266"/>
            <ac:spMk id="67" creationId="{F05BB7E5-0414-46E3-ACA2-7A724BD64068}"/>
          </ac:spMkLst>
        </pc:spChg>
        <pc:spChg chg="add mod">
          <ac:chgData name="Sameer G Joshi (DJPR)" userId="bd06337d-ce8c-4c34-b1d1-7fbf8f91b6eb" providerId="ADAL" clId="{7BF6CCE1-D8BE-47A6-A57C-E281D236CFBA}" dt="2022-08-12T02:07:55.781" v="1331" actId="1037"/>
          <ac:spMkLst>
            <pc:docMk/>
            <pc:sldMk cId="3253327431" sldId="266"/>
            <ac:spMk id="68" creationId="{6A7CD8FA-B2DE-4867-8DA9-37A67FB47D5F}"/>
          </ac:spMkLst>
        </pc:spChg>
        <pc:spChg chg="add mod">
          <ac:chgData name="Sameer G Joshi (DJPR)" userId="bd06337d-ce8c-4c34-b1d1-7fbf8f91b6eb" providerId="ADAL" clId="{7BF6CCE1-D8BE-47A6-A57C-E281D236CFBA}" dt="2022-08-12T02:08:10.093" v="1380" actId="1038"/>
          <ac:spMkLst>
            <pc:docMk/>
            <pc:sldMk cId="3253327431" sldId="266"/>
            <ac:spMk id="69" creationId="{04A00608-BAAE-42BC-B487-0BE4C378D83E}"/>
          </ac:spMkLst>
        </pc:spChg>
        <pc:spChg chg="add mod">
          <ac:chgData name="Sameer G Joshi (DJPR)" userId="bd06337d-ce8c-4c34-b1d1-7fbf8f91b6eb" providerId="ADAL" clId="{7BF6CCE1-D8BE-47A6-A57C-E281D236CFBA}" dt="2022-08-12T02:29:10.174" v="1383" actId="20577"/>
          <ac:spMkLst>
            <pc:docMk/>
            <pc:sldMk cId="3253327431" sldId="266"/>
            <ac:spMk id="70" creationId="{60522944-7842-4F7B-A239-C52F537E68BD}"/>
          </ac:spMkLst>
        </pc:spChg>
        <pc:spChg chg="add mod">
          <ac:chgData name="Sameer G Joshi (DJPR)" userId="bd06337d-ce8c-4c34-b1d1-7fbf8f91b6eb" providerId="ADAL" clId="{7BF6CCE1-D8BE-47A6-A57C-E281D236CFBA}" dt="2022-08-12T02:29:19.860" v="1386" actId="20577"/>
          <ac:spMkLst>
            <pc:docMk/>
            <pc:sldMk cId="3253327431" sldId="266"/>
            <ac:spMk id="71" creationId="{A46463BE-FB71-4C5B-89BA-A1FAD008454C}"/>
          </ac:spMkLst>
        </pc:spChg>
        <pc:spChg chg="add mod">
          <ac:chgData name="Sameer G Joshi (DJPR)" userId="bd06337d-ce8c-4c34-b1d1-7fbf8f91b6eb" providerId="ADAL" clId="{7BF6CCE1-D8BE-47A6-A57C-E281D236CFBA}" dt="2022-08-12T02:29:33.014" v="1399" actId="1037"/>
          <ac:spMkLst>
            <pc:docMk/>
            <pc:sldMk cId="3253327431" sldId="266"/>
            <ac:spMk id="72" creationId="{97F9E3C1-CE8C-493E-85BC-8090BFB17DF1}"/>
          </ac:spMkLst>
        </pc:spChg>
        <pc:spChg chg="add mod">
          <ac:chgData name="Sameer G Joshi (DJPR)" userId="bd06337d-ce8c-4c34-b1d1-7fbf8f91b6eb" providerId="ADAL" clId="{7BF6CCE1-D8BE-47A6-A57C-E281D236CFBA}" dt="2022-08-12T02:29:47.158" v="1411" actId="1038"/>
          <ac:spMkLst>
            <pc:docMk/>
            <pc:sldMk cId="3253327431" sldId="266"/>
            <ac:spMk id="73" creationId="{4E2F6EA0-4DAA-4EA2-98E9-5BA270CA3220}"/>
          </ac:spMkLst>
        </pc:spChg>
        <pc:spChg chg="add mod">
          <ac:chgData name="Sameer G Joshi (DJPR)" userId="bd06337d-ce8c-4c34-b1d1-7fbf8f91b6eb" providerId="ADAL" clId="{7BF6CCE1-D8BE-47A6-A57C-E281D236CFBA}" dt="2022-08-12T02:30:22.029" v="1425" actId="1038"/>
          <ac:spMkLst>
            <pc:docMk/>
            <pc:sldMk cId="3253327431" sldId="266"/>
            <ac:spMk id="74" creationId="{4C1AB6A7-0622-4FE3-9517-6F0F2FBA60E8}"/>
          </ac:spMkLst>
        </pc:spChg>
        <pc:spChg chg="add mod">
          <ac:chgData name="Sameer G Joshi (DJPR)" userId="bd06337d-ce8c-4c34-b1d1-7fbf8f91b6eb" providerId="ADAL" clId="{7BF6CCE1-D8BE-47A6-A57C-E281D236CFBA}" dt="2022-08-12T02:30:29.732" v="1428" actId="20577"/>
          <ac:spMkLst>
            <pc:docMk/>
            <pc:sldMk cId="3253327431" sldId="266"/>
            <ac:spMk id="75" creationId="{CD96D131-83B3-435F-A258-BEF18247FE20}"/>
          </ac:spMkLst>
        </pc:spChg>
        <pc:spChg chg="add mod">
          <ac:chgData name="Sameer G Joshi (DJPR)" userId="bd06337d-ce8c-4c34-b1d1-7fbf8f91b6eb" providerId="ADAL" clId="{7BF6CCE1-D8BE-47A6-A57C-E281D236CFBA}" dt="2022-08-12T02:30:46.478" v="1436" actId="1037"/>
          <ac:spMkLst>
            <pc:docMk/>
            <pc:sldMk cId="3253327431" sldId="266"/>
            <ac:spMk id="76" creationId="{C59E7922-336A-4CBC-8E3E-72BAFE05C99A}"/>
          </ac:spMkLst>
        </pc:spChg>
        <pc:spChg chg="add mod">
          <ac:chgData name="Sameer G Joshi (DJPR)" userId="bd06337d-ce8c-4c34-b1d1-7fbf8f91b6eb" providerId="ADAL" clId="{7BF6CCE1-D8BE-47A6-A57C-E281D236CFBA}" dt="2022-08-12T02:30:52.540" v="1438" actId="1076"/>
          <ac:spMkLst>
            <pc:docMk/>
            <pc:sldMk cId="3253327431" sldId="266"/>
            <ac:spMk id="77" creationId="{03C6F77F-9E51-4E01-920E-EA8743C4EA16}"/>
          </ac:spMkLst>
        </pc:spChg>
        <pc:spChg chg="add mod">
          <ac:chgData name="Sameer G Joshi (DJPR)" userId="bd06337d-ce8c-4c34-b1d1-7fbf8f91b6eb" providerId="ADAL" clId="{7BF6CCE1-D8BE-47A6-A57C-E281D236CFBA}" dt="2022-08-12T02:30:57.140" v="1440" actId="1076"/>
          <ac:spMkLst>
            <pc:docMk/>
            <pc:sldMk cId="3253327431" sldId="266"/>
            <ac:spMk id="78" creationId="{FBC3C03A-7EFD-482F-A948-86183E5A89FF}"/>
          </ac:spMkLst>
        </pc:spChg>
        <pc:spChg chg="add mod">
          <ac:chgData name="Sameer G Joshi (DJPR)" userId="bd06337d-ce8c-4c34-b1d1-7fbf8f91b6eb" providerId="ADAL" clId="{7BF6CCE1-D8BE-47A6-A57C-E281D236CFBA}" dt="2022-08-12T02:31:02.745" v="1442" actId="1076"/>
          <ac:spMkLst>
            <pc:docMk/>
            <pc:sldMk cId="3253327431" sldId="266"/>
            <ac:spMk id="79" creationId="{24ACC823-8CAE-4BD5-899B-AAD020855246}"/>
          </ac:spMkLst>
        </pc:spChg>
        <pc:spChg chg="add mod">
          <ac:chgData name="Sameer G Joshi (DJPR)" userId="bd06337d-ce8c-4c34-b1d1-7fbf8f91b6eb" providerId="ADAL" clId="{7BF6CCE1-D8BE-47A6-A57C-E281D236CFBA}" dt="2022-08-12T02:31:16.436" v="1445" actId="20577"/>
          <ac:spMkLst>
            <pc:docMk/>
            <pc:sldMk cId="3253327431" sldId="266"/>
            <ac:spMk id="80" creationId="{F41BE0F8-D025-48B4-A41A-43773CADE6ED}"/>
          </ac:spMkLst>
        </pc:spChg>
        <pc:spChg chg="add mod">
          <ac:chgData name="Sameer G Joshi (DJPR)" userId="bd06337d-ce8c-4c34-b1d1-7fbf8f91b6eb" providerId="ADAL" clId="{7BF6CCE1-D8BE-47A6-A57C-E281D236CFBA}" dt="2022-08-12T02:31:33.041" v="1461" actId="1037"/>
          <ac:spMkLst>
            <pc:docMk/>
            <pc:sldMk cId="3253327431" sldId="266"/>
            <ac:spMk id="81" creationId="{956C6B68-4C62-451B-8740-AF905B61678F}"/>
          </ac:spMkLst>
        </pc:spChg>
        <pc:spChg chg="add mod">
          <ac:chgData name="Sameer G Joshi (DJPR)" userId="bd06337d-ce8c-4c34-b1d1-7fbf8f91b6eb" providerId="ADAL" clId="{7BF6CCE1-D8BE-47A6-A57C-E281D236CFBA}" dt="2022-08-12T02:31:46.206" v="1473" actId="1035"/>
          <ac:spMkLst>
            <pc:docMk/>
            <pc:sldMk cId="3253327431" sldId="266"/>
            <ac:spMk id="82" creationId="{23A27792-B6F1-4E99-94CC-51D478B5E6C5}"/>
          </ac:spMkLst>
        </pc:spChg>
        <pc:spChg chg="add mod">
          <ac:chgData name="Sameer G Joshi (DJPR)" userId="bd06337d-ce8c-4c34-b1d1-7fbf8f91b6eb" providerId="ADAL" clId="{7BF6CCE1-D8BE-47A6-A57C-E281D236CFBA}" dt="2022-08-12T02:31:57.891" v="1476" actId="20577"/>
          <ac:spMkLst>
            <pc:docMk/>
            <pc:sldMk cId="3253327431" sldId="266"/>
            <ac:spMk id="83" creationId="{FE735ED4-EAE1-4EE4-B453-3817E806B9C0}"/>
          </ac:spMkLst>
        </pc:spChg>
        <pc:spChg chg="add mod">
          <ac:chgData name="Sameer G Joshi (DJPR)" userId="bd06337d-ce8c-4c34-b1d1-7fbf8f91b6eb" providerId="ADAL" clId="{7BF6CCE1-D8BE-47A6-A57C-E281D236CFBA}" dt="2022-08-12T02:32:16.535" v="1483" actId="1037"/>
          <ac:spMkLst>
            <pc:docMk/>
            <pc:sldMk cId="3253327431" sldId="266"/>
            <ac:spMk id="84" creationId="{273FD37B-E15A-456E-954C-8433E8CDBE77}"/>
          </ac:spMkLst>
        </pc:spChg>
        <pc:spChg chg="add mod">
          <ac:chgData name="Sameer G Joshi (DJPR)" userId="bd06337d-ce8c-4c34-b1d1-7fbf8f91b6eb" providerId="ADAL" clId="{7BF6CCE1-D8BE-47A6-A57C-E281D236CFBA}" dt="2022-08-12T02:32:29.935" v="1488" actId="1037"/>
          <ac:spMkLst>
            <pc:docMk/>
            <pc:sldMk cId="3253327431" sldId="266"/>
            <ac:spMk id="85" creationId="{77B6DDDC-CA71-4E9A-93F7-FD84DECCA3F9}"/>
          </ac:spMkLst>
        </pc:spChg>
        <pc:cxnChg chg="add del">
          <ac:chgData name="Sameer G Joshi (DJPR)" userId="bd06337d-ce8c-4c34-b1d1-7fbf8f91b6eb" providerId="ADAL" clId="{7BF6CCE1-D8BE-47A6-A57C-E281D236CFBA}" dt="2022-08-12T02:34:10.839" v="1490" actId="478"/>
          <ac:cxnSpMkLst>
            <pc:docMk/>
            <pc:sldMk cId="3253327431" sldId="266"/>
            <ac:cxnSpMk id="3" creationId="{DC0BA504-252A-4F01-875D-7081354F71EB}"/>
          </ac:cxnSpMkLst>
        </pc:cxnChg>
      </pc:sldChg>
      <pc:sldChg chg="addSp modSp mod">
        <pc:chgData name="Sameer G Joshi (DJPR)" userId="bd06337d-ce8c-4c34-b1d1-7fbf8f91b6eb" providerId="ADAL" clId="{7BF6CCE1-D8BE-47A6-A57C-E281D236CFBA}" dt="2022-08-12T03:49:45.813" v="1720" actId="1038"/>
        <pc:sldMkLst>
          <pc:docMk/>
          <pc:sldMk cId="1068351154" sldId="267"/>
        </pc:sldMkLst>
        <pc:spChg chg="add mod">
          <ac:chgData name="Sameer G Joshi (DJPR)" userId="bd06337d-ce8c-4c34-b1d1-7fbf8f91b6eb" providerId="ADAL" clId="{7BF6CCE1-D8BE-47A6-A57C-E281D236CFBA}" dt="2022-08-12T03:11:37.040" v="1503" actId="1036"/>
          <ac:spMkLst>
            <pc:docMk/>
            <pc:sldMk cId="1068351154" sldId="267"/>
            <ac:spMk id="51" creationId="{FAE0D08A-BDA3-4306-9257-93FF39BAE4BB}"/>
          </ac:spMkLst>
        </pc:spChg>
        <pc:spChg chg="add mod">
          <ac:chgData name="Sameer G Joshi (DJPR)" userId="bd06337d-ce8c-4c34-b1d1-7fbf8f91b6eb" providerId="ADAL" clId="{7BF6CCE1-D8BE-47A6-A57C-E281D236CFBA}" dt="2022-08-12T03:11:29.623" v="1496" actId="1076"/>
          <ac:spMkLst>
            <pc:docMk/>
            <pc:sldMk cId="1068351154" sldId="267"/>
            <ac:spMk id="52" creationId="{E82518FF-2830-4FC7-8FD7-05C04625611B}"/>
          </ac:spMkLst>
        </pc:spChg>
        <pc:spChg chg="add mod">
          <ac:chgData name="Sameer G Joshi (DJPR)" userId="bd06337d-ce8c-4c34-b1d1-7fbf8f91b6eb" providerId="ADAL" clId="{7BF6CCE1-D8BE-47A6-A57C-E281D236CFBA}" dt="2022-08-12T03:11:46.247" v="1507" actId="1037"/>
          <ac:spMkLst>
            <pc:docMk/>
            <pc:sldMk cId="1068351154" sldId="267"/>
            <ac:spMk id="53" creationId="{F2C19DE0-5E42-4BE6-8F42-1FA2D18EC1CE}"/>
          </ac:spMkLst>
        </pc:spChg>
        <pc:spChg chg="add mod">
          <ac:chgData name="Sameer G Joshi (DJPR)" userId="bd06337d-ce8c-4c34-b1d1-7fbf8f91b6eb" providerId="ADAL" clId="{7BF6CCE1-D8BE-47A6-A57C-E281D236CFBA}" dt="2022-08-12T03:11:53.377" v="1509" actId="1076"/>
          <ac:spMkLst>
            <pc:docMk/>
            <pc:sldMk cId="1068351154" sldId="267"/>
            <ac:spMk id="54" creationId="{1B7CBCDB-70AF-4DE3-BBD3-02B8F058DBD9}"/>
          </ac:spMkLst>
        </pc:spChg>
        <pc:spChg chg="add mod">
          <ac:chgData name="Sameer G Joshi (DJPR)" userId="bd06337d-ce8c-4c34-b1d1-7fbf8f91b6eb" providerId="ADAL" clId="{7BF6CCE1-D8BE-47A6-A57C-E281D236CFBA}" dt="2022-08-12T03:12:00.272" v="1511" actId="1076"/>
          <ac:spMkLst>
            <pc:docMk/>
            <pc:sldMk cId="1068351154" sldId="267"/>
            <ac:spMk id="55" creationId="{3A9C2D7F-F965-4B78-9102-1955234C0096}"/>
          </ac:spMkLst>
        </pc:spChg>
        <pc:spChg chg="add mod">
          <ac:chgData name="Sameer G Joshi (DJPR)" userId="bd06337d-ce8c-4c34-b1d1-7fbf8f91b6eb" providerId="ADAL" clId="{7BF6CCE1-D8BE-47A6-A57C-E281D236CFBA}" dt="2022-08-12T03:12:08.089" v="1517" actId="1035"/>
          <ac:spMkLst>
            <pc:docMk/>
            <pc:sldMk cId="1068351154" sldId="267"/>
            <ac:spMk id="56" creationId="{E6D5FD67-FBF8-4268-A3DB-343070E0C1AA}"/>
          </ac:spMkLst>
        </pc:spChg>
        <pc:spChg chg="add mod">
          <ac:chgData name="Sameer G Joshi (DJPR)" userId="bd06337d-ce8c-4c34-b1d1-7fbf8f91b6eb" providerId="ADAL" clId="{7BF6CCE1-D8BE-47A6-A57C-E281D236CFBA}" dt="2022-08-12T03:12:14.964" v="1519" actId="1076"/>
          <ac:spMkLst>
            <pc:docMk/>
            <pc:sldMk cId="1068351154" sldId="267"/>
            <ac:spMk id="57" creationId="{05A7D75F-0409-4FEA-820F-DE6C1640697D}"/>
          </ac:spMkLst>
        </pc:spChg>
        <pc:spChg chg="add mod">
          <ac:chgData name="Sameer G Joshi (DJPR)" userId="bd06337d-ce8c-4c34-b1d1-7fbf8f91b6eb" providerId="ADAL" clId="{7BF6CCE1-D8BE-47A6-A57C-E281D236CFBA}" dt="2022-08-12T03:12:32.751" v="1523" actId="20577"/>
          <ac:spMkLst>
            <pc:docMk/>
            <pc:sldMk cId="1068351154" sldId="267"/>
            <ac:spMk id="58" creationId="{F1DC0DE0-F782-480C-9965-DD2003BFEAD9}"/>
          </ac:spMkLst>
        </pc:spChg>
        <pc:spChg chg="add mod">
          <ac:chgData name="Sameer G Joshi (DJPR)" userId="bd06337d-ce8c-4c34-b1d1-7fbf8f91b6eb" providerId="ADAL" clId="{7BF6CCE1-D8BE-47A6-A57C-E281D236CFBA}" dt="2022-08-12T03:12:46.723" v="1530" actId="1038"/>
          <ac:spMkLst>
            <pc:docMk/>
            <pc:sldMk cId="1068351154" sldId="267"/>
            <ac:spMk id="59" creationId="{8D23A538-AA86-4056-BE06-E301A8E075A9}"/>
          </ac:spMkLst>
        </pc:spChg>
        <pc:spChg chg="add mod">
          <ac:chgData name="Sameer G Joshi (DJPR)" userId="bd06337d-ce8c-4c34-b1d1-7fbf8f91b6eb" providerId="ADAL" clId="{7BF6CCE1-D8BE-47A6-A57C-E281D236CFBA}" dt="2022-08-12T03:13:01.440" v="1534" actId="1035"/>
          <ac:spMkLst>
            <pc:docMk/>
            <pc:sldMk cId="1068351154" sldId="267"/>
            <ac:spMk id="60" creationId="{129AFE6C-980E-4B6B-902F-36427ED3E6C2}"/>
          </ac:spMkLst>
        </pc:spChg>
        <pc:spChg chg="add mod">
          <ac:chgData name="Sameer G Joshi (DJPR)" userId="bd06337d-ce8c-4c34-b1d1-7fbf8f91b6eb" providerId="ADAL" clId="{7BF6CCE1-D8BE-47A6-A57C-E281D236CFBA}" dt="2022-08-12T03:13:21.105" v="1536" actId="1076"/>
          <ac:spMkLst>
            <pc:docMk/>
            <pc:sldMk cId="1068351154" sldId="267"/>
            <ac:spMk id="61" creationId="{E5710D2B-5847-4969-AE56-FAE329AB081E}"/>
          </ac:spMkLst>
        </pc:spChg>
        <pc:spChg chg="add mod">
          <ac:chgData name="Sameer G Joshi (DJPR)" userId="bd06337d-ce8c-4c34-b1d1-7fbf8f91b6eb" providerId="ADAL" clId="{7BF6CCE1-D8BE-47A6-A57C-E281D236CFBA}" dt="2022-08-12T03:13:29.857" v="1539" actId="1038"/>
          <ac:spMkLst>
            <pc:docMk/>
            <pc:sldMk cId="1068351154" sldId="267"/>
            <ac:spMk id="62" creationId="{4F119F9E-E767-44CB-A0D4-38D614B9C6DD}"/>
          </ac:spMkLst>
        </pc:spChg>
        <pc:spChg chg="add mod">
          <ac:chgData name="Sameer G Joshi (DJPR)" userId="bd06337d-ce8c-4c34-b1d1-7fbf8f91b6eb" providerId="ADAL" clId="{7BF6CCE1-D8BE-47A6-A57C-E281D236CFBA}" dt="2022-08-12T03:13:38.561" v="1542" actId="1035"/>
          <ac:spMkLst>
            <pc:docMk/>
            <pc:sldMk cId="1068351154" sldId="267"/>
            <ac:spMk id="63" creationId="{DBE431F5-961F-490F-AADA-BDF734D6ABF0}"/>
          </ac:spMkLst>
        </pc:spChg>
        <pc:spChg chg="add mod">
          <ac:chgData name="Sameer G Joshi (DJPR)" userId="bd06337d-ce8c-4c34-b1d1-7fbf8f91b6eb" providerId="ADAL" clId="{7BF6CCE1-D8BE-47A6-A57C-E281D236CFBA}" dt="2022-08-12T03:15:05.792" v="1558" actId="1038"/>
          <ac:spMkLst>
            <pc:docMk/>
            <pc:sldMk cId="1068351154" sldId="267"/>
            <ac:spMk id="64" creationId="{7F05314A-6033-4932-928D-60A0BF824768}"/>
          </ac:spMkLst>
        </pc:spChg>
        <pc:spChg chg="add mod">
          <ac:chgData name="Sameer G Joshi (DJPR)" userId="bd06337d-ce8c-4c34-b1d1-7fbf8f91b6eb" providerId="ADAL" clId="{7BF6CCE1-D8BE-47A6-A57C-E281D236CFBA}" dt="2022-08-12T03:14:19.522" v="1550" actId="1076"/>
          <ac:spMkLst>
            <pc:docMk/>
            <pc:sldMk cId="1068351154" sldId="267"/>
            <ac:spMk id="65" creationId="{71D2E553-C0A9-4027-BA41-F02F4C430382}"/>
          </ac:spMkLst>
        </pc:spChg>
        <pc:spChg chg="add mod">
          <ac:chgData name="Sameer G Joshi (DJPR)" userId="bd06337d-ce8c-4c34-b1d1-7fbf8f91b6eb" providerId="ADAL" clId="{7BF6CCE1-D8BE-47A6-A57C-E281D236CFBA}" dt="2022-08-12T03:14:24.805" v="1552" actId="1076"/>
          <ac:spMkLst>
            <pc:docMk/>
            <pc:sldMk cId="1068351154" sldId="267"/>
            <ac:spMk id="66" creationId="{FA5034DE-2054-4AE6-A8AF-B19AF37FB323}"/>
          </ac:spMkLst>
        </pc:spChg>
        <pc:spChg chg="add mod">
          <ac:chgData name="Sameer G Joshi (DJPR)" userId="bd06337d-ce8c-4c34-b1d1-7fbf8f91b6eb" providerId="ADAL" clId="{7BF6CCE1-D8BE-47A6-A57C-E281D236CFBA}" dt="2022-08-12T03:32:18.351" v="1574" actId="1036"/>
          <ac:spMkLst>
            <pc:docMk/>
            <pc:sldMk cId="1068351154" sldId="267"/>
            <ac:spMk id="67" creationId="{6DC9CAF5-AD1C-4D59-844C-27A145830BA6}"/>
          </ac:spMkLst>
        </pc:spChg>
        <pc:spChg chg="add mod">
          <ac:chgData name="Sameer G Joshi (DJPR)" userId="bd06337d-ce8c-4c34-b1d1-7fbf8f91b6eb" providerId="ADAL" clId="{7BF6CCE1-D8BE-47A6-A57C-E281D236CFBA}" dt="2022-08-12T03:32:18.351" v="1574" actId="1036"/>
          <ac:spMkLst>
            <pc:docMk/>
            <pc:sldMk cId="1068351154" sldId="267"/>
            <ac:spMk id="68" creationId="{594EA57A-C98B-4180-957E-B8E36A1CC632}"/>
          </ac:spMkLst>
        </pc:spChg>
        <pc:spChg chg="add mod">
          <ac:chgData name="Sameer G Joshi (DJPR)" userId="bd06337d-ce8c-4c34-b1d1-7fbf8f91b6eb" providerId="ADAL" clId="{7BF6CCE1-D8BE-47A6-A57C-E281D236CFBA}" dt="2022-08-12T03:32:25.557" v="1580" actId="1035"/>
          <ac:spMkLst>
            <pc:docMk/>
            <pc:sldMk cId="1068351154" sldId="267"/>
            <ac:spMk id="69" creationId="{2DDF7272-6F9F-437F-9B29-D70BFD3C8F21}"/>
          </ac:spMkLst>
        </pc:spChg>
        <pc:spChg chg="add mod">
          <ac:chgData name="Sameer G Joshi (DJPR)" userId="bd06337d-ce8c-4c34-b1d1-7fbf8f91b6eb" providerId="ADAL" clId="{7BF6CCE1-D8BE-47A6-A57C-E281D236CFBA}" dt="2022-08-12T03:32:01.866" v="1560" actId="1076"/>
          <ac:spMkLst>
            <pc:docMk/>
            <pc:sldMk cId="1068351154" sldId="267"/>
            <ac:spMk id="70" creationId="{ADA3856D-2712-4F00-BB77-20E0A4713FDA}"/>
          </ac:spMkLst>
        </pc:spChg>
        <pc:spChg chg="add mod">
          <ac:chgData name="Sameer G Joshi (DJPR)" userId="bd06337d-ce8c-4c34-b1d1-7fbf8f91b6eb" providerId="ADAL" clId="{7BF6CCE1-D8BE-47A6-A57C-E281D236CFBA}" dt="2022-08-12T03:32:37.942" v="1582" actId="1076"/>
          <ac:spMkLst>
            <pc:docMk/>
            <pc:sldMk cId="1068351154" sldId="267"/>
            <ac:spMk id="71" creationId="{7FAAA861-54E4-4059-B9F3-02804C08B620}"/>
          </ac:spMkLst>
        </pc:spChg>
        <pc:spChg chg="add mod">
          <ac:chgData name="Sameer G Joshi (DJPR)" userId="bd06337d-ce8c-4c34-b1d1-7fbf8f91b6eb" providerId="ADAL" clId="{7BF6CCE1-D8BE-47A6-A57C-E281D236CFBA}" dt="2022-08-12T03:33:35.612" v="1585" actId="20577"/>
          <ac:spMkLst>
            <pc:docMk/>
            <pc:sldMk cId="1068351154" sldId="267"/>
            <ac:spMk id="72" creationId="{D213B437-7596-4D2C-93DC-CD749D07488A}"/>
          </ac:spMkLst>
        </pc:spChg>
        <pc:spChg chg="add mod">
          <ac:chgData name="Sameer G Joshi (DJPR)" userId="bd06337d-ce8c-4c34-b1d1-7fbf8f91b6eb" providerId="ADAL" clId="{7BF6CCE1-D8BE-47A6-A57C-E281D236CFBA}" dt="2022-08-12T03:33:46.893" v="1588" actId="20577"/>
          <ac:spMkLst>
            <pc:docMk/>
            <pc:sldMk cId="1068351154" sldId="267"/>
            <ac:spMk id="73" creationId="{0829662E-917B-430A-BA1A-14E09A893A36}"/>
          </ac:spMkLst>
        </pc:spChg>
        <pc:spChg chg="add mod">
          <ac:chgData name="Sameer G Joshi (DJPR)" userId="bd06337d-ce8c-4c34-b1d1-7fbf8f91b6eb" providerId="ADAL" clId="{7BF6CCE1-D8BE-47A6-A57C-E281D236CFBA}" dt="2022-08-12T03:33:54.116" v="1591" actId="20577"/>
          <ac:spMkLst>
            <pc:docMk/>
            <pc:sldMk cId="1068351154" sldId="267"/>
            <ac:spMk id="74" creationId="{5981767A-F4BB-4D31-913F-42BA0C9F0DCC}"/>
          </ac:spMkLst>
        </pc:spChg>
        <pc:spChg chg="add mod">
          <ac:chgData name="Sameer G Joshi (DJPR)" userId="bd06337d-ce8c-4c34-b1d1-7fbf8f91b6eb" providerId="ADAL" clId="{7BF6CCE1-D8BE-47A6-A57C-E281D236CFBA}" dt="2022-08-12T03:34:37.949" v="1593" actId="1076"/>
          <ac:spMkLst>
            <pc:docMk/>
            <pc:sldMk cId="1068351154" sldId="267"/>
            <ac:spMk id="75" creationId="{6CF04A73-D574-425F-9E14-B95F1CEE1722}"/>
          </ac:spMkLst>
        </pc:spChg>
        <pc:spChg chg="add mod">
          <ac:chgData name="Sameer G Joshi (DJPR)" userId="bd06337d-ce8c-4c34-b1d1-7fbf8f91b6eb" providerId="ADAL" clId="{7BF6CCE1-D8BE-47A6-A57C-E281D236CFBA}" dt="2022-08-12T03:34:46.760" v="1595" actId="1076"/>
          <ac:spMkLst>
            <pc:docMk/>
            <pc:sldMk cId="1068351154" sldId="267"/>
            <ac:spMk id="76" creationId="{F897E469-2572-408A-A793-864CDAF3B1A6}"/>
          </ac:spMkLst>
        </pc:spChg>
        <pc:spChg chg="add mod">
          <ac:chgData name="Sameer G Joshi (DJPR)" userId="bd06337d-ce8c-4c34-b1d1-7fbf8f91b6eb" providerId="ADAL" clId="{7BF6CCE1-D8BE-47A6-A57C-E281D236CFBA}" dt="2022-08-12T03:34:52.194" v="1597" actId="1076"/>
          <ac:spMkLst>
            <pc:docMk/>
            <pc:sldMk cId="1068351154" sldId="267"/>
            <ac:spMk id="77" creationId="{FF794740-A461-455F-9A81-0E353755ED4B}"/>
          </ac:spMkLst>
        </pc:spChg>
        <pc:spChg chg="add mod">
          <ac:chgData name="Sameer G Joshi (DJPR)" userId="bd06337d-ce8c-4c34-b1d1-7fbf8f91b6eb" providerId="ADAL" clId="{7BF6CCE1-D8BE-47A6-A57C-E281D236CFBA}" dt="2022-08-12T03:34:56.749" v="1599" actId="1076"/>
          <ac:spMkLst>
            <pc:docMk/>
            <pc:sldMk cId="1068351154" sldId="267"/>
            <ac:spMk id="78" creationId="{B5A93B82-1FE0-45A3-ACF5-5E0358A37B28}"/>
          </ac:spMkLst>
        </pc:spChg>
        <pc:spChg chg="add mod">
          <ac:chgData name="Sameer G Joshi (DJPR)" userId="bd06337d-ce8c-4c34-b1d1-7fbf8f91b6eb" providerId="ADAL" clId="{7BF6CCE1-D8BE-47A6-A57C-E281D236CFBA}" dt="2022-08-12T03:35:01.496" v="1601" actId="1076"/>
          <ac:spMkLst>
            <pc:docMk/>
            <pc:sldMk cId="1068351154" sldId="267"/>
            <ac:spMk id="79" creationId="{93F57888-CD88-4083-B9D3-C3C5053A253D}"/>
          </ac:spMkLst>
        </pc:spChg>
        <pc:spChg chg="add mod">
          <ac:chgData name="Sameer G Joshi (DJPR)" userId="bd06337d-ce8c-4c34-b1d1-7fbf8f91b6eb" providerId="ADAL" clId="{7BF6CCE1-D8BE-47A6-A57C-E281D236CFBA}" dt="2022-08-12T03:35:06.604" v="1603" actId="1076"/>
          <ac:spMkLst>
            <pc:docMk/>
            <pc:sldMk cId="1068351154" sldId="267"/>
            <ac:spMk id="80" creationId="{D7AAED49-B499-481C-A0CC-A2E596378738}"/>
          </ac:spMkLst>
        </pc:spChg>
        <pc:spChg chg="add mod">
          <ac:chgData name="Sameer G Joshi (DJPR)" userId="bd06337d-ce8c-4c34-b1d1-7fbf8f91b6eb" providerId="ADAL" clId="{7BF6CCE1-D8BE-47A6-A57C-E281D236CFBA}" dt="2022-08-12T03:35:12.895" v="1608" actId="1035"/>
          <ac:spMkLst>
            <pc:docMk/>
            <pc:sldMk cId="1068351154" sldId="267"/>
            <ac:spMk id="81" creationId="{A6570311-3D95-4558-993B-E04EE550FA58}"/>
          </ac:spMkLst>
        </pc:spChg>
        <pc:spChg chg="add mod">
          <ac:chgData name="Sameer G Joshi (DJPR)" userId="bd06337d-ce8c-4c34-b1d1-7fbf8f91b6eb" providerId="ADAL" clId="{7BF6CCE1-D8BE-47A6-A57C-E281D236CFBA}" dt="2022-08-12T03:35:18.218" v="1610" actId="1076"/>
          <ac:spMkLst>
            <pc:docMk/>
            <pc:sldMk cId="1068351154" sldId="267"/>
            <ac:spMk id="82" creationId="{67FBB7C1-F1A5-4BA1-87E2-23A1DB820567}"/>
          </ac:spMkLst>
        </pc:spChg>
        <pc:spChg chg="add mod">
          <ac:chgData name="Sameer G Joshi (DJPR)" userId="bd06337d-ce8c-4c34-b1d1-7fbf8f91b6eb" providerId="ADAL" clId="{7BF6CCE1-D8BE-47A6-A57C-E281D236CFBA}" dt="2022-08-12T03:46:02.764" v="1617" actId="1036"/>
          <ac:spMkLst>
            <pc:docMk/>
            <pc:sldMk cId="1068351154" sldId="267"/>
            <ac:spMk id="83" creationId="{4775E0B2-A4C3-4C80-8D84-5DCB84046577}"/>
          </ac:spMkLst>
        </pc:spChg>
        <pc:spChg chg="add mod">
          <ac:chgData name="Sameer G Joshi (DJPR)" userId="bd06337d-ce8c-4c34-b1d1-7fbf8f91b6eb" providerId="ADAL" clId="{7BF6CCE1-D8BE-47A6-A57C-E281D236CFBA}" dt="2022-08-12T03:46:19.528" v="1621" actId="1038"/>
          <ac:spMkLst>
            <pc:docMk/>
            <pc:sldMk cId="1068351154" sldId="267"/>
            <ac:spMk id="84" creationId="{08628F50-6502-49DC-AB72-D1F2B0415D84}"/>
          </ac:spMkLst>
        </pc:spChg>
        <pc:spChg chg="add mod">
          <ac:chgData name="Sameer G Joshi (DJPR)" userId="bd06337d-ce8c-4c34-b1d1-7fbf8f91b6eb" providerId="ADAL" clId="{7BF6CCE1-D8BE-47A6-A57C-E281D236CFBA}" dt="2022-08-12T03:46:25.905" v="1623" actId="1076"/>
          <ac:spMkLst>
            <pc:docMk/>
            <pc:sldMk cId="1068351154" sldId="267"/>
            <ac:spMk id="85" creationId="{5B140304-02DB-49E9-A05F-51C6B4254E0A}"/>
          </ac:spMkLst>
        </pc:spChg>
        <pc:spChg chg="add mod">
          <ac:chgData name="Sameer G Joshi (DJPR)" userId="bd06337d-ce8c-4c34-b1d1-7fbf8f91b6eb" providerId="ADAL" clId="{7BF6CCE1-D8BE-47A6-A57C-E281D236CFBA}" dt="2022-08-12T03:46:32.392" v="1625" actId="1076"/>
          <ac:spMkLst>
            <pc:docMk/>
            <pc:sldMk cId="1068351154" sldId="267"/>
            <ac:spMk id="86" creationId="{BBEB1A93-4E45-48A0-AA10-5681134B0839}"/>
          </ac:spMkLst>
        </pc:spChg>
        <pc:spChg chg="add mod">
          <ac:chgData name="Sameer G Joshi (DJPR)" userId="bd06337d-ce8c-4c34-b1d1-7fbf8f91b6eb" providerId="ADAL" clId="{7BF6CCE1-D8BE-47A6-A57C-E281D236CFBA}" dt="2022-08-12T03:47:12.247" v="1628" actId="20577"/>
          <ac:spMkLst>
            <pc:docMk/>
            <pc:sldMk cId="1068351154" sldId="267"/>
            <ac:spMk id="87" creationId="{24E0EE74-C343-4D01-91FF-6850951F98B5}"/>
          </ac:spMkLst>
        </pc:spChg>
        <pc:spChg chg="add mod">
          <ac:chgData name="Sameer G Joshi (DJPR)" userId="bd06337d-ce8c-4c34-b1d1-7fbf8f91b6eb" providerId="ADAL" clId="{7BF6CCE1-D8BE-47A6-A57C-E281D236CFBA}" dt="2022-08-12T03:47:18.609" v="1630" actId="1076"/>
          <ac:spMkLst>
            <pc:docMk/>
            <pc:sldMk cId="1068351154" sldId="267"/>
            <ac:spMk id="88" creationId="{9922041F-7EE3-4030-BA6B-50F852355C2B}"/>
          </ac:spMkLst>
        </pc:spChg>
        <pc:spChg chg="add mod">
          <ac:chgData name="Sameer G Joshi (DJPR)" userId="bd06337d-ce8c-4c34-b1d1-7fbf8f91b6eb" providerId="ADAL" clId="{7BF6CCE1-D8BE-47A6-A57C-E281D236CFBA}" dt="2022-08-12T03:47:28.494" v="1634" actId="20577"/>
          <ac:spMkLst>
            <pc:docMk/>
            <pc:sldMk cId="1068351154" sldId="267"/>
            <ac:spMk id="89" creationId="{CDA67C90-5DDE-4C19-92B2-BF2BDFB2415B}"/>
          </ac:spMkLst>
        </pc:spChg>
        <pc:spChg chg="add mod">
          <ac:chgData name="Sameer G Joshi (DJPR)" userId="bd06337d-ce8c-4c34-b1d1-7fbf8f91b6eb" providerId="ADAL" clId="{7BF6CCE1-D8BE-47A6-A57C-E281D236CFBA}" dt="2022-08-12T03:47:51.845" v="1642" actId="1037"/>
          <ac:spMkLst>
            <pc:docMk/>
            <pc:sldMk cId="1068351154" sldId="267"/>
            <ac:spMk id="90" creationId="{632BCBA0-3D4E-4167-80B1-C01BDEB43378}"/>
          </ac:spMkLst>
        </pc:spChg>
        <pc:spChg chg="add mod">
          <ac:chgData name="Sameer G Joshi (DJPR)" userId="bd06337d-ce8c-4c34-b1d1-7fbf8f91b6eb" providerId="ADAL" clId="{7BF6CCE1-D8BE-47A6-A57C-E281D236CFBA}" dt="2022-08-12T03:48:00.057" v="1644" actId="1076"/>
          <ac:spMkLst>
            <pc:docMk/>
            <pc:sldMk cId="1068351154" sldId="267"/>
            <ac:spMk id="91" creationId="{CEBEAEF0-9367-4147-B84B-0042639F1827}"/>
          </ac:spMkLst>
        </pc:spChg>
        <pc:spChg chg="add mod">
          <ac:chgData name="Sameer G Joshi (DJPR)" userId="bd06337d-ce8c-4c34-b1d1-7fbf8f91b6eb" providerId="ADAL" clId="{7BF6CCE1-D8BE-47A6-A57C-E281D236CFBA}" dt="2022-08-12T03:48:16.877" v="1659" actId="1038"/>
          <ac:spMkLst>
            <pc:docMk/>
            <pc:sldMk cId="1068351154" sldId="267"/>
            <ac:spMk id="92" creationId="{F8F37A39-296F-464F-BC84-3398083ACA06}"/>
          </ac:spMkLst>
        </pc:spChg>
        <pc:spChg chg="add mod">
          <ac:chgData name="Sameer G Joshi (DJPR)" userId="bd06337d-ce8c-4c34-b1d1-7fbf8f91b6eb" providerId="ADAL" clId="{7BF6CCE1-D8BE-47A6-A57C-E281D236CFBA}" dt="2022-08-12T03:48:33.213" v="1662" actId="20577"/>
          <ac:spMkLst>
            <pc:docMk/>
            <pc:sldMk cId="1068351154" sldId="267"/>
            <ac:spMk id="93" creationId="{763648E8-EE7B-4FEC-B63B-A80B5DEFE47F}"/>
          </ac:spMkLst>
        </pc:spChg>
        <pc:spChg chg="add mod">
          <ac:chgData name="Sameer G Joshi (DJPR)" userId="bd06337d-ce8c-4c34-b1d1-7fbf8f91b6eb" providerId="ADAL" clId="{7BF6CCE1-D8BE-47A6-A57C-E281D236CFBA}" dt="2022-08-12T03:48:45.436" v="1675" actId="1038"/>
          <ac:spMkLst>
            <pc:docMk/>
            <pc:sldMk cId="1068351154" sldId="267"/>
            <ac:spMk id="94" creationId="{AF3A7209-A386-4461-830C-E23D1A7C4D64}"/>
          </ac:spMkLst>
        </pc:spChg>
        <pc:spChg chg="add mod">
          <ac:chgData name="Sameer G Joshi (DJPR)" userId="bd06337d-ce8c-4c34-b1d1-7fbf8f91b6eb" providerId="ADAL" clId="{7BF6CCE1-D8BE-47A6-A57C-E281D236CFBA}" dt="2022-08-12T03:49:00.496" v="1689" actId="1036"/>
          <ac:spMkLst>
            <pc:docMk/>
            <pc:sldMk cId="1068351154" sldId="267"/>
            <ac:spMk id="95" creationId="{962B0A95-ED2C-4C79-9F87-3CB80CEC04D1}"/>
          </ac:spMkLst>
        </pc:spChg>
        <pc:spChg chg="add mod">
          <ac:chgData name="Sameer G Joshi (DJPR)" userId="bd06337d-ce8c-4c34-b1d1-7fbf8f91b6eb" providerId="ADAL" clId="{7BF6CCE1-D8BE-47A6-A57C-E281D236CFBA}" dt="2022-08-12T03:49:20.422" v="1700" actId="1037"/>
          <ac:spMkLst>
            <pc:docMk/>
            <pc:sldMk cId="1068351154" sldId="267"/>
            <ac:spMk id="96" creationId="{337CA20B-3176-453B-933A-0CB6AB570F0D}"/>
          </ac:spMkLst>
        </pc:spChg>
        <pc:spChg chg="add mod">
          <ac:chgData name="Sameer G Joshi (DJPR)" userId="bd06337d-ce8c-4c34-b1d1-7fbf8f91b6eb" providerId="ADAL" clId="{7BF6CCE1-D8BE-47A6-A57C-E281D236CFBA}" dt="2022-08-12T03:49:32.666" v="1710" actId="1038"/>
          <ac:spMkLst>
            <pc:docMk/>
            <pc:sldMk cId="1068351154" sldId="267"/>
            <ac:spMk id="97" creationId="{35AB09B8-FE84-4026-8E7B-D3F499C0EFA1}"/>
          </ac:spMkLst>
        </pc:spChg>
        <pc:spChg chg="add mod">
          <ac:chgData name="Sameer G Joshi (DJPR)" userId="bd06337d-ce8c-4c34-b1d1-7fbf8f91b6eb" providerId="ADAL" clId="{7BF6CCE1-D8BE-47A6-A57C-E281D236CFBA}" dt="2022-08-12T03:49:45.813" v="1720" actId="1038"/>
          <ac:spMkLst>
            <pc:docMk/>
            <pc:sldMk cId="1068351154" sldId="267"/>
            <ac:spMk id="98" creationId="{067BEBD5-D816-4C70-967D-F737FBB25BCE}"/>
          </ac:spMkLst>
        </pc:spChg>
      </pc:sldChg>
      <pc:sldChg chg="addSp delSp modSp mod">
        <pc:chgData name="Sameer G Joshi (DJPR)" userId="bd06337d-ce8c-4c34-b1d1-7fbf8f91b6eb" providerId="ADAL" clId="{7BF6CCE1-D8BE-47A6-A57C-E281D236CFBA}" dt="2022-08-12T05:24:21.447" v="2232" actId="20577"/>
        <pc:sldMkLst>
          <pc:docMk/>
          <pc:sldMk cId="2979161283" sldId="268"/>
        </pc:sldMkLst>
        <pc:spChg chg="add mod">
          <ac:chgData name="Sameer G Joshi (DJPR)" userId="bd06337d-ce8c-4c34-b1d1-7fbf8f91b6eb" providerId="ADAL" clId="{7BF6CCE1-D8BE-47A6-A57C-E281D236CFBA}" dt="2022-08-12T04:01:30.539" v="1842" actId="1038"/>
          <ac:spMkLst>
            <pc:docMk/>
            <pc:sldMk cId="2979161283" sldId="268"/>
            <ac:spMk id="37" creationId="{ED8874C5-1D36-4C46-9649-924564AABA09}"/>
          </ac:spMkLst>
        </pc:spChg>
        <pc:spChg chg="add mod">
          <ac:chgData name="Sameer G Joshi (DJPR)" userId="bd06337d-ce8c-4c34-b1d1-7fbf8f91b6eb" providerId="ADAL" clId="{7BF6CCE1-D8BE-47A6-A57C-E281D236CFBA}" dt="2022-08-12T04:40:49.381" v="1844" actId="1076"/>
          <ac:spMkLst>
            <pc:docMk/>
            <pc:sldMk cId="2979161283" sldId="268"/>
            <ac:spMk id="43" creationId="{A9583028-091B-4746-A6FC-44C93576093B}"/>
          </ac:spMkLst>
        </pc:spChg>
        <pc:spChg chg="add mod">
          <ac:chgData name="Sameer G Joshi (DJPR)" userId="bd06337d-ce8c-4c34-b1d1-7fbf8f91b6eb" providerId="ADAL" clId="{7BF6CCE1-D8BE-47A6-A57C-E281D236CFBA}" dt="2022-08-12T04:41:01.368" v="1850" actId="1037"/>
          <ac:spMkLst>
            <pc:docMk/>
            <pc:sldMk cId="2979161283" sldId="268"/>
            <ac:spMk id="44" creationId="{8ACC89E4-66BF-48F6-A247-6C2B6CA5C4EE}"/>
          </ac:spMkLst>
        </pc:spChg>
        <pc:spChg chg="add mod">
          <ac:chgData name="Sameer G Joshi (DJPR)" userId="bd06337d-ce8c-4c34-b1d1-7fbf8f91b6eb" providerId="ADAL" clId="{7BF6CCE1-D8BE-47A6-A57C-E281D236CFBA}" dt="2022-08-12T04:41:15.993" v="1869" actId="1037"/>
          <ac:spMkLst>
            <pc:docMk/>
            <pc:sldMk cId="2979161283" sldId="268"/>
            <ac:spMk id="45" creationId="{7E61E826-0D52-4E15-97C8-4F3840A23517}"/>
          </ac:spMkLst>
        </pc:spChg>
        <pc:spChg chg="add mod">
          <ac:chgData name="Sameer G Joshi (DJPR)" userId="bd06337d-ce8c-4c34-b1d1-7fbf8f91b6eb" providerId="ADAL" clId="{7BF6CCE1-D8BE-47A6-A57C-E281D236CFBA}" dt="2022-08-12T04:41:28.617" v="1875" actId="1035"/>
          <ac:spMkLst>
            <pc:docMk/>
            <pc:sldMk cId="2979161283" sldId="268"/>
            <ac:spMk id="46" creationId="{36F2FEA5-655C-42EB-8F11-EE1FE66E06EB}"/>
          </ac:spMkLst>
        </pc:spChg>
        <pc:spChg chg="add mod">
          <ac:chgData name="Sameer G Joshi (DJPR)" userId="bd06337d-ce8c-4c34-b1d1-7fbf8f91b6eb" providerId="ADAL" clId="{7BF6CCE1-D8BE-47A6-A57C-E281D236CFBA}" dt="2022-08-12T04:41:34.206" v="1877" actId="1076"/>
          <ac:spMkLst>
            <pc:docMk/>
            <pc:sldMk cId="2979161283" sldId="268"/>
            <ac:spMk id="47" creationId="{893CFC63-41D7-4BC0-B40A-22B4EEF1D210}"/>
          </ac:spMkLst>
        </pc:spChg>
        <pc:spChg chg="add mod">
          <ac:chgData name="Sameer G Joshi (DJPR)" userId="bd06337d-ce8c-4c34-b1d1-7fbf8f91b6eb" providerId="ADAL" clId="{7BF6CCE1-D8BE-47A6-A57C-E281D236CFBA}" dt="2022-08-12T04:41:39.590" v="1879" actId="1076"/>
          <ac:spMkLst>
            <pc:docMk/>
            <pc:sldMk cId="2979161283" sldId="268"/>
            <ac:spMk id="48" creationId="{3F72B321-B4DF-4E5D-99D9-A12C67410A75}"/>
          </ac:spMkLst>
        </pc:spChg>
        <pc:spChg chg="add mod">
          <ac:chgData name="Sameer G Joshi (DJPR)" userId="bd06337d-ce8c-4c34-b1d1-7fbf8f91b6eb" providerId="ADAL" clId="{7BF6CCE1-D8BE-47A6-A57C-E281D236CFBA}" dt="2022-08-12T04:42:04.673" v="1905" actId="1036"/>
          <ac:spMkLst>
            <pc:docMk/>
            <pc:sldMk cId="2979161283" sldId="268"/>
            <ac:spMk id="49" creationId="{AD24371F-5D50-4A46-B85B-1E8E7AB0AC19}"/>
          </ac:spMkLst>
        </pc:spChg>
        <pc:spChg chg="add mod">
          <ac:chgData name="Sameer G Joshi (DJPR)" userId="bd06337d-ce8c-4c34-b1d1-7fbf8f91b6eb" providerId="ADAL" clId="{7BF6CCE1-D8BE-47A6-A57C-E281D236CFBA}" dt="2022-08-12T04:42:16.497" v="1925" actId="20577"/>
          <ac:spMkLst>
            <pc:docMk/>
            <pc:sldMk cId="2979161283" sldId="268"/>
            <ac:spMk id="50" creationId="{84D48355-0E76-4A4E-BA58-777DB2626014}"/>
          </ac:spMkLst>
        </pc:spChg>
        <pc:spChg chg="add mod">
          <ac:chgData name="Sameer G Joshi (DJPR)" userId="bd06337d-ce8c-4c34-b1d1-7fbf8f91b6eb" providerId="ADAL" clId="{7BF6CCE1-D8BE-47A6-A57C-E281D236CFBA}" dt="2022-08-12T04:42:32.002" v="1940" actId="1038"/>
          <ac:spMkLst>
            <pc:docMk/>
            <pc:sldMk cId="2979161283" sldId="268"/>
            <ac:spMk id="51" creationId="{F7B46DF1-5E0B-451A-8129-1D58963FA559}"/>
          </ac:spMkLst>
        </pc:spChg>
        <pc:spChg chg="add mod">
          <ac:chgData name="Sameer G Joshi (DJPR)" userId="bd06337d-ce8c-4c34-b1d1-7fbf8f91b6eb" providerId="ADAL" clId="{7BF6CCE1-D8BE-47A6-A57C-E281D236CFBA}" dt="2022-08-12T04:42:45.723" v="1965" actId="1035"/>
          <ac:spMkLst>
            <pc:docMk/>
            <pc:sldMk cId="2979161283" sldId="268"/>
            <ac:spMk id="52" creationId="{9D1F9D54-7C18-4A50-8AB4-9F2CD243D8F9}"/>
          </ac:spMkLst>
        </pc:spChg>
        <pc:spChg chg="add mod">
          <ac:chgData name="Sameer G Joshi (DJPR)" userId="bd06337d-ce8c-4c34-b1d1-7fbf8f91b6eb" providerId="ADAL" clId="{7BF6CCE1-D8BE-47A6-A57C-E281D236CFBA}" dt="2022-08-12T04:43:00.275" v="2008" actId="1037"/>
          <ac:spMkLst>
            <pc:docMk/>
            <pc:sldMk cId="2979161283" sldId="268"/>
            <ac:spMk id="53" creationId="{DC290F82-BCE8-4268-A117-8EA88107AD0B}"/>
          </ac:spMkLst>
        </pc:spChg>
        <pc:spChg chg="add mod">
          <ac:chgData name="Sameer G Joshi (DJPR)" userId="bd06337d-ce8c-4c34-b1d1-7fbf8f91b6eb" providerId="ADAL" clId="{7BF6CCE1-D8BE-47A6-A57C-E281D236CFBA}" dt="2022-08-12T04:43:14.883" v="2060" actId="1038"/>
          <ac:spMkLst>
            <pc:docMk/>
            <pc:sldMk cId="2979161283" sldId="268"/>
            <ac:spMk id="54" creationId="{65FF0721-822A-47C3-BEFF-9CE58D986B78}"/>
          </ac:spMkLst>
        </pc:spChg>
        <pc:spChg chg="add mod">
          <ac:chgData name="Sameer G Joshi (DJPR)" userId="bd06337d-ce8c-4c34-b1d1-7fbf8f91b6eb" providerId="ADAL" clId="{7BF6CCE1-D8BE-47A6-A57C-E281D236CFBA}" dt="2022-08-12T04:43:27.705" v="2104" actId="20577"/>
          <ac:spMkLst>
            <pc:docMk/>
            <pc:sldMk cId="2979161283" sldId="268"/>
            <ac:spMk id="55" creationId="{85B879E6-4739-47DA-9196-7C7A1405D2C8}"/>
          </ac:spMkLst>
        </pc:spChg>
        <pc:spChg chg="add mod">
          <ac:chgData name="Sameer G Joshi (DJPR)" userId="bd06337d-ce8c-4c34-b1d1-7fbf8f91b6eb" providerId="ADAL" clId="{7BF6CCE1-D8BE-47A6-A57C-E281D236CFBA}" dt="2022-08-12T04:43:41.371" v="2106" actId="1076"/>
          <ac:spMkLst>
            <pc:docMk/>
            <pc:sldMk cId="2979161283" sldId="268"/>
            <ac:spMk id="56" creationId="{36CB5031-A1FE-4C7F-8FB3-7F1755489ABD}"/>
          </ac:spMkLst>
        </pc:spChg>
        <pc:spChg chg="add mod">
          <ac:chgData name="Sameer G Joshi (DJPR)" userId="bd06337d-ce8c-4c34-b1d1-7fbf8f91b6eb" providerId="ADAL" clId="{7BF6CCE1-D8BE-47A6-A57C-E281D236CFBA}" dt="2022-08-12T04:43:55.548" v="2195" actId="1036"/>
          <ac:spMkLst>
            <pc:docMk/>
            <pc:sldMk cId="2979161283" sldId="268"/>
            <ac:spMk id="57" creationId="{E0BEC1EA-64E2-4BB3-AB61-9F1A0A6227CC}"/>
          </ac:spMkLst>
        </pc:spChg>
        <pc:spChg chg="add mod">
          <ac:chgData name="Sameer G Joshi (DJPR)" userId="bd06337d-ce8c-4c34-b1d1-7fbf8f91b6eb" providerId="ADAL" clId="{7BF6CCE1-D8BE-47A6-A57C-E281D236CFBA}" dt="2022-08-12T05:20:06.461" v="2198" actId="20577"/>
          <ac:spMkLst>
            <pc:docMk/>
            <pc:sldMk cId="2979161283" sldId="268"/>
            <ac:spMk id="58" creationId="{96BEE6CA-09BD-43C9-A8D1-90DDDDDCBE8E}"/>
          </ac:spMkLst>
        </pc:spChg>
        <pc:spChg chg="add del mod">
          <ac:chgData name="Sameer G Joshi (DJPR)" userId="bd06337d-ce8c-4c34-b1d1-7fbf8f91b6eb" providerId="ADAL" clId="{7BF6CCE1-D8BE-47A6-A57C-E281D236CFBA}" dt="2022-08-12T05:22:34.804" v="2200" actId="478"/>
          <ac:spMkLst>
            <pc:docMk/>
            <pc:sldMk cId="2979161283" sldId="268"/>
            <ac:spMk id="59" creationId="{DF8C87D4-4C0D-4FE3-B915-36F9AB5528DB}"/>
          </ac:spMkLst>
        </pc:spChg>
        <pc:spChg chg="add mod">
          <ac:chgData name="Sameer G Joshi (DJPR)" userId="bd06337d-ce8c-4c34-b1d1-7fbf8f91b6eb" providerId="ADAL" clId="{7BF6CCE1-D8BE-47A6-A57C-E281D236CFBA}" dt="2022-08-12T05:22:42.938" v="2202" actId="1076"/>
          <ac:spMkLst>
            <pc:docMk/>
            <pc:sldMk cId="2979161283" sldId="268"/>
            <ac:spMk id="60" creationId="{6B25A806-4176-4960-B5E8-D0D476557942}"/>
          </ac:spMkLst>
        </pc:spChg>
        <pc:spChg chg="add mod">
          <ac:chgData name="Sameer G Joshi (DJPR)" userId="bd06337d-ce8c-4c34-b1d1-7fbf8f91b6eb" providerId="ADAL" clId="{7BF6CCE1-D8BE-47A6-A57C-E281D236CFBA}" dt="2022-08-12T05:22:48.438" v="2204" actId="1076"/>
          <ac:spMkLst>
            <pc:docMk/>
            <pc:sldMk cId="2979161283" sldId="268"/>
            <ac:spMk id="61" creationId="{047E5746-9F60-4752-BDA7-4246574B6739}"/>
          </ac:spMkLst>
        </pc:spChg>
        <pc:spChg chg="add mod">
          <ac:chgData name="Sameer G Joshi (DJPR)" userId="bd06337d-ce8c-4c34-b1d1-7fbf8f91b6eb" providerId="ADAL" clId="{7BF6CCE1-D8BE-47A6-A57C-E281D236CFBA}" dt="2022-08-12T05:22:54.157" v="2206" actId="1076"/>
          <ac:spMkLst>
            <pc:docMk/>
            <pc:sldMk cId="2979161283" sldId="268"/>
            <ac:spMk id="62" creationId="{E616042F-1912-4C3C-BFF0-55AB7A70454D}"/>
          </ac:spMkLst>
        </pc:spChg>
        <pc:spChg chg="add mod">
          <ac:chgData name="Sameer G Joshi (DJPR)" userId="bd06337d-ce8c-4c34-b1d1-7fbf8f91b6eb" providerId="ADAL" clId="{7BF6CCE1-D8BE-47A6-A57C-E281D236CFBA}" dt="2022-08-12T05:23:04.687" v="2208" actId="1076"/>
          <ac:spMkLst>
            <pc:docMk/>
            <pc:sldMk cId="2979161283" sldId="268"/>
            <ac:spMk id="63" creationId="{C2CF1622-CC56-4DFD-A106-F292B08F7B31}"/>
          </ac:spMkLst>
        </pc:spChg>
        <pc:spChg chg="add mod">
          <ac:chgData name="Sameer G Joshi (DJPR)" userId="bd06337d-ce8c-4c34-b1d1-7fbf8f91b6eb" providerId="ADAL" clId="{7BF6CCE1-D8BE-47A6-A57C-E281D236CFBA}" dt="2022-08-12T05:23:09.951" v="2210" actId="1076"/>
          <ac:spMkLst>
            <pc:docMk/>
            <pc:sldMk cId="2979161283" sldId="268"/>
            <ac:spMk id="64" creationId="{787E0DC3-88D7-416A-B058-8DBE11355C67}"/>
          </ac:spMkLst>
        </pc:spChg>
        <pc:spChg chg="add mod">
          <ac:chgData name="Sameer G Joshi (DJPR)" userId="bd06337d-ce8c-4c34-b1d1-7fbf8f91b6eb" providerId="ADAL" clId="{7BF6CCE1-D8BE-47A6-A57C-E281D236CFBA}" dt="2022-08-12T05:23:17.851" v="2212" actId="1076"/>
          <ac:spMkLst>
            <pc:docMk/>
            <pc:sldMk cId="2979161283" sldId="268"/>
            <ac:spMk id="65" creationId="{9003693F-A57D-40F4-AB6B-524E9A92AC45}"/>
          </ac:spMkLst>
        </pc:spChg>
        <pc:spChg chg="add mod">
          <ac:chgData name="Sameer G Joshi (DJPR)" userId="bd06337d-ce8c-4c34-b1d1-7fbf8f91b6eb" providerId="ADAL" clId="{7BF6CCE1-D8BE-47A6-A57C-E281D236CFBA}" dt="2022-08-12T05:23:24.440" v="2214" actId="1076"/>
          <ac:spMkLst>
            <pc:docMk/>
            <pc:sldMk cId="2979161283" sldId="268"/>
            <ac:spMk id="66" creationId="{EC019B4F-BAC9-42BA-AAC9-774E9DFDC311}"/>
          </ac:spMkLst>
        </pc:spChg>
        <pc:spChg chg="add mod">
          <ac:chgData name="Sameer G Joshi (DJPR)" userId="bd06337d-ce8c-4c34-b1d1-7fbf8f91b6eb" providerId="ADAL" clId="{7BF6CCE1-D8BE-47A6-A57C-E281D236CFBA}" dt="2022-08-12T05:23:32.855" v="2216" actId="1076"/>
          <ac:spMkLst>
            <pc:docMk/>
            <pc:sldMk cId="2979161283" sldId="268"/>
            <ac:spMk id="67" creationId="{22A66B30-F020-4207-8F0B-1543634A40B0}"/>
          </ac:spMkLst>
        </pc:spChg>
        <pc:spChg chg="add mod">
          <ac:chgData name="Sameer G Joshi (DJPR)" userId="bd06337d-ce8c-4c34-b1d1-7fbf8f91b6eb" providerId="ADAL" clId="{7BF6CCE1-D8BE-47A6-A57C-E281D236CFBA}" dt="2022-08-12T05:23:39.246" v="2218" actId="1076"/>
          <ac:spMkLst>
            <pc:docMk/>
            <pc:sldMk cId="2979161283" sldId="268"/>
            <ac:spMk id="68" creationId="{C4B177B5-8B96-4ADC-BD2D-BA42C0BFB364}"/>
          </ac:spMkLst>
        </pc:spChg>
        <pc:spChg chg="add mod">
          <ac:chgData name="Sameer G Joshi (DJPR)" userId="bd06337d-ce8c-4c34-b1d1-7fbf8f91b6eb" providerId="ADAL" clId="{7BF6CCE1-D8BE-47A6-A57C-E281D236CFBA}" dt="2022-08-12T05:23:44.073" v="2220" actId="1076"/>
          <ac:spMkLst>
            <pc:docMk/>
            <pc:sldMk cId="2979161283" sldId="268"/>
            <ac:spMk id="69" creationId="{BFBAA2B5-0328-44FF-946A-B95FBD2DC819}"/>
          </ac:spMkLst>
        </pc:spChg>
        <pc:spChg chg="add mod">
          <ac:chgData name="Sameer G Joshi (DJPR)" userId="bd06337d-ce8c-4c34-b1d1-7fbf8f91b6eb" providerId="ADAL" clId="{7BF6CCE1-D8BE-47A6-A57C-E281D236CFBA}" dt="2022-08-12T05:23:49.638" v="2222" actId="1076"/>
          <ac:spMkLst>
            <pc:docMk/>
            <pc:sldMk cId="2979161283" sldId="268"/>
            <ac:spMk id="70" creationId="{53A151F2-3040-4B32-8A92-89D7C6C2DEA4}"/>
          </ac:spMkLst>
        </pc:spChg>
        <pc:spChg chg="add mod">
          <ac:chgData name="Sameer G Joshi (DJPR)" userId="bd06337d-ce8c-4c34-b1d1-7fbf8f91b6eb" providerId="ADAL" clId="{7BF6CCE1-D8BE-47A6-A57C-E281D236CFBA}" dt="2022-08-12T05:23:55.073" v="2224" actId="1076"/>
          <ac:spMkLst>
            <pc:docMk/>
            <pc:sldMk cId="2979161283" sldId="268"/>
            <ac:spMk id="71" creationId="{1DCEA661-A037-46E7-A585-7383444AD51B}"/>
          </ac:spMkLst>
        </pc:spChg>
        <pc:spChg chg="add mod">
          <ac:chgData name="Sameer G Joshi (DJPR)" userId="bd06337d-ce8c-4c34-b1d1-7fbf8f91b6eb" providerId="ADAL" clId="{7BF6CCE1-D8BE-47A6-A57C-E281D236CFBA}" dt="2022-08-12T05:24:07.606" v="2227" actId="20577"/>
          <ac:spMkLst>
            <pc:docMk/>
            <pc:sldMk cId="2979161283" sldId="268"/>
            <ac:spMk id="72" creationId="{FC498652-0A99-4494-9C63-2C11251D2B16}"/>
          </ac:spMkLst>
        </pc:spChg>
        <pc:spChg chg="add mod">
          <ac:chgData name="Sameer G Joshi (DJPR)" userId="bd06337d-ce8c-4c34-b1d1-7fbf8f91b6eb" providerId="ADAL" clId="{7BF6CCE1-D8BE-47A6-A57C-E281D236CFBA}" dt="2022-08-12T05:24:14.229" v="2229" actId="1076"/>
          <ac:spMkLst>
            <pc:docMk/>
            <pc:sldMk cId="2979161283" sldId="268"/>
            <ac:spMk id="73" creationId="{5EFF3373-B822-414A-9B31-072CBED3EA84}"/>
          </ac:spMkLst>
        </pc:spChg>
        <pc:spChg chg="add mod">
          <ac:chgData name="Sameer G Joshi (DJPR)" userId="bd06337d-ce8c-4c34-b1d1-7fbf8f91b6eb" providerId="ADAL" clId="{7BF6CCE1-D8BE-47A6-A57C-E281D236CFBA}" dt="2022-08-12T05:24:21.447" v="2232" actId="20577"/>
          <ac:spMkLst>
            <pc:docMk/>
            <pc:sldMk cId="2979161283" sldId="268"/>
            <ac:spMk id="74" creationId="{2BE327E9-378D-4A3B-B479-EB6FCB739E4D}"/>
          </ac:spMkLst>
        </pc:spChg>
      </pc:sldChg>
      <pc:sldChg chg="addSp delSp modSp new mod">
        <pc:chgData name="Sameer G Joshi (DJPR)" userId="bd06337d-ce8c-4c34-b1d1-7fbf8f91b6eb" providerId="ADAL" clId="{7BF6CCE1-D8BE-47A6-A57C-E281D236CFBA}" dt="2022-08-11T13:20:14.605" v="715" actId="12788"/>
        <pc:sldMkLst>
          <pc:docMk/>
          <pc:sldMk cId="431396935" sldId="270"/>
        </pc:sldMkLst>
        <pc:spChg chg="del">
          <ac:chgData name="Sameer G Joshi (DJPR)" userId="bd06337d-ce8c-4c34-b1d1-7fbf8f91b6eb" providerId="ADAL" clId="{7BF6CCE1-D8BE-47A6-A57C-E281D236CFBA}" dt="2022-08-11T13:03:33.499" v="472" actId="478"/>
          <ac:spMkLst>
            <pc:docMk/>
            <pc:sldMk cId="431396935" sldId="270"/>
            <ac:spMk id="2" creationId="{B5818CD1-1D0F-4FAB-866A-8102C49D9C10}"/>
          </ac:spMkLst>
        </pc:spChg>
        <pc:spChg chg="del">
          <ac:chgData name="Sameer G Joshi (DJPR)" userId="bd06337d-ce8c-4c34-b1d1-7fbf8f91b6eb" providerId="ADAL" clId="{7BF6CCE1-D8BE-47A6-A57C-E281D236CFBA}" dt="2022-08-11T13:03:33.499" v="472" actId="478"/>
          <ac:spMkLst>
            <pc:docMk/>
            <pc:sldMk cId="431396935" sldId="270"/>
            <ac:spMk id="3" creationId="{2A870C78-CF48-4C65-953D-9DC1593AED5A}"/>
          </ac:spMkLst>
        </pc:spChg>
        <pc:spChg chg="add mod">
          <ac:chgData name="Sameer G Joshi (DJPR)" userId="bd06337d-ce8c-4c34-b1d1-7fbf8f91b6eb" providerId="ADAL" clId="{7BF6CCE1-D8BE-47A6-A57C-E281D236CFBA}" dt="2022-08-11T13:10:04.245" v="493" actId="1076"/>
          <ac:spMkLst>
            <pc:docMk/>
            <pc:sldMk cId="431396935" sldId="270"/>
            <ac:spMk id="8" creationId="{55245928-502E-4B50-BEE5-45CDBA1A1057}"/>
          </ac:spMkLst>
        </pc:spChg>
        <pc:spChg chg="add mod">
          <ac:chgData name="Sameer G Joshi (DJPR)" userId="bd06337d-ce8c-4c34-b1d1-7fbf8f91b6eb" providerId="ADAL" clId="{7BF6CCE1-D8BE-47A6-A57C-E281D236CFBA}" dt="2022-08-11T13:10:08.629" v="494" actId="1076"/>
          <ac:spMkLst>
            <pc:docMk/>
            <pc:sldMk cId="431396935" sldId="270"/>
            <ac:spMk id="9" creationId="{898354EF-20F5-4240-A265-4DB8854181BD}"/>
          </ac:spMkLst>
        </pc:spChg>
        <pc:spChg chg="add mod">
          <ac:chgData name="Sameer G Joshi (DJPR)" userId="bd06337d-ce8c-4c34-b1d1-7fbf8f91b6eb" providerId="ADAL" clId="{7BF6CCE1-D8BE-47A6-A57C-E281D236CFBA}" dt="2022-08-11T13:12:42.378" v="559" actId="12788"/>
          <ac:spMkLst>
            <pc:docMk/>
            <pc:sldMk cId="431396935" sldId="270"/>
            <ac:spMk id="10" creationId="{191332D6-5BED-47DF-841B-D8C6A66BAE79}"/>
          </ac:spMkLst>
        </pc:spChg>
        <pc:spChg chg="add mod">
          <ac:chgData name="Sameer G Joshi (DJPR)" userId="bd06337d-ce8c-4c34-b1d1-7fbf8f91b6eb" providerId="ADAL" clId="{7BF6CCE1-D8BE-47A6-A57C-E281D236CFBA}" dt="2022-08-11T13:12:42.378" v="559" actId="12788"/>
          <ac:spMkLst>
            <pc:docMk/>
            <pc:sldMk cId="431396935" sldId="270"/>
            <ac:spMk id="11" creationId="{F3F65DBD-30E1-4B7A-B16D-7C62BD46E801}"/>
          </ac:spMkLst>
        </pc:spChg>
        <pc:spChg chg="add mod">
          <ac:chgData name="Sameer G Joshi (DJPR)" userId="bd06337d-ce8c-4c34-b1d1-7fbf8f91b6eb" providerId="ADAL" clId="{7BF6CCE1-D8BE-47A6-A57C-E281D236CFBA}" dt="2022-08-11T13:14:53.004" v="564" actId="1076"/>
          <ac:spMkLst>
            <pc:docMk/>
            <pc:sldMk cId="431396935" sldId="270"/>
            <ac:spMk id="12" creationId="{1B923363-9290-4194-9E9A-922E15556F01}"/>
          </ac:spMkLst>
        </pc:spChg>
        <pc:spChg chg="add mod">
          <ac:chgData name="Sameer G Joshi (DJPR)" userId="bd06337d-ce8c-4c34-b1d1-7fbf8f91b6eb" providerId="ADAL" clId="{7BF6CCE1-D8BE-47A6-A57C-E281D236CFBA}" dt="2022-08-11T13:15:11.893" v="566" actId="1076"/>
          <ac:spMkLst>
            <pc:docMk/>
            <pc:sldMk cId="431396935" sldId="270"/>
            <ac:spMk id="13" creationId="{20B7DD1C-7CD3-49AC-9011-FBD65396D079}"/>
          </ac:spMkLst>
        </pc:spChg>
        <pc:spChg chg="add mod">
          <ac:chgData name="Sameer G Joshi (DJPR)" userId="bd06337d-ce8c-4c34-b1d1-7fbf8f91b6eb" providerId="ADAL" clId="{7BF6CCE1-D8BE-47A6-A57C-E281D236CFBA}" dt="2022-08-11T13:15:22.333" v="575" actId="1038"/>
          <ac:spMkLst>
            <pc:docMk/>
            <pc:sldMk cId="431396935" sldId="270"/>
            <ac:spMk id="14" creationId="{69DCDB21-A806-4B06-AABC-62D85215C1A6}"/>
          </ac:spMkLst>
        </pc:spChg>
        <pc:spChg chg="add mod">
          <ac:chgData name="Sameer G Joshi (DJPR)" userId="bd06337d-ce8c-4c34-b1d1-7fbf8f91b6eb" providerId="ADAL" clId="{7BF6CCE1-D8BE-47A6-A57C-E281D236CFBA}" dt="2022-08-11T13:15:30.317" v="624" actId="1035"/>
          <ac:spMkLst>
            <pc:docMk/>
            <pc:sldMk cId="431396935" sldId="270"/>
            <ac:spMk id="15" creationId="{97906485-29FE-4B8B-8540-4F71DDD04286}"/>
          </ac:spMkLst>
        </pc:spChg>
        <pc:spChg chg="add mod">
          <ac:chgData name="Sameer G Joshi (DJPR)" userId="bd06337d-ce8c-4c34-b1d1-7fbf8f91b6eb" providerId="ADAL" clId="{7BF6CCE1-D8BE-47A6-A57C-E281D236CFBA}" dt="2022-08-11T13:16:22.446" v="664" actId="20577"/>
          <ac:spMkLst>
            <pc:docMk/>
            <pc:sldMk cId="431396935" sldId="270"/>
            <ac:spMk id="16" creationId="{3BE9808A-6EDB-490B-BFF6-F1A6B8D34931}"/>
          </ac:spMkLst>
        </pc:spChg>
        <pc:spChg chg="add mod">
          <ac:chgData name="Sameer G Joshi (DJPR)" userId="bd06337d-ce8c-4c34-b1d1-7fbf8f91b6eb" providerId="ADAL" clId="{7BF6CCE1-D8BE-47A6-A57C-E281D236CFBA}" dt="2022-08-11T13:16:25.093" v="666" actId="20577"/>
          <ac:spMkLst>
            <pc:docMk/>
            <pc:sldMk cId="431396935" sldId="270"/>
            <ac:spMk id="17" creationId="{00BC26A1-D83C-4589-AB6C-01397AFE7A71}"/>
          </ac:spMkLst>
        </pc:spChg>
        <pc:spChg chg="add mod">
          <ac:chgData name="Sameer G Joshi (DJPR)" userId="bd06337d-ce8c-4c34-b1d1-7fbf8f91b6eb" providerId="ADAL" clId="{7BF6CCE1-D8BE-47A6-A57C-E281D236CFBA}" dt="2022-08-11T13:16:27.654" v="668" actId="20577"/>
          <ac:spMkLst>
            <pc:docMk/>
            <pc:sldMk cId="431396935" sldId="270"/>
            <ac:spMk id="18" creationId="{2D7E4241-C8DF-4F55-BD4B-C014526E02A9}"/>
          </ac:spMkLst>
        </pc:spChg>
        <pc:spChg chg="add mod">
          <ac:chgData name="Sameer G Joshi (DJPR)" userId="bd06337d-ce8c-4c34-b1d1-7fbf8f91b6eb" providerId="ADAL" clId="{7BF6CCE1-D8BE-47A6-A57C-E281D236CFBA}" dt="2022-08-11T13:16:18.174" v="662" actId="20577"/>
          <ac:spMkLst>
            <pc:docMk/>
            <pc:sldMk cId="431396935" sldId="270"/>
            <ac:spMk id="19" creationId="{B8D3BB3C-2F59-4C11-9356-7DC9ED4E1976}"/>
          </ac:spMkLst>
        </pc:spChg>
        <pc:spChg chg="add mod">
          <ac:chgData name="Sameer G Joshi (DJPR)" userId="bd06337d-ce8c-4c34-b1d1-7fbf8f91b6eb" providerId="ADAL" clId="{7BF6CCE1-D8BE-47A6-A57C-E281D236CFBA}" dt="2022-08-11T13:17:09.217" v="670" actId="1076"/>
          <ac:spMkLst>
            <pc:docMk/>
            <pc:sldMk cId="431396935" sldId="270"/>
            <ac:spMk id="20" creationId="{DF88FC0F-B590-43A8-947B-3B9F4189BDA4}"/>
          </ac:spMkLst>
        </pc:spChg>
        <pc:spChg chg="add mod">
          <ac:chgData name="Sameer G Joshi (DJPR)" userId="bd06337d-ce8c-4c34-b1d1-7fbf8f91b6eb" providerId="ADAL" clId="{7BF6CCE1-D8BE-47A6-A57C-E281D236CFBA}" dt="2022-08-11T13:17:27.846" v="681" actId="20577"/>
          <ac:spMkLst>
            <pc:docMk/>
            <pc:sldMk cId="431396935" sldId="270"/>
            <ac:spMk id="21" creationId="{7E72B7D0-9370-4041-8B71-866EF6323A08}"/>
          </ac:spMkLst>
        </pc:spChg>
        <pc:spChg chg="add mod">
          <ac:chgData name="Sameer G Joshi (DJPR)" userId="bd06337d-ce8c-4c34-b1d1-7fbf8f91b6eb" providerId="ADAL" clId="{7BF6CCE1-D8BE-47A6-A57C-E281D236CFBA}" dt="2022-08-11T13:17:55.646" v="693" actId="20577"/>
          <ac:spMkLst>
            <pc:docMk/>
            <pc:sldMk cId="431396935" sldId="270"/>
            <ac:spMk id="22" creationId="{9DF807A9-70FE-4D7A-9606-DC84B37B779D}"/>
          </ac:spMkLst>
        </pc:spChg>
        <pc:spChg chg="add mod">
          <ac:chgData name="Sameer G Joshi (DJPR)" userId="bd06337d-ce8c-4c34-b1d1-7fbf8f91b6eb" providerId="ADAL" clId="{7BF6CCE1-D8BE-47A6-A57C-E281D236CFBA}" dt="2022-08-11T13:17:59.583" v="695" actId="20577"/>
          <ac:spMkLst>
            <pc:docMk/>
            <pc:sldMk cId="431396935" sldId="270"/>
            <ac:spMk id="23" creationId="{5D045660-F623-4FD7-B28F-B3DEFA77FC4C}"/>
          </ac:spMkLst>
        </pc:spChg>
        <pc:spChg chg="add mod">
          <ac:chgData name="Sameer G Joshi (DJPR)" userId="bd06337d-ce8c-4c34-b1d1-7fbf8f91b6eb" providerId="ADAL" clId="{7BF6CCE1-D8BE-47A6-A57C-E281D236CFBA}" dt="2022-08-11T13:18:44.782" v="698" actId="20577"/>
          <ac:spMkLst>
            <pc:docMk/>
            <pc:sldMk cId="431396935" sldId="270"/>
            <ac:spMk id="24" creationId="{5601D2D7-97C4-4EBF-A869-B22CF545E201}"/>
          </ac:spMkLst>
        </pc:spChg>
        <pc:spChg chg="add mod">
          <ac:chgData name="Sameer G Joshi (DJPR)" userId="bd06337d-ce8c-4c34-b1d1-7fbf8f91b6eb" providerId="ADAL" clId="{7BF6CCE1-D8BE-47A6-A57C-E281D236CFBA}" dt="2022-08-11T13:18:53.598" v="705" actId="20577"/>
          <ac:spMkLst>
            <pc:docMk/>
            <pc:sldMk cId="431396935" sldId="270"/>
            <ac:spMk id="25" creationId="{152993A1-1ACF-449E-B805-5DDEF232458F}"/>
          </ac:spMkLst>
        </pc:spChg>
        <pc:spChg chg="add mod">
          <ac:chgData name="Sameer G Joshi (DJPR)" userId="bd06337d-ce8c-4c34-b1d1-7fbf8f91b6eb" providerId="ADAL" clId="{7BF6CCE1-D8BE-47A6-A57C-E281D236CFBA}" dt="2022-08-11T13:19:02.112" v="708" actId="20577"/>
          <ac:spMkLst>
            <pc:docMk/>
            <pc:sldMk cId="431396935" sldId="270"/>
            <ac:spMk id="26" creationId="{7F18F51A-A0F1-47BE-8585-678CDE7200E3}"/>
          </ac:spMkLst>
        </pc:spChg>
        <pc:spChg chg="add mod">
          <ac:chgData name="Sameer G Joshi (DJPR)" userId="bd06337d-ce8c-4c34-b1d1-7fbf8f91b6eb" providerId="ADAL" clId="{7BF6CCE1-D8BE-47A6-A57C-E281D236CFBA}" dt="2022-08-11T13:19:09.118" v="711" actId="20577"/>
          <ac:spMkLst>
            <pc:docMk/>
            <pc:sldMk cId="431396935" sldId="270"/>
            <ac:spMk id="27" creationId="{07B75C50-5245-4FD6-854A-7CB67FE2627D}"/>
          </ac:spMkLst>
        </pc:spChg>
        <pc:spChg chg="add mod">
          <ac:chgData name="Sameer G Joshi (DJPR)" userId="bd06337d-ce8c-4c34-b1d1-7fbf8f91b6eb" providerId="ADAL" clId="{7BF6CCE1-D8BE-47A6-A57C-E281D236CFBA}" dt="2022-08-11T13:20:14.605" v="715" actId="12788"/>
          <ac:spMkLst>
            <pc:docMk/>
            <pc:sldMk cId="431396935" sldId="270"/>
            <ac:spMk id="28" creationId="{24CB00F3-1B4E-4754-8590-B90A92402110}"/>
          </ac:spMkLst>
        </pc:spChg>
        <pc:spChg chg="add mod">
          <ac:chgData name="Sameer G Joshi (DJPR)" userId="bd06337d-ce8c-4c34-b1d1-7fbf8f91b6eb" providerId="ADAL" clId="{7BF6CCE1-D8BE-47A6-A57C-E281D236CFBA}" dt="2022-08-11T13:20:14.605" v="715" actId="12788"/>
          <ac:spMkLst>
            <pc:docMk/>
            <pc:sldMk cId="431396935" sldId="270"/>
            <ac:spMk id="29" creationId="{3954DA14-F553-4160-A38B-E57C33FE0C3F}"/>
          </ac:spMkLst>
        </pc:spChg>
        <pc:picChg chg="add mod modCrop">
          <ac:chgData name="Sameer G Joshi (DJPR)" userId="bd06337d-ce8c-4c34-b1d1-7fbf8f91b6eb" providerId="ADAL" clId="{7BF6CCE1-D8BE-47A6-A57C-E281D236CFBA}" dt="2022-08-11T13:06:55.725" v="480" actId="732"/>
          <ac:picMkLst>
            <pc:docMk/>
            <pc:sldMk cId="431396935" sldId="270"/>
            <ac:picMk id="5" creationId="{7A637FB7-80E8-4403-AFE3-CCF6300B6310}"/>
          </ac:picMkLst>
        </pc:picChg>
        <pc:picChg chg="add mod modCrop">
          <ac:chgData name="Sameer G Joshi (DJPR)" userId="bd06337d-ce8c-4c34-b1d1-7fbf8f91b6eb" providerId="ADAL" clId="{7BF6CCE1-D8BE-47A6-A57C-E281D236CFBA}" dt="2022-08-11T13:08:59.147" v="490" actId="1076"/>
          <ac:picMkLst>
            <pc:docMk/>
            <pc:sldMk cId="431396935" sldId="270"/>
            <ac:picMk id="7" creationId="{6AE66881-A4DA-411F-98E1-77FFE9F3185B}"/>
          </ac:picMkLst>
        </pc:picChg>
      </pc:sldChg>
    </pc:docChg>
  </pc:docChgLst>
  <pc:docChgLst>
    <pc:chgData name="Garry M Rosewarne (DJPR)" userId="51564b9f-0e86-4dd8-9e91-f771a6d10681" providerId="ADAL" clId="{9BEB1E0D-27F8-4284-B2D7-1581E69CC78E}"/>
    <pc:docChg chg="custSel modSld">
      <pc:chgData name="Garry M Rosewarne (DJPR)" userId="51564b9f-0e86-4dd8-9e91-f771a6d10681" providerId="ADAL" clId="{9BEB1E0D-27F8-4284-B2D7-1581E69CC78E}" dt="2021-12-21T21:54:20.218" v="2" actId="1589"/>
      <pc:docMkLst>
        <pc:docMk/>
      </pc:docMkLst>
      <pc:sldChg chg="addCm">
        <pc:chgData name="Garry M Rosewarne (DJPR)" userId="51564b9f-0e86-4dd8-9e91-f771a6d10681" providerId="ADAL" clId="{9BEB1E0D-27F8-4284-B2D7-1581E69CC78E}" dt="2021-12-21T21:54:20.218" v="2" actId="1589"/>
        <pc:sldMkLst>
          <pc:docMk/>
          <pc:sldMk cId="424659793" sldId="259"/>
        </pc:sldMkLst>
      </pc:sldChg>
      <pc:sldChg chg="addCm modCm">
        <pc:chgData name="Garry M Rosewarne (DJPR)" userId="51564b9f-0e86-4dd8-9e91-f771a6d10681" providerId="ADAL" clId="{9BEB1E0D-27F8-4284-B2D7-1581E69CC78E}" dt="2021-12-21T21:53:53.215" v="1"/>
        <pc:sldMkLst>
          <pc:docMk/>
          <pc:sldMk cId="2000004557" sldId="260"/>
        </pc:sldMkLst>
      </pc:sldChg>
    </pc:docChg>
  </pc:docChgLst>
  <pc:docChgLst>
    <pc:chgData name="Sameer" userId="bd06337d-ce8c-4c34-b1d1-7fbf8f91b6eb" providerId="ADAL" clId="{449E2AB2-FE71-461C-94D3-9E867087BE31}"/>
    <pc:docChg chg="undo custSel addSld modSld">
      <pc:chgData name="Sameer" userId="bd06337d-ce8c-4c34-b1d1-7fbf8f91b6eb" providerId="ADAL" clId="{449E2AB2-FE71-461C-94D3-9E867087BE31}" dt="2021-03-22T04:54:03.553" v="1286" actId="1076"/>
      <pc:docMkLst>
        <pc:docMk/>
      </pc:docMkLst>
      <pc:sldChg chg="modSp mod">
        <pc:chgData name="Sameer" userId="bd06337d-ce8c-4c34-b1d1-7fbf8f91b6eb" providerId="ADAL" clId="{449E2AB2-FE71-461C-94D3-9E867087BE31}" dt="2021-03-22T01:39:45.033" v="944" actId="20577"/>
        <pc:sldMkLst>
          <pc:docMk/>
          <pc:sldMk cId="3352034816" sldId="256"/>
        </pc:sldMkLst>
        <pc:spChg chg="mod">
          <ac:chgData name="Sameer" userId="bd06337d-ce8c-4c34-b1d1-7fbf8f91b6eb" providerId="ADAL" clId="{449E2AB2-FE71-461C-94D3-9E867087BE31}" dt="2021-03-22T01:39:45.033" v="944" actId="20577"/>
          <ac:spMkLst>
            <pc:docMk/>
            <pc:sldMk cId="3352034816" sldId="256"/>
            <ac:spMk id="8" creationId="{520DCA2E-CECA-42FB-8D8D-F305B5344E3E}"/>
          </ac:spMkLst>
        </pc:spChg>
      </pc:sldChg>
      <pc:sldChg chg="modSp mod">
        <pc:chgData name="Sameer" userId="bd06337d-ce8c-4c34-b1d1-7fbf8f91b6eb" providerId="ADAL" clId="{449E2AB2-FE71-461C-94D3-9E867087BE31}" dt="2021-03-22T01:40:14.813" v="946" actId="113"/>
        <pc:sldMkLst>
          <pc:docMk/>
          <pc:sldMk cId="370308576" sldId="257"/>
        </pc:sldMkLst>
        <pc:spChg chg="mod">
          <ac:chgData name="Sameer" userId="bd06337d-ce8c-4c34-b1d1-7fbf8f91b6eb" providerId="ADAL" clId="{449E2AB2-FE71-461C-94D3-9E867087BE31}" dt="2021-03-22T01:40:14.813" v="946" actId="113"/>
          <ac:spMkLst>
            <pc:docMk/>
            <pc:sldMk cId="370308576" sldId="257"/>
            <ac:spMk id="11" creationId="{A23CB308-B3A7-472D-94CB-A4661D696ED2}"/>
          </ac:spMkLst>
        </pc:spChg>
      </pc:sldChg>
      <pc:sldChg chg="modSp mod">
        <pc:chgData name="Sameer" userId="bd06337d-ce8c-4c34-b1d1-7fbf8f91b6eb" providerId="ADAL" clId="{449E2AB2-FE71-461C-94D3-9E867087BE31}" dt="2021-03-22T01:41:13.532" v="972" actId="6549"/>
        <pc:sldMkLst>
          <pc:docMk/>
          <pc:sldMk cId="2203674866" sldId="258"/>
        </pc:sldMkLst>
        <pc:spChg chg="mod">
          <ac:chgData name="Sameer" userId="bd06337d-ce8c-4c34-b1d1-7fbf8f91b6eb" providerId="ADAL" clId="{449E2AB2-FE71-461C-94D3-9E867087BE31}" dt="2021-03-22T01:34:34.814" v="911" actId="1076"/>
          <ac:spMkLst>
            <pc:docMk/>
            <pc:sldMk cId="2203674866" sldId="258"/>
            <ac:spMk id="11" creationId="{F47A1C11-6121-479E-999B-743F8B3B0102}"/>
          </ac:spMkLst>
        </pc:spChg>
        <pc:spChg chg="mod">
          <ac:chgData name="Sameer" userId="bd06337d-ce8c-4c34-b1d1-7fbf8f91b6eb" providerId="ADAL" clId="{449E2AB2-FE71-461C-94D3-9E867087BE31}" dt="2021-03-22T01:34:41.904" v="912" actId="1076"/>
          <ac:spMkLst>
            <pc:docMk/>
            <pc:sldMk cId="2203674866" sldId="258"/>
            <ac:spMk id="12" creationId="{39B48064-32AF-488B-A4AC-5E955AE5DC19}"/>
          </ac:spMkLst>
        </pc:spChg>
        <pc:spChg chg="mod">
          <ac:chgData name="Sameer" userId="bd06337d-ce8c-4c34-b1d1-7fbf8f91b6eb" providerId="ADAL" clId="{449E2AB2-FE71-461C-94D3-9E867087BE31}" dt="2021-03-22T01:34:51.600" v="914" actId="1076"/>
          <ac:spMkLst>
            <pc:docMk/>
            <pc:sldMk cId="2203674866" sldId="258"/>
            <ac:spMk id="13" creationId="{166DCA8E-895F-42C9-8D34-A942C93FDA3E}"/>
          </ac:spMkLst>
        </pc:spChg>
        <pc:spChg chg="mod">
          <ac:chgData name="Sameer" userId="bd06337d-ce8c-4c34-b1d1-7fbf8f91b6eb" providerId="ADAL" clId="{449E2AB2-FE71-461C-94D3-9E867087BE31}" dt="2021-03-22T01:34:47.082" v="913" actId="1076"/>
          <ac:spMkLst>
            <pc:docMk/>
            <pc:sldMk cId="2203674866" sldId="258"/>
            <ac:spMk id="14" creationId="{1A4BC8A9-00C7-4001-9DA9-3C8D33C7C327}"/>
          </ac:spMkLst>
        </pc:spChg>
        <pc:spChg chg="mod">
          <ac:chgData name="Sameer" userId="bd06337d-ce8c-4c34-b1d1-7fbf8f91b6eb" providerId="ADAL" clId="{449E2AB2-FE71-461C-94D3-9E867087BE31}" dt="2021-03-22T01:41:13.532" v="972" actId="6549"/>
          <ac:spMkLst>
            <pc:docMk/>
            <pc:sldMk cId="2203674866" sldId="258"/>
            <ac:spMk id="19" creationId="{106A8FBD-909B-4774-B43F-1FC484A71BE3}"/>
          </ac:spMkLst>
        </pc:spChg>
        <pc:picChg chg="mod">
          <ac:chgData name="Sameer" userId="bd06337d-ce8c-4c34-b1d1-7fbf8f91b6eb" providerId="ADAL" clId="{449E2AB2-FE71-461C-94D3-9E867087BE31}" dt="2021-03-22T01:34:17.151" v="910" actId="14100"/>
          <ac:picMkLst>
            <pc:docMk/>
            <pc:sldMk cId="2203674866" sldId="258"/>
            <ac:picMk id="10" creationId="{981463CE-92E3-455D-B01F-2BD9BBE3F108}"/>
          </ac:picMkLst>
        </pc:picChg>
      </pc:sldChg>
      <pc:sldChg chg="addSp modSp mod">
        <pc:chgData name="Sameer" userId="bd06337d-ce8c-4c34-b1d1-7fbf8f91b6eb" providerId="ADAL" clId="{449E2AB2-FE71-461C-94D3-9E867087BE31}" dt="2021-03-22T01:55:32.012" v="1148" actId="6549"/>
        <pc:sldMkLst>
          <pc:docMk/>
          <pc:sldMk cId="424659793" sldId="259"/>
        </pc:sldMkLst>
        <pc:spChg chg="add mod">
          <ac:chgData name="Sameer" userId="bd06337d-ce8c-4c34-b1d1-7fbf8f91b6eb" providerId="ADAL" clId="{449E2AB2-FE71-461C-94D3-9E867087BE31}" dt="2021-03-22T01:42:42.796" v="992" actId="20577"/>
          <ac:spMkLst>
            <pc:docMk/>
            <pc:sldMk cId="424659793" sldId="259"/>
            <ac:spMk id="45" creationId="{0227BC53-1451-4229-BC1B-B04DA18D1F65}"/>
          </ac:spMkLst>
        </pc:spChg>
        <pc:spChg chg="add mod">
          <ac:chgData name="Sameer" userId="bd06337d-ce8c-4c34-b1d1-7fbf8f91b6eb" providerId="ADAL" clId="{449E2AB2-FE71-461C-94D3-9E867087BE31}" dt="2021-03-22T01:42:47.004" v="994" actId="20577"/>
          <ac:spMkLst>
            <pc:docMk/>
            <pc:sldMk cId="424659793" sldId="259"/>
            <ac:spMk id="46" creationId="{74B73A61-87F6-4DB1-BB45-EF26BF045C5D}"/>
          </ac:spMkLst>
        </pc:spChg>
        <pc:spChg chg="add mod">
          <ac:chgData name="Sameer" userId="bd06337d-ce8c-4c34-b1d1-7fbf8f91b6eb" providerId="ADAL" clId="{449E2AB2-FE71-461C-94D3-9E867087BE31}" dt="2021-03-22T01:42:51.109" v="996" actId="20577"/>
          <ac:spMkLst>
            <pc:docMk/>
            <pc:sldMk cId="424659793" sldId="259"/>
            <ac:spMk id="47" creationId="{20092974-FFF2-427F-86BE-3F8CE2B7DF58}"/>
          </ac:spMkLst>
        </pc:spChg>
        <pc:spChg chg="add mod">
          <ac:chgData name="Sameer" userId="bd06337d-ce8c-4c34-b1d1-7fbf8f91b6eb" providerId="ADAL" clId="{449E2AB2-FE71-461C-94D3-9E867087BE31}" dt="2021-03-22T01:42:54.766" v="998" actId="20577"/>
          <ac:spMkLst>
            <pc:docMk/>
            <pc:sldMk cId="424659793" sldId="259"/>
            <ac:spMk id="48" creationId="{6F2001C1-FB4C-440D-B8E4-8186B1FE4F5B}"/>
          </ac:spMkLst>
        </pc:spChg>
        <pc:spChg chg="add mod">
          <ac:chgData name="Sameer" userId="bd06337d-ce8c-4c34-b1d1-7fbf8f91b6eb" providerId="ADAL" clId="{449E2AB2-FE71-461C-94D3-9E867087BE31}" dt="2021-03-22T01:44:41.403" v="1002" actId="1076"/>
          <ac:spMkLst>
            <pc:docMk/>
            <pc:sldMk cId="424659793" sldId="259"/>
            <ac:spMk id="49" creationId="{6BD89384-B8F0-48CE-BB60-15E33C29F509}"/>
          </ac:spMkLst>
        </pc:spChg>
        <pc:spChg chg="add mod">
          <ac:chgData name="Sameer" userId="bd06337d-ce8c-4c34-b1d1-7fbf8f91b6eb" providerId="ADAL" clId="{449E2AB2-FE71-461C-94D3-9E867087BE31}" dt="2021-03-22T01:44:41.403" v="1002" actId="1076"/>
          <ac:spMkLst>
            <pc:docMk/>
            <pc:sldMk cId="424659793" sldId="259"/>
            <ac:spMk id="50" creationId="{81821875-2D3B-45C0-922F-745DD1306B42}"/>
          </ac:spMkLst>
        </pc:spChg>
        <pc:spChg chg="add mod">
          <ac:chgData name="Sameer" userId="bd06337d-ce8c-4c34-b1d1-7fbf8f91b6eb" providerId="ADAL" clId="{449E2AB2-FE71-461C-94D3-9E867087BE31}" dt="2021-03-22T01:44:41.403" v="1002" actId="1076"/>
          <ac:spMkLst>
            <pc:docMk/>
            <pc:sldMk cId="424659793" sldId="259"/>
            <ac:spMk id="51" creationId="{D0993CDF-5917-4120-87F5-545380F8F160}"/>
          </ac:spMkLst>
        </pc:spChg>
        <pc:spChg chg="mod">
          <ac:chgData name="Sameer" userId="bd06337d-ce8c-4c34-b1d1-7fbf8f91b6eb" providerId="ADAL" clId="{449E2AB2-FE71-461C-94D3-9E867087BE31}" dt="2021-03-22T01:41:41.320" v="987" actId="1035"/>
          <ac:spMkLst>
            <pc:docMk/>
            <pc:sldMk cId="424659793" sldId="259"/>
            <ac:spMk id="52" creationId="{04D8749E-0701-4826-8647-1EBE4FFF68C3}"/>
          </ac:spMkLst>
        </pc:spChg>
        <pc:spChg chg="mod">
          <ac:chgData name="Sameer" userId="bd06337d-ce8c-4c34-b1d1-7fbf8f91b6eb" providerId="ADAL" clId="{449E2AB2-FE71-461C-94D3-9E867087BE31}" dt="2021-03-22T01:41:41.320" v="987" actId="1035"/>
          <ac:spMkLst>
            <pc:docMk/>
            <pc:sldMk cId="424659793" sldId="259"/>
            <ac:spMk id="53" creationId="{46F2D02C-0EAA-4928-8836-AA0064670ACE}"/>
          </ac:spMkLst>
        </pc:spChg>
        <pc:spChg chg="mod">
          <ac:chgData name="Sameer" userId="bd06337d-ce8c-4c34-b1d1-7fbf8f91b6eb" providerId="ADAL" clId="{449E2AB2-FE71-461C-94D3-9E867087BE31}" dt="2021-03-22T01:41:41.320" v="987" actId="1035"/>
          <ac:spMkLst>
            <pc:docMk/>
            <pc:sldMk cId="424659793" sldId="259"/>
            <ac:spMk id="54" creationId="{FE813D58-DAF1-4639-BC1D-3DE4CBEF83FD}"/>
          </ac:spMkLst>
        </pc:spChg>
        <pc:spChg chg="mod">
          <ac:chgData name="Sameer" userId="bd06337d-ce8c-4c34-b1d1-7fbf8f91b6eb" providerId="ADAL" clId="{449E2AB2-FE71-461C-94D3-9E867087BE31}" dt="2021-03-22T01:41:41.320" v="987" actId="1035"/>
          <ac:spMkLst>
            <pc:docMk/>
            <pc:sldMk cId="424659793" sldId="259"/>
            <ac:spMk id="55" creationId="{B0C557C0-83C4-4E77-BD40-A7F21D2AC8EA}"/>
          </ac:spMkLst>
        </pc:spChg>
        <pc:spChg chg="mod">
          <ac:chgData name="Sameer" userId="bd06337d-ce8c-4c34-b1d1-7fbf8f91b6eb" providerId="ADAL" clId="{449E2AB2-FE71-461C-94D3-9E867087BE31}" dt="2021-03-22T01:41:41.320" v="987" actId="1035"/>
          <ac:spMkLst>
            <pc:docMk/>
            <pc:sldMk cId="424659793" sldId="259"/>
            <ac:spMk id="60" creationId="{B31399A1-928F-44CD-A96D-B340E4ADEE0B}"/>
          </ac:spMkLst>
        </pc:spChg>
        <pc:spChg chg="mod">
          <ac:chgData name="Sameer" userId="bd06337d-ce8c-4c34-b1d1-7fbf8f91b6eb" providerId="ADAL" clId="{449E2AB2-FE71-461C-94D3-9E867087BE31}" dt="2021-03-22T01:41:41.320" v="987" actId="1035"/>
          <ac:spMkLst>
            <pc:docMk/>
            <pc:sldMk cId="424659793" sldId="259"/>
            <ac:spMk id="61" creationId="{DE43E371-9D86-47B7-8835-26D443F69183}"/>
          </ac:spMkLst>
        </pc:spChg>
        <pc:spChg chg="mod">
          <ac:chgData name="Sameer" userId="bd06337d-ce8c-4c34-b1d1-7fbf8f91b6eb" providerId="ADAL" clId="{449E2AB2-FE71-461C-94D3-9E867087BE31}" dt="2021-03-22T01:41:41.320" v="987" actId="1035"/>
          <ac:spMkLst>
            <pc:docMk/>
            <pc:sldMk cId="424659793" sldId="259"/>
            <ac:spMk id="62" creationId="{F69A1AE3-1AA8-46D2-A368-96A14F0F66F8}"/>
          </ac:spMkLst>
        </pc:spChg>
        <pc:spChg chg="mod">
          <ac:chgData name="Sameer" userId="bd06337d-ce8c-4c34-b1d1-7fbf8f91b6eb" providerId="ADAL" clId="{449E2AB2-FE71-461C-94D3-9E867087BE31}" dt="2021-03-22T01:41:41.320" v="987" actId="1035"/>
          <ac:spMkLst>
            <pc:docMk/>
            <pc:sldMk cId="424659793" sldId="259"/>
            <ac:spMk id="63" creationId="{91B9C6C1-15B8-466A-8898-75F3D0455C44}"/>
          </ac:spMkLst>
        </pc:spChg>
        <pc:spChg chg="mod">
          <ac:chgData name="Sameer" userId="bd06337d-ce8c-4c34-b1d1-7fbf8f91b6eb" providerId="ADAL" clId="{449E2AB2-FE71-461C-94D3-9E867087BE31}" dt="2021-03-22T01:55:32.012" v="1148" actId="6549"/>
          <ac:spMkLst>
            <pc:docMk/>
            <pc:sldMk cId="424659793" sldId="259"/>
            <ac:spMk id="64" creationId="{E945096F-49E4-4222-A35A-CF28CE8283A8}"/>
          </ac:spMkLst>
        </pc:spChg>
        <pc:spChg chg="mod">
          <ac:chgData name="Sameer" userId="bd06337d-ce8c-4c34-b1d1-7fbf8f91b6eb" providerId="ADAL" clId="{449E2AB2-FE71-461C-94D3-9E867087BE31}" dt="2021-03-22T01:41:41.320" v="987" actId="1035"/>
          <ac:spMkLst>
            <pc:docMk/>
            <pc:sldMk cId="424659793" sldId="259"/>
            <ac:spMk id="66" creationId="{9A758585-214B-4CFE-9328-BF628DB65CA2}"/>
          </ac:spMkLst>
        </pc:spChg>
        <pc:spChg chg="add mod">
          <ac:chgData name="Sameer" userId="bd06337d-ce8c-4c34-b1d1-7fbf8f91b6eb" providerId="ADAL" clId="{449E2AB2-FE71-461C-94D3-9E867087BE31}" dt="2021-03-22T01:44:41.403" v="1002" actId="1076"/>
          <ac:spMkLst>
            <pc:docMk/>
            <pc:sldMk cId="424659793" sldId="259"/>
            <ac:spMk id="67" creationId="{0A73ADE7-BBEE-41CF-9677-8B35A13A483E}"/>
          </ac:spMkLst>
        </pc:spChg>
        <pc:spChg chg="add mod">
          <ac:chgData name="Sameer" userId="bd06337d-ce8c-4c34-b1d1-7fbf8f91b6eb" providerId="ADAL" clId="{449E2AB2-FE71-461C-94D3-9E867087BE31}" dt="2021-03-22T01:45:04.170" v="1004" actId="1076"/>
          <ac:spMkLst>
            <pc:docMk/>
            <pc:sldMk cId="424659793" sldId="259"/>
            <ac:spMk id="68" creationId="{83916AE0-9EAC-4561-8941-752C32314158}"/>
          </ac:spMkLst>
        </pc:spChg>
        <pc:spChg chg="add mod">
          <ac:chgData name="Sameer" userId="bd06337d-ce8c-4c34-b1d1-7fbf8f91b6eb" providerId="ADAL" clId="{449E2AB2-FE71-461C-94D3-9E867087BE31}" dt="2021-03-22T01:45:08.617" v="1007" actId="1036"/>
          <ac:spMkLst>
            <pc:docMk/>
            <pc:sldMk cId="424659793" sldId="259"/>
            <ac:spMk id="69" creationId="{F9FC764F-EBA4-4B4C-84F2-AB9A34FB7355}"/>
          </ac:spMkLst>
        </pc:spChg>
        <pc:spChg chg="add mod">
          <ac:chgData name="Sameer" userId="bd06337d-ce8c-4c34-b1d1-7fbf8f91b6eb" providerId="ADAL" clId="{449E2AB2-FE71-461C-94D3-9E867087BE31}" dt="2021-03-22T01:45:11.841" v="1011" actId="1036"/>
          <ac:spMkLst>
            <pc:docMk/>
            <pc:sldMk cId="424659793" sldId="259"/>
            <ac:spMk id="70" creationId="{25EF780B-AEAB-44D7-ADFF-FDD8C83D25AF}"/>
          </ac:spMkLst>
        </pc:spChg>
        <pc:spChg chg="add mod">
          <ac:chgData name="Sameer" userId="bd06337d-ce8c-4c34-b1d1-7fbf8f91b6eb" providerId="ADAL" clId="{449E2AB2-FE71-461C-94D3-9E867087BE31}" dt="2021-03-22T01:45:04.170" v="1004" actId="1076"/>
          <ac:spMkLst>
            <pc:docMk/>
            <pc:sldMk cId="424659793" sldId="259"/>
            <ac:spMk id="71" creationId="{CAB21247-47EC-4FF6-94C1-A376FDC9D1C8}"/>
          </ac:spMkLst>
        </pc:spChg>
        <pc:spChg chg="add mod">
          <ac:chgData name="Sameer" userId="bd06337d-ce8c-4c34-b1d1-7fbf8f91b6eb" providerId="ADAL" clId="{449E2AB2-FE71-461C-94D3-9E867087BE31}" dt="2021-03-22T01:45:26.509" v="1013" actId="1076"/>
          <ac:spMkLst>
            <pc:docMk/>
            <pc:sldMk cId="424659793" sldId="259"/>
            <ac:spMk id="72" creationId="{F7748153-2009-4C94-9A07-2AA420FA1AB4}"/>
          </ac:spMkLst>
        </pc:spChg>
        <pc:spChg chg="add mod">
          <ac:chgData name="Sameer" userId="bd06337d-ce8c-4c34-b1d1-7fbf8f91b6eb" providerId="ADAL" clId="{449E2AB2-FE71-461C-94D3-9E867087BE31}" dt="2021-03-22T01:45:26.509" v="1013" actId="1076"/>
          <ac:spMkLst>
            <pc:docMk/>
            <pc:sldMk cId="424659793" sldId="259"/>
            <ac:spMk id="73" creationId="{27D79F2D-F874-4538-8889-07FF2968E88A}"/>
          </ac:spMkLst>
        </pc:spChg>
        <pc:spChg chg="add mod">
          <ac:chgData name="Sameer" userId="bd06337d-ce8c-4c34-b1d1-7fbf8f91b6eb" providerId="ADAL" clId="{449E2AB2-FE71-461C-94D3-9E867087BE31}" dt="2021-03-22T01:45:26.509" v="1013" actId="1076"/>
          <ac:spMkLst>
            <pc:docMk/>
            <pc:sldMk cId="424659793" sldId="259"/>
            <ac:spMk id="74" creationId="{61C844A3-15BF-4CCE-8AB5-FDEC228B5B98}"/>
          </ac:spMkLst>
        </pc:spChg>
        <pc:spChg chg="add mod">
          <ac:chgData name="Sameer" userId="bd06337d-ce8c-4c34-b1d1-7fbf8f91b6eb" providerId="ADAL" clId="{449E2AB2-FE71-461C-94D3-9E867087BE31}" dt="2021-03-22T01:45:30.603" v="1015" actId="1036"/>
          <ac:spMkLst>
            <pc:docMk/>
            <pc:sldMk cId="424659793" sldId="259"/>
            <ac:spMk id="75" creationId="{75A0A8A1-8E8F-4113-A4B6-33148AD14392}"/>
          </ac:spMkLst>
        </pc:spChg>
        <pc:grpChg chg="mod">
          <ac:chgData name="Sameer" userId="bd06337d-ce8c-4c34-b1d1-7fbf8f91b6eb" providerId="ADAL" clId="{449E2AB2-FE71-461C-94D3-9E867087BE31}" dt="2021-03-22T01:41:41.320" v="987" actId="1035"/>
          <ac:grpSpMkLst>
            <pc:docMk/>
            <pc:sldMk cId="424659793" sldId="259"/>
            <ac:grpSpMk id="30" creationId="{9EA0A4B8-2729-41B2-8668-FA98BD79D0BE}"/>
          </ac:grpSpMkLst>
        </pc:grpChg>
        <pc:grpChg chg="mod">
          <ac:chgData name="Sameer" userId="bd06337d-ce8c-4c34-b1d1-7fbf8f91b6eb" providerId="ADAL" clId="{449E2AB2-FE71-461C-94D3-9E867087BE31}" dt="2021-03-22T01:41:41.320" v="987" actId="1035"/>
          <ac:grpSpMkLst>
            <pc:docMk/>
            <pc:sldMk cId="424659793" sldId="259"/>
            <ac:grpSpMk id="35" creationId="{A00F72AD-4F8B-41CB-9EC4-BDE7CD1BA065}"/>
          </ac:grpSpMkLst>
        </pc:grpChg>
      </pc:sldChg>
      <pc:sldChg chg="addSp delSp modSp mod">
        <pc:chgData name="Sameer" userId="bd06337d-ce8c-4c34-b1d1-7fbf8f91b6eb" providerId="ADAL" clId="{449E2AB2-FE71-461C-94D3-9E867087BE31}" dt="2021-03-22T04:49:07.610" v="1285" actId="6549"/>
        <pc:sldMkLst>
          <pc:docMk/>
          <pc:sldMk cId="2000004557" sldId="260"/>
        </pc:sldMkLst>
        <pc:spChg chg="mod">
          <ac:chgData name="Sameer" userId="bd06337d-ce8c-4c34-b1d1-7fbf8f91b6eb" providerId="ADAL" clId="{449E2AB2-FE71-461C-94D3-9E867087BE31}" dt="2021-03-22T01:35:20.022" v="917" actId="2710"/>
          <ac:spMkLst>
            <pc:docMk/>
            <pc:sldMk cId="2000004557" sldId="260"/>
            <ac:spMk id="6" creationId="{4E8C1A93-770A-4C1C-9961-68EC984DFA55}"/>
          </ac:spMkLst>
        </pc:spChg>
        <pc:spChg chg="mod">
          <ac:chgData name="Sameer" userId="bd06337d-ce8c-4c34-b1d1-7fbf8f91b6eb" providerId="ADAL" clId="{449E2AB2-FE71-461C-94D3-9E867087BE31}" dt="2021-03-22T04:49:07.610" v="1285" actId="6549"/>
          <ac:spMkLst>
            <pc:docMk/>
            <pc:sldMk cId="2000004557" sldId="260"/>
            <ac:spMk id="10" creationId="{59C0504E-C7AF-4D43-8383-ED0A5BC07BE9}"/>
          </ac:spMkLst>
        </pc:spChg>
        <pc:spChg chg="add mod">
          <ac:chgData name="Sameer" userId="bd06337d-ce8c-4c34-b1d1-7fbf8f91b6eb" providerId="ADAL" clId="{449E2AB2-FE71-461C-94D3-9E867087BE31}" dt="2021-03-22T01:31:39.434" v="809" actId="1076"/>
          <ac:spMkLst>
            <pc:docMk/>
            <pc:sldMk cId="2000004557" sldId="260"/>
            <ac:spMk id="11" creationId="{B85949FD-1409-4C16-86E6-61191A01DC54}"/>
          </ac:spMkLst>
        </pc:spChg>
        <pc:spChg chg="del">
          <ac:chgData name="Sameer" userId="bd06337d-ce8c-4c34-b1d1-7fbf8f91b6eb" providerId="ADAL" clId="{449E2AB2-FE71-461C-94D3-9E867087BE31}" dt="2021-03-22T01:31:31.535" v="807" actId="478"/>
          <ac:spMkLst>
            <pc:docMk/>
            <pc:sldMk cId="2000004557" sldId="260"/>
            <ac:spMk id="12" creationId="{A41F9AFE-C61D-425F-A866-666AE31AD4F0}"/>
          </ac:spMkLst>
        </pc:spChg>
      </pc:sldChg>
      <pc:sldChg chg="addSp delSp modSp new mod">
        <pc:chgData name="Sameer" userId="bd06337d-ce8c-4c34-b1d1-7fbf8f91b6eb" providerId="ADAL" clId="{449E2AB2-FE71-461C-94D3-9E867087BE31}" dt="2021-03-22T01:35:59.325" v="923" actId="1038"/>
        <pc:sldMkLst>
          <pc:docMk/>
          <pc:sldMk cId="3894103260" sldId="261"/>
        </pc:sldMkLst>
        <pc:spChg chg="del">
          <ac:chgData name="Sameer" userId="bd06337d-ce8c-4c34-b1d1-7fbf8f91b6eb" providerId="ADAL" clId="{449E2AB2-FE71-461C-94D3-9E867087BE31}" dt="2021-03-21T23:07:51.486" v="1" actId="478"/>
          <ac:spMkLst>
            <pc:docMk/>
            <pc:sldMk cId="3894103260" sldId="261"/>
            <ac:spMk id="2" creationId="{C8E52FA2-2B2B-4BD3-BAF6-69E23BE6D091}"/>
          </ac:spMkLst>
        </pc:spChg>
        <pc:spChg chg="del">
          <ac:chgData name="Sameer" userId="bd06337d-ce8c-4c34-b1d1-7fbf8f91b6eb" providerId="ADAL" clId="{449E2AB2-FE71-461C-94D3-9E867087BE31}" dt="2021-03-21T23:07:51.486" v="1" actId="478"/>
          <ac:spMkLst>
            <pc:docMk/>
            <pc:sldMk cId="3894103260" sldId="261"/>
            <ac:spMk id="3" creationId="{A1B71840-C47C-4D07-A935-1AF8939B25B5}"/>
          </ac:spMkLst>
        </pc:spChg>
        <pc:spChg chg="add mod">
          <ac:chgData name="Sameer" userId="bd06337d-ce8c-4c34-b1d1-7fbf8f91b6eb" providerId="ADAL" clId="{449E2AB2-FE71-461C-94D3-9E867087BE31}" dt="2021-03-22T01:14:04.252" v="786" actId="20577"/>
          <ac:spMkLst>
            <pc:docMk/>
            <pc:sldMk cId="3894103260" sldId="261"/>
            <ac:spMk id="7" creationId="{5DA62E7F-4D8B-4F68-A7A1-F0286AE3CEE2}"/>
          </ac:spMkLst>
        </pc:spChg>
        <pc:spChg chg="add mod">
          <ac:chgData name="Sameer" userId="bd06337d-ce8c-4c34-b1d1-7fbf8f91b6eb" providerId="ADAL" clId="{449E2AB2-FE71-461C-94D3-9E867087BE31}" dt="2021-03-22T01:14:09.393" v="788" actId="20577"/>
          <ac:spMkLst>
            <pc:docMk/>
            <pc:sldMk cId="3894103260" sldId="261"/>
            <ac:spMk id="8" creationId="{272C0B60-CFDB-4C5B-B2D1-AF4193BBDF06}"/>
          </ac:spMkLst>
        </pc:spChg>
        <pc:spChg chg="add mod">
          <ac:chgData name="Sameer" userId="bd06337d-ce8c-4c34-b1d1-7fbf8f91b6eb" providerId="ADAL" clId="{449E2AB2-FE71-461C-94D3-9E867087BE31}" dt="2021-03-22T01:13:25.796" v="782" actId="1036"/>
          <ac:spMkLst>
            <pc:docMk/>
            <pc:sldMk cId="3894103260" sldId="261"/>
            <ac:spMk id="9" creationId="{73D2CAE9-63A3-4C5F-AEC4-0D6D07752DAC}"/>
          </ac:spMkLst>
        </pc:spChg>
        <pc:spChg chg="add mod">
          <ac:chgData name="Sameer" userId="bd06337d-ce8c-4c34-b1d1-7fbf8f91b6eb" providerId="ADAL" clId="{449E2AB2-FE71-461C-94D3-9E867087BE31}" dt="2021-03-22T01:13:25.796" v="782" actId="1036"/>
          <ac:spMkLst>
            <pc:docMk/>
            <pc:sldMk cId="3894103260" sldId="261"/>
            <ac:spMk id="10" creationId="{3945BAE7-35EC-47C1-B85D-A5D4017CEEDF}"/>
          </ac:spMkLst>
        </pc:spChg>
        <pc:spChg chg="add mod">
          <ac:chgData name="Sameer" userId="bd06337d-ce8c-4c34-b1d1-7fbf8f91b6eb" providerId="ADAL" clId="{449E2AB2-FE71-461C-94D3-9E867087BE31}" dt="2021-03-22T01:12:52.853" v="707" actId="1036"/>
          <ac:spMkLst>
            <pc:docMk/>
            <pc:sldMk cId="3894103260" sldId="261"/>
            <ac:spMk id="11" creationId="{56822EF3-1A32-4209-9381-5ACEF9224BF9}"/>
          </ac:spMkLst>
        </pc:spChg>
        <pc:spChg chg="add mod">
          <ac:chgData name="Sameer" userId="bd06337d-ce8c-4c34-b1d1-7fbf8f91b6eb" providerId="ADAL" clId="{449E2AB2-FE71-461C-94D3-9E867087BE31}" dt="2021-03-22T01:12:52.853" v="707" actId="1036"/>
          <ac:spMkLst>
            <pc:docMk/>
            <pc:sldMk cId="3894103260" sldId="261"/>
            <ac:spMk id="12" creationId="{D07A34F5-E1D7-4963-92A4-A34305AD7E4D}"/>
          </ac:spMkLst>
        </pc:spChg>
        <pc:spChg chg="add mod">
          <ac:chgData name="Sameer" userId="bd06337d-ce8c-4c34-b1d1-7fbf8f91b6eb" providerId="ADAL" clId="{449E2AB2-FE71-461C-94D3-9E867087BE31}" dt="2021-03-22T01:35:59.325" v="923" actId="1038"/>
          <ac:spMkLst>
            <pc:docMk/>
            <pc:sldMk cId="3894103260" sldId="261"/>
            <ac:spMk id="13" creationId="{06EDB3DB-11B7-4BF7-9207-CE06B65DA4AC}"/>
          </ac:spMkLst>
        </pc:spChg>
        <pc:spChg chg="add mod">
          <ac:chgData name="Sameer" userId="bd06337d-ce8c-4c34-b1d1-7fbf8f91b6eb" providerId="ADAL" clId="{449E2AB2-FE71-461C-94D3-9E867087BE31}" dt="2021-03-22T01:12:52.853" v="707" actId="1036"/>
          <ac:spMkLst>
            <pc:docMk/>
            <pc:sldMk cId="3894103260" sldId="261"/>
            <ac:spMk id="14" creationId="{97F0DAA3-B7BA-4A6F-AD4F-6242C6F5A64E}"/>
          </ac:spMkLst>
        </pc:spChg>
        <pc:spChg chg="add mod">
          <ac:chgData name="Sameer" userId="bd06337d-ce8c-4c34-b1d1-7fbf8f91b6eb" providerId="ADAL" clId="{449E2AB2-FE71-461C-94D3-9E867087BE31}" dt="2021-03-22T01:13:25.796" v="782" actId="1036"/>
          <ac:spMkLst>
            <pc:docMk/>
            <pc:sldMk cId="3894103260" sldId="261"/>
            <ac:spMk id="15" creationId="{8C5BCF82-98BD-4AE7-B566-5E13F6C903C3}"/>
          </ac:spMkLst>
        </pc:spChg>
        <pc:spChg chg="add mod">
          <ac:chgData name="Sameer" userId="bd06337d-ce8c-4c34-b1d1-7fbf8f91b6eb" providerId="ADAL" clId="{449E2AB2-FE71-461C-94D3-9E867087BE31}" dt="2021-03-22T01:12:52.853" v="707" actId="1036"/>
          <ac:spMkLst>
            <pc:docMk/>
            <pc:sldMk cId="3894103260" sldId="261"/>
            <ac:spMk id="16" creationId="{90125D82-0349-4F5F-B634-E6EA15E91039}"/>
          </ac:spMkLst>
        </pc:spChg>
        <pc:spChg chg="add mod">
          <ac:chgData name="Sameer" userId="bd06337d-ce8c-4c34-b1d1-7fbf8f91b6eb" providerId="ADAL" clId="{449E2AB2-FE71-461C-94D3-9E867087BE31}" dt="2021-03-22T01:13:25.796" v="782" actId="1036"/>
          <ac:spMkLst>
            <pc:docMk/>
            <pc:sldMk cId="3894103260" sldId="261"/>
            <ac:spMk id="17" creationId="{824517C7-5926-46FA-B58D-313660F00FE7}"/>
          </ac:spMkLst>
        </pc:spChg>
        <pc:spChg chg="add mod">
          <ac:chgData name="Sameer" userId="bd06337d-ce8c-4c34-b1d1-7fbf8f91b6eb" providerId="ADAL" clId="{449E2AB2-FE71-461C-94D3-9E867087BE31}" dt="2021-03-22T01:13:03.285" v="734" actId="1035"/>
          <ac:spMkLst>
            <pc:docMk/>
            <pc:sldMk cId="3894103260" sldId="261"/>
            <ac:spMk id="18" creationId="{9F1DF5AA-1841-427B-899E-BFD1CA7693DE}"/>
          </ac:spMkLst>
        </pc:spChg>
        <pc:graphicFrameChg chg="add mod">
          <ac:chgData name="Sameer" userId="bd06337d-ce8c-4c34-b1d1-7fbf8f91b6eb" providerId="ADAL" clId="{449E2AB2-FE71-461C-94D3-9E867087BE31}" dt="2021-03-22T01:13:25.796" v="782" actId="1036"/>
          <ac:graphicFrameMkLst>
            <pc:docMk/>
            <pc:sldMk cId="3894103260" sldId="261"/>
            <ac:graphicFrameMk id="4" creationId="{83F68524-785E-4614-8FB3-E608D0FDB6CC}"/>
          </ac:graphicFrameMkLst>
        </pc:graphicFrameChg>
        <pc:graphicFrameChg chg="add mod">
          <ac:chgData name="Sameer" userId="bd06337d-ce8c-4c34-b1d1-7fbf8f91b6eb" providerId="ADAL" clId="{449E2AB2-FE71-461C-94D3-9E867087BE31}" dt="2021-03-22T01:12:52.853" v="707" actId="1036"/>
          <ac:graphicFrameMkLst>
            <pc:docMk/>
            <pc:sldMk cId="3894103260" sldId="261"/>
            <ac:graphicFrameMk id="5" creationId="{F88B36AA-8262-4DAB-A280-CD4CF3198FBC}"/>
          </ac:graphicFrameMkLst>
        </pc:graphicFrameChg>
        <pc:graphicFrameChg chg="add del mod">
          <ac:chgData name="Sameer" userId="bd06337d-ce8c-4c34-b1d1-7fbf8f91b6eb" providerId="ADAL" clId="{449E2AB2-FE71-461C-94D3-9E867087BE31}" dt="2021-03-22T00:48:57.147" v="367" actId="478"/>
          <ac:graphicFrameMkLst>
            <pc:docMk/>
            <pc:sldMk cId="3894103260" sldId="261"/>
            <ac:graphicFrameMk id="6" creationId="{356FA61D-4856-46C5-8E0A-36440B5A4FF8}"/>
          </ac:graphicFrameMkLst>
        </pc:graphicFrameChg>
      </pc:sldChg>
      <pc:sldChg chg="addSp delSp modSp new mod">
        <pc:chgData name="Sameer" userId="bd06337d-ce8c-4c34-b1d1-7fbf8f91b6eb" providerId="ADAL" clId="{449E2AB2-FE71-461C-94D3-9E867087BE31}" dt="2021-03-22T01:40:00.252" v="945" actId="113"/>
        <pc:sldMkLst>
          <pc:docMk/>
          <pc:sldMk cId="477948994" sldId="262"/>
        </pc:sldMkLst>
        <pc:spChg chg="del">
          <ac:chgData name="Sameer" userId="bd06337d-ce8c-4c34-b1d1-7fbf8f91b6eb" providerId="ADAL" clId="{449E2AB2-FE71-461C-94D3-9E867087BE31}" dt="2021-03-21T23:56:57.685" v="40" actId="478"/>
          <ac:spMkLst>
            <pc:docMk/>
            <pc:sldMk cId="477948994" sldId="262"/>
            <ac:spMk id="2" creationId="{102A9B24-3D83-48F2-81C6-CA2C82304AF4}"/>
          </ac:spMkLst>
        </pc:spChg>
        <pc:spChg chg="del">
          <ac:chgData name="Sameer" userId="bd06337d-ce8c-4c34-b1d1-7fbf8f91b6eb" providerId="ADAL" clId="{449E2AB2-FE71-461C-94D3-9E867087BE31}" dt="2021-03-21T23:56:57.685" v="40" actId="478"/>
          <ac:spMkLst>
            <pc:docMk/>
            <pc:sldMk cId="477948994" sldId="262"/>
            <ac:spMk id="3" creationId="{B280C44A-91CF-409B-AB4D-6474B679E7DA}"/>
          </ac:spMkLst>
        </pc:spChg>
        <pc:spChg chg="add del mod">
          <ac:chgData name="Sameer" userId="bd06337d-ce8c-4c34-b1d1-7fbf8f91b6eb" providerId="ADAL" clId="{449E2AB2-FE71-461C-94D3-9E867087BE31}" dt="2021-03-22T00:15:01.338" v="279" actId="478"/>
          <ac:spMkLst>
            <pc:docMk/>
            <pc:sldMk cId="477948994" sldId="262"/>
            <ac:spMk id="6" creationId="{8D85E468-54F3-491B-8E60-D5FE7AA43999}"/>
          </ac:spMkLst>
        </pc:spChg>
        <pc:spChg chg="add del mod">
          <ac:chgData name="Sameer" userId="bd06337d-ce8c-4c34-b1d1-7fbf8f91b6eb" providerId="ADAL" clId="{449E2AB2-FE71-461C-94D3-9E867087BE31}" dt="2021-03-22T00:12:03.710" v="191" actId="478"/>
          <ac:spMkLst>
            <pc:docMk/>
            <pc:sldMk cId="477948994" sldId="262"/>
            <ac:spMk id="7" creationId="{EE2E99E7-6EDB-46C1-A1DD-8EA5243F3546}"/>
          </ac:spMkLst>
        </pc:spChg>
        <pc:spChg chg="add del mod">
          <ac:chgData name="Sameer" userId="bd06337d-ce8c-4c34-b1d1-7fbf8f91b6eb" providerId="ADAL" clId="{449E2AB2-FE71-461C-94D3-9E867087BE31}" dt="2021-03-22T00:14:58.970" v="278" actId="478"/>
          <ac:spMkLst>
            <pc:docMk/>
            <pc:sldMk cId="477948994" sldId="262"/>
            <ac:spMk id="12" creationId="{DACDB234-73BB-4A14-8D91-7C16ED8C2399}"/>
          </ac:spMkLst>
        </pc:spChg>
        <pc:spChg chg="add del mod">
          <ac:chgData name="Sameer" userId="bd06337d-ce8c-4c34-b1d1-7fbf8f91b6eb" providerId="ADAL" clId="{449E2AB2-FE71-461C-94D3-9E867087BE31}" dt="2021-03-22T00:14:58.970" v="278" actId="478"/>
          <ac:spMkLst>
            <pc:docMk/>
            <pc:sldMk cId="477948994" sldId="262"/>
            <ac:spMk id="13" creationId="{04602590-CD4A-44E6-A713-06AC14139FAE}"/>
          </ac:spMkLst>
        </pc:spChg>
        <pc:spChg chg="add del mod">
          <ac:chgData name="Sameer" userId="bd06337d-ce8c-4c34-b1d1-7fbf8f91b6eb" providerId="ADAL" clId="{449E2AB2-FE71-461C-94D3-9E867087BE31}" dt="2021-03-22T00:14:58.970" v="278" actId="478"/>
          <ac:spMkLst>
            <pc:docMk/>
            <pc:sldMk cId="477948994" sldId="262"/>
            <ac:spMk id="14" creationId="{A7252F7C-4616-4C2B-AC11-B50F40705622}"/>
          </ac:spMkLst>
        </pc:spChg>
        <pc:spChg chg="add del mod">
          <ac:chgData name="Sameer" userId="bd06337d-ce8c-4c34-b1d1-7fbf8f91b6eb" providerId="ADAL" clId="{449E2AB2-FE71-461C-94D3-9E867087BE31}" dt="2021-03-22T00:14:58.970" v="278" actId="478"/>
          <ac:spMkLst>
            <pc:docMk/>
            <pc:sldMk cId="477948994" sldId="262"/>
            <ac:spMk id="15" creationId="{E097CF32-F0CC-460E-A5E6-AB43F00EC8F9}"/>
          </ac:spMkLst>
        </pc:spChg>
        <pc:spChg chg="add del mod">
          <ac:chgData name="Sameer" userId="bd06337d-ce8c-4c34-b1d1-7fbf8f91b6eb" providerId="ADAL" clId="{449E2AB2-FE71-461C-94D3-9E867087BE31}" dt="2021-03-22T00:14:58.970" v="278" actId="478"/>
          <ac:spMkLst>
            <pc:docMk/>
            <pc:sldMk cId="477948994" sldId="262"/>
            <ac:spMk id="16" creationId="{CB54D1DC-32C1-4B58-8D1A-042FC392CE55}"/>
          </ac:spMkLst>
        </pc:spChg>
        <pc:spChg chg="add del mod">
          <ac:chgData name="Sameer" userId="bd06337d-ce8c-4c34-b1d1-7fbf8f91b6eb" providerId="ADAL" clId="{449E2AB2-FE71-461C-94D3-9E867087BE31}" dt="2021-03-22T00:15:01.338" v="279" actId="478"/>
          <ac:spMkLst>
            <pc:docMk/>
            <pc:sldMk cId="477948994" sldId="262"/>
            <ac:spMk id="18" creationId="{7553C435-0FA8-4146-A092-252953E9F7EE}"/>
          </ac:spMkLst>
        </pc:spChg>
        <pc:spChg chg="add del mod">
          <ac:chgData name="Sameer" userId="bd06337d-ce8c-4c34-b1d1-7fbf8f91b6eb" providerId="ADAL" clId="{449E2AB2-FE71-461C-94D3-9E867087BE31}" dt="2021-03-22T00:14:58.970" v="278" actId="478"/>
          <ac:spMkLst>
            <pc:docMk/>
            <pc:sldMk cId="477948994" sldId="262"/>
            <ac:spMk id="19" creationId="{60BB17F8-0B2B-4C9C-BED3-353866EB31E8}"/>
          </ac:spMkLst>
        </pc:spChg>
        <pc:spChg chg="add del mod">
          <ac:chgData name="Sameer" userId="bd06337d-ce8c-4c34-b1d1-7fbf8f91b6eb" providerId="ADAL" clId="{449E2AB2-FE71-461C-94D3-9E867087BE31}" dt="2021-03-22T00:14:58.970" v="278" actId="478"/>
          <ac:spMkLst>
            <pc:docMk/>
            <pc:sldMk cId="477948994" sldId="262"/>
            <ac:spMk id="20" creationId="{041D59E6-6BA5-4EB6-A68C-F9AAF1B7320C}"/>
          </ac:spMkLst>
        </pc:spChg>
        <pc:spChg chg="add del mod">
          <ac:chgData name="Sameer" userId="bd06337d-ce8c-4c34-b1d1-7fbf8f91b6eb" providerId="ADAL" clId="{449E2AB2-FE71-461C-94D3-9E867087BE31}" dt="2021-03-22T00:15:01.338" v="279" actId="478"/>
          <ac:spMkLst>
            <pc:docMk/>
            <pc:sldMk cId="477948994" sldId="262"/>
            <ac:spMk id="21" creationId="{DAF1EC30-8EF9-4371-820B-1E7EAD5B86F6}"/>
          </ac:spMkLst>
        </pc:spChg>
        <pc:spChg chg="add del mod">
          <ac:chgData name="Sameer" userId="bd06337d-ce8c-4c34-b1d1-7fbf8f91b6eb" providerId="ADAL" clId="{449E2AB2-FE71-461C-94D3-9E867087BE31}" dt="2021-03-22T00:15:01.338" v="279" actId="478"/>
          <ac:spMkLst>
            <pc:docMk/>
            <pc:sldMk cId="477948994" sldId="262"/>
            <ac:spMk id="22" creationId="{A3A20B0B-025B-438D-9D14-00915AD03FD3}"/>
          </ac:spMkLst>
        </pc:spChg>
        <pc:spChg chg="add del mod">
          <ac:chgData name="Sameer" userId="bd06337d-ce8c-4c34-b1d1-7fbf8f91b6eb" providerId="ADAL" clId="{449E2AB2-FE71-461C-94D3-9E867087BE31}" dt="2021-03-22T00:14:58.970" v="278" actId="478"/>
          <ac:spMkLst>
            <pc:docMk/>
            <pc:sldMk cId="477948994" sldId="262"/>
            <ac:spMk id="23" creationId="{82B0BBFE-C007-4DDC-95B2-90EFEB0BFC8D}"/>
          </ac:spMkLst>
        </pc:spChg>
        <pc:spChg chg="add del mod">
          <ac:chgData name="Sameer" userId="bd06337d-ce8c-4c34-b1d1-7fbf8f91b6eb" providerId="ADAL" clId="{449E2AB2-FE71-461C-94D3-9E867087BE31}" dt="2021-03-22T00:15:07.970" v="280" actId="478"/>
          <ac:spMkLst>
            <pc:docMk/>
            <pc:sldMk cId="477948994" sldId="262"/>
            <ac:spMk id="24" creationId="{148729A0-2CC7-4916-A012-262876C036FD}"/>
          </ac:spMkLst>
        </pc:spChg>
        <pc:spChg chg="add del mod">
          <ac:chgData name="Sameer" userId="bd06337d-ce8c-4c34-b1d1-7fbf8f91b6eb" providerId="ADAL" clId="{449E2AB2-FE71-461C-94D3-9E867087BE31}" dt="2021-03-22T00:15:07.970" v="280" actId="478"/>
          <ac:spMkLst>
            <pc:docMk/>
            <pc:sldMk cId="477948994" sldId="262"/>
            <ac:spMk id="25" creationId="{5835FBEA-91E4-46CE-88B9-CABBA74A8256}"/>
          </ac:spMkLst>
        </pc:spChg>
        <pc:spChg chg="add del mod">
          <ac:chgData name="Sameer" userId="bd06337d-ce8c-4c34-b1d1-7fbf8f91b6eb" providerId="ADAL" clId="{449E2AB2-FE71-461C-94D3-9E867087BE31}" dt="2021-03-22T00:15:07.970" v="280" actId="478"/>
          <ac:spMkLst>
            <pc:docMk/>
            <pc:sldMk cId="477948994" sldId="262"/>
            <ac:spMk id="26" creationId="{EAC10118-35C0-4A0B-9102-46C0960F886B}"/>
          </ac:spMkLst>
        </pc:spChg>
        <pc:spChg chg="add del mod">
          <ac:chgData name="Sameer" userId="bd06337d-ce8c-4c34-b1d1-7fbf8f91b6eb" providerId="ADAL" clId="{449E2AB2-FE71-461C-94D3-9E867087BE31}" dt="2021-03-22T00:15:07.970" v="280" actId="478"/>
          <ac:spMkLst>
            <pc:docMk/>
            <pc:sldMk cId="477948994" sldId="262"/>
            <ac:spMk id="27" creationId="{A1C44962-6ADD-482E-AAE4-A23E75A6EE04}"/>
          </ac:spMkLst>
        </pc:spChg>
        <pc:spChg chg="add del mod">
          <ac:chgData name="Sameer" userId="bd06337d-ce8c-4c34-b1d1-7fbf8f91b6eb" providerId="ADAL" clId="{449E2AB2-FE71-461C-94D3-9E867087BE31}" dt="2021-03-22T00:15:07.970" v="280" actId="478"/>
          <ac:spMkLst>
            <pc:docMk/>
            <pc:sldMk cId="477948994" sldId="262"/>
            <ac:spMk id="28" creationId="{A511B8D9-FDD3-4E84-B3BF-89A31C9C78A5}"/>
          </ac:spMkLst>
        </pc:spChg>
        <pc:spChg chg="add mod">
          <ac:chgData name="Sameer" userId="bd06337d-ce8c-4c34-b1d1-7fbf8f91b6eb" providerId="ADAL" clId="{449E2AB2-FE71-461C-94D3-9E867087BE31}" dt="2021-03-22T01:40:00.252" v="945" actId="113"/>
          <ac:spMkLst>
            <pc:docMk/>
            <pc:sldMk cId="477948994" sldId="262"/>
            <ac:spMk id="34" creationId="{ABDAA586-0445-4E95-BEB2-6FB7147CA9D9}"/>
          </ac:spMkLst>
        </pc:spChg>
        <pc:graphicFrameChg chg="add del mod">
          <ac:chgData name="Sameer" userId="bd06337d-ce8c-4c34-b1d1-7fbf8f91b6eb" providerId="ADAL" clId="{449E2AB2-FE71-461C-94D3-9E867087BE31}" dt="2021-03-22T00:07:12.494" v="121"/>
          <ac:graphicFrameMkLst>
            <pc:docMk/>
            <pc:sldMk cId="477948994" sldId="262"/>
            <ac:graphicFrameMk id="17" creationId="{899DD0EA-4086-4E09-A6F5-1D5D9E8C54A7}"/>
          </ac:graphicFrameMkLst>
        </pc:graphicFrameChg>
        <pc:picChg chg="add del mod modCrop">
          <ac:chgData name="Sameer" userId="bd06337d-ce8c-4c34-b1d1-7fbf8f91b6eb" providerId="ADAL" clId="{449E2AB2-FE71-461C-94D3-9E867087BE31}" dt="2021-03-22T00:00:17.231" v="53" actId="478"/>
          <ac:picMkLst>
            <pc:docMk/>
            <pc:sldMk cId="477948994" sldId="262"/>
            <ac:picMk id="5" creationId="{46631FC0-814E-4E58-80AF-F05967E91CB3}"/>
          </ac:picMkLst>
        </pc:picChg>
        <pc:picChg chg="add del mod modCrop">
          <ac:chgData name="Sameer" userId="bd06337d-ce8c-4c34-b1d1-7fbf8f91b6eb" providerId="ADAL" clId="{449E2AB2-FE71-461C-94D3-9E867087BE31}" dt="2021-03-22T00:03:12.360" v="58" actId="478"/>
          <ac:picMkLst>
            <pc:docMk/>
            <pc:sldMk cId="477948994" sldId="262"/>
            <ac:picMk id="9" creationId="{2B39C153-9BC3-4A61-A616-F8F85D2F3466}"/>
          </ac:picMkLst>
        </pc:picChg>
        <pc:picChg chg="add del mod modCrop">
          <ac:chgData name="Sameer" userId="bd06337d-ce8c-4c34-b1d1-7fbf8f91b6eb" providerId="ADAL" clId="{449E2AB2-FE71-461C-94D3-9E867087BE31}" dt="2021-03-22T00:12:58.761" v="194" actId="478"/>
          <ac:picMkLst>
            <pc:docMk/>
            <pc:sldMk cId="477948994" sldId="262"/>
            <ac:picMk id="11" creationId="{23489228-BF93-4424-89E9-32CAA8D349B0}"/>
          </ac:picMkLst>
        </pc:picChg>
        <pc:picChg chg="add del">
          <ac:chgData name="Sameer" userId="bd06337d-ce8c-4c34-b1d1-7fbf8f91b6eb" providerId="ADAL" clId="{449E2AB2-FE71-461C-94D3-9E867087BE31}" dt="2021-03-22T00:12:31.075" v="193" actId="478"/>
          <ac:picMkLst>
            <pc:docMk/>
            <pc:sldMk cId="477948994" sldId="262"/>
            <ac:picMk id="29" creationId="{AA9460CA-F734-4026-9933-A90C9406FD34}"/>
          </ac:picMkLst>
        </pc:picChg>
        <pc:picChg chg="add mod modCrop">
          <ac:chgData name="Sameer" userId="bd06337d-ce8c-4c34-b1d1-7fbf8f91b6eb" providerId="ADAL" clId="{449E2AB2-FE71-461C-94D3-9E867087BE31}" dt="2021-03-22T01:33:15.983" v="843" actId="14100"/>
          <ac:picMkLst>
            <pc:docMk/>
            <pc:sldMk cId="477948994" sldId="262"/>
            <ac:picMk id="31" creationId="{A1A9CCFA-12A9-424F-B698-82AA8A8D5E35}"/>
          </ac:picMkLst>
        </pc:picChg>
        <pc:picChg chg="add mod">
          <ac:chgData name="Sameer" userId="bd06337d-ce8c-4c34-b1d1-7fbf8f91b6eb" providerId="ADAL" clId="{449E2AB2-FE71-461C-94D3-9E867087BE31}" dt="2021-03-22T01:33:36.265" v="872" actId="1036"/>
          <ac:picMkLst>
            <pc:docMk/>
            <pc:sldMk cId="477948994" sldId="262"/>
            <ac:picMk id="33" creationId="{71F80468-2BCF-4AB1-9EC0-99CBECA10147}"/>
          </ac:picMkLst>
        </pc:picChg>
      </pc:sldChg>
      <pc:sldChg chg="addSp delSp modSp new mod">
        <pc:chgData name="Sameer" userId="bd06337d-ce8c-4c34-b1d1-7fbf8f91b6eb" providerId="ADAL" clId="{449E2AB2-FE71-461C-94D3-9E867087BE31}" dt="2021-03-22T04:33:52.736" v="1217" actId="20577"/>
        <pc:sldMkLst>
          <pc:docMk/>
          <pc:sldMk cId="1609758187" sldId="263"/>
        </pc:sldMkLst>
        <pc:spChg chg="del">
          <ac:chgData name="Sameer" userId="bd06337d-ce8c-4c34-b1d1-7fbf8f91b6eb" providerId="ADAL" clId="{449E2AB2-FE71-461C-94D3-9E867087BE31}" dt="2021-03-22T04:33:21.216" v="1150" actId="478"/>
          <ac:spMkLst>
            <pc:docMk/>
            <pc:sldMk cId="1609758187" sldId="263"/>
            <ac:spMk id="2" creationId="{9721BC79-4B43-4C6D-A131-726FA42FB138}"/>
          </ac:spMkLst>
        </pc:spChg>
        <pc:spChg chg="del">
          <ac:chgData name="Sameer" userId="bd06337d-ce8c-4c34-b1d1-7fbf8f91b6eb" providerId="ADAL" clId="{449E2AB2-FE71-461C-94D3-9E867087BE31}" dt="2021-03-22T04:33:21.216" v="1150" actId="478"/>
          <ac:spMkLst>
            <pc:docMk/>
            <pc:sldMk cId="1609758187" sldId="263"/>
            <ac:spMk id="3" creationId="{1DB6F2D5-8BD3-4511-A36F-293706979FBA}"/>
          </ac:spMkLst>
        </pc:spChg>
        <pc:spChg chg="add mod">
          <ac:chgData name="Sameer" userId="bd06337d-ce8c-4c34-b1d1-7fbf8f91b6eb" providerId="ADAL" clId="{449E2AB2-FE71-461C-94D3-9E867087BE31}" dt="2021-03-22T04:33:52.736" v="1217" actId="20577"/>
          <ac:spMkLst>
            <pc:docMk/>
            <pc:sldMk cId="1609758187" sldId="263"/>
            <ac:spMk id="4" creationId="{522CAF92-07D5-4CA8-8BCB-5C73D1A04CF6}"/>
          </ac:spMkLst>
        </pc:spChg>
      </pc:sldChg>
      <pc:sldChg chg="addSp delSp modSp new mod">
        <pc:chgData name="Sameer" userId="bd06337d-ce8c-4c34-b1d1-7fbf8f91b6eb" providerId="ADAL" clId="{449E2AB2-FE71-461C-94D3-9E867087BE31}" dt="2021-03-22T04:54:03.553" v="1286" actId="1076"/>
        <pc:sldMkLst>
          <pc:docMk/>
          <pc:sldMk cId="2515884158" sldId="264"/>
        </pc:sldMkLst>
        <pc:spChg chg="del">
          <ac:chgData name="Sameer" userId="bd06337d-ce8c-4c34-b1d1-7fbf8f91b6eb" providerId="ADAL" clId="{449E2AB2-FE71-461C-94D3-9E867087BE31}" dt="2021-03-22T04:33:58.601" v="1219" actId="478"/>
          <ac:spMkLst>
            <pc:docMk/>
            <pc:sldMk cId="2515884158" sldId="264"/>
            <ac:spMk id="2" creationId="{1EACC53D-D785-412E-B1DD-E2B81EB86815}"/>
          </ac:spMkLst>
        </pc:spChg>
        <pc:spChg chg="del">
          <ac:chgData name="Sameer" userId="bd06337d-ce8c-4c34-b1d1-7fbf8f91b6eb" providerId="ADAL" clId="{449E2AB2-FE71-461C-94D3-9E867087BE31}" dt="2021-03-22T04:33:58.601" v="1219" actId="478"/>
          <ac:spMkLst>
            <pc:docMk/>
            <pc:sldMk cId="2515884158" sldId="264"/>
            <ac:spMk id="3" creationId="{425AC0D5-C98C-4E4A-835B-2A2E53457E4F}"/>
          </ac:spMkLst>
        </pc:spChg>
        <pc:spChg chg="add mod">
          <ac:chgData name="Sameer" userId="bd06337d-ce8c-4c34-b1d1-7fbf8f91b6eb" providerId="ADAL" clId="{449E2AB2-FE71-461C-94D3-9E867087BE31}" dt="2021-03-22T04:54:03.553" v="1286" actId="1076"/>
          <ac:spMkLst>
            <pc:docMk/>
            <pc:sldMk cId="2515884158" sldId="264"/>
            <ac:spMk id="4" creationId="{13C379B6-F83E-4BDB-822B-B675E25271B2}"/>
          </ac:spMkLst>
        </pc:spChg>
      </pc:sldChg>
    </pc:docChg>
  </pc:docChgLst>
  <pc:docChgLst>
    <pc:chgData name="Garry M Rosewarne (DJPR)" userId="51564b9f-0e86-4dd8-9e91-f771a6d10681" providerId="ADAL" clId="{DEB5863A-1BDC-425C-B1E6-428EDC671F6F}"/>
    <pc:docChg chg="modSld">
      <pc:chgData name="Garry M Rosewarne (DJPR)" userId="51564b9f-0e86-4dd8-9e91-f771a6d10681" providerId="ADAL" clId="{DEB5863A-1BDC-425C-B1E6-428EDC671F6F}" dt="2021-06-22T23:00:11.220" v="6" actId="2085"/>
      <pc:docMkLst>
        <pc:docMk/>
      </pc:docMkLst>
      <pc:sldChg chg="modSp mod">
        <pc:chgData name="Garry M Rosewarne (DJPR)" userId="51564b9f-0e86-4dd8-9e91-f771a6d10681" providerId="ADAL" clId="{DEB5863A-1BDC-425C-B1E6-428EDC671F6F}" dt="2021-06-22T22:56:38.482" v="0" actId="2085"/>
        <pc:sldMkLst>
          <pc:docMk/>
          <pc:sldMk cId="2000004557" sldId="260"/>
        </pc:sldMkLst>
        <pc:spChg chg="mod">
          <ac:chgData name="Garry M Rosewarne (DJPR)" userId="51564b9f-0e86-4dd8-9e91-f771a6d10681" providerId="ADAL" clId="{DEB5863A-1BDC-425C-B1E6-428EDC671F6F}" dt="2021-06-22T22:56:38.482" v="0" actId="2085"/>
          <ac:spMkLst>
            <pc:docMk/>
            <pc:sldMk cId="2000004557" sldId="260"/>
            <ac:spMk id="10" creationId="{59C0504E-C7AF-4D43-8383-ED0A5BC07BE9}"/>
          </ac:spMkLst>
        </pc:spChg>
      </pc:sldChg>
      <pc:sldChg chg="modSp">
        <pc:chgData name="Garry M Rosewarne (DJPR)" userId="51564b9f-0e86-4dd8-9e91-f771a6d10681" providerId="ADAL" clId="{DEB5863A-1BDC-425C-B1E6-428EDC671F6F}" dt="2021-06-22T22:57:05.656" v="1" actId="2085"/>
        <pc:sldMkLst>
          <pc:docMk/>
          <pc:sldMk cId="3894103260" sldId="261"/>
        </pc:sldMkLst>
        <pc:graphicFrameChg chg="mod">
          <ac:chgData name="Garry M Rosewarne (DJPR)" userId="51564b9f-0e86-4dd8-9e91-f771a6d10681" providerId="ADAL" clId="{DEB5863A-1BDC-425C-B1E6-428EDC671F6F}" dt="2021-06-22T22:57:05.656" v="1" actId="2085"/>
          <ac:graphicFrameMkLst>
            <pc:docMk/>
            <pc:sldMk cId="3894103260" sldId="261"/>
            <ac:graphicFrameMk id="4" creationId="{83F68524-785E-4614-8FB3-E608D0FDB6CC}"/>
          </ac:graphicFrameMkLst>
        </pc:graphicFrameChg>
      </pc:sldChg>
      <pc:sldChg chg="modSp mod">
        <pc:chgData name="Garry M Rosewarne (DJPR)" userId="51564b9f-0e86-4dd8-9e91-f771a6d10681" providerId="ADAL" clId="{DEB5863A-1BDC-425C-B1E6-428EDC671F6F}" dt="2021-06-22T22:57:33.040" v="2" actId="2085"/>
        <pc:sldMkLst>
          <pc:docMk/>
          <pc:sldMk cId="583791291" sldId="265"/>
        </pc:sldMkLst>
        <pc:spChg chg="mod">
          <ac:chgData name="Garry M Rosewarne (DJPR)" userId="51564b9f-0e86-4dd8-9e91-f771a6d10681" providerId="ADAL" clId="{DEB5863A-1BDC-425C-B1E6-428EDC671F6F}" dt="2021-06-22T22:57:33.040" v="2" actId="2085"/>
          <ac:spMkLst>
            <pc:docMk/>
            <pc:sldMk cId="583791291" sldId="265"/>
            <ac:spMk id="14" creationId="{49211749-BCC9-422A-AA45-479681C574AF}"/>
          </ac:spMkLst>
        </pc:spChg>
      </pc:sldChg>
      <pc:sldChg chg="modSp">
        <pc:chgData name="Garry M Rosewarne (DJPR)" userId="51564b9f-0e86-4dd8-9e91-f771a6d10681" providerId="ADAL" clId="{DEB5863A-1BDC-425C-B1E6-428EDC671F6F}" dt="2021-06-22T22:58:18.013" v="3" actId="2085"/>
        <pc:sldMkLst>
          <pc:docMk/>
          <pc:sldMk cId="3253327431" sldId="266"/>
        </pc:sldMkLst>
        <pc:graphicFrameChg chg="mod">
          <ac:chgData name="Garry M Rosewarne (DJPR)" userId="51564b9f-0e86-4dd8-9e91-f771a6d10681" providerId="ADAL" clId="{DEB5863A-1BDC-425C-B1E6-428EDC671F6F}" dt="2021-06-22T22:58:18.013" v="3" actId="2085"/>
          <ac:graphicFrameMkLst>
            <pc:docMk/>
            <pc:sldMk cId="3253327431" sldId="266"/>
            <ac:graphicFrameMk id="4" creationId="{B4F142F7-E095-410F-AAEA-E0E9C20CB6F5}"/>
          </ac:graphicFrameMkLst>
        </pc:graphicFrameChg>
      </pc:sldChg>
      <pc:sldChg chg="modSp">
        <pc:chgData name="Garry M Rosewarne (DJPR)" userId="51564b9f-0e86-4dd8-9e91-f771a6d10681" providerId="ADAL" clId="{DEB5863A-1BDC-425C-B1E6-428EDC671F6F}" dt="2021-06-22T22:58:53.729" v="4" actId="2085"/>
        <pc:sldMkLst>
          <pc:docMk/>
          <pc:sldMk cId="1068351154" sldId="267"/>
        </pc:sldMkLst>
        <pc:graphicFrameChg chg="mod">
          <ac:chgData name="Garry M Rosewarne (DJPR)" userId="51564b9f-0e86-4dd8-9e91-f771a6d10681" providerId="ADAL" clId="{DEB5863A-1BDC-425C-B1E6-428EDC671F6F}" dt="2021-06-22T22:58:53.729" v="4" actId="2085"/>
          <ac:graphicFrameMkLst>
            <pc:docMk/>
            <pc:sldMk cId="1068351154" sldId="267"/>
            <ac:graphicFrameMk id="4" creationId="{0C239B8B-09DC-47A1-8EFD-3AF724F16352}"/>
          </ac:graphicFrameMkLst>
        </pc:graphicFrameChg>
      </pc:sldChg>
      <pc:sldChg chg="modSp mod">
        <pc:chgData name="Garry M Rosewarne (DJPR)" userId="51564b9f-0e86-4dd8-9e91-f771a6d10681" providerId="ADAL" clId="{DEB5863A-1BDC-425C-B1E6-428EDC671F6F}" dt="2021-06-22T22:59:25.912" v="5" actId="2085"/>
        <pc:sldMkLst>
          <pc:docMk/>
          <pc:sldMk cId="2979161283" sldId="268"/>
        </pc:sldMkLst>
        <pc:spChg chg="mod">
          <ac:chgData name="Garry M Rosewarne (DJPR)" userId="51564b9f-0e86-4dd8-9e91-f771a6d10681" providerId="ADAL" clId="{DEB5863A-1BDC-425C-B1E6-428EDC671F6F}" dt="2021-06-22T22:59:25.912" v="5" actId="2085"/>
          <ac:spMkLst>
            <pc:docMk/>
            <pc:sldMk cId="2979161283" sldId="268"/>
            <ac:spMk id="7" creationId="{160F0EE4-00BD-4C36-B867-7272062E708A}"/>
          </ac:spMkLst>
        </pc:spChg>
      </pc:sldChg>
      <pc:sldChg chg="modSp mod">
        <pc:chgData name="Garry M Rosewarne (DJPR)" userId="51564b9f-0e86-4dd8-9e91-f771a6d10681" providerId="ADAL" clId="{DEB5863A-1BDC-425C-B1E6-428EDC671F6F}" dt="2021-06-22T23:00:11.220" v="6" actId="2085"/>
        <pc:sldMkLst>
          <pc:docMk/>
          <pc:sldMk cId="446862676" sldId="269"/>
        </pc:sldMkLst>
        <pc:spChg chg="mod">
          <ac:chgData name="Garry M Rosewarne (DJPR)" userId="51564b9f-0e86-4dd8-9e91-f771a6d10681" providerId="ADAL" clId="{DEB5863A-1BDC-425C-B1E6-428EDC671F6F}" dt="2021-06-22T23:00:11.220" v="6" actId="2085"/>
          <ac:spMkLst>
            <pc:docMk/>
            <pc:sldMk cId="446862676" sldId="269"/>
            <ac:spMk id="5" creationId="{251A451C-65F8-4F03-8117-EF5D0DAAADEE}"/>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F78B28F-7304-4A85-BAEA-0EC4E117ACDA}" type="datetimeFigureOut">
              <a:rPr lang="en-AU" smtClean="0"/>
              <a:t>18/08/2022</a:t>
            </a:fld>
            <a:endParaRPr lang="en-AU"/>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5D59735-A97C-4F46-AB21-BC617F29AEAD}" type="slidenum">
              <a:rPr lang="en-AU" smtClean="0"/>
              <a:t>‹#›</a:t>
            </a:fld>
            <a:endParaRPr lang="en-AU"/>
          </a:p>
        </p:txBody>
      </p:sp>
    </p:spTree>
    <p:extLst>
      <p:ext uri="{BB962C8B-B14F-4D97-AF65-F5344CB8AC3E}">
        <p14:creationId xmlns:p14="http://schemas.microsoft.com/office/powerpoint/2010/main" val="11972113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85763" y="1496484"/>
            <a:ext cx="4371975" cy="3183467"/>
          </a:xfrm>
        </p:spPr>
        <p:txBody>
          <a:bodyPr anchor="b"/>
          <a:lstStyle>
            <a:lvl1pPr algn="ctr">
              <a:defRPr sz="3375"/>
            </a:lvl1pPr>
          </a:lstStyle>
          <a:p>
            <a:r>
              <a:rPr lang="en-US"/>
              <a:t>Click to edit Master title style</a:t>
            </a:r>
            <a:endParaRPr lang="en-US" dirty="0"/>
          </a:p>
        </p:txBody>
      </p:sp>
      <p:sp>
        <p:nvSpPr>
          <p:cNvPr id="3" name="Subtitle 2"/>
          <p:cNvSpPr>
            <a:spLocks noGrp="1"/>
          </p:cNvSpPr>
          <p:nvPr>
            <p:ph type="subTitle" idx="1"/>
          </p:nvPr>
        </p:nvSpPr>
        <p:spPr>
          <a:xfrm>
            <a:off x="642938" y="4802717"/>
            <a:ext cx="3857625" cy="2207683"/>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115B3A3-1A83-47F8-AB04-6D622BAB9632}" type="datetimeFigureOut">
              <a:rPr lang="en-AU" smtClean="0"/>
              <a:t>18/08/2022</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38082022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15B3A3-1A83-47F8-AB04-6D622BAB9632}" type="datetimeFigureOut">
              <a:rPr lang="en-AU" smtClean="0"/>
              <a:t>18/08/2022</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12961870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680818" y="486834"/>
            <a:ext cx="1109067"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53616" y="486834"/>
            <a:ext cx="3262908"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15B3A3-1A83-47F8-AB04-6D622BAB9632}" type="datetimeFigureOut">
              <a:rPr lang="en-AU" smtClean="0"/>
              <a:t>18/08/2022</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37045746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15B3A3-1A83-47F8-AB04-6D622BAB9632}" type="datetimeFigureOut">
              <a:rPr lang="en-AU" smtClean="0"/>
              <a:t>18/08/2022</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36780579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50937" y="2279653"/>
            <a:ext cx="4436269" cy="3803649"/>
          </a:xfrm>
        </p:spPr>
        <p:txBody>
          <a:bodyPr anchor="b"/>
          <a:lstStyle>
            <a:lvl1pPr>
              <a:defRPr sz="3375"/>
            </a:lvl1pPr>
          </a:lstStyle>
          <a:p>
            <a:r>
              <a:rPr lang="en-US"/>
              <a:t>Click to edit Master title style</a:t>
            </a:r>
            <a:endParaRPr lang="en-US" dirty="0"/>
          </a:p>
        </p:txBody>
      </p:sp>
      <p:sp>
        <p:nvSpPr>
          <p:cNvPr id="3" name="Text Placeholder 2"/>
          <p:cNvSpPr>
            <a:spLocks noGrp="1"/>
          </p:cNvSpPr>
          <p:nvPr>
            <p:ph type="body" idx="1"/>
          </p:nvPr>
        </p:nvSpPr>
        <p:spPr>
          <a:xfrm>
            <a:off x="350937" y="6119286"/>
            <a:ext cx="4436269" cy="2000249"/>
          </a:xfrm>
        </p:spPr>
        <p:txBody>
          <a:bodyPr/>
          <a:lstStyle>
            <a:lvl1pPr marL="0" indent="0">
              <a:buNone/>
              <a:defRPr sz="1350">
                <a:solidFill>
                  <a:schemeClr val="tx1"/>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115B3A3-1A83-47F8-AB04-6D622BAB9632}" type="datetimeFigureOut">
              <a:rPr lang="en-AU" smtClean="0"/>
              <a:t>18/08/2022</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34250106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53615" y="2434167"/>
            <a:ext cx="2185988"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603897" y="2434167"/>
            <a:ext cx="2185988"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115B3A3-1A83-47F8-AB04-6D622BAB9632}" type="datetimeFigureOut">
              <a:rPr lang="en-AU" smtClean="0"/>
              <a:t>18/08/2022</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42187738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54285" y="486836"/>
            <a:ext cx="4436269"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354286" y="2241551"/>
            <a:ext cx="2175941"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p:cNvSpPr>
            <a:spLocks noGrp="1"/>
          </p:cNvSpPr>
          <p:nvPr>
            <p:ph sz="half" idx="2"/>
          </p:nvPr>
        </p:nvSpPr>
        <p:spPr>
          <a:xfrm>
            <a:off x="354286" y="3340100"/>
            <a:ext cx="2175941"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603897" y="2241551"/>
            <a:ext cx="2186657"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p:cNvSpPr>
            <a:spLocks noGrp="1"/>
          </p:cNvSpPr>
          <p:nvPr>
            <p:ph sz="quarter" idx="4"/>
          </p:nvPr>
        </p:nvSpPr>
        <p:spPr>
          <a:xfrm>
            <a:off x="2603897" y="3340100"/>
            <a:ext cx="218665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115B3A3-1A83-47F8-AB04-6D622BAB9632}" type="datetimeFigureOut">
              <a:rPr lang="en-AU" smtClean="0"/>
              <a:t>18/08/2022</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4173210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115B3A3-1A83-47F8-AB04-6D622BAB9632}" type="datetimeFigureOut">
              <a:rPr lang="en-AU" smtClean="0"/>
              <a:t>18/08/2022</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9321411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15B3A3-1A83-47F8-AB04-6D622BAB9632}" type="datetimeFigureOut">
              <a:rPr lang="en-AU" smtClean="0"/>
              <a:t>18/08/2022</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42607875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54285" y="609600"/>
            <a:ext cx="1658913" cy="2133600"/>
          </a:xfrm>
        </p:spPr>
        <p:txBody>
          <a:bodyPr anchor="b"/>
          <a:lstStyle>
            <a:lvl1pPr>
              <a:defRPr sz="1800"/>
            </a:lvl1pPr>
          </a:lstStyle>
          <a:p>
            <a:r>
              <a:rPr lang="en-US"/>
              <a:t>Click to edit Master title style</a:t>
            </a:r>
            <a:endParaRPr lang="en-US" dirty="0"/>
          </a:p>
        </p:txBody>
      </p:sp>
      <p:sp>
        <p:nvSpPr>
          <p:cNvPr id="3" name="Content Placeholder 2"/>
          <p:cNvSpPr>
            <a:spLocks noGrp="1"/>
          </p:cNvSpPr>
          <p:nvPr>
            <p:ph idx="1"/>
          </p:nvPr>
        </p:nvSpPr>
        <p:spPr>
          <a:xfrm>
            <a:off x="2186657" y="1316569"/>
            <a:ext cx="2603897" cy="6498167"/>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54285" y="2743200"/>
            <a:ext cx="1658913"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p:cNvSpPr>
            <a:spLocks noGrp="1"/>
          </p:cNvSpPr>
          <p:nvPr>
            <p:ph type="dt" sz="half" idx="10"/>
          </p:nvPr>
        </p:nvSpPr>
        <p:spPr/>
        <p:txBody>
          <a:bodyPr/>
          <a:lstStyle/>
          <a:p>
            <a:fld id="{2115B3A3-1A83-47F8-AB04-6D622BAB9632}" type="datetimeFigureOut">
              <a:rPr lang="en-AU" smtClean="0"/>
              <a:t>18/08/2022</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36842081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54285" y="609600"/>
            <a:ext cx="1658913" cy="2133600"/>
          </a:xfrm>
        </p:spPr>
        <p:txBody>
          <a:bodyPr anchor="b"/>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186657" y="1316569"/>
            <a:ext cx="2603897" cy="6498167"/>
          </a:xfrm>
        </p:spPr>
        <p:txBody>
          <a:bodyPr anchor="t"/>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r>
              <a:rPr lang="en-US" dirty="0"/>
              <a:t>Click icon to </a:t>
            </a:r>
            <a:r>
              <a:rPr lang="en-US"/>
              <a:t>add picture</a:t>
            </a:r>
            <a:endParaRPr lang="en-US" dirty="0"/>
          </a:p>
        </p:txBody>
      </p:sp>
      <p:sp>
        <p:nvSpPr>
          <p:cNvPr id="4" name="Text Placeholder 3"/>
          <p:cNvSpPr>
            <a:spLocks noGrp="1"/>
          </p:cNvSpPr>
          <p:nvPr>
            <p:ph type="body" sz="half" idx="2"/>
          </p:nvPr>
        </p:nvSpPr>
        <p:spPr>
          <a:xfrm>
            <a:off x="354285" y="2743200"/>
            <a:ext cx="1658913"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p:cNvSpPr>
            <a:spLocks noGrp="1"/>
          </p:cNvSpPr>
          <p:nvPr>
            <p:ph type="dt" sz="half" idx="10"/>
          </p:nvPr>
        </p:nvSpPr>
        <p:spPr/>
        <p:txBody>
          <a:bodyPr/>
          <a:lstStyle/>
          <a:p>
            <a:fld id="{2115B3A3-1A83-47F8-AB04-6D622BAB9632}" type="datetimeFigureOut">
              <a:rPr lang="en-AU" smtClean="0"/>
              <a:t>18/08/2022</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FED637C-C5A7-48CD-944C-E17764FF506B}" type="slidenum">
              <a:rPr lang="en-AU" smtClean="0"/>
              <a:t>‹#›</a:t>
            </a:fld>
            <a:endParaRPr lang="en-AU"/>
          </a:p>
        </p:txBody>
      </p:sp>
    </p:spTree>
    <p:extLst>
      <p:ext uri="{BB962C8B-B14F-4D97-AF65-F5344CB8AC3E}">
        <p14:creationId xmlns:p14="http://schemas.microsoft.com/office/powerpoint/2010/main" val="36224830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53616" y="486836"/>
            <a:ext cx="4436269"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53616" y="2434167"/>
            <a:ext cx="4436269"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53615" y="8475136"/>
            <a:ext cx="1157288" cy="486833"/>
          </a:xfrm>
          <a:prstGeom prst="rect">
            <a:avLst/>
          </a:prstGeom>
        </p:spPr>
        <p:txBody>
          <a:bodyPr vert="horz" lIns="91440" tIns="45720" rIns="91440" bIns="45720" rtlCol="0" anchor="ctr"/>
          <a:lstStyle>
            <a:lvl1pPr algn="l">
              <a:defRPr sz="675">
                <a:solidFill>
                  <a:schemeClr val="tx1">
                    <a:tint val="75000"/>
                  </a:schemeClr>
                </a:solidFill>
              </a:defRPr>
            </a:lvl1pPr>
          </a:lstStyle>
          <a:p>
            <a:fld id="{2115B3A3-1A83-47F8-AB04-6D622BAB9632}" type="datetimeFigureOut">
              <a:rPr lang="en-AU" smtClean="0"/>
              <a:t>18/08/2022</a:t>
            </a:fld>
            <a:endParaRPr lang="en-AU"/>
          </a:p>
        </p:txBody>
      </p:sp>
      <p:sp>
        <p:nvSpPr>
          <p:cNvPr id="5" name="Footer Placeholder 4"/>
          <p:cNvSpPr>
            <a:spLocks noGrp="1"/>
          </p:cNvSpPr>
          <p:nvPr>
            <p:ph type="ftr" sz="quarter" idx="3"/>
          </p:nvPr>
        </p:nvSpPr>
        <p:spPr>
          <a:xfrm>
            <a:off x="1703785" y="8475136"/>
            <a:ext cx="1735931" cy="48683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3632597" y="8475136"/>
            <a:ext cx="1157288" cy="486833"/>
          </a:xfrm>
          <a:prstGeom prst="rect">
            <a:avLst/>
          </a:prstGeom>
        </p:spPr>
        <p:txBody>
          <a:bodyPr vert="horz" lIns="91440" tIns="45720" rIns="91440" bIns="45720" rtlCol="0" anchor="ctr"/>
          <a:lstStyle>
            <a:lvl1pPr algn="r">
              <a:defRPr sz="675">
                <a:solidFill>
                  <a:schemeClr val="tx1">
                    <a:tint val="75000"/>
                  </a:schemeClr>
                </a:solidFill>
              </a:defRPr>
            </a:lvl1pPr>
          </a:lstStyle>
          <a:p>
            <a:fld id="{FFED637C-C5A7-48CD-944C-E17764FF506B}" type="slidenum">
              <a:rPr lang="en-AU" smtClean="0"/>
              <a:t>‹#›</a:t>
            </a:fld>
            <a:endParaRPr lang="en-AU"/>
          </a:p>
        </p:txBody>
      </p:sp>
    </p:spTree>
    <p:extLst>
      <p:ext uri="{BB962C8B-B14F-4D97-AF65-F5344CB8AC3E}">
        <p14:creationId xmlns:p14="http://schemas.microsoft.com/office/powerpoint/2010/main" val="364300894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image" Target="../media/image3.tiff"/><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3.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2.xml"/><Relationship Id="rId4" Type="http://schemas.openxmlformats.org/officeDocument/2006/relationships/image" Target="../media/image8.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indoor, wall, door, dirty&#10;&#10;Description automatically generated">
            <a:extLst>
              <a:ext uri="{FF2B5EF4-FFF2-40B4-BE49-F238E27FC236}">
                <a16:creationId xmlns:a16="http://schemas.microsoft.com/office/drawing/2014/main" id="{1EFA5835-E534-4D42-A7CB-56F3929F60DC}"/>
              </a:ext>
            </a:extLst>
          </p:cNvPr>
          <p:cNvPicPr>
            <a:picLocks noChangeAspect="1"/>
          </p:cNvPicPr>
          <p:nvPr/>
        </p:nvPicPr>
        <p:blipFill rotWithShape="1">
          <a:blip r:embed="rId2">
            <a:extLst>
              <a:ext uri="{28A0092B-C50C-407E-A947-70E740481C1C}">
                <a14:useLocalDpi xmlns:a14="http://schemas.microsoft.com/office/drawing/2010/main" val="0"/>
              </a:ext>
            </a:extLst>
          </a:blip>
          <a:srcRect r="13112"/>
          <a:stretch/>
        </p:blipFill>
        <p:spPr>
          <a:xfrm>
            <a:off x="220214" y="773541"/>
            <a:ext cx="2835175" cy="2175355"/>
          </a:xfrm>
          <a:prstGeom prst="rect">
            <a:avLst/>
          </a:prstGeom>
        </p:spPr>
      </p:pic>
      <p:pic>
        <p:nvPicPr>
          <p:cNvPr id="5" name="Picture 4" descr="A picture containing map&#10;&#10;Description automatically generated">
            <a:extLst>
              <a:ext uri="{FF2B5EF4-FFF2-40B4-BE49-F238E27FC236}">
                <a16:creationId xmlns:a16="http://schemas.microsoft.com/office/drawing/2014/main" id="{618E246C-3142-4EEA-A3C9-AAAC2D555660}"/>
              </a:ext>
            </a:extLst>
          </p:cNvPr>
          <p:cNvPicPr>
            <a:picLocks noChangeAspect="1"/>
          </p:cNvPicPr>
          <p:nvPr/>
        </p:nvPicPr>
        <p:blipFill rotWithShape="1">
          <a:blip r:embed="rId3">
            <a:extLst>
              <a:ext uri="{28A0092B-C50C-407E-A947-70E740481C1C}">
                <a14:useLocalDpi xmlns:a14="http://schemas.microsoft.com/office/drawing/2010/main" val="0"/>
              </a:ext>
            </a:extLst>
          </a:blip>
          <a:srcRect l="7244" r="13082"/>
          <a:stretch/>
        </p:blipFill>
        <p:spPr>
          <a:xfrm rot="16200000">
            <a:off x="2925504" y="951116"/>
            <a:ext cx="2175356" cy="1820210"/>
          </a:xfrm>
          <a:prstGeom prst="rect">
            <a:avLst/>
          </a:prstGeom>
        </p:spPr>
      </p:pic>
      <p:sp>
        <p:nvSpPr>
          <p:cNvPr id="6" name="Rectangle 5">
            <a:extLst>
              <a:ext uri="{FF2B5EF4-FFF2-40B4-BE49-F238E27FC236}">
                <a16:creationId xmlns:a16="http://schemas.microsoft.com/office/drawing/2014/main" id="{8DCDC6EC-6E71-4C6F-BD73-6B62F915E554}"/>
              </a:ext>
            </a:extLst>
          </p:cNvPr>
          <p:cNvSpPr/>
          <p:nvPr/>
        </p:nvSpPr>
        <p:spPr>
          <a:xfrm>
            <a:off x="140362" y="3109818"/>
            <a:ext cx="4782925" cy="1015663"/>
          </a:xfrm>
          <a:prstGeom prst="rect">
            <a:avLst/>
          </a:prstGeom>
        </p:spPr>
        <p:txBody>
          <a:bodyPr wrap="square">
            <a:spAutoFit/>
          </a:bodyPr>
          <a:lstStyle/>
          <a:p>
            <a:pPr algn="just"/>
            <a:r>
              <a:rPr lang="en-AU" sz="1200" b="1" dirty="0">
                <a:latin typeface="Times New Roman" panose="02020603050405020304" pitchFamily="18" charset="0"/>
                <a:cs typeface="Times New Roman" panose="02020603050405020304" pitchFamily="18" charset="0"/>
              </a:rPr>
              <a:t>Supplementary Figure S1. </a:t>
            </a:r>
            <a:r>
              <a:rPr lang="en-AU" sz="1200" dirty="0">
                <a:effectLst/>
                <a:latin typeface="Times New Roman" panose="02020603050405020304" pitchFamily="18" charset="0"/>
                <a:ea typeface="Calibri" panose="020F0502020204030204" pitchFamily="34" charset="0"/>
              </a:rPr>
              <a:t>Field pea plants inoculated with </a:t>
            </a:r>
            <a:r>
              <a:rPr lang="en-AU" sz="1200" i="1" dirty="0">
                <a:effectLst/>
                <a:latin typeface="Times New Roman" panose="02020603050405020304" pitchFamily="18" charset="0"/>
                <a:ea typeface="Calibri" panose="020F0502020204030204" pitchFamily="34" charset="0"/>
              </a:rPr>
              <a:t>Peyronellaea pinodes </a:t>
            </a:r>
            <a:r>
              <a:rPr lang="en-AU" sz="1200" dirty="0">
                <a:effectLst/>
                <a:latin typeface="Times New Roman" panose="02020603050405020304" pitchFamily="18" charset="0"/>
                <a:ea typeface="Calibri" panose="020F0502020204030204" pitchFamily="34" charset="0"/>
              </a:rPr>
              <a:t>and </a:t>
            </a:r>
            <a:r>
              <a:rPr lang="en-AU" sz="1200" i="1" dirty="0">
                <a:effectLst/>
                <a:latin typeface="Times New Roman" panose="02020603050405020304" pitchFamily="18" charset="0"/>
                <a:ea typeface="Calibri" panose="020F0502020204030204" pitchFamily="34" charset="0"/>
              </a:rPr>
              <a:t>Didymella pinodella </a:t>
            </a:r>
            <a:r>
              <a:rPr lang="en-AU" sz="1200" dirty="0">
                <a:effectLst/>
                <a:latin typeface="Times New Roman" panose="02020603050405020304" pitchFamily="18" charset="0"/>
                <a:ea typeface="Calibri" panose="020F0502020204030204" pitchFamily="34" charset="0"/>
              </a:rPr>
              <a:t>at controlled environment facility in Horsham. The view from outside of the controlled environment showing the control systems and the two tents (a). Inoculated field pea plants and overhead humidifying pipes housed in the tent (b). </a:t>
            </a:r>
            <a:endParaRPr lang="en-AU" sz="1200" dirty="0"/>
          </a:p>
        </p:txBody>
      </p:sp>
      <p:sp>
        <p:nvSpPr>
          <p:cNvPr id="7" name="TextBox 6">
            <a:extLst>
              <a:ext uri="{FF2B5EF4-FFF2-40B4-BE49-F238E27FC236}">
                <a16:creationId xmlns:a16="http://schemas.microsoft.com/office/drawing/2014/main" id="{FEC7E80B-2463-40E3-A660-48C107A19F58}"/>
              </a:ext>
            </a:extLst>
          </p:cNvPr>
          <p:cNvSpPr txBox="1"/>
          <p:nvPr/>
        </p:nvSpPr>
        <p:spPr>
          <a:xfrm>
            <a:off x="140362" y="387392"/>
            <a:ext cx="333746" cy="253916"/>
          </a:xfrm>
          <a:prstGeom prst="rect">
            <a:avLst/>
          </a:prstGeom>
          <a:noFill/>
        </p:spPr>
        <p:txBody>
          <a:bodyPr wrap="none" rtlCol="0">
            <a:spAutoFit/>
          </a:bodyPr>
          <a:lstStyle/>
          <a:p>
            <a:r>
              <a:rPr lang="en-AU" sz="1050" dirty="0">
                <a:latin typeface="Times New Roman" panose="02020603050405020304" pitchFamily="18" charset="0"/>
                <a:cs typeface="Times New Roman" panose="02020603050405020304" pitchFamily="18" charset="0"/>
              </a:rPr>
              <a:t>(a)</a:t>
            </a:r>
          </a:p>
        </p:txBody>
      </p:sp>
      <p:sp>
        <p:nvSpPr>
          <p:cNvPr id="8" name="TextBox 7">
            <a:extLst>
              <a:ext uri="{FF2B5EF4-FFF2-40B4-BE49-F238E27FC236}">
                <a16:creationId xmlns:a16="http://schemas.microsoft.com/office/drawing/2014/main" id="{709122D4-5954-4374-8F5E-8D03A12CC6F3}"/>
              </a:ext>
            </a:extLst>
          </p:cNvPr>
          <p:cNvSpPr txBox="1"/>
          <p:nvPr/>
        </p:nvSpPr>
        <p:spPr>
          <a:xfrm>
            <a:off x="3006742" y="387394"/>
            <a:ext cx="341760" cy="253916"/>
          </a:xfrm>
          <a:prstGeom prst="rect">
            <a:avLst/>
          </a:prstGeom>
          <a:noFill/>
        </p:spPr>
        <p:txBody>
          <a:bodyPr wrap="none" rtlCol="0">
            <a:spAutoFit/>
          </a:bodyPr>
          <a:lstStyle/>
          <a:p>
            <a:r>
              <a:rPr lang="en-AU" sz="1050"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2339306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104B54DA-2ACF-4D2F-9628-203800804B01}"/>
              </a:ext>
            </a:extLst>
          </p:cNvPr>
          <p:cNvSpPr txBox="1"/>
          <p:nvPr/>
        </p:nvSpPr>
        <p:spPr>
          <a:xfrm>
            <a:off x="1445810" y="7506865"/>
            <a:ext cx="1649816"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Log starting quantity </a:t>
            </a:r>
          </a:p>
        </p:txBody>
      </p:sp>
      <p:sp>
        <p:nvSpPr>
          <p:cNvPr id="11" name="TextBox 10">
            <a:extLst>
              <a:ext uri="{FF2B5EF4-FFF2-40B4-BE49-F238E27FC236}">
                <a16:creationId xmlns:a16="http://schemas.microsoft.com/office/drawing/2014/main" id="{7E2881C9-791E-43C5-987C-B68E93BDDD2F}"/>
              </a:ext>
            </a:extLst>
          </p:cNvPr>
          <p:cNvSpPr txBox="1"/>
          <p:nvPr/>
        </p:nvSpPr>
        <p:spPr>
          <a:xfrm rot="16200000">
            <a:off x="328762" y="1393778"/>
            <a:ext cx="488793"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Ct</a:t>
            </a:r>
          </a:p>
        </p:txBody>
      </p:sp>
      <p:sp>
        <p:nvSpPr>
          <p:cNvPr id="16" name="TextBox 15">
            <a:extLst>
              <a:ext uri="{FF2B5EF4-FFF2-40B4-BE49-F238E27FC236}">
                <a16:creationId xmlns:a16="http://schemas.microsoft.com/office/drawing/2014/main" id="{222346BD-5D31-40F9-A7F1-826F9DBAFFAB}"/>
              </a:ext>
            </a:extLst>
          </p:cNvPr>
          <p:cNvSpPr txBox="1"/>
          <p:nvPr/>
        </p:nvSpPr>
        <p:spPr>
          <a:xfrm rot="16200000">
            <a:off x="333007" y="3832382"/>
            <a:ext cx="488793"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Ct</a:t>
            </a:r>
          </a:p>
        </p:txBody>
      </p:sp>
      <p:sp>
        <p:nvSpPr>
          <p:cNvPr id="17" name="TextBox 16">
            <a:extLst>
              <a:ext uri="{FF2B5EF4-FFF2-40B4-BE49-F238E27FC236}">
                <a16:creationId xmlns:a16="http://schemas.microsoft.com/office/drawing/2014/main" id="{095D69FD-E1B4-45A9-A37E-03F027EAF430}"/>
              </a:ext>
            </a:extLst>
          </p:cNvPr>
          <p:cNvSpPr txBox="1"/>
          <p:nvPr/>
        </p:nvSpPr>
        <p:spPr>
          <a:xfrm rot="16200000">
            <a:off x="328763" y="6224406"/>
            <a:ext cx="488793"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Ct</a:t>
            </a:r>
          </a:p>
        </p:txBody>
      </p:sp>
      <p:sp>
        <p:nvSpPr>
          <p:cNvPr id="18" name="TextBox 17">
            <a:extLst>
              <a:ext uri="{FF2B5EF4-FFF2-40B4-BE49-F238E27FC236}">
                <a16:creationId xmlns:a16="http://schemas.microsoft.com/office/drawing/2014/main" id="{BF4A03D7-D376-456F-A710-2CD4D8A4A0F8}"/>
              </a:ext>
            </a:extLst>
          </p:cNvPr>
          <p:cNvSpPr txBox="1"/>
          <p:nvPr/>
        </p:nvSpPr>
        <p:spPr>
          <a:xfrm>
            <a:off x="314017" y="336464"/>
            <a:ext cx="304892" cy="276999"/>
          </a:xfrm>
          <a:prstGeom prst="rect">
            <a:avLst/>
          </a:prstGeom>
          <a:noFill/>
        </p:spPr>
        <p:txBody>
          <a:bodyPr wrap="none" rtlCol="0">
            <a:spAutoFit/>
          </a:bodyPr>
          <a:lstStyle/>
          <a:p>
            <a:r>
              <a:rPr lang="en-AU" sz="1200" dirty="0">
                <a:latin typeface="Times New Roman" panose="02020603050405020304" pitchFamily="18" charset="0"/>
                <a:cs typeface="Times New Roman" panose="02020603050405020304" pitchFamily="18" charset="0"/>
              </a:rPr>
              <a:t>a)</a:t>
            </a:r>
          </a:p>
        </p:txBody>
      </p:sp>
      <p:sp>
        <p:nvSpPr>
          <p:cNvPr id="19" name="TextBox 18">
            <a:extLst>
              <a:ext uri="{FF2B5EF4-FFF2-40B4-BE49-F238E27FC236}">
                <a16:creationId xmlns:a16="http://schemas.microsoft.com/office/drawing/2014/main" id="{4F78C8B9-780C-4860-8FE4-4B89D8BABE42}"/>
              </a:ext>
            </a:extLst>
          </p:cNvPr>
          <p:cNvSpPr txBox="1"/>
          <p:nvPr/>
        </p:nvSpPr>
        <p:spPr>
          <a:xfrm>
            <a:off x="269614" y="2913400"/>
            <a:ext cx="312906" cy="276999"/>
          </a:xfrm>
          <a:prstGeom prst="rect">
            <a:avLst/>
          </a:prstGeom>
          <a:noFill/>
        </p:spPr>
        <p:txBody>
          <a:bodyPr wrap="none" rtlCol="0">
            <a:spAutoFit/>
          </a:bodyPr>
          <a:lstStyle/>
          <a:p>
            <a:r>
              <a:rPr lang="en-AU" sz="1200" dirty="0">
                <a:latin typeface="Times New Roman" panose="02020603050405020304" pitchFamily="18" charset="0"/>
                <a:cs typeface="Times New Roman" panose="02020603050405020304" pitchFamily="18" charset="0"/>
              </a:rPr>
              <a:t>b)</a:t>
            </a:r>
          </a:p>
        </p:txBody>
      </p:sp>
      <p:sp>
        <p:nvSpPr>
          <p:cNvPr id="20" name="TextBox 19">
            <a:extLst>
              <a:ext uri="{FF2B5EF4-FFF2-40B4-BE49-F238E27FC236}">
                <a16:creationId xmlns:a16="http://schemas.microsoft.com/office/drawing/2014/main" id="{A38DEE29-6C86-45B2-97B1-16A62AC653EA}"/>
              </a:ext>
            </a:extLst>
          </p:cNvPr>
          <p:cNvSpPr txBox="1"/>
          <p:nvPr/>
        </p:nvSpPr>
        <p:spPr>
          <a:xfrm>
            <a:off x="269614" y="5403237"/>
            <a:ext cx="304892" cy="276999"/>
          </a:xfrm>
          <a:prstGeom prst="rect">
            <a:avLst/>
          </a:prstGeom>
          <a:noFill/>
        </p:spPr>
        <p:txBody>
          <a:bodyPr wrap="none" rtlCol="0">
            <a:spAutoFit/>
          </a:bodyPr>
          <a:lstStyle/>
          <a:p>
            <a:r>
              <a:rPr lang="en-AU" sz="1200" dirty="0">
                <a:latin typeface="Times New Roman" panose="02020603050405020304" pitchFamily="18" charset="0"/>
                <a:cs typeface="Times New Roman" panose="02020603050405020304" pitchFamily="18" charset="0"/>
              </a:rPr>
              <a:t>c)</a:t>
            </a:r>
          </a:p>
        </p:txBody>
      </p:sp>
      <p:pic>
        <p:nvPicPr>
          <p:cNvPr id="3" name="Picture 2">
            <a:extLst>
              <a:ext uri="{FF2B5EF4-FFF2-40B4-BE49-F238E27FC236}">
                <a16:creationId xmlns:a16="http://schemas.microsoft.com/office/drawing/2014/main" id="{19CB36F8-1BD7-457F-82E7-EB17E23725CB}"/>
              </a:ext>
            </a:extLst>
          </p:cNvPr>
          <p:cNvPicPr>
            <a:picLocks noChangeAspect="1"/>
          </p:cNvPicPr>
          <p:nvPr/>
        </p:nvPicPr>
        <p:blipFill rotWithShape="1">
          <a:blip r:embed="rId2">
            <a:extLst>
              <a:ext uri="{28A0092B-C50C-407E-A947-70E740481C1C}">
                <a14:useLocalDpi xmlns:a14="http://schemas.microsoft.com/office/drawing/2010/main" val="0"/>
              </a:ext>
            </a:extLst>
          </a:blip>
          <a:srcRect l="2577" b="3941"/>
          <a:stretch/>
        </p:blipFill>
        <p:spPr>
          <a:xfrm>
            <a:off x="712424" y="490531"/>
            <a:ext cx="3030435" cy="2196000"/>
          </a:xfrm>
          <a:prstGeom prst="rect">
            <a:avLst/>
          </a:prstGeom>
        </p:spPr>
      </p:pic>
      <p:pic>
        <p:nvPicPr>
          <p:cNvPr id="5" name="Picture 4" descr="Chart, line chart&#10;&#10;Description automatically generated">
            <a:extLst>
              <a:ext uri="{FF2B5EF4-FFF2-40B4-BE49-F238E27FC236}">
                <a16:creationId xmlns:a16="http://schemas.microsoft.com/office/drawing/2014/main" id="{F20A2574-756A-415C-AC36-A9F18674EA5C}"/>
              </a:ext>
            </a:extLst>
          </p:cNvPr>
          <p:cNvPicPr>
            <a:picLocks noChangeAspect="1"/>
          </p:cNvPicPr>
          <p:nvPr/>
        </p:nvPicPr>
        <p:blipFill rotWithShape="1">
          <a:blip r:embed="rId3">
            <a:extLst>
              <a:ext uri="{28A0092B-C50C-407E-A947-70E740481C1C}">
                <a14:useLocalDpi xmlns:a14="http://schemas.microsoft.com/office/drawing/2010/main" val="0"/>
              </a:ext>
            </a:extLst>
          </a:blip>
          <a:srcRect l="2577" b="3941"/>
          <a:stretch/>
        </p:blipFill>
        <p:spPr>
          <a:xfrm>
            <a:off x="695910" y="2807670"/>
            <a:ext cx="3030436" cy="2196000"/>
          </a:xfrm>
          <a:prstGeom prst="rect">
            <a:avLst/>
          </a:prstGeom>
        </p:spPr>
      </p:pic>
      <p:pic>
        <p:nvPicPr>
          <p:cNvPr id="7" name="Picture 6" descr="Chart, line chart&#10;&#10;Description automatically generated">
            <a:extLst>
              <a:ext uri="{FF2B5EF4-FFF2-40B4-BE49-F238E27FC236}">
                <a16:creationId xmlns:a16="http://schemas.microsoft.com/office/drawing/2014/main" id="{D347D469-9370-4A90-8676-137927145E1B}"/>
              </a:ext>
            </a:extLst>
          </p:cNvPr>
          <p:cNvPicPr>
            <a:picLocks noChangeAspect="1"/>
          </p:cNvPicPr>
          <p:nvPr/>
        </p:nvPicPr>
        <p:blipFill rotWithShape="1">
          <a:blip r:embed="rId4">
            <a:extLst>
              <a:ext uri="{28A0092B-C50C-407E-A947-70E740481C1C}">
                <a14:useLocalDpi xmlns:a14="http://schemas.microsoft.com/office/drawing/2010/main" val="0"/>
              </a:ext>
            </a:extLst>
          </a:blip>
          <a:srcRect l="3024" b="4185"/>
          <a:stretch/>
        </p:blipFill>
        <p:spPr>
          <a:xfrm>
            <a:off x="711659" y="5295767"/>
            <a:ext cx="3031200" cy="2196000"/>
          </a:xfrm>
          <a:prstGeom prst="rect">
            <a:avLst/>
          </a:prstGeom>
        </p:spPr>
      </p:pic>
      <p:sp>
        <p:nvSpPr>
          <p:cNvPr id="15" name="TextBox 14">
            <a:extLst>
              <a:ext uri="{FF2B5EF4-FFF2-40B4-BE49-F238E27FC236}">
                <a16:creationId xmlns:a16="http://schemas.microsoft.com/office/drawing/2014/main" id="{C09FDC9F-8375-4B0E-BF4B-FC0A711EBBF8}"/>
              </a:ext>
            </a:extLst>
          </p:cNvPr>
          <p:cNvSpPr txBox="1"/>
          <p:nvPr/>
        </p:nvSpPr>
        <p:spPr>
          <a:xfrm>
            <a:off x="2743885" y="754898"/>
            <a:ext cx="364202" cy="307777"/>
          </a:xfrm>
          <a:prstGeom prst="rect">
            <a:avLst/>
          </a:prstGeom>
          <a:noFill/>
        </p:spPr>
        <p:txBody>
          <a:bodyPr wrap="none" rtlCol="0">
            <a:spAutoFit/>
          </a:bodyPr>
          <a:lstStyle/>
          <a:p>
            <a:r>
              <a:rPr lang="en-AU" sz="1400" dirty="0"/>
              <a:t>**</a:t>
            </a:r>
          </a:p>
        </p:txBody>
      </p:sp>
      <p:sp>
        <p:nvSpPr>
          <p:cNvPr id="24" name="TextBox 23">
            <a:extLst>
              <a:ext uri="{FF2B5EF4-FFF2-40B4-BE49-F238E27FC236}">
                <a16:creationId xmlns:a16="http://schemas.microsoft.com/office/drawing/2014/main" id="{4BB56304-B29F-430E-887B-F4FDFF4F289B}"/>
              </a:ext>
            </a:extLst>
          </p:cNvPr>
          <p:cNvSpPr txBox="1"/>
          <p:nvPr/>
        </p:nvSpPr>
        <p:spPr>
          <a:xfrm>
            <a:off x="2729596" y="3079660"/>
            <a:ext cx="364202" cy="307777"/>
          </a:xfrm>
          <a:prstGeom prst="rect">
            <a:avLst/>
          </a:prstGeom>
          <a:noFill/>
        </p:spPr>
        <p:txBody>
          <a:bodyPr wrap="none" rtlCol="0">
            <a:spAutoFit/>
          </a:bodyPr>
          <a:lstStyle/>
          <a:p>
            <a:r>
              <a:rPr lang="en-AU" sz="1400" dirty="0"/>
              <a:t>**</a:t>
            </a:r>
          </a:p>
        </p:txBody>
      </p:sp>
      <p:sp>
        <p:nvSpPr>
          <p:cNvPr id="25" name="TextBox 24">
            <a:extLst>
              <a:ext uri="{FF2B5EF4-FFF2-40B4-BE49-F238E27FC236}">
                <a16:creationId xmlns:a16="http://schemas.microsoft.com/office/drawing/2014/main" id="{11DD4ED1-39FF-4CE3-9494-A467C4CD55C4}"/>
              </a:ext>
            </a:extLst>
          </p:cNvPr>
          <p:cNvSpPr txBox="1"/>
          <p:nvPr/>
        </p:nvSpPr>
        <p:spPr>
          <a:xfrm>
            <a:off x="2743885" y="5549805"/>
            <a:ext cx="364202" cy="307777"/>
          </a:xfrm>
          <a:prstGeom prst="rect">
            <a:avLst/>
          </a:prstGeom>
          <a:noFill/>
        </p:spPr>
        <p:txBody>
          <a:bodyPr wrap="none" rtlCol="0">
            <a:spAutoFit/>
          </a:bodyPr>
          <a:lstStyle/>
          <a:p>
            <a:r>
              <a:rPr lang="en-AU" sz="1400" dirty="0"/>
              <a:t>**</a:t>
            </a:r>
          </a:p>
        </p:txBody>
      </p:sp>
    </p:spTree>
    <p:extLst>
      <p:ext uri="{BB962C8B-B14F-4D97-AF65-F5344CB8AC3E}">
        <p14:creationId xmlns:p14="http://schemas.microsoft.com/office/powerpoint/2010/main" val="5570932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E0B0C1E0-6FDE-475D-ABA8-3D6EC69EC323}"/>
              </a:ext>
            </a:extLst>
          </p:cNvPr>
          <p:cNvSpPr txBox="1"/>
          <p:nvPr/>
        </p:nvSpPr>
        <p:spPr>
          <a:xfrm>
            <a:off x="314167" y="231207"/>
            <a:ext cx="312906" cy="276999"/>
          </a:xfrm>
          <a:prstGeom prst="rect">
            <a:avLst/>
          </a:prstGeom>
          <a:noFill/>
        </p:spPr>
        <p:txBody>
          <a:bodyPr wrap="none" rtlCol="0">
            <a:spAutoFit/>
          </a:bodyPr>
          <a:lstStyle/>
          <a:p>
            <a:r>
              <a:rPr lang="en-AU" sz="1200" dirty="0">
                <a:latin typeface="Times New Roman" panose="02020603050405020304" pitchFamily="18" charset="0"/>
                <a:cs typeface="Times New Roman" panose="02020603050405020304" pitchFamily="18" charset="0"/>
              </a:rPr>
              <a:t>d)</a:t>
            </a:r>
          </a:p>
        </p:txBody>
      </p:sp>
      <p:sp>
        <p:nvSpPr>
          <p:cNvPr id="11" name="TextBox 10">
            <a:extLst>
              <a:ext uri="{FF2B5EF4-FFF2-40B4-BE49-F238E27FC236}">
                <a16:creationId xmlns:a16="http://schemas.microsoft.com/office/drawing/2014/main" id="{7E21F5E0-D655-4B7E-BEBF-44228D0C3F80}"/>
              </a:ext>
            </a:extLst>
          </p:cNvPr>
          <p:cNvSpPr txBox="1"/>
          <p:nvPr/>
        </p:nvSpPr>
        <p:spPr>
          <a:xfrm>
            <a:off x="318174" y="2669662"/>
            <a:ext cx="304892" cy="276999"/>
          </a:xfrm>
          <a:prstGeom prst="rect">
            <a:avLst/>
          </a:prstGeom>
          <a:noFill/>
        </p:spPr>
        <p:txBody>
          <a:bodyPr wrap="none" rtlCol="0">
            <a:spAutoFit/>
          </a:bodyPr>
          <a:lstStyle/>
          <a:p>
            <a:r>
              <a:rPr lang="en-AU" sz="1200" dirty="0">
                <a:latin typeface="Times New Roman" panose="02020603050405020304" pitchFamily="18" charset="0"/>
                <a:cs typeface="Times New Roman" panose="02020603050405020304" pitchFamily="18" charset="0"/>
              </a:rPr>
              <a:t>e)</a:t>
            </a:r>
          </a:p>
        </p:txBody>
      </p:sp>
      <p:sp>
        <p:nvSpPr>
          <p:cNvPr id="12" name="TextBox 11">
            <a:extLst>
              <a:ext uri="{FF2B5EF4-FFF2-40B4-BE49-F238E27FC236}">
                <a16:creationId xmlns:a16="http://schemas.microsoft.com/office/drawing/2014/main" id="{B7A90DAA-B5C7-4482-B49E-A18875F99856}"/>
              </a:ext>
            </a:extLst>
          </p:cNvPr>
          <p:cNvSpPr txBox="1"/>
          <p:nvPr/>
        </p:nvSpPr>
        <p:spPr>
          <a:xfrm>
            <a:off x="326991" y="5200396"/>
            <a:ext cx="287258" cy="276999"/>
          </a:xfrm>
          <a:prstGeom prst="rect">
            <a:avLst/>
          </a:prstGeom>
          <a:noFill/>
        </p:spPr>
        <p:txBody>
          <a:bodyPr wrap="none" rtlCol="0">
            <a:spAutoFit/>
          </a:bodyPr>
          <a:lstStyle/>
          <a:p>
            <a:r>
              <a:rPr lang="en-AU" sz="1200" dirty="0">
                <a:latin typeface="Times New Roman" panose="02020603050405020304" pitchFamily="18" charset="0"/>
                <a:cs typeface="Times New Roman" panose="02020603050405020304" pitchFamily="18" charset="0"/>
              </a:rPr>
              <a:t>f)</a:t>
            </a:r>
          </a:p>
        </p:txBody>
      </p:sp>
      <p:sp>
        <p:nvSpPr>
          <p:cNvPr id="13" name="TextBox 12">
            <a:extLst>
              <a:ext uri="{FF2B5EF4-FFF2-40B4-BE49-F238E27FC236}">
                <a16:creationId xmlns:a16="http://schemas.microsoft.com/office/drawing/2014/main" id="{811402F5-C89C-4BAF-8A75-3E0ADADC6EA1}"/>
              </a:ext>
            </a:extLst>
          </p:cNvPr>
          <p:cNvSpPr txBox="1"/>
          <p:nvPr/>
        </p:nvSpPr>
        <p:spPr>
          <a:xfrm>
            <a:off x="1372897" y="7601488"/>
            <a:ext cx="2251881"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Log starting quantity </a:t>
            </a:r>
          </a:p>
        </p:txBody>
      </p:sp>
      <p:sp>
        <p:nvSpPr>
          <p:cNvPr id="14" name="TextBox 13">
            <a:extLst>
              <a:ext uri="{FF2B5EF4-FFF2-40B4-BE49-F238E27FC236}">
                <a16:creationId xmlns:a16="http://schemas.microsoft.com/office/drawing/2014/main" id="{EDCDE73B-68F3-4A6B-831F-FA548F8450D1}"/>
              </a:ext>
            </a:extLst>
          </p:cNvPr>
          <p:cNvSpPr txBox="1"/>
          <p:nvPr/>
        </p:nvSpPr>
        <p:spPr>
          <a:xfrm rot="16200000">
            <a:off x="242173" y="1378732"/>
            <a:ext cx="488793"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Ct</a:t>
            </a:r>
          </a:p>
        </p:txBody>
      </p:sp>
      <p:sp>
        <p:nvSpPr>
          <p:cNvPr id="15" name="TextBox 14">
            <a:extLst>
              <a:ext uri="{FF2B5EF4-FFF2-40B4-BE49-F238E27FC236}">
                <a16:creationId xmlns:a16="http://schemas.microsoft.com/office/drawing/2014/main" id="{2A11BAFA-50ED-44BD-A06C-59A363CBC906}"/>
              </a:ext>
            </a:extLst>
          </p:cNvPr>
          <p:cNvSpPr txBox="1"/>
          <p:nvPr/>
        </p:nvSpPr>
        <p:spPr>
          <a:xfrm rot="16200000">
            <a:off x="242173" y="3853016"/>
            <a:ext cx="488793"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Ct</a:t>
            </a:r>
          </a:p>
        </p:txBody>
      </p:sp>
      <p:sp>
        <p:nvSpPr>
          <p:cNvPr id="16" name="TextBox 15">
            <a:extLst>
              <a:ext uri="{FF2B5EF4-FFF2-40B4-BE49-F238E27FC236}">
                <a16:creationId xmlns:a16="http://schemas.microsoft.com/office/drawing/2014/main" id="{700F26B8-2ACC-4351-A8E9-5FEA32FE078F}"/>
              </a:ext>
            </a:extLst>
          </p:cNvPr>
          <p:cNvSpPr txBox="1"/>
          <p:nvPr/>
        </p:nvSpPr>
        <p:spPr>
          <a:xfrm rot="16200000">
            <a:off x="242173" y="6301763"/>
            <a:ext cx="488793" cy="27699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Ct</a:t>
            </a:r>
          </a:p>
        </p:txBody>
      </p:sp>
      <p:sp>
        <p:nvSpPr>
          <p:cNvPr id="20" name="TextBox 19">
            <a:extLst>
              <a:ext uri="{FF2B5EF4-FFF2-40B4-BE49-F238E27FC236}">
                <a16:creationId xmlns:a16="http://schemas.microsoft.com/office/drawing/2014/main" id="{851780F3-DCAF-460C-914D-B75533DCD51A}"/>
              </a:ext>
            </a:extLst>
          </p:cNvPr>
          <p:cNvSpPr txBox="1"/>
          <p:nvPr/>
        </p:nvSpPr>
        <p:spPr>
          <a:xfrm>
            <a:off x="0" y="7827630"/>
            <a:ext cx="5023058" cy="120032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Supplementary Figure S2</a:t>
            </a:r>
            <a:r>
              <a:rPr lang="en-AU" sz="1200" dirty="0">
                <a:latin typeface="Times New Roman" panose="02020603050405020304" pitchFamily="18" charset="0"/>
                <a:cs typeface="Times New Roman" panose="02020603050405020304" pitchFamily="18" charset="0"/>
              </a:rPr>
              <a:t>. Standard curve generated by plotting the log10 of starting cDNA quantity of field pea and Ct values for </a:t>
            </a:r>
            <a:r>
              <a:rPr lang="en-AU" sz="1200" i="1" dirty="0">
                <a:latin typeface="Times New Roman" panose="02020603050405020304" pitchFamily="18" charset="0"/>
                <a:cs typeface="Times New Roman" panose="02020603050405020304" pitchFamily="18" charset="0"/>
              </a:rPr>
              <a:t>PsOXII</a:t>
            </a:r>
            <a:r>
              <a:rPr lang="en-AU" sz="1200" dirty="0">
                <a:latin typeface="Times New Roman" panose="02020603050405020304" pitchFamily="18" charset="0"/>
                <a:cs typeface="Times New Roman" panose="02020603050405020304" pitchFamily="18" charset="0"/>
              </a:rPr>
              <a:t> (a), </a:t>
            </a:r>
            <a:r>
              <a:rPr lang="en-AU" sz="1200" i="1" dirty="0">
                <a:latin typeface="Times New Roman" panose="02020603050405020304" pitchFamily="18" charset="0"/>
                <a:cs typeface="Times New Roman" panose="02020603050405020304" pitchFamily="18" charset="0"/>
              </a:rPr>
              <a:t>PsAPX11</a:t>
            </a:r>
            <a:r>
              <a:rPr lang="en-AU" sz="1200" dirty="0">
                <a:latin typeface="Times New Roman" panose="02020603050405020304" pitchFamily="18" charset="0"/>
                <a:cs typeface="Times New Roman" panose="02020603050405020304" pitchFamily="18" charset="0"/>
              </a:rPr>
              <a:t> (b), </a:t>
            </a:r>
            <a:r>
              <a:rPr lang="en-AU" sz="1200" i="1" dirty="0">
                <a:latin typeface="Times New Roman" panose="02020603050405020304" pitchFamily="18" charset="0"/>
                <a:cs typeface="Times New Roman" panose="02020603050405020304" pitchFamily="18" charset="0"/>
              </a:rPr>
              <a:t>Pshmm6</a:t>
            </a:r>
            <a:r>
              <a:rPr lang="en-AU" sz="1200" dirty="0">
                <a:latin typeface="Times New Roman" panose="02020603050405020304" pitchFamily="18" charset="0"/>
                <a:cs typeface="Times New Roman" panose="02020603050405020304" pitchFamily="18" charset="0"/>
              </a:rPr>
              <a:t> (c), </a:t>
            </a:r>
            <a:r>
              <a:rPr lang="en-AU" sz="1200" i="1" dirty="0">
                <a:latin typeface="Times New Roman" panose="02020603050405020304" pitchFamily="18" charset="0"/>
                <a:cs typeface="Times New Roman" panose="02020603050405020304" pitchFamily="18" charset="0"/>
              </a:rPr>
              <a:t>PsCHS3</a:t>
            </a:r>
            <a:r>
              <a:rPr lang="en-AU" sz="1200" dirty="0">
                <a:latin typeface="Times New Roman" panose="02020603050405020304" pitchFamily="18" charset="0"/>
                <a:cs typeface="Times New Roman" panose="02020603050405020304" pitchFamily="18" charset="0"/>
              </a:rPr>
              <a:t> (d), </a:t>
            </a:r>
            <a:r>
              <a:rPr lang="en-AU" sz="1200" i="1" dirty="0">
                <a:latin typeface="Times New Roman" panose="02020603050405020304" pitchFamily="18" charset="0"/>
                <a:cs typeface="Times New Roman" panose="02020603050405020304" pitchFamily="18" charset="0"/>
              </a:rPr>
              <a:t>PsOPR1</a:t>
            </a:r>
            <a:r>
              <a:rPr lang="en-AU" sz="1200" dirty="0">
                <a:latin typeface="Times New Roman" panose="02020603050405020304" pitchFamily="18" charset="0"/>
                <a:cs typeface="Times New Roman" panose="02020603050405020304" pitchFamily="18" charset="0"/>
              </a:rPr>
              <a:t> (e) and </a:t>
            </a:r>
            <a:r>
              <a:rPr lang="en-AU" sz="1200" i="1" dirty="0">
                <a:latin typeface="Times New Roman" panose="02020603050405020304" pitchFamily="18" charset="0"/>
                <a:cs typeface="Times New Roman" panose="02020603050405020304" pitchFamily="18" charset="0"/>
              </a:rPr>
              <a:t>PsHiston3</a:t>
            </a:r>
            <a:r>
              <a:rPr lang="en-AU" sz="1200" dirty="0">
                <a:latin typeface="Times New Roman" panose="02020603050405020304" pitchFamily="18" charset="0"/>
                <a:cs typeface="Times New Roman" panose="02020603050405020304" pitchFamily="18" charset="0"/>
              </a:rPr>
              <a:t> (f). R</a:t>
            </a:r>
            <a:r>
              <a:rPr lang="en-AU" sz="1200" baseline="30000" dirty="0">
                <a:latin typeface="Times New Roman" panose="02020603050405020304" pitchFamily="18" charset="0"/>
                <a:cs typeface="Times New Roman" panose="02020603050405020304" pitchFamily="18" charset="0"/>
              </a:rPr>
              <a:t>2</a:t>
            </a:r>
            <a:r>
              <a:rPr lang="en-AU" sz="1200" dirty="0">
                <a:latin typeface="Times New Roman" panose="02020603050405020304" pitchFamily="18" charset="0"/>
                <a:cs typeface="Times New Roman" panose="02020603050405020304" pitchFamily="18" charset="0"/>
              </a:rPr>
              <a:t> shows the best linear fit for the standards. In each plot the linear curve is described by y=</a:t>
            </a:r>
            <a:r>
              <a:rPr lang="en-AU" sz="1200" dirty="0" err="1">
                <a:latin typeface="Times New Roman" panose="02020603050405020304" pitchFamily="18" charset="0"/>
                <a:cs typeface="Times New Roman" panose="02020603050405020304" pitchFamily="18" charset="0"/>
              </a:rPr>
              <a:t>mx+c</a:t>
            </a:r>
            <a:r>
              <a:rPr lang="en-AU" sz="1200" dirty="0">
                <a:latin typeface="Times New Roman" panose="02020603050405020304" pitchFamily="18" charset="0"/>
                <a:cs typeface="Times New Roman" panose="02020603050405020304" pitchFamily="18" charset="0"/>
              </a:rPr>
              <a:t> where y is Ct value, x is log10 starting quantity, m is the slope of the curve and c is intercept. E is the efficiency of the primer pairs.</a:t>
            </a:r>
          </a:p>
        </p:txBody>
      </p:sp>
      <p:pic>
        <p:nvPicPr>
          <p:cNvPr id="3" name="Picture 2" descr="Chart, line chart&#10;&#10;Description automatically generated">
            <a:extLst>
              <a:ext uri="{FF2B5EF4-FFF2-40B4-BE49-F238E27FC236}">
                <a16:creationId xmlns:a16="http://schemas.microsoft.com/office/drawing/2014/main" id="{D7B41613-4B41-4B09-88CC-92F44D9368A2}"/>
              </a:ext>
            </a:extLst>
          </p:cNvPr>
          <p:cNvPicPr>
            <a:picLocks noChangeAspect="1"/>
          </p:cNvPicPr>
          <p:nvPr/>
        </p:nvPicPr>
        <p:blipFill rotWithShape="1">
          <a:blip r:embed="rId2">
            <a:extLst>
              <a:ext uri="{28A0092B-C50C-407E-A947-70E740481C1C}">
                <a14:useLocalDpi xmlns:a14="http://schemas.microsoft.com/office/drawing/2010/main" val="0"/>
              </a:ext>
            </a:extLst>
          </a:blip>
          <a:srcRect l="3056" b="3902"/>
          <a:stretch/>
        </p:blipFill>
        <p:spPr>
          <a:xfrm>
            <a:off x="580910" y="482780"/>
            <a:ext cx="3031200" cy="2196000"/>
          </a:xfrm>
          <a:prstGeom prst="rect">
            <a:avLst/>
          </a:prstGeom>
        </p:spPr>
      </p:pic>
      <p:pic>
        <p:nvPicPr>
          <p:cNvPr id="7" name="Picture 6" descr="Chart, line chart&#10;&#10;Description automatically generated">
            <a:extLst>
              <a:ext uri="{FF2B5EF4-FFF2-40B4-BE49-F238E27FC236}">
                <a16:creationId xmlns:a16="http://schemas.microsoft.com/office/drawing/2014/main" id="{1624CCFB-4DAE-4D3C-B38D-0FB4842573DC}"/>
              </a:ext>
            </a:extLst>
          </p:cNvPr>
          <p:cNvPicPr>
            <a:picLocks noChangeAspect="1"/>
          </p:cNvPicPr>
          <p:nvPr/>
        </p:nvPicPr>
        <p:blipFill rotWithShape="1">
          <a:blip r:embed="rId3">
            <a:extLst>
              <a:ext uri="{28A0092B-C50C-407E-A947-70E740481C1C}">
                <a14:useLocalDpi xmlns:a14="http://schemas.microsoft.com/office/drawing/2010/main" val="0"/>
              </a:ext>
            </a:extLst>
          </a:blip>
          <a:srcRect l="3148" b="3902"/>
          <a:stretch/>
        </p:blipFill>
        <p:spPr>
          <a:xfrm>
            <a:off x="580910" y="2927587"/>
            <a:ext cx="3031200" cy="2196000"/>
          </a:xfrm>
          <a:prstGeom prst="rect">
            <a:avLst/>
          </a:prstGeom>
        </p:spPr>
      </p:pic>
      <p:pic>
        <p:nvPicPr>
          <p:cNvPr id="21" name="Picture 20" descr="Chart, line chart&#10;&#10;Description automatically generated">
            <a:extLst>
              <a:ext uri="{FF2B5EF4-FFF2-40B4-BE49-F238E27FC236}">
                <a16:creationId xmlns:a16="http://schemas.microsoft.com/office/drawing/2014/main" id="{62958B15-C3C3-4A03-ABBF-4F3E71E48418}"/>
              </a:ext>
            </a:extLst>
          </p:cNvPr>
          <p:cNvPicPr>
            <a:picLocks noChangeAspect="1"/>
          </p:cNvPicPr>
          <p:nvPr/>
        </p:nvPicPr>
        <p:blipFill rotWithShape="1">
          <a:blip r:embed="rId4">
            <a:extLst>
              <a:ext uri="{28A0092B-C50C-407E-A947-70E740481C1C}">
                <a14:useLocalDpi xmlns:a14="http://schemas.microsoft.com/office/drawing/2010/main" val="0"/>
              </a:ext>
            </a:extLst>
          </a:blip>
          <a:srcRect l="3148" b="3902"/>
          <a:stretch/>
        </p:blipFill>
        <p:spPr>
          <a:xfrm>
            <a:off x="580910" y="5325122"/>
            <a:ext cx="3031200" cy="2196787"/>
          </a:xfrm>
          <a:prstGeom prst="rect">
            <a:avLst/>
          </a:prstGeom>
        </p:spPr>
      </p:pic>
      <p:sp>
        <p:nvSpPr>
          <p:cNvPr id="2" name="TextBox 1">
            <a:extLst>
              <a:ext uri="{FF2B5EF4-FFF2-40B4-BE49-F238E27FC236}">
                <a16:creationId xmlns:a16="http://schemas.microsoft.com/office/drawing/2014/main" id="{A8371189-6095-481B-B1BD-4753FCAAA347}"/>
              </a:ext>
            </a:extLst>
          </p:cNvPr>
          <p:cNvSpPr txBox="1"/>
          <p:nvPr/>
        </p:nvSpPr>
        <p:spPr>
          <a:xfrm>
            <a:off x="2615294" y="740609"/>
            <a:ext cx="364202" cy="307777"/>
          </a:xfrm>
          <a:prstGeom prst="rect">
            <a:avLst/>
          </a:prstGeom>
          <a:noFill/>
        </p:spPr>
        <p:txBody>
          <a:bodyPr wrap="none" rtlCol="0">
            <a:spAutoFit/>
          </a:bodyPr>
          <a:lstStyle/>
          <a:p>
            <a:r>
              <a:rPr lang="en-AU" sz="1400" dirty="0"/>
              <a:t>**</a:t>
            </a:r>
          </a:p>
        </p:txBody>
      </p:sp>
      <p:sp>
        <p:nvSpPr>
          <p:cNvPr id="22" name="TextBox 21">
            <a:extLst>
              <a:ext uri="{FF2B5EF4-FFF2-40B4-BE49-F238E27FC236}">
                <a16:creationId xmlns:a16="http://schemas.microsoft.com/office/drawing/2014/main" id="{0785FD63-81C2-46FD-8CD8-2E8D880C126A}"/>
              </a:ext>
            </a:extLst>
          </p:cNvPr>
          <p:cNvSpPr txBox="1"/>
          <p:nvPr/>
        </p:nvSpPr>
        <p:spPr>
          <a:xfrm>
            <a:off x="2562902" y="3181436"/>
            <a:ext cx="364202" cy="307777"/>
          </a:xfrm>
          <a:prstGeom prst="rect">
            <a:avLst/>
          </a:prstGeom>
          <a:noFill/>
        </p:spPr>
        <p:txBody>
          <a:bodyPr wrap="none" rtlCol="0">
            <a:spAutoFit/>
          </a:bodyPr>
          <a:lstStyle/>
          <a:p>
            <a:r>
              <a:rPr lang="en-AU" sz="1400" dirty="0"/>
              <a:t>**</a:t>
            </a:r>
          </a:p>
        </p:txBody>
      </p:sp>
      <p:sp>
        <p:nvSpPr>
          <p:cNvPr id="23" name="TextBox 22">
            <a:extLst>
              <a:ext uri="{FF2B5EF4-FFF2-40B4-BE49-F238E27FC236}">
                <a16:creationId xmlns:a16="http://schemas.microsoft.com/office/drawing/2014/main" id="{A6E4C43E-EE2F-4C81-8F04-29380981D8C4}"/>
              </a:ext>
            </a:extLst>
          </p:cNvPr>
          <p:cNvSpPr txBox="1"/>
          <p:nvPr/>
        </p:nvSpPr>
        <p:spPr>
          <a:xfrm>
            <a:off x="2618969" y="5585538"/>
            <a:ext cx="364202" cy="307777"/>
          </a:xfrm>
          <a:prstGeom prst="rect">
            <a:avLst/>
          </a:prstGeom>
          <a:noFill/>
        </p:spPr>
        <p:txBody>
          <a:bodyPr wrap="none" rtlCol="0">
            <a:spAutoFit/>
          </a:bodyPr>
          <a:lstStyle/>
          <a:p>
            <a:r>
              <a:rPr lang="en-AU" sz="1400" dirty="0"/>
              <a:t>**</a:t>
            </a:r>
          </a:p>
        </p:txBody>
      </p:sp>
    </p:spTree>
    <p:extLst>
      <p:ext uri="{BB962C8B-B14F-4D97-AF65-F5344CB8AC3E}">
        <p14:creationId xmlns:p14="http://schemas.microsoft.com/office/powerpoint/2010/main" val="15249279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21F3A5AA3824E46BFAC0E04B86D97A8" ma:contentTypeVersion="14" ma:contentTypeDescription="Create a new document." ma:contentTypeScope="" ma:versionID="1c8432351984fac78a8a03e6e7717661">
  <xsd:schema xmlns:xsd="http://www.w3.org/2001/XMLSchema" xmlns:xs="http://www.w3.org/2001/XMLSchema" xmlns:p="http://schemas.microsoft.com/office/2006/metadata/properties" xmlns:ns2="d2231a62-9fa0-4454-a05e-9b4660a1a828" xmlns:ns3="17b31d3a-6eed-4502-ac0a-e0f4c9c81272" targetNamespace="http://schemas.microsoft.com/office/2006/metadata/properties" ma:root="true" ma:fieldsID="97ff81a78f2e389d9bd8f26e72e8b250" ns2:_="" ns3:_="">
    <xsd:import namespace="d2231a62-9fa0-4454-a05e-9b4660a1a828"/>
    <xsd:import namespace="17b31d3a-6eed-4502-ac0a-e0f4c9c81272"/>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element ref="ns2:MediaServiceDateTaken" minOccurs="0"/>
                <xsd:element ref="ns2:MediaServiceAutoTags" minOccurs="0"/>
                <xsd:element ref="ns2:MediaServiceGenerationTime" minOccurs="0"/>
                <xsd:element ref="ns2:MediaServiceEventHashCode" minOccurs="0"/>
                <xsd:element ref="ns2:MediaServiceOCR"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2231a62-9fa0-4454-a05e-9b4660a1a82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4" nillable="true" ma:displayName="MediaServiceDateTaken" ma:hidden="true" ma:internalName="MediaServiceDateTaken" ma:readOnly="true">
      <xsd:simpleType>
        <xsd:restriction base="dms:Text"/>
      </xsd:simpleType>
    </xsd:element>
    <xsd:element name="MediaServiceAutoTags" ma:index="15" nillable="true" ma:displayName="Tags" ma:internalName="MediaServiceAutoTags"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element name="lcf76f155ced4ddcb4097134ff3c332f" ma:index="20" nillable="true" ma:taxonomy="true" ma:internalName="lcf76f155ced4ddcb4097134ff3c332f" ma:taxonomyFieldName="MediaServiceImageTags" ma:displayName="Image Tags" ma:readOnly="false" ma:fieldId="{5cf76f15-5ced-4ddc-b409-7134ff3c332f}" ma:taxonomyMulti="true" ma:sspId="9292314e-c97d-49c1-8ae7-4cb6e1c4f97c"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17b31d3a-6eed-4502-ac0a-e0f4c9c8127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TaxCatchAll" ma:index="21" nillable="true" ma:displayName="Taxonomy Catch All Column" ma:hidden="true" ma:list="{069ba445-3ab7-4a3d-bdc1-b352437b0781}" ma:internalName="TaxCatchAll" ma:showField="CatchAllData" ma:web="17b31d3a-6eed-4502-ac0a-e0f4c9c81272">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SharedWithUsers xmlns="17b31d3a-6eed-4502-ac0a-e0f4c9c81272">
      <UserInfo>
        <DisplayName>Yvonne O Ogaji (DJPR)</DisplayName>
        <AccountId>92</AccountId>
        <AccountType/>
      </UserInfo>
    </SharedWithUsers>
    <TaxCatchAll xmlns="17b31d3a-6eed-4502-ac0a-e0f4c9c81272" xsi:nil="true"/>
    <lcf76f155ced4ddcb4097134ff3c332f xmlns="d2231a62-9fa0-4454-a05e-9b4660a1a828">
      <Terms xmlns="http://schemas.microsoft.com/office/infopath/2007/PartnerControls"/>
    </lcf76f155ced4ddcb4097134ff3c332f>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662BC4A-4A17-47EA-B323-727EA1DFE3E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2231a62-9fa0-4454-a05e-9b4660a1a828"/>
    <ds:schemaRef ds:uri="17b31d3a-6eed-4502-ac0a-e0f4c9c8127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B849278E-CC1F-49FD-A103-8C495159AA7A}">
  <ds:schemaRefs>
    <ds:schemaRef ds:uri="17b31d3a-6eed-4502-ac0a-e0f4c9c81272"/>
    <ds:schemaRef ds:uri="http://schemas.microsoft.com/office/2006/metadata/properties"/>
    <ds:schemaRef ds:uri="http://schemas.microsoft.com/office/infopath/2007/PartnerControls"/>
    <ds:schemaRef ds:uri="d2231a62-9fa0-4454-a05e-9b4660a1a828"/>
  </ds:schemaRefs>
</ds:datastoreItem>
</file>

<file path=customXml/itemProps3.xml><?xml version="1.0" encoding="utf-8"?>
<ds:datastoreItem xmlns:ds="http://schemas.openxmlformats.org/officeDocument/2006/customXml" ds:itemID="{6D0EC879-316C-4868-89B4-3DF76FA0D83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65358</TotalTime>
  <Words>195</Words>
  <Application>Microsoft Office PowerPoint</Application>
  <PresentationFormat>On-screen Show (16:9)</PresentationFormat>
  <Paragraphs>24</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meer G Joshi (DJPR)</dc:creator>
  <cp:lastModifiedBy>Sameer Joshi</cp:lastModifiedBy>
  <cp:revision>3</cp:revision>
  <dcterms:created xsi:type="dcterms:W3CDTF">2021-03-19T04:05:31Z</dcterms:created>
  <dcterms:modified xsi:type="dcterms:W3CDTF">2022-08-18T04:38:1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21F3A5AA3824E46BFAC0E04B86D97A8</vt:lpwstr>
  </property>
  <property fmtid="{D5CDD505-2E9C-101B-9397-08002B2CF9AE}" pid="3" name="MSIP_Label_d00a4df9-c942-4b09-b23a-6c1023f6de27_Enabled">
    <vt:lpwstr>true</vt:lpwstr>
  </property>
  <property fmtid="{D5CDD505-2E9C-101B-9397-08002B2CF9AE}" pid="4" name="MSIP_Label_d00a4df9-c942-4b09-b23a-6c1023f6de27_SetDate">
    <vt:lpwstr>2022-04-22T00:34:26Z</vt:lpwstr>
  </property>
  <property fmtid="{D5CDD505-2E9C-101B-9397-08002B2CF9AE}" pid="5" name="MSIP_Label_d00a4df9-c942-4b09-b23a-6c1023f6de27_Method">
    <vt:lpwstr>Privileged</vt:lpwstr>
  </property>
  <property fmtid="{D5CDD505-2E9C-101B-9397-08002B2CF9AE}" pid="6" name="MSIP_Label_d00a4df9-c942-4b09-b23a-6c1023f6de27_Name">
    <vt:lpwstr>Official (DJPR)</vt:lpwstr>
  </property>
  <property fmtid="{D5CDD505-2E9C-101B-9397-08002B2CF9AE}" pid="7" name="MSIP_Label_d00a4df9-c942-4b09-b23a-6c1023f6de27_SiteId">
    <vt:lpwstr>722ea0be-3e1c-4b11-ad6f-9401d6856e24</vt:lpwstr>
  </property>
  <property fmtid="{D5CDD505-2E9C-101B-9397-08002B2CF9AE}" pid="8" name="MSIP_Label_d00a4df9-c942-4b09-b23a-6c1023f6de27_ActionId">
    <vt:lpwstr>3fcae7f3-99cb-4b8c-91f9-e63cd787c541</vt:lpwstr>
  </property>
  <property fmtid="{D5CDD505-2E9C-101B-9397-08002B2CF9AE}" pid="9" name="MSIP_Label_d00a4df9-c942-4b09-b23a-6c1023f6de27_ContentBits">
    <vt:lpwstr>3</vt:lpwstr>
  </property>
  <property fmtid="{D5CDD505-2E9C-101B-9397-08002B2CF9AE}" pid="10" name="MediaServiceImageTags">
    <vt:lpwstr/>
  </property>
</Properties>
</file>